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7" r:id="rId2"/>
    <p:sldId id="258" r:id="rId3"/>
    <p:sldId id="259" r:id="rId4"/>
    <p:sldId id="256" r:id="rId5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9C9C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63"/>
  </p:normalViewPr>
  <p:slideViewPr>
    <p:cSldViewPr snapToGrid="0">
      <p:cViewPr varScale="1">
        <p:scale>
          <a:sx n="75" d="100"/>
          <a:sy n="75" d="100"/>
        </p:scale>
        <p:origin x="30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TERA.univ-lyon1.fr\homepers\louise.conilh\Bureau\MDA-MB-361\PCR\Matrice%20PCR%20MDA%20Recepteur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/TERA.univ-lyon1.fr\homepers\louise.conilh\Bureau\MDA-MB-361\PCR\MDA%20PCR%20MRP1%20MVP-LRP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/TERA.univ-lyon1.fr\homepers\louise.conilh\Bureau\ADH%20GENES%20heat%20map%20ok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/TERA.univ-lyon1.fr\homepers\louise.conilh\Bureau\ADH%20GENES%20heat%20map%20ok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/TERA.univ-lyon1.fr\homepers\louise.conilh\Bureau\ADH%20GENES%20heat%20map%20ok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TERA.univ-lyon1.fr\homepers\louise.conilh\Bureau\MDA-MB-361\PCR\Matrice%20PCR%20MDA%20Recepteur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TERA.univ-lyon1.fr\homepers\louise.conilh\Bureau\MDA-MB-361\PCR\Matrice%20PCR%20MDA%20Recepteur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TERA.univ-lyon1.fr\homepers\louise.conilh\Bureau\MDA-MB-361\PCR\Matrice%20PCR%20MDA%20Recepteur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TERA.univ-lyon1.fr\homepers\louise.conilh\Bureau\MDA-MB-361\PCR\Matrice%20PCR%20MDA%20Recepteur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TERA.univ-lyon1.fr\homepers\louise.conilh\Bureau\MDA-MB-361\PCR\MDA%20PCR%20MRP1%20MVP-LRP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TERA.univ-lyon1.fr\homepers\louise.conilh\Bureau\MDA-MB-361\PCR\Matrice%20PCR%20MDA%20Recepteurs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/TERA.univ-lyon1.fr\homepers\louise.conilh\Bureau\MDA-MB-361\PCR\Matrice%20PCR%20MDA%20Recepteurs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/TERA.univ-lyon1.fr\homepers\louise.conilh\Bureau\MDA-MB-361\PCR\Matrice%20PCR%20MDA%20Recepteurs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sz="12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b="1" dirty="0"/>
              <a:t>Relative expression of </a:t>
            </a:r>
            <a:r>
              <a:rPr lang="en-US" sz="1200" b="1" baseline="0" dirty="0"/>
              <a:t>MRP1 (normalized to 28S) </a:t>
            </a:r>
            <a:endParaRPr lang="en-US" sz="1200" b="1" dirty="0"/>
          </a:p>
        </c:rich>
      </c:tx>
      <c:layout>
        <c:manualLayout>
          <c:xMode val="edge"/>
          <c:yMode val="edge"/>
          <c:x val="0.16166917026637925"/>
          <c:y val="3.807786545665375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sz="12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3.9783021688510362E-2"/>
          <c:y val="0.17747599473754391"/>
          <c:w val="0.94352321365365921"/>
          <c:h val="0.659092298531258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RP1 (1a)'!$E$3:$E$5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tx>
          <c:spPr>
            <a:solidFill>
              <a:schemeClr val="accent1"/>
            </a:solidFill>
            <a:ln w="9525">
              <a:solidFill>
                <a:schemeClr val="accent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RP1 (1a)'!$Y$3:$Y$4</c:f>
                <c:numCache>
                  <c:formatCode>General</c:formatCode>
                  <c:ptCount val="2"/>
                  <c:pt idx="1">
                    <c:v>2.874532567698539E-2</c:v>
                  </c:pt>
                </c:numCache>
              </c:numRef>
            </c:plus>
            <c:minus>
              <c:numRef>
                <c:f>'MRP1 (1a)'!$Y$3:$Y$4</c:f>
                <c:numCache>
                  <c:formatCode>General</c:formatCode>
                  <c:ptCount val="2"/>
                  <c:pt idx="1">
                    <c:v>2.87453256769853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RP1 (1a)'!$E$3:$E$5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cat>
          <c:val>
            <c:numRef>
              <c:f>'MRP1 (1a)'!$X$3:$X$4</c:f>
              <c:numCache>
                <c:formatCode>0.000</c:formatCode>
                <c:ptCount val="2"/>
                <c:pt idx="0" formatCode="General">
                  <c:v>1</c:v>
                </c:pt>
                <c:pt idx="1">
                  <c:v>0.697371833175199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C3-BD44-8824-E5DC308252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2"/>
        <c:axId val="188151232"/>
        <c:axId val="188149984"/>
      </c:barChart>
      <c:catAx>
        <c:axId val="188151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49984"/>
        <c:crosses val="autoZero"/>
        <c:auto val="1"/>
        <c:lblAlgn val="ctr"/>
        <c:lblOffset val="100"/>
        <c:noMultiLvlLbl val="0"/>
      </c:catAx>
      <c:valAx>
        <c:axId val="1881499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512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 b="1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1200" b="1" i="0" baseline="0" dirty="0">
                <a:effectLst/>
              </a:rPr>
              <a:t>Relative expression of MVP/LRP (normalized to 28S) </a:t>
            </a:r>
            <a:endParaRPr lang="fr-FR" sz="1200" dirty="0">
              <a:effectLst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 b="1">
                <a:solidFill>
                  <a:prstClr val="black">
                    <a:lumMod val="65000"/>
                    <a:lumOff val="35000"/>
                  </a:prstClr>
                </a:solidFill>
              </a:defRPr>
            </a:pPr>
            <a:endParaRPr lang="en-US" sz="1200" b="1" dirty="0"/>
          </a:p>
        </c:rich>
      </c:tx>
      <c:layout>
        <c:manualLayout>
          <c:xMode val="edge"/>
          <c:yMode val="edge"/>
          <c:x val="0.18984300311521954"/>
          <c:y val="3.077015240210246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200" b="1" i="0" u="none" strike="noStrike" kern="1200" spc="0" baseline="0">
              <a:solidFill>
                <a:prstClr val="black">
                  <a:lumMod val="65000"/>
                  <a:lumOff val="35000"/>
                </a:prst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3.9783021688510362E-2"/>
          <c:y val="0.17747599473754391"/>
          <c:w val="0.94352321365365921"/>
          <c:h val="0.659092298531258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VP (6)'!$E$3:$E$5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tx>
          <c:spPr>
            <a:solidFill>
              <a:schemeClr val="accent2"/>
            </a:solidFill>
            <a:ln w="9525">
              <a:solidFill>
                <a:schemeClr val="accent2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VP (6)'!$Y$3:$Y$4</c:f>
                <c:numCache>
                  <c:formatCode>General</c:formatCode>
                  <c:ptCount val="2"/>
                  <c:pt idx="1">
                    <c:v>3.3486642928805925E-2</c:v>
                  </c:pt>
                </c:numCache>
              </c:numRef>
            </c:plus>
            <c:minus>
              <c:numRef>
                <c:f>'MVP (6)'!$Y$3:$Y$4</c:f>
                <c:numCache>
                  <c:formatCode>General</c:formatCode>
                  <c:ptCount val="2"/>
                  <c:pt idx="1">
                    <c:v>3.348664292880592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VP (6)'!$E$3:$E$5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cat>
          <c:val>
            <c:numRef>
              <c:f>'MVP (6)'!$X$3:$X$5</c:f>
              <c:numCache>
                <c:formatCode>0.000</c:formatCode>
                <c:ptCount val="3"/>
                <c:pt idx="0" formatCode="General">
                  <c:v>1</c:v>
                </c:pt>
                <c:pt idx="1">
                  <c:v>1.4983070768766842</c:v>
                </c:pt>
                <c:pt idx="2">
                  <c:v>0.790041311863375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6EA-AD49-9A90-BBC737F59F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2"/>
        <c:axId val="188151232"/>
        <c:axId val="188149984"/>
      </c:barChart>
      <c:catAx>
        <c:axId val="188151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49984"/>
        <c:crosses val="autoZero"/>
        <c:auto val="1"/>
        <c:lblAlgn val="ctr"/>
        <c:lblOffset val="100"/>
        <c:noMultiLvlLbl val="0"/>
      </c:catAx>
      <c:valAx>
        <c:axId val="1881499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512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xMode val="edge"/>
          <c:yMode val="edge"/>
          <c:x val="3.9285714285714285E-2"/>
          <c:y val="1.9643044619422571E-2"/>
          <c:w val="0.92142857142857137"/>
          <c:h val="0.89702362204724428"/>
        </c:manualLayout>
      </c:layout>
      <c:scatterChart>
        <c:scatterStyle val="lineMarker"/>
        <c:varyColors val="0"/>
        <c:ser>
          <c:idx val="0"/>
          <c:order val="0"/>
          <c:spPr>
            <a:ln w="12700">
              <a:solidFill>
                <a:srgbClr val="020000"/>
              </a:solidFill>
              <a:prstDash val="solid"/>
            </a:ln>
            <a:effectLst/>
          </c:spPr>
          <c:marker>
            <c:spPr>
              <a:noFill/>
              <a:ln w="6350">
                <a:noFill/>
              </a:ln>
            </c:spPr>
          </c:marker>
          <c:xVal>
            <c:numRef>
              <c:f>'Heat maps3_HID6'!$A$1:$A$15</c:f>
              <c:numCache>
                <c:formatCode>0</c:formatCode>
                <c:ptCount val="15"/>
                <c:pt idx="0">
                  <c:v>1.75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2.5</c:v>
                </c:pt>
                <c:pt idx="5">
                  <c:v>2.5</c:v>
                </c:pt>
                <c:pt idx="6">
                  <c:v>2</c:v>
                </c:pt>
                <c:pt idx="7">
                  <c:v>2</c:v>
                </c:pt>
                <c:pt idx="8">
                  <c:v>2</c:v>
                </c:pt>
                <c:pt idx="9">
                  <c:v>3</c:v>
                </c:pt>
                <c:pt idx="10">
                  <c:v>3</c:v>
                </c:pt>
                <c:pt idx="11">
                  <c:v>3</c:v>
                </c:pt>
                <c:pt idx="12">
                  <c:v>2.5</c:v>
                </c:pt>
                <c:pt idx="13">
                  <c:v>2.5</c:v>
                </c:pt>
                <c:pt idx="14">
                  <c:v>1.75</c:v>
                </c:pt>
              </c:numCache>
            </c:numRef>
          </c:xVal>
          <c:yVal>
            <c:numRef>
              <c:f>'Heat maps3_HID6'!$B$1:$B$15</c:f>
              <c:numCache>
                <c:formatCode>0</c:formatCode>
                <c:ptCount val="15"/>
                <c:pt idx="0">
                  <c:v>4383820979.4358492</c:v>
                </c:pt>
                <c:pt idx="1">
                  <c:v>4383820979.4358492</c:v>
                </c:pt>
                <c:pt idx="2">
                  <c:v>0</c:v>
                </c:pt>
                <c:pt idx="3">
                  <c:v>4383820979.4358492</c:v>
                </c:pt>
                <c:pt idx="4">
                  <c:v>4383820979.4358492</c:v>
                </c:pt>
                <c:pt idx="5">
                  <c:v>1095446981.2325385</c:v>
                </c:pt>
                <c:pt idx="6">
                  <c:v>1095446981.2325385</c:v>
                </c:pt>
                <c:pt idx="7">
                  <c:v>0</c:v>
                </c:pt>
                <c:pt idx="8">
                  <c:v>1095446981.2325385</c:v>
                </c:pt>
                <c:pt idx="9">
                  <c:v>1095446981.2325385</c:v>
                </c:pt>
                <c:pt idx="10">
                  <c:v>0</c:v>
                </c:pt>
                <c:pt idx="11">
                  <c:v>1095446981.2325385</c:v>
                </c:pt>
                <c:pt idx="12">
                  <c:v>1095446981.2325385</c:v>
                </c:pt>
                <c:pt idx="13">
                  <c:v>4383820979.4358492</c:v>
                </c:pt>
                <c:pt idx="14">
                  <c:v>4383820979.435849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DB9-4441-B938-720213B7D8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9220432"/>
        <c:axId val="239221264"/>
      </c:scatterChart>
      <c:valAx>
        <c:axId val="239220432"/>
        <c:scaling>
          <c:orientation val="minMax"/>
          <c:max val="3.5"/>
          <c:min val="0.5"/>
        </c:scaling>
        <c:delete val="0"/>
        <c:axPos val="b"/>
        <c:numFmt formatCode="General" sourceLinked="0"/>
        <c:majorTickMark val="none"/>
        <c:minorTickMark val="none"/>
        <c:tickLblPos val="none"/>
        <c:spPr>
          <a:ln w="6350">
            <a:noFill/>
          </a:ln>
        </c:spPr>
        <c:txPr>
          <a:bodyPr/>
          <a:lstStyle/>
          <a:p>
            <a:pPr>
              <a:defRPr sz="700"/>
            </a:pPr>
            <a:endParaRPr lang="fr-FR"/>
          </a:p>
        </c:txPr>
        <c:crossAx val="239221264"/>
        <c:crosses val="autoZero"/>
        <c:crossBetween val="midCat"/>
      </c:valAx>
      <c:valAx>
        <c:axId val="239221264"/>
        <c:scaling>
          <c:orientation val="minMax"/>
          <c:min val="0"/>
        </c:scaling>
        <c:delete val="0"/>
        <c:axPos val="l"/>
        <c:numFmt formatCode="General" sourceLinked="0"/>
        <c:majorTickMark val="none"/>
        <c:minorTickMark val="none"/>
        <c:tickLblPos val="none"/>
        <c:spPr>
          <a:ln w="6350">
            <a:noFill/>
          </a:ln>
        </c:spPr>
        <c:txPr>
          <a:bodyPr/>
          <a:lstStyle/>
          <a:p>
            <a:pPr>
              <a:defRPr sz="700"/>
            </a:pPr>
            <a:endParaRPr lang="fr-FR"/>
          </a:p>
        </c:txPr>
        <c:crossAx val="239220432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6350">
      <a:noFill/>
    </a:ln>
  </c:sp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xMode val="edge"/>
          <c:yMode val="edge"/>
          <c:x val="3.3333333333333333E-2"/>
          <c:y val="7.1428571428571426E-3"/>
          <c:w val="0.96666666666666667"/>
          <c:h val="0.97678571428571426"/>
        </c:manualLayout>
      </c:layout>
      <c:scatterChart>
        <c:scatterStyle val="lineMarker"/>
        <c:varyColors val="0"/>
        <c:ser>
          <c:idx val="0"/>
          <c:order val="0"/>
          <c:spPr>
            <a:ln w="12700">
              <a:solidFill>
                <a:srgbClr val="020000"/>
              </a:solidFill>
              <a:prstDash val="solid"/>
            </a:ln>
            <a:effectLst/>
          </c:spPr>
          <c:marker>
            <c:spPr>
              <a:noFill/>
              <a:ln w="6350">
                <a:noFill/>
              </a:ln>
            </c:spPr>
          </c:marker>
          <c:xVal>
            <c:numRef>
              <c:f>'Heat maps3_HID6'!$H$1:$H$2325</c:f>
              <c:numCache>
                <c:formatCode>0</c:formatCode>
                <c:ptCount val="2325"/>
                <c:pt idx="0">
                  <c:v>1895526519.3810787</c:v>
                </c:pt>
                <c:pt idx="1">
                  <c:v>1895526519.3810787</c:v>
                </c:pt>
                <c:pt idx="2">
                  <c:v>192876310.62387407</c:v>
                </c:pt>
                <c:pt idx="3">
                  <c:v>192876310.62387407</c:v>
                </c:pt>
                <c:pt idx="4">
                  <c:v>0</c:v>
                </c:pt>
                <c:pt idx="5">
                  <c:v>192876310.62387407</c:v>
                </c:pt>
                <c:pt idx="6">
                  <c:v>192876310.62387407</c:v>
                </c:pt>
                <c:pt idx="7">
                  <c:v>37903578.432480589</c:v>
                </c:pt>
                <c:pt idx="8">
                  <c:v>37903578.432480589</c:v>
                </c:pt>
                <c:pt idx="9">
                  <c:v>0</c:v>
                </c:pt>
                <c:pt idx="10">
                  <c:v>37903578.432480589</c:v>
                </c:pt>
                <c:pt idx="11">
                  <c:v>37903578.432480589</c:v>
                </c:pt>
                <c:pt idx="12">
                  <c:v>0</c:v>
                </c:pt>
                <c:pt idx="13">
                  <c:v>37903578.432480589</c:v>
                </c:pt>
                <c:pt idx="14">
                  <c:v>37903578.432480589</c:v>
                </c:pt>
                <c:pt idx="15">
                  <c:v>192876310.62387407</c:v>
                </c:pt>
                <c:pt idx="16">
                  <c:v>192876310.62387407</c:v>
                </c:pt>
                <c:pt idx="17">
                  <c:v>1895526519.3810787</c:v>
                </c:pt>
                <c:pt idx="18">
                  <c:v>1895526519.3810787</c:v>
                </c:pt>
                <c:pt idx="19">
                  <c:v>1666346668.7257748</c:v>
                </c:pt>
                <c:pt idx="20">
                  <c:v>1666346668.7257748</c:v>
                </c:pt>
                <c:pt idx="21">
                  <c:v>0</c:v>
                </c:pt>
                <c:pt idx="22">
                  <c:v>1666346668.7257748</c:v>
                </c:pt>
                <c:pt idx="23">
                  <c:v>1666346668.7257748</c:v>
                </c:pt>
                <c:pt idx="24">
                  <c:v>556269028.81687307</c:v>
                </c:pt>
                <c:pt idx="25">
                  <c:v>556269028.81687307</c:v>
                </c:pt>
                <c:pt idx="26">
                  <c:v>159106316.10036436</c:v>
                </c:pt>
                <c:pt idx="27">
                  <c:v>159106316.10036436</c:v>
                </c:pt>
                <c:pt idx="28">
                  <c:v>0</c:v>
                </c:pt>
                <c:pt idx="29">
                  <c:v>159106316.10036436</c:v>
                </c:pt>
                <c:pt idx="30">
                  <c:v>159106316.10036436</c:v>
                </c:pt>
                <c:pt idx="31">
                  <c:v>34645845.815806158</c:v>
                </c:pt>
                <c:pt idx="32">
                  <c:v>34645845.815806158</c:v>
                </c:pt>
                <c:pt idx="33">
                  <c:v>0</c:v>
                </c:pt>
                <c:pt idx="34">
                  <c:v>34645845.815806158</c:v>
                </c:pt>
                <c:pt idx="35">
                  <c:v>34645845.815806158</c:v>
                </c:pt>
                <c:pt idx="36">
                  <c:v>13033797.807730749</c:v>
                </c:pt>
                <c:pt idx="37">
                  <c:v>13033797.807730749</c:v>
                </c:pt>
                <c:pt idx="38">
                  <c:v>2214706.0946786595</c:v>
                </c:pt>
                <c:pt idx="39">
                  <c:v>2214706.0946786595</c:v>
                </c:pt>
                <c:pt idx="40">
                  <c:v>0</c:v>
                </c:pt>
                <c:pt idx="41">
                  <c:v>2214706.0946786595</c:v>
                </c:pt>
                <c:pt idx="42">
                  <c:v>2214706.0946786595</c:v>
                </c:pt>
                <c:pt idx="43">
                  <c:v>0</c:v>
                </c:pt>
                <c:pt idx="44">
                  <c:v>2214706.0946786595</c:v>
                </c:pt>
                <c:pt idx="45">
                  <c:v>2214706.0946786595</c:v>
                </c:pt>
                <c:pt idx="46">
                  <c:v>13033797.807730749</c:v>
                </c:pt>
                <c:pt idx="47">
                  <c:v>13033797.807730749</c:v>
                </c:pt>
                <c:pt idx="48">
                  <c:v>3788110.9394003493</c:v>
                </c:pt>
                <c:pt idx="49">
                  <c:v>3788110.9394003493</c:v>
                </c:pt>
                <c:pt idx="50">
                  <c:v>0</c:v>
                </c:pt>
                <c:pt idx="51">
                  <c:v>3788110.9394003493</c:v>
                </c:pt>
                <c:pt idx="52">
                  <c:v>3788110.9394003493</c:v>
                </c:pt>
                <c:pt idx="53">
                  <c:v>0</c:v>
                </c:pt>
                <c:pt idx="54">
                  <c:v>3788110.9394003493</c:v>
                </c:pt>
                <c:pt idx="55">
                  <c:v>3788110.9394003493</c:v>
                </c:pt>
                <c:pt idx="56">
                  <c:v>13033797.807730749</c:v>
                </c:pt>
                <c:pt idx="57">
                  <c:v>13033797.807730749</c:v>
                </c:pt>
                <c:pt idx="58">
                  <c:v>34645845.815806158</c:v>
                </c:pt>
                <c:pt idx="59">
                  <c:v>34645845.815806158</c:v>
                </c:pt>
                <c:pt idx="60">
                  <c:v>159106316.10036436</c:v>
                </c:pt>
                <c:pt idx="61">
                  <c:v>159106316.10036436</c:v>
                </c:pt>
                <c:pt idx="62">
                  <c:v>556269028.81687307</c:v>
                </c:pt>
                <c:pt idx="63">
                  <c:v>556269028.81687307</c:v>
                </c:pt>
                <c:pt idx="64">
                  <c:v>318605164.94198072</c:v>
                </c:pt>
                <c:pt idx="65">
                  <c:v>318605164.94198072</c:v>
                </c:pt>
                <c:pt idx="66">
                  <c:v>119111018.21166036</c:v>
                </c:pt>
                <c:pt idx="67">
                  <c:v>119111018.21166036</c:v>
                </c:pt>
                <c:pt idx="68">
                  <c:v>46178134.130883597</c:v>
                </c:pt>
                <c:pt idx="69">
                  <c:v>46178134.130883597</c:v>
                </c:pt>
                <c:pt idx="70">
                  <c:v>4623144.7131077182</c:v>
                </c:pt>
                <c:pt idx="71">
                  <c:v>4623144.7131077182</c:v>
                </c:pt>
                <c:pt idx="72">
                  <c:v>499992.86154299544</c:v>
                </c:pt>
                <c:pt idx="73">
                  <c:v>499992.86154299544</c:v>
                </c:pt>
                <c:pt idx="74">
                  <c:v>0</c:v>
                </c:pt>
                <c:pt idx="75">
                  <c:v>499992.86154299544</c:v>
                </c:pt>
                <c:pt idx="76">
                  <c:v>499992.86154299544</c:v>
                </c:pt>
                <c:pt idx="77">
                  <c:v>347258.19959018508</c:v>
                </c:pt>
                <c:pt idx="78">
                  <c:v>347258.19959018508</c:v>
                </c:pt>
                <c:pt idx="79">
                  <c:v>0</c:v>
                </c:pt>
                <c:pt idx="80">
                  <c:v>347258.19959018508</c:v>
                </c:pt>
                <c:pt idx="81">
                  <c:v>347258.19959018508</c:v>
                </c:pt>
                <c:pt idx="82">
                  <c:v>116793.08795690317</c:v>
                </c:pt>
                <c:pt idx="83">
                  <c:v>116793.08795690317</c:v>
                </c:pt>
                <c:pt idx="84">
                  <c:v>0</c:v>
                </c:pt>
                <c:pt idx="85">
                  <c:v>116793.08795690317</c:v>
                </c:pt>
                <c:pt idx="86">
                  <c:v>116793.08795690317</c:v>
                </c:pt>
                <c:pt idx="87">
                  <c:v>0</c:v>
                </c:pt>
                <c:pt idx="88">
                  <c:v>116793.08795690317</c:v>
                </c:pt>
                <c:pt idx="89">
                  <c:v>116793.08795690317</c:v>
                </c:pt>
                <c:pt idx="90">
                  <c:v>347258.19959018508</c:v>
                </c:pt>
                <c:pt idx="91">
                  <c:v>347258.19959018508</c:v>
                </c:pt>
                <c:pt idx="92">
                  <c:v>499992.86154299544</c:v>
                </c:pt>
                <c:pt idx="93">
                  <c:v>499992.86154299544</c:v>
                </c:pt>
                <c:pt idx="94">
                  <c:v>4623144.7131077182</c:v>
                </c:pt>
                <c:pt idx="95">
                  <c:v>4623144.7131077182</c:v>
                </c:pt>
                <c:pt idx="96">
                  <c:v>1532106.3025188348</c:v>
                </c:pt>
                <c:pt idx="97">
                  <c:v>1532106.3025188348</c:v>
                </c:pt>
                <c:pt idx="98">
                  <c:v>0</c:v>
                </c:pt>
                <c:pt idx="99">
                  <c:v>1532106.3025188348</c:v>
                </c:pt>
                <c:pt idx="100">
                  <c:v>1532106.3025188348</c:v>
                </c:pt>
                <c:pt idx="101">
                  <c:v>548798.27524396114</c:v>
                </c:pt>
                <c:pt idx="102">
                  <c:v>548798.27524396114</c:v>
                </c:pt>
                <c:pt idx="103">
                  <c:v>0</c:v>
                </c:pt>
                <c:pt idx="104">
                  <c:v>548798.27524396114</c:v>
                </c:pt>
                <c:pt idx="105">
                  <c:v>548798.27524396114</c:v>
                </c:pt>
                <c:pt idx="106">
                  <c:v>192627.68769096246</c:v>
                </c:pt>
                <c:pt idx="107">
                  <c:v>192627.68769096246</c:v>
                </c:pt>
                <c:pt idx="108">
                  <c:v>0</c:v>
                </c:pt>
                <c:pt idx="109">
                  <c:v>192627.68769096246</c:v>
                </c:pt>
                <c:pt idx="110">
                  <c:v>192627.68769096246</c:v>
                </c:pt>
                <c:pt idx="111">
                  <c:v>0</c:v>
                </c:pt>
                <c:pt idx="112">
                  <c:v>192627.68769096246</c:v>
                </c:pt>
                <c:pt idx="113">
                  <c:v>192627.68769096246</c:v>
                </c:pt>
                <c:pt idx="114">
                  <c:v>548798.27524396114</c:v>
                </c:pt>
                <c:pt idx="115">
                  <c:v>548798.27524396114</c:v>
                </c:pt>
                <c:pt idx="116">
                  <c:v>1532106.3025188348</c:v>
                </c:pt>
                <c:pt idx="117">
                  <c:v>1532106.3025188348</c:v>
                </c:pt>
                <c:pt idx="118">
                  <c:v>4623144.7131077182</c:v>
                </c:pt>
                <c:pt idx="119">
                  <c:v>4623144.7131077182</c:v>
                </c:pt>
                <c:pt idx="120">
                  <c:v>46178134.130883597</c:v>
                </c:pt>
                <c:pt idx="121">
                  <c:v>46178134.130883597</c:v>
                </c:pt>
                <c:pt idx="122">
                  <c:v>21176092.839965925</c:v>
                </c:pt>
                <c:pt idx="123">
                  <c:v>21176092.839965925</c:v>
                </c:pt>
                <c:pt idx="124">
                  <c:v>812876.76997404511</c:v>
                </c:pt>
                <c:pt idx="125">
                  <c:v>812876.76997404511</c:v>
                </c:pt>
                <c:pt idx="126">
                  <c:v>0</c:v>
                </c:pt>
                <c:pt idx="127">
                  <c:v>812876.76997404511</c:v>
                </c:pt>
                <c:pt idx="128">
                  <c:v>812876.76997404511</c:v>
                </c:pt>
                <c:pt idx="129">
                  <c:v>0</c:v>
                </c:pt>
                <c:pt idx="130">
                  <c:v>812876.76997404511</c:v>
                </c:pt>
                <c:pt idx="131">
                  <c:v>812876.76997404511</c:v>
                </c:pt>
                <c:pt idx="132">
                  <c:v>21176092.839965925</c:v>
                </c:pt>
                <c:pt idx="133">
                  <c:v>21176092.839965925</c:v>
                </c:pt>
                <c:pt idx="134">
                  <c:v>3966832.2116848747</c:v>
                </c:pt>
                <c:pt idx="135">
                  <c:v>3966832.2116848747</c:v>
                </c:pt>
                <c:pt idx="136">
                  <c:v>249843.7629089964</c:v>
                </c:pt>
                <c:pt idx="137">
                  <c:v>249843.7629089964</c:v>
                </c:pt>
                <c:pt idx="138">
                  <c:v>10070.719301304172</c:v>
                </c:pt>
                <c:pt idx="139">
                  <c:v>10070.719301304172</c:v>
                </c:pt>
                <c:pt idx="140">
                  <c:v>0</c:v>
                </c:pt>
                <c:pt idx="141">
                  <c:v>10070.719301304172</c:v>
                </c:pt>
                <c:pt idx="142">
                  <c:v>10070.719301304172</c:v>
                </c:pt>
                <c:pt idx="143">
                  <c:v>0</c:v>
                </c:pt>
                <c:pt idx="144">
                  <c:v>10070.719301304172</c:v>
                </c:pt>
                <c:pt idx="145">
                  <c:v>10070.719301304172</c:v>
                </c:pt>
                <c:pt idx="146">
                  <c:v>249843.7629089964</c:v>
                </c:pt>
                <c:pt idx="147">
                  <c:v>249843.7629089964</c:v>
                </c:pt>
                <c:pt idx="148">
                  <c:v>24157.070565315116</c:v>
                </c:pt>
                <c:pt idx="149">
                  <c:v>24157.070565315116</c:v>
                </c:pt>
                <c:pt idx="150">
                  <c:v>0</c:v>
                </c:pt>
                <c:pt idx="151">
                  <c:v>24157.070565315116</c:v>
                </c:pt>
                <c:pt idx="152">
                  <c:v>24157.070565315116</c:v>
                </c:pt>
                <c:pt idx="153">
                  <c:v>5265.9467679990903</c:v>
                </c:pt>
                <c:pt idx="154">
                  <c:v>5265.9467679990903</c:v>
                </c:pt>
                <c:pt idx="155">
                  <c:v>0</c:v>
                </c:pt>
                <c:pt idx="156">
                  <c:v>5265.9467679990903</c:v>
                </c:pt>
                <c:pt idx="157">
                  <c:v>5265.9467679990903</c:v>
                </c:pt>
                <c:pt idx="158">
                  <c:v>0</c:v>
                </c:pt>
                <c:pt idx="159">
                  <c:v>5265.9467679990903</c:v>
                </c:pt>
                <c:pt idx="160">
                  <c:v>5265.9467679990903</c:v>
                </c:pt>
                <c:pt idx="161">
                  <c:v>24157.070565315116</c:v>
                </c:pt>
                <c:pt idx="162">
                  <c:v>24157.070565315116</c:v>
                </c:pt>
                <c:pt idx="163">
                  <c:v>249843.7629089964</c:v>
                </c:pt>
                <c:pt idx="164">
                  <c:v>249843.7629089964</c:v>
                </c:pt>
                <c:pt idx="165">
                  <c:v>3966832.2116848747</c:v>
                </c:pt>
                <c:pt idx="166">
                  <c:v>3966832.2116848747</c:v>
                </c:pt>
                <c:pt idx="167">
                  <c:v>2367223.8978568665</c:v>
                </c:pt>
                <c:pt idx="168">
                  <c:v>2367223.8978568665</c:v>
                </c:pt>
                <c:pt idx="169">
                  <c:v>289013.99139718665</c:v>
                </c:pt>
                <c:pt idx="170">
                  <c:v>289013.99139718665</c:v>
                </c:pt>
                <c:pt idx="171">
                  <c:v>0</c:v>
                </c:pt>
                <c:pt idx="172">
                  <c:v>289013.99139718665</c:v>
                </c:pt>
                <c:pt idx="173">
                  <c:v>289013.99139718665</c:v>
                </c:pt>
                <c:pt idx="174">
                  <c:v>47063.875505324919</c:v>
                </c:pt>
                <c:pt idx="175">
                  <c:v>47063.875505324919</c:v>
                </c:pt>
                <c:pt idx="176">
                  <c:v>0</c:v>
                </c:pt>
                <c:pt idx="177">
                  <c:v>47063.875505324919</c:v>
                </c:pt>
                <c:pt idx="178">
                  <c:v>47063.875505324919</c:v>
                </c:pt>
                <c:pt idx="179">
                  <c:v>0</c:v>
                </c:pt>
                <c:pt idx="180">
                  <c:v>47063.875505324919</c:v>
                </c:pt>
                <c:pt idx="181">
                  <c:v>47063.875505324919</c:v>
                </c:pt>
                <c:pt idx="182">
                  <c:v>289013.99139718665</c:v>
                </c:pt>
                <c:pt idx="183">
                  <c:v>289013.99139718665</c:v>
                </c:pt>
                <c:pt idx="184">
                  <c:v>2367223.8978568665</c:v>
                </c:pt>
                <c:pt idx="185">
                  <c:v>2367223.8978568665</c:v>
                </c:pt>
                <c:pt idx="186">
                  <c:v>571080.55611383426</c:v>
                </c:pt>
                <c:pt idx="187">
                  <c:v>571080.55611383426</c:v>
                </c:pt>
                <c:pt idx="188">
                  <c:v>0</c:v>
                </c:pt>
                <c:pt idx="189">
                  <c:v>571080.55611383426</c:v>
                </c:pt>
                <c:pt idx="190">
                  <c:v>571080.55611383426</c:v>
                </c:pt>
                <c:pt idx="191">
                  <c:v>156667.91361310106</c:v>
                </c:pt>
                <c:pt idx="192">
                  <c:v>156667.91361310106</c:v>
                </c:pt>
                <c:pt idx="193">
                  <c:v>0</c:v>
                </c:pt>
                <c:pt idx="194">
                  <c:v>156667.91361310106</c:v>
                </c:pt>
                <c:pt idx="195">
                  <c:v>156667.91361310106</c:v>
                </c:pt>
                <c:pt idx="196">
                  <c:v>104037.72290031046</c:v>
                </c:pt>
                <c:pt idx="197">
                  <c:v>104037.72290031046</c:v>
                </c:pt>
                <c:pt idx="198">
                  <c:v>0</c:v>
                </c:pt>
                <c:pt idx="199">
                  <c:v>104037.72290031046</c:v>
                </c:pt>
                <c:pt idx="200">
                  <c:v>104037.72290031046</c:v>
                </c:pt>
                <c:pt idx="201">
                  <c:v>46610.989336250532</c:v>
                </c:pt>
                <c:pt idx="202">
                  <c:v>46610.989336250532</c:v>
                </c:pt>
                <c:pt idx="203">
                  <c:v>0</c:v>
                </c:pt>
                <c:pt idx="204">
                  <c:v>46610.989336250532</c:v>
                </c:pt>
                <c:pt idx="205">
                  <c:v>46610.989336250532</c:v>
                </c:pt>
                <c:pt idx="206">
                  <c:v>0</c:v>
                </c:pt>
                <c:pt idx="207">
                  <c:v>46610.989336250532</c:v>
                </c:pt>
                <c:pt idx="208">
                  <c:v>46610.989336250532</c:v>
                </c:pt>
                <c:pt idx="209">
                  <c:v>104037.72290031046</c:v>
                </c:pt>
                <c:pt idx="210">
                  <c:v>104037.72290031046</c:v>
                </c:pt>
                <c:pt idx="211">
                  <c:v>156667.91361310106</c:v>
                </c:pt>
                <c:pt idx="212">
                  <c:v>156667.91361310106</c:v>
                </c:pt>
                <c:pt idx="213">
                  <c:v>571080.55611383426</c:v>
                </c:pt>
                <c:pt idx="214">
                  <c:v>571080.55611383426</c:v>
                </c:pt>
                <c:pt idx="215">
                  <c:v>2367223.8978568665</c:v>
                </c:pt>
                <c:pt idx="216">
                  <c:v>2367223.8978568665</c:v>
                </c:pt>
                <c:pt idx="217">
                  <c:v>3966832.2116848747</c:v>
                </c:pt>
                <c:pt idx="218">
                  <c:v>3966832.2116848747</c:v>
                </c:pt>
                <c:pt idx="219">
                  <c:v>21176092.839965925</c:v>
                </c:pt>
                <c:pt idx="220">
                  <c:v>21176092.839965925</c:v>
                </c:pt>
                <c:pt idx="221">
                  <c:v>46178134.130883597</c:v>
                </c:pt>
                <c:pt idx="222">
                  <c:v>46178134.130883597</c:v>
                </c:pt>
                <c:pt idx="223">
                  <c:v>119111018.21166036</c:v>
                </c:pt>
                <c:pt idx="224">
                  <c:v>119111018.21166036</c:v>
                </c:pt>
                <c:pt idx="225">
                  <c:v>50774218.630889751</c:v>
                </c:pt>
                <c:pt idx="226">
                  <c:v>50774218.630889751</c:v>
                </c:pt>
                <c:pt idx="227">
                  <c:v>15974919.409691965</c:v>
                </c:pt>
                <c:pt idx="228">
                  <c:v>15974919.409691965</c:v>
                </c:pt>
                <c:pt idx="229">
                  <c:v>0</c:v>
                </c:pt>
                <c:pt idx="230">
                  <c:v>15974919.409691965</c:v>
                </c:pt>
                <c:pt idx="231">
                  <c:v>15974919.409691965</c:v>
                </c:pt>
                <c:pt idx="232">
                  <c:v>6564845.7424283158</c:v>
                </c:pt>
                <c:pt idx="233">
                  <c:v>6564845.7424283158</c:v>
                </c:pt>
                <c:pt idx="234">
                  <c:v>2351195.9468915388</c:v>
                </c:pt>
                <c:pt idx="235">
                  <c:v>2351195.9468915388</c:v>
                </c:pt>
                <c:pt idx="236">
                  <c:v>120891.59914873596</c:v>
                </c:pt>
                <c:pt idx="237">
                  <c:v>120891.59914873596</c:v>
                </c:pt>
                <c:pt idx="238">
                  <c:v>0</c:v>
                </c:pt>
                <c:pt idx="239">
                  <c:v>120891.59914873596</c:v>
                </c:pt>
                <c:pt idx="240">
                  <c:v>120891.59914873596</c:v>
                </c:pt>
                <c:pt idx="241">
                  <c:v>5420.2713063226747</c:v>
                </c:pt>
                <c:pt idx="242">
                  <c:v>5420.2713063226747</c:v>
                </c:pt>
                <c:pt idx="243">
                  <c:v>0</c:v>
                </c:pt>
                <c:pt idx="244">
                  <c:v>5420.2713063226747</c:v>
                </c:pt>
                <c:pt idx="245">
                  <c:v>5420.2713063226747</c:v>
                </c:pt>
                <c:pt idx="246">
                  <c:v>0</c:v>
                </c:pt>
                <c:pt idx="247">
                  <c:v>5420.2713063226747</c:v>
                </c:pt>
                <c:pt idx="248">
                  <c:v>5420.2713063226747</c:v>
                </c:pt>
                <c:pt idx="249">
                  <c:v>120891.59914873596</c:v>
                </c:pt>
                <c:pt idx="250">
                  <c:v>120891.59914873596</c:v>
                </c:pt>
                <c:pt idx="251">
                  <c:v>2351195.9468915388</c:v>
                </c:pt>
                <c:pt idx="252">
                  <c:v>2351195.9468915388</c:v>
                </c:pt>
                <c:pt idx="253">
                  <c:v>307012.15300539881</c:v>
                </c:pt>
                <c:pt idx="254">
                  <c:v>307012.15300539881</c:v>
                </c:pt>
                <c:pt idx="255">
                  <c:v>14426.614004311386</c:v>
                </c:pt>
                <c:pt idx="256">
                  <c:v>14426.614004311386</c:v>
                </c:pt>
                <c:pt idx="257">
                  <c:v>0</c:v>
                </c:pt>
                <c:pt idx="258">
                  <c:v>14426.614004311386</c:v>
                </c:pt>
                <c:pt idx="259">
                  <c:v>14426.614004311386</c:v>
                </c:pt>
                <c:pt idx="260">
                  <c:v>0</c:v>
                </c:pt>
                <c:pt idx="261">
                  <c:v>14426.614004311386</c:v>
                </c:pt>
                <c:pt idx="262">
                  <c:v>14426.614004311386</c:v>
                </c:pt>
                <c:pt idx="263">
                  <c:v>307012.15300539881</c:v>
                </c:pt>
                <c:pt idx="264">
                  <c:v>307012.15300539881</c:v>
                </c:pt>
                <c:pt idx="265">
                  <c:v>156111.79236335403</c:v>
                </c:pt>
                <c:pt idx="266">
                  <c:v>156111.79236335403</c:v>
                </c:pt>
                <c:pt idx="267">
                  <c:v>0</c:v>
                </c:pt>
                <c:pt idx="268">
                  <c:v>156111.79236335403</c:v>
                </c:pt>
                <c:pt idx="269">
                  <c:v>156111.79236335403</c:v>
                </c:pt>
                <c:pt idx="270">
                  <c:v>5121.2825463215859</c:v>
                </c:pt>
                <c:pt idx="271">
                  <c:v>5121.2825463215859</c:v>
                </c:pt>
                <c:pt idx="272">
                  <c:v>0</c:v>
                </c:pt>
                <c:pt idx="273">
                  <c:v>5121.2825463215859</c:v>
                </c:pt>
                <c:pt idx="274">
                  <c:v>5121.2825463215859</c:v>
                </c:pt>
                <c:pt idx="275">
                  <c:v>0</c:v>
                </c:pt>
                <c:pt idx="276">
                  <c:v>5121.2825463215859</c:v>
                </c:pt>
                <c:pt idx="277">
                  <c:v>5121.2825463215859</c:v>
                </c:pt>
                <c:pt idx="278">
                  <c:v>156111.79236335403</c:v>
                </c:pt>
                <c:pt idx="279">
                  <c:v>156111.79236335403</c:v>
                </c:pt>
                <c:pt idx="280">
                  <c:v>307012.15300539881</c:v>
                </c:pt>
                <c:pt idx="281">
                  <c:v>307012.15300539881</c:v>
                </c:pt>
                <c:pt idx="282">
                  <c:v>2351195.9468915388</c:v>
                </c:pt>
                <c:pt idx="283">
                  <c:v>2351195.9468915388</c:v>
                </c:pt>
                <c:pt idx="284">
                  <c:v>6564845.7424283158</c:v>
                </c:pt>
                <c:pt idx="285">
                  <c:v>6564845.7424283158</c:v>
                </c:pt>
                <c:pt idx="286">
                  <c:v>5040182.1616053553</c:v>
                </c:pt>
                <c:pt idx="287">
                  <c:v>5040182.1616053553</c:v>
                </c:pt>
                <c:pt idx="288">
                  <c:v>382811.35235418082</c:v>
                </c:pt>
                <c:pt idx="289">
                  <c:v>382811.35235418082</c:v>
                </c:pt>
                <c:pt idx="290">
                  <c:v>0</c:v>
                </c:pt>
                <c:pt idx="291">
                  <c:v>382811.35235418082</c:v>
                </c:pt>
                <c:pt idx="292">
                  <c:v>382811.35235418082</c:v>
                </c:pt>
                <c:pt idx="293">
                  <c:v>0</c:v>
                </c:pt>
                <c:pt idx="294">
                  <c:v>382811.35235418082</c:v>
                </c:pt>
                <c:pt idx="295">
                  <c:v>382811.35235418082</c:v>
                </c:pt>
                <c:pt idx="296">
                  <c:v>5040182.1616053553</c:v>
                </c:pt>
                <c:pt idx="297">
                  <c:v>5040182.1616053553</c:v>
                </c:pt>
                <c:pt idx="298">
                  <c:v>787273.58970018395</c:v>
                </c:pt>
                <c:pt idx="299">
                  <c:v>787273.58970018395</c:v>
                </c:pt>
                <c:pt idx="300">
                  <c:v>0</c:v>
                </c:pt>
                <c:pt idx="301">
                  <c:v>787273.58970018395</c:v>
                </c:pt>
                <c:pt idx="302">
                  <c:v>787273.58970018395</c:v>
                </c:pt>
                <c:pt idx="303">
                  <c:v>0</c:v>
                </c:pt>
                <c:pt idx="304">
                  <c:v>787273.58970018395</c:v>
                </c:pt>
                <c:pt idx="305">
                  <c:v>787273.58970018395</c:v>
                </c:pt>
                <c:pt idx="306">
                  <c:v>5040182.1616053553</c:v>
                </c:pt>
                <c:pt idx="307">
                  <c:v>5040182.1616053553</c:v>
                </c:pt>
                <c:pt idx="308">
                  <c:v>6564845.7424283158</c:v>
                </c:pt>
                <c:pt idx="309">
                  <c:v>6564845.7424283158</c:v>
                </c:pt>
                <c:pt idx="310">
                  <c:v>15974919.409691965</c:v>
                </c:pt>
                <c:pt idx="311">
                  <c:v>15974919.409691965</c:v>
                </c:pt>
                <c:pt idx="312">
                  <c:v>50774218.630889751</c:v>
                </c:pt>
                <c:pt idx="313">
                  <c:v>50774218.630889751</c:v>
                </c:pt>
                <c:pt idx="314">
                  <c:v>27284479.657797121</c:v>
                </c:pt>
                <c:pt idx="315">
                  <c:v>27284479.657797121</c:v>
                </c:pt>
                <c:pt idx="316">
                  <c:v>2469162.2866536854</c:v>
                </c:pt>
                <c:pt idx="317">
                  <c:v>2469162.2866536854</c:v>
                </c:pt>
                <c:pt idx="318">
                  <c:v>958466.59291934595</c:v>
                </c:pt>
                <c:pt idx="319">
                  <c:v>958466.59291934595</c:v>
                </c:pt>
                <c:pt idx="320">
                  <c:v>190400.74840125989</c:v>
                </c:pt>
                <c:pt idx="321">
                  <c:v>190400.74840125989</c:v>
                </c:pt>
                <c:pt idx="322">
                  <c:v>29462.709927660668</c:v>
                </c:pt>
                <c:pt idx="323">
                  <c:v>29462.709927660668</c:v>
                </c:pt>
                <c:pt idx="324">
                  <c:v>0</c:v>
                </c:pt>
                <c:pt idx="325">
                  <c:v>29462.709927660668</c:v>
                </c:pt>
                <c:pt idx="326">
                  <c:v>29462.709927660668</c:v>
                </c:pt>
                <c:pt idx="327">
                  <c:v>6718.1678901425339</c:v>
                </c:pt>
                <c:pt idx="328">
                  <c:v>6718.1678901425339</c:v>
                </c:pt>
                <c:pt idx="329">
                  <c:v>0</c:v>
                </c:pt>
                <c:pt idx="330">
                  <c:v>6718.1678901425339</c:v>
                </c:pt>
                <c:pt idx="331">
                  <c:v>6718.1678901425339</c:v>
                </c:pt>
                <c:pt idx="332">
                  <c:v>3203.3288093260658</c:v>
                </c:pt>
                <c:pt idx="333">
                  <c:v>3203.3288093260658</c:v>
                </c:pt>
                <c:pt idx="334">
                  <c:v>0</c:v>
                </c:pt>
                <c:pt idx="335">
                  <c:v>3203.3288093260658</c:v>
                </c:pt>
                <c:pt idx="336">
                  <c:v>3203.3288093260658</c:v>
                </c:pt>
                <c:pt idx="337">
                  <c:v>280.79419599896914</c:v>
                </c:pt>
                <c:pt idx="338">
                  <c:v>280.79419599896914</c:v>
                </c:pt>
                <c:pt idx="339">
                  <c:v>0</c:v>
                </c:pt>
                <c:pt idx="340">
                  <c:v>280.79419599896914</c:v>
                </c:pt>
                <c:pt idx="341">
                  <c:v>280.79419599896914</c:v>
                </c:pt>
                <c:pt idx="342">
                  <c:v>0</c:v>
                </c:pt>
                <c:pt idx="343">
                  <c:v>280.79419599896914</c:v>
                </c:pt>
                <c:pt idx="344">
                  <c:v>280.79419599896914</c:v>
                </c:pt>
                <c:pt idx="345">
                  <c:v>3203.3288093260658</c:v>
                </c:pt>
                <c:pt idx="346">
                  <c:v>3203.3288093260658</c:v>
                </c:pt>
                <c:pt idx="347">
                  <c:v>6718.1678901425339</c:v>
                </c:pt>
                <c:pt idx="348">
                  <c:v>6718.1678901425339</c:v>
                </c:pt>
                <c:pt idx="349">
                  <c:v>29462.709927660668</c:v>
                </c:pt>
                <c:pt idx="350">
                  <c:v>29462.709927660668</c:v>
                </c:pt>
                <c:pt idx="351">
                  <c:v>190400.74840125989</c:v>
                </c:pt>
                <c:pt idx="352">
                  <c:v>190400.74840125989</c:v>
                </c:pt>
                <c:pt idx="353">
                  <c:v>37045.694906603276</c:v>
                </c:pt>
                <c:pt idx="354">
                  <c:v>37045.694906603276</c:v>
                </c:pt>
                <c:pt idx="355">
                  <c:v>10333.675457320112</c:v>
                </c:pt>
                <c:pt idx="356">
                  <c:v>10333.675457320112</c:v>
                </c:pt>
                <c:pt idx="357">
                  <c:v>0</c:v>
                </c:pt>
                <c:pt idx="358">
                  <c:v>10333.675457320112</c:v>
                </c:pt>
                <c:pt idx="359">
                  <c:v>10333.675457320112</c:v>
                </c:pt>
                <c:pt idx="360">
                  <c:v>0</c:v>
                </c:pt>
                <c:pt idx="361">
                  <c:v>10333.675457320112</c:v>
                </c:pt>
                <c:pt idx="362">
                  <c:v>10333.675457320112</c:v>
                </c:pt>
                <c:pt idx="363">
                  <c:v>37045.694906603276</c:v>
                </c:pt>
                <c:pt idx="364">
                  <c:v>37045.694906603276</c:v>
                </c:pt>
                <c:pt idx="365">
                  <c:v>25699.774358298484</c:v>
                </c:pt>
                <c:pt idx="366">
                  <c:v>25699.774358298484</c:v>
                </c:pt>
                <c:pt idx="367">
                  <c:v>0</c:v>
                </c:pt>
                <c:pt idx="368">
                  <c:v>25699.774358298484</c:v>
                </c:pt>
                <c:pt idx="369">
                  <c:v>25699.774358298484</c:v>
                </c:pt>
                <c:pt idx="370">
                  <c:v>3126.8141823310752</c:v>
                </c:pt>
                <c:pt idx="371">
                  <c:v>3126.8141823310752</c:v>
                </c:pt>
                <c:pt idx="372">
                  <c:v>0</c:v>
                </c:pt>
                <c:pt idx="373">
                  <c:v>3126.8141823310752</c:v>
                </c:pt>
                <c:pt idx="374">
                  <c:v>3126.8141823310752</c:v>
                </c:pt>
                <c:pt idx="375">
                  <c:v>0</c:v>
                </c:pt>
                <c:pt idx="376">
                  <c:v>3126.8141823310752</c:v>
                </c:pt>
                <c:pt idx="377">
                  <c:v>3126.8141823310752</c:v>
                </c:pt>
                <c:pt idx="378">
                  <c:v>25699.774358298484</c:v>
                </c:pt>
                <c:pt idx="379">
                  <c:v>25699.774358298484</c:v>
                </c:pt>
                <c:pt idx="380">
                  <c:v>37045.694906603276</c:v>
                </c:pt>
                <c:pt idx="381">
                  <c:v>37045.694906603276</c:v>
                </c:pt>
                <c:pt idx="382">
                  <c:v>190400.74840125989</c:v>
                </c:pt>
                <c:pt idx="383">
                  <c:v>190400.74840125989</c:v>
                </c:pt>
                <c:pt idx="384">
                  <c:v>958466.59291934595</c:v>
                </c:pt>
                <c:pt idx="385">
                  <c:v>958466.59291934595</c:v>
                </c:pt>
                <c:pt idx="386">
                  <c:v>220576.18306288676</c:v>
                </c:pt>
                <c:pt idx="387">
                  <c:v>220576.18306288676</c:v>
                </c:pt>
                <c:pt idx="388">
                  <c:v>11015.15916098006</c:v>
                </c:pt>
                <c:pt idx="389">
                  <c:v>11015.15916098006</c:v>
                </c:pt>
                <c:pt idx="390">
                  <c:v>0</c:v>
                </c:pt>
                <c:pt idx="391">
                  <c:v>11015.15916098006</c:v>
                </c:pt>
                <c:pt idx="392">
                  <c:v>11015.15916098006</c:v>
                </c:pt>
                <c:pt idx="393">
                  <c:v>0</c:v>
                </c:pt>
                <c:pt idx="394">
                  <c:v>11015.15916098006</c:v>
                </c:pt>
                <c:pt idx="395">
                  <c:v>11015.15916098006</c:v>
                </c:pt>
                <c:pt idx="396">
                  <c:v>220576.18306288676</c:v>
                </c:pt>
                <c:pt idx="397">
                  <c:v>220576.18306288676</c:v>
                </c:pt>
                <c:pt idx="398">
                  <c:v>69881.67207893866</c:v>
                </c:pt>
                <c:pt idx="399">
                  <c:v>69881.67207893866</c:v>
                </c:pt>
                <c:pt idx="400">
                  <c:v>11245.669072072676</c:v>
                </c:pt>
                <c:pt idx="401">
                  <c:v>11245.669072072676</c:v>
                </c:pt>
                <c:pt idx="402">
                  <c:v>0</c:v>
                </c:pt>
                <c:pt idx="403">
                  <c:v>11245.669072072676</c:v>
                </c:pt>
                <c:pt idx="404">
                  <c:v>11245.669072072676</c:v>
                </c:pt>
                <c:pt idx="405">
                  <c:v>2938.5565083177084</c:v>
                </c:pt>
                <c:pt idx="406">
                  <c:v>2938.5565083177084</c:v>
                </c:pt>
                <c:pt idx="407">
                  <c:v>0</c:v>
                </c:pt>
                <c:pt idx="408">
                  <c:v>2938.5565083177084</c:v>
                </c:pt>
                <c:pt idx="409">
                  <c:v>2938.5565083177084</c:v>
                </c:pt>
                <c:pt idx="410">
                  <c:v>0</c:v>
                </c:pt>
                <c:pt idx="411">
                  <c:v>2938.5565083177084</c:v>
                </c:pt>
                <c:pt idx="412">
                  <c:v>2938.5565083177084</c:v>
                </c:pt>
                <c:pt idx="413">
                  <c:v>11245.669072072676</c:v>
                </c:pt>
                <c:pt idx="414">
                  <c:v>11245.669072072676</c:v>
                </c:pt>
                <c:pt idx="415">
                  <c:v>69881.67207893866</c:v>
                </c:pt>
                <c:pt idx="416">
                  <c:v>69881.67207893866</c:v>
                </c:pt>
                <c:pt idx="417">
                  <c:v>18901.893725770627</c:v>
                </c:pt>
                <c:pt idx="418">
                  <c:v>18901.893725770627</c:v>
                </c:pt>
                <c:pt idx="419">
                  <c:v>0</c:v>
                </c:pt>
                <c:pt idx="420">
                  <c:v>18901.893725770627</c:v>
                </c:pt>
                <c:pt idx="421">
                  <c:v>18901.893725770627</c:v>
                </c:pt>
                <c:pt idx="422">
                  <c:v>8790.4545213217698</c:v>
                </c:pt>
                <c:pt idx="423">
                  <c:v>8790.4545213217698</c:v>
                </c:pt>
                <c:pt idx="424">
                  <c:v>0</c:v>
                </c:pt>
                <c:pt idx="425">
                  <c:v>8790.4545213217698</c:v>
                </c:pt>
                <c:pt idx="426">
                  <c:v>8790.4545213217698</c:v>
                </c:pt>
                <c:pt idx="427">
                  <c:v>0</c:v>
                </c:pt>
                <c:pt idx="428">
                  <c:v>8790.4545213217698</c:v>
                </c:pt>
                <c:pt idx="429">
                  <c:v>8790.4545213217698</c:v>
                </c:pt>
                <c:pt idx="430">
                  <c:v>18901.893725770627</c:v>
                </c:pt>
                <c:pt idx="431">
                  <c:v>18901.893725770627</c:v>
                </c:pt>
                <c:pt idx="432">
                  <c:v>69881.67207893866</c:v>
                </c:pt>
                <c:pt idx="433">
                  <c:v>69881.67207893866</c:v>
                </c:pt>
                <c:pt idx="434">
                  <c:v>220576.18306288676</c:v>
                </c:pt>
                <c:pt idx="435">
                  <c:v>220576.18306288676</c:v>
                </c:pt>
                <c:pt idx="436">
                  <c:v>958466.59291934595</c:v>
                </c:pt>
                <c:pt idx="437">
                  <c:v>958466.59291934595</c:v>
                </c:pt>
                <c:pt idx="438">
                  <c:v>2469162.2866536854</c:v>
                </c:pt>
                <c:pt idx="439">
                  <c:v>2469162.2866536854</c:v>
                </c:pt>
                <c:pt idx="440">
                  <c:v>1927243.1893264481</c:v>
                </c:pt>
                <c:pt idx="441">
                  <c:v>1927243.1893264481</c:v>
                </c:pt>
                <c:pt idx="442">
                  <c:v>128503.78376944667</c:v>
                </c:pt>
                <c:pt idx="443">
                  <c:v>128503.78376944667</c:v>
                </c:pt>
                <c:pt idx="444">
                  <c:v>6936.0522279788902</c:v>
                </c:pt>
                <c:pt idx="445">
                  <c:v>6936.0522279788902</c:v>
                </c:pt>
                <c:pt idx="446">
                  <c:v>0</c:v>
                </c:pt>
                <c:pt idx="447">
                  <c:v>6936.0522279788902</c:v>
                </c:pt>
                <c:pt idx="448">
                  <c:v>6936.0522279788902</c:v>
                </c:pt>
                <c:pt idx="449">
                  <c:v>0</c:v>
                </c:pt>
                <c:pt idx="450">
                  <c:v>6936.0522279788902</c:v>
                </c:pt>
                <c:pt idx="451">
                  <c:v>6936.0522279788902</c:v>
                </c:pt>
                <c:pt idx="452">
                  <c:v>128503.78376944667</c:v>
                </c:pt>
                <c:pt idx="453">
                  <c:v>128503.78376944667</c:v>
                </c:pt>
                <c:pt idx="454">
                  <c:v>62276.963772453171</c:v>
                </c:pt>
                <c:pt idx="455">
                  <c:v>62276.963772453171</c:v>
                </c:pt>
                <c:pt idx="456">
                  <c:v>7472.4382748687685</c:v>
                </c:pt>
                <c:pt idx="457">
                  <c:v>7472.4382748687685</c:v>
                </c:pt>
                <c:pt idx="458">
                  <c:v>443.16954288133405</c:v>
                </c:pt>
                <c:pt idx="459">
                  <c:v>443.16954288133405</c:v>
                </c:pt>
                <c:pt idx="460">
                  <c:v>0</c:v>
                </c:pt>
                <c:pt idx="461">
                  <c:v>443.16954288133405</c:v>
                </c:pt>
                <c:pt idx="462">
                  <c:v>443.16954288133405</c:v>
                </c:pt>
                <c:pt idx="463">
                  <c:v>293.37808844100704</c:v>
                </c:pt>
                <c:pt idx="464">
                  <c:v>293.37808844100704</c:v>
                </c:pt>
                <c:pt idx="465">
                  <c:v>0</c:v>
                </c:pt>
                <c:pt idx="466">
                  <c:v>293.37808844100704</c:v>
                </c:pt>
                <c:pt idx="467">
                  <c:v>293.37808844100704</c:v>
                </c:pt>
                <c:pt idx="468">
                  <c:v>58.907115998330148</c:v>
                </c:pt>
                <c:pt idx="469">
                  <c:v>58.907115998330148</c:v>
                </c:pt>
                <c:pt idx="470">
                  <c:v>0</c:v>
                </c:pt>
                <c:pt idx="471">
                  <c:v>58.907115998330148</c:v>
                </c:pt>
                <c:pt idx="472">
                  <c:v>58.907115998330148</c:v>
                </c:pt>
                <c:pt idx="473">
                  <c:v>0</c:v>
                </c:pt>
                <c:pt idx="474">
                  <c:v>58.907115998330148</c:v>
                </c:pt>
                <c:pt idx="475">
                  <c:v>58.907115998330148</c:v>
                </c:pt>
                <c:pt idx="476">
                  <c:v>293.37808844100704</c:v>
                </c:pt>
                <c:pt idx="477">
                  <c:v>293.37808844100704</c:v>
                </c:pt>
                <c:pt idx="478">
                  <c:v>443.16954288133405</c:v>
                </c:pt>
                <c:pt idx="479">
                  <c:v>443.16954288133405</c:v>
                </c:pt>
                <c:pt idx="480">
                  <c:v>7472.4382748687685</c:v>
                </c:pt>
                <c:pt idx="481">
                  <c:v>7472.4382748687685</c:v>
                </c:pt>
                <c:pt idx="482">
                  <c:v>1690.7383623213948</c:v>
                </c:pt>
                <c:pt idx="483">
                  <c:v>1690.7383623213948</c:v>
                </c:pt>
                <c:pt idx="484">
                  <c:v>0</c:v>
                </c:pt>
                <c:pt idx="485">
                  <c:v>1690.7383623213948</c:v>
                </c:pt>
                <c:pt idx="486">
                  <c:v>1690.7383623213948</c:v>
                </c:pt>
                <c:pt idx="487">
                  <c:v>0</c:v>
                </c:pt>
                <c:pt idx="488">
                  <c:v>1690.7383623213948</c:v>
                </c:pt>
                <c:pt idx="489">
                  <c:v>1690.7383623213948</c:v>
                </c:pt>
                <c:pt idx="490">
                  <c:v>7472.4382748687685</c:v>
                </c:pt>
                <c:pt idx="491">
                  <c:v>7472.4382748687685</c:v>
                </c:pt>
                <c:pt idx="492">
                  <c:v>62276.963772453171</c:v>
                </c:pt>
                <c:pt idx="493">
                  <c:v>62276.963772453171</c:v>
                </c:pt>
                <c:pt idx="494">
                  <c:v>17612.491555191442</c:v>
                </c:pt>
                <c:pt idx="495">
                  <c:v>17612.491555191442</c:v>
                </c:pt>
                <c:pt idx="496">
                  <c:v>3669.5907594755868</c:v>
                </c:pt>
                <c:pt idx="497">
                  <c:v>3669.5907594755868</c:v>
                </c:pt>
                <c:pt idx="498">
                  <c:v>289.13083632671766</c:v>
                </c:pt>
                <c:pt idx="499">
                  <c:v>289.13083632671766</c:v>
                </c:pt>
                <c:pt idx="500">
                  <c:v>0</c:v>
                </c:pt>
                <c:pt idx="501">
                  <c:v>289.13083632671766</c:v>
                </c:pt>
                <c:pt idx="502">
                  <c:v>289.13083632671766</c:v>
                </c:pt>
                <c:pt idx="503">
                  <c:v>0</c:v>
                </c:pt>
                <c:pt idx="504">
                  <c:v>289.13083632671766</c:v>
                </c:pt>
                <c:pt idx="505">
                  <c:v>289.13083632671766</c:v>
                </c:pt>
                <c:pt idx="506">
                  <c:v>3669.5907594755868</c:v>
                </c:pt>
                <c:pt idx="507">
                  <c:v>3669.5907594755868</c:v>
                </c:pt>
                <c:pt idx="508">
                  <c:v>1207.532544436709</c:v>
                </c:pt>
                <c:pt idx="509">
                  <c:v>1207.532544436709</c:v>
                </c:pt>
                <c:pt idx="510">
                  <c:v>0</c:v>
                </c:pt>
                <c:pt idx="511">
                  <c:v>1207.532544436709</c:v>
                </c:pt>
                <c:pt idx="512">
                  <c:v>1207.532544436709</c:v>
                </c:pt>
                <c:pt idx="513">
                  <c:v>195.6761333281905</c:v>
                </c:pt>
                <c:pt idx="514">
                  <c:v>195.6761333281905</c:v>
                </c:pt>
                <c:pt idx="515">
                  <c:v>0</c:v>
                </c:pt>
                <c:pt idx="516">
                  <c:v>195.6761333281905</c:v>
                </c:pt>
                <c:pt idx="517">
                  <c:v>195.6761333281905</c:v>
                </c:pt>
                <c:pt idx="518">
                  <c:v>0</c:v>
                </c:pt>
                <c:pt idx="519">
                  <c:v>195.6761333281905</c:v>
                </c:pt>
                <c:pt idx="520">
                  <c:v>195.6761333281905</c:v>
                </c:pt>
                <c:pt idx="521">
                  <c:v>1207.532544436709</c:v>
                </c:pt>
                <c:pt idx="522">
                  <c:v>1207.532544436709</c:v>
                </c:pt>
                <c:pt idx="523">
                  <c:v>3669.5907594755868</c:v>
                </c:pt>
                <c:pt idx="524">
                  <c:v>3669.5907594755868</c:v>
                </c:pt>
                <c:pt idx="525">
                  <c:v>17612.491555191442</c:v>
                </c:pt>
                <c:pt idx="526">
                  <c:v>17612.491555191442</c:v>
                </c:pt>
                <c:pt idx="527">
                  <c:v>6606.3287110711481</c:v>
                </c:pt>
                <c:pt idx="528">
                  <c:v>6606.3287110711481</c:v>
                </c:pt>
                <c:pt idx="529">
                  <c:v>0</c:v>
                </c:pt>
                <c:pt idx="530">
                  <c:v>6606.3287110711481</c:v>
                </c:pt>
                <c:pt idx="531">
                  <c:v>6606.3287110711481</c:v>
                </c:pt>
                <c:pt idx="532">
                  <c:v>2522.7963604547817</c:v>
                </c:pt>
                <c:pt idx="533">
                  <c:v>2522.7963604547817</c:v>
                </c:pt>
                <c:pt idx="534">
                  <c:v>213.81082632902209</c:v>
                </c:pt>
                <c:pt idx="535">
                  <c:v>213.81082632902209</c:v>
                </c:pt>
                <c:pt idx="536">
                  <c:v>0</c:v>
                </c:pt>
                <c:pt idx="537">
                  <c:v>213.81082632902209</c:v>
                </c:pt>
                <c:pt idx="538">
                  <c:v>213.81082632902209</c:v>
                </c:pt>
                <c:pt idx="539">
                  <c:v>0</c:v>
                </c:pt>
                <c:pt idx="540">
                  <c:v>213.81082632902209</c:v>
                </c:pt>
                <c:pt idx="541">
                  <c:v>213.81082632902209</c:v>
                </c:pt>
                <c:pt idx="542">
                  <c:v>2522.7963604547817</c:v>
                </c:pt>
                <c:pt idx="543">
                  <c:v>2522.7963604547817</c:v>
                </c:pt>
                <c:pt idx="544">
                  <c:v>766.94182533042112</c:v>
                </c:pt>
                <c:pt idx="545">
                  <c:v>766.94182533042112</c:v>
                </c:pt>
                <c:pt idx="546">
                  <c:v>0</c:v>
                </c:pt>
                <c:pt idx="547">
                  <c:v>766.94182533042112</c:v>
                </c:pt>
                <c:pt idx="548">
                  <c:v>766.94182533042112</c:v>
                </c:pt>
                <c:pt idx="549">
                  <c:v>201.28556932856557</c:v>
                </c:pt>
                <c:pt idx="550">
                  <c:v>201.28556932856557</c:v>
                </c:pt>
                <c:pt idx="551">
                  <c:v>0</c:v>
                </c:pt>
                <c:pt idx="552">
                  <c:v>201.28556932856557</c:v>
                </c:pt>
                <c:pt idx="553">
                  <c:v>201.28556932856557</c:v>
                </c:pt>
                <c:pt idx="554">
                  <c:v>0</c:v>
                </c:pt>
                <c:pt idx="555">
                  <c:v>201.28556932856557</c:v>
                </c:pt>
                <c:pt idx="556">
                  <c:v>201.28556932856557</c:v>
                </c:pt>
                <c:pt idx="557">
                  <c:v>766.94182533042112</c:v>
                </c:pt>
                <c:pt idx="558">
                  <c:v>766.94182533042112</c:v>
                </c:pt>
                <c:pt idx="559">
                  <c:v>2522.7963604547817</c:v>
                </c:pt>
                <c:pt idx="560">
                  <c:v>2522.7963604547817</c:v>
                </c:pt>
                <c:pt idx="561">
                  <c:v>6606.3287110711481</c:v>
                </c:pt>
                <c:pt idx="562">
                  <c:v>6606.3287110711481</c:v>
                </c:pt>
                <c:pt idx="563">
                  <c:v>17612.491555191442</c:v>
                </c:pt>
                <c:pt idx="564">
                  <c:v>17612.491555191442</c:v>
                </c:pt>
                <c:pt idx="565">
                  <c:v>62276.963772453171</c:v>
                </c:pt>
                <c:pt idx="566">
                  <c:v>62276.963772453171</c:v>
                </c:pt>
                <c:pt idx="567">
                  <c:v>128503.78376944667</c:v>
                </c:pt>
                <c:pt idx="568">
                  <c:v>128503.78376944667</c:v>
                </c:pt>
                <c:pt idx="569">
                  <c:v>1927243.1893264481</c:v>
                </c:pt>
                <c:pt idx="570">
                  <c:v>1927243.1893264481</c:v>
                </c:pt>
                <c:pt idx="571">
                  <c:v>377798.14037419687</c:v>
                </c:pt>
                <c:pt idx="572">
                  <c:v>377798.14037419687</c:v>
                </c:pt>
                <c:pt idx="573">
                  <c:v>188111.61008468439</c:v>
                </c:pt>
                <c:pt idx="574">
                  <c:v>188111.61008468439</c:v>
                </c:pt>
                <c:pt idx="575">
                  <c:v>24815.380801265979</c:v>
                </c:pt>
                <c:pt idx="576">
                  <c:v>24815.380801265979</c:v>
                </c:pt>
                <c:pt idx="577">
                  <c:v>4381.4073379786932</c:v>
                </c:pt>
                <c:pt idx="578">
                  <c:v>4381.4073379786932</c:v>
                </c:pt>
                <c:pt idx="579">
                  <c:v>619.44649899289027</c:v>
                </c:pt>
                <c:pt idx="580">
                  <c:v>619.44649899289027</c:v>
                </c:pt>
                <c:pt idx="581">
                  <c:v>0</c:v>
                </c:pt>
                <c:pt idx="582">
                  <c:v>619.44649899289027</c:v>
                </c:pt>
                <c:pt idx="583">
                  <c:v>619.44649899289027</c:v>
                </c:pt>
                <c:pt idx="584">
                  <c:v>593.89044632560945</c:v>
                </c:pt>
                <c:pt idx="585">
                  <c:v>593.89044632560945</c:v>
                </c:pt>
                <c:pt idx="586">
                  <c:v>0</c:v>
                </c:pt>
                <c:pt idx="587">
                  <c:v>593.89044632560945</c:v>
                </c:pt>
                <c:pt idx="588">
                  <c:v>593.89044632560945</c:v>
                </c:pt>
                <c:pt idx="589">
                  <c:v>0</c:v>
                </c:pt>
                <c:pt idx="590">
                  <c:v>593.89044632560945</c:v>
                </c:pt>
                <c:pt idx="591">
                  <c:v>593.89044632560945</c:v>
                </c:pt>
                <c:pt idx="592">
                  <c:v>619.44649899289027</c:v>
                </c:pt>
                <c:pt idx="593">
                  <c:v>619.44649899289027</c:v>
                </c:pt>
                <c:pt idx="594">
                  <c:v>4381.4073379786932</c:v>
                </c:pt>
                <c:pt idx="595">
                  <c:v>4381.4073379786932</c:v>
                </c:pt>
                <c:pt idx="596">
                  <c:v>1339.2768686583361</c:v>
                </c:pt>
                <c:pt idx="597">
                  <c:v>1339.2768686583361</c:v>
                </c:pt>
                <c:pt idx="598">
                  <c:v>0</c:v>
                </c:pt>
                <c:pt idx="599">
                  <c:v>1339.2768686583361</c:v>
                </c:pt>
                <c:pt idx="600">
                  <c:v>1339.2768686583361</c:v>
                </c:pt>
                <c:pt idx="601">
                  <c:v>302.05806533154049</c:v>
                </c:pt>
                <c:pt idx="602">
                  <c:v>302.05806533154049</c:v>
                </c:pt>
                <c:pt idx="603">
                  <c:v>0</c:v>
                </c:pt>
                <c:pt idx="604">
                  <c:v>302.05806533154049</c:v>
                </c:pt>
                <c:pt idx="605">
                  <c:v>302.05806533154049</c:v>
                </c:pt>
                <c:pt idx="606">
                  <c:v>44.126867998225286</c:v>
                </c:pt>
                <c:pt idx="607">
                  <c:v>44.126867998225286</c:v>
                </c:pt>
                <c:pt idx="608">
                  <c:v>0</c:v>
                </c:pt>
                <c:pt idx="609">
                  <c:v>44.126867998225286</c:v>
                </c:pt>
                <c:pt idx="610">
                  <c:v>44.126867998225286</c:v>
                </c:pt>
                <c:pt idx="611">
                  <c:v>0</c:v>
                </c:pt>
                <c:pt idx="612">
                  <c:v>44.126867998225286</c:v>
                </c:pt>
                <c:pt idx="613">
                  <c:v>44.126867998225286</c:v>
                </c:pt>
                <c:pt idx="614">
                  <c:v>302.05806533154049</c:v>
                </c:pt>
                <c:pt idx="615">
                  <c:v>302.05806533154049</c:v>
                </c:pt>
                <c:pt idx="616">
                  <c:v>1339.2768686583361</c:v>
                </c:pt>
                <c:pt idx="617">
                  <c:v>1339.2768686583361</c:v>
                </c:pt>
                <c:pt idx="618">
                  <c:v>4381.4073379786932</c:v>
                </c:pt>
                <c:pt idx="619">
                  <c:v>4381.4073379786932</c:v>
                </c:pt>
                <c:pt idx="620">
                  <c:v>24815.380801265979</c:v>
                </c:pt>
                <c:pt idx="621">
                  <c:v>24815.380801265979</c:v>
                </c:pt>
                <c:pt idx="622">
                  <c:v>8933.6958245715578</c:v>
                </c:pt>
                <c:pt idx="623">
                  <c:v>8933.6958245715578</c:v>
                </c:pt>
                <c:pt idx="624">
                  <c:v>971.87625790501738</c:v>
                </c:pt>
                <c:pt idx="625">
                  <c:v>971.87625790501738</c:v>
                </c:pt>
                <c:pt idx="626">
                  <c:v>139.34284544162389</c:v>
                </c:pt>
                <c:pt idx="627">
                  <c:v>139.34284544162389</c:v>
                </c:pt>
                <c:pt idx="628">
                  <c:v>0</c:v>
                </c:pt>
                <c:pt idx="629">
                  <c:v>139.34284544162389</c:v>
                </c:pt>
                <c:pt idx="630">
                  <c:v>139.34284544162389</c:v>
                </c:pt>
                <c:pt idx="631">
                  <c:v>4.4088249995285471</c:v>
                </c:pt>
                <c:pt idx="632">
                  <c:v>4.4088249995285471</c:v>
                </c:pt>
                <c:pt idx="633">
                  <c:v>0</c:v>
                </c:pt>
                <c:pt idx="634">
                  <c:v>4.4088249995285471</c:v>
                </c:pt>
                <c:pt idx="635">
                  <c:v>4.4088249995285471</c:v>
                </c:pt>
                <c:pt idx="636">
                  <c:v>0</c:v>
                </c:pt>
                <c:pt idx="637">
                  <c:v>4.4088249995285471</c:v>
                </c:pt>
                <c:pt idx="638">
                  <c:v>4.4088249995285471</c:v>
                </c:pt>
                <c:pt idx="639">
                  <c:v>139.34284544162389</c:v>
                </c:pt>
                <c:pt idx="640">
                  <c:v>139.34284544162389</c:v>
                </c:pt>
                <c:pt idx="641">
                  <c:v>971.87625790501738</c:v>
                </c:pt>
                <c:pt idx="642">
                  <c:v>971.87625790501738</c:v>
                </c:pt>
                <c:pt idx="643">
                  <c:v>280.13422849449029</c:v>
                </c:pt>
                <c:pt idx="644">
                  <c:v>280.13422849449029</c:v>
                </c:pt>
                <c:pt idx="645">
                  <c:v>30.531852333308169</c:v>
                </c:pt>
                <c:pt idx="646">
                  <c:v>30.531852333308169</c:v>
                </c:pt>
                <c:pt idx="647">
                  <c:v>0</c:v>
                </c:pt>
                <c:pt idx="648">
                  <c:v>30.531852333308169</c:v>
                </c:pt>
                <c:pt idx="649">
                  <c:v>30.531852333308169</c:v>
                </c:pt>
                <c:pt idx="650">
                  <c:v>0</c:v>
                </c:pt>
                <c:pt idx="651">
                  <c:v>30.531852333308169</c:v>
                </c:pt>
                <c:pt idx="652">
                  <c:v>30.531852333308169</c:v>
                </c:pt>
                <c:pt idx="653">
                  <c:v>280.13422849449029</c:v>
                </c:pt>
                <c:pt idx="654">
                  <c:v>280.13422849449029</c:v>
                </c:pt>
                <c:pt idx="655">
                  <c:v>37.987384330922275</c:v>
                </c:pt>
                <c:pt idx="656">
                  <c:v>37.987384330922275</c:v>
                </c:pt>
                <c:pt idx="657">
                  <c:v>0</c:v>
                </c:pt>
                <c:pt idx="658">
                  <c:v>37.987384330922275</c:v>
                </c:pt>
                <c:pt idx="659">
                  <c:v>37.987384330922275</c:v>
                </c:pt>
                <c:pt idx="660">
                  <c:v>0</c:v>
                </c:pt>
                <c:pt idx="661">
                  <c:v>37.987384330922275</c:v>
                </c:pt>
                <c:pt idx="662">
                  <c:v>37.987384330922275</c:v>
                </c:pt>
                <c:pt idx="663">
                  <c:v>280.13422849449029</c:v>
                </c:pt>
                <c:pt idx="664">
                  <c:v>280.13422849449029</c:v>
                </c:pt>
                <c:pt idx="665">
                  <c:v>971.87625790501738</c:v>
                </c:pt>
                <c:pt idx="666">
                  <c:v>971.87625790501738</c:v>
                </c:pt>
                <c:pt idx="667">
                  <c:v>8933.6958245715578</c:v>
                </c:pt>
                <c:pt idx="668">
                  <c:v>8933.6958245715578</c:v>
                </c:pt>
                <c:pt idx="669">
                  <c:v>2256.1794363319368</c:v>
                </c:pt>
                <c:pt idx="670">
                  <c:v>2256.1794363319368</c:v>
                </c:pt>
                <c:pt idx="671">
                  <c:v>0</c:v>
                </c:pt>
                <c:pt idx="672">
                  <c:v>2256.1794363319368</c:v>
                </c:pt>
                <c:pt idx="673">
                  <c:v>2256.1794363319368</c:v>
                </c:pt>
                <c:pt idx="674">
                  <c:v>719.38898032955558</c:v>
                </c:pt>
                <c:pt idx="675">
                  <c:v>719.38898032955558</c:v>
                </c:pt>
                <c:pt idx="676">
                  <c:v>0</c:v>
                </c:pt>
                <c:pt idx="677">
                  <c:v>719.38898032955558</c:v>
                </c:pt>
                <c:pt idx="678">
                  <c:v>719.38898032955558</c:v>
                </c:pt>
                <c:pt idx="679">
                  <c:v>0</c:v>
                </c:pt>
                <c:pt idx="680">
                  <c:v>719.38898032955558</c:v>
                </c:pt>
                <c:pt idx="681">
                  <c:v>719.38898032955558</c:v>
                </c:pt>
                <c:pt idx="682">
                  <c:v>2256.1794363319368</c:v>
                </c:pt>
                <c:pt idx="683">
                  <c:v>2256.1794363319368</c:v>
                </c:pt>
                <c:pt idx="684">
                  <c:v>8933.6958245715578</c:v>
                </c:pt>
                <c:pt idx="685">
                  <c:v>8933.6958245715578</c:v>
                </c:pt>
                <c:pt idx="686">
                  <c:v>24815.380801265979</c:v>
                </c:pt>
                <c:pt idx="687">
                  <c:v>24815.380801265979</c:v>
                </c:pt>
                <c:pt idx="688">
                  <c:v>188111.61008468439</c:v>
                </c:pt>
                <c:pt idx="689">
                  <c:v>188111.61008468439</c:v>
                </c:pt>
                <c:pt idx="690">
                  <c:v>47073.116932240933</c:v>
                </c:pt>
                <c:pt idx="691">
                  <c:v>47073.116932240933</c:v>
                </c:pt>
                <c:pt idx="692">
                  <c:v>0</c:v>
                </c:pt>
                <c:pt idx="693">
                  <c:v>47073.116932240933</c:v>
                </c:pt>
                <c:pt idx="694">
                  <c:v>47073.116932240933</c:v>
                </c:pt>
                <c:pt idx="695">
                  <c:v>14943.489523030676</c:v>
                </c:pt>
                <c:pt idx="696">
                  <c:v>14943.489523030676</c:v>
                </c:pt>
                <c:pt idx="697">
                  <c:v>2444.965440764398</c:v>
                </c:pt>
                <c:pt idx="698">
                  <c:v>2444.965440764398</c:v>
                </c:pt>
                <c:pt idx="699">
                  <c:v>0</c:v>
                </c:pt>
                <c:pt idx="700">
                  <c:v>2444.965440764398</c:v>
                </c:pt>
                <c:pt idx="701">
                  <c:v>2444.965440764398</c:v>
                </c:pt>
                <c:pt idx="702">
                  <c:v>339.86118899948349</c:v>
                </c:pt>
                <c:pt idx="703">
                  <c:v>339.86118899948349</c:v>
                </c:pt>
                <c:pt idx="704">
                  <c:v>0</c:v>
                </c:pt>
                <c:pt idx="705">
                  <c:v>339.86118899948349</c:v>
                </c:pt>
                <c:pt idx="706">
                  <c:v>339.86118899948349</c:v>
                </c:pt>
                <c:pt idx="707">
                  <c:v>0</c:v>
                </c:pt>
                <c:pt idx="708">
                  <c:v>339.86118899948349</c:v>
                </c:pt>
                <c:pt idx="709">
                  <c:v>339.86118899948349</c:v>
                </c:pt>
                <c:pt idx="710">
                  <c:v>2444.965440764398</c:v>
                </c:pt>
                <c:pt idx="711">
                  <c:v>2444.965440764398</c:v>
                </c:pt>
                <c:pt idx="712">
                  <c:v>14943.489523030676</c:v>
                </c:pt>
                <c:pt idx="713">
                  <c:v>14943.489523030676</c:v>
                </c:pt>
                <c:pt idx="714">
                  <c:v>7292.2274323281817</c:v>
                </c:pt>
                <c:pt idx="715">
                  <c:v>7292.2274323281817</c:v>
                </c:pt>
                <c:pt idx="716">
                  <c:v>710.95825614447301</c:v>
                </c:pt>
                <c:pt idx="717">
                  <c:v>710.95825614447301</c:v>
                </c:pt>
                <c:pt idx="718">
                  <c:v>150.86317299666584</c:v>
                </c:pt>
                <c:pt idx="719">
                  <c:v>150.86317299666584</c:v>
                </c:pt>
                <c:pt idx="720">
                  <c:v>0</c:v>
                </c:pt>
                <c:pt idx="721">
                  <c:v>150.86317299666584</c:v>
                </c:pt>
                <c:pt idx="722">
                  <c:v>150.86317299666584</c:v>
                </c:pt>
                <c:pt idx="723">
                  <c:v>0</c:v>
                </c:pt>
                <c:pt idx="724">
                  <c:v>150.86317299666584</c:v>
                </c:pt>
                <c:pt idx="725">
                  <c:v>150.86317299666584</c:v>
                </c:pt>
                <c:pt idx="726">
                  <c:v>710.95825614447301</c:v>
                </c:pt>
                <c:pt idx="727">
                  <c:v>710.95825614447301</c:v>
                </c:pt>
                <c:pt idx="728">
                  <c:v>323.96325811004789</c:v>
                </c:pt>
                <c:pt idx="729">
                  <c:v>323.96325811004789</c:v>
                </c:pt>
                <c:pt idx="730">
                  <c:v>0</c:v>
                </c:pt>
                <c:pt idx="731">
                  <c:v>323.96325811004789</c:v>
                </c:pt>
                <c:pt idx="732">
                  <c:v>323.96325811004789</c:v>
                </c:pt>
                <c:pt idx="733">
                  <c:v>48.653990333101483</c:v>
                </c:pt>
                <c:pt idx="734">
                  <c:v>48.653990333101483</c:v>
                </c:pt>
                <c:pt idx="735">
                  <c:v>0</c:v>
                </c:pt>
                <c:pt idx="736">
                  <c:v>48.653990333101483</c:v>
                </c:pt>
                <c:pt idx="737">
                  <c:v>48.653990333101483</c:v>
                </c:pt>
                <c:pt idx="738">
                  <c:v>0</c:v>
                </c:pt>
                <c:pt idx="739">
                  <c:v>48.653990333101483</c:v>
                </c:pt>
                <c:pt idx="740">
                  <c:v>48.653990333101483</c:v>
                </c:pt>
                <c:pt idx="741">
                  <c:v>323.96325811004789</c:v>
                </c:pt>
                <c:pt idx="742">
                  <c:v>323.96325811004789</c:v>
                </c:pt>
                <c:pt idx="743">
                  <c:v>710.95825614447301</c:v>
                </c:pt>
                <c:pt idx="744">
                  <c:v>710.95825614447301</c:v>
                </c:pt>
                <c:pt idx="745">
                  <c:v>7292.2274323281817</c:v>
                </c:pt>
                <c:pt idx="746">
                  <c:v>7292.2274323281817</c:v>
                </c:pt>
                <c:pt idx="747">
                  <c:v>1274.7306203326405</c:v>
                </c:pt>
                <c:pt idx="748">
                  <c:v>1274.7306203326405</c:v>
                </c:pt>
                <c:pt idx="749">
                  <c:v>0</c:v>
                </c:pt>
                <c:pt idx="750">
                  <c:v>1274.7306203326405</c:v>
                </c:pt>
                <c:pt idx="751">
                  <c:v>1274.7306203326405</c:v>
                </c:pt>
                <c:pt idx="752">
                  <c:v>0</c:v>
                </c:pt>
                <c:pt idx="753">
                  <c:v>1274.7306203326405</c:v>
                </c:pt>
                <c:pt idx="754">
                  <c:v>1274.7306203326405</c:v>
                </c:pt>
                <c:pt idx="755">
                  <c:v>7292.2274323281817</c:v>
                </c:pt>
                <c:pt idx="756">
                  <c:v>7292.2274323281817</c:v>
                </c:pt>
                <c:pt idx="757">
                  <c:v>14943.489523030676</c:v>
                </c:pt>
                <c:pt idx="758">
                  <c:v>14943.489523030676</c:v>
                </c:pt>
                <c:pt idx="759">
                  <c:v>47073.116932240933</c:v>
                </c:pt>
                <c:pt idx="760">
                  <c:v>47073.116932240933</c:v>
                </c:pt>
                <c:pt idx="761">
                  <c:v>188111.61008468439</c:v>
                </c:pt>
                <c:pt idx="762">
                  <c:v>188111.61008468439</c:v>
                </c:pt>
                <c:pt idx="763">
                  <c:v>377798.14037419687</c:v>
                </c:pt>
                <c:pt idx="764">
                  <c:v>377798.14037419687</c:v>
                </c:pt>
                <c:pt idx="765">
                  <c:v>200621.29612376681</c:v>
                </c:pt>
                <c:pt idx="766">
                  <c:v>200621.29612376681</c:v>
                </c:pt>
                <c:pt idx="767">
                  <c:v>55062.659164385281</c:v>
                </c:pt>
                <c:pt idx="768">
                  <c:v>55062.659164385281</c:v>
                </c:pt>
                <c:pt idx="769">
                  <c:v>0</c:v>
                </c:pt>
                <c:pt idx="770">
                  <c:v>55062.659164385281</c:v>
                </c:pt>
                <c:pt idx="771">
                  <c:v>55062.659164385281</c:v>
                </c:pt>
                <c:pt idx="772">
                  <c:v>9135.8948014146554</c:v>
                </c:pt>
                <c:pt idx="773">
                  <c:v>9135.8948014146554</c:v>
                </c:pt>
                <c:pt idx="774">
                  <c:v>603.08083632766488</c:v>
                </c:pt>
                <c:pt idx="775">
                  <c:v>603.08083632766488</c:v>
                </c:pt>
                <c:pt idx="776">
                  <c:v>0</c:v>
                </c:pt>
                <c:pt idx="777">
                  <c:v>603.08083632766488</c:v>
                </c:pt>
                <c:pt idx="778">
                  <c:v>603.08083632766488</c:v>
                </c:pt>
                <c:pt idx="779">
                  <c:v>0</c:v>
                </c:pt>
                <c:pt idx="780">
                  <c:v>603.08083632766488</c:v>
                </c:pt>
                <c:pt idx="781">
                  <c:v>603.08083632766488</c:v>
                </c:pt>
                <c:pt idx="782">
                  <c:v>9135.8948014146554</c:v>
                </c:pt>
                <c:pt idx="783">
                  <c:v>9135.8948014146554</c:v>
                </c:pt>
                <c:pt idx="784">
                  <c:v>4551.8613452912232</c:v>
                </c:pt>
                <c:pt idx="785">
                  <c:v>4551.8613452912232</c:v>
                </c:pt>
                <c:pt idx="786">
                  <c:v>0</c:v>
                </c:pt>
                <c:pt idx="787">
                  <c:v>4551.8613452912232</c:v>
                </c:pt>
                <c:pt idx="788">
                  <c:v>4551.8613452912232</c:v>
                </c:pt>
                <c:pt idx="789">
                  <c:v>1090.4676334916614</c:v>
                </c:pt>
                <c:pt idx="790">
                  <c:v>1090.4676334916614</c:v>
                </c:pt>
                <c:pt idx="791">
                  <c:v>0</c:v>
                </c:pt>
                <c:pt idx="792">
                  <c:v>1090.4676334916614</c:v>
                </c:pt>
                <c:pt idx="793">
                  <c:v>1090.4676334916614</c:v>
                </c:pt>
                <c:pt idx="794">
                  <c:v>636.07131099468916</c:v>
                </c:pt>
                <c:pt idx="795">
                  <c:v>636.07131099468916</c:v>
                </c:pt>
                <c:pt idx="796">
                  <c:v>0</c:v>
                </c:pt>
                <c:pt idx="797">
                  <c:v>636.07131099468916</c:v>
                </c:pt>
                <c:pt idx="798">
                  <c:v>636.07131099468916</c:v>
                </c:pt>
                <c:pt idx="799">
                  <c:v>290.96112899777944</c:v>
                </c:pt>
                <c:pt idx="800">
                  <c:v>290.96112899777944</c:v>
                </c:pt>
                <c:pt idx="801">
                  <c:v>0</c:v>
                </c:pt>
                <c:pt idx="802">
                  <c:v>290.96112899777944</c:v>
                </c:pt>
                <c:pt idx="803">
                  <c:v>290.96112899777944</c:v>
                </c:pt>
                <c:pt idx="804">
                  <c:v>0</c:v>
                </c:pt>
                <c:pt idx="805">
                  <c:v>290.96112899777944</c:v>
                </c:pt>
                <c:pt idx="806">
                  <c:v>290.96112899777944</c:v>
                </c:pt>
                <c:pt idx="807">
                  <c:v>636.07131099468916</c:v>
                </c:pt>
                <c:pt idx="808">
                  <c:v>636.07131099468916</c:v>
                </c:pt>
                <c:pt idx="809">
                  <c:v>1090.4676334916614</c:v>
                </c:pt>
                <c:pt idx="810">
                  <c:v>1090.4676334916614</c:v>
                </c:pt>
                <c:pt idx="811">
                  <c:v>4551.8613452912232</c:v>
                </c:pt>
                <c:pt idx="812">
                  <c:v>4551.8613452912232</c:v>
                </c:pt>
                <c:pt idx="813">
                  <c:v>9135.8948014146554</c:v>
                </c:pt>
                <c:pt idx="814">
                  <c:v>9135.8948014146554</c:v>
                </c:pt>
                <c:pt idx="815">
                  <c:v>55062.659164385281</c:v>
                </c:pt>
                <c:pt idx="816">
                  <c:v>55062.659164385281</c:v>
                </c:pt>
                <c:pt idx="817">
                  <c:v>200621.29612376681</c:v>
                </c:pt>
                <c:pt idx="818">
                  <c:v>200621.29612376681</c:v>
                </c:pt>
                <c:pt idx="819">
                  <c:v>86654.22770028995</c:v>
                </c:pt>
                <c:pt idx="820">
                  <c:v>86654.22770028995</c:v>
                </c:pt>
                <c:pt idx="821">
                  <c:v>16332.759332121666</c:v>
                </c:pt>
                <c:pt idx="822">
                  <c:v>16332.759332121666</c:v>
                </c:pt>
                <c:pt idx="823">
                  <c:v>3831.0365181460247</c:v>
                </c:pt>
                <c:pt idx="824">
                  <c:v>3831.0365181460247</c:v>
                </c:pt>
                <c:pt idx="825">
                  <c:v>196.33627316550442</c:v>
                </c:pt>
                <c:pt idx="826">
                  <c:v>196.33627316550442</c:v>
                </c:pt>
                <c:pt idx="827">
                  <c:v>23.224710999676571</c:v>
                </c:pt>
                <c:pt idx="828">
                  <c:v>23.224710999676571</c:v>
                </c:pt>
                <c:pt idx="829">
                  <c:v>0</c:v>
                </c:pt>
                <c:pt idx="830">
                  <c:v>23.224710999676571</c:v>
                </c:pt>
                <c:pt idx="831">
                  <c:v>23.224710999676571</c:v>
                </c:pt>
                <c:pt idx="832">
                  <c:v>0</c:v>
                </c:pt>
                <c:pt idx="833">
                  <c:v>23.224710999676571</c:v>
                </c:pt>
                <c:pt idx="834">
                  <c:v>23.224710999676571</c:v>
                </c:pt>
                <c:pt idx="835">
                  <c:v>196.33627316550442</c:v>
                </c:pt>
                <c:pt idx="836">
                  <c:v>196.33627316550442</c:v>
                </c:pt>
                <c:pt idx="837">
                  <c:v>58.409474331487267</c:v>
                </c:pt>
                <c:pt idx="838">
                  <c:v>58.409474331487267</c:v>
                </c:pt>
                <c:pt idx="839">
                  <c:v>0</c:v>
                </c:pt>
                <c:pt idx="840">
                  <c:v>58.409474331487267</c:v>
                </c:pt>
                <c:pt idx="841">
                  <c:v>58.409474331487267</c:v>
                </c:pt>
                <c:pt idx="842">
                  <c:v>0</c:v>
                </c:pt>
                <c:pt idx="843">
                  <c:v>58.409474331487267</c:v>
                </c:pt>
                <c:pt idx="844">
                  <c:v>58.409474331487267</c:v>
                </c:pt>
                <c:pt idx="845">
                  <c:v>196.33627316550442</c:v>
                </c:pt>
                <c:pt idx="846">
                  <c:v>196.33627316550442</c:v>
                </c:pt>
                <c:pt idx="847">
                  <c:v>3831.0365181460247</c:v>
                </c:pt>
                <c:pt idx="848">
                  <c:v>3831.0365181460247</c:v>
                </c:pt>
                <c:pt idx="849">
                  <c:v>1029.8859003257453</c:v>
                </c:pt>
                <c:pt idx="850">
                  <c:v>1029.8859003257453</c:v>
                </c:pt>
                <c:pt idx="851">
                  <c:v>0</c:v>
                </c:pt>
                <c:pt idx="852">
                  <c:v>1029.8859003257453</c:v>
                </c:pt>
                <c:pt idx="853">
                  <c:v>1029.8859003257453</c:v>
                </c:pt>
                <c:pt idx="854">
                  <c:v>379.07479632627468</c:v>
                </c:pt>
                <c:pt idx="855">
                  <c:v>379.07479632627468</c:v>
                </c:pt>
                <c:pt idx="856">
                  <c:v>0</c:v>
                </c:pt>
                <c:pt idx="857">
                  <c:v>379.07479632627468</c:v>
                </c:pt>
                <c:pt idx="858">
                  <c:v>379.07479632627468</c:v>
                </c:pt>
                <c:pt idx="859">
                  <c:v>0</c:v>
                </c:pt>
                <c:pt idx="860">
                  <c:v>379.07479632627468</c:v>
                </c:pt>
                <c:pt idx="861">
                  <c:v>379.07479632627468</c:v>
                </c:pt>
                <c:pt idx="862">
                  <c:v>1029.8859003257453</c:v>
                </c:pt>
                <c:pt idx="863">
                  <c:v>1029.8859003257453</c:v>
                </c:pt>
                <c:pt idx="864">
                  <c:v>3831.0365181460247</c:v>
                </c:pt>
                <c:pt idx="865">
                  <c:v>3831.0365181460247</c:v>
                </c:pt>
                <c:pt idx="866">
                  <c:v>16332.759332121666</c:v>
                </c:pt>
                <c:pt idx="867">
                  <c:v>16332.759332121666</c:v>
                </c:pt>
                <c:pt idx="868">
                  <c:v>7801.4757201424836</c:v>
                </c:pt>
                <c:pt idx="869">
                  <c:v>7801.4757201424836</c:v>
                </c:pt>
                <c:pt idx="870">
                  <c:v>0</c:v>
                </c:pt>
                <c:pt idx="871">
                  <c:v>7801.4757201424836</c:v>
                </c:pt>
                <c:pt idx="872">
                  <c:v>7801.4757201424836</c:v>
                </c:pt>
                <c:pt idx="873">
                  <c:v>717.78829006004366</c:v>
                </c:pt>
                <c:pt idx="874">
                  <c:v>717.78829006004366</c:v>
                </c:pt>
                <c:pt idx="875">
                  <c:v>29.166596333314693</c:v>
                </c:pt>
                <c:pt idx="876">
                  <c:v>29.166596333314693</c:v>
                </c:pt>
                <c:pt idx="877">
                  <c:v>0</c:v>
                </c:pt>
                <c:pt idx="878">
                  <c:v>29.166596333314693</c:v>
                </c:pt>
                <c:pt idx="879">
                  <c:v>29.166596333314693</c:v>
                </c:pt>
                <c:pt idx="880">
                  <c:v>0</c:v>
                </c:pt>
                <c:pt idx="881">
                  <c:v>29.166596333314693</c:v>
                </c:pt>
                <c:pt idx="882">
                  <c:v>29.166596333314693</c:v>
                </c:pt>
                <c:pt idx="883">
                  <c:v>717.78829006004366</c:v>
                </c:pt>
                <c:pt idx="884">
                  <c:v>717.78829006004366</c:v>
                </c:pt>
                <c:pt idx="885">
                  <c:v>222.82661733066902</c:v>
                </c:pt>
                <c:pt idx="886">
                  <c:v>222.82661733066902</c:v>
                </c:pt>
                <c:pt idx="887">
                  <c:v>0</c:v>
                </c:pt>
                <c:pt idx="888">
                  <c:v>222.82661733066902</c:v>
                </c:pt>
                <c:pt idx="889">
                  <c:v>222.82661733066902</c:v>
                </c:pt>
                <c:pt idx="890">
                  <c:v>100.78009599787853</c:v>
                </c:pt>
                <c:pt idx="891">
                  <c:v>100.78009599787853</c:v>
                </c:pt>
                <c:pt idx="892">
                  <c:v>0</c:v>
                </c:pt>
                <c:pt idx="893">
                  <c:v>100.78009599787853</c:v>
                </c:pt>
                <c:pt idx="894">
                  <c:v>100.78009599787853</c:v>
                </c:pt>
                <c:pt idx="895">
                  <c:v>0</c:v>
                </c:pt>
                <c:pt idx="896">
                  <c:v>100.78009599787853</c:v>
                </c:pt>
                <c:pt idx="897">
                  <c:v>100.78009599787853</c:v>
                </c:pt>
                <c:pt idx="898">
                  <c:v>222.82661733066902</c:v>
                </c:pt>
                <c:pt idx="899">
                  <c:v>222.82661733066902</c:v>
                </c:pt>
                <c:pt idx="900">
                  <c:v>717.78829006004366</c:v>
                </c:pt>
                <c:pt idx="901">
                  <c:v>717.78829006004366</c:v>
                </c:pt>
                <c:pt idx="902">
                  <c:v>7801.4757201424836</c:v>
                </c:pt>
                <c:pt idx="903">
                  <c:v>7801.4757201424836</c:v>
                </c:pt>
                <c:pt idx="904">
                  <c:v>16332.759332121666</c:v>
                </c:pt>
                <c:pt idx="905">
                  <c:v>16332.759332121666</c:v>
                </c:pt>
                <c:pt idx="906">
                  <c:v>86654.22770028995</c:v>
                </c:pt>
                <c:pt idx="907">
                  <c:v>86654.22770028995</c:v>
                </c:pt>
                <c:pt idx="908">
                  <c:v>39475.474459660378</c:v>
                </c:pt>
                <c:pt idx="909">
                  <c:v>39475.474459660378</c:v>
                </c:pt>
                <c:pt idx="910">
                  <c:v>7039.6338841376783</c:v>
                </c:pt>
                <c:pt idx="911">
                  <c:v>7039.6338841376783</c:v>
                </c:pt>
                <c:pt idx="912">
                  <c:v>1779.3397060011646</c:v>
                </c:pt>
                <c:pt idx="913">
                  <c:v>1779.3397060011646</c:v>
                </c:pt>
                <c:pt idx="914">
                  <c:v>103.93571233207048</c:v>
                </c:pt>
                <c:pt idx="915">
                  <c:v>103.93571233207048</c:v>
                </c:pt>
                <c:pt idx="916">
                  <c:v>0</c:v>
                </c:pt>
                <c:pt idx="917">
                  <c:v>103.93571233207048</c:v>
                </c:pt>
                <c:pt idx="918">
                  <c:v>103.93571233207048</c:v>
                </c:pt>
                <c:pt idx="919">
                  <c:v>0</c:v>
                </c:pt>
                <c:pt idx="920">
                  <c:v>103.93571233207048</c:v>
                </c:pt>
                <c:pt idx="921">
                  <c:v>103.93571233207048</c:v>
                </c:pt>
                <c:pt idx="922">
                  <c:v>1779.3397060011646</c:v>
                </c:pt>
                <c:pt idx="923">
                  <c:v>1779.3397060011646</c:v>
                </c:pt>
                <c:pt idx="924">
                  <c:v>771.11947234778381</c:v>
                </c:pt>
                <c:pt idx="925">
                  <c:v>771.11947234778381</c:v>
                </c:pt>
                <c:pt idx="926">
                  <c:v>75.172165330008511</c:v>
                </c:pt>
                <c:pt idx="927">
                  <c:v>75.172165330008511</c:v>
                </c:pt>
                <c:pt idx="928">
                  <c:v>0</c:v>
                </c:pt>
                <c:pt idx="929">
                  <c:v>75.172165330008511</c:v>
                </c:pt>
                <c:pt idx="930">
                  <c:v>75.172165330008511</c:v>
                </c:pt>
                <c:pt idx="931">
                  <c:v>0</c:v>
                </c:pt>
                <c:pt idx="932">
                  <c:v>75.172165330008511</c:v>
                </c:pt>
                <c:pt idx="933">
                  <c:v>75.172165330008511</c:v>
                </c:pt>
                <c:pt idx="934">
                  <c:v>771.11947234778381</c:v>
                </c:pt>
                <c:pt idx="935">
                  <c:v>771.11947234778381</c:v>
                </c:pt>
                <c:pt idx="936">
                  <c:v>224.05735877532527</c:v>
                </c:pt>
                <c:pt idx="937">
                  <c:v>224.05735877532527</c:v>
                </c:pt>
                <c:pt idx="938">
                  <c:v>0</c:v>
                </c:pt>
                <c:pt idx="939">
                  <c:v>224.05735877532527</c:v>
                </c:pt>
                <c:pt idx="940">
                  <c:v>224.05735877532527</c:v>
                </c:pt>
                <c:pt idx="941">
                  <c:v>3.265460332815699</c:v>
                </c:pt>
                <c:pt idx="942">
                  <c:v>3.265460332815699</c:v>
                </c:pt>
                <c:pt idx="943">
                  <c:v>0</c:v>
                </c:pt>
                <c:pt idx="944">
                  <c:v>3.265460332815699</c:v>
                </c:pt>
                <c:pt idx="945">
                  <c:v>3.265460332815699</c:v>
                </c:pt>
                <c:pt idx="946">
                  <c:v>0</c:v>
                </c:pt>
                <c:pt idx="947">
                  <c:v>3.265460332815699</c:v>
                </c:pt>
                <c:pt idx="948">
                  <c:v>3.265460332815699</c:v>
                </c:pt>
                <c:pt idx="949">
                  <c:v>224.05735877532527</c:v>
                </c:pt>
                <c:pt idx="950">
                  <c:v>224.05735877532527</c:v>
                </c:pt>
                <c:pt idx="951">
                  <c:v>771.11947234778381</c:v>
                </c:pt>
                <c:pt idx="952">
                  <c:v>771.11947234778381</c:v>
                </c:pt>
                <c:pt idx="953">
                  <c:v>1779.3397060011646</c:v>
                </c:pt>
                <c:pt idx="954">
                  <c:v>1779.3397060011646</c:v>
                </c:pt>
                <c:pt idx="955">
                  <c:v>7039.6338841376783</c:v>
                </c:pt>
                <c:pt idx="956">
                  <c:v>7039.6338841376783</c:v>
                </c:pt>
                <c:pt idx="957">
                  <c:v>1985.7927242567557</c:v>
                </c:pt>
                <c:pt idx="958">
                  <c:v>1985.7927242567557</c:v>
                </c:pt>
                <c:pt idx="959">
                  <c:v>239.68453621887065</c:v>
                </c:pt>
                <c:pt idx="960">
                  <c:v>239.68453621887065</c:v>
                </c:pt>
                <c:pt idx="961">
                  <c:v>30.015647998736249</c:v>
                </c:pt>
                <c:pt idx="962">
                  <c:v>30.015647998736249</c:v>
                </c:pt>
                <c:pt idx="963">
                  <c:v>6.8637403325339328</c:v>
                </c:pt>
                <c:pt idx="964">
                  <c:v>6.8637403325339328</c:v>
                </c:pt>
                <c:pt idx="965">
                  <c:v>0</c:v>
                </c:pt>
                <c:pt idx="966">
                  <c:v>6.8637403325339328</c:v>
                </c:pt>
                <c:pt idx="967">
                  <c:v>6.8637403325339328</c:v>
                </c:pt>
                <c:pt idx="968">
                  <c:v>0</c:v>
                </c:pt>
                <c:pt idx="969">
                  <c:v>6.8637403325339328</c:v>
                </c:pt>
                <c:pt idx="970">
                  <c:v>6.8637403325339328</c:v>
                </c:pt>
                <c:pt idx="971">
                  <c:v>30.015647998736249</c:v>
                </c:pt>
                <c:pt idx="972">
                  <c:v>30.015647998736249</c:v>
                </c:pt>
                <c:pt idx="973">
                  <c:v>9.2854523322725999</c:v>
                </c:pt>
                <c:pt idx="974">
                  <c:v>9.2854523322725999</c:v>
                </c:pt>
                <c:pt idx="975">
                  <c:v>0</c:v>
                </c:pt>
                <c:pt idx="976">
                  <c:v>9.2854523322725999</c:v>
                </c:pt>
                <c:pt idx="977">
                  <c:v>9.2854523322725999</c:v>
                </c:pt>
                <c:pt idx="978">
                  <c:v>0</c:v>
                </c:pt>
                <c:pt idx="979">
                  <c:v>9.2854523322725999</c:v>
                </c:pt>
                <c:pt idx="980">
                  <c:v>9.2854523322725999</c:v>
                </c:pt>
                <c:pt idx="981">
                  <c:v>30.015647998736249</c:v>
                </c:pt>
                <c:pt idx="982">
                  <c:v>30.015647998736249</c:v>
                </c:pt>
                <c:pt idx="983">
                  <c:v>239.68453621887065</c:v>
                </c:pt>
                <c:pt idx="984">
                  <c:v>239.68453621887065</c:v>
                </c:pt>
                <c:pt idx="985">
                  <c:v>54.374858333267085</c:v>
                </c:pt>
                <c:pt idx="986">
                  <c:v>54.374858333267085</c:v>
                </c:pt>
                <c:pt idx="987">
                  <c:v>0</c:v>
                </c:pt>
                <c:pt idx="988">
                  <c:v>54.374858333267085</c:v>
                </c:pt>
                <c:pt idx="989">
                  <c:v>54.374858333267085</c:v>
                </c:pt>
                <c:pt idx="990">
                  <c:v>0</c:v>
                </c:pt>
                <c:pt idx="991">
                  <c:v>54.374858333267085</c:v>
                </c:pt>
                <c:pt idx="992">
                  <c:v>54.374858333267085</c:v>
                </c:pt>
                <c:pt idx="993">
                  <c:v>239.68453621887065</c:v>
                </c:pt>
                <c:pt idx="994">
                  <c:v>239.68453621887065</c:v>
                </c:pt>
                <c:pt idx="995">
                  <c:v>1985.7927242567557</c:v>
                </c:pt>
                <c:pt idx="996">
                  <c:v>1985.7927242567557</c:v>
                </c:pt>
                <c:pt idx="997">
                  <c:v>637.96634781885848</c:v>
                </c:pt>
                <c:pt idx="998">
                  <c:v>637.96634781885848</c:v>
                </c:pt>
                <c:pt idx="999">
                  <c:v>69.825071997316329</c:v>
                </c:pt>
                <c:pt idx="1000">
                  <c:v>69.825071997316329</c:v>
                </c:pt>
                <c:pt idx="1001">
                  <c:v>0</c:v>
                </c:pt>
                <c:pt idx="1002">
                  <c:v>69.825071997316329</c:v>
                </c:pt>
                <c:pt idx="1003">
                  <c:v>69.825071997316329</c:v>
                </c:pt>
                <c:pt idx="1004">
                  <c:v>0</c:v>
                </c:pt>
                <c:pt idx="1005">
                  <c:v>69.825071997316329</c:v>
                </c:pt>
                <c:pt idx="1006">
                  <c:v>69.825071997316329</c:v>
                </c:pt>
                <c:pt idx="1007">
                  <c:v>637.96634781885848</c:v>
                </c:pt>
                <c:pt idx="1008">
                  <c:v>637.96634781885848</c:v>
                </c:pt>
                <c:pt idx="1009">
                  <c:v>364.90024710475706</c:v>
                </c:pt>
                <c:pt idx="1010">
                  <c:v>364.90024710475706</c:v>
                </c:pt>
                <c:pt idx="1011">
                  <c:v>0</c:v>
                </c:pt>
                <c:pt idx="1012">
                  <c:v>364.90024710475706</c:v>
                </c:pt>
                <c:pt idx="1013">
                  <c:v>364.90024710475706</c:v>
                </c:pt>
                <c:pt idx="1014">
                  <c:v>45.325289332881141</c:v>
                </c:pt>
                <c:pt idx="1015">
                  <c:v>45.325289332881141</c:v>
                </c:pt>
                <c:pt idx="1016">
                  <c:v>0</c:v>
                </c:pt>
                <c:pt idx="1017">
                  <c:v>45.325289332881141</c:v>
                </c:pt>
                <c:pt idx="1018">
                  <c:v>45.325289332881141</c:v>
                </c:pt>
                <c:pt idx="1019">
                  <c:v>0</c:v>
                </c:pt>
                <c:pt idx="1020">
                  <c:v>45.325289332881141</c:v>
                </c:pt>
                <c:pt idx="1021">
                  <c:v>45.325289332881141</c:v>
                </c:pt>
                <c:pt idx="1022">
                  <c:v>364.90024710475706</c:v>
                </c:pt>
                <c:pt idx="1023">
                  <c:v>364.90024710475706</c:v>
                </c:pt>
                <c:pt idx="1024">
                  <c:v>637.96634781885848</c:v>
                </c:pt>
                <c:pt idx="1025">
                  <c:v>637.96634781885848</c:v>
                </c:pt>
                <c:pt idx="1026">
                  <c:v>1985.7927242567557</c:v>
                </c:pt>
                <c:pt idx="1027">
                  <c:v>1985.7927242567557</c:v>
                </c:pt>
                <c:pt idx="1028">
                  <c:v>7039.6338841376783</c:v>
                </c:pt>
                <c:pt idx="1029">
                  <c:v>7039.6338841376783</c:v>
                </c:pt>
                <c:pt idx="1030">
                  <c:v>39475.474459660378</c:v>
                </c:pt>
                <c:pt idx="1031">
                  <c:v>39475.474459660378</c:v>
                </c:pt>
                <c:pt idx="1032">
                  <c:v>12471.857801702843</c:v>
                </c:pt>
                <c:pt idx="1033">
                  <c:v>12471.857801702843</c:v>
                </c:pt>
                <c:pt idx="1034">
                  <c:v>1256.0301525729044</c:v>
                </c:pt>
                <c:pt idx="1035">
                  <c:v>1256.0301525729044</c:v>
                </c:pt>
                <c:pt idx="1036">
                  <c:v>79.195845165026896</c:v>
                </c:pt>
                <c:pt idx="1037">
                  <c:v>79.195845165026896</c:v>
                </c:pt>
                <c:pt idx="1038">
                  <c:v>12.502184332069508</c:v>
                </c:pt>
                <c:pt idx="1039">
                  <c:v>12.502184332069508</c:v>
                </c:pt>
                <c:pt idx="1040">
                  <c:v>0</c:v>
                </c:pt>
                <c:pt idx="1041">
                  <c:v>12.502184332069508</c:v>
                </c:pt>
                <c:pt idx="1042">
                  <c:v>12.502184332069508</c:v>
                </c:pt>
                <c:pt idx="1043">
                  <c:v>0</c:v>
                </c:pt>
                <c:pt idx="1044">
                  <c:v>12.502184332069508</c:v>
                </c:pt>
                <c:pt idx="1045">
                  <c:v>12.502184332069508</c:v>
                </c:pt>
                <c:pt idx="1046">
                  <c:v>79.195845165026896</c:v>
                </c:pt>
                <c:pt idx="1047">
                  <c:v>79.195845165026896</c:v>
                </c:pt>
                <c:pt idx="1048">
                  <c:v>40.906272998252717</c:v>
                </c:pt>
                <c:pt idx="1049">
                  <c:v>40.906272998252717</c:v>
                </c:pt>
                <c:pt idx="1050">
                  <c:v>0</c:v>
                </c:pt>
                <c:pt idx="1051">
                  <c:v>40.906272998252717</c:v>
                </c:pt>
                <c:pt idx="1052">
                  <c:v>40.906272998252717</c:v>
                </c:pt>
                <c:pt idx="1053">
                  <c:v>0</c:v>
                </c:pt>
                <c:pt idx="1054">
                  <c:v>40.906272998252717</c:v>
                </c:pt>
                <c:pt idx="1055">
                  <c:v>40.906272998252717</c:v>
                </c:pt>
                <c:pt idx="1056">
                  <c:v>79.195845165026896</c:v>
                </c:pt>
                <c:pt idx="1057">
                  <c:v>79.195845165026896</c:v>
                </c:pt>
                <c:pt idx="1058">
                  <c:v>1256.0301525729044</c:v>
                </c:pt>
                <c:pt idx="1059">
                  <c:v>1256.0301525729044</c:v>
                </c:pt>
                <c:pt idx="1060">
                  <c:v>342.59348822084394</c:v>
                </c:pt>
                <c:pt idx="1061">
                  <c:v>342.59348822084394</c:v>
                </c:pt>
                <c:pt idx="1062">
                  <c:v>0</c:v>
                </c:pt>
                <c:pt idx="1063">
                  <c:v>342.59348822084394</c:v>
                </c:pt>
                <c:pt idx="1064">
                  <c:v>342.59348822084394</c:v>
                </c:pt>
                <c:pt idx="1065">
                  <c:v>221.5225187746266</c:v>
                </c:pt>
                <c:pt idx="1066">
                  <c:v>221.5225187746266</c:v>
                </c:pt>
                <c:pt idx="1067">
                  <c:v>0</c:v>
                </c:pt>
                <c:pt idx="1068">
                  <c:v>221.5225187746266</c:v>
                </c:pt>
                <c:pt idx="1069">
                  <c:v>221.5225187746266</c:v>
                </c:pt>
                <c:pt idx="1070">
                  <c:v>41.208296332234283</c:v>
                </c:pt>
                <c:pt idx="1071">
                  <c:v>41.208296332234283</c:v>
                </c:pt>
                <c:pt idx="1072">
                  <c:v>0</c:v>
                </c:pt>
                <c:pt idx="1073">
                  <c:v>41.208296332234283</c:v>
                </c:pt>
                <c:pt idx="1074">
                  <c:v>41.208296332234283</c:v>
                </c:pt>
                <c:pt idx="1075">
                  <c:v>0</c:v>
                </c:pt>
                <c:pt idx="1076">
                  <c:v>41.208296332234283</c:v>
                </c:pt>
                <c:pt idx="1077">
                  <c:v>41.208296332234283</c:v>
                </c:pt>
                <c:pt idx="1078">
                  <c:v>221.5225187746266</c:v>
                </c:pt>
                <c:pt idx="1079">
                  <c:v>221.5225187746266</c:v>
                </c:pt>
                <c:pt idx="1080">
                  <c:v>342.59348822084394</c:v>
                </c:pt>
                <c:pt idx="1081">
                  <c:v>342.59348822084394</c:v>
                </c:pt>
                <c:pt idx="1082">
                  <c:v>1256.0301525729044</c:v>
                </c:pt>
                <c:pt idx="1083">
                  <c:v>1256.0301525729044</c:v>
                </c:pt>
                <c:pt idx="1084">
                  <c:v>12471.857801702843</c:v>
                </c:pt>
                <c:pt idx="1085">
                  <c:v>12471.857801702843</c:v>
                </c:pt>
                <c:pt idx="1086">
                  <c:v>11199.997415993457</c:v>
                </c:pt>
                <c:pt idx="1087">
                  <c:v>11199.997415993457</c:v>
                </c:pt>
                <c:pt idx="1088">
                  <c:v>3645.1404425046776</c:v>
                </c:pt>
                <c:pt idx="1089">
                  <c:v>3645.1404425046776</c:v>
                </c:pt>
                <c:pt idx="1090">
                  <c:v>394.53154649449408</c:v>
                </c:pt>
                <c:pt idx="1091">
                  <c:v>394.53154649449408</c:v>
                </c:pt>
                <c:pt idx="1092">
                  <c:v>54.893265292481722</c:v>
                </c:pt>
                <c:pt idx="1093">
                  <c:v>54.893265292481722</c:v>
                </c:pt>
                <c:pt idx="1094">
                  <c:v>15.908739275575766</c:v>
                </c:pt>
                <c:pt idx="1095">
                  <c:v>15.908739275575766</c:v>
                </c:pt>
                <c:pt idx="1096">
                  <c:v>0.9053934883805036</c:v>
                </c:pt>
                <c:pt idx="1097">
                  <c:v>0.9053934883805036</c:v>
                </c:pt>
                <c:pt idx="1098">
                  <c:v>0.1005689998886467</c:v>
                </c:pt>
                <c:pt idx="1099">
                  <c:v>0.1005689998886467</c:v>
                </c:pt>
                <c:pt idx="1100">
                  <c:v>0</c:v>
                </c:pt>
                <c:pt idx="1101">
                  <c:v>0.1005689998886467</c:v>
                </c:pt>
                <c:pt idx="1102">
                  <c:v>0.1005689998886467</c:v>
                </c:pt>
                <c:pt idx="1103">
                  <c:v>0</c:v>
                </c:pt>
                <c:pt idx="1104">
                  <c:v>0.1005689998886467</c:v>
                </c:pt>
                <c:pt idx="1105">
                  <c:v>0.1005689998886467</c:v>
                </c:pt>
                <c:pt idx="1106">
                  <c:v>0.9053934883805036</c:v>
                </c:pt>
                <c:pt idx="1107">
                  <c:v>0.9053934883805036</c:v>
                </c:pt>
                <c:pt idx="1108">
                  <c:v>0.28658177754352648</c:v>
                </c:pt>
                <c:pt idx="1109">
                  <c:v>0.28658177754352648</c:v>
                </c:pt>
                <c:pt idx="1110">
                  <c:v>0</c:v>
                </c:pt>
                <c:pt idx="1111">
                  <c:v>0.28658177754352648</c:v>
                </c:pt>
                <c:pt idx="1112">
                  <c:v>0.28658177754352648</c:v>
                </c:pt>
                <c:pt idx="1113">
                  <c:v>1.3601333296091556E-2</c:v>
                </c:pt>
                <c:pt idx="1114">
                  <c:v>1.3601333296091556E-2</c:v>
                </c:pt>
                <c:pt idx="1115">
                  <c:v>0</c:v>
                </c:pt>
                <c:pt idx="1116">
                  <c:v>1.3601333296091556E-2</c:v>
                </c:pt>
                <c:pt idx="1117">
                  <c:v>1.3601333296091556E-2</c:v>
                </c:pt>
                <c:pt idx="1118">
                  <c:v>0</c:v>
                </c:pt>
                <c:pt idx="1119">
                  <c:v>1.3601333296091556E-2</c:v>
                </c:pt>
                <c:pt idx="1120">
                  <c:v>1.3601333296091556E-2</c:v>
                </c:pt>
                <c:pt idx="1121">
                  <c:v>0.28658177754352648</c:v>
                </c:pt>
                <c:pt idx="1122">
                  <c:v>0.28658177754352648</c:v>
                </c:pt>
                <c:pt idx="1123">
                  <c:v>0.9053934883805036</c:v>
                </c:pt>
                <c:pt idx="1124">
                  <c:v>0.9053934883805036</c:v>
                </c:pt>
                <c:pt idx="1125">
                  <c:v>15.908739275575766</c:v>
                </c:pt>
                <c:pt idx="1126">
                  <c:v>15.908739275575766</c:v>
                </c:pt>
                <c:pt idx="1127">
                  <c:v>2.4770085824231294</c:v>
                </c:pt>
                <c:pt idx="1128">
                  <c:v>2.4770085824231294</c:v>
                </c:pt>
                <c:pt idx="1129">
                  <c:v>0.14636933325466717</c:v>
                </c:pt>
                <c:pt idx="1130">
                  <c:v>0.14636933325466717</c:v>
                </c:pt>
                <c:pt idx="1131">
                  <c:v>0</c:v>
                </c:pt>
                <c:pt idx="1132">
                  <c:v>0.14636933325466717</c:v>
                </c:pt>
                <c:pt idx="1133">
                  <c:v>0.14636933325466717</c:v>
                </c:pt>
                <c:pt idx="1134">
                  <c:v>0</c:v>
                </c:pt>
                <c:pt idx="1135">
                  <c:v>0.14636933325466717</c:v>
                </c:pt>
                <c:pt idx="1136">
                  <c:v>0.14636933325466717</c:v>
                </c:pt>
                <c:pt idx="1137">
                  <c:v>2.4770085824231294</c:v>
                </c:pt>
                <c:pt idx="1138">
                  <c:v>2.4770085824231294</c:v>
                </c:pt>
                <c:pt idx="1139">
                  <c:v>2.0341846659345459</c:v>
                </c:pt>
                <c:pt idx="1140">
                  <c:v>2.0341846659345459</c:v>
                </c:pt>
                <c:pt idx="1141">
                  <c:v>0.14450599960198088</c:v>
                </c:pt>
                <c:pt idx="1142">
                  <c:v>0.14450599960198088</c:v>
                </c:pt>
                <c:pt idx="1143">
                  <c:v>9.363333292082927E-4</c:v>
                </c:pt>
                <c:pt idx="1144">
                  <c:v>9.363333292082927E-4</c:v>
                </c:pt>
                <c:pt idx="1145">
                  <c:v>0</c:v>
                </c:pt>
                <c:pt idx="1146">
                  <c:v>9.363333292082927E-4</c:v>
                </c:pt>
                <c:pt idx="1147">
                  <c:v>9.363333292082927E-4</c:v>
                </c:pt>
                <c:pt idx="1148">
                  <c:v>0</c:v>
                </c:pt>
                <c:pt idx="1149">
                  <c:v>9.363333292082927E-4</c:v>
                </c:pt>
                <c:pt idx="1150">
                  <c:v>9.363333292082927E-4</c:v>
                </c:pt>
                <c:pt idx="1151">
                  <c:v>0.14450599960198088</c:v>
                </c:pt>
                <c:pt idx="1152">
                  <c:v>0.14450599960198088</c:v>
                </c:pt>
                <c:pt idx="1153">
                  <c:v>4.5530333309654225E-2</c:v>
                </c:pt>
                <c:pt idx="1154">
                  <c:v>4.5530333309654225E-2</c:v>
                </c:pt>
                <c:pt idx="1155">
                  <c:v>0</c:v>
                </c:pt>
                <c:pt idx="1156">
                  <c:v>4.5530333309654225E-2</c:v>
                </c:pt>
                <c:pt idx="1157">
                  <c:v>4.5530333309654225E-2</c:v>
                </c:pt>
                <c:pt idx="1158">
                  <c:v>0</c:v>
                </c:pt>
                <c:pt idx="1159">
                  <c:v>4.5530333309654225E-2</c:v>
                </c:pt>
                <c:pt idx="1160">
                  <c:v>4.5530333309654225E-2</c:v>
                </c:pt>
                <c:pt idx="1161">
                  <c:v>0.14450599960198088</c:v>
                </c:pt>
                <c:pt idx="1162">
                  <c:v>0.14450599960198088</c:v>
                </c:pt>
                <c:pt idx="1163">
                  <c:v>2.0341846659345459</c:v>
                </c:pt>
                <c:pt idx="1164">
                  <c:v>2.0341846659345459</c:v>
                </c:pt>
                <c:pt idx="1165">
                  <c:v>0.32703099999383906</c:v>
                </c:pt>
                <c:pt idx="1166">
                  <c:v>0.32703099999383906</c:v>
                </c:pt>
                <c:pt idx="1167">
                  <c:v>0</c:v>
                </c:pt>
                <c:pt idx="1168">
                  <c:v>0.32703099999383906</c:v>
                </c:pt>
                <c:pt idx="1169">
                  <c:v>0.32703099999383906</c:v>
                </c:pt>
                <c:pt idx="1170">
                  <c:v>0</c:v>
                </c:pt>
                <c:pt idx="1171">
                  <c:v>0.32703099999383906</c:v>
                </c:pt>
                <c:pt idx="1172">
                  <c:v>0.32703099999383906</c:v>
                </c:pt>
                <c:pt idx="1173">
                  <c:v>2.0341846659345459</c:v>
                </c:pt>
                <c:pt idx="1174">
                  <c:v>2.0341846659345459</c:v>
                </c:pt>
                <c:pt idx="1175">
                  <c:v>2.4770085824231294</c:v>
                </c:pt>
                <c:pt idx="1176">
                  <c:v>2.4770085824231294</c:v>
                </c:pt>
                <c:pt idx="1177">
                  <c:v>15.908739275575766</c:v>
                </c:pt>
                <c:pt idx="1178">
                  <c:v>15.908739275575766</c:v>
                </c:pt>
                <c:pt idx="1179">
                  <c:v>54.893265292481722</c:v>
                </c:pt>
                <c:pt idx="1180">
                  <c:v>54.893265292481722</c:v>
                </c:pt>
                <c:pt idx="1181">
                  <c:v>25.802998531392923</c:v>
                </c:pt>
                <c:pt idx="1182">
                  <c:v>25.802998531392923</c:v>
                </c:pt>
                <c:pt idx="1183">
                  <c:v>4.4800006658729785</c:v>
                </c:pt>
                <c:pt idx="1184">
                  <c:v>4.4800006658729785</c:v>
                </c:pt>
                <c:pt idx="1185">
                  <c:v>0.73124133310681327</c:v>
                </c:pt>
                <c:pt idx="1186">
                  <c:v>0.73124133310681327</c:v>
                </c:pt>
                <c:pt idx="1187">
                  <c:v>0</c:v>
                </c:pt>
                <c:pt idx="1188">
                  <c:v>0.73124133310681327</c:v>
                </c:pt>
                <c:pt idx="1189">
                  <c:v>0.73124133310681327</c:v>
                </c:pt>
                <c:pt idx="1190">
                  <c:v>0</c:v>
                </c:pt>
                <c:pt idx="1191">
                  <c:v>0.73124133310681327</c:v>
                </c:pt>
                <c:pt idx="1192">
                  <c:v>0.73124133310681327</c:v>
                </c:pt>
                <c:pt idx="1193">
                  <c:v>4.4800006658729785</c:v>
                </c:pt>
                <c:pt idx="1194">
                  <c:v>4.4800006658729785</c:v>
                </c:pt>
                <c:pt idx="1195">
                  <c:v>0.80324799976012484</c:v>
                </c:pt>
                <c:pt idx="1196">
                  <c:v>0.80324799976012484</c:v>
                </c:pt>
                <c:pt idx="1197">
                  <c:v>0</c:v>
                </c:pt>
                <c:pt idx="1198">
                  <c:v>0.80324799976012484</c:v>
                </c:pt>
                <c:pt idx="1199">
                  <c:v>0.80324799976012484</c:v>
                </c:pt>
                <c:pt idx="1200">
                  <c:v>0</c:v>
                </c:pt>
                <c:pt idx="1201">
                  <c:v>0.80324799976012484</c:v>
                </c:pt>
                <c:pt idx="1202">
                  <c:v>0.80324799976012484</c:v>
                </c:pt>
                <c:pt idx="1203">
                  <c:v>4.4800006658729785</c:v>
                </c:pt>
                <c:pt idx="1204">
                  <c:v>4.4800006658729785</c:v>
                </c:pt>
                <c:pt idx="1205">
                  <c:v>25.802998531392923</c:v>
                </c:pt>
                <c:pt idx="1206">
                  <c:v>25.802998531392923</c:v>
                </c:pt>
                <c:pt idx="1207">
                  <c:v>5.1654704658150417</c:v>
                </c:pt>
                <c:pt idx="1208">
                  <c:v>5.1654704658150417</c:v>
                </c:pt>
                <c:pt idx="1209">
                  <c:v>0.89860633320703709</c:v>
                </c:pt>
                <c:pt idx="1210">
                  <c:v>0.89860633320703709</c:v>
                </c:pt>
                <c:pt idx="1211">
                  <c:v>0</c:v>
                </c:pt>
                <c:pt idx="1212">
                  <c:v>0.89860633320703709</c:v>
                </c:pt>
                <c:pt idx="1213">
                  <c:v>0.89860633320703709</c:v>
                </c:pt>
                <c:pt idx="1214">
                  <c:v>0</c:v>
                </c:pt>
                <c:pt idx="1215">
                  <c:v>0.89860633320703709</c:v>
                </c:pt>
                <c:pt idx="1216">
                  <c:v>0.89860633320703709</c:v>
                </c:pt>
                <c:pt idx="1217">
                  <c:v>5.1654704658150417</c:v>
                </c:pt>
                <c:pt idx="1218">
                  <c:v>5.1654704658150417</c:v>
                </c:pt>
                <c:pt idx="1219">
                  <c:v>1.1242563327100146</c:v>
                </c:pt>
                <c:pt idx="1220">
                  <c:v>1.1242563327100146</c:v>
                </c:pt>
                <c:pt idx="1221">
                  <c:v>0</c:v>
                </c:pt>
                <c:pt idx="1222">
                  <c:v>1.1242563327100146</c:v>
                </c:pt>
                <c:pt idx="1223">
                  <c:v>1.1242563327100146</c:v>
                </c:pt>
                <c:pt idx="1224">
                  <c:v>0.76486433324240022</c:v>
                </c:pt>
                <c:pt idx="1225">
                  <c:v>0.76486433324240022</c:v>
                </c:pt>
                <c:pt idx="1226">
                  <c:v>0</c:v>
                </c:pt>
                <c:pt idx="1227">
                  <c:v>0.76486433324240022</c:v>
                </c:pt>
                <c:pt idx="1228">
                  <c:v>0.76486433324240022</c:v>
                </c:pt>
                <c:pt idx="1229">
                  <c:v>0</c:v>
                </c:pt>
                <c:pt idx="1230">
                  <c:v>0.76486433324240022</c:v>
                </c:pt>
                <c:pt idx="1231">
                  <c:v>0.76486433324240022</c:v>
                </c:pt>
                <c:pt idx="1232">
                  <c:v>1.1242563327100146</c:v>
                </c:pt>
                <c:pt idx="1233">
                  <c:v>1.1242563327100146</c:v>
                </c:pt>
                <c:pt idx="1234">
                  <c:v>5.1654704658150417</c:v>
                </c:pt>
                <c:pt idx="1235">
                  <c:v>5.1654704658150417</c:v>
                </c:pt>
                <c:pt idx="1236">
                  <c:v>25.802998531392923</c:v>
                </c:pt>
                <c:pt idx="1237">
                  <c:v>25.802998531392923</c:v>
                </c:pt>
                <c:pt idx="1238">
                  <c:v>54.893265292481722</c:v>
                </c:pt>
                <c:pt idx="1239">
                  <c:v>54.893265292481722</c:v>
                </c:pt>
                <c:pt idx="1240">
                  <c:v>394.53154649449408</c:v>
                </c:pt>
                <c:pt idx="1241">
                  <c:v>394.53154649449408</c:v>
                </c:pt>
                <c:pt idx="1242">
                  <c:v>132.40806072820538</c:v>
                </c:pt>
                <c:pt idx="1243">
                  <c:v>132.40806072820538</c:v>
                </c:pt>
                <c:pt idx="1244">
                  <c:v>22.087957164646596</c:v>
                </c:pt>
                <c:pt idx="1245">
                  <c:v>22.087957164646596</c:v>
                </c:pt>
                <c:pt idx="1246">
                  <c:v>3.715329332787674</c:v>
                </c:pt>
                <c:pt idx="1247">
                  <c:v>3.715329332787674</c:v>
                </c:pt>
                <c:pt idx="1248">
                  <c:v>0</c:v>
                </c:pt>
                <c:pt idx="1249">
                  <c:v>3.715329332787674</c:v>
                </c:pt>
                <c:pt idx="1250">
                  <c:v>3.715329332787674</c:v>
                </c:pt>
                <c:pt idx="1251">
                  <c:v>1.3062879999276527</c:v>
                </c:pt>
                <c:pt idx="1252">
                  <c:v>1.3062879999276527</c:v>
                </c:pt>
                <c:pt idx="1253">
                  <c:v>0</c:v>
                </c:pt>
                <c:pt idx="1254">
                  <c:v>1.3062879999276527</c:v>
                </c:pt>
                <c:pt idx="1255">
                  <c:v>1.3062879999276527</c:v>
                </c:pt>
                <c:pt idx="1256">
                  <c:v>0</c:v>
                </c:pt>
                <c:pt idx="1257">
                  <c:v>1.3062879999276527</c:v>
                </c:pt>
                <c:pt idx="1258">
                  <c:v>1.3062879999276527</c:v>
                </c:pt>
                <c:pt idx="1259">
                  <c:v>3.715329332787674</c:v>
                </c:pt>
                <c:pt idx="1260">
                  <c:v>3.715329332787674</c:v>
                </c:pt>
                <c:pt idx="1261">
                  <c:v>22.087957164646596</c:v>
                </c:pt>
                <c:pt idx="1262">
                  <c:v>22.087957164646596</c:v>
                </c:pt>
                <c:pt idx="1263">
                  <c:v>13.939938165404314</c:v>
                </c:pt>
                <c:pt idx="1264">
                  <c:v>13.939938165404314</c:v>
                </c:pt>
                <c:pt idx="1265">
                  <c:v>1.6111989998176079</c:v>
                </c:pt>
                <c:pt idx="1266">
                  <c:v>1.6111989998176079</c:v>
                </c:pt>
                <c:pt idx="1267">
                  <c:v>0</c:v>
                </c:pt>
                <c:pt idx="1268">
                  <c:v>1.6111989998176079</c:v>
                </c:pt>
                <c:pt idx="1269">
                  <c:v>1.6111989998176079</c:v>
                </c:pt>
                <c:pt idx="1270">
                  <c:v>0</c:v>
                </c:pt>
                <c:pt idx="1271">
                  <c:v>1.6111989998176079</c:v>
                </c:pt>
                <c:pt idx="1272">
                  <c:v>1.6111989998176079</c:v>
                </c:pt>
                <c:pt idx="1273">
                  <c:v>13.939938165404314</c:v>
                </c:pt>
                <c:pt idx="1274">
                  <c:v>13.939938165404314</c:v>
                </c:pt>
                <c:pt idx="1275">
                  <c:v>2.0354823329590785</c:v>
                </c:pt>
                <c:pt idx="1276">
                  <c:v>2.0354823329590785</c:v>
                </c:pt>
                <c:pt idx="1277">
                  <c:v>0</c:v>
                </c:pt>
                <c:pt idx="1278">
                  <c:v>2.0354823329590785</c:v>
                </c:pt>
                <c:pt idx="1279">
                  <c:v>2.0354823329590785</c:v>
                </c:pt>
                <c:pt idx="1280">
                  <c:v>0</c:v>
                </c:pt>
                <c:pt idx="1281">
                  <c:v>2.0354823329590785</c:v>
                </c:pt>
                <c:pt idx="1282">
                  <c:v>2.0354823329590785</c:v>
                </c:pt>
                <c:pt idx="1283">
                  <c:v>13.939938165404314</c:v>
                </c:pt>
                <c:pt idx="1284">
                  <c:v>13.939938165404314</c:v>
                </c:pt>
                <c:pt idx="1285">
                  <c:v>22.087957164646596</c:v>
                </c:pt>
                <c:pt idx="1286">
                  <c:v>22.087957164646596</c:v>
                </c:pt>
                <c:pt idx="1287">
                  <c:v>132.40806072820538</c:v>
                </c:pt>
                <c:pt idx="1288">
                  <c:v>132.40806072820538</c:v>
                </c:pt>
                <c:pt idx="1289">
                  <c:v>99.67469415621828</c:v>
                </c:pt>
                <c:pt idx="1290">
                  <c:v>99.67469415621828</c:v>
                </c:pt>
                <c:pt idx="1291">
                  <c:v>13.856918410099253</c:v>
                </c:pt>
                <c:pt idx="1292">
                  <c:v>13.856918410099253</c:v>
                </c:pt>
                <c:pt idx="1293">
                  <c:v>2.5129086485531995</c:v>
                </c:pt>
                <c:pt idx="1294">
                  <c:v>2.5129086485531995</c:v>
                </c:pt>
                <c:pt idx="1295">
                  <c:v>0.14516099968611618</c:v>
                </c:pt>
                <c:pt idx="1296">
                  <c:v>0.14516099968611618</c:v>
                </c:pt>
                <c:pt idx="1297">
                  <c:v>0</c:v>
                </c:pt>
                <c:pt idx="1298">
                  <c:v>0.14516099968611618</c:v>
                </c:pt>
                <c:pt idx="1299">
                  <c:v>0.14516099968611618</c:v>
                </c:pt>
                <c:pt idx="1300">
                  <c:v>3.4346999955416645E-2</c:v>
                </c:pt>
                <c:pt idx="1301">
                  <c:v>3.4346999955416645E-2</c:v>
                </c:pt>
                <c:pt idx="1302">
                  <c:v>0</c:v>
                </c:pt>
                <c:pt idx="1303">
                  <c:v>3.4346999955416645E-2</c:v>
                </c:pt>
                <c:pt idx="1304">
                  <c:v>3.4346999955416645E-2</c:v>
                </c:pt>
                <c:pt idx="1305">
                  <c:v>0</c:v>
                </c:pt>
                <c:pt idx="1306">
                  <c:v>3.4346999955416645E-2</c:v>
                </c:pt>
                <c:pt idx="1307">
                  <c:v>3.4346999955416645E-2</c:v>
                </c:pt>
                <c:pt idx="1308">
                  <c:v>0.14516099968611618</c:v>
                </c:pt>
                <c:pt idx="1309">
                  <c:v>0.14516099968611618</c:v>
                </c:pt>
                <c:pt idx="1310">
                  <c:v>2.5129086485531995</c:v>
                </c:pt>
                <c:pt idx="1311">
                  <c:v>2.5129086485531995</c:v>
                </c:pt>
                <c:pt idx="1312">
                  <c:v>1.0807254882703743</c:v>
                </c:pt>
                <c:pt idx="1313">
                  <c:v>1.0807254882703743</c:v>
                </c:pt>
                <c:pt idx="1314">
                  <c:v>0.30545433328028637</c:v>
                </c:pt>
                <c:pt idx="1315">
                  <c:v>0.30545433328028637</c:v>
                </c:pt>
                <c:pt idx="1316">
                  <c:v>0</c:v>
                </c:pt>
                <c:pt idx="1317">
                  <c:v>0.30545433328028637</c:v>
                </c:pt>
                <c:pt idx="1318">
                  <c:v>0.30545433328028637</c:v>
                </c:pt>
                <c:pt idx="1319">
                  <c:v>0</c:v>
                </c:pt>
                <c:pt idx="1320">
                  <c:v>0.30545433328028637</c:v>
                </c:pt>
                <c:pt idx="1321">
                  <c:v>0.30545433328028637</c:v>
                </c:pt>
                <c:pt idx="1322">
                  <c:v>1.0807254882703743</c:v>
                </c:pt>
                <c:pt idx="1323">
                  <c:v>1.0807254882703743</c:v>
                </c:pt>
                <c:pt idx="1324">
                  <c:v>0.34766144398638249</c:v>
                </c:pt>
                <c:pt idx="1325">
                  <c:v>0.34766144398638249</c:v>
                </c:pt>
                <c:pt idx="1326">
                  <c:v>0</c:v>
                </c:pt>
                <c:pt idx="1327">
                  <c:v>0.34766144398638249</c:v>
                </c:pt>
                <c:pt idx="1328">
                  <c:v>0.34766144398638249</c:v>
                </c:pt>
                <c:pt idx="1329">
                  <c:v>0.13716699997521115</c:v>
                </c:pt>
                <c:pt idx="1330">
                  <c:v>0.13716699997521115</c:v>
                </c:pt>
                <c:pt idx="1331">
                  <c:v>0</c:v>
                </c:pt>
                <c:pt idx="1332">
                  <c:v>0.13716699997521115</c:v>
                </c:pt>
                <c:pt idx="1333">
                  <c:v>0.13716699997521115</c:v>
                </c:pt>
                <c:pt idx="1334">
                  <c:v>0</c:v>
                </c:pt>
                <c:pt idx="1335">
                  <c:v>0.13716699997521115</c:v>
                </c:pt>
                <c:pt idx="1336">
                  <c:v>0.13716699997521115</c:v>
                </c:pt>
                <c:pt idx="1337">
                  <c:v>0.34766144398638249</c:v>
                </c:pt>
                <c:pt idx="1338">
                  <c:v>0.34766144398638249</c:v>
                </c:pt>
                <c:pt idx="1339">
                  <c:v>1.0807254882703743</c:v>
                </c:pt>
                <c:pt idx="1340">
                  <c:v>1.0807254882703743</c:v>
                </c:pt>
                <c:pt idx="1341">
                  <c:v>2.5129086485531995</c:v>
                </c:pt>
                <c:pt idx="1342">
                  <c:v>2.5129086485531995</c:v>
                </c:pt>
                <c:pt idx="1343">
                  <c:v>13.856918410099253</c:v>
                </c:pt>
                <c:pt idx="1344">
                  <c:v>13.856918410099253</c:v>
                </c:pt>
                <c:pt idx="1345">
                  <c:v>3.5456989376883445</c:v>
                </c:pt>
                <c:pt idx="1346">
                  <c:v>3.5456989376883445</c:v>
                </c:pt>
                <c:pt idx="1347">
                  <c:v>0.30355377750685852</c:v>
                </c:pt>
                <c:pt idx="1348">
                  <c:v>0.30355377750685852</c:v>
                </c:pt>
                <c:pt idx="1349">
                  <c:v>0</c:v>
                </c:pt>
                <c:pt idx="1350">
                  <c:v>0.30355377750685852</c:v>
                </c:pt>
                <c:pt idx="1351">
                  <c:v>0.30355377750685852</c:v>
                </c:pt>
                <c:pt idx="1352">
                  <c:v>0.20884899989437566</c:v>
                </c:pt>
                <c:pt idx="1353">
                  <c:v>0.20884899989437566</c:v>
                </c:pt>
                <c:pt idx="1354">
                  <c:v>0</c:v>
                </c:pt>
                <c:pt idx="1355">
                  <c:v>0.20884899989437566</c:v>
                </c:pt>
                <c:pt idx="1356">
                  <c:v>0.20884899989437566</c:v>
                </c:pt>
                <c:pt idx="1357">
                  <c:v>0</c:v>
                </c:pt>
                <c:pt idx="1358">
                  <c:v>0.20884899989437566</c:v>
                </c:pt>
                <c:pt idx="1359">
                  <c:v>0.20884899989437566</c:v>
                </c:pt>
                <c:pt idx="1360">
                  <c:v>0.30355377750685852</c:v>
                </c:pt>
                <c:pt idx="1361">
                  <c:v>0.30355377750685852</c:v>
                </c:pt>
                <c:pt idx="1362">
                  <c:v>3.5456989376883445</c:v>
                </c:pt>
                <c:pt idx="1363">
                  <c:v>3.5456989376883445</c:v>
                </c:pt>
                <c:pt idx="1364">
                  <c:v>0.31683108327796983</c:v>
                </c:pt>
                <c:pt idx="1365">
                  <c:v>0.31683108327796983</c:v>
                </c:pt>
                <c:pt idx="1366">
                  <c:v>0</c:v>
                </c:pt>
                <c:pt idx="1367">
                  <c:v>0.31683108327796983</c:v>
                </c:pt>
                <c:pt idx="1368">
                  <c:v>0.31683108327796983</c:v>
                </c:pt>
                <c:pt idx="1369">
                  <c:v>0</c:v>
                </c:pt>
                <c:pt idx="1370">
                  <c:v>0.31683108327796983</c:v>
                </c:pt>
                <c:pt idx="1371">
                  <c:v>0.31683108327796983</c:v>
                </c:pt>
                <c:pt idx="1372">
                  <c:v>3.5456989376883445</c:v>
                </c:pt>
                <c:pt idx="1373">
                  <c:v>3.5456989376883445</c:v>
                </c:pt>
                <c:pt idx="1374">
                  <c:v>13.856918410099253</c:v>
                </c:pt>
                <c:pt idx="1375">
                  <c:v>13.856918410099253</c:v>
                </c:pt>
                <c:pt idx="1376">
                  <c:v>99.67469415621828</c:v>
                </c:pt>
                <c:pt idx="1377">
                  <c:v>99.67469415621828</c:v>
                </c:pt>
                <c:pt idx="1378">
                  <c:v>24.136608600488895</c:v>
                </c:pt>
                <c:pt idx="1379">
                  <c:v>24.136608600488895</c:v>
                </c:pt>
                <c:pt idx="1380">
                  <c:v>3.2727640829726692</c:v>
                </c:pt>
                <c:pt idx="1381">
                  <c:v>3.2727640829726692</c:v>
                </c:pt>
                <c:pt idx="1382">
                  <c:v>0</c:v>
                </c:pt>
                <c:pt idx="1383">
                  <c:v>3.2727640829726692</c:v>
                </c:pt>
                <c:pt idx="1384">
                  <c:v>3.2727640829726692</c:v>
                </c:pt>
                <c:pt idx="1385">
                  <c:v>0</c:v>
                </c:pt>
                <c:pt idx="1386">
                  <c:v>3.2727640829726692</c:v>
                </c:pt>
                <c:pt idx="1387">
                  <c:v>3.2727640829726692</c:v>
                </c:pt>
                <c:pt idx="1388">
                  <c:v>24.136608600488895</c:v>
                </c:pt>
                <c:pt idx="1389">
                  <c:v>24.136608600488895</c:v>
                </c:pt>
                <c:pt idx="1390">
                  <c:v>4.8481788488402211</c:v>
                </c:pt>
                <c:pt idx="1391">
                  <c:v>4.8481788488402211</c:v>
                </c:pt>
                <c:pt idx="1392">
                  <c:v>0.51342908319173897</c:v>
                </c:pt>
                <c:pt idx="1393">
                  <c:v>0.51342908319173897</c:v>
                </c:pt>
                <c:pt idx="1394">
                  <c:v>0</c:v>
                </c:pt>
                <c:pt idx="1395">
                  <c:v>0.51342908319173897</c:v>
                </c:pt>
                <c:pt idx="1396">
                  <c:v>0.51342908319173897</c:v>
                </c:pt>
                <c:pt idx="1397">
                  <c:v>0</c:v>
                </c:pt>
                <c:pt idx="1398">
                  <c:v>0.51342908319173897</c:v>
                </c:pt>
                <c:pt idx="1399">
                  <c:v>0.51342908319173897</c:v>
                </c:pt>
                <c:pt idx="1400">
                  <c:v>4.8481788488402211</c:v>
                </c:pt>
                <c:pt idx="1401">
                  <c:v>4.8481788488402211</c:v>
                </c:pt>
                <c:pt idx="1402">
                  <c:v>1.3354569996387204</c:v>
                </c:pt>
                <c:pt idx="1403">
                  <c:v>1.3354569996387204</c:v>
                </c:pt>
                <c:pt idx="1404">
                  <c:v>0</c:v>
                </c:pt>
                <c:pt idx="1405">
                  <c:v>1.3354569996387204</c:v>
                </c:pt>
                <c:pt idx="1406">
                  <c:v>1.3354569996387204</c:v>
                </c:pt>
                <c:pt idx="1407">
                  <c:v>0.66596699971668771</c:v>
                </c:pt>
                <c:pt idx="1408">
                  <c:v>0.66596699971668771</c:v>
                </c:pt>
                <c:pt idx="1409">
                  <c:v>0</c:v>
                </c:pt>
                <c:pt idx="1410">
                  <c:v>0.66596699971668771</c:v>
                </c:pt>
                <c:pt idx="1411">
                  <c:v>0.66596699971668771</c:v>
                </c:pt>
                <c:pt idx="1412">
                  <c:v>0</c:v>
                </c:pt>
                <c:pt idx="1413">
                  <c:v>0.66596699971668771</c:v>
                </c:pt>
                <c:pt idx="1414">
                  <c:v>0.66596699971668771</c:v>
                </c:pt>
                <c:pt idx="1415">
                  <c:v>1.3354569996387204</c:v>
                </c:pt>
                <c:pt idx="1416">
                  <c:v>1.3354569996387204</c:v>
                </c:pt>
                <c:pt idx="1417">
                  <c:v>4.8481788488402211</c:v>
                </c:pt>
                <c:pt idx="1418">
                  <c:v>4.8481788488402211</c:v>
                </c:pt>
                <c:pt idx="1419">
                  <c:v>24.136608600488895</c:v>
                </c:pt>
                <c:pt idx="1420">
                  <c:v>24.136608600488895</c:v>
                </c:pt>
                <c:pt idx="1421">
                  <c:v>99.67469415621828</c:v>
                </c:pt>
                <c:pt idx="1422">
                  <c:v>99.67469415621828</c:v>
                </c:pt>
                <c:pt idx="1423">
                  <c:v>132.40806072820538</c:v>
                </c:pt>
                <c:pt idx="1424">
                  <c:v>132.40806072820538</c:v>
                </c:pt>
                <c:pt idx="1425">
                  <c:v>394.53154649449408</c:v>
                </c:pt>
                <c:pt idx="1426">
                  <c:v>394.53154649449408</c:v>
                </c:pt>
                <c:pt idx="1427">
                  <c:v>3645.1404425046776</c:v>
                </c:pt>
                <c:pt idx="1428">
                  <c:v>3645.1404425046776</c:v>
                </c:pt>
                <c:pt idx="1429">
                  <c:v>1198.9774649039789</c:v>
                </c:pt>
                <c:pt idx="1430">
                  <c:v>1198.9774649039789</c:v>
                </c:pt>
                <c:pt idx="1431">
                  <c:v>240.50247438932487</c:v>
                </c:pt>
                <c:pt idx="1432">
                  <c:v>240.50247438932487</c:v>
                </c:pt>
                <c:pt idx="1433">
                  <c:v>30.906574053735397</c:v>
                </c:pt>
                <c:pt idx="1434">
                  <c:v>30.906574053735397</c:v>
                </c:pt>
                <c:pt idx="1435">
                  <c:v>0</c:v>
                </c:pt>
                <c:pt idx="1436">
                  <c:v>30.906574053735397</c:v>
                </c:pt>
                <c:pt idx="1437">
                  <c:v>30.906574053735397</c:v>
                </c:pt>
                <c:pt idx="1438">
                  <c:v>2.8979657775597976</c:v>
                </c:pt>
                <c:pt idx="1439">
                  <c:v>2.8979657775597976</c:v>
                </c:pt>
                <c:pt idx="1440">
                  <c:v>0</c:v>
                </c:pt>
                <c:pt idx="1441">
                  <c:v>2.8979657775597976</c:v>
                </c:pt>
                <c:pt idx="1442">
                  <c:v>2.8979657775597976</c:v>
                </c:pt>
                <c:pt idx="1443">
                  <c:v>1.5568653329287254</c:v>
                </c:pt>
                <c:pt idx="1444">
                  <c:v>1.5568653329287254</c:v>
                </c:pt>
                <c:pt idx="1445">
                  <c:v>0</c:v>
                </c:pt>
                <c:pt idx="1446">
                  <c:v>1.5568653329287254</c:v>
                </c:pt>
                <c:pt idx="1447">
                  <c:v>1.5568653329287254</c:v>
                </c:pt>
                <c:pt idx="1448">
                  <c:v>0</c:v>
                </c:pt>
                <c:pt idx="1449">
                  <c:v>1.5568653329287254</c:v>
                </c:pt>
                <c:pt idx="1450">
                  <c:v>1.5568653329287254</c:v>
                </c:pt>
                <c:pt idx="1451">
                  <c:v>2.8979657775597976</c:v>
                </c:pt>
                <c:pt idx="1452">
                  <c:v>2.8979657775597976</c:v>
                </c:pt>
                <c:pt idx="1453">
                  <c:v>30.906574053735397</c:v>
                </c:pt>
                <c:pt idx="1454">
                  <c:v>30.906574053735397</c:v>
                </c:pt>
                <c:pt idx="1455">
                  <c:v>240.50247438932487</c:v>
                </c:pt>
                <c:pt idx="1456">
                  <c:v>240.50247438932487</c:v>
                </c:pt>
                <c:pt idx="1457">
                  <c:v>106.4548160226563</c:v>
                </c:pt>
                <c:pt idx="1458">
                  <c:v>106.4548160226563</c:v>
                </c:pt>
                <c:pt idx="1459">
                  <c:v>10.633317954480637</c:v>
                </c:pt>
                <c:pt idx="1460">
                  <c:v>10.633317954480637</c:v>
                </c:pt>
                <c:pt idx="1461">
                  <c:v>1.7352973330724575</c:v>
                </c:pt>
                <c:pt idx="1462">
                  <c:v>1.7352973330724575</c:v>
                </c:pt>
                <c:pt idx="1463">
                  <c:v>0</c:v>
                </c:pt>
                <c:pt idx="1464">
                  <c:v>1.7352973330724575</c:v>
                </c:pt>
                <c:pt idx="1465">
                  <c:v>1.7352973330724575</c:v>
                </c:pt>
                <c:pt idx="1466">
                  <c:v>0</c:v>
                </c:pt>
                <c:pt idx="1467">
                  <c:v>1.7352973330724575</c:v>
                </c:pt>
                <c:pt idx="1468">
                  <c:v>1.7352973330724575</c:v>
                </c:pt>
                <c:pt idx="1469">
                  <c:v>10.633317954480637</c:v>
                </c:pt>
                <c:pt idx="1470">
                  <c:v>10.633317954480637</c:v>
                </c:pt>
                <c:pt idx="1471">
                  <c:v>3.3339367772863668</c:v>
                </c:pt>
                <c:pt idx="1472">
                  <c:v>3.3339367772863668</c:v>
                </c:pt>
                <c:pt idx="1473">
                  <c:v>0</c:v>
                </c:pt>
                <c:pt idx="1474">
                  <c:v>3.3339367772863668</c:v>
                </c:pt>
                <c:pt idx="1475">
                  <c:v>3.3339367772863668</c:v>
                </c:pt>
                <c:pt idx="1476">
                  <c:v>0.78840833318687453</c:v>
                </c:pt>
                <c:pt idx="1477">
                  <c:v>0.78840833318687453</c:v>
                </c:pt>
                <c:pt idx="1478">
                  <c:v>0</c:v>
                </c:pt>
                <c:pt idx="1479">
                  <c:v>0.78840833318687453</c:v>
                </c:pt>
                <c:pt idx="1480">
                  <c:v>0.78840833318687453</c:v>
                </c:pt>
                <c:pt idx="1481">
                  <c:v>0</c:v>
                </c:pt>
                <c:pt idx="1482">
                  <c:v>0.78840833318687453</c:v>
                </c:pt>
                <c:pt idx="1483">
                  <c:v>0.78840833318687453</c:v>
                </c:pt>
                <c:pt idx="1484">
                  <c:v>3.3339367772863668</c:v>
                </c:pt>
                <c:pt idx="1485">
                  <c:v>3.3339367772863668</c:v>
                </c:pt>
                <c:pt idx="1486">
                  <c:v>10.633317954480637</c:v>
                </c:pt>
                <c:pt idx="1487">
                  <c:v>10.633317954480637</c:v>
                </c:pt>
                <c:pt idx="1488">
                  <c:v>106.4548160226563</c:v>
                </c:pt>
                <c:pt idx="1489">
                  <c:v>106.4548160226563</c:v>
                </c:pt>
                <c:pt idx="1490">
                  <c:v>54.724767053831179</c:v>
                </c:pt>
                <c:pt idx="1491">
                  <c:v>54.724767053831179</c:v>
                </c:pt>
                <c:pt idx="1492">
                  <c:v>0</c:v>
                </c:pt>
                <c:pt idx="1493">
                  <c:v>54.724767053831179</c:v>
                </c:pt>
                <c:pt idx="1494">
                  <c:v>54.724767053831179</c:v>
                </c:pt>
                <c:pt idx="1495">
                  <c:v>6.1484777767996377</c:v>
                </c:pt>
                <c:pt idx="1496">
                  <c:v>6.1484777767996377</c:v>
                </c:pt>
                <c:pt idx="1497">
                  <c:v>0</c:v>
                </c:pt>
                <c:pt idx="1498">
                  <c:v>6.1484777767996377</c:v>
                </c:pt>
                <c:pt idx="1499">
                  <c:v>6.1484777767996377</c:v>
                </c:pt>
                <c:pt idx="1500">
                  <c:v>1.259169333276511</c:v>
                </c:pt>
                <c:pt idx="1501">
                  <c:v>1.259169333276511</c:v>
                </c:pt>
                <c:pt idx="1502">
                  <c:v>0</c:v>
                </c:pt>
                <c:pt idx="1503">
                  <c:v>1.259169333276511</c:v>
                </c:pt>
                <c:pt idx="1504">
                  <c:v>1.259169333276511</c:v>
                </c:pt>
                <c:pt idx="1505">
                  <c:v>0</c:v>
                </c:pt>
                <c:pt idx="1506">
                  <c:v>1.259169333276511</c:v>
                </c:pt>
                <c:pt idx="1507">
                  <c:v>1.259169333276511</c:v>
                </c:pt>
                <c:pt idx="1508">
                  <c:v>6.1484777767996377</c:v>
                </c:pt>
                <c:pt idx="1509">
                  <c:v>6.1484777767996377</c:v>
                </c:pt>
                <c:pt idx="1510">
                  <c:v>54.724767053831179</c:v>
                </c:pt>
                <c:pt idx="1511">
                  <c:v>54.724767053831179</c:v>
                </c:pt>
                <c:pt idx="1512">
                  <c:v>106.4548160226563</c:v>
                </c:pt>
                <c:pt idx="1513">
                  <c:v>106.4548160226563</c:v>
                </c:pt>
                <c:pt idx="1514">
                  <c:v>240.50247438932487</c:v>
                </c:pt>
                <c:pt idx="1515">
                  <c:v>240.50247438932487</c:v>
                </c:pt>
                <c:pt idx="1516">
                  <c:v>1198.9774649039789</c:v>
                </c:pt>
                <c:pt idx="1517">
                  <c:v>1198.9774649039789</c:v>
                </c:pt>
                <c:pt idx="1518">
                  <c:v>921.8705850871886</c:v>
                </c:pt>
                <c:pt idx="1519">
                  <c:v>921.8705850871886</c:v>
                </c:pt>
                <c:pt idx="1520">
                  <c:v>54.620630163870793</c:v>
                </c:pt>
                <c:pt idx="1521">
                  <c:v>54.620630163870793</c:v>
                </c:pt>
                <c:pt idx="1522">
                  <c:v>0.74700433322302318</c:v>
                </c:pt>
                <c:pt idx="1523">
                  <c:v>0.74700433322302318</c:v>
                </c:pt>
                <c:pt idx="1524">
                  <c:v>0</c:v>
                </c:pt>
                <c:pt idx="1525">
                  <c:v>0.74700433322302318</c:v>
                </c:pt>
                <c:pt idx="1526">
                  <c:v>0.74700433322302318</c:v>
                </c:pt>
                <c:pt idx="1527">
                  <c:v>0</c:v>
                </c:pt>
                <c:pt idx="1528">
                  <c:v>0.74700433322302318</c:v>
                </c:pt>
                <c:pt idx="1529">
                  <c:v>0.74700433322302318</c:v>
                </c:pt>
                <c:pt idx="1530">
                  <c:v>54.620630163870793</c:v>
                </c:pt>
                <c:pt idx="1531">
                  <c:v>54.620630163870793</c:v>
                </c:pt>
                <c:pt idx="1532">
                  <c:v>7.5916923329555344</c:v>
                </c:pt>
                <c:pt idx="1533">
                  <c:v>7.5916923329555344</c:v>
                </c:pt>
                <c:pt idx="1534">
                  <c:v>0</c:v>
                </c:pt>
                <c:pt idx="1535">
                  <c:v>7.5916923329555344</c:v>
                </c:pt>
                <c:pt idx="1536">
                  <c:v>7.5916923329555344</c:v>
                </c:pt>
                <c:pt idx="1537">
                  <c:v>0</c:v>
                </c:pt>
                <c:pt idx="1538">
                  <c:v>7.5916923329555344</c:v>
                </c:pt>
                <c:pt idx="1539">
                  <c:v>7.5916923329555344</c:v>
                </c:pt>
                <c:pt idx="1540">
                  <c:v>54.620630163870793</c:v>
                </c:pt>
                <c:pt idx="1541">
                  <c:v>54.620630163870793</c:v>
                </c:pt>
                <c:pt idx="1542">
                  <c:v>921.8705850871886</c:v>
                </c:pt>
                <c:pt idx="1543">
                  <c:v>921.8705850871886</c:v>
                </c:pt>
                <c:pt idx="1544">
                  <c:v>314.81705108999648</c:v>
                </c:pt>
                <c:pt idx="1545">
                  <c:v>314.81705108999648</c:v>
                </c:pt>
                <c:pt idx="1546">
                  <c:v>58.693789474072268</c:v>
                </c:pt>
                <c:pt idx="1547">
                  <c:v>58.693789474072268</c:v>
                </c:pt>
                <c:pt idx="1548">
                  <c:v>0</c:v>
                </c:pt>
                <c:pt idx="1549">
                  <c:v>58.693789474072268</c:v>
                </c:pt>
                <c:pt idx="1550">
                  <c:v>58.693789474072268</c:v>
                </c:pt>
                <c:pt idx="1551">
                  <c:v>18.160326165111886</c:v>
                </c:pt>
                <c:pt idx="1552">
                  <c:v>18.160326165111886</c:v>
                </c:pt>
                <c:pt idx="1553">
                  <c:v>0.93338233312448926</c:v>
                </c:pt>
                <c:pt idx="1554">
                  <c:v>0.93338233312448926</c:v>
                </c:pt>
                <c:pt idx="1555">
                  <c:v>0</c:v>
                </c:pt>
                <c:pt idx="1556">
                  <c:v>0.93338233312448926</c:v>
                </c:pt>
                <c:pt idx="1557">
                  <c:v>0.93338233312448926</c:v>
                </c:pt>
                <c:pt idx="1558">
                  <c:v>0</c:v>
                </c:pt>
                <c:pt idx="1559">
                  <c:v>0.93338233312448926</c:v>
                </c:pt>
                <c:pt idx="1560">
                  <c:v>0.93338233312448926</c:v>
                </c:pt>
                <c:pt idx="1561">
                  <c:v>18.160326165111886</c:v>
                </c:pt>
                <c:pt idx="1562">
                  <c:v>18.160326165111886</c:v>
                </c:pt>
                <c:pt idx="1563">
                  <c:v>2.1231094993955533</c:v>
                </c:pt>
                <c:pt idx="1564">
                  <c:v>2.1231094993955533</c:v>
                </c:pt>
                <c:pt idx="1565">
                  <c:v>0.36984133315820045</c:v>
                </c:pt>
                <c:pt idx="1566">
                  <c:v>0.36984133315820045</c:v>
                </c:pt>
                <c:pt idx="1567">
                  <c:v>0</c:v>
                </c:pt>
                <c:pt idx="1568">
                  <c:v>0.36984133315820045</c:v>
                </c:pt>
                <c:pt idx="1569">
                  <c:v>0.36984133315820045</c:v>
                </c:pt>
                <c:pt idx="1570">
                  <c:v>0</c:v>
                </c:pt>
                <c:pt idx="1571">
                  <c:v>0.36984133315820045</c:v>
                </c:pt>
                <c:pt idx="1572">
                  <c:v>0.36984133315820045</c:v>
                </c:pt>
                <c:pt idx="1573">
                  <c:v>2.1231094993955533</c:v>
                </c:pt>
                <c:pt idx="1574">
                  <c:v>2.1231094993955533</c:v>
                </c:pt>
                <c:pt idx="1575">
                  <c:v>0.62482299971636779</c:v>
                </c:pt>
                <c:pt idx="1576">
                  <c:v>0.62482299971636779</c:v>
                </c:pt>
                <c:pt idx="1577">
                  <c:v>0</c:v>
                </c:pt>
                <c:pt idx="1578">
                  <c:v>0.62482299971636779</c:v>
                </c:pt>
                <c:pt idx="1579">
                  <c:v>0.62482299971636779</c:v>
                </c:pt>
                <c:pt idx="1580">
                  <c:v>0</c:v>
                </c:pt>
                <c:pt idx="1581">
                  <c:v>0.62482299971636779</c:v>
                </c:pt>
                <c:pt idx="1582">
                  <c:v>0.62482299971636779</c:v>
                </c:pt>
                <c:pt idx="1583">
                  <c:v>2.1231094993955533</c:v>
                </c:pt>
                <c:pt idx="1584">
                  <c:v>2.1231094993955533</c:v>
                </c:pt>
                <c:pt idx="1585">
                  <c:v>18.160326165111886</c:v>
                </c:pt>
                <c:pt idx="1586">
                  <c:v>18.160326165111886</c:v>
                </c:pt>
                <c:pt idx="1587">
                  <c:v>58.693789474072268</c:v>
                </c:pt>
                <c:pt idx="1588">
                  <c:v>58.693789474072268</c:v>
                </c:pt>
                <c:pt idx="1589">
                  <c:v>314.81705108999648</c:v>
                </c:pt>
                <c:pt idx="1590">
                  <c:v>314.81705108999648</c:v>
                </c:pt>
                <c:pt idx="1591">
                  <c:v>106.47234568521262</c:v>
                </c:pt>
                <c:pt idx="1592">
                  <c:v>106.47234568521262</c:v>
                </c:pt>
                <c:pt idx="1593">
                  <c:v>0</c:v>
                </c:pt>
                <c:pt idx="1594">
                  <c:v>106.47234568521262</c:v>
                </c:pt>
                <c:pt idx="1595">
                  <c:v>106.47234568521262</c:v>
                </c:pt>
                <c:pt idx="1596">
                  <c:v>47.561046420445187</c:v>
                </c:pt>
                <c:pt idx="1597">
                  <c:v>47.561046420445187</c:v>
                </c:pt>
                <c:pt idx="1598">
                  <c:v>6.989417444191572</c:v>
                </c:pt>
                <c:pt idx="1599">
                  <c:v>6.989417444191572</c:v>
                </c:pt>
                <c:pt idx="1600">
                  <c:v>0</c:v>
                </c:pt>
                <c:pt idx="1601">
                  <c:v>6.989417444191572</c:v>
                </c:pt>
                <c:pt idx="1602">
                  <c:v>6.989417444191572</c:v>
                </c:pt>
                <c:pt idx="1603">
                  <c:v>1.9465043328606197</c:v>
                </c:pt>
                <c:pt idx="1604">
                  <c:v>1.9465043328606197</c:v>
                </c:pt>
                <c:pt idx="1605">
                  <c:v>0</c:v>
                </c:pt>
                <c:pt idx="1606">
                  <c:v>1.9465043328606197</c:v>
                </c:pt>
                <c:pt idx="1607">
                  <c:v>1.9465043328606197</c:v>
                </c:pt>
                <c:pt idx="1608">
                  <c:v>0</c:v>
                </c:pt>
                <c:pt idx="1609">
                  <c:v>1.9465043328606197</c:v>
                </c:pt>
                <c:pt idx="1610">
                  <c:v>1.9465043328606197</c:v>
                </c:pt>
                <c:pt idx="1611">
                  <c:v>6.989417444191572</c:v>
                </c:pt>
                <c:pt idx="1612">
                  <c:v>6.989417444191572</c:v>
                </c:pt>
                <c:pt idx="1613">
                  <c:v>47.561046420445187</c:v>
                </c:pt>
                <c:pt idx="1614">
                  <c:v>47.561046420445187</c:v>
                </c:pt>
                <c:pt idx="1615">
                  <c:v>7.2541343332093557</c:v>
                </c:pt>
                <c:pt idx="1616">
                  <c:v>7.2541343332093557</c:v>
                </c:pt>
                <c:pt idx="1617">
                  <c:v>0</c:v>
                </c:pt>
                <c:pt idx="1618">
                  <c:v>7.2541343332093557</c:v>
                </c:pt>
                <c:pt idx="1619">
                  <c:v>7.2541343332093557</c:v>
                </c:pt>
                <c:pt idx="1620">
                  <c:v>0</c:v>
                </c:pt>
                <c:pt idx="1621">
                  <c:v>7.2541343332093557</c:v>
                </c:pt>
                <c:pt idx="1622">
                  <c:v>7.2541343332093557</c:v>
                </c:pt>
                <c:pt idx="1623">
                  <c:v>47.561046420445187</c:v>
                </c:pt>
                <c:pt idx="1624">
                  <c:v>47.561046420445187</c:v>
                </c:pt>
                <c:pt idx="1625">
                  <c:v>106.47234568521262</c:v>
                </c:pt>
                <c:pt idx="1626">
                  <c:v>106.47234568521262</c:v>
                </c:pt>
                <c:pt idx="1627">
                  <c:v>314.81705108999648</c:v>
                </c:pt>
                <c:pt idx="1628">
                  <c:v>314.81705108999648</c:v>
                </c:pt>
                <c:pt idx="1629">
                  <c:v>921.8705850871886</c:v>
                </c:pt>
                <c:pt idx="1630">
                  <c:v>921.8705850871886</c:v>
                </c:pt>
                <c:pt idx="1631">
                  <c:v>1198.9774649039789</c:v>
                </c:pt>
                <c:pt idx="1632">
                  <c:v>1198.9774649039789</c:v>
                </c:pt>
                <c:pt idx="1633">
                  <c:v>3645.1404425046776</c:v>
                </c:pt>
                <c:pt idx="1634">
                  <c:v>3645.1404425046776</c:v>
                </c:pt>
                <c:pt idx="1635">
                  <c:v>11199.997415993457</c:v>
                </c:pt>
                <c:pt idx="1636">
                  <c:v>11199.997415993457</c:v>
                </c:pt>
                <c:pt idx="1637">
                  <c:v>5417.5969832427882</c:v>
                </c:pt>
                <c:pt idx="1638">
                  <c:v>5417.5969832427882</c:v>
                </c:pt>
                <c:pt idx="1639">
                  <c:v>1707.1802273090707</c:v>
                </c:pt>
                <c:pt idx="1640">
                  <c:v>1707.1802273090707</c:v>
                </c:pt>
                <c:pt idx="1641">
                  <c:v>250.03791818379281</c:v>
                </c:pt>
                <c:pt idx="1642">
                  <c:v>250.03791818379281</c:v>
                </c:pt>
                <c:pt idx="1643">
                  <c:v>38.371577333116932</c:v>
                </c:pt>
                <c:pt idx="1644">
                  <c:v>38.371577333116932</c:v>
                </c:pt>
                <c:pt idx="1645">
                  <c:v>0</c:v>
                </c:pt>
                <c:pt idx="1646">
                  <c:v>38.371577333116932</c:v>
                </c:pt>
                <c:pt idx="1647">
                  <c:v>38.371577333116932</c:v>
                </c:pt>
                <c:pt idx="1648">
                  <c:v>6.4915359992816359</c:v>
                </c:pt>
                <c:pt idx="1649">
                  <c:v>6.4915359992816359</c:v>
                </c:pt>
                <c:pt idx="1650">
                  <c:v>0</c:v>
                </c:pt>
                <c:pt idx="1651">
                  <c:v>6.4915359992816359</c:v>
                </c:pt>
                <c:pt idx="1652">
                  <c:v>6.4915359992816359</c:v>
                </c:pt>
                <c:pt idx="1653">
                  <c:v>0</c:v>
                </c:pt>
                <c:pt idx="1654">
                  <c:v>6.4915359992816359</c:v>
                </c:pt>
                <c:pt idx="1655">
                  <c:v>6.4915359992816359</c:v>
                </c:pt>
                <c:pt idx="1656">
                  <c:v>38.371577333116932</c:v>
                </c:pt>
                <c:pt idx="1657">
                  <c:v>38.371577333116932</c:v>
                </c:pt>
                <c:pt idx="1658">
                  <c:v>250.03791818379281</c:v>
                </c:pt>
                <c:pt idx="1659">
                  <c:v>250.03791818379281</c:v>
                </c:pt>
                <c:pt idx="1660">
                  <c:v>112.62231014629279</c:v>
                </c:pt>
                <c:pt idx="1661">
                  <c:v>112.62231014629279</c:v>
                </c:pt>
                <c:pt idx="1662">
                  <c:v>15.690684099212049</c:v>
                </c:pt>
                <c:pt idx="1663">
                  <c:v>15.690684099212049</c:v>
                </c:pt>
                <c:pt idx="1664">
                  <c:v>0</c:v>
                </c:pt>
                <c:pt idx="1665">
                  <c:v>15.690684099212049</c:v>
                </c:pt>
                <c:pt idx="1666">
                  <c:v>15.690684099212049</c:v>
                </c:pt>
                <c:pt idx="1667">
                  <c:v>7.9171517210860554</c:v>
                </c:pt>
                <c:pt idx="1668">
                  <c:v>7.9171517210860554</c:v>
                </c:pt>
                <c:pt idx="1669">
                  <c:v>0</c:v>
                </c:pt>
                <c:pt idx="1670">
                  <c:v>7.9171517210860554</c:v>
                </c:pt>
                <c:pt idx="1671">
                  <c:v>7.9171517210860554</c:v>
                </c:pt>
                <c:pt idx="1672">
                  <c:v>2.332525444209673</c:v>
                </c:pt>
                <c:pt idx="1673">
                  <c:v>2.332525444209673</c:v>
                </c:pt>
                <c:pt idx="1674">
                  <c:v>0</c:v>
                </c:pt>
                <c:pt idx="1675">
                  <c:v>2.332525444209673</c:v>
                </c:pt>
                <c:pt idx="1676">
                  <c:v>2.332525444209673</c:v>
                </c:pt>
                <c:pt idx="1677">
                  <c:v>0.15840233318149613</c:v>
                </c:pt>
                <c:pt idx="1678">
                  <c:v>0.15840233318149613</c:v>
                </c:pt>
                <c:pt idx="1679">
                  <c:v>0</c:v>
                </c:pt>
                <c:pt idx="1680">
                  <c:v>0.15840233318149613</c:v>
                </c:pt>
                <c:pt idx="1681">
                  <c:v>0.15840233318149613</c:v>
                </c:pt>
                <c:pt idx="1682">
                  <c:v>0</c:v>
                </c:pt>
                <c:pt idx="1683">
                  <c:v>0.15840233318149613</c:v>
                </c:pt>
                <c:pt idx="1684">
                  <c:v>0.15840233318149613</c:v>
                </c:pt>
                <c:pt idx="1685">
                  <c:v>2.332525444209673</c:v>
                </c:pt>
                <c:pt idx="1686">
                  <c:v>2.332525444209673</c:v>
                </c:pt>
                <c:pt idx="1687">
                  <c:v>7.9171517210860554</c:v>
                </c:pt>
                <c:pt idx="1688">
                  <c:v>7.9171517210860554</c:v>
                </c:pt>
                <c:pt idx="1689">
                  <c:v>15.690684099212049</c:v>
                </c:pt>
                <c:pt idx="1690">
                  <c:v>15.690684099212049</c:v>
                </c:pt>
                <c:pt idx="1691">
                  <c:v>112.62231014629279</c:v>
                </c:pt>
                <c:pt idx="1692">
                  <c:v>112.62231014629279</c:v>
                </c:pt>
                <c:pt idx="1693">
                  <c:v>18.346047998968562</c:v>
                </c:pt>
                <c:pt idx="1694">
                  <c:v>18.346047998968562</c:v>
                </c:pt>
                <c:pt idx="1695">
                  <c:v>0</c:v>
                </c:pt>
                <c:pt idx="1696">
                  <c:v>18.346047998968562</c:v>
                </c:pt>
                <c:pt idx="1697">
                  <c:v>18.346047998968562</c:v>
                </c:pt>
                <c:pt idx="1698">
                  <c:v>8.1743573328047123</c:v>
                </c:pt>
                <c:pt idx="1699">
                  <c:v>8.1743573328047123</c:v>
                </c:pt>
                <c:pt idx="1700">
                  <c:v>0</c:v>
                </c:pt>
                <c:pt idx="1701">
                  <c:v>8.1743573328047123</c:v>
                </c:pt>
                <c:pt idx="1702">
                  <c:v>8.1743573328047123</c:v>
                </c:pt>
                <c:pt idx="1703">
                  <c:v>0</c:v>
                </c:pt>
                <c:pt idx="1704">
                  <c:v>8.1743573328047123</c:v>
                </c:pt>
                <c:pt idx="1705">
                  <c:v>8.1743573328047123</c:v>
                </c:pt>
                <c:pt idx="1706">
                  <c:v>18.346047998968562</c:v>
                </c:pt>
                <c:pt idx="1707">
                  <c:v>18.346047998968562</c:v>
                </c:pt>
                <c:pt idx="1708">
                  <c:v>112.62231014629279</c:v>
                </c:pt>
                <c:pt idx="1709">
                  <c:v>112.62231014629279</c:v>
                </c:pt>
                <c:pt idx="1710">
                  <c:v>250.03791818379281</c:v>
                </c:pt>
                <c:pt idx="1711">
                  <c:v>250.03791818379281</c:v>
                </c:pt>
                <c:pt idx="1712">
                  <c:v>1707.1802273090707</c:v>
                </c:pt>
                <c:pt idx="1713">
                  <c:v>1707.1802273090707</c:v>
                </c:pt>
                <c:pt idx="1714">
                  <c:v>512.95160217644991</c:v>
                </c:pt>
                <c:pt idx="1715">
                  <c:v>512.95160217644991</c:v>
                </c:pt>
                <c:pt idx="1716">
                  <c:v>52.067602332156035</c:v>
                </c:pt>
                <c:pt idx="1717">
                  <c:v>52.067602332156035</c:v>
                </c:pt>
                <c:pt idx="1718">
                  <c:v>0</c:v>
                </c:pt>
                <c:pt idx="1719">
                  <c:v>52.067602332156035</c:v>
                </c:pt>
                <c:pt idx="1720">
                  <c:v>52.067602332156035</c:v>
                </c:pt>
                <c:pt idx="1721">
                  <c:v>0</c:v>
                </c:pt>
                <c:pt idx="1722">
                  <c:v>52.067602332156035</c:v>
                </c:pt>
                <c:pt idx="1723">
                  <c:v>52.067602332156035</c:v>
                </c:pt>
                <c:pt idx="1724">
                  <c:v>512.95160217644991</c:v>
                </c:pt>
                <c:pt idx="1725">
                  <c:v>512.95160217644991</c:v>
                </c:pt>
                <c:pt idx="1726">
                  <c:v>61.549511538123731</c:v>
                </c:pt>
                <c:pt idx="1727">
                  <c:v>61.549511538123731</c:v>
                </c:pt>
                <c:pt idx="1728">
                  <c:v>9.631712249520815</c:v>
                </c:pt>
                <c:pt idx="1729">
                  <c:v>9.631712249520815</c:v>
                </c:pt>
                <c:pt idx="1730">
                  <c:v>0</c:v>
                </c:pt>
                <c:pt idx="1731">
                  <c:v>9.631712249520815</c:v>
                </c:pt>
                <c:pt idx="1732">
                  <c:v>9.631712249520815</c:v>
                </c:pt>
                <c:pt idx="1733">
                  <c:v>0</c:v>
                </c:pt>
                <c:pt idx="1734">
                  <c:v>9.631712249520815</c:v>
                </c:pt>
                <c:pt idx="1735">
                  <c:v>9.631712249520815</c:v>
                </c:pt>
                <c:pt idx="1736">
                  <c:v>61.549511538123731</c:v>
                </c:pt>
                <c:pt idx="1737">
                  <c:v>61.549511538123731</c:v>
                </c:pt>
                <c:pt idx="1738">
                  <c:v>15.881562999977506</c:v>
                </c:pt>
                <c:pt idx="1739">
                  <c:v>15.881562999977506</c:v>
                </c:pt>
                <c:pt idx="1740">
                  <c:v>0</c:v>
                </c:pt>
                <c:pt idx="1741">
                  <c:v>15.881562999977506</c:v>
                </c:pt>
                <c:pt idx="1742">
                  <c:v>15.881562999977506</c:v>
                </c:pt>
                <c:pt idx="1743">
                  <c:v>0</c:v>
                </c:pt>
                <c:pt idx="1744">
                  <c:v>15.881562999977506</c:v>
                </c:pt>
                <c:pt idx="1745">
                  <c:v>15.881562999977506</c:v>
                </c:pt>
                <c:pt idx="1746">
                  <c:v>61.549511538123731</c:v>
                </c:pt>
                <c:pt idx="1747">
                  <c:v>61.549511538123731</c:v>
                </c:pt>
                <c:pt idx="1748">
                  <c:v>512.95160217644991</c:v>
                </c:pt>
                <c:pt idx="1749">
                  <c:v>512.95160217644991</c:v>
                </c:pt>
                <c:pt idx="1750">
                  <c:v>1707.1802273090707</c:v>
                </c:pt>
                <c:pt idx="1751">
                  <c:v>1707.1802273090707</c:v>
                </c:pt>
                <c:pt idx="1752">
                  <c:v>5417.5969832427882</c:v>
                </c:pt>
                <c:pt idx="1753">
                  <c:v>5417.5969832427882</c:v>
                </c:pt>
                <c:pt idx="1754">
                  <c:v>2579.2613701721275</c:v>
                </c:pt>
                <c:pt idx="1755">
                  <c:v>2579.2613701721275</c:v>
                </c:pt>
                <c:pt idx="1756">
                  <c:v>253.960220441449</c:v>
                </c:pt>
                <c:pt idx="1757">
                  <c:v>253.960220441449</c:v>
                </c:pt>
                <c:pt idx="1758">
                  <c:v>0</c:v>
                </c:pt>
                <c:pt idx="1759">
                  <c:v>253.960220441449</c:v>
                </c:pt>
                <c:pt idx="1760">
                  <c:v>253.960220441449</c:v>
                </c:pt>
                <c:pt idx="1761">
                  <c:v>65.157841330364946</c:v>
                </c:pt>
                <c:pt idx="1762">
                  <c:v>65.157841330364946</c:v>
                </c:pt>
                <c:pt idx="1763">
                  <c:v>0</c:v>
                </c:pt>
                <c:pt idx="1764">
                  <c:v>65.157841330364946</c:v>
                </c:pt>
                <c:pt idx="1765">
                  <c:v>65.157841330364946</c:v>
                </c:pt>
                <c:pt idx="1766">
                  <c:v>0</c:v>
                </c:pt>
                <c:pt idx="1767">
                  <c:v>65.157841330364946</c:v>
                </c:pt>
                <c:pt idx="1768">
                  <c:v>65.157841330364946</c:v>
                </c:pt>
                <c:pt idx="1769">
                  <c:v>253.960220441449</c:v>
                </c:pt>
                <c:pt idx="1770">
                  <c:v>253.960220441449</c:v>
                </c:pt>
                <c:pt idx="1771">
                  <c:v>2579.2613701721275</c:v>
                </c:pt>
                <c:pt idx="1772">
                  <c:v>2579.2613701721275</c:v>
                </c:pt>
                <c:pt idx="1773">
                  <c:v>1084.3774483027876</c:v>
                </c:pt>
                <c:pt idx="1774">
                  <c:v>1084.3774483027876</c:v>
                </c:pt>
                <c:pt idx="1775">
                  <c:v>101.12654892970849</c:v>
                </c:pt>
                <c:pt idx="1776">
                  <c:v>101.12654892970849</c:v>
                </c:pt>
                <c:pt idx="1777">
                  <c:v>0</c:v>
                </c:pt>
                <c:pt idx="1778">
                  <c:v>101.12654892970849</c:v>
                </c:pt>
                <c:pt idx="1779">
                  <c:v>101.12654892970849</c:v>
                </c:pt>
                <c:pt idx="1780">
                  <c:v>56.234992665048509</c:v>
                </c:pt>
                <c:pt idx="1781">
                  <c:v>56.234992665048509</c:v>
                </c:pt>
                <c:pt idx="1782">
                  <c:v>6.4361463330444568</c:v>
                </c:pt>
                <c:pt idx="1783">
                  <c:v>6.4361463330444568</c:v>
                </c:pt>
                <c:pt idx="1784">
                  <c:v>0</c:v>
                </c:pt>
                <c:pt idx="1785">
                  <c:v>6.4361463330444568</c:v>
                </c:pt>
                <c:pt idx="1786">
                  <c:v>6.4361463330444568</c:v>
                </c:pt>
                <c:pt idx="1787">
                  <c:v>0</c:v>
                </c:pt>
                <c:pt idx="1788">
                  <c:v>6.4361463330444568</c:v>
                </c:pt>
                <c:pt idx="1789">
                  <c:v>6.4361463330444568</c:v>
                </c:pt>
                <c:pt idx="1790">
                  <c:v>56.234992665048509</c:v>
                </c:pt>
                <c:pt idx="1791">
                  <c:v>56.234992665048509</c:v>
                </c:pt>
                <c:pt idx="1792">
                  <c:v>19.246140333292313</c:v>
                </c:pt>
                <c:pt idx="1793">
                  <c:v>19.246140333292313</c:v>
                </c:pt>
                <c:pt idx="1794">
                  <c:v>0</c:v>
                </c:pt>
                <c:pt idx="1795">
                  <c:v>19.246140333292313</c:v>
                </c:pt>
                <c:pt idx="1796">
                  <c:v>19.246140333292313</c:v>
                </c:pt>
                <c:pt idx="1797">
                  <c:v>0</c:v>
                </c:pt>
                <c:pt idx="1798">
                  <c:v>19.246140333292313</c:v>
                </c:pt>
                <c:pt idx="1799">
                  <c:v>19.246140333292313</c:v>
                </c:pt>
                <c:pt idx="1800">
                  <c:v>56.234992665048509</c:v>
                </c:pt>
                <c:pt idx="1801">
                  <c:v>56.234992665048509</c:v>
                </c:pt>
                <c:pt idx="1802">
                  <c:v>101.12654892970849</c:v>
                </c:pt>
                <c:pt idx="1803">
                  <c:v>101.12654892970849</c:v>
                </c:pt>
                <c:pt idx="1804">
                  <c:v>1084.3774483027876</c:v>
                </c:pt>
                <c:pt idx="1805">
                  <c:v>1084.3774483027876</c:v>
                </c:pt>
                <c:pt idx="1806">
                  <c:v>315.55808433177617</c:v>
                </c:pt>
                <c:pt idx="1807">
                  <c:v>315.55808433177617</c:v>
                </c:pt>
                <c:pt idx="1808">
                  <c:v>0</c:v>
                </c:pt>
                <c:pt idx="1809">
                  <c:v>315.55808433177617</c:v>
                </c:pt>
                <c:pt idx="1810">
                  <c:v>315.55808433177617</c:v>
                </c:pt>
                <c:pt idx="1811">
                  <c:v>36.189274332621785</c:v>
                </c:pt>
                <c:pt idx="1812">
                  <c:v>36.189274332621785</c:v>
                </c:pt>
                <c:pt idx="1813">
                  <c:v>0</c:v>
                </c:pt>
                <c:pt idx="1814">
                  <c:v>36.189274332621785</c:v>
                </c:pt>
                <c:pt idx="1815">
                  <c:v>36.189274332621785</c:v>
                </c:pt>
                <c:pt idx="1816">
                  <c:v>0</c:v>
                </c:pt>
                <c:pt idx="1817">
                  <c:v>36.189274332621785</c:v>
                </c:pt>
                <c:pt idx="1818">
                  <c:v>36.189274332621785</c:v>
                </c:pt>
                <c:pt idx="1819">
                  <c:v>315.55808433177617</c:v>
                </c:pt>
                <c:pt idx="1820">
                  <c:v>315.55808433177617</c:v>
                </c:pt>
                <c:pt idx="1821">
                  <c:v>1084.3774483027876</c:v>
                </c:pt>
                <c:pt idx="1822">
                  <c:v>1084.3774483027876</c:v>
                </c:pt>
                <c:pt idx="1823">
                  <c:v>2579.2613701721275</c:v>
                </c:pt>
                <c:pt idx="1824">
                  <c:v>2579.2613701721275</c:v>
                </c:pt>
                <c:pt idx="1825">
                  <c:v>5417.5969832427882</c:v>
                </c:pt>
                <c:pt idx="1826">
                  <c:v>5417.5969832427882</c:v>
                </c:pt>
                <c:pt idx="1827">
                  <c:v>11199.997415993457</c:v>
                </c:pt>
                <c:pt idx="1828">
                  <c:v>11199.997415993457</c:v>
                </c:pt>
                <c:pt idx="1829">
                  <c:v>12471.857801702843</c:v>
                </c:pt>
                <c:pt idx="1830">
                  <c:v>12471.857801702843</c:v>
                </c:pt>
                <c:pt idx="1831">
                  <c:v>39475.474459660378</c:v>
                </c:pt>
                <c:pt idx="1832">
                  <c:v>39475.474459660378</c:v>
                </c:pt>
                <c:pt idx="1833">
                  <c:v>86654.22770028995</c:v>
                </c:pt>
                <c:pt idx="1834">
                  <c:v>86654.22770028995</c:v>
                </c:pt>
                <c:pt idx="1835">
                  <c:v>200621.29612376681</c:v>
                </c:pt>
                <c:pt idx="1836">
                  <c:v>200621.29612376681</c:v>
                </c:pt>
                <c:pt idx="1837">
                  <c:v>377798.14037419687</c:v>
                </c:pt>
                <c:pt idx="1838">
                  <c:v>377798.14037419687</c:v>
                </c:pt>
                <c:pt idx="1839">
                  <c:v>1927243.1893264481</c:v>
                </c:pt>
                <c:pt idx="1840">
                  <c:v>1927243.1893264481</c:v>
                </c:pt>
                <c:pt idx="1841">
                  <c:v>2469162.2866536854</c:v>
                </c:pt>
                <c:pt idx="1842">
                  <c:v>2469162.2866536854</c:v>
                </c:pt>
                <c:pt idx="1843">
                  <c:v>27284479.657797121</c:v>
                </c:pt>
                <c:pt idx="1844">
                  <c:v>27284479.657797121</c:v>
                </c:pt>
                <c:pt idx="1845">
                  <c:v>8687055.4057223592</c:v>
                </c:pt>
                <c:pt idx="1846">
                  <c:v>8687055.4057223592</c:v>
                </c:pt>
                <c:pt idx="1847">
                  <c:v>1520475.901665278</c:v>
                </c:pt>
                <c:pt idx="1848">
                  <c:v>1520475.901665278</c:v>
                </c:pt>
                <c:pt idx="1849">
                  <c:v>334644.43536759279</c:v>
                </c:pt>
                <c:pt idx="1850">
                  <c:v>334644.43536759279</c:v>
                </c:pt>
                <c:pt idx="1851">
                  <c:v>25111.587420448421</c:v>
                </c:pt>
                <c:pt idx="1852">
                  <c:v>25111.587420448421</c:v>
                </c:pt>
                <c:pt idx="1853">
                  <c:v>0</c:v>
                </c:pt>
                <c:pt idx="1854">
                  <c:v>25111.587420448421</c:v>
                </c:pt>
                <c:pt idx="1855">
                  <c:v>25111.587420448421</c:v>
                </c:pt>
                <c:pt idx="1856">
                  <c:v>11838.8043159873</c:v>
                </c:pt>
                <c:pt idx="1857">
                  <c:v>11838.8043159873</c:v>
                </c:pt>
                <c:pt idx="1858">
                  <c:v>0</c:v>
                </c:pt>
                <c:pt idx="1859">
                  <c:v>11838.8043159873</c:v>
                </c:pt>
                <c:pt idx="1860">
                  <c:v>11838.8043159873</c:v>
                </c:pt>
                <c:pt idx="1861">
                  <c:v>3969.4157493176081</c:v>
                </c:pt>
                <c:pt idx="1862">
                  <c:v>3969.4157493176081</c:v>
                </c:pt>
                <c:pt idx="1863">
                  <c:v>0</c:v>
                </c:pt>
                <c:pt idx="1864">
                  <c:v>3969.4157493176081</c:v>
                </c:pt>
                <c:pt idx="1865">
                  <c:v>3969.4157493176081</c:v>
                </c:pt>
                <c:pt idx="1866">
                  <c:v>0</c:v>
                </c:pt>
                <c:pt idx="1867">
                  <c:v>3969.4157493176081</c:v>
                </c:pt>
                <c:pt idx="1868">
                  <c:v>3969.4157493176081</c:v>
                </c:pt>
                <c:pt idx="1869">
                  <c:v>11838.8043159873</c:v>
                </c:pt>
                <c:pt idx="1870">
                  <c:v>11838.8043159873</c:v>
                </c:pt>
                <c:pt idx="1871">
                  <c:v>25111.587420448421</c:v>
                </c:pt>
                <c:pt idx="1872">
                  <c:v>25111.587420448421</c:v>
                </c:pt>
                <c:pt idx="1873">
                  <c:v>334644.43536759279</c:v>
                </c:pt>
                <c:pt idx="1874">
                  <c:v>334644.43536759279</c:v>
                </c:pt>
                <c:pt idx="1875">
                  <c:v>81213.168720579662</c:v>
                </c:pt>
                <c:pt idx="1876">
                  <c:v>81213.168720579662</c:v>
                </c:pt>
                <c:pt idx="1877">
                  <c:v>6376.3523143209586</c:v>
                </c:pt>
                <c:pt idx="1878">
                  <c:v>6376.3523143209586</c:v>
                </c:pt>
                <c:pt idx="1879">
                  <c:v>0</c:v>
                </c:pt>
                <c:pt idx="1880">
                  <c:v>6376.3523143209586</c:v>
                </c:pt>
                <c:pt idx="1881">
                  <c:v>6376.3523143209586</c:v>
                </c:pt>
                <c:pt idx="1882">
                  <c:v>0</c:v>
                </c:pt>
                <c:pt idx="1883">
                  <c:v>6376.3523143209586</c:v>
                </c:pt>
                <c:pt idx="1884">
                  <c:v>6376.3523143209586</c:v>
                </c:pt>
                <c:pt idx="1885">
                  <c:v>81213.168720579662</c:v>
                </c:pt>
                <c:pt idx="1886">
                  <c:v>81213.168720579662</c:v>
                </c:pt>
                <c:pt idx="1887">
                  <c:v>7458.3910869809315</c:v>
                </c:pt>
                <c:pt idx="1888">
                  <c:v>7458.3910869809315</c:v>
                </c:pt>
                <c:pt idx="1889">
                  <c:v>0</c:v>
                </c:pt>
                <c:pt idx="1890">
                  <c:v>7458.3910869809315</c:v>
                </c:pt>
                <c:pt idx="1891">
                  <c:v>7458.3910869809315</c:v>
                </c:pt>
                <c:pt idx="1892">
                  <c:v>0</c:v>
                </c:pt>
                <c:pt idx="1893">
                  <c:v>7458.3910869809315</c:v>
                </c:pt>
                <c:pt idx="1894">
                  <c:v>7458.3910869809315</c:v>
                </c:pt>
                <c:pt idx="1895">
                  <c:v>81213.168720579662</c:v>
                </c:pt>
                <c:pt idx="1896">
                  <c:v>81213.168720579662</c:v>
                </c:pt>
                <c:pt idx="1897">
                  <c:v>334644.43536759279</c:v>
                </c:pt>
                <c:pt idx="1898">
                  <c:v>334644.43536759279</c:v>
                </c:pt>
                <c:pt idx="1899">
                  <c:v>1520475.901665278</c:v>
                </c:pt>
                <c:pt idx="1900">
                  <c:v>1520475.901665278</c:v>
                </c:pt>
                <c:pt idx="1901">
                  <c:v>423930.68500050658</c:v>
                </c:pt>
                <c:pt idx="1902">
                  <c:v>423930.68500050658</c:v>
                </c:pt>
                <c:pt idx="1903">
                  <c:v>32532.228544299302</c:v>
                </c:pt>
                <c:pt idx="1904">
                  <c:v>32532.228544299302</c:v>
                </c:pt>
                <c:pt idx="1905">
                  <c:v>0</c:v>
                </c:pt>
                <c:pt idx="1906">
                  <c:v>32532.228544299302</c:v>
                </c:pt>
                <c:pt idx="1907">
                  <c:v>32532.228544299302</c:v>
                </c:pt>
                <c:pt idx="1908">
                  <c:v>0</c:v>
                </c:pt>
                <c:pt idx="1909">
                  <c:v>32532.228544299302</c:v>
                </c:pt>
                <c:pt idx="1910">
                  <c:v>32532.228544299302</c:v>
                </c:pt>
                <c:pt idx="1911">
                  <c:v>423930.68500050658</c:v>
                </c:pt>
                <c:pt idx="1912">
                  <c:v>423930.68500050658</c:v>
                </c:pt>
                <c:pt idx="1913">
                  <c:v>53054.933194297198</c:v>
                </c:pt>
                <c:pt idx="1914">
                  <c:v>53054.933194297198</c:v>
                </c:pt>
                <c:pt idx="1915">
                  <c:v>0</c:v>
                </c:pt>
                <c:pt idx="1916">
                  <c:v>53054.933194297198</c:v>
                </c:pt>
                <c:pt idx="1917">
                  <c:v>53054.933194297198</c:v>
                </c:pt>
                <c:pt idx="1918">
                  <c:v>0</c:v>
                </c:pt>
                <c:pt idx="1919">
                  <c:v>53054.933194297198</c:v>
                </c:pt>
                <c:pt idx="1920">
                  <c:v>53054.933194297198</c:v>
                </c:pt>
                <c:pt idx="1921">
                  <c:v>423930.68500050658</c:v>
                </c:pt>
                <c:pt idx="1922">
                  <c:v>423930.68500050658</c:v>
                </c:pt>
                <c:pt idx="1923">
                  <c:v>1520475.901665278</c:v>
                </c:pt>
                <c:pt idx="1924">
                  <c:v>1520475.901665278</c:v>
                </c:pt>
                <c:pt idx="1925">
                  <c:v>8687055.4057223592</c:v>
                </c:pt>
                <c:pt idx="1926">
                  <c:v>8687055.4057223592</c:v>
                </c:pt>
                <c:pt idx="1927">
                  <c:v>2941248.1491049239</c:v>
                </c:pt>
                <c:pt idx="1928">
                  <c:v>2941248.1491049239</c:v>
                </c:pt>
                <c:pt idx="1929">
                  <c:v>745894.9084691602</c:v>
                </c:pt>
                <c:pt idx="1930">
                  <c:v>745894.9084691602</c:v>
                </c:pt>
                <c:pt idx="1931">
                  <c:v>26973.145459096384</c:v>
                </c:pt>
                <c:pt idx="1932">
                  <c:v>26973.145459096384</c:v>
                </c:pt>
                <c:pt idx="1933">
                  <c:v>0</c:v>
                </c:pt>
                <c:pt idx="1934">
                  <c:v>26973.145459096384</c:v>
                </c:pt>
                <c:pt idx="1935">
                  <c:v>26973.145459096384</c:v>
                </c:pt>
                <c:pt idx="1936">
                  <c:v>2781.3934493230727</c:v>
                </c:pt>
                <c:pt idx="1937">
                  <c:v>2781.3934493230727</c:v>
                </c:pt>
                <c:pt idx="1938">
                  <c:v>0</c:v>
                </c:pt>
                <c:pt idx="1939">
                  <c:v>2781.3934493230727</c:v>
                </c:pt>
                <c:pt idx="1940">
                  <c:v>2781.3934493230727</c:v>
                </c:pt>
                <c:pt idx="1941">
                  <c:v>0</c:v>
                </c:pt>
                <c:pt idx="1942">
                  <c:v>2781.3934493230727</c:v>
                </c:pt>
                <c:pt idx="1943">
                  <c:v>2781.3934493230727</c:v>
                </c:pt>
                <c:pt idx="1944">
                  <c:v>26973.145459096384</c:v>
                </c:pt>
                <c:pt idx="1945">
                  <c:v>26973.145459096384</c:v>
                </c:pt>
                <c:pt idx="1946">
                  <c:v>745894.9084691602</c:v>
                </c:pt>
                <c:pt idx="1947">
                  <c:v>745894.9084691602</c:v>
                </c:pt>
                <c:pt idx="1948">
                  <c:v>50162.808480697408</c:v>
                </c:pt>
                <c:pt idx="1949">
                  <c:v>50162.808480697408</c:v>
                </c:pt>
                <c:pt idx="1950">
                  <c:v>0</c:v>
                </c:pt>
                <c:pt idx="1951">
                  <c:v>50162.808480697408</c:v>
                </c:pt>
                <c:pt idx="1952">
                  <c:v>50162.808480697408</c:v>
                </c:pt>
                <c:pt idx="1953">
                  <c:v>11729.377296328103</c:v>
                </c:pt>
                <c:pt idx="1954">
                  <c:v>11729.377296328103</c:v>
                </c:pt>
                <c:pt idx="1955">
                  <c:v>0</c:v>
                </c:pt>
                <c:pt idx="1956">
                  <c:v>11729.377296328103</c:v>
                </c:pt>
                <c:pt idx="1957">
                  <c:v>11729.377296328103</c:v>
                </c:pt>
                <c:pt idx="1958">
                  <c:v>0</c:v>
                </c:pt>
                <c:pt idx="1959">
                  <c:v>11729.377296328103</c:v>
                </c:pt>
                <c:pt idx="1960">
                  <c:v>11729.377296328103</c:v>
                </c:pt>
                <c:pt idx="1961">
                  <c:v>50162.808480697408</c:v>
                </c:pt>
                <c:pt idx="1962">
                  <c:v>50162.808480697408</c:v>
                </c:pt>
                <c:pt idx="1963">
                  <c:v>745894.9084691602</c:v>
                </c:pt>
                <c:pt idx="1964">
                  <c:v>745894.9084691602</c:v>
                </c:pt>
                <c:pt idx="1965">
                  <c:v>2941248.1491049239</c:v>
                </c:pt>
                <c:pt idx="1966">
                  <c:v>2941248.1491049239</c:v>
                </c:pt>
                <c:pt idx="1967">
                  <c:v>1001975.1058724273</c:v>
                </c:pt>
                <c:pt idx="1968">
                  <c:v>1001975.1058724273</c:v>
                </c:pt>
                <c:pt idx="1969">
                  <c:v>42462.027820288073</c:v>
                </c:pt>
                <c:pt idx="1970">
                  <c:v>42462.027820288073</c:v>
                </c:pt>
                <c:pt idx="1971">
                  <c:v>0</c:v>
                </c:pt>
                <c:pt idx="1972">
                  <c:v>42462.027820288073</c:v>
                </c:pt>
                <c:pt idx="1973">
                  <c:v>42462.027820288073</c:v>
                </c:pt>
                <c:pt idx="1974">
                  <c:v>0</c:v>
                </c:pt>
                <c:pt idx="1975">
                  <c:v>42462.027820288073</c:v>
                </c:pt>
                <c:pt idx="1976">
                  <c:v>42462.027820288073</c:v>
                </c:pt>
                <c:pt idx="1977">
                  <c:v>1001975.1058724273</c:v>
                </c:pt>
                <c:pt idx="1978">
                  <c:v>1001975.1058724273</c:v>
                </c:pt>
                <c:pt idx="1979">
                  <c:v>98180.214610020339</c:v>
                </c:pt>
                <c:pt idx="1980">
                  <c:v>98180.214610020339</c:v>
                </c:pt>
                <c:pt idx="1981">
                  <c:v>0</c:v>
                </c:pt>
                <c:pt idx="1982">
                  <c:v>98180.214610020339</c:v>
                </c:pt>
                <c:pt idx="1983">
                  <c:v>98180.214610020339</c:v>
                </c:pt>
                <c:pt idx="1984">
                  <c:v>24714.037984300558</c:v>
                </c:pt>
                <c:pt idx="1985">
                  <c:v>24714.037984300558</c:v>
                </c:pt>
                <c:pt idx="1986">
                  <c:v>0</c:v>
                </c:pt>
                <c:pt idx="1987">
                  <c:v>24714.037984300558</c:v>
                </c:pt>
                <c:pt idx="1988">
                  <c:v>24714.037984300558</c:v>
                </c:pt>
                <c:pt idx="1989">
                  <c:v>0</c:v>
                </c:pt>
                <c:pt idx="1990">
                  <c:v>24714.037984300558</c:v>
                </c:pt>
                <c:pt idx="1991">
                  <c:v>24714.037984300558</c:v>
                </c:pt>
                <c:pt idx="1992">
                  <c:v>98180.214610020339</c:v>
                </c:pt>
                <c:pt idx="1993">
                  <c:v>98180.214610020339</c:v>
                </c:pt>
                <c:pt idx="1994">
                  <c:v>1001975.1058724273</c:v>
                </c:pt>
                <c:pt idx="1995">
                  <c:v>1001975.1058724273</c:v>
                </c:pt>
                <c:pt idx="1996">
                  <c:v>2941248.1491049239</c:v>
                </c:pt>
                <c:pt idx="1997">
                  <c:v>2941248.1491049239</c:v>
                </c:pt>
                <c:pt idx="1998">
                  <c:v>8687055.4057223592</c:v>
                </c:pt>
                <c:pt idx="1999">
                  <c:v>8687055.4057223592</c:v>
                </c:pt>
                <c:pt idx="2000">
                  <c:v>27284479.657797121</c:v>
                </c:pt>
                <c:pt idx="2001">
                  <c:v>27284479.657797121</c:v>
                </c:pt>
                <c:pt idx="2002">
                  <c:v>50774218.630889751</c:v>
                </c:pt>
                <c:pt idx="2003">
                  <c:v>50774218.630889751</c:v>
                </c:pt>
                <c:pt idx="2004">
                  <c:v>119111018.21166036</c:v>
                </c:pt>
                <c:pt idx="2005">
                  <c:v>119111018.21166036</c:v>
                </c:pt>
                <c:pt idx="2006">
                  <c:v>318605164.94198072</c:v>
                </c:pt>
                <c:pt idx="2007">
                  <c:v>318605164.94198072</c:v>
                </c:pt>
                <c:pt idx="2008">
                  <c:v>151483842.25287032</c:v>
                </c:pt>
                <c:pt idx="2009">
                  <c:v>151483842.25287032</c:v>
                </c:pt>
                <c:pt idx="2010">
                  <c:v>26420281.166910913</c:v>
                </c:pt>
                <c:pt idx="2011">
                  <c:v>26420281.166910913</c:v>
                </c:pt>
                <c:pt idx="2012">
                  <c:v>4649981.1138915354</c:v>
                </c:pt>
                <c:pt idx="2013">
                  <c:v>4649981.1138915354</c:v>
                </c:pt>
                <c:pt idx="2014">
                  <c:v>0</c:v>
                </c:pt>
                <c:pt idx="2015">
                  <c:v>4649981.1138915354</c:v>
                </c:pt>
                <c:pt idx="2016">
                  <c:v>4649981.1138915354</c:v>
                </c:pt>
                <c:pt idx="2017">
                  <c:v>0</c:v>
                </c:pt>
                <c:pt idx="2018">
                  <c:v>4649981.1138915354</c:v>
                </c:pt>
                <c:pt idx="2019">
                  <c:v>4649981.1138915354</c:v>
                </c:pt>
                <c:pt idx="2020">
                  <c:v>26420281.166910913</c:v>
                </c:pt>
                <c:pt idx="2021">
                  <c:v>26420281.166910913</c:v>
                </c:pt>
                <c:pt idx="2022">
                  <c:v>6635592.8173878696</c:v>
                </c:pt>
                <c:pt idx="2023">
                  <c:v>6635592.8173878696</c:v>
                </c:pt>
                <c:pt idx="2024">
                  <c:v>0</c:v>
                </c:pt>
                <c:pt idx="2025">
                  <c:v>6635592.8173878696</c:v>
                </c:pt>
                <c:pt idx="2026">
                  <c:v>6635592.8173878696</c:v>
                </c:pt>
                <c:pt idx="2027">
                  <c:v>1680548.6761757974</c:v>
                </c:pt>
                <c:pt idx="2028">
                  <c:v>1680548.6761757974</c:v>
                </c:pt>
                <c:pt idx="2029">
                  <c:v>0</c:v>
                </c:pt>
                <c:pt idx="2030">
                  <c:v>1680548.6761757974</c:v>
                </c:pt>
                <c:pt idx="2031">
                  <c:v>1680548.6761757974</c:v>
                </c:pt>
                <c:pt idx="2032">
                  <c:v>0</c:v>
                </c:pt>
                <c:pt idx="2033">
                  <c:v>1680548.6761757974</c:v>
                </c:pt>
                <c:pt idx="2034">
                  <c:v>1680548.6761757974</c:v>
                </c:pt>
                <c:pt idx="2035">
                  <c:v>6635592.8173878696</c:v>
                </c:pt>
                <c:pt idx="2036">
                  <c:v>6635592.8173878696</c:v>
                </c:pt>
                <c:pt idx="2037">
                  <c:v>26420281.166910913</c:v>
                </c:pt>
                <c:pt idx="2038">
                  <c:v>26420281.166910913</c:v>
                </c:pt>
                <c:pt idx="2039">
                  <c:v>151483842.25287032</c:v>
                </c:pt>
                <c:pt idx="2040">
                  <c:v>151483842.25287032</c:v>
                </c:pt>
                <c:pt idx="2041">
                  <c:v>34882769.963479996</c:v>
                </c:pt>
                <c:pt idx="2042">
                  <c:v>34882769.963479996</c:v>
                </c:pt>
                <c:pt idx="2043">
                  <c:v>3555286.1670598979</c:v>
                </c:pt>
                <c:pt idx="2044">
                  <c:v>3555286.1670598979</c:v>
                </c:pt>
                <c:pt idx="2045">
                  <c:v>720917.49466275214</c:v>
                </c:pt>
                <c:pt idx="2046">
                  <c:v>720917.49466275214</c:v>
                </c:pt>
                <c:pt idx="2047">
                  <c:v>0</c:v>
                </c:pt>
                <c:pt idx="2048">
                  <c:v>720917.49466275214</c:v>
                </c:pt>
                <c:pt idx="2049">
                  <c:v>720917.49466275214</c:v>
                </c:pt>
                <c:pt idx="2050">
                  <c:v>284295.66163008049</c:v>
                </c:pt>
                <c:pt idx="2051">
                  <c:v>284295.66163008049</c:v>
                </c:pt>
                <c:pt idx="2052">
                  <c:v>6575.8425363041488</c:v>
                </c:pt>
                <c:pt idx="2053">
                  <c:v>6575.8425363041488</c:v>
                </c:pt>
                <c:pt idx="2054">
                  <c:v>0</c:v>
                </c:pt>
                <c:pt idx="2055">
                  <c:v>6575.8425363041488</c:v>
                </c:pt>
                <c:pt idx="2056">
                  <c:v>6575.8425363041488</c:v>
                </c:pt>
                <c:pt idx="2057">
                  <c:v>0</c:v>
                </c:pt>
                <c:pt idx="2058">
                  <c:v>6575.8425363041488</c:v>
                </c:pt>
                <c:pt idx="2059">
                  <c:v>6575.8425363041488</c:v>
                </c:pt>
                <c:pt idx="2060">
                  <c:v>284295.66163008049</c:v>
                </c:pt>
                <c:pt idx="2061">
                  <c:v>284295.66163008049</c:v>
                </c:pt>
                <c:pt idx="2062">
                  <c:v>61814.729156255911</c:v>
                </c:pt>
                <c:pt idx="2063">
                  <c:v>61814.729156255911</c:v>
                </c:pt>
                <c:pt idx="2064">
                  <c:v>0</c:v>
                </c:pt>
                <c:pt idx="2065">
                  <c:v>61814.729156255911</c:v>
                </c:pt>
                <c:pt idx="2066">
                  <c:v>61814.729156255911</c:v>
                </c:pt>
                <c:pt idx="2067">
                  <c:v>0</c:v>
                </c:pt>
                <c:pt idx="2068">
                  <c:v>61814.729156255911</c:v>
                </c:pt>
                <c:pt idx="2069">
                  <c:v>61814.729156255911</c:v>
                </c:pt>
                <c:pt idx="2070">
                  <c:v>284295.66163008049</c:v>
                </c:pt>
                <c:pt idx="2071">
                  <c:v>284295.66163008049</c:v>
                </c:pt>
                <c:pt idx="2072">
                  <c:v>720917.49466275214</c:v>
                </c:pt>
                <c:pt idx="2073">
                  <c:v>720917.49466275214</c:v>
                </c:pt>
                <c:pt idx="2074">
                  <c:v>3555286.1670598979</c:v>
                </c:pt>
                <c:pt idx="2075">
                  <c:v>3555286.1670598979</c:v>
                </c:pt>
                <c:pt idx="2076">
                  <c:v>943654.17459130858</c:v>
                </c:pt>
                <c:pt idx="2077">
                  <c:v>943654.17459130858</c:v>
                </c:pt>
                <c:pt idx="2078">
                  <c:v>203041.25392121062</c:v>
                </c:pt>
                <c:pt idx="2079">
                  <c:v>203041.25392121062</c:v>
                </c:pt>
                <c:pt idx="2080">
                  <c:v>0</c:v>
                </c:pt>
                <c:pt idx="2081">
                  <c:v>203041.25392121062</c:v>
                </c:pt>
                <c:pt idx="2082">
                  <c:v>203041.25392121062</c:v>
                </c:pt>
                <c:pt idx="2083">
                  <c:v>0</c:v>
                </c:pt>
                <c:pt idx="2084">
                  <c:v>203041.25392121062</c:v>
                </c:pt>
                <c:pt idx="2085">
                  <c:v>203041.25392121062</c:v>
                </c:pt>
                <c:pt idx="2086">
                  <c:v>943654.17459130858</c:v>
                </c:pt>
                <c:pt idx="2087">
                  <c:v>943654.17459130858</c:v>
                </c:pt>
                <c:pt idx="2088">
                  <c:v>277433.44906892732</c:v>
                </c:pt>
                <c:pt idx="2089">
                  <c:v>277433.44906892732</c:v>
                </c:pt>
                <c:pt idx="2090">
                  <c:v>0</c:v>
                </c:pt>
                <c:pt idx="2091">
                  <c:v>277433.44906892732</c:v>
                </c:pt>
                <c:pt idx="2092">
                  <c:v>277433.44906892732</c:v>
                </c:pt>
                <c:pt idx="2093">
                  <c:v>0</c:v>
                </c:pt>
                <c:pt idx="2094">
                  <c:v>277433.44906892732</c:v>
                </c:pt>
                <c:pt idx="2095">
                  <c:v>277433.44906892732</c:v>
                </c:pt>
                <c:pt idx="2096">
                  <c:v>943654.17459130858</c:v>
                </c:pt>
                <c:pt idx="2097">
                  <c:v>943654.17459130858</c:v>
                </c:pt>
                <c:pt idx="2098">
                  <c:v>3555286.1670598979</c:v>
                </c:pt>
                <c:pt idx="2099">
                  <c:v>3555286.1670598979</c:v>
                </c:pt>
                <c:pt idx="2100">
                  <c:v>34882769.963479996</c:v>
                </c:pt>
                <c:pt idx="2101">
                  <c:v>34882769.963479996</c:v>
                </c:pt>
                <c:pt idx="2102">
                  <c:v>8579710.5342085306</c:v>
                </c:pt>
                <c:pt idx="2103">
                  <c:v>8579710.5342085306</c:v>
                </c:pt>
                <c:pt idx="2104">
                  <c:v>3113861.640149957</c:v>
                </c:pt>
                <c:pt idx="2105">
                  <c:v>3113861.640149957</c:v>
                </c:pt>
                <c:pt idx="2106">
                  <c:v>251785.35026309354</c:v>
                </c:pt>
                <c:pt idx="2107">
                  <c:v>251785.35026309354</c:v>
                </c:pt>
                <c:pt idx="2108">
                  <c:v>0</c:v>
                </c:pt>
                <c:pt idx="2109">
                  <c:v>251785.35026309354</c:v>
                </c:pt>
                <c:pt idx="2110">
                  <c:v>251785.35026309354</c:v>
                </c:pt>
                <c:pt idx="2111">
                  <c:v>54150.142323975328</c:v>
                </c:pt>
                <c:pt idx="2112">
                  <c:v>54150.142323975328</c:v>
                </c:pt>
                <c:pt idx="2113">
                  <c:v>0</c:v>
                </c:pt>
                <c:pt idx="2114">
                  <c:v>54150.142323975328</c:v>
                </c:pt>
                <c:pt idx="2115">
                  <c:v>54150.142323975328</c:v>
                </c:pt>
                <c:pt idx="2116">
                  <c:v>0</c:v>
                </c:pt>
                <c:pt idx="2117">
                  <c:v>54150.142323975328</c:v>
                </c:pt>
                <c:pt idx="2118">
                  <c:v>54150.142323975328</c:v>
                </c:pt>
                <c:pt idx="2119">
                  <c:v>251785.35026309354</c:v>
                </c:pt>
                <c:pt idx="2120">
                  <c:v>251785.35026309354</c:v>
                </c:pt>
                <c:pt idx="2121">
                  <c:v>3113861.640149957</c:v>
                </c:pt>
                <c:pt idx="2122">
                  <c:v>3113861.640149957</c:v>
                </c:pt>
                <c:pt idx="2123">
                  <c:v>724853.4741906391</c:v>
                </c:pt>
                <c:pt idx="2124">
                  <c:v>724853.4741906391</c:v>
                </c:pt>
                <c:pt idx="2125">
                  <c:v>76128.431033287372</c:v>
                </c:pt>
                <c:pt idx="2126">
                  <c:v>76128.431033287372</c:v>
                </c:pt>
                <c:pt idx="2127">
                  <c:v>0</c:v>
                </c:pt>
                <c:pt idx="2128">
                  <c:v>76128.431033287372</c:v>
                </c:pt>
                <c:pt idx="2129">
                  <c:v>76128.431033287372</c:v>
                </c:pt>
                <c:pt idx="2130">
                  <c:v>0</c:v>
                </c:pt>
                <c:pt idx="2131">
                  <c:v>76128.431033287372</c:v>
                </c:pt>
                <c:pt idx="2132">
                  <c:v>76128.431033287372</c:v>
                </c:pt>
                <c:pt idx="2133">
                  <c:v>724853.4741906391</c:v>
                </c:pt>
                <c:pt idx="2134">
                  <c:v>724853.4741906391</c:v>
                </c:pt>
                <c:pt idx="2135">
                  <c:v>297487.27391199156</c:v>
                </c:pt>
                <c:pt idx="2136">
                  <c:v>297487.27391199156</c:v>
                </c:pt>
                <c:pt idx="2137">
                  <c:v>0</c:v>
                </c:pt>
                <c:pt idx="2138">
                  <c:v>297487.27391199156</c:v>
                </c:pt>
                <c:pt idx="2139">
                  <c:v>297487.27391199156</c:v>
                </c:pt>
                <c:pt idx="2140">
                  <c:v>5187.902462313773</c:v>
                </c:pt>
                <c:pt idx="2141">
                  <c:v>5187.902462313773</c:v>
                </c:pt>
                <c:pt idx="2142">
                  <c:v>0</c:v>
                </c:pt>
                <c:pt idx="2143">
                  <c:v>5187.902462313773</c:v>
                </c:pt>
                <c:pt idx="2144">
                  <c:v>5187.902462313773</c:v>
                </c:pt>
                <c:pt idx="2145">
                  <c:v>0</c:v>
                </c:pt>
                <c:pt idx="2146">
                  <c:v>5187.902462313773</c:v>
                </c:pt>
                <c:pt idx="2147">
                  <c:v>5187.902462313773</c:v>
                </c:pt>
                <c:pt idx="2148">
                  <c:v>297487.27391199156</c:v>
                </c:pt>
                <c:pt idx="2149">
                  <c:v>297487.27391199156</c:v>
                </c:pt>
                <c:pt idx="2150">
                  <c:v>724853.4741906391</c:v>
                </c:pt>
                <c:pt idx="2151">
                  <c:v>724853.4741906391</c:v>
                </c:pt>
                <c:pt idx="2152">
                  <c:v>3113861.640149957</c:v>
                </c:pt>
                <c:pt idx="2153">
                  <c:v>3113861.640149957</c:v>
                </c:pt>
                <c:pt idx="2154">
                  <c:v>8579710.5342085306</c:v>
                </c:pt>
                <c:pt idx="2155">
                  <c:v>8579710.5342085306</c:v>
                </c:pt>
                <c:pt idx="2156">
                  <c:v>4689355.4872236196</c:v>
                </c:pt>
                <c:pt idx="2157">
                  <c:v>4689355.4872236196</c:v>
                </c:pt>
                <c:pt idx="2158">
                  <c:v>105538.16041426695</c:v>
                </c:pt>
                <c:pt idx="2159">
                  <c:v>105538.16041426695</c:v>
                </c:pt>
                <c:pt idx="2160">
                  <c:v>13239.818286999882</c:v>
                </c:pt>
                <c:pt idx="2161">
                  <c:v>13239.818286999882</c:v>
                </c:pt>
                <c:pt idx="2162">
                  <c:v>0</c:v>
                </c:pt>
                <c:pt idx="2163">
                  <c:v>13239.818286999882</c:v>
                </c:pt>
                <c:pt idx="2164">
                  <c:v>13239.818286999882</c:v>
                </c:pt>
                <c:pt idx="2165">
                  <c:v>0</c:v>
                </c:pt>
                <c:pt idx="2166">
                  <c:v>13239.818286999882</c:v>
                </c:pt>
                <c:pt idx="2167">
                  <c:v>13239.818286999882</c:v>
                </c:pt>
                <c:pt idx="2168">
                  <c:v>105538.16041426695</c:v>
                </c:pt>
                <c:pt idx="2169">
                  <c:v>105538.16041426695</c:v>
                </c:pt>
                <c:pt idx="2170">
                  <c:v>73611.246198296009</c:v>
                </c:pt>
                <c:pt idx="2171">
                  <c:v>73611.246198296009</c:v>
                </c:pt>
                <c:pt idx="2172">
                  <c:v>2699.307398981417</c:v>
                </c:pt>
                <c:pt idx="2173">
                  <c:v>2699.307398981417</c:v>
                </c:pt>
                <c:pt idx="2174">
                  <c:v>0</c:v>
                </c:pt>
                <c:pt idx="2175">
                  <c:v>2699.307398981417</c:v>
                </c:pt>
                <c:pt idx="2176">
                  <c:v>2699.307398981417</c:v>
                </c:pt>
                <c:pt idx="2177">
                  <c:v>0</c:v>
                </c:pt>
                <c:pt idx="2178">
                  <c:v>2699.307398981417</c:v>
                </c:pt>
                <c:pt idx="2179">
                  <c:v>2699.307398981417</c:v>
                </c:pt>
                <c:pt idx="2180">
                  <c:v>73611.246198296009</c:v>
                </c:pt>
                <c:pt idx="2181">
                  <c:v>73611.246198296009</c:v>
                </c:pt>
                <c:pt idx="2182">
                  <c:v>20305.405966024049</c:v>
                </c:pt>
                <c:pt idx="2183">
                  <c:v>20305.405966024049</c:v>
                </c:pt>
                <c:pt idx="2184">
                  <c:v>0</c:v>
                </c:pt>
                <c:pt idx="2185">
                  <c:v>20305.405966024049</c:v>
                </c:pt>
                <c:pt idx="2186">
                  <c:v>20305.405966024049</c:v>
                </c:pt>
                <c:pt idx="2187">
                  <c:v>3910.7760147734216</c:v>
                </c:pt>
                <c:pt idx="2188">
                  <c:v>3910.7760147734216</c:v>
                </c:pt>
                <c:pt idx="2189">
                  <c:v>0</c:v>
                </c:pt>
                <c:pt idx="2190">
                  <c:v>3910.7760147734216</c:v>
                </c:pt>
                <c:pt idx="2191">
                  <c:v>3910.7760147734216</c:v>
                </c:pt>
                <c:pt idx="2192">
                  <c:v>152.83063432884597</c:v>
                </c:pt>
                <c:pt idx="2193">
                  <c:v>152.83063432884597</c:v>
                </c:pt>
                <c:pt idx="2194">
                  <c:v>0</c:v>
                </c:pt>
                <c:pt idx="2195">
                  <c:v>152.83063432884597</c:v>
                </c:pt>
                <c:pt idx="2196">
                  <c:v>152.83063432884597</c:v>
                </c:pt>
                <c:pt idx="2197">
                  <c:v>0</c:v>
                </c:pt>
                <c:pt idx="2198">
                  <c:v>152.83063432884597</c:v>
                </c:pt>
                <c:pt idx="2199">
                  <c:v>152.83063432884597</c:v>
                </c:pt>
                <c:pt idx="2200">
                  <c:v>3910.7760147734216</c:v>
                </c:pt>
                <c:pt idx="2201">
                  <c:v>3910.7760147734216</c:v>
                </c:pt>
                <c:pt idx="2202">
                  <c:v>20305.405966024049</c:v>
                </c:pt>
                <c:pt idx="2203">
                  <c:v>20305.405966024049</c:v>
                </c:pt>
                <c:pt idx="2204">
                  <c:v>73611.246198296009</c:v>
                </c:pt>
                <c:pt idx="2205">
                  <c:v>73611.246198296009</c:v>
                </c:pt>
                <c:pt idx="2206">
                  <c:v>105538.16041426695</c:v>
                </c:pt>
                <c:pt idx="2207">
                  <c:v>105538.16041426695</c:v>
                </c:pt>
                <c:pt idx="2208">
                  <c:v>4689355.4872236196</c:v>
                </c:pt>
                <c:pt idx="2209">
                  <c:v>4689355.4872236196</c:v>
                </c:pt>
                <c:pt idx="2210">
                  <c:v>1599465.8971660614</c:v>
                </c:pt>
                <c:pt idx="2211">
                  <c:v>1599465.8971660614</c:v>
                </c:pt>
                <c:pt idx="2212">
                  <c:v>147242.35014058946</c:v>
                </c:pt>
                <c:pt idx="2213">
                  <c:v>147242.35014058946</c:v>
                </c:pt>
                <c:pt idx="2214">
                  <c:v>8052.7861843219498</c:v>
                </c:pt>
                <c:pt idx="2215">
                  <c:v>8052.7861843219498</c:v>
                </c:pt>
                <c:pt idx="2216">
                  <c:v>0</c:v>
                </c:pt>
                <c:pt idx="2217">
                  <c:v>8052.7861843219498</c:v>
                </c:pt>
                <c:pt idx="2218">
                  <c:v>8052.7861843219498</c:v>
                </c:pt>
                <c:pt idx="2219">
                  <c:v>0</c:v>
                </c:pt>
                <c:pt idx="2220">
                  <c:v>8052.7861843219498</c:v>
                </c:pt>
                <c:pt idx="2221">
                  <c:v>8052.7861843219498</c:v>
                </c:pt>
                <c:pt idx="2222">
                  <c:v>147242.35014058946</c:v>
                </c:pt>
                <c:pt idx="2223">
                  <c:v>147242.35014058946</c:v>
                </c:pt>
                <c:pt idx="2224">
                  <c:v>47861.994890651767</c:v>
                </c:pt>
                <c:pt idx="2225">
                  <c:v>47861.994890651767</c:v>
                </c:pt>
                <c:pt idx="2226">
                  <c:v>0</c:v>
                </c:pt>
                <c:pt idx="2227">
                  <c:v>47861.994890651767</c:v>
                </c:pt>
                <c:pt idx="2228">
                  <c:v>47861.994890651767</c:v>
                </c:pt>
                <c:pt idx="2229">
                  <c:v>36733.131194277805</c:v>
                </c:pt>
                <c:pt idx="2230">
                  <c:v>36733.131194277805</c:v>
                </c:pt>
                <c:pt idx="2231">
                  <c:v>0</c:v>
                </c:pt>
                <c:pt idx="2232">
                  <c:v>36733.131194277805</c:v>
                </c:pt>
                <c:pt idx="2233">
                  <c:v>36733.131194277805</c:v>
                </c:pt>
                <c:pt idx="2234">
                  <c:v>11725.042276301112</c:v>
                </c:pt>
                <c:pt idx="2235">
                  <c:v>11725.042276301112</c:v>
                </c:pt>
                <c:pt idx="2236">
                  <c:v>0</c:v>
                </c:pt>
                <c:pt idx="2237">
                  <c:v>11725.042276301112</c:v>
                </c:pt>
                <c:pt idx="2238">
                  <c:v>11725.042276301112</c:v>
                </c:pt>
                <c:pt idx="2239">
                  <c:v>0</c:v>
                </c:pt>
                <c:pt idx="2240">
                  <c:v>11725.042276301112</c:v>
                </c:pt>
                <c:pt idx="2241">
                  <c:v>11725.042276301112</c:v>
                </c:pt>
                <c:pt idx="2242">
                  <c:v>36733.131194277805</c:v>
                </c:pt>
                <c:pt idx="2243">
                  <c:v>36733.131194277805</c:v>
                </c:pt>
                <c:pt idx="2244">
                  <c:v>47861.994890651767</c:v>
                </c:pt>
                <c:pt idx="2245">
                  <c:v>47861.994890651767</c:v>
                </c:pt>
                <c:pt idx="2246">
                  <c:v>147242.35014058946</c:v>
                </c:pt>
                <c:pt idx="2247">
                  <c:v>147242.35014058946</c:v>
                </c:pt>
                <c:pt idx="2248">
                  <c:v>1599465.8971660614</c:v>
                </c:pt>
                <c:pt idx="2249">
                  <c:v>1599465.8971660614</c:v>
                </c:pt>
                <c:pt idx="2250">
                  <c:v>483391.5016280479</c:v>
                </c:pt>
                <c:pt idx="2251">
                  <c:v>483391.5016280479</c:v>
                </c:pt>
                <c:pt idx="2252">
                  <c:v>19740.842450319589</c:v>
                </c:pt>
                <c:pt idx="2253">
                  <c:v>19740.842450319589</c:v>
                </c:pt>
                <c:pt idx="2254">
                  <c:v>0</c:v>
                </c:pt>
                <c:pt idx="2255">
                  <c:v>19740.842450319589</c:v>
                </c:pt>
                <c:pt idx="2256">
                  <c:v>19740.842450319589</c:v>
                </c:pt>
                <c:pt idx="2257">
                  <c:v>0</c:v>
                </c:pt>
                <c:pt idx="2258">
                  <c:v>19740.842450319589</c:v>
                </c:pt>
                <c:pt idx="2259">
                  <c:v>19740.842450319589</c:v>
                </c:pt>
                <c:pt idx="2260">
                  <c:v>483391.5016280479</c:v>
                </c:pt>
                <c:pt idx="2261">
                  <c:v>483391.5016280479</c:v>
                </c:pt>
                <c:pt idx="2262">
                  <c:v>234903.63491379432</c:v>
                </c:pt>
                <c:pt idx="2263">
                  <c:v>234903.63491379432</c:v>
                </c:pt>
                <c:pt idx="2264">
                  <c:v>38236.726045411888</c:v>
                </c:pt>
                <c:pt idx="2265">
                  <c:v>38236.726045411888</c:v>
                </c:pt>
                <c:pt idx="2266">
                  <c:v>0</c:v>
                </c:pt>
                <c:pt idx="2267">
                  <c:v>38236.726045411888</c:v>
                </c:pt>
                <c:pt idx="2268">
                  <c:v>38236.726045411888</c:v>
                </c:pt>
                <c:pt idx="2269">
                  <c:v>25306.895840328758</c:v>
                </c:pt>
                <c:pt idx="2270">
                  <c:v>25306.895840328758</c:v>
                </c:pt>
                <c:pt idx="2271">
                  <c:v>0</c:v>
                </c:pt>
                <c:pt idx="2272">
                  <c:v>25306.895840328758</c:v>
                </c:pt>
                <c:pt idx="2273">
                  <c:v>25306.895840328758</c:v>
                </c:pt>
                <c:pt idx="2274">
                  <c:v>0</c:v>
                </c:pt>
                <c:pt idx="2275">
                  <c:v>25306.895840328758</c:v>
                </c:pt>
                <c:pt idx="2276">
                  <c:v>25306.895840328758</c:v>
                </c:pt>
                <c:pt idx="2277">
                  <c:v>38236.726045411888</c:v>
                </c:pt>
                <c:pt idx="2278">
                  <c:v>38236.726045411888</c:v>
                </c:pt>
                <c:pt idx="2279">
                  <c:v>234903.63491379432</c:v>
                </c:pt>
                <c:pt idx="2280">
                  <c:v>234903.63491379432</c:v>
                </c:pt>
                <c:pt idx="2281">
                  <c:v>52533.195122645084</c:v>
                </c:pt>
                <c:pt idx="2282">
                  <c:v>52533.195122645084</c:v>
                </c:pt>
                <c:pt idx="2283">
                  <c:v>687.75060899205494</c:v>
                </c:pt>
                <c:pt idx="2284">
                  <c:v>687.75060899205494</c:v>
                </c:pt>
                <c:pt idx="2285">
                  <c:v>0</c:v>
                </c:pt>
                <c:pt idx="2286">
                  <c:v>687.75060899205494</c:v>
                </c:pt>
                <c:pt idx="2287">
                  <c:v>687.75060899205494</c:v>
                </c:pt>
                <c:pt idx="2288">
                  <c:v>0</c:v>
                </c:pt>
                <c:pt idx="2289">
                  <c:v>687.75060899205494</c:v>
                </c:pt>
                <c:pt idx="2290">
                  <c:v>687.75060899205494</c:v>
                </c:pt>
                <c:pt idx="2291">
                  <c:v>52533.195122645084</c:v>
                </c:pt>
                <c:pt idx="2292">
                  <c:v>52533.195122645084</c:v>
                </c:pt>
                <c:pt idx="2293">
                  <c:v>1560.0075209947731</c:v>
                </c:pt>
                <c:pt idx="2294">
                  <c:v>1560.0075209947731</c:v>
                </c:pt>
                <c:pt idx="2295">
                  <c:v>0</c:v>
                </c:pt>
                <c:pt idx="2296">
                  <c:v>1560.0075209947731</c:v>
                </c:pt>
                <c:pt idx="2297">
                  <c:v>1560.0075209947731</c:v>
                </c:pt>
                <c:pt idx="2298">
                  <c:v>0</c:v>
                </c:pt>
                <c:pt idx="2299">
                  <c:v>1560.0075209947731</c:v>
                </c:pt>
                <c:pt idx="2300">
                  <c:v>1560.0075209947731</c:v>
                </c:pt>
                <c:pt idx="2301">
                  <c:v>52533.195122645084</c:v>
                </c:pt>
                <c:pt idx="2302">
                  <c:v>52533.195122645084</c:v>
                </c:pt>
                <c:pt idx="2303">
                  <c:v>234903.63491379432</c:v>
                </c:pt>
                <c:pt idx="2304">
                  <c:v>234903.63491379432</c:v>
                </c:pt>
                <c:pt idx="2305">
                  <c:v>483391.5016280479</c:v>
                </c:pt>
                <c:pt idx="2306">
                  <c:v>483391.5016280479</c:v>
                </c:pt>
                <c:pt idx="2307">
                  <c:v>1599465.8971660614</c:v>
                </c:pt>
                <c:pt idx="2308">
                  <c:v>1599465.8971660614</c:v>
                </c:pt>
                <c:pt idx="2309">
                  <c:v>4689355.4872236196</c:v>
                </c:pt>
                <c:pt idx="2310">
                  <c:v>4689355.4872236196</c:v>
                </c:pt>
                <c:pt idx="2311">
                  <c:v>8579710.5342085306</c:v>
                </c:pt>
                <c:pt idx="2312">
                  <c:v>8579710.5342085306</c:v>
                </c:pt>
                <c:pt idx="2313">
                  <c:v>34882769.963479996</c:v>
                </c:pt>
                <c:pt idx="2314">
                  <c:v>34882769.963479996</c:v>
                </c:pt>
                <c:pt idx="2315">
                  <c:v>151483842.25287032</c:v>
                </c:pt>
                <c:pt idx="2316">
                  <c:v>151483842.25287032</c:v>
                </c:pt>
                <c:pt idx="2317">
                  <c:v>318605164.94198072</c:v>
                </c:pt>
                <c:pt idx="2318">
                  <c:v>318605164.94198072</c:v>
                </c:pt>
                <c:pt idx="2319">
                  <c:v>556269028.81687307</c:v>
                </c:pt>
                <c:pt idx="2320">
                  <c:v>556269028.81687307</c:v>
                </c:pt>
                <c:pt idx="2321">
                  <c:v>1666346668.7257748</c:v>
                </c:pt>
                <c:pt idx="2322">
                  <c:v>1666346668.7257748</c:v>
                </c:pt>
                <c:pt idx="2323">
                  <c:v>1895526519.3810787</c:v>
                </c:pt>
                <c:pt idx="2324">
                  <c:v>1895526519.3810787</c:v>
                </c:pt>
              </c:numCache>
            </c:numRef>
          </c:xVal>
          <c:yVal>
            <c:numRef>
              <c:f>'Heat maps3_HID6'!$G$1:$G$2325</c:f>
              <c:numCache>
                <c:formatCode>0</c:formatCode>
                <c:ptCount val="2325"/>
                <c:pt idx="0">
                  <c:v>25.150350034236908</c:v>
                </c:pt>
                <c:pt idx="1">
                  <c:v>1.75</c:v>
                </c:pt>
                <c:pt idx="2">
                  <c:v>1.75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2.5</c:v>
                </c:pt>
                <c:pt idx="7">
                  <c:v>2.5</c:v>
                </c:pt>
                <c:pt idx="8">
                  <c:v>2</c:v>
                </c:pt>
                <c:pt idx="9">
                  <c:v>2</c:v>
                </c:pt>
                <c:pt idx="10">
                  <c:v>2</c:v>
                </c:pt>
                <c:pt idx="11">
                  <c:v>3</c:v>
                </c:pt>
                <c:pt idx="12">
                  <c:v>3</c:v>
                </c:pt>
                <c:pt idx="13">
                  <c:v>3</c:v>
                </c:pt>
                <c:pt idx="14">
                  <c:v>2.5</c:v>
                </c:pt>
                <c:pt idx="15">
                  <c:v>2.5</c:v>
                </c:pt>
                <c:pt idx="16">
                  <c:v>1.75</c:v>
                </c:pt>
                <c:pt idx="17">
                  <c:v>1.75</c:v>
                </c:pt>
                <c:pt idx="18">
                  <c:v>48.550700068473816</c:v>
                </c:pt>
                <c:pt idx="19">
                  <c:v>48.550700068473816</c:v>
                </c:pt>
                <c:pt idx="20">
                  <c:v>4</c:v>
                </c:pt>
                <c:pt idx="21">
                  <c:v>4</c:v>
                </c:pt>
                <c:pt idx="22">
                  <c:v>4</c:v>
                </c:pt>
                <c:pt idx="23">
                  <c:v>93.101400136947632</c:v>
                </c:pt>
                <c:pt idx="24">
                  <c:v>93.101400136947632</c:v>
                </c:pt>
                <c:pt idx="25">
                  <c:v>6.125</c:v>
                </c:pt>
                <c:pt idx="26">
                  <c:v>6.125</c:v>
                </c:pt>
                <c:pt idx="27">
                  <c:v>5</c:v>
                </c:pt>
                <c:pt idx="28">
                  <c:v>5</c:v>
                </c:pt>
                <c:pt idx="29">
                  <c:v>5</c:v>
                </c:pt>
                <c:pt idx="30">
                  <c:v>7.25</c:v>
                </c:pt>
                <c:pt idx="31">
                  <c:v>7.25</c:v>
                </c:pt>
                <c:pt idx="32">
                  <c:v>6</c:v>
                </c:pt>
                <c:pt idx="33">
                  <c:v>6</c:v>
                </c:pt>
                <c:pt idx="34">
                  <c:v>6</c:v>
                </c:pt>
                <c:pt idx="35">
                  <c:v>8.5</c:v>
                </c:pt>
                <c:pt idx="36">
                  <c:v>8.5</c:v>
                </c:pt>
                <c:pt idx="37">
                  <c:v>7.5</c:v>
                </c:pt>
                <c:pt idx="38">
                  <c:v>7.5</c:v>
                </c:pt>
                <c:pt idx="39">
                  <c:v>7</c:v>
                </c:pt>
                <c:pt idx="40">
                  <c:v>7</c:v>
                </c:pt>
                <c:pt idx="41">
                  <c:v>7</c:v>
                </c:pt>
                <c:pt idx="42">
                  <c:v>8</c:v>
                </c:pt>
                <c:pt idx="43">
                  <c:v>8</c:v>
                </c:pt>
                <c:pt idx="44">
                  <c:v>8</c:v>
                </c:pt>
                <c:pt idx="45">
                  <c:v>7.5</c:v>
                </c:pt>
                <c:pt idx="46">
                  <c:v>7.5</c:v>
                </c:pt>
                <c:pt idx="47">
                  <c:v>9.5</c:v>
                </c:pt>
                <c:pt idx="48">
                  <c:v>9.5</c:v>
                </c:pt>
                <c:pt idx="49">
                  <c:v>9</c:v>
                </c:pt>
                <c:pt idx="50">
                  <c:v>9</c:v>
                </c:pt>
                <c:pt idx="51">
                  <c:v>9</c:v>
                </c:pt>
                <c:pt idx="52">
                  <c:v>10</c:v>
                </c:pt>
                <c:pt idx="53">
                  <c:v>10</c:v>
                </c:pt>
                <c:pt idx="54">
                  <c:v>10</c:v>
                </c:pt>
                <c:pt idx="55">
                  <c:v>9.5</c:v>
                </c:pt>
                <c:pt idx="56">
                  <c:v>9.5</c:v>
                </c:pt>
                <c:pt idx="57">
                  <c:v>8.5</c:v>
                </c:pt>
                <c:pt idx="58">
                  <c:v>8.5</c:v>
                </c:pt>
                <c:pt idx="59">
                  <c:v>7.25</c:v>
                </c:pt>
                <c:pt idx="60">
                  <c:v>7.25</c:v>
                </c:pt>
                <c:pt idx="61">
                  <c:v>6.125</c:v>
                </c:pt>
                <c:pt idx="62">
                  <c:v>6.125</c:v>
                </c:pt>
                <c:pt idx="63">
                  <c:v>180.07780027389526</c:v>
                </c:pt>
                <c:pt idx="64">
                  <c:v>180.07780027389526</c:v>
                </c:pt>
                <c:pt idx="65">
                  <c:v>62.337241172790527</c:v>
                </c:pt>
                <c:pt idx="66">
                  <c:v>62.337241172790527</c:v>
                </c:pt>
                <c:pt idx="67">
                  <c:v>18.18359375</c:v>
                </c:pt>
                <c:pt idx="68">
                  <c:v>18.18359375</c:v>
                </c:pt>
                <c:pt idx="69">
                  <c:v>13.875</c:v>
                </c:pt>
                <c:pt idx="70">
                  <c:v>13.875</c:v>
                </c:pt>
                <c:pt idx="71">
                  <c:v>11.875</c:v>
                </c:pt>
                <c:pt idx="72">
                  <c:v>11.875</c:v>
                </c:pt>
                <c:pt idx="73">
                  <c:v>11</c:v>
                </c:pt>
                <c:pt idx="74">
                  <c:v>11</c:v>
                </c:pt>
                <c:pt idx="75">
                  <c:v>11</c:v>
                </c:pt>
                <c:pt idx="76">
                  <c:v>12.75</c:v>
                </c:pt>
                <c:pt idx="77">
                  <c:v>12.75</c:v>
                </c:pt>
                <c:pt idx="78">
                  <c:v>12</c:v>
                </c:pt>
                <c:pt idx="79">
                  <c:v>12</c:v>
                </c:pt>
                <c:pt idx="80">
                  <c:v>12</c:v>
                </c:pt>
                <c:pt idx="81">
                  <c:v>13.5</c:v>
                </c:pt>
                <c:pt idx="82">
                  <c:v>13.5</c:v>
                </c:pt>
                <c:pt idx="83">
                  <c:v>13</c:v>
                </c:pt>
                <c:pt idx="84">
                  <c:v>13</c:v>
                </c:pt>
                <c:pt idx="85">
                  <c:v>13</c:v>
                </c:pt>
                <c:pt idx="86">
                  <c:v>14</c:v>
                </c:pt>
                <c:pt idx="87">
                  <c:v>14</c:v>
                </c:pt>
                <c:pt idx="88">
                  <c:v>14</c:v>
                </c:pt>
                <c:pt idx="89">
                  <c:v>13.5</c:v>
                </c:pt>
                <c:pt idx="90">
                  <c:v>13.5</c:v>
                </c:pt>
                <c:pt idx="91">
                  <c:v>12.75</c:v>
                </c:pt>
                <c:pt idx="92">
                  <c:v>12.75</c:v>
                </c:pt>
                <c:pt idx="93">
                  <c:v>11.875</c:v>
                </c:pt>
                <c:pt idx="94">
                  <c:v>11.875</c:v>
                </c:pt>
                <c:pt idx="95">
                  <c:v>15.875</c:v>
                </c:pt>
                <c:pt idx="96">
                  <c:v>15.875</c:v>
                </c:pt>
                <c:pt idx="97">
                  <c:v>15</c:v>
                </c:pt>
                <c:pt idx="98">
                  <c:v>15</c:v>
                </c:pt>
                <c:pt idx="99">
                  <c:v>15</c:v>
                </c:pt>
                <c:pt idx="100">
                  <c:v>16.75</c:v>
                </c:pt>
                <c:pt idx="101">
                  <c:v>16.75</c:v>
                </c:pt>
                <c:pt idx="102">
                  <c:v>16</c:v>
                </c:pt>
                <c:pt idx="103">
                  <c:v>16</c:v>
                </c:pt>
                <c:pt idx="104">
                  <c:v>16</c:v>
                </c:pt>
                <c:pt idx="105">
                  <c:v>17.5</c:v>
                </c:pt>
                <c:pt idx="106">
                  <c:v>17.5</c:v>
                </c:pt>
                <c:pt idx="107">
                  <c:v>17</c:v>
                </c:pt>
                <c:pt idx="108">
                  <c:v>17</c:v>
                </c:pt>
                <c:pt idx="109">
                  <c:v>17</c:v>
                </c:pt>
                <c:pt idx="110">
                  <c:v>18</c:v>
                </c:pt>
                <c:pt idx="111">
                  <c:v>18</c:v>
                </c:pt>
                <c:pt idx="112">
                  <c:v>18</c:v>
                </c:pt>
                <c:pt idx="113">
                  <c:v>17.5</c:v>
                </c:pt>
                <c:pt idx="114">
                  <c:v>17.5</c:v>
                </c:pt>
                <c:pt idx="115">
                  <c:v>16.75</c:v>
                </c:pt>
                <c:pt idx="116">
                  <c:v>16.75</c:v>
                </c:pt>
                <c:pt idx="117">
                  <c:v>15.875</c:v>
                </c:pt>
                <c:pt idx="118">
                  <c:v>15.875</c:v>
                </c:pt>
                <c:pt idx="119">
                  <c:v>13.875</c:v>
                </c:pt>
                <c:pt idx="120">
                  <c:v>13.875</c:v>
                </c:pt>
                <c:pt idx="121">
                  <c:v>22.4921875</c:v>
                </c:pt>
                <c:pt idx="122">
                  <c:v>22.4921875</c:v>
                </c:pt>
                <c:pt idx="123">
                  <c:v>19.5</c:v>
                </c:pt>
                <c:pt idx="124">
                  <c:v>19.5</c:v>
                </c:pt>
                <c:pt idx="125">
                  <c:v>19</c:v>
                </c:pt>
                <c:pt idx="126">
                  <c:v>19</c:v>
                </c:pt>
                <c:pt idx="127">
                  <c:v>19</c:v>
                </c:pt>
                <c:pt idx="128">
                  <c:v>20</c:v>
                </c:pt>
                <c:pt idx="129">
                  <c:v>20</c:v>
                </c:pt>
                <c:pt idx="130">
                  <c:v>20</c:v>
                </c:pt>
                <c:pt idx="131">
                  <c:v>19.5</c:v>
                </c:pt>
                <c:pt idx="132">
                  <c:v>19.5</c:v>
                </c:pt>
                <c:pt idx="133">
                  <c:v>25.484375</c:v>
                </c:pt>
                <c:pt idx="134">
                  <c:v>25.484375</c:v>
                </c:pt>
                <c:pt idx="135">
                  <c:v>22.625</c:v>
                </c:pt>
                <c:pt idx="136">
                  <c:v>22.625</c:v>
                </c:pt>
                <c:pt idx="137">
                  <c:v>21.5</c:v>
                </c:pt>
                <c:pt idx="138">
                  <c:v>21.5</c:v>
                </c:pt>
                <c:pt idx="139">
                  <c:v>21</c:v>
                </c:pt>
                <c:pt idx="140">
                  <c:v>21</c:v>
                </c:pt>
                <c:pt idx="141">
                  <c:v>21</c:v>
                </c:pt>
                <c:pt idx="142">
                  <c:v>22</c:v>
                </c:pt>
                <c:pt idx="143">
                  <c:v>22</c:v>
                </c:pt>
                <c:pt idx="144">
                  <c:v>22</c:v>
                </c:pt>
                <c:pt idx="145">
                  <c:v>21.5</c:v>
                </c:pt>
                <c:pt idx="146">
                  <c:v>21.5</c:v>
                </c:pt>
                <c:pt idx="147">
                  <c:v>23.75</c:v>
                </c:pt>
                <c:pt idx="148">
                  <c:v>23.75</c:v>
                </c:pt>
                <c:pt idx="149">
                  <c:v>23</c:v>
                </c:pt>
                <c:pt idx="150">
                  <c:v>23</c:v>
                </c:pt>
                <c:pt idx="151">
                  <c:v>23</c:v>
                </c:pt>
                <c:pt idx="152">
                  <c:v>24.5</c:v>
                </c:pt>
                <c:pt idx="153">
                  <c:v>24.5</c:v>
                </c:pt>
                <c:pt idx="154">
                  <c:v>24</c:v>
                </c:pt>
                <c:pt idx="155">
                  <c:v>24</c:v>
                </c:pt>
                <c:pt idx="156">
                  <c:v>24</c:v>
                </c:pt>
                <c:pt idx="157">
                  <c:v>25</c:v>
                </c:pt>
                <c:pt idx="158">
                  <c:v>25</c:v>
                </c:pt>
                <c:pt idx="159">
                  <c:v>25</c:v>
                </c:pt>
                <c:pt idx="160">
                  <c:v>24.5</c:v>
                </c:pt>
                <c:pt idx="161">
                  <c:v>24.5</c:v>
                </c:pt>
                <c:pt idx="162">
                  <c:v>23.75</c:v>
                </c:pt>
                <c:pt idx="163">
                  <c:v>23.75</c:v>
                </c:pt>
                <c:pt idx="164">
                  <c:v>22.625</c:v>
                </c:pt>
                <c:pt idx="165">
                  <c:v>22.625</c:v>
                </c:pt>
                <c:pt idx="166">
                  <c:v>28.34375</c:v>
                </c:pt>
                <c:pt idx="167">
                  <c:v>28.34375</c:v>
                </c:pt>
                <c:pt idx="168">
                  <c:v>26.75</c:v>
                </c:pt>
                <c:pt idx="169">
                  <c:v>26.75</c:v>
                </c:pt>
                <c:pt idx="170">
                  <c:v>26</c:v>
                </c:pt>
                <c:pt idx="171">
                  <c:v>26</c:v>
                </c:pt>
                <c:pt idx="172">
                  <c:v>26</c:v>
                </c:pt>
                <c:pt idx="173">
                  <c:v>27.5</c:v>
                </c:pt>
                <c:pt idx="174">
                  <c:v>27.5</c:v>
                </c:pt>
                <c:pt idx="175">
                  <c:v>27</c:v>
                </c:pt>
                <c:pt idx="176">
                  <c:v>27</c:v>
                </c:pt>
                <c:pt idx="177">
                  <c:v>27</c:v>
                </c:pt>
                <c:pt idx="178">
                  <c:v>28</c:v>
                </c:pt>
                <c:pt idx="179">
                  <c:v>28</c:v>
                </c:pt>
                <c:pt idx="180">
                  <c:v>28</c:v>
                </c:pt>
                <c:pt idx="181">
                  <c:v>27.5</c:v>
                </c:pt>
                <c:pt idx="182">
                  <c:v>27.5</c:v>
                </c:pt>
                <c:pt idx="183">
                  <c:v>26.75</c:v>
                </c:pt>
                <c:pt idx="184">
                  <c:v>26.75</c:v>
                </c:pt>
                <c:pt idx="185">
                  <c:v>29.9375</c:v>
                </c:pt>
                <c:pt idx="186">
                  <c:v>29.9375</c:v>
                </c:pt>
                <c:pt idx="187">
                  <c:v>29</c:v>
                </c:pt>
                <c:pt idx="188">
                  <c:v>29</c:v>
                </c:pt>
                <c:pt idx="189">
                  <c:v>29</c:v>
                </c:pt>
                <c:pt idx="190">
                  <c:v>30.875</c:v>
                </c:pt>
                <c:pt idx="191">
                  <c:v>30.875</c:v>
                </c:pt>
                <c:pt idx="192">
                  <c:v>30</c:v>
                </c:pt>
                <c:pt idx="193">
                  <c:v>30</c:v>
                </c:pt>
                <c:pt idx="194">
                  <c:v>30</c:v>
                </c:pt>
                <c:pt idx="195">
                  <c:v>31.75</c:v>
                </c:pt>
                <c:pt idx="196">
                  <c:v>31.75</c:v>
                </c:pt>
                <c:pt idx="197">
                  <c:v>31</c:v>
                </c:pt>
                <c:pt idx="198">
                  <c:v>31</c:v>
                </c:pt>
                <c:pt idx="199">
                  <c:v>31</c:v>
                </c:pt>
                <c:pt idx="200">
                  <c:v>32.5</c:v>
                </c:pt>
                <c:pt idx="201">
                  <c:v>32.5</c:v>
                </c:pt>
                <c:pt idx="202">
                  <c:v>32</c:v>
                </c:pt>
                <c:pt idx="203">
                  <c:v>32</c:v>
                </c:pt>
                <c:pt idx="204">
                  <c:v>32</c:v>
                </c:pt>
                <c:pt idx="205">
                  <c:v>33</c:v>
                </c:pt>
                <c:pt idx="206">
                  <c:v>33</c:v>
                </c:pt>
                <c:pt idx="207">
                  <c:v>33</c:v>
                </c:pt>
                <c:pt idx="208">
                  <c:v>32.5</c:v>
                </c:pt>
                <c:pt idx="209">
                  <c:v>32.5</c:v>
                </c:pt>
                <c:pt idx="210">
                  <c:v>31.75</c:v>
                </c:pt>
                <c:pt idx="211">
                  <c:v>31.75</c:v>
                </c:pt>
                <c:pt idx="212">
                  <c:v>30.875</c:v>
                </c:pt>
                <c:pt idx="213">
                  <c:v>30.875</c:v>
                </c:pt>
                <c:pt idx="214">
                  <c:v>29.9375</c:v>
                </c:pt>
                <c:pt idx="215">
                  <c:v>29.9375</c:v>
                </c:pt>
                <c:pt idx="216">
                  <c:v>28.34375</c:v>
                </c:pt>
                <c:pt idx="217">
                  <c:v>28.34375</c:v>
                </c:pt>
                <c:pt idx="218">
                  <c:v>25.484375</c:v>
                </c:pt>
                <c:pt idx="219">
                  <c:v>25.484375</c:v>
                </c:pt>
                <c:pt idx="220">
                  <c:v>22.4921875</c:v>
                </c:pt>
                <c:pt idx="221">
                  <c:v>22.4921875</c:v>
                </c:pt>
                <c:pt idx="222">
                  <c:v>18.18359375</c:v>
                </c:pt>
                <c:pt idx="223">
                  <c:v>18.18359375</c:v>
                </c:pt>
                <c:pt idx="224">
                  <c:v>106.49088859558105</c:v>
                </c:pt>
                <c:pt idx="225">
                  <c:v>106.49088859558105</c:v>
                </c:pt>
                <c:pt idx="226">
                  <c:v>37.546875</c:v>
                </c:pt>
                <c:pt idx="227">
                  <c:v>37.546875</c:v>
                </c:pt>
                <c:pt idx="228">
                  <c:v>34</c:v>
                </c:pt>
                <c:pt idx="229">
                  <c:v>34</c:v>
                </c:pt>
                <c:pt idx="230">
                  <c:v>34</c:v>
                </c:pt>
                <c:pt idx="231">
                  <c:v>41.09375</c:v>
                </c:pt>
                <c:pt idx="232">
                  <c:v>41.09375</c:v>
                </c:pt>
                <c:pt idx="233">
                  <c:v>37.6875</c:v>
                </c:pt>
                <c:pt idx="234">
                  <c:v>37.6875</c:v>
                </c:pt>
                <c:pt idx="235">
                  <c:v>35.75</c:v>
                </c:pt>
                <c:pt idx="236">
                  <c:v>35.75</c:v>
                </c:pt>
                <c:pt idx="237">
                  <c:v>35</c:v>
                </c:pt>
                <c:pt idx="238">
                  <c:v>35</c:v>
                </c:pt>
                <c:pt idx="239">
                  <c:v>35</c:v>
                </c:pt>
                <c:pt idx="240">
                  <c:v>36.5</c:v>
                </c:pt>
                <c:pt idx="241">
                  <c:v>36.5</c:v>
                </c:pt>
                <c:pt idx="242">
                  <c:v>36</c:v>
                </c:pt>
                <c:pt idx="243">
                  <c:v>36</c:v>
                </c:pt>
                <c:pt idx="244">
                  <c:v>36</c:v>
                </c:pt>
                <c:pt idx="245">
                  <c:v>37</c:v>
                </c:pt>
                <c:pt idx="246">
                  <c:v>37</c:v>
                </c:pt>
                <c:pt idx="247">
                  <c:v>37</c:v>
                </c:pt>
                <c:pt idx="248">
                  <c:v>36.5</c:v>
                </c:pt>
                <c:pt idx="249">
                  <c:v>36.5</c:v>
                </c:pt>
                <c:pt idx="250">
                  <c:v>35.75</c:v>
                </c:pt>
                <c:pt idx="251">
                  <c:v>35.75</c:v>
                </c:pt>
                <c:pt idx="252">
                  <c:v>39.625</c:v>
                </c:pt>
                <c:pt idx="253">
                  <c:v>39.625</c:v>
                </c:pt>
                <c:pt idx="254">
                  <c:v>38.5</c:v>
                </c:pt>
                <c:pt idx="255">
                  <c:v>38.5</c:v>
                </c:pt>
                <c:pt idx="256">
                  <c:v>38</c:v>
                </c:pt>
                <c:pt idx="257">
                  <c:v>38</c:v>
                </c:pt>
                <c:pt idx="258">
                  <c:v>38</c:v>
                </c:pt>
                <c:pt idx="259">
                  <c:v>39</c:v>
                </c:pt>
                <c:pt idx="260">
                  <c:v>39</c:v>
                </c:pt>
                <c:pt idx="261">
                  <c:v>39</c:v>
                </c:pt>
                <c:pt idx="262">
                  <c:v>38.5</c:v>
                </c:pt>
                <c:pt idx="263">
                  <c:v>38.5</c:v>
                </c:pt>
                <c:pt idx="264">
                  <c:v>40.75</c:v>
                </c:pt>
                <c:pt idx="265">
                  <c:v>40.75</c:v>
                </c:pt>
                <c:pt idx="266">
                  <c:v>40</c:v>
                </c:pt>
                <c:pt idx="267">
                  <c:v>40</c:v>
                </c:pt>
                <c:pt idx="268">
                  <c:v>40</c:v>
                </c:pt>
                <c:pt idx="269">
                  <c:v>41.5</c:v>
                </c:pt>
                <c:pt idx="270">
                  <c:v>41.5</c:v>
                </c:pt>
                <c:pt idx="271">
                  <c:v>41</c:v>
                </c:pt>
                <c:pt idx="272">
                  <c:v>41</c:v>
                </c:pt>
                <c:pt idx="273">
                  <c:v>41</c:v>
                </c:pt>
                <c:pt idx="274">
                  <c:v>42</c:v>
                </c:pt>
                <c:pt idx="275">
                  <c:v>42</c:v>
                </c:pt>
                <c:pt idx="276">
                  <c:v>42</c:v>
                </c:pt>
                <c:pt idx="277">
                  <c:v>41.5</c:v>
                </c:pt>
                <c:pt idx="278">
                  <c:v>41.5</c:v>
                </c:pt>
                <c:pt idx="279">
                  <c:v>40.75</c:v>
                </c:pt>
                <c:pt idx="280">
                  <c:v>40.75</c:v>
                </c:pt>
                <c:pt idx="281">
                  <c:v>39.625</c:v>
                </c:pt>
                <c:pt idx="282">
                  <c:v>39.625</c:v>
                </c:pt>
                <c:pt idx="283">
                  <c:v>37.6875</c:v>
                </c:pt>
                <c:pt idx="284">
                  <c:v>37.6875</c:v>
                </c:pt>
                <c:pt idx="285">
                  <c:v>44.5</c:v>
                </c:pt>
                <c:pt idx="286">
                  <c:v>44.5</c:v>
                </c:pt>
                <c:pt idx="287">
                  <c:v>43.5</c:v>
                </c:pt>
                <c:pt idx="288">
                  <c:v>43.5</c:v>
                </c:pt>
                <c:pt idx="289">
                  <c:v>43</c:v>
                </c:pt>
                <c:pt idx="290">
                  <c:v>43</c:v>
                </c:pt>
                <c:pt idx="291">
                  <c:v>43</c:v>
                </c:pt>
                <c:pt idx="292">
                  <c:v>44</c:v>
                </c:pt>
                <c:pt idx="293">
                  <c:v>44</c:v>
                </c:pt>
                <c:pt idx="294">
                  <c:v>44</c:v>
                </c:pt>
                <c:pt idx="295">
                  <c:v>43.5</c:v>
                </c:pt>
                <c:pt idx="296">
                  <c:v>43.5</c:v>
                </c:pt>
                <c:pt idx="297">
                  <c:v>45.5</c:v>
                </c:pt>
                <c:pt idx="298">
                  <c:v>45.5</c:v>
                </c:pt>
                <c:pt idx="299">
                  <c:v>45</c:v>
                </c:pt>
                <c:pt idx="300">
                  <c:v>45</c:v>
                </c:pt>
                <c:pt idx="301">
                  <c:v>45</c:v>
                </c:pt>
                <c:pt idx="302">
                  <c:v>46</c:v>
                </c:pt>
                <c:pt idx="303">
                  <c:v>46</c:v>
                </c:pt>
                <c:pt idx="304">
                  <c:v>46</c:v>
                </c:pt>
                <c:pt idx="305">
                  <c:v>45.5</c:v>
                </c:pt>
                <c:pt idx="306">
                  <c:v>45.5</c:v>
                </c:pt>
                <c:pt idx="307">
                  <c:v>44.5</c:v>
                </c:pt>
                <c:pt idx="308">
                  <c:v>44.5</c:v>
                </c:pt>
                <c:pt idx="309">
                  <c:v>41.09375</c:v>
                </c:pt>
                <c:pt idx="310">
                  <c:v>41.09375</c:v>
                </c:pt>
                <c:pt idx="311">
                  <c:v>37.546875</c:v>
                </c:pt>
                <c:pt idx="312">
                  <c:v>37.546875</c:v>
                </c:pt>
                <c:pt idx="313">
                  <c:v>175.43490219116211</c:v>
                </c:pt>
                <c:pt idx="314">
                  <c:v>175.43490219116211</c:v>
                </c:pt>
                <c:pt idx="315">
                  <c:v>73.229179382324219</c:v>
                </c:pt>
                <c:pt idx="316">
                  <c:v>73.229179382324219</c:v>
                </c:pt>
                <c:pt idx="317">
                  <c:v>55.078125</c:v>
                </c:pt>
                <c:pt idx="318">
                  <c:v>55.078125</c:v>
                </c:pt>
                <c:pt idx="319">
                  <c:v>50.78125</c:v>
                </c:pt>
                <c:pt idx="320">
                  <c:v>50.78125</c:v>
                </c:pt>
                <c:pt idx="321">
                  <c:v>47.9375</c:v>
                </c:pt>
                <c:pt idx="322">
                  <c:v>47.9375</c:v>
                </c:pt>
                <c:pt idx="323">
                  <c:v>47</c:v>
                </c:pt>
                <c:pt idx="324">
                  <c:v>47</c:v>
                </c:pt>
                <c:pt idx="325">
                  <c:v>47</c:v>
                </c:pt>
                <c:pt idx="326">
                  <c:v>48.875</c:v>
                </c:pt>
                <c:pt idx="327">
                  <c:v>48.875</c:v>
                </c:pt>
                <c:pt idx="328">
                  <c:v>48</c:v>
                </c:pt>
                <c:pt idx="329">
                  <c:v>48</c:v>
                </c:pt>
                <c:pt idx="330">
                  <c:v>48</c:v>
                </c:pt>
                <c:pt idx="331">
                  <c:v>49.75</c:v>
                </c:pt>
                <c:pt idx="332">
                  <c:v>49.75</c:v>
                </c:pt>
                <c:pt idx="333">
                  <c:v>49</c:v>
                </c:pt>
                <c:pt idx="334">
                  <c:v>49</c:v>
                </c:pt>
                <c:pt idx="335">
                  <c:v>49</c:v>
                </c:pt>
                <c:pt idx="336">
                  <c:v>50.5</c:v>
                </c:pt>
                <c:pt idx="337">
                  <c:v>50.5</c:v>
                </c:pt>
                <c:pt idx="338">
                  <c:v>50</c:v>
                </c:pt>
                <c:pt idx="339">
                  <c:v>50</c:v>
                </c:pt>
                <c:pt idx="340">
                  <c:v>50</c:v>
                </c:pt>
                <c:pt idx="341">
                  <c:v>51</c:v>
                </c:pt>
                <c:pt idx="342">
                  <c:v>51</c:v>
                </c:pt>
                <c:pt idx="343">
                  <c:v>51</c:v>
                </c:pt>
                <c:pt idx="344">
                  <c:v>50.5</c:v>
                </c:pt>
                <c:pt idx="345">
                  <c:v>50.5</c:v>
                </c:pt>
                <c:pt idx="346">
                  <c:v>49.75</c:v>
                </c:pt>
                <c:pt idx="347">
                  <c:v>49.75</c:v>
                </c:pt>
                <c:pt idx="348">
                  <c:v>48.875</c:v>
                </c:pt>
                <c:pt idx="349">
                  <c:v>48.875</c:v>
                </c:pt>
                <c:pt idx="350">
                  <c:v>47.9375</c:v>
                </c:pt>
                <c:pt idx="351">
                  <c:v>47.9375</c:v>
                </c:pt>
                <c:pt idx="352">
                  <c:v>53.625</c:v>
                </c:pt>
                <c:pt idx="353">
                  <c:v>53.625</c:v>
                </c:pt>
                <c:pt idx="354">
                  <c:v>52.5</c:v>
                </c:pt>
                <c:pt idx="355">
                  <c:v>52.5</c:v>
                </c:pt>
                <c:pt idx="356">
                  <c:v>52</c:v>
                </c:pt>
                <c:pt idx="357">
                  <c:v>52</c:v>
                </c:pt>
                <c:pt idx="358">
                  <c:v>52</c:v>
                </c:pt>
                <c:pt idx="359">
                  <c:v>53</c:v>
                </c:pt>
                <c:pt idx="360">
                  <c:v>53</c:v>
                </c:pt>
                <c:pt idx="361">
                  <c:v>53</c:v>
                </c:pt>
                <c:pt idx="362">
                  <c:v>52.5</c:v>
                </c:pt>
                <c:pt idx="363">
                  <c:v>52.5</c:v>
                </c:pt>
                <c:pt idx="364">
                  <c:v>54.75</c:v>
                </c:pt>
                <c:pt idx="365">
                  <c:v>54.75</c:v>
                </c:pt>
                <c:pt idx="366">
                  <c:v>54</c:v>
                </c:pt>
                <c:pt idx="367">
                  <c:v>54</c:v>
                </c:pt>
                <c:pt idx="368">
                  <c:v>54</c:v>
                </c:pt>
                <c:pt idx="369">
                  <c:v>55.5</c:v>
                </c:pt>
                <c:pt idx="370">
                  <c:v>55.5</c:v>
                </c:pt>
                <c:pt idx="371">
                  <c:v>55</c:v>
                </c:pt>
                <c:pt idx="372">
                  <c:v>55</c:v>
                </c:pt>
                <c:pt idx="373">
                  <c:v>55</c:v>
                </c:pt>
                <c:pt idx="374">
                  <c:v>56</c:v>
                </c:pt>
                <c:pt idx="375">
                  <c:v>56</c:v>
                </c:pt>
                <c:pt idx="376">
                  <c:v>56</c:v>
                </c:pt>
                <c:pt idx="377">
                  <c:v>55.5</c:v>
                </c:pt>
                <c:pt idx="378">
                  <c:v>55.5</c:v>
                </c:pt>
                <c:pt idx="379">
                  <c:v>54.75</c:v>
                </c:pt>
                <c:pt idx="380">
                  <c:v>54.75</c:v>
                </c:pt>
                <c:pt idx="381">
                  <c:v>53.625</c:v>
                </c:pt>
                <c:pt idx="382">
                  <c:v>53.625</c:v>
                </c:pt>
                <c:pt idx="383">
                  <c:v>50.78125</c:v>
                </c:pt>
                <c:pt idx="384">
                  <c:v>50.78125</c:v>
                </c:pt>
                <c:pt idx="385">
                  <c:v>59.375</c:v>
                </c:pt>
                <c:pt idx="386">
                  <c:v>59.375</c:v>
                </c:pt>
                <c:pt idx="387">
                  <c:v>57.5</c:v>
                </c:pt>
                <c:pt idx="388">
                  <c:v>57.5</c:v>
                </c:pt>
                <c:pt idx="389">
                  <c:v>57</c:v>
                </c:pt>
                <c:pt idx="390">
                  <c:v>57</c:v>
                </c:pt>
                <c:pt idx="391">
                  <c:v>57</c:v>
                </c:pt>
                <c:pt idx="392">
                  <c:v>58</c:v>
                </c:pt>
                <c:pt idx="393">
                  <c:v>58</c:v>
                </c:pt>
                <c:pt idx="394">
                  <c:v>58</c:v>
                </c:pt>
                <c:pt idx="395">
                  <c:v>57.5</c:v>
                </c:pt>
                <c:pt idx="396">
                  <c:v>57.5</c:v>
                </c:pt>
                <c:pt idx="397">
                  <c:v>61.25</c:v>
                </c:pt>
                <c:pt idx="398">
                  <c:v>61.25</c:v>
                </c:pt>
                <c:pt idx="399">
                  <c:v>59.75</c:v>
                </c:pt>
                <c:pt idx="400">
                  <c:v>59.75</c:v>
                </c:pt>
                <c:pt idx="401">
                  <c:v>59</c:v>
                </c:pt>
                <c:pt idx="402">
                  <c:v>59</c:v>
                </c:pt>
                <c:pt idx="403">
                  <c:v>59</c:v>
                </c:pt>
                <c:pt idx="404">
                  <c:v>60.5</c:v>
                </c:pt>
                <c:pt idx="405">
                  <c:v>60.5</c:v>
                </c:pt>
                <c:pt idx="406">
                  <c:v>60</c:v>
                </c:pt>
                <c:pt idx="407">
                  <c:v>60</c:v>
                </c:pt>
                <c:pt idx="408">
                  <c:v>60</c:v>
                </c:pt>
                <c:pt idx="409">
                  <c:v>61</c:v>
                </c:pt>
                <c:pt idx="410">
                  <c:v>61</c:v>
                </c:pt>
                <c:pt idx="411">
                  <c:v>61</c:v>
                </c:pt>
                <c:pt idx="412">
                  <c:v>60.5</c:v>
                </c:pt>
                <c:pt idx="413">
                  <c:v>60.5</c:v>
                </c:pt>
                <c:pt idx="414">
                  <c:v>59.75</c:v>
                </c:pt>
                <c:pt idx="415">
                  <c:v>59.75</c:v>
                </c:pt>
                <c:pt idx="416">
                  <c:v>62.75</c:v>
                </c:pt>
                <c:pt idx="417">
                  <c:v>62.75</c:v>
                </c:pt>
                <c:pt idx="418">
                  <c:v>62</c:v>
                </c:pt>
                <c:pt idx="419">
                  <c:v>62</c:v>
                </c:pt>
                <c:pt idx="420">
                  <c:v>62</c:v>
                </c:pt>
                <c:pt idx="421">
                  <c:v>63.5</c:v>
                </c:pt>
                <c:pt idx="422">
                  <c:v>63.5</c:v>
                </c:pt>
                <c:pt idx="423">
                  <c:v>63</c:v>
                </c:pt>
                <c:pt idx="424">
                  <c:v>63</c:v>
                </c:pt>
                <c:pt idx="425">
                  <c:v>63</c:v>
                </c:pt>
                <c:pt idx="426">
                  <c:v>64</c:v>
                </c:pt>
                <c:pt idx="427">
                  <c:v>64</c:v>
                </c:pt>
                <c:pt idx="428">
                  <c:v>64</c:v>
                </c:pt>
                <c:pt idx="429">
                  <c:v>63.5</c:v>
                </c:pt>
                <c:pt idx="430">
                  <c:v>63.5</c:v>
                </c:pt>
                <c:pt idx="431">
                  <c:v>62.75</c:v>
                </c:pt>
                <c:pt idx="432">
                  <c:v>62.75</c:v>
                </c:pt>
                <c:pt idx="433">
                  <c:v>61.25</c:v>
                </c:pt>
                <c:pt idx="434">
                  <c:v>61.25</c:v>
                </c:pt>
                <c:pt idx="435">
                  <c:v>59.375</c:v>
                </c:pt>
                <c:pt idx="436">
                  <c:v>59.375</c:v>
                </c:pt>
                <c:pt idx="437">
                  <c:v>55.078125</c:v>
                </c:pt>
                <c:pt idx="438">
                  <c:v>55.078125</c:v>
                </c:pt>
                <c:pt idx="439">
                  <c:v>91.380233764648438</c:v>
                </c:pt>
                <c:pt idx="440">
                  <c:v>91.380233764648438</c:v>
                </c:pt>
                <c:pt idx="441">
                  <c:v>69.4140625</c:v>
                </c:pt>
                <c:pt idx="442">
                  <c:v>69.4140625</c:v>
                </c:pt>
                <c:pt idx="443">
                  <c:v>65.5</c:v>
                </c:pt>
                <c:pt idx="444">
                  <c:v>65.5</c:v>
                </c:pt>
                <c:pt idx="445">
                  <c:v>65</c:v>
                </c:pt>
                <c:pt idx="446">
                  <c:v>65</c:v>
                </c:pt>
                <c:pt idx="447">
                  <c:v>65</c:v>
                </c:pt>
                <c:pt idx="448">
                  <c:v>66</c:v>
                </c:pt>
                <c:pt idx="449">
                  <c:v>66</c:v>
                </c:pt>
                <c:pt idx="450">
                  <c:v>66</c:v>
                </c:pt>
                <c:pt idx="451">
                  <c:v>65.5</c:v>
                </c:pt>
                <c:pt idx="452">
                  <c:v>65.5</c:v>
                </c:pt>
                <c:pt idx="453">
                  <c:v>73.328125</c:v>
                </c:pt>
                <c:pt idx="454">
                  <c:v>73.328125</c:v>
                </c:pt>
                <c:pt idx="455">
                  <c:v>69.6875</c:v>
                </c:pt>
                <c:pt idx="456">
                  <c:v>69.6875</c:v>
                </c:pt>
                <c:pt idx="457">
                  <c:v>67.875</c:v>
                </c:pt>
                <c:pt idx="458">
                  <c:v>67.875</c:v>
                </c:pt>
                <c:pt idx="459">
                  <c:v>67</c:v>
                </c:pt>
                <c:pt idx="460">
                  <c:v>67</c:v>
                </c:pt>
                <c:pt idx="461">
                  <c:v>67</c:v>
                </c:pt>
                <c:pt idx="462">
                  <c:v>68.75</c:v>
                </c:pt>
                <c:pt idx="463">
                  <c:v>68.75</c:v>
                </c:pt>
                <c:pt idx="464">
                  <c:v>68</c:v>
                </c:pt>
                <c:pt idx="465">
                  <c:v>68</c:v>
                </c:pt>
                <c:pt idx="466">
                  <c:v>68</c:v>
                </c:pt>
                <c:pt idx="467">
                  <c:v>69.5</c:v>
                </c:pt>
                <c:pt idx="468">
                  <c:v>69.5</c:v>
                </c:pt>
                <c:pt idx="469">
                  <c:v>69</c:v>
                </c:pt>
                <c:pt idx="470">
                  <c:v>69</c:v>
                </c:pt>
                <c:pt idx="471">
                  <c:v>69</c:v>
                </c:pt>
                <c:pt idx="472">
                  <c:v>70</c:v>
                </c:pt>
                <c:pt idx="473">
                  <c:v>70</c:v>
                </c:pt>
                <c:pt idx="474">
                  <c:v>70</c:v>
                </c:pt>
                <c:pt idx="475">
                  <c:v>69.5</c:v>
                </c:pt>
                <c:pt idx="476">
                  <c:v>69.5</c:v>
                </c:pt>
                <c:pt idx="477">
                  <c:v>68.75</c:v>
                </c:pt>
                <c:pt idx="478">
                  <c:v>68.75</c:v>
                </c:pt>
                <c:pt idx="479">
                  <c:v>67.875</c:v>
                </c:pt>
                <c:pt idx="480">
                  <c:v>67.875</c:v>
                </c:pt>
                <c:pt idx="481">
                  <c:v>71.5</c:v>
                </c:pt>
                <c:pt idx="482">
                  <c:v>71.5</c:v>
                </c:pt>
                <c:pt idx="483">
                  <c:v>71</c:v>
                </c:pt>
                <c:pt idx="484">
                  <c:v>71</c:v>
                </c:pt>
                <c:pt idx="485">
                  <c:v>71</c:v>
                </c:pt>
                <c:pt idx="486">
                  <c:v>72</c:v>
                </c:pt>
                <c:pt idx="487">
                  <c:v>72</c:v>
                </c:pt>
                <c:pt idx="488">
                  <c:v>72</c:v>
                </c:pt>
                <c:pt idx="489">
                  <c:v>71.5</c:v>
                </c:pt>
                <c:pt idx="490">
                  <c:v>71.5</c:v>
                </c:pt>
                <c:pt idx="491">
                  <c:v>69.6875</c:v>
                </c:pt>
                <c:pt idx="492">
                  <c:v>69.6875</c:v>
                </c:pt>
                <c:pt idx="493">
                  <c:v>76.96875</c:v>
                </c:pt>
                <c:pt idx="494">
                  <c:v>76.96875</c:v>
                </c:pt>
                <c:pt idx="495">
                  <c:v>74.625</c:v>
                </c:pt>
                <c:pt idx="496">
                  <c:v>74.625</c:v>
                </c:pt>
                <c:pt idx="497">
                  <c:v>73.5</c:v>
                </c:pt>
                <c:pt idx="498">
                  <c:v>73.5</c:v>
                </c:pt>
                <c:pt idx="499">
                  <c:v>73</c:v>
                </c:pt>
                <c:pt idx="500">
                  <c:v>73</c:v>
                </c:pt>
                <c:pt idx="501">
                  <c:v>73</c:v>
                </c:pt>
                <c:pt idx="502">
                  <c:v>74</c:v>
                </c:pt>
                <c:pt idx="503">
                  <c:v>74</c:v>
                </c:pt>
                <c:pt idx="504">
                  <c:v>74</c:v>
                </c:pt>
                <c:pt idx="505">
                  <c:v>73.5</c:v>
                </c:pt>
                <c:pt idx="506">
                  <c:v>73.5</c:v>
                </c:pt>
                <c:pt idx="507">
                  <c:v>75.75</c:v>
                </c:pt>
                <c:pt idx="508">
                  <c:v>75.75</c:v>
                </c:pt>
                <c:pt idx="509">
                  <c:v>75</c:v>
                </c:pt>
                <c:pt idx="510">
                  <c:v>75</c:v>
                </c:pt>
                <c:pt idx="511">
                  <c:v>75</c:v>
                </c:pt>
                <c:pt idx="512">
                  <c:v>76.5</c:v>
                </c:pt>
                <c:pt idx="513">
                  <c:v>76.5</c:v>
                </c:pt>
                <c:pt idx="514">
                  <c:v>76</c:v>
                </c:pt>
                <c:pt idx="515">
                  <c:v>76</c:v>
                </c:pt>
                <c:pt idx="516">
                  <c:v>76</c:v>
                </c:pt>
                <c:pt idx="517">
                  <c:v>77</c:v>
                </c:pt>
                <c:pt idx="518">
                  <c:v>77</c:v>
                </c:pt>
                <c:pt idx="519">
                  <c:v>77</c:v>
                </c:pt>
                <c:pt idx="520">
                  <c:v>76.5</c:v>
                </c:pt>
                <c:pt idx="521">
                  <c:v>76.5</c:v>
                </c:pt>
                <c:pt idx="522">
                  <c:v>75.75</c:v>
                </c:pt>
                <c:pt idx="523">
                  <c:v>75.75</c:v>
                </c:pt>
                <c:pt idx="524">
                  <c:v>74.625</c:v>
                </c:pt>
                <c:pt idx="525">
                  <c:v>74.625</c:v>
                </c:pt>
                <c:pt idx="526">
                  <c:v>79.3125</c:v>
                </c:pt>
                <c:pt idx="527">
                  <c:v>79.3125</c:v>
                </c:pt>
                <c:pt idx="528">
                  <c:v>78</c:v>
                </c:pt>
                <c:pt idx="529">
                  <c:v>78</c:v>
                </c:pt>
                <c:pt idx="530">
                  <c:v>78</c:v>
                </c:pt>
                <c:pt idx="531">
                  <c:v>80.625</c:v>
                </c:pt>
                <c:pt idx="532">
                  <c:v>80.625</c:v>
                </c:pt>
                <c:pt idx="533">
                  <c:v>79.5</c:v>
                </c:pt>
                <c:pt idx="534">
                  <c:v>79.5</c:v>
                </c:pt>
                <c:pt idx="535">
                  <c:v>79</c:v>
                </c:pt>
                <c:pt idx="536">
                  <c:v>79</c:v>
                </c:pt>
                <c:pt idx="537">
                  <c:v>79</c:v>
                </c:pt>
                <c:pt idx="538">
                  <c:v>80</c:v>
                </c:pt>
                <c:pt idx="539">
                  <c:v>80</c:v>
                </c:pt>
                <c:pt idx="540">
                  <c:v>80</c:v>
                </c:pt>
                <c:pt idx="541">
                  <c:v>79.5</c:v>
                </c:pt>
                <c:pt idx="542">
                  <c:v>79.5</c:v>
                </c:pt>
                <c:pt idx="543">
                  <c:v>81.75</c:v>
                </c:pt>
                <c:pt idx="544">
                  <c:v>81.75</c:v>
                </c:pt>
                <c:pt idx="545">
                  <c:v>81</c:v>
                </c:pt>
                <c:pt idx="546">
                  <c:v>81</c:v>
                </c:pt>
                <c:pt idx="547">
                  <c:v>81</c:v>
                </c:pt>
                <c:pt idx="548">
                  <c:v>82.5</c:v>
                </c:pt>
                <c:pt idx="549">
                  <c:v>82.5</c:v>
                </c:pt>
                <c:pt idx="550">
                  <c:v>82</c:v>
                </c:pt>
                <c:pt idx="551">
                  <c:v>82</c:v>
                </c:pt>
                <c:pt idx="552">
                  <c:v>82</c:v>
                </c:pt>
                <c:pt idx="553">
                  <c:v>83</c:v>
                </c:pt>
                <c:pt idx="554">
                  <c:v>83</c:v>
                </c:pt>
                <c:pt idx="555">
                  <c:v>83</c:v>
                </c:pt>
                <c:pt idx="556">
                  <c:v>82.5</c:v>
                </c:pt>
                <c:pt idx="557">
                  <c:v>82.5</c:v>
                </c:pt>
                <c:pt idx="558">
                  <c:v>81.75</c:v>
                </c:pt>
                <c:pt idx="559">
                  <c:v>81.75</c:v>
                </c:pt>
                <c:pt idx="560">
                  <c:v>80.625</c:v>
                </c:pt>
                <c:pt idx="561">
                  <c:v>80.625</c:v>
                </c:pt>
                <c:pt idx="562">
                  <c:v>79.3125</c:v>
                </c:pt>
                <c:pt idx="563">
                  <c:v>79.3125</c:v>
                </c:pt>
                <c:pt idx="564">
                  <c:v>76.96875</c:v>
                </c:pt>
                <c:pt idx="565">
                  <c:v>76.96875</c:v>
                </c:pt>
                <c:pt idx="566">
                  <c:v>73.328125</c:v>
                </c:pt>
                <c:pt idx="567">
                  <c:v>73.328125</c:v>
                </c:pt>
                <c:pt idx="568">
                  <c:v>69.4140625</c:v>
                </c:pt>
                <c:pt idx="569">
                  <c:v>69.4140625</c:v>
                </c:pt>
                <c:pt idx="570">
                  <c:v>113.34640502929688</c:v>
                </c:pt>
                <c:pt idx="571">
                  <c:v>113.34640502929688</c:v>
                </c:pt>
                <c:pt idx="572">
                  <c:v>97.2890625</c:v>
                </c:pt>
                <c:pt idx="573">
                  <c:v>97.2890625</c:v>
                </c:pt>
                <c:pt idx="574">
                  <c:v>91.25</c:v>
                </c:pt>
                <c:pt idx="575">
                  <c:v>91.25</c:v>
                </c:pt>
                <c:pt idx="576">
                  <c:v>86.3125</c:v>
                </c:pt>
                <c:pt idx="577">
                  <c:v>86.3125</c:v>
                </c:pt>
                <c:pt idx="578">
                  <c:v>84.75</c:v>
                </c:pt>
                <c:pt idx="579">
                  <c:v>84.75</c:v>
                </c:pt>
                <c:pt idx="580">
                  <c:v>84</c:v>
                </c:pt>
                <c:pt idx="581">
                  <c:v>84</c:v>
                </c:pt>
                <c:pt idx="582">
                  <c:v>84</c:v>
                </c:pt>
                <c:pt idx="583">
                  <c:v>85.5</c:v>
                </c:pt>
                <c:pt idx="584">
                  <c:v>85.5</c:v>
                </c:pt>
                <c:pt idx="585">
                  <c:v>85</c:v>
                </c:pt>
                <c:pt idx="586">
                  <c:v>85</c:v>
                </c:pt>
                <c:pt idx="587">
                  <c:v>85</c:v>
                </c:pt>
                <c:pt idx="588">
                  <c:v>86</c:v>
                </c:pt>
                <c:pt idx="589">
                  <c:v>86</c:v>
                </c:pt>
                <c:pt idx="590">
                  <c:v>86</c:v>
                </c:pt>
                <c:pt idx="591">
                  <c:v>85.5</c:v>
                </c:pt>
                <c:pt idx="592">
                  <c:v>85.5</c:v>
                </c:pt>
                <c:pt idx="593">
                  <c:v>84.75</c:v>
                </c:pt>
                <c:pt idx="594">
                  <c:v>84.75</c:v>
                </c:pt>
                <c:pt idx="595">
                  <c:v>87.875</c:v>
                </c:pt>
                <c:pt idx="596">
                  <c:v>87.875</c:v>
                </c:pt>
                <c:pt idx="597">
                  <c:v>87</c:v>
                </c:pt>
                <c:pt idx="598">
                  <c:v>87</c:v>
                </c:pt>
                <c:pt idx="599">
                  <c:v>87</c:v>
                </c:pt>
                <c:pt idx="600">
                  <c:v>88.75</c:v>
                </c:pt>
                <c:pt idx="601">
                  <c:v>88.75</c:v>
                </c:pt>
                <c:pt idx="602">
                  <c:v>88</c:v>
                </c:pt>
                <c:pt idx="603">
                  <c:v>88</c:v>
                </c:pt>
                <c:pt idx="604">
                  <c:v>88</c:v>
                </c:pt>
                <c:pt idx="605">
                  <c:v>89.5</c:v>
                </c:pt>
                <c:pt idx="606">
                  <c:v>89.5</c:v>
                </c:pt>
                <c:pt idx="607">
                  <c:v>89</c:v>
                </c:pt>
                <c:pt idx="608">
                  <c:v>89</c:v>
                </c:pt>
                <c:pt idx="609">
                  <c:v>89</c:v>
                </c:pt>
                <c:pt idx="610">
                  <c:v>90</c:v>
                </c:pt>
                <c:pt idx="611">
                  <c:v>90</c:v>
                </c:pt>
                <c:pt idx="612">
                  <c:v>90</c:v>
                </c:pt>
                <c:pt idx="613">
                  <c:v>89.5</c:v>
                </c:pt>
                <c:pt idx="614">
                  <c:v>89.5</c:v>
                </c:pt>
                <c:pt idx="615">
                  <c:v>88.75</c:v>
                </c:pt>
                <c:pt idx="616">
                  <c:v>88.75</c:v>
                </c:pt>
                <c:pt idx="617">
                  <c:v>87.875</c:v>
                </c:pt>
                <c:pt idx="618">
                  <c:v>87.875</c:v>
                </c:pt>
                <c:pt idx="619">
                  <c:v>86.3125</c:v>
                </c:pt>
                <c:pt idx="620">
                  <c:v>86.3125</c:v>
                </c:pt>
                <c:pt idx="621">
                  <c:v>96.1875</c:v>
                </c:pt>
                <c:pt idx="622">
                  <c:v>96.1875</c:v>
                </c:pt>
                <c:pt idx="623">
                  <c:v>93.625</c:v>
                </c:pt>
                <c:pt idx="624">
                  <c:v>93.625</c:v>
                </c:pt>
                <c:pt idx="625">
                  <c:v>91.75</c:v>
                </c:pt>
                <c:pt idx="626">
                  <c:v>91.75</c:v>
                </c:pt>
                <c:pt idx="627">
                  <c:v>91</c:v>
                </c:pt>
                <c:pt idx="628">
                  <c:v>91</c:v>
                </c:pt>
                <c:pt idx="629">
                  <c:v>91</c:v>
                </c:pt>
                <c:pt idx="630">
                  <c:v>92.5</c:v>
                </c:pt>
                <c:pt idx="631">
                  <c:v>92.5</c:v>
                </c:pt>
                <c:pt idx="632">
                  <c:v>92</c:v>
                </c:pt>
                <c:pt idx="633">
                  <c:v>92</c:v>
                </c:pt>
                <c:pt idx="634">
                  <c:v>92</c:v>
                </c:pt>
                <c:pt idx="635">
                  <c:v>93</c:v>
                </c:pt>
                <c:pt idx="636">
                  <c:v>93</c:v>
                </c:pt>
                <c:pt idx="637">
                  <c:v>93</c:v>
                </c:pt>
                <c:pt idx="638">
                  <c:v>92.5</c:v>
                </c:pt>
                <c:pt idx="639">
                  <c:v>92.5</c:v>
                </c:pt>
                <c:pt idx="640">
                  <c:v>91.75</c:v>
                </c:pt>
                <c:pt idx="641">
                  <c:v>91.75</c:v>
                </c:pt>
                <c:pt idx="642">
                  <c:v>95.5</c:v>
                </c:pt>
                <c:pt idx="643">
                  <c:v>95.5</c:v>
                </c:pt>
                <c:pt idx="644">
                  <c:v>94.5</c:v>
                </c:pt>
                <c:pt idx="645">
                  <c:v>94.5</c:v>
                </c:pt>
                <c:pt idx="646">
                  <c:v>94</c:v>
                </c:pt>
                <c:pt idx="647">
                  <c:v>94</c:v>
                </c:pt>
                <c:pt idx="648">
                  <c:v>94</c:v>
                </c:pt>
                <c:pt idx="649">
                  <c:v>95</c:v>
                </c:pt>
                <c:pt idx="650">
                  <c:v>95</c:v>
                </c:pt>
                <c:pt idx="651">
                  <c:v>95</c:v>
                </c:pt>
                <c:pt idx="652">
                  <c:v>94.5</c:v>
                </c:pt>
                <c:pt idx="653">
                  <c:v>94.5</c:v>
                </c:pt>
                <c:pt idx="654">
                  <c:v>96.5</c:v>
                </c:pt>
                <c:pt idx="655">
                  <c:v>96.5</c:v>
                </c:pt>
                <c:pt idx="656">
                  <c:v>96</c:v>
                </c:pt>
                <c:pt idx="657">
                  <c:v>96</c:v>
                </c:pt>
                <c:pt idx="658">
                  <c:v>96</c:v>
                </c:pt>
                <c:pt idx="659">
                  <c:v>97</c:v>
                </c:pt>
                <c:pt idx="660">
                  <c:v>97</c:v>
                </c:pt>
                <c:pt idx="661">
                  <c:v>97</c:v>
                </c:pt>
                <c:pt idx="662">
                  <c:v>96.5</c:v>
                </c:pt>
                <c:pt idx="663">
                  <c:v>96.5</c:v>
                </c:pt>
                <c:pt idx="664">
                  <c:v>95.5</c:v>
                </c:pt>
                <c:pt idx="665">
                  <c:v>95.5</c:v>
                </c:pt>
                <c:pt idx="666">
                  <c:v>93.625</c:v>
                </c:pt>
                <c:pt idx="667">
                  <c:v>93.625</c:v>
                </c:pt>
                <c:pt idx="668">
                  <c:v>98.75</c:v>
                </c:pt>
                <c:pt idx="669">
                  <c:v>98.75</c:v>
                </c:pt>
                <c:pt idx="670">
                  <c:v>98</c:v>
                </c:pt>
                <c:pt idx="671">
                  <c:v>98</c:v>
                </c:pt>
                <c:pt idx="672">
                  <c:v>98</c:v>
                </c:pt>
                <c:pt idx="673">
                  <c:v>99.5</c:v>
                </c:pt>
                <c:pt idx="674">
                  <c:v>99.5</c:v>
                </c:pt>
                <c:pt idx="675">
                  <c:v>99</c:v>
                </c:pt>
                <c:pt idx="676">
                  <c:v>99</c:v>
                </c:pt>
                <c:pt idx="677">
                  <c:v>99</c:v>
                </c:pt>
                <c:pt idx="678">
                  <c:v>100</c:v>
                </c:pt>
                <c:pt idx="679">
                  <c:v>100</c:v>
                </c:pt>
                <c:pt idx="680">
                  <c:v>100</c:v>
                </c:pt>
                <c:pt idx="681">
                  <c:v>99.5</c:v>
                </c:pt>
                <c:pt idx="682">
                  <c:v>99.5</c:v>
                </c:pt>
                <c:pt idx="683">
                  <c:v>98.75</c:v>
                </c:pt>
                <c:pt idx="684">
                  <c:v>98.75</c:v>
                </c:pt>
                <c:pt idx="685">
                  <c:v>96.1875</c:v>
                </c:pt>
                <c:pt idx="686">
                  <c:v>96.1875</c:v>
                </c:pt>
                <c:pt idx="687">
                  <c:v>91.25</c:v>
                </c:pt>
                <c:pt idx="688">
                  <c:v>91.25</c:v>
                </c:pt>
                <c:pt idx="689">
                  <c:v>103.328125</c:v>
                </c:pt>
                <c:pt idx="690">
                  <c:v>103.328125</c:v>
                </c:pt>
                <c:pt idx="691">
                  <c:v>101</c:v>
                </c:pt>
                <c:pt idx="692">
                  <c:v>101</c:v>
                </c:pt>
                <c:pt idx="693">
                  <c:v>101</c:v>
                </c:pt>
                <c:pt idx="694">
                  <c:v>105.65625</c:v>
                </c:pt>
                <c:pt idx="695">
                  <c:v>105.65625</c:v>
                </c:pt>
                <c:pt idx="696">
                  <c:v>102.75</c:v>
                </c:pt>
                <c:pt idx="697">
                  <c:v>102.75</c:v>
                </c:pt>
                <c:pt idx="698">
                  <c:v>102</c:v>
                </c:pt>
                <c:pt idx="699">
                  <c:v>102</c:v>
                </c:pt>
                <c:pt idx="700">
                  <c:v>102</c:v>
                </c:pt>
                <c:pt idx="701">
                  <c:v>103.5</c:v>
                </c:pt>
                <c:pt idx="702">
                  <c:v>103.5</c:v>
                </c:pt>
                <c:pt idx="703">
                  <c:v>103</c:v>
                </c:pt>
                <c:pt idx="704">
                  <c:v>103</c:v>
                </c:pt>
                <c:pt idx="705">
                  <c:v>103</c:v>
                </c:pt>
                <c:pt idx="706">
                  <c:v>104</c:v>
                </c:pt>
                <c:pt idx="707">
                  <c:v>104</c:v>
                </c:pt>
                <c:pt idx="708">
                  <c:v>104</c:v>
                </c:pt>
                <c:pt idx="709">
                  <c:v>103.5</c:v>
                </c:pt>
                <c:pt idx="710">
                  <c:v>103.5</c:v>
                </c:pt>
                <c:pt idx="711">
                  <c:v>102.75</c:v>
                </c:pt>
                <c:pt idx="712">
                  <c:v>102.75</c:v>
                </c:pt>
                <c:pt idx="713">
                  <c:v>108.5625</c:v>
                </c:pt>
                <c:pt idx="714">
                  <c:v>108.5625</c:v>
                </c:pt>
                <c:pt idx="715">
                  <c:v>106.625</c:v>
                </c:pt>
                <c:pt idx="716">
                  <c:v>106.625</c:v>
                </c:pt>
                <c:pt idx="717">
                  <c:v>105.5</c:v>
                </c:pt>
                <c:pt idx="718">
                  <c:v>105.5</c:v>
                </c:pt>
                <c:pt idx="719">
                  <c:v>105</c:v>
                </c:pt>
                <c:pt idx="720">
                  <c:v>105</c:v>
                </c:pt>
                <c:pt idx="721">
                  <c:v>105</c:v>
                </c:pt>
                <c:pt idx="722">
                  <c:v>106</c:v>
                </c:pt>
                <c:pt idx="723">
                  <c:v>106</c:v>
                </c:pt>
                <c:pt idx="724">
                  <c:v>106</c:v>
                </c:pt>
                <c:pt idx="725">
                  <c:v>105.5</c:v>
                </c:pt>
                <c:pt idx="726">
                  <c:v>105.5</c:v>
                </c:pt>
                <c:pt idx="727">
                  <c:v>107.75</c:v>
                </c:pt>
                <c:pt idx="728">
                  <c:v>107.75</c:v>
                </c:pt>
                <c:pt idx="729">
                  <c:v>107</c:v>
                </c:pt>
                <c:pt idx="730">
                  <c:v>107</c:v>
                </c:pt>
                <c:pt idx="731">
                  <c:v>107</c:v>
                </c:pt>
                <c:pt idx="732">
                  <c:v>108.5</c:v>
                </c:pt>
                <c:pt idx="733">
                  <c:v>108.5</c:v>
                </c:pt>
                <c:pt idx="734">
                  <c:v>108</c:v>
                </c:pt>
                <c:pt idx="735">
                  <c:v>108</c:v>
                </c:pt>
                <c:pt idx="736">
                  <c:v>108</c:v>
                </c:pt>
                <c:pt idx="737">
                  <c:v>109</c:v>
                </c:pt>
                <c:pt idx="738">
                  <c:v>109</c:v>
                </c:pt>
                <c:pt idx="739">
                  <c:v>109</c:v>
                </c:pt>
                <c:pt idx="740">
                  <c:v>108.5</c:v>
                </c:pt>
                <c:pt idx="741">
                  <c:v>108.5</c:v>
                </c:pt>
                <c:pt idx="742">
                  <c:v>107.75</c:v>
                </c:pt>
                <c:pt idx="743">
                  <c:v>107.75</c:v>
                </c:pt>
                <c:pt idx="744">
                  <c:v>106.625</c:v>
                </c:pt>
                <c:pt idx="745">
                  <c:v>106.625</c:v>
                </c:pt>
                <c:pt idx="746">
                  <c:v>110.5</c:v>
                </c:pt>
                <c:pt idx="747">
                  <c:v>110.5</c:v>
                </c:pt>
                <c:pt idx="748">
                  <c:v>110</c:v>
                </c:pt>
                <c:pt idx="749">
                  <c:v>110</c:v>
                </c:pt>
                <c:pt idx="750">
                  <c:v>110</c:v>
                </c:pt>
                <c:pt idx="751">
                  <c:v>111</c:v>
                </c:pt>
                <c:pt idx="752">
                  <c:v>111</c:v>
                </c:pt>
                <c:pt idx="753">
                  <c:v>111</c:v>
                </c:pt>
                <c:pt idx="754">
                  <c:v>110.5</c:v>
                </c:pt>
                <c:pt idx="755">
                  <c:v>110.5</c:v>
                </c:pt>
                <c:pt idx="756">
                  <c:v>108.5625</c:v>
                </c:pt>
                <c:pt idx="757">
                  <c:v>108.5625</c:v>
                </c:pt>
                <c:pt idx="758">
                  <c:v>105.65625</c:v>
                </c:pt>
                <c:pt idx="759">
                  <c:v>105.65625</c:v>
                </c:pt>
                <c:pt idx="760">
                  <c:v>103.328125</c:v>
                </c:pt>
                <c:pt idx="761">
                  <c:v>103.328125</c:v>
                </c:pt>
                <c:pt idx="762">
                  <c:v>97.2890625</c:v>
                </c:pt>
                <c:pt idx="763">
                  <c:v>97.2890625</c:v>
                </c:pt>
                <c:pt idx="764">
                  <c:v>129.40374755859375</c:v>
                </c:pt>
                <c:pt idx="765">
                  <c:v>129.40374755859375</c:v>
                </c:pt>
                <c:pt idx="766">
                  <c:v>113.359375</c:v>
                </c:pt>
                <c:pt idx="767">
                  <c:v>113.359375</c:v>
                </c:pt>
                <c:pt idx="768">
                  <c:v>112</c:v>
                </c:pt>
                <c:pt idx="769">
                  <c:v>112</c:v>
                </c:pt>
                <c:pt idx="770">
                  <c:v>112</c:v>
                </c:pt>
                <c:pt idx="771">
                  <c:v>114.71875</c:v>
                </c:pt>
                <c:pt idx="772">
                  <c:v>114.71875</c:v>
                </c:pt>
                <c:pt idx="773">
                  <c:v>113.5</c:v>
                </c:pt>
                <c:pt idx="774">
                  <c:v>113.5</c:v>
                </c:pt>
                <c:pt idx="775">
                  <c:v>113</c:v>
                </c:pt>
                <c:pt idx="776">
                  <c:v>113</c:v>
                </c:pt>
                <c:pt idx="777">
                  <c:v>113</c:v>
                </c:pt>
                <c:pt idx="778">
                  <c:v>114</c:v>
                </c:pt>
                <c:pt idx="779">
                  <c:v>114</c:v>
                </c:pt>
                <c:pt idx="780">
                  <c:v>114</c:v>
                </c:pt>
                <c:pt idx="781">
                  <c:v>113.5</c:v>
                </c:pt>
                <c:pt idx="782">
                  <c:v>113.5</c:v>
                </c:pt>
                <c:pt idx="783">
                  <c:v>115.9375</c:v>
                </c:pt>
                <c:pt idx="784">
                  <c:v>115.9375</c:v>
                </c:pt>
                <c:pt idx="785">
                  <c:v>115</c:v>
                </c:pt>
                <c:pt idx="786">
                  <c:v>115</c:v>
                </c:pt>
                <c:pt idx="787">
                  <c:v>115</c:v>
                </c:pt>
                <c:pt idx="788">
                  <c:v>116.875</c:v>
                </c:pt>
                <c:pt idx="789">
                  <c:v>116.875</c:v>
                </c:pt>
                <c:pt idx="790">
                  <c:v>116</c:v>
                </c:pt>
                <c:pt idx="791">
                  <c:v>116</c:v>
                </c:pt>
                <c:pt idx="792">
                  <c:v>116</c:v>
                </c:pt>
                <c:pt idx="793">
                  <c:v>117.75</c:v>
                </c:pt>
                <c:pt idx="794">
                  <c:v>117.75</c:v>
                </c:pt>
                <c:pt idx="795">
                  <c:v>117</c:v>
                </c:pt>
                <c:pt idx="796">
                  <c:v>117</c:v>
                </c:pt>
                <c:pt idx="797">
                  <c:v>117</c:v>
                </c:pt>
                <c:pt idx="798">
                  <c:v>118.5</c:v>
                </c:pt>
                <c:pt idx="799">
                  <c:v>118.5</c:v>
                </c:pt>
                <c:pt idx="800">
                  <c:v>118</c:v>
                </c:pt>
                <c:pt idx="801">
                  <c:v>118</c:v>
                </c:pt>
                <c:pt idx="802">
                  <c:v>118</c:v>
                </c:pt>
                <c:pt idx="803">
                  <c:v>119</c:v>
                </c:pt>
                <c:pt idx="804">
                  <c:v>119</c:v>
                </c:pt>
                <c:pt idx="805">
                  <c:v>119</c:v>
                </c:pt>
                <c:pt idx="806">
                  <c:v>118.5</c:v>
                </c:pt>
                <c:pt idx="807">
                  <c:v>118.5</c:v>
                </c:pt>
                <c:pt idx="808">
                  <c:v>117.75</c:v>
                </c:pt>
                <c:pt idx="809">
                  <c:v>117.75</c:v>
                </c:pt>
                <c:pt idx="810">
                  <c:v>116.875</c:v>
                </c:pt>
                <c:pt idx="811">
                  <c:v>116.875</c:v>
                </c:pt>
                <c:pt idx="812">
                  <c:v>115.9375</c:v>
                </c:pt>
                <c:pt idx="813">
                  <c:v>115.9375</c:v>
                </c:pt>
                <c:pt idx="814">
                  <c:v>114.71875</c:v>
                </c:pt>
                <c:pt idx="815">
                  <c:v>114.71875</c:v>
                </c:pt>
                <c:pt idx="816">
                  <c:v>113.359375</c:v>
                </c:pt>
                <c:pt idx="817">
                  <c:v>113.359375</c:v>
                </c:pt>
                <c:pt idx="818">
                  <c:v>145.4481201171875</c:v>
                </c:pt>
                <c:pt idx="819">
                  <c:v>145.4481201171875</c:v>
                </c:pt>
                <c:pt idx="820">
                  <c:v>125.71875</c:v>
                </c:pt>
                <c:pt idx="821">
                  <c:v>125.71875</c:v>
                </c:pt>
                <c:pt idx="822">
                  <c:v>123.125</c:v>
                </c:pt>
                <c:pt idx="823">
                  <c:v>123.125</c:v>
                </c:pt>
                <c:pt idx="824">
                  <c:v>121.5</c:v>
                </c:pt>
                <c:pt idx="825">
                  <c:v>121.5</c:v>
                </c:pt>
                <c:pt idx="826">
                  <c:v>120.5</c:v>
                </c:pt>
                <c:pt idx="827">
                  <c:v>120.5</c:v>
                </c:pt>
                <c:pt idx="828">
                  <c:v>120</c:v>
                </c:pt>
                <c:pt idx="829">
                  <c:v>120</c:v>
                </c:pt>
                <c:pt idx="830">
                  <c:v>120</c:v>
                </c:pt>
                <c:pt idx="831">
                  <c:v>121</c:v>
                </c:pt>
                <c:pt idx="832">
                  <c:v>121</c:v>
                </c:pt>
                <c:pt idx="833">
                  <c:v>121</c:v>
                </c:pt>
                <c:pt idx="834">
                  <c:v>120.5</c:v>
                </c:pt>
                <c:pt idx="835">
                  <c:v>120.5</c:v>
                </c:pt>
                <c:pt idx="836">
                  <c:v>122.5</c:v>
                </c:pt>
                <c:pt idx="837">
                  <c:v>122.5</c:v>
                </c:pt>
                <c:pt idx="838">
                  <c:v>122</c:v>
                </c:pt>
                <c:pt idx="839">
                  <c:v>122</c:v>
                </c:pt>
                <c:pt idx="840">
                  <c:v>122</c:v>
                </c:pt>
                <c:pt idx="841">
                  <c:v>123</c:v>
                </c:pt>
                <c:pt idx="842">
                  <c:v>123</c:v>
                </c:pt>
                <c:pt idx="843">
                  <c:v>123</c:v>
                </c:pt>
                <c:pt idx="844">
                  <c:v>122.5</c:v>
                </c:pt>
                <c:pt idx="845">
                  <c:v>122.5</c:v>
                </c:pt>
                <c:pt idx="846">
                  <c:v>121.5</c:v>
                </c:pt>
                <c:pt idx="847">
                  <c:v>121.5</c:v>
                </c:pt>
                <c:pt idx="848">
                  <c:v>124.75</c:v>
                </c:pt>
                <c:pt idx="849">
                  <c:v>124.75</c:v>
                </c:pt>
                <c:pt idx="850">
                  <c:v>124</c:v>
                </c:pt>
                <c:pt idx="851">
                  <c:v>124</c:v>
                </c:pt>
                <c:pt idx="852">
                  <c:v>124</c:v>
                </c:pt>
                <c:pt idx="853">
                  <c:v>125.5</c:v>
                </c:pt>
                <c:pt idx="854">
                  <c:v>125.5</c:v>
                </c:pt>
                <c:pt idx="855">
                  <c:v>125</c:v>
                </c:pt>
                <c:pt idx="856">
                  <c:v>125</c:v>
                </c:pt>
                <c:pt idx="857">
                  <c:v>125</c:v>
                </c:pt>
                <c:pt idx="858">
                  <c:v>126</c:v>
                </c:pt>
                <c:pt idx="859">
                  <c:v>126</c:v>
                </c:pt>
                <c:pt idx="860">
                  <c:v>126</c:v>
                </c:pt>
                <c:pt idx="861">
                  <c:v>125.5</c:v>
                </c:pt>
                <c:pt idx="862">
                  <c:v>125.5</c:v>
                </c:pt>
                <c:pt idx="863">
                  <c:v>124.75</c:v>
                </c:pt>
                <c:pt idx="864">
                  <c:v>124.75</c:v>
                </c:pt>
                <c:pt idx="865">
                  <c:v>123.125</c:v>
                </c:pt>
                <c:pt idx="866">
                  <c:v>123.125</c:v>
                </c:pt>
                <c:pt idx="867">
                  <c:v>128.3125</c:v>
                </c:pt>
                <c:pt idx="868">
                  <c:v>128.3125</c:v>
                </c:pt>
                <c:pt idx="869">
                  <c:v>127</c:v>
                </c:pt>
                <c:pt idx="870">
                  <c:v>127</c:v>
                </c:pt>
                <c:pt idx="871">
                  <c:v>127</c:v>
                </c:pt>
                <c:pt idx="872">
                  <c:v>129.625</c:v>
                </c:pt>
                <c:pt idx="873">
                  <c:v>129.625</c:v>
                </c:pt>
                <c:pt idx="874">
                  <c:v>128.5</c:v>
                </c:pt>
                <c:pt idx="875">
                  <c:v>128.5</c:v>
                </c:pt>
                <c:pt idx="876">
                  <c:v>128</c:v>
                </c:pt>
                <c:pt idx="877">
                  <c:v>128</c:v>
                </c:pt>
                <c:pt idx="878">
                  <c:v>128</c:v>
                </c:pt>
                <c:pt idx="879">
                  <c:v>129</c:v>
                </c:pt>
                <c:pt idx="880">
                  <c:v>129</c:v>
                </c:pt>
                <c:pt idx="881">
                  <c:v>129</c:v>
                </c:pt>
                <c:pt idx="882">
                  <c:v>128.5</c:v>
                </c:pt>
                <c:pt idx="883">
                  <c:v>128.5</c:v>
                </c:pt>
                <c:pt idx="884">
                  <c:v>130.75</c:v>
                </c:pt>
                <c:pt idx="885">
                  <c:v>130.75</c:v>
                </c:pt>
                <c:pt idx="886">
                  <c:v>130</c:v>
                </c:pt>
                <c:pt idx="887">
                  <c:v>130</c:v>
                </c:pt>
                <c:pt idx="888">
                  <c:v>130</c:v>
                </c:pt>
                <c:pt idx="889">
                  <c:v>131.5</c:v>
                </c:pt>
                <c:pt idx="890">
                  <c:v>131.5</c:v>
                </c:pt>
                <c:pt idx="891">
                  <c:v>131</c:v>
                </c:pt>
                <c:pt idx="892">
                  <c:v>131</c:v>
                </c:pt>
                <c:pt idx="893">
                  <c:v>131</c:v>
                </c:pt>
                <c:pt idx="894">
                  <c:v>132</c:v>
                </c:pt>
                <c:pt idx="895">
                  <c:v>132</c:v>
                </c:pt>
                <c:pt idx="896">
                  <c:v>132</c:v>
                </c:pt>
                <c:pt idx="897">
                  <c:v>131.5</c:v>
                </c:pt>
                <c:pt idx="898">
                  <c:v>131.5</c:v>
                </c:pt>
                <c:pt idx="899">
                  <c:v>130.75</c:v>
                </c:pt>
                <c:pt idx="900">
                  <c:v>130.75</c:v>
                </c:pt>
                <c:pt idx="901">
                  <c:v>129.625</c:v>
                </c:pt>
                <c:pt idx="902">
                  <c:v>129.625</c:v>
                </c:pt>
                <c:pt idx="903">
                  <c:v>128.3125</c:v>
                </c:pt>
                <c:pt idx="904">
                  <c:v>128.3125</c:v>
                </c:pt>
                <c:pt idx="905">
                  <c:v>125.71875</c:v>
                </c:pt>
                <c:pt idx="906">
                  <c:v>125.71875</c:v>
                </c:pt>
                <c:pt idx="907">
                  <c:v>165.177490234375</c:v>
                </c:pt>
                <c:pt idx="908">
                  <c:v>165.177490234375</c:v>
                </c:pt>
                <c:pt idx="909">
                  <c:v>140.1875</c:v>
                </c:pt>
                <c:pt idx="910">
                  <c:v>140.1875</c:v>
                </c:pt>
                <c:pt idx="911">
                  <c:v>135.0625</c:v>
                </c:pt>
                <c:pt idx="912">
                  <c:v>135.0625</c:v>
                </c:pt>
                <c:pt idx="913">
                  <c:v>133.5</c:v>
                </c:pt>
                <c:pt idx="914">
                  <c:v>133.5</c:v>
                </c:pt>
                <c:pt idx="915">
                  <c:v>133</c:v>
                </c:pt>
                <c:pt idx="916">
                  <c:v>133</c:v>
                </c:pt>
                <c:pt idx="917">
                  <c:v>133</c:v>
                </c:pt>
                <c:pt idx="918">
                  <c:v>134</c:v>
                </c:pt>
                <c:pt idx="919">
                  <c:v>134</c:v>
                </c:pt>
                <c:pt idx="920">
                  <c:v>134</c:v>
                </c:pt>
                <c:pt idx="921">
                  <c:v>133.5</c:v>
                </c:pt>
                <c:pt idx="922">
                  <c:v>133.5</c:v>
                </c:pt>
                <c:pt idx="923">
                  <c:v>136.625</c:v>
                </c:pt>
                <c:pt idx="924">
                  <c:v>136.625</c:v>
                </c:pt>
                <c:pt idx="925">
                  <c:v>135.5</c:v>
                </c:pt>
                <c:pt idx="926">
                  <c:v>135.5</c:v>
                </c:pt>
                <c:pt idx="927">
                  <c:v>135</c:v>
                </c:pt>
                <c:pt idx="928">
                  <c:v>135</c:v>
                </c:pt>
                <c:pt idx="929">
                  <c:v>135</c:v>
                </c:pt>
                <c:pt idx="930">
                  <c:v>136</c:v>
                </c:pt>
                <c:pt idx="931">
                  <c:v>136</c:v>
                </c:pt>
                <c:pt idx="932">
                  <c:v>136</c:v>
                </c:pt>
                <c:pt idx="933">
                  <c:v>135.5</c:v>
                </c:pt>
                <c:pt idx="934">
                  <c:v>135.5</c:v>
                </c:pt>
                <c:pt idx="935">
                  <c:v>137.75</c:v>
                </c:pt>
                <c:pt idx="936">
                  <c:v>137.75</c:v>
                </c:pt>
                <c:pt idx="937">
                  <c:v>137</c:v>
                </c:pt>
                <c:pt idx="938">
                  <c:v>137</c:v>
                </c:pt>
                <c:pt idx="939">
                  <c:v>137</c:v>
                </c:pt>
                <c:pt idx="940">
                  <c:v>138.5</c:v>
                </c:pt>
                <c:pt idx="941">
                  <c:v>138.5</c:v>
                </c:pt>
                <c:pt idx="942">
                  <c:v>138</c:v>
                </c:pt>
                <c:pt idx="943">
                  <c:v>138</c:v>
                </c:pt>
                <c:pt idx="944">
                  <c:v>138</c:v>
                </c:pt>
                <c:pt idx="945">
                  <c:v>139</c:v>
                </c:pt>
                <c:pt idx="946">
                  <c:v>139</c:v>
                </c:pt>
                <c:pt idx="947">
                  <c:v>139</c:v>
                </c:pt>
                <c:pt idx="948">
                  <c:v>138.5</c:v>
                </c:pt>
                <c:pt idx="949">
                  <c:v>138.5</c:v>
                </c:pt>
                <c:pt idx="950">
                  <c:v>137.75</c:v>
                </c:pt>
                <c:pt idx="951">
                  <c:v>137.75</c:v>
                </c:pt>
                <c:pt idx="952">
                  <c:v>136.625</c:v>
                </c:pt>
                <c:pt idx="953">
                  <c:v>136.625</c:v>
                </c:pt>
                <c:pt idx="954">
                  <c:v>135.0625</c:v>
                </c:pt>
                <c:pt idx="955">
                  <c:v>135.0625</c:v>
                </c:pt>
                <c:pt idx="956">
                  <c:v>145.3125</c:v>
                </c:pt>
                <c:pt idx="957">
                  <c:v>145.3125</c:v>
                </c:pt>
                <c:pt idx="958">
                  <c:v>143</c:v>
                </c:pt>
                <c:pt idx="959">
                  <c:v>143</c:v>
                </c:pt>
                <c:pt idx="960">
                  <c:v>141.5</c:v>
                </c:pt>
                <c:pt idx="961">
                  <c:v>141.5</c:v>
                </c:pt>
                <c:pt idx="962">
                  <c:v>140.5</c:v>
                </c:pt>
                <c:pt idx="963">
                  <c:v>140.5</c:v>
                </c:pt>
                <c:pt idx="964">
                  <c:v>140</c:v>
                </c:pt>
                <c:pt idx="965">
                  <c:v>140</c:v>
                </c:pt>
                <c:pt idx="966">
                  <c:v>140</c:v>
                </c:pt>
                <c:pt idx="967">
                  <c:v>141</c:v>
                </c:pt>
                <c:pt idx="968">
                  <c:v>141</c:v>
                </c:pt>
                <c:pt idx="969">
                  <c:v>141</c:v>
                </c:pt>
                <c:pt idx="970">
                  <c:v>140.5</c:v>
                </c:pt>
                <c:pt idx="971">
                  <c:v>140.5</c:v>
                </c:pt>
                <c:pt idx="972">
                  <c:v>142.5</c:v>
                </c:pt>
                <c:pt idx="973">
                  <c:v>142.5</c:v>
                </c:pt>
                <c:pt idx="974">
                  <c:v>142</c:v>
                </c:pt>
                <c:pt idx="975">
                  <c:v>142</c:v>
                </c:pt>
                <c:pt idx="976">
                  <c:v>142</c:v>
                </c:pt>
                <c:pt idx="977">
                  <c:v>143</c:v>
                </c:pt>
                <c:pt idx="978">
                  <c:v>143</c:v>
                </c:pt>
                <c:pt idx="979">
                  <c:v>143</c:v>
                </c:pt>
                <c:pt idx="980">
                  <c:v>142.5</c:v>
                </c:pt>
                <c:pt idx="981">
                  <c:v>142.5</c:v>
                </c:pt>
                <c:pt idx="982">
                  <c:v>141.5</c:v>
                </c:pt>
                <c:pt idx="983">
                  <c:v>141.5</c:v>
                </c:pt>
                <c:pt idx="984">
                  <c:v>144.5</c:v>
                </c:pt>
                <c:pt idx="985">
                  <c:v>144.5</c:v>
                </c:pt>
                <c:pt idx="986">
                  <c:v>144</c:v>
                </c:pt>
                <c:pt idx="987">
                  <c:v>144</c:v>
                </c:pt>
                <c:pt idx="988">
                  <c:v>144</c:v>
                </c:pt>
                <c:pt idx="989">
                  <c:v>145</c:v>
                </c:pt>
                <c:pt idx="990">
                  <c:v>145</c:v>
                </c:pt>
                <c:pt idx="991">
                  <c:v>145</c:v>
                </c:pt>
                <c:pt idx="992">
                  <c:v>144.5</c:v>
                </c:pt>
                <c:pt idx="993">
                  <c:v>144.5</c:v>
                </c:pt>
                <c:pt idx="994">
                  <c:v>143</c:v>
                </c:pt>
                <c:pt idx="995">
                  <c:v>143</c:v>
                </c:pt>
                <c:pt idx="996">
                  <c:v>147.625</c:v>
                </c:pt>
                <c:pt idx="997">
                  <c:v>147.625</c:v>
                </c:pt>
                <c:pt idx="998">
                  <c:v>146.5</c:v>
                </c:pt>
                <c:pt idx="999">
                  <c:v>146.5</c:v>
                </c:pt>
                <c:pt idx="1000">
                  <c:v>146</c:v>
                </c:pt>
                <c:pt idx="1001">
                  <c:v>146</c:v>
                </c:pt>
                <c:pt idx="1002">
                  <c:v>146</c:v>
                </c:pt>
                <c:pt idx="1003">
                  <c:v>147</c:v>
                </c:pt>
                <c:pt idx="1004">
                  <c:v>147</c:v>
                </c:pt>
                <c:pt idx="1005">
                  <c:v>147</c:v>
                </c:pt>
                <c:pt idx="1006">
                  <c:v>146.5</c:v>
                </c:pt>
                <c:pt idx="1007">
                  <c:v>146.5</c:v>
                </c:pt>
                <c:pt idx="1008">
                  <c:v>148.75</c:v>
                </c:pt>
                <c:pt idx="1009">
                  <c:v>148.75</c:v>
                </c:pt>
                <c:pt idx="1010">
                  <c:v>148</c:v>
                </c:pt>
                <c:pt idx="1011">
                  <c:v>148</c:v>
                </c:pt>
                <c:pt idx="1012">
                  <c:v>148</c:v>
                </c:pt>
                <c:pt idx="1013">
                  <c:v>149.5</c:v>
                </c:pt>
                <c:pt idx="1014">
                  <c:v>149.5</c:v>
                </c:pt>
                <c:pt idx="1015">
                  <c:v>149</c:v>
                </c:pt>
                <c:pt idx="1016">
                  <c:v>149</c:v>
                </c:pt>
                <c:pt idx="1017">
                  <c:v>149</c:v>
                </c:pt>
                <c:pt idx="1018">
                  <c:v>150</c:v>
                </c:pt>
                <c:pt idx="1019">
                  <c:v>150</c:v>
                </c:pt>
                <c:pt idx="1020">
                  <c:v>150</c:v>
                </c:pt>
                <c:pt idx="1021">
                  <c:v>149.5</c:v>
                </c:pt>
                <c:pt idx="1022">
                  <c:v>149.5</c:v>
                </c:pt>
                <c:pt idx="1023">
                  <c:v>148.75</c:v>
                </c:pt>
                <c:pt idx="1024">
                  <c:v>148.75</c:v>
                </c:pt>
                <c:pt idx="1025">
                  <c:v>147.625</c:v>
                </c:pt>
                <c:pt idx="1026">
                  <c:v>147.625</c:v>
                </c:pt>
                <c:pt idx="1027">
                  <c:v>145.3125</c:v>
                </c:pt>
                <c:pt idx="1028">
                  <c:v>145.3125</c:v>
                </c:pt>
                <c:pt idx="1029">
                  <c:v>140.1875</c:v>
                </c:pt>
                <c:pt idx="1030">
                  <c:v>140.1875</c:v>
                </c:pt>
                <c:pt idx="1031">
                  <c:v>190.16748046875</c:v>
                </c:pt>
                <c:pt idx="1032">
                  <c:v>190.16748046875</c:v>
                </c:pt>
                <c:pt idx="1033">
                  <c:v>154.1875</c:v>
                </c:pt>
                <c:pt idx="1034">
                  <c:v>154.1875</c:v>
                </c:pt>
                <c:pt idx="1035">
                  <c:v>152.5</c:v>
                </c:pt>
                <c:pt idx="1036">
                  <c:v>152.5</c:v>
                </c:pt>
                <c:pt idx="1037">
                  <c:v>151.5</c:v>
                </c:pt>
                <c:pt idx="1038">
                  <c:v>151.5</c:v>
                </c:pt>
                <c:pt idx="1039">
                  <c:v>151</c:v>
                </c:pt>
                <c:pt idx="1040">
                  <c:v>151</c:v>
                </c:pt>
                <c:pt idx="1041">
                  <c:v>151</c:v>
                </c:pt>
                <c:pt idx="1042">
                  <c:v>152</c:v>
                </c:pt>
                <c:pt idx="1043">
                  <c:v>152</c:v>
                </c:pt>
                <c:pt idx="1044">
                  <c:v>152</c:v>
                </c:pt>
                <c:pt idx="1045">
                  <c:v>151.5</c:v>
                </c:pt>
                <c:pt idx="1046">
                  <c:v>151.5</c:v>
                </c:pt>
                <c:pt idx="1047">
                  <c:v>153.5</c:v>
                </c:pt>
                <c:pt idx="1048">
                  <c:v>153.5</c:v>
                </c:pt>
                <c:pt idx="1049">
                  <c:v>153</c:v>
                </c:pt>
                <c:pt idx="1050">
                  <c:v>153</c:v>
                </c:pt>
                <c:pt idx="1051">
                  <c:v>153</c:v>
                </c:pt>
                <c:pt idx="1052">
                  <c:v>154</c:v>
                </c:pt>
                <c:pt idx="1053">
                  <c:v>154</c:v>
                </c:pt>
                <c:pt idx="1054">
                  <c:v>154</c:v>
                </c:pt>
                <c:pt idx="1055">
                  <c:v>153.5</c:v>
                </c:pt>
                <c:pt idx="1056">
                  <c:v>153.5</c:v>
                </c:pt>
                <c:pt idx="1057">
                  <c:v>152.5</c:v>
                </c:pt>
                <c:pt idx="1058">
                  <c:v>152.5</c:v>
                </c:pt>
                <c:pt idx="1059">
                  <c:v>155.875</c:v>
                </c:pt>
                <c:pt idx="1060">
                  <c:v>155.875</c:v>
                </c:pt>
                <c:pt idx="1061">
                  <c:v>155</c:v>
                </c:pt>
                <c:pt idx="1062">
                  <c:v>155</c:v>
                </c:pt>
                <c:pt idx="1063">
                  <c:v>155</c:v>
                </c:pt>
                <c:pt idx="1064">
                  <c:v>156.75</c:v>
                </c:pt>
                <c:pt idx="1065">
                  <c:v>156.75</c:v>
                </c:pt>
                <c:pt idx="1066">
                  <c:v>156</c:v>
                </c:pt>
                <c:pt idx="1067">
                  <c:v>156</c:v>
                </c:pt>
                <c:pt idx="1068">
                  <c:v>156</c:v>
                </c:pt>
                <c:pt idx="1069">
                  <c:v>157.5</c:v>
                </c:pt>
                <c:pt idx="1070">
                  <c:v>157.5</c:v>
                </c:pt>
                <c:pt idx="1071">
                  <c:v>157</c:v>
                </c:pt>
                <c:pt idx="1072">
                  <c:v>157</c:v>
                </c:pt>
                <c:pt idx="1073">
                  <c:v>157</c:v>
                </c:pt>
                <c:pt idx="1074">
                  <c:v>158</c:v>
                </c:pt>
                <c:pt idx="1075">
                  <c:v>158</c:v>
                </c:pt>
                <c:pt idx="1076">
                  <c:v>158</c:v>
                </c:pt>
                <c:pt idx="1077">
                  <c:v>157.5</c:v>
                </c:pt>
                <c:pt idx="1078">
                  <c:v>157.5</c:v>
                </c:pt>
                <c:pt idx="1079">
                  <c:v>156.75</c:v>
                </c:pt>
                <c:pt idx="1080">
                  <c:v>156.75</c:v>
                </c:pt>
                <c:pt idx="1081">
                  <c:v>155.875</c:v>
                </c:pt>
                <c:pt idx="1082">
                  <c:v>155.875</c:v>
                </c:pt>
                <c:pt idx="1083">
                  <c:v>154.1875</c:v>
                </c:pt>
                <c:pt idx="1084">
                  <c:v>154.1875</c:v>
                </c:pt>
                <c:pt idx="1085">
                  <c:v>226.1474609375</c:v>
                </c:pt>
                <c:pt idx="1086">
                  <c:v>226.1474609375</c:v>
                </c:pt>
                <c:pt idx="1087">
                  <c:v>199.845703125</c:v>
                </c:pt>
                <c:pt idx="1088">
                  <c:v>199.845703125</c:v>
                </c:pt>
                <c:pt idx="1089">
                  <c:v>180.40234375</c:v>
                </c:pt>
                <c:pt idx="1090">
                  <c:v>180.40234375</c:v>
                </c:pt>
                <c:pt idx="1091">
                  <c:v>169.625</c:v>
                </c:pt>
                <c:pt idx="1092">
                  <c:v>169.625</c:v>
                </c:pt>
                <c:pt idx="1093">
                  <c:v>163.6875</c:v>
                </c:pt>
                <c:pt idx="1094">
                  <c:v>163.6875</c:v>
                </c:pt>
                <c:pt idx="1095">
                  <c:v>160.625</c:v>
                </c:pt>
                <c:pt idx="1096">
                  <c:v>160.625</c:v>
                </c:pt>
                <c:pt idx="1097">
                  <c:v>159.5</c:v>
                </c:pt>
                <c:pt idx="1098">
                  <c:v>159.5</c:v>
                </c:pt>
                <c:pt idx="1099">
                  <c:v>159</c:v>
                </c:pt>
                <c:pt idx="1100">
                  <c:v>159</c:v>
                </c:pt>
                <c:pt idx="1101">
                  <c:v>159</c:v>
                </c:pt>
                <c:pt idx="1102">
                  <c:v>160</c:v>
                </c:pt>
                <c:pt idx="1103">
                  <c:v>160</c:v>
                </c:pt>
                <c:pt idx="1104">
                  <c:v>160</c:v>
                </c:pt>
                <c:pt idx="1105">
                  <c:v>159.5</c:v>
                </c:pt>
                <c:pt idx="1106">
                  <c:v>159.5</c:v>
                </c:pt>
                <c:pt idx="1107">
                  <c:v>161.75</c:v>
                </c:pt>
                <c:pt idx="1108">
                  <c:v>161.75</c:v>
                </c:pt>
                <c:pt idx="1109">
                  <c:v>161</c:v>
                </c:pt>
                <c:pt idx="1110">
                  <c:v>161</c:v>
                </c:pt>
                <c:pt idx="1111">
                  <c:v>161</c:v>
                </c:pt>
                <c:pt idx="1112">
                  <c:v>162.5</c:v>
                </c:pt>
                <c:pt idx="1113">
                  <c:v>162.5</c:v>
                </c:pt>
                <c:pt idx="1114">
                  <c:v>162</c:v>
                </c:pt>
                <c:pt idx="1115">
                  <c:v>162</c:v>
                </c:pt>
                <c:pt idx="1116">
                  <c:v>162</c:v>
                </c:pt>
                <c:pt idx="1117">
                  <c:v>163</c:v>
                </c:pt>
                <c:pt idx="1118">
                  <c:v>163</c:v>
                </c:pt>
                <c:pt idx="1119">
                  <c:v>163</c:v>
                </c:pt>
                <c:pt idx="1120">
                  <c:v>162.5</c:v>
                </c:pt>
                <c:pt idx="1121">
                  <c:v>162.5</c:v>
                </c:pt>
                <c:pt idx="1122">
                  <c:v>161.75</c:v>
                </c:pt>
                <c:pt idx="1123">
                  <c:v>161.75</c:v>
                </c:pt>
                <c:pt idx="1124">
                  <c:v>160.625</c:v>
                </c:pt>
                <c:pt idx="1125">
                  <c:v>160.625</c:v>
                </c:pt>
                <c:pt idx="1126">
                  <c:v>166.75</c:v>
                </c:pt>
                <c:pt idx="1127">
                  <c:v>166.75</c:v>
                </c:pt>
                <c:pt idx="1128">
                  <c:v>164.5</c:v>
                </c:pt>
                <c:pt idx="1129">
                  <c:v>164.5</c:v>
                </c:pt>
                <c:pt idx="1130">
                  <c:v>164</c:v>
                </c:pt>
                <c:pt idx="1131">
                  <c:v>164</c:v>
                </c:pt>
                <c:pt idx="1132">
                  <c:v>164</c:v>
                </c:pt>
                <c:pt idx="1133">
                  <c:v>165</c:v>
                </c:pt>
                <c:pt idx="1134">
                  <c:v>165</c:v>
                </c:pt>
                <c:pt idx="1135">
                  <c:v>165</c:v>
                </c:pt>
                <c:pt idx="1136">
                  <c:v>164.5</c:v>
                </c:pt>
                <c:pt idx="1137">
                  <c:v>164.5</c:v>
                </c:pt>
                <c:pt idx="1138">
                  <c:v>169</c:v>
                </c:pt>
                <c:pt idx="1139">
                  <c:v>169</c:v>
                </c:pt>
                <c:pt idx="1140">
                  <c:v>167.5</c:v>
                </c:pt>
                <c:pt idx="1141">
                  <c:v>167.5</c:v>
                </c:pt>
                <c:pt idx="1142">
                  <c:v>166.5</c:v>
                </c:pt>
                <c:pt idx="1143">
                  <c:v>166.5</c:v>
                </c:pt>
                <c:pt idx="1144">
                  <c:v>166</c:v>
                </c:pt>
                <c:pt idx="1145">
                  <c:v>166</c:v>
                </c:pt>
                <c:pt idx="1146">
                  <c:v>166</c:v>
                </c:pt>
                <c:pt idx="1147">
                  <c:v>167</c:v>
                </c:pt>
                <c:pt idx="1148">
                  <c:v>167</c:v>
                </c:pt>
                <c:pt idx="1149">
                  <c:v>167</c:v>
                </c:pt>
                <c:pt idx="1150">
                  <c:v>166.5</c:v>
                </c:pt>
                <c:pt idx="1151">
                  <c:v>166.5</c:v>
                </c:pt>
                <c:pt idx="1152">
                  <c:v>168.5</c:v>
                </c:pt>
                <c:pt idx="1153">
                  <c:v>168.5</c:v>
                </c:pt>
                <c:pt idx="1154">
                  <c:v>168</c:v>
                </c:pt>
                <c:pt idx="1155">
                  <c:v>168</c:v>
                </c:pt>
                <c:pt idx="1156">
                  <c:v>168</c:v>
                </c:pt>
                <c:pt idx="1157">
                  <c:v>169</c:v>
                </c:pt>
                <c:pt idx="1158">
                  <c:v>169</c:v>
                </c:pt>
                <c:pt idx="1159">
                  <c:v>169</c:v>
                </c:pt>
                <c:pt idx="1160">
                  <c:v>168.5</c:v>
                </c:pt>
                <c:pt idx="1161">
                  <c:v>168.5</c:v>
                </c:pt>
                <c:pt idx="1162">
                  <c:v>167.5</c:v>
                </c:pt>
                <c:pt idx="1163">
                  <c:v>167.5</c:v>
                </c:pt>
                <c:pt idx="1164">
                  <c:v>170.5</c:v>
                </c:pt>
                <c:pt idx="1165">
                  <c:v>170.5</c:v>
                </c:pt>
                <c:pt idx="1166">
                  <c:v>170</c:v>
                </c:pt>
                <c:pt idx="1167">
                  <c:v>170</c:v>
                </c:pt>
                <c:pt idx="1168">
                  <c:v>170</c:v>
                </c:pt>
                <c:pt idx="1169">
                  <c:v>171</c:v>
                </c:pt>
                <c:pt idx="1170">
                  <c:v>171</c:v>
                </c:pt>
                <c:pt idx="1171">
                  <c:v>171</c:v>
                </c:pt>
                <c:pt idx="1172">
                  <c:v>170.5</c:v>
                </c:pt>
                <c:pt idx="1173">
                  <c:v>170.5</c:v>
                </c:pt>
                <c:pt idx="1174">
                  <c:v>169</c:v>
                </c:pt>
                <c:pt idx="1175">
                  <c:v>169</c:v>
                </c:pt>
                <c:pt idx="1176">
                  <c:v>166.75</c:v>
                </c:pt>
                <c:pt idx="1177">
                  <c:v>166.75</c:v>
                </c:pt>
                <c:pt idx="1178">
                  <c:v>163.6875</c:v>
                </c:pt>
                <c:pt idx="1179">
                  <c:v>163.6875</c:v>
                </c:pt>
                <c:pt idx="1180">
                  <c:v>175.5625</c:v>
                </c:pt>
                <c:pt idx="1181">
                  <c:v>175.5625</c:v>
                </c:pt>
                <c:pt idx="1182">
                  <c:v>173.5</c:v>
                </c:pt>
                <c:pt idx="1183">
                  <c:v>173.5</c:v>
                </c:pt>
                <c:pt idx="1184">
                  <c:v>172.5</c:v>
                </c:pt>
                <c:pt idx="1185">
                  <c:v>172.5</c:v>
                </c:pt>
                <c:pt idx="1186">
                  <c:v>172</c:v>
                </c:pt>
                <c:pt idx="1187">
                  <c:v>172</c:v>
                </c:pt>
                <c:pt idx="1188">
                  <c:v>172</c:v>
                </c:pt>
                <c:pt idx="1189">
                  <c:v>173</c:v>
                </c:pt>
                <c:pt idx="1190">
                  <c:v>173</c:v>
                </c:pt>
                <c:pt idx="1191">
                  <c:v>173</c:v>
                </c:pt>
                <c:pt idx="1192">
                  <c:v>172.5</c:v>
                </c:pt>
                <c:pt idx="1193">
                  <c:v>172.5</c:v>
                </c:pt>
                <c:pt idx="1194">
                  <c:v>174.5</c:v>
                </c:pt>
                <c:pt idx="1195">
                  <c:v>174.5</c:v>
                </c:pt>
                <c:pt idx="1196">
                  <c:v>174</c:v>
                </c:pt>
                <c:pt idx="1197">
                  <c:v>174</c:v>
                </c:pt>
                <c:pt idx="1198">
                  <c:v>174</c:v>
                </c:pt>
                <c:pt idx="1199">
                  <c:v>175</c:v>
                </c:pt>
                <c:pt idx="1200">
                  <c:v>175</c:v>
                </c:pt>
                <c:pt idx="1201">
                  <c:v>175</c:v>
                </c:pt>
                <c:pt idx="1202">
                  <c:v>174.5</c:v>
                </c:pt>
                <c:pt idx="1203">
                  <c:v>174.5</c:v>
                </c:pt>
                <c:pt idx="1204">
                  <c:v>173.5</c:v>
                </c:pt>
                <c:pt idx="1205">
                  <c:v>173.5</c:v>
                </c:pt>
                <c:pt idx="1206">
                  <c:v>177.625</c:v>
                </c:pt>
                <c:pt idx="1207">
                  <c:v>177.625</c:v>
                </c:pt>
                <c:pt idx="1208">
                  <c:v>176.5</c:v>
                </c:pt>
                <c:pt idx="1209">
                  <c:v>176.5</c:v>
                </c:pt>
                <c:pt idx="1210">
                  <c:v>176</c:v>
                </c:pt>
                <c:pt idx="1211">
                  <c:v>176</c:v>
                </c:pt>
                <c:pt idx="1212">
                  <c:v>176</c:v>
                </c:pt>
                <c:pt idx="1213">
                  <c:v>177</c:v>
                </c:pt>
                <c:pt idx="1214">
                  <c:v>177</c:v>
                </c:pt>
                <c:pt idx="1215">
                  <c:v>177</c:v>
                </c:pt>
                <c:pt idx="1216">
                  <c:v>176.5</c:v>
                </c:pt>
                <c:pt idx="1217">
                  <c:v>176.5</c:v>
                </c:pt>
                <c:pt idx="1218">
                  <c:v>178.75</c:v>
                </c:pt>
                <c:pt idx="1219">
                  <c:v>178.75</c:v>
                </c:pt>
                <c:pt idx="1220">
                  <c:v>178</c:v>
                </c:pt>
                <c:pt idx="1221">
                  <c:v>178</c:v>
                </c:pt>
                <c:pt idx="1222">
                  <c:v>178</c:v>
                </c:pt>
                <c:pt idx="1223">
                  <c:v>179.5</c:v>
                </c:pt>
                <c:pt idx="1224">
                  <c:v>179.5</c:v>
                </c:pt>
                <c:pt idx="1225">
                  <c:v>179</c:v>
                </c:pt>
                <c:pt idx="1226">
                  <c:v>179</c:v>
                </c:pt>
                <c:pt idx="1227">
                  <c:v>179</c:v>
                </c:pt>
                <c:pt idx="1228">
                  <c:v>180</c:v>
                </c:pt>
                <c:pt idx="1229">
                  <c:v>180</c:v>
                </c:pt>
                <c:pt idx="1230">
                  <c:v>180</c:v>
                </c:pt>
                <c:pt idx="1231">
                  <c:v>179.5</c:v>
                </c:pt>
                <c:pt idx="1232">
                  <c:v>179.5</c:v>
                </c:pt>
                <c:pt idx="1233">
                  <c:v>178.75</c:v>
                </c:pt>
                <c:pt idx="1234">
                  <c:v>178.75</c:v>
                </c:pt>
                <c:pt idx="1235">
                  <c:v>177.625</c:v>
                </c:pt>
                <c:pt idx="1236">
                  <c:v>177.625</c:v>
                </c:pt>
                <c:pt idx="1237">
                  <c:v>175.5625</c:v>
                </c:pt>
                <c:pt idx="1238">
                  <c:v>175.5625</c:v>
                </c:pt>
                <c:pt idx="1239">
                  <c:v>169.625</c:v>
                </c:pt>
                <c:pt idx="1240">
                  <c:v>169.625</c:v>
                </c:pt>
                <c:pt idx="1241">
                  <c:v>191.1796875</c:v>
                </c:pt>
                <c:pt idx="1242">
                  <c:v>191.1796875</c:v>
                </c:pt>
                <c:pt idx="1243">
                  <c:v>183.625</c:v>
                </c:pt>
                <c:pt idx="1244">
                  <c:v>183.625</c:v>
                </c:pt>
                <c:pt idx="1245">
                  <c:v>181.75</c:v>
                </c:pt>
                <c:pt idx="1246">
                  <c:v>181.75</c:v>
                </c:pt>
                <c:pt idx="1247">
                  <c:v>181</c:v>
                </c:pt>
                <c:pt idx="1248">
                  <c:v>181</c:v>
                </c:pt>
                <c:pt idx="1249">
                  <c:v>181</c:v>
                </c:pt>
                <c:pt idx="1250">
                  <c:v>182.5</c:v>
                </c:pt>
                <c:pt idx="1251">
                  <c:v>182.5</c:v>
                </c:pt>
                <c:pt idx="1252">
                  <c:v>182</c:v>
                </c:pt>
                <c:pt idx="1253">
                  <c:v>182</c:v>
                </c:pt>
                <c:pt idx="1254">
                  <c:v>182</c:v>
                </c:pt>
                <c:pt idx="1255">
                  <c:v>183</c:v>
                </c:pt>
                <c:pt idx="1256">
                  <c:v>183</c:v>
                </c:pt>
                <c:pt idx="1257">
                  <c:v>183</c:v>
                </c:pt>
                <c:pt idx="1258">
                  <c:v>182.5</c:v>
                </c:pt>
                <c:pt idx="1259">
                  <c:v>182.5</c:v>
                </c:pt>
                <c:pt idx="1260">
                  <c:v>181.75</c:v>
                </c:pt>
                <c:pt idx="1261">
                  <c:v>181.75</c:v>
                </c:pt>
                <c:pt idx="1262">
                  <c:v>185.5</c:v>
                </c:pt>
                <c:pt idx="1263">
                  <c:v>185.5</c:v>
                </c:pt>
                <c:pt idx="1264">
                  <c:v>184.5</c:v>
                </c:pt>
                <c:pt idx="1265">
                  <c:v>184.5</c:v>
                </c:pt>
                <c:pt idx="1266">
                  <c:v>184</c:v>
                </c:pt>
                <c:pt idx="1267">
                  <c:v>184</c:v>
                </c:pt>
                <c:pt idx="1268">
                  <c:v>184</c:v>
                </c:pt>
                <c:pt idx="1269">
                  <c:v>185</c:v>
                </c:pt>
                <c:pt idx="1270">
                  <c:v>185</c:v>
                </c:pt>
                <c:pt idx="1271">
                  <c:v>185</c:v>
                </c:pt>
                <c:pt idx="1272">
                  <c:v>184.5</c:v>
                </c:pt>
                <c:pt idx="1273">
                  <c:v>184.5</c:v>
                </c:pt>
                <c:pt idx="1274">
                  <c:v>186.5</c:v>
                </c:pt>
                <c:pt idx="1275">
                  <c:v>186.5</c:v>
                </c:pt>
                <c:pt idx="1276">
                  <c:v>186</c:v>
                </c:pt>
                <c:pt idx="1277">
                  <c:v>186</c:v>
                </c:pt>
                <c:pt idx="1278">
                  <c:v>186</c:v>
                </c:pt>
                <c:pt idx="1279">
                  <c:v>187</c:v>
                </c:pt>
                <c:pt idx="1280">
                  <c:v>187</c:v>
                </c:pt>
                <c:pt idx="1281">
                  <c:v>187</c:v>
                </c:pt>
                <c:pt idx="1282">
                  <c:v>186.5</c:v>
                </c:pt>
                <c:pt idx="1283">
                  <c:v>186.5</c:v>
                </c:pt>
                <c:pt idx="1284">
                  <c:v>185.5</c:v>
                </c:pt>
                <c:pt idx="1285">
                  <c:v>185.5</c:v>
                </c:pt>
                <c:pt idx="1286">
                  <c:v>183.625</c:v>
                </c:pt>
                <c:pt idx="1287">
                  <c:v>183.625</c:v>
                </c:pt>
                <c:pt idx="1288">
                  <c:v>198.734375</c:v>
                </c:pt>
                <c:pt idx="1289">
                  <c:v>198.734375</c:v>
                </c:pt>
                <c:pt idx="1290">
                  <c:v>194.40625</c:v>
                </c:pt>
                <c:pt idx="1291">
                  <c:v>194.40625</c:v>
                </c:pt>
                <c:pt idx="1292">
                  <c:v>190.6875</c:v>
                </c:pt>
                <c:pt idx="1293">
                  <c:v>190.6875</c:v>
                </c:pt>
                <c:pt idx="1294">
                  <c:v>188.75</c:v>
                </c:pt>
                <c:pt idx="1295">
                  <c:v>188.75</c:v>
                </c:pt>
                <c:pt idx="1296">
                  <c:v>188</c:v>
                </c:pt>
                <c:pt idx="1297">
                  <c:v>188</c:v>
                </c:pt>
                <c:pt idx="1298">
                  <c:v>188</c:v>
                </c:pt>
                <c:pt idx="1299">
                  <c:v>189.5</c:v>
                </c:pt>
                <c:pt idx="1300">
                  <c:v>189.5</c:v>
                </c:pt>
                <c:pt idx="1301">
                  <c:v>189</c:v>
                </c:pt>
                <c:pt idx="1302">
                  <c:v>189</c:v>
                </c:pt>
                <c:pt idx="1303">
                  <c:v>189</c:v>
                </c:pt>
                <c:pt idx="1304">
                  <c:v>190</c:v>
                </c:pt>
                <c:pt idx="1305">
                  <c:v>190</c:v>
                </c:pt>
                <c:pt idx="1306">
                  <c:v>190</c:v>
                </c:pt>
                <c:pt idx="1307">
                  <c:v>189.5</c:v>
                </c:pt>
                <c:pt idx="1308">
                  <c:v>189.5</c:v>
                </c:pt>
                <c:pt idx="1309">
                  <c:v>188.75</c:v>
                </c:pt>
                <c:pt idx="1310">
                  <c:v>188.75</c:v>
                </c:pt>
                <c:pt idx="1311">
                  <c:v>192.625</c:v>
                </c:pt>
                <c:pt idx="1312">
                  <c:v>192.625</c:v>
                </c:pt>
                <c:pt idx="1313">
                  <c:v>191.5</c:v>
                </c:pt>
                <c:pt idx="1314">
                  <c:v>191.5</c:v>
                </c:pt>
                <c:pt idx="1315">
                  <c:v>191</c:v>
                </c:pt>
                <c:pt idx="1316">
                  <c:v>191</c:v>
                </c:pt>
                <c:pt idx="1317">
                  <c:v>191</c:v>
                </c:pt>
                <c:pt idx="1318">
                  <c:v>192</c:v>
                </c:pt>
                <c:pt idx="1319">
                  <c:v>192</c:v>
                </c:pt>
                <c:pt idx="1320">
                  <c:v>192</c:v>
                </c:pt>
                <c:pt idx="1321">
                  <c:v>191.5</c:v>
                </c:pt>
                <c:pt idx="1322">
                  <c:v>191.5</c:v>
                </c:pt>
                <c:pt idx="1323">
                  <c:v>193.75</c:v>
                </c:pt>
                <c:pt idx="1324">
                  <c:v>193.75</c:v>
                </c:pt>
                <c:pt idx="1325">
                  <c:v>193</c:v>
                </c:pt>
                <c:pt idx="1326">
                  <c:v>193</c:v>
                </c:pt>
                <c:pt idx="1327">
                  <c:v>193</c:v>
                </c:pt>
                <c:pt idx="1328">
                  <c:v>194.5</c:v>
                </c:pt>
                <c:pt idx="1329">
                  <c:v>194.5</c:v>
                </c:pt>
                <c:pt idx="1330">
                  <c:v>194</c:v>
                </c:pt>
                <c:pt idx="1331">
                  <c:v>194</c:v>
                </c:pt>
                <c:pt idx="1332">
                  <c:v>194</c:v>
                </c:pt>
                <c:pt idx="1333">
                  <c:v>195</c:v>
                </c:pt>
                <c:pt idx="1334">
                  <c:v>195</c:v>
                </c:pt>
                <c:pt idx="1335">
                  <c:v>195</c:v>
                </c:pt>
                <c:pt idx="1336">
                  <c:v>194.5</c:v>
                </c:pt>
                <c:pt idx="1337">
                  <c:v>194.5</c:v>
                </c:pt>
                <c:pt idx="1338">
                  <c:v>193.75</c:v>
                </c:pt>
                <c:pt idx="1339">
                  <c:v>193.75</c:v>
                </c:pt>
                <c:pt idx="1340">
                  <c:v>192.625</c:v>
                </c:pt>
                <c:pt idx="1341">
                  <c:v>192.625</c:v>
                </c:pt>
                <c:pt idx="1342">
                  <c:v>190.6875</c:v>
                </c:pt>
                <c:pt idx="1343">
                  <c:v>190.6875</c:v>
                </c:pt>
                <c:pt idx="1344">
                  <c:v>198.125</c:v>
                </c:pt>
                <c:pt idx="1345">
                  <c:v>198.125</c:v>
                </c:pt>
                <c:pt idx="1346">
                  <c:v>196.75</c:v>
                </c:pt>
                <c:pt idx="1347">
                  <c:v>196.75</c:v>
                </c:pt>
                <c:pt idx="1348">
                  <c:v>196</c:v>
                </c:pt>
                <c:pt idx="1349">
                  <c:v>196</c:v>
                </c:pt>
                <c:pt idx="1350">
                  <c:v>196</c:v>
                </c:pt>
                <c:pt idx="1351">
                  <c:v>197.5</c:v>
                </c:pt>
                <c:pt idx="1352">
                  <c:v>197.5</c:v>
                </c:pt>
                <c:pt idx="1353">
                  <c:v>197</c:v>
                </c:pt>
                <c:pt idx="1354">
                  <c:v>197</c:v>
                </c:pt>
                <c:pt idx="1355">
                  <c:v>197</c:v>
                </c:pt>
                <c:pt idx="1356">
                  <c:v>198</c:v>
                </c:pt>
                <c:pt idx="1357">
                  <c:v>198</c:v>
                </c:pt>
                <c:pt idx="1358">
                  <c:v>198</c:v>
                </c:pt>
                <c:pt idx="1359">
                  <c:v>197.5</c:v>
                </c:pt>
                <c:pt idx="1360">
                  <c:v>197.5</c:v>
                </c:pt>
                <c:pt idx="1361">
                  <c:v>196.75</c:v>
                </c:pt>
                <c:pt idx="1362">
                  <c:v>196.75</c:v>
                </c:pt>
                <c:pt idx="1363">
                  <c:v>199.5</c:v>
                </c:pt>
                <c:pt idx="1364">
                  <c:v>199.5</c:v>
                </c:pt>
                <c:pt idx="1365">
                  <c:v>199</c:v>
                </c:pt>
                <c:pt idx="1366">
                  <c:v>199</c:v>
                </c:pt>
                <c:pt idx="1367">
                  <c:v>199</c:v>
                </c:pt>
                <c:pt idx="1368">
                  <c:v>200</c:v>
                </c:pt>
                <c:pt idx="1369">
                  <c:v>200</c:v>
                </c:pt>
                <c:pt idx="1370">
                  <c:v>200</c:v>
                </c:pt>
                <c:pt idx="1371">
                  <c:v>199.5</c:v>
                </c:pt>
                <c:pt idx="1372">
                  <c:v>199.5</c:v>
                </c:pt>
                <c:pt idx="1373">
                  <c:v>198.125</c:v>
                </c:pt>
                <c:pt idx="1374">
                  <c:v>198.125</c:v>
                </c:pt>
                <c:pt idx="1375">
                  <c:v>194.40625</c:v>
                </c:pt>
                <c:pt idx="1376">
                  <c:v>194.40625</c:v>
                </c:pt>
                <c:pt idx="1377">
                  <c:v>203.0625</c:v>
                </c:pt>
                <c:pt idx="1378">
                  <c:v>203.0625</c:v>
                </c:pt>
                <c:pt idx="1379">
                  <c:v>201.5</c:v>
                </c:pt>
                <c:pt idx="1380">
                  <c:v>201.5</c:v>
                </c:pt>
                <c:pt idx="1381">
                  <c:v>201</c:v>
                </c:pt>
                <c:pt idx="1382">
                  <c:v>201</c:v>
                </c:pt>
                <c:pt idx="1383">
                  <c:v>201</c:v>
                </c:pt>
                <c:pt idx="1384">
                  <c:v>202</c:v>
                </c:pt>
                <c:pt idx="1385">
                  <c:v>202</c:v>
                </c:pt>
                <c:pt idx="1386">
                  <c:v>202</c:v>
                </c:pt>
                <c:pt idx="1387">
                  <c:v>201.5</c:v>
                </c:pt>
                <c:pt idx="1388">
                  <c:v>201.5</c:v>
                </c:pt>
                <c:pt idx="1389">
                  <c:v>204.625</c:v>
                </c:pt>
                <c:pt idx="1390">
                  <c:v>204.625</c:v>
                </c:pt>
                <c:pt idx="1391">
                  <c:v>203.5</c:v>
                </c:pt>
                <c:pt idx="1392">
                  <c:v>203.5</c:v>
                </c:pt>
                <c:pt idx="1393">
                  <c:v>203</c:v>
                </c:pt>
                <c:pt idx="1394">
                  <c:v>203</c:v>
                </c:pt>
                <c:pt idx="1395">
                  <c:v>203</c:v>
                </c:pt>
                <c:pt idx="1396">
                  <c:v>204</c:v>
                </c:pt>
                <c:pt idx="1397">
                  <c:v>204</c:v>
                </c:pt>
                <c:pt idx="1398">
                  <c:v>204</c:v>
                </c:pt>
                <c:pt idx="1399">
                  <c:v>203.5</c:v>
                </c:pt>
                <c:pt idx="1400">
                  <c:v>203.5</c:v>
                </c:pt>
                <c:pt idx="1401">
                  <c:v>205.75</c:v>
                </c:pt>
                <c:pt idx="1402">
                  <c:v>205.75</c:v>
                </c:pt>
                <c:pt idx="1403">
                  <c:v>205</c:v>
                </c:pt>
                <c:pt idx="1404">
                  <c:v>205</c:v>
                </c:pt>
                <c:pt idx="1405">
                  <c:v>205</c:v>
                </c:pt>
                <c:pt idx="1406">
                  <c:v>206.5</c:v>
                </c:pt>
                <c:pt idx="1407">
                  <c:v>206.5</c:v>
                </c:pt>
                <c:pt idx="1408">
                  <c:v>206</c:v>
                </c:pt>
                <c:pt idx="1409">
                  <c:v>206</c:v>
                </c:pt>
                <c:pt idx="1410">
                  <c:v>206</c:v>
                </c:pt>
                <c:pt idx="1411">
                  <c:v>207</c:v>
                </c:pt>
                <c:pt idx="1412">
                  <c:v>207</c:v>
                </c:pt>
                <c:pt idx="1413">
                  <c:v>207</c:v>
                </c:pt>
                <c:pt idx="1414">
                  <c:v>206.5</c:v>
                </c:pt>
                <c:pt idx="1415">
                  <c:v>206.5</c:v>
                </c:pt>
                <c:pt idx="1416">
                  <c:v>205.75</c:v>
                </c:pt>
                <c:pt idx="1417">
                  <c:v>205.75</c:v>
                </c:pt>
                <c:pt idx="1418">
                  <c:v>204.625</c:v>
                </c:pt>
                <c:pt idx="1419">
                  <c:v>204.625</c:v>
                </c:pt>
                <c:pt idx="1420">
                  <c:v>203.0625</c:v>
                </c:pt>
                <c:pt idx="1421">
                  <c:v>203.0625</c:v>
                </c:pt>
                <c:pt idx="1422">
                  <c:v>198.734375</c:v>
                </c:pt>
                <c:pt idx="1423">
                  <c:v>198.734375</c:v>
                </c:pt>
                <c:pt idx="1424">
                  <c:v>191.1796875</c:v>
                </c:pt>
                <c:pt idx="1425">
                  <c:v>191.1796875</c:v>
                </c:pt>
                <c:pt idx="1426">
                  <c:v>180.40234375</c:v>
                </c:pt>
                <c:pt idx="1427">
                  <c:v>180.40234375</c:v>
                </c:pt>
                <c:pt idx="1428">
                  <c:v>219.2890625</c:v>
                </c:pt>
                <c:pt idx="1429">
                  <c:v>219.2890625</c:v>
                </c:pt>
                <c:pt idx="1430">
                  <c:v>212.3125</c:v>
                </c:pt>
                <c:pt idx="1431">
                  <c:v>212.3125</c:v>
                </c:pt>
                <c:pt idx="1432">
                  <c:v>208.875</c:v>
                </c:pt>
                <c:pt idx="1433">
                  <c:v>208.875</c:v>
                </c:pt>
                <c:pt idx="1434">
                  <c:v>208</c:v>
                </c:pt>
                <c:pt idx="1435">
                  <c:v>208</c:v>
                </c:pt>
                <c:pt idx="1436">
                  <c:v>208</c:v>
                </c:pt>
                <c:pt idx="1437">
                  <c:v>209.75</c:v>
                </c:pt>
                <c:pt idx="1438">
                  <c:v>209.75</c:v>
                </c:pt>
                <c:pt idx="1439">
                  <c:v>209</c:v>
                </c:pt>
                <c:pt idx="1440">
                  <c:v>209</c:v>
                </c:pt>
                <c:pt idx="1441">
                  <c:v>209</c:v>
                </c:pt>
                <c:pt idx="1442">
                  <c:v>210.5</c:v>
                </c:pt>
                <c:pt idx="1443">
                  <c:v>210.5</c:v>
                </c:pt>
                <c:pt idx="1444">
                  <c:v>210</c:v>
                </c:pt>
                <c:pt idx="1445">
                  <c:v>210</c:v>
                </c:pt>
                <c:pt idx="1446">
                  <c:v>210</c:v>
                </c:pt>
                <c:pt idx="1447">
                  <c:v>211</c:v>
                </c:pt>
                <c:pt idx="1448">
                  <c:v>211</c:v>
                </c:pt>
                <c:pt idx="1449">
                  <c:v>211</c:v>
                </c:pt>
                <c:pt idx="1450">
                  <c:v>210.5</c:v>
                </c:pt>
                <c:pt idx="1451">
                  <c:v>210.5</c:v>
                </c:pt>
                <c:pt idx="1452">
                  <c:v>209.75</c:v>
                </c:pt>
                <c:pt idx="1453">
                  <c:v>209.75</c:v>
                </c:pt>
                <c:pt idx="1454">
                  <c:v>208.875</c:v>
                </c:pt>
                <c:pt idx="1455">
                  <c:v>208.875</c:v>
                </c:pt>
                <c:pt idx="1456">
                  <c:v>215.75</c:v>
                </c:pt>
                <c:pt idx="1457">
                  <c:v>215.75</c:v>
                </c:pt>
                <c:pt idx="1458">
                  <c:v>213.625</c:v>
                </c:pt>
                <c:pt idx="1459">
                  <c:v>213.625</c:v>
                </c:pt>
                <c:pt idx="1460">
                  <c:v>212.5</c:v>
                </c:pt>
                <c:pt idx="1461">
                  <c:v>212.5</c:v>
                </c:pt>
                <c:pt idx="1462">
                  <c:v>212</c:v>
                </c:pt>
                <c:pt idx="1463">
                  <c:v>212</c:v>
                </c:pt>
                <c:pt idx="1464">
                  <c:v>212</c:v>
                </c:pt>
                <c:pt idx="1465">
                  <c:v>213</c:v>
                </c:pt>
                <c:pt idx="1466">
                  <c:v>213</c:v>
                </c:pt>
                <c:pt idx="1467">
                  <c:v>213</c:v>
                </c:pt>
                <c:pt idx="1468">
                  <c:v>212.5</c:v>
                </c:pt>
                <c:pt idx="1469">
                  <c:v>212.5</c:v>
                </c:pt>
                <c:pt idx="1470">
                  <c:v>214.75</c:v>
                </c:pt>
                <c:pt idx="1471">
                  <c:v>214.75</c:v>
                </c:pt>
                <c:pt idx="1472">
                  <c:v>214</c:v>
                </c:pt>
                <c:pt idx="1473">
                  <c:v>214</c:v>
                </c:pt>
                <c:pt idx="1474">
                  <c:v>214</c:v>
                </c:pt>
                <c:pt idx="1475">
                  <c:v>215.5</c:v>
                </c:pt>
                <c:pt idx="1476">
                  <c:v>215.5</c:v>
                </c:pt>
                <c:pt idx="1477">
                  <c:v>215</c:v>
                </c:pt>
                <c:pt idx="1478">
                  <c:v>215</c:v>
                </c:pt>
                <c:pt idx="1479">
                  <c:v>215</c:v>
                </c:pt>
                <c:pt idx="1480">
                  <c:v>216</c:v>
                </c:pt>
                <c:pt idx="1481">
                  <c:v>216</c:v>
                </c:pt>
                <c:pt idx="1482">
                  <c:v>216</c:v>
                </c:pt>
                <c:pt idx="1483">
                  <c:v>215.5</c:v>
                </c:pt>
                <c:pt idx="1484">
                  <c:v>215.5</c:v>
                </c:pt>
                <c:pt idx="1485">
                  <c:v>214.75</c:v>
                </c:pt>
                <c:pt idx="1486">
                  <c:v>214.75</c:v>
                </c:pt>
                <c:pt idx="1487">
                  <c:v>213.625</c:v>
                </c:pt>
                <c:pt idx="1488">
                  <c:v>213.625</c:v>
                </c:pt>
                <c:pt idx="1489">
                  <c:v>217.875</c:v>
                </c:pt>
                <c:pt idx="1490">
                  <c:v>217.875</c:v>
                </c:pt>
                <c:pt idx="1491">
                  <c:v>217</c:v>
                </c:pt>
                <c:pt idx="1492">
                  <c:v>217</c:v>
                </c:pt>
                <c:pt idx="1493">
                  <c:v>217</c:v>
                </c:pt>
                <c:pt idx="1494">
                  <c:v>218.75</c:v>
                </c:pt>
                <c:pt idx="1495">
                  <c:v>218.75</c:v>
                </c:pt>
                <c:pt idx="1496">
                  <c:v>218</c:v>
                </c:pt>
                <c:pt idx="1497">
                  <c:v>218</c:v>
                </c:pt>
                <c:pt idx="1498">
                  <c:v>218</c:v>
                </c:pt>
                <c:pt idx="1499">
                  <c:v>219.5</c:v>
                </c:pt>
                <c:pt idx="1500">
                  <c:v>219.5</c:v>
                </c:pt>
                <c:pt idx="1501">
                  <c:v>219</c:v>
                </c:pt>
                <c:pt idx="1502">
                  <c:v>219</c:v>
                </c:pt>
                <c:pt idx="1503">
                  <c:v>219</c:v>
                </c:pt>
                <c:pt idx="1504">
                  <c:v>220</c:v>
                </c:pt>
                <c:pt idx="1505">
                  <c:v>220</c:v>
                </c:pt>
                <c:pt idx="1506">
                  <c:v>220</c:v>
                </c:pt>
                <c:pt idx="1507">
                  <c:v>219.5</c:v>
                </c:pt>
                <c:pt idx="1508">
                  <c:v>219.5</c:v>
                </c:pt>
                <c:pt idx="1509">
                  <c:v>218.75</c:v>
                </c:pt>
                <c:pt idx="1510">
                  <c:v>218.75</c:v>
                </c:pt>
                <c:pt idx="1511">
                  <c:v>217.875</c:v>
                </c:pt>
                <c:pt idx="1512">
                  <c:v>217.875</c:v>
                </c:pt>
                <c:pt idx="1513">
                  <c:v>215.75</c:v>
                </c:pt>
                <c:pt idx="1514">
                  <c:v>215.75</c:v>
                </c:pt>
                <c:pt idx="1515">
                  <c:v>212.3125</c:v>
                </c:pt>
                <c:pt idx="1516">
                  <c:v>212.3125</c:v>
                </c:pt>
                <c:pt idx="1517">
                  <c:v>226.265625</c:v>
                </c:pt>
                <c:pt idx="1518">
                  <c:v>226.265625</c:v>
                </c:pt>
                <c:pt idx="1519">
                  <c:v>222.5</c:v>
                </c:pt>
                <c:pt idx="1520">
                  <c:v>222.5</c:v>
                </c:pt>
                <c:pt idx="1521">
                  <c:v>221.5</c:v>
                </c:pt>
                <c:pt idx="1522">
                  <c:v>221.5</c:v>
                </c:pt>
                <c:pt idx="1523">
                  <c:v>221</c:v>
                </c:pt>
                <c:pt idx="1524">
                  <c:v>221</c:v>
                </c:pt>
                <c:pt idx="1525">
                  <c:v>221</c:v>
                </c:pt>
                <c:pt idx="1526">
                  <c:v>222</c:v>
                </c:pt>
                <c:pt idx="1527">
                  <c:v>222</c:v>
                </c:pt>
                <c:pt idx="1528">
                  <c:v>222</c:v>
                </c:pt>
                <c:pt idx="1529">
                  <c:v>221.5</c:v>
                </c:pt>
                <c:pt idx="1530">
                  <c:v>221.5</c:v>
                </c:pt>
                <c:pt idx="1531">
                  <c:v>223.5</c:v>
                </c:pt>
                <c:pt idx="1532">
                  <c:v>223.5</c:v>
                </c:pt>
                <c:pt idx="1533">
                  <c:v>223</c:v>
                </c:pt>
                <c:pt idx="1534">
                  <c:v>223</c:v>
                </c:pt>
                <c:pt idx="1535">
                  <c:v>223</c:v>
                </c:pt>
                <c:pt idx="1536">
                  <c:v>224</c:v>
                </c:pt>
                <c:pt idx="1537">
                  <c:v>224</c:v>
                </c:pt>
                <c:pt idx="1538">
                  <c:v>224</c:v>
                </c:pt>
                <c:pt idx="1539">
                  <c:v>223.5</c:v>
                </c:pt>
                <c:pt idx="1540">
                  <c:v>223.5</c:v>
                </c:pt>
                <c:pt idx="1541">
                  <c:v>222.5</c:v>
                </c:pt>
                <c:pt idx="1542">
                  <c:v>222.5</c:v>
                </c:pt>
                <c:pt idx="1543">
                  <c:v>230.03125</c:v>
                </c:pt>
                <c:pt idx="1544">
                  <c:v>230.03125</c:v>
                </c:pt>
                <c:pt idx="1545">
                  <c:v>226.5</c:v>
                </c:pt>
                <c:pt idx="1546">
                  <c:v>226.5</c:v>
                </c:pt>
                <c:pt idx="1547">
                  <c:v>225</c:v>
                </c:pt>
                <c:pt idx="1548">
                  <c:v>225</c:v>
                </c:pt>
                <c:pt idx="1549">
                  <c:v>225</c:v>
                </c:pt>
                <c:pt idx="1550">
                  <c:v>228</c:v>
                </c:pt>
                <c:pt idx="1551">
                  <c:v>228</c:v>
                </c:pt>
                <c:pt idx="1552">
                  <c:v>226.5</c:v>
                </c:pt>
                <c:pt idx="1553">
                  <c:v>226.5</c:v>
                </c:pt>
                <c:pt idx="1554">
                  <c:v>226</c:v>
                </c:pt>
                <c:pt idx="1555">
                  <c:v>226</c:v>
                </c:pt>
                <c:pt idx="1556">
                  <c:v>226</c:v>
                </c:pt>
                <c:pt idx="1557">
                  <c:v>227</c:v>
                </c:pt>
                <c:pt idx="1558">
                  <c:v>227</c:v>
                </c:pt>
                <c:pt idx="1559">
                  <c:v>227</c:v>
                </c:pt>
                <c:pt idx="1560">
                  <c:v>226.5</c:v>
                </c:pt>
                <c:pt idx="1561">
                  <c:v>226.5</c:v>
                </c:pt>
                <c:pt idx="1562">
                  <c:v>229.5</c:v>
                </c:pt>
                <c:pt idx="1563">
                  <c:v>229.5</c:v>
                </c:pt>
                <c:pt idx="1564">
                  <c:v>228.5</c:v>
                </c:pt>
                <c:pt idx="1565">
                  <c:v>228.5</c:v>
                </c:pt>
                <c:pt idx="1566">
                  <c:v>228</c:v>
                </c:pt>
                <c:pt idx="1567">
                  <c:v>228</c:v>
                </c:pt>
                <c:pt idx="1568">
                  <c:v>228</c:v>
                </c:pt>
                <c:pt idx="1569">
                  <c:v>229</c:v>
                </c:pt>
                <c:pt idx="1570">
                  <c:v>229</c:v>
                </c:pt>
                <c:pt idx="1571">
                  <c:v>229</c:v>
                </c:pt>
                <c:pt idx="1572">
                  <c:v>228.5</c:v>
                </c:pt>
                <c:pt idx="1573">
                  <c:v>228.5</c:v>
                </c:pt>
                <c:pt idx="1574">
                  <c:v>230.5</c:v>
                </c:pt>
                <c:pt idx="1575">
                  <c:v>230.5</c:v>
                </c:pt>
                <c:pt idx="1576">
                  <c:v>230</c:v>
                </c:pt>
                <c:pt idx="1577">
                  <c:v>230</c:v>
                </c:pt>
                <c:pt idx="1578">
                  <c:v>230</c:v>
                </c:pt>
                <c:pt idx="1579">
                  <c:v>231</c:v>
                </c:pt>
                <c:pt idx="1580">
                  <c:v>231</c:v>
                </c:pt>
                <c:pt idx="1581">
                  <c:v>231</c:v>
                </c:pt>
                <c:pt idx="1582">
                  <c:v>230.5</c:v>
                </c:pt>
                <c:pt idx="1583">
                  <c:v>230.5</c:v>
                </c:pt>
                <c:pt idx="1584">
                  <c:v>229.5</c:v>
                </c:pt>
                <c:pt idx="1585">
                  <c:v>229.5</c:v>
                </c:pt>
                <c:pt idx="1586">
                  <c:v>228</c:v>
                </c:pt>
                <c:pt idx="1587">
                  <c:v>228</c:v>
                </c:pt>
                <c:pt idx="1588">
                  <c:v>226.5</c:v>
                </c:pt>
                <c:pt idx="1589">
                  <c:v>226.5</c:v>
                </c:pt>
                <c:pt idx="1590">
                  <c:v>233.5625</c:v>
                </c:pt>
                <c:pt idx="1591">
                  <c:v>233.5625</c:v>
                </c:pt>
                <c:pt idx="1592">
                  <c:v>232</c:v>
                </c:pt>
                <c:pt idx="1593">
                  <c:v>232</c:v>
                </c:pt>
                <c:pt idx="1594">
                  <c:v>232</c:v>
                </c:pt>
                <c:pt idx="1595">
                  <c:v>235.125</c:v>
                </c:pt>
                <c:pt idx="1596">
                  <c:v>235.125</c:v>
                </c:pt>
                <c:pt idx="1597">
                  <c:v>233.75</c:v>
                </c:pt>
                <c:pt idx="1598">
                  <c:v>233.75</c:v>
                </c:pt>
                <c:pt idx="1599">
                  <c:v>233</c:v>
                </c:pt>
                <c:pt idx="1600">
                  <c:v>233</c:v>
                </c:pt>
                <c:pt idx="1601">
                  <c:v>233</c:v>
                </c:pt>
                <c:pt idx="1602">
                  <c:v>234.5</c:v>
                </c:pt>
                <c:pt idx="1603">
                  <c:v>234.5</c:v>
                </c:pt>
                <c:pt idx="1604">
                  <c:v>234</c:v>
                </c:pt>
                <c:pt idx="1605">
                  <c:v>234</c:v>
                </c:pt>
                <c:pt idx="1606">
                  <c:v>234</c:v>
                </c:pt>
                <c:pt idx="1607">
                  <c:v>235</c:v>
                </c:pt>
                <c:pt idx="1608">
                  <c:v>235</c:v>
                </c:pt>
                <c:pt idx="1609">
                  <c:v>235</c:v>
                </c:pt>
                <c:pt idx="1610">
                  <c:v>234.5</c:v>
                </c:pt>
                <c:pt idx="1611">
                  <c:v>234.5</c:v>
                </c:pt>
                <c:pt idx="1612">
                  <c:v>233.75</c:v>
                </c:pt>
                <c:pt idx="1613">
                  <c:v>233.75</c:v>
                </c:pt>
                <c:pt idx="1614">
                  <c:v>236.5</c:v>
                </c:pt>
                <c:pt idx="1615">
                  <c:v>236.5</c:v>
                </c:pt>
                <c:pt idx="1616">
                  <c:v>236</c:v>
                </c:pt>
                <c:pt idx="1617">
                  <c:v>236</c:v>
                </c:pt>
                <c:pt idx="1618">
                  <c:v>236</c:v>
                </c:pt>
                <c:pt idx="1619">
                  <c:v>237</c:v>
                </c:pt>
                <c:pt idx="1620">
                  <c:v>237</c:v>
                </c:pt>
                <c:pt idx="1621">
                  <c:v>237</c:v>
                </c:pt>
                <c:pt idx="1622">
                  <c:v>236.5</c:v>
                </c:pt>
                <c:pt idx="1623">
                  <c:v>236.5</c:v>
                </c:pt>
                <c:pt idx="1624">
                  <c:v>235.125</c:v>
                </c:pt>
                <c:pt idx="1625">
                  <c:v>235.125</c:v>
                </c:pt>
                <c:pt idx="1626">
                  <c:v>233.5625</c:v>
                </c:pt>
                <c:pt idx="1627">
                  <c:v>233.5625</c:v>
                </c:pt>
                <c:pt idx="1628">
                  <c:v>230.03125</c:v>
                </c:pt>
                <c:pt idx="1629">
                  <c:v>230.03125</c:v>
                </c:pt>
                <c:pt idx="1630">
                  <c:v>226.265625</c:v>
                </c:pt>
                <c:pt idx="1631">
                  <c:v>226.265625</c:v>
                </c:pt>
                <c:pt idx="1632">
                  <c:v>219.2890625</c:v>
                </c:pt>
                <c:pt idx="1633">
                  <c:v>219.2890625</c:v>
                </c:pt>
                <c:pt idx="1634">
                  <c:v>199.845703125</c:v>
                </c:pt>
                <c:pt idx="1635">
                  <c:v>199.845703125</c:v>
                </c:pt>
                <c:pt idx="1636">
                  <c:v>252.44921875</c:v>
                </c:pt>
                <c:pt idx="1637">
                  <c:v>252.44921875</c:v>
                </c:pt>
                <c:pt idx="1638">
                  <c:v>246.2734375</c:v>
                </c:pt>
                <c:pt idx="1639">
                  <c:v>246.2734375</c:v>
                </c:pt>
                <c:pt idx="1640">
                  <c:v>241.546875</c:v>
                </c:pt>
                <c:pt idx="1641">
                  <c:v>241.546875</c:v>
                </c:pt>
                <c:pt idx="1642">
                  <c:v>238.75</c:v>
                </c:pt>
                <c:pt idx="1643">
                  <c:v>238.75</c:v>
                </c:pt>
                <c:pt idx="1644">
                  <c:v>238</c:v>
                </c:pt>
                <c:pt idx="1645">
                  <c:v>238</c:v>
                </c:pt>
                <c:pt idx="1646">
                  <c:v>238</c:v>
                </c:pt>
                <c:pt idx="1647">
                  <c:v>239.5</c:v>
                </c:pt>
                <c:pt idx="1648">
                  <c:v>239.5</c:v>
                </c:pt>
                <c:pt idx="1649">
                  <c:v>239</c:v>
                </c:pt>
                <c:pt idx="1650">
                  <c:v>239</c:v>
                </c:pt>
                <c:pt idx="1651">
                  <c:v>239</c:v>
                </c:pt>
                <c:pt idx="1652">
                  <c:v>240</c:v>
                </c:pt>
                <c:pt idx="1653">
                  <c:v>240</c:v>
                </c:pt>
                <c:pt idx="1654">
                  <c:v>240</c:v>
                </c:pt>
                <c:pt idx="1655">
                  <c:v>239.5</c:v>
                </c:pt>
                <c:pt idx="1656">
                  <c:v>239.5</c:v>
                </c:pt>
                <c:pt idx="1657">
                  <c:v>238.75</c:v>
                </c:pt>
                <c:pt idx="1658">
                  <c:v>238.75</c:v>
                </c:pt>
                <c:pt idx="1659">
                  <c:v>244.34375</c:v>
                </c:pt>
                <c:pt idx="1660">
                  <c:v>244.34375</c:v>
                </c:pt>
                <c:pt idx="1661">
                  <c:v>241.9375</c:v>
                </c:pt>
                <c:pt idx="1662">
                  <c:v>241.9375</c:v>
                </c:pt>
                <c:pt idx="1663">
                  <c:v>241</c:v>
                </c:pt>
                <c:pt idx="1664">
                  <c:v>241</c:v>
                </c:pt>
                <c:pt idx="1665">
                  <c:v>241</c:v>
                </c:pt>
                <c:pt idx="1666">
                  <c:v>242.875</c:v>
                </c:pt>
                <c:pt idx="1667">
                  <c:v>242.875</c:v>
                </c:pt>
                <c:pt idx="1668">
                  <c:v>242</c:v>
                </c:pt>
                <c:pt idx="1669">
                  <c:v>242</c:v>
                </c:pt>
                <c:pt idx="1670">
                  <c:v>242</c:v>
                </c:pt>
                <c:pt idx="1671">
                  <c:v>243.75</c:v>
                </c:pt>
                <c:pt idx="1672">
                  <c:v>243.75</c:v>
                </c:pt>
                <c:pt idx="1673">
                  <c:v>243</c:v>
                </c:pt>
                <c:pt idx="1674">
                  <c:v>243</c:v>
                </c:pt>
                <c:pt idx="1675">
                  <c:v>243</c:v>
                </c:pt>
                <c:pt idx="1676">
                  <c:v>244.5</c:v>
                </c:pt>
                <c:pt idx="1677">
                  <c:v>244.5</c:v>
                </c:pt>
                <c:pt idx="1678">
                  <c:v>244</c:v>
                </c:pt>
                <c:pt idx="1679">
                  <c:v>244</c:v>
                </c:pt>
                <c:pt idx="1680">
                  <c:v>244</c:v>
                </c:pt>
                <c:pt idx="1681">
                  <c:v>245</c:v>
                </c:pt>
                <c:pt idx="1682">
                  <c:v>245</c:v>
                </c:pt>
                <c:pt idx="1683">
                  <c:v>245</c:v>
                </c:pt>
                <c:pt idx="1684">
                  <c:v>244.5</c:v>
                </c:pt>
                <c:pt idx="1685">
                  <c:v>244.5</c:v>
                </c:pt>
                <c:pt idx="1686">
                  <c:v>243.75</c:v>
                </c:pt>
                <c:pt idx="1687">
                  <c:v>243.75</c:v>
                </c:pt>
                <c:pt idx="1688">
                  <c:v>242.875</c:v>
                </c:pt>
                <c:pt idx="1689">
                  <c:v>242.875</c:v>
                </c:pt>
                <c:pt idx="1690">
                  <c:v>241.9375</c:v>
                </c:pt>
                <c:pt idx="1691">
                  <c:v>241.9375</c:v>
                </c:pt>
                <c:pt idx="1692">
                  <c:v>246.75</c:v>
                </c:pt>
                <c:pt idx="1693">
                  <c:v>246.75</c:v>
                </c:pt>
                <c:pt idx="1694">
                  <c:v>246</c:v>
                </c:pt>
                <c:pt idx="1695">
                  <c:v>246</c:v>
                </c:pt>
                <c:pt idx="1696">
                  <c:v>246</c:v>
                </c:pt>
                <c:pt idx="1697">
                  <c:v>247.5</c:v>
                </c:pt>
                <c:pt idx="1698">
                  <c:v>247.5</c:v>
                </c:pt>
                <c:pt idx="1699">
                  <c:v>247</c:v>
                </c:pt>
                <c:pt idx="1700">
                  <c:v>247</c:v>
                </c:pt>
                <c:pt idx="1701">
                  <c:v>247</c:v>
                </c:pt>
                <c:pt idx="1702">
                  <c:v>248</c:v>
                </c:pt>
                <c:pt idx="1703">
                  <c:v>248</c:v>
                </c:pt>
                <c:pt idx="1704">
                  <c:v>248</c:v>
                </c:pt>
                <c:pt idx="1705">
                  <c:v>247.5</c:v>
                </c:pt>
                <c:pt idx="1706">
                  <c:v>247.5</c:v>
                </c:pt>
                <c:pt idx="1707">
                  <c:v>246.75</c:v>
                </c:pt>
                <c:pt idx="1708">
                  <c:v>246.75</c:v>
                </c:pt>
                <c:pt idx="1709">
                  <c:v>244.34375</c:v>
                </c:pt>
                <c:pt idx="1710">
                  <c:v>244.34375</c:v>
                </c:pt>
                <c:pt idx="1711">
                  <c:v>241.546875</c:v>
                </c:pt>
                <c:pt idx="1712">
                  <c:v>241.546875</c:v>
                </c:pt>
                <c:pt idx="1713">
                  <c:v>251</c:v>
                </c:pt>
                <c:pt idx="1714">
                  <c:v>251</c:v>
                </c:pt>
                <c:pt idx="1715">
                  <c:v>249.5</c:v>
                </c:pt>
                <c:pt idx="1716">
                  <c:v>249.5</c:v>
                </c:pt>
                <c:pt idx="1717">
                  <c:v>249</c:v>
                </c:pt>
                <c:pt idx="1718">
                  <c:v>249</c:v>
                </c:pt>
                <c:pt idx="1719">
                  <c:v>249</c:v>
                </c:pt>
                <c:pt idx="1720">
                  <c:v>250</c:v>
                </c:pt>
                <c:pt idx="1721">
                  <c:v>250</c:v>
                </c:pt>
                <c:pt idx="1722">
                  <c:v>250</c:v>
                </c:pt>
                <c:pt idx="1723">
                  <c:v>249.5</c:v>
                </c:pt>
                <c:pt idx="1724">
                  <c:v>249.5</c:v>
                </c:pt>
                <c:pt idx="1725">
                  <c:v>252.5</c:v>
                </c:pt>
                <c:pt idx="1726">
                  <c:v>252.5</c:v>
                </c:pt>
                <c:pt idx="1727">
                  <c:v>251.5</c:v>
                </c:pt>
                <c:pt idx="1728">
                  <c:v>251.5</c:v>
                </c:pt>
                <c:pt idx="1729">
                  <c:v>251</c:v>
                </c:pt>
                <c:pt idx="1730">
                  <c:v>251</c:v>
                </c:pt>
                <c:pt idx="1731">
                  <c:v>251</c:v>
                </c:pt>
                <c:pt idx="1732">
                  <c:v>252</c:v>
                </c:pt>
                <c:pt idx="1733">
                  <c:v>252</c:v>
                </c:pt>
                <c:pt idx="1734">
                  <c:v>252</c:v>
                </c:pt>
                <c:pt idx="1735">
                  <c:v>251.5</c:v>
                </c:pt>
                <c:pt idx="1736">
                  <c:v>251.5</c:v>
                </c:pt>
                <c:pt idx="1737">
                  <c:v>253.5</c:v>
                </c:pt>
                <c:pt idx="1738">
                  <c:v>253.5</c:v>
                </c:pt>
                <c:pt idx="1739">
                  <c:v>253</c:v>
                </c:pt>
                <c:pt idx="1740">
                  <c:v>253</c:v>
                </c:pt>
                <c:pt idx="1741">
                  <c:v>253</c:v>
                </c:pt>
                <c:pt idx="1742">
                  <c:v>254</c:v>
                </c:pt>
                <c:pt idx="1743">
                  <c:v>254</c:v>
                </c:pt>
                <c:pt idx="1744">
                  <c:v>254</c:v>
                </c:pt>
                <c:pt idx="1745">
                  <c:v>253.5</c:v>
                </c:pt>
                <c:pt idx="1746">
                  <c:v>253.5</c:v>
                </c:pt>
                <c:pt idx="1747">
                  <c:v>252.5</c:v>
                </c:pt>
                <c:pt idx="1748">
                  <c:v>252.5</c:v>
                </c:pt>
                <c:pt idx="1749">
                  <c:v>251</c:v>
                </c:pt>
                <c:pt idx="1750">
                  <c:v>251</c:v>
                </c:pt>
                <c:pt idx="1751">
                  <c:v>246.2734375</c:v>
                </c:pt>
                <c:pt idx="1752">
                  <c:v>246.2734375</c:v>
                </c:pt>
                <c:pt idx="1753">
                  <c:v>258.625</c:v>
                </c:pt>
                <c:pt idx="1754">
                  <c:v>258.625</c:v>
                </c:pt>
                <c:pt idx="1755">
                  <c:v>255.75</c:v>
                </c:pt>
                <c:pt idx="1756">
                  <c:v>255.75</c:v>
                </c:pt>
                <c:pt idx="1757">
                  <c:v>255</c:v>
                </c:pt>
                <c:pt idx="1758">
                  <c:v>255</c:v>
                </c:pt>
                <c:pt idx="1759">
                  <c:v>255</c:v>
                </c:pt>
                <c:pt idx="1760">
                  <c:v>256.5</c:v>
                </c:pt>
                <c:pt idx="1761">
                  <c:v>256.5</c:v>
                </c:pt>
                <c:pt idx="1762">
                  <c:v>256</c:v>
                </c:pt>
                <c:pt idx="1763">
                  <c:v>256</c:v>
                </c:pt>
                <c:pt idx="1764">
                  <c:v>256</c:v>
                </c:pt>
                <c:pt idx="1765">
                  <c:v>257</c:v>
                </c:pt>
                <c:pt idx="1766">
                  <c:v>257</c:v>
                </c:pt>
                <c:pt idx="1767">
                  <c:v>257</c:v>
                </c:pt>
                <c:pt idx="1768">
                  <c:v>256.5</c:v>
                </c:pt>
                <c:pt idx="1769">
                  <c:v>256.5</c:v>
                </c:pt>
                <c:pt idx="1770">
                  <c:v>255.75</c:v>
                </c:pt>
                <c:pt idx="1771">
                  <c:v>255.75</c:v>
                </c:pt>
                <c:pt idx="1772">
                  <c:v>261.5</c:v>
                </c:pt>
                <c:pt idx="1773">
                  <c:v>261.5</c:v>
                </c:pt>
                <c:pt idx="1774">
                  <c:v>259.25</c:v>
                </c:pt>
                <c:pt idx="1775">
                  <c:v>259.25</c:v>
                </c:pt>
                <c:pt idx="1776">
                  <c:v>258</c:v>
                </c:pt>
                <c:pt idx="1777">
                  <c:v>258</c:v>
                </c:pt>
                <c:pt idx="1778">
                  <c:v>258</c:v>
                </c:pt>
                <c:pt idx="1779">
                  <c:v>260.5</c:v>
                </c:pt>
                <c:pt idx="1780">
                  <c:v>260.5</c:v>
                </c:pt>
                <c:pt idx="1781">
                  <c:v>259.5</c:v>
                </c:pt>
                <c:pt idx="1782">
                  <c:v>259.5</c:v>
                </c:pt>
                <c:pt idx="1783">
                  <c:v>259</c:v>
                </c:pt>
                <c:pt idx="1784">
                  <c:v>259</c:v>
                </c:pt>
                <c:pt idx="1785">
                  <c:v>259</c:v>
                </c:pt>
                <c:pt idx="1786">
                  <c:v>260</c:v>
                </c:pt>
                <c:pt idx="1787">
                  <c:v>260</c:v>
                </c:pt>
                <c:pt idx="1788">
                  <c:v>260</c:v>
                </c:pt>
                <c:pt idx="1789">
                  <c:v>259.5</c:v>
                </c:pt>
                <c:pt idx="1790">
                  <c:v>259.5</c:v>
                </c:pt>
                <c:pt idx="1791">
                  <c:v>261.5</c:v>
                </c:pt>
                <c:pt idx="1792">
                  <c:v>261.5</c:v>
                </c:pt>
                <c:pt idx="1793">
                  <c:v>261</c:v>
                </c:pt>
                <c:pt idx="1794">
                  <c:v>261</c:v>
                </c:pt>
                <c:pt idx="1795">
                  <c:v>261</c:v>
                </c:pt>
                <c:pt idx="1796">
                  <c:v>262</c:v>
                </c:pt>
                <c:pt idx="1797">
                  <c:v>262</c:v>
                </c:pt>
                <c:pt idx="1798">
                  <c:v>262</c:v>
                </c:pt>
                <c:pt idx="1799">
                  <c:v>261.5</c:v>
                </c:pt>
                <c:pt idx="1800">
                  <c:v>261.5</c:v>
                </c:pt>
                <c:pt idx="1801">
                  <c:v>260.5</c:v>
                </c:pt>
                <c:pt idx="1802">
                  <c:v>260.5</c:v>
                </c:pt>
                <c:pt idx="1803">
                  <c:v>259.25</c:v>
                </c:pt>
                <c:pt idx="1804">
                  <c:v>259.25</c:v>
                </c:pt>
                <c:pt idx="1805">
                  <c:v>263.75</c:v>
                </c:pt>
                <c:pt idx="1806">
                  <c:v>263.75</c:v>
                </c:pt>
                <c:pt idx="1807">
                  <c:v>263</c:v>
                </c:pt>
                <c:pt idx="1808">
                  <c:v>263</c:v>
                </c:pt>
                <c:pt idx="1809">
                  <c:v>263</c:v>
                </c:pt>
                <c:pt idx="1810">
                  <c:v>264.5</c:v>
                </c:pt>
                <c:pt idx="1811">
                  <c:v>264.5</c:v>
                </c:pt>
                <c:pt idx="1812">
                  <c:v>264</c:v>
                </c:pt>
                <c:pt idx="1813">
                  <c:v>264</c:v>
                </c:pt>
                <c:pt idx="1814">
                  <c:v>264</c:v>
                </c:pt>
                <c:pt idx="1815">
                  <c:v>265</c:v>
                </c:pt>
                <c:pt idx="1816">
                  <c:v>265</c:v>
                </c:pt>
                <c:pt idx="1817">
                  <c:v>265</c:v>
                </c:pt>
                <c:pt idx="1818">
                  <c:v>264.5</c:v>
                </c:pt>
                <c:pt idx="1819">
                  <c:v>264.5</c:v>
                </c:pt>
                <c:pt idx="1820">
                  <c:v>263.75</c:v>
                </c:pt>
                <c:pt idx="1821">
                  <c:v>263.75</c:v>
                </c:pt>
                <c:pt idx="1822">
                  <c:v>261.5</c:v>
                </c:pt>
                <c:pt idx="1823">
                  <c:v>261.5</c:v>
                </c:pt>
                <c:pt idx="1824">
                  <c:v>258.625</c:v>
                </c:pt>
                <c:pt idx="1825">
                  <c:v>258.625</c:v>
                </c:pt>
                <c:pt idx="1826">
                  <c:v>252.44921875</c:v>
                </c:pt>
                <c:pt idx="1827">
                  <c:v>252.44921875</c:v>
                </c:pt>
                <c:pt idx="1828">
                  <c:v>226.1474609375</c:v>
                </c:pt>
                <c:pt idx="1829">
                  <c:v>226.1474609375</c:v>
                </c:pt>
                <c:pt idx="1830">
                  <c:v>190.16748046875</c:v>
                </c:pt>
                <c:pt idx="1831">
                  <c:v>190.16748046875</c:v>
                </c:pt>
                <c:pt idx="1832">
                  <c:v>165.177490234375</c:v>
                </c:pt>
                <c:pt idx="1833">
                  <c:v>165.177490234375</c:v>
                </c:pt>
                <c:pt idx="1834">
                  <c:v>145.4481201171875</c:v>
                </c:pt>
                <c:pt idx="1835">
                  <c:v>145.4481201171875</c:v>
                </c:pt>
                <c:pt idx="1836">
                  <c:v>129.40374755859375</c:v>
                </c:pt>
                <c:pt idx="1837">
                  <c:v>129.40374755859375</c:v>
                </c:pt>
                <c:pt idx="1838">
                  <c:v>113.34640502929688</c:v>
                </c:pt>
                <c:pt idx="1839">
                  <c:v>113.34640502929688</c:v>
                </c:pt>
                <c:pt idx="1840">
                  <c:v>91.380233764648438</c:v>
                </c:pt>
                <c:pt idx="1841">
                  <c:v>91.380233764648438</c:v>
                </c:pt>
                <c:pt idx="1842">
                  <c:v>73.229179382324219</c:v>
                </c:pt>
                <c:pt idx="1843">
                  <c:v>73.229179382324219</c:v>
                </c:pt>
                <c:pt idx="1844">
                  <c:v>277.640625</c:v>
                </c:pt>
                <c:pt idx="1845">
                  <c:v>277.640625</c:v>
                </c:pt>
                <c:pt idx="1846">
                  <c:v>272.34375</c:v>
                </c:pt>
                <c:pt idx="1847">
                  <c:v>272.34375</c:v>
                </c:pt>
                <c:pt idx="1848">
                  <c:v>269.1875</c:v>
                </c:pt>
                <c:pt idx="1849">
                  <c:v>269.1875</c:v>
                </c:pt>
                <c:pt idx="1850">
                  <c:v>266.875</c:v>
                </c:pt>
                <c:pt idx="1851">
                  <c:v>266.875</c:v>
                </c:pt>
                <c:pt idx="1852">
                  <c:v>266</c:v>
                </c:pt>
                <c:pt idx="1853">
                  <c:v>266</c:v>
                </c:pt>
                <c:pt idx="1854">
                  <c:v>266</c:v>
                </c:pt>
                <c:pt idx="1855">
                  <c:v>267.75</c:v>
                </c:pt>
                <c:pt idx="1856">
                  <c:v>267.75</c:v>
                </c:pt>
                <c:pt idx="1857">
                  <c:v>267</c:v>
                </c:pt>
                <c:pt idx="1858">
                  <c:v>267</c:v>
                </c:pt>
                <c:pt idx="1859">
                  <c:v>267</c:v>
                </c:pt>
                <c:pt idx="1860">
                  <c:v>268.5</c:v>
                </c:pt>
                <c:pt idx="1861">
                  <c:v>268.5</c:v>
                </c:pt>
                <c:pt idx="1862">
                  <c:v>268</c:v>
                </c:pt>
                <c:pt idx="1863">
                  <c:v>268</c:v>
                </c:pt>
                <c:pt idx="1864">
                  <c:v>268</c:v>
                </c:pt>
                <c:pt idx="1865">
                  <c:v>269</c:v>
                </c:pt>
                <c:pt idx="1866">
                  <c:v>269</c:v>
                </c:pt>
                <c:pt idx="1867">
                  <c:v>269</c:v>
                </c:pt>
                <c:pt idx="1868">
                  <c:v>268.5</c:v>
                </c:pt>
                <c:pt idx="1869">
                  <c:v>268.5</c:v>
                </c:pt>
                <c:pt idx="1870">
                  <c:v>267.75</c:v>
                </c:pt>
                <c:pt idx="1871">
                  <c:v>267.75</c:v>
                </c:pt>
                <c:pt idx="1872">
                  <c:v>266.875</c:v>
                </c:pt>
                <c:pt idx="1873">
                  <c:v>266.875</c:v>
                </c:pt>
                <c:pt idx="1874">
                  <c:v>271.5</c:v>
                </c:pt>
                <c:pt idx="1875">
                  <c:v>271.5</c:v>
                </c:pt>
                <c:pt idx="1876">
                  <c:v>270.5</c:v>
                </c:pt>
                <c:pt idx="1877">
                  <c:v>270.5</c:v>
                </c:pt>
                <c:pt idx="1878">
                  <c:v>270</c:v>
                </c:pt>
                <c:pt idx="1879">
                  <c:v>270</c:v>
                </c:pt>
                <c:pt idx="1880">
                  <c:v>270</c:v>
                </c:pt>
                <c:pt idx="1881">
                  <c:v>271</c:v>
                </c:pt>
                <c:pt idx="1882">
                  <c:v>271</c:v>
                </c:pt>
                <c:pt idx="1883">
                  <c:v>271</c:v>
                </c:pt>
                <c:pt idx="1884">
                  <c:v>270.5</c:v>
                </c:pt>
                <c:pt idx="1885">
                  <c:v>270.5</c:v>
                </c:pt>
                <c:pt idx="1886">
                  <c:v>272.5</c:v>
                </c:pt>
                <c:pt idx="1887">
                  <c:v>272.5</c:v>
                </c:pt>
                <c:pt idx="1888">
                  <c:v>272</c:v>
                </c:pt>
                <c:pt idx="1889">
                  <c:v>272</c:v>
                </c:pt>
                <c:pt idx="1890">
                  <c:v>272</c:v>
                </c:pt>
                <c:pt idx="1891">
                  <c:v>273</c:v>
                </c:pt>
                <c:pt idx="1892">
                  <c:v>273</c:v>
                </c:pt>
                <c:pt idx="1893">
                  <c:v>273</c:v>
                </c:pt>
                <c:pt idx="1894">
                  <c:v>272.5</c:v>
                </c:pt>
                <c:pt idx="1895">
                  <c:v>272.5</c:v>
                </c:pt>
                <c:pt idx="1896">
                  <c:v>271.5</c:v>
                </c:pt>
                <c:pt idx="1897">
                  <c:v>271.5</c:v>
                </c:pt>
                <c:pt idx="1898">
                  <c:v>269.1875</c:v>
                </c:pt>
                <c:pt idx="1899">
                  <c:v>269.1875</c:v>
                </c:pt>
                <c:pt idx="1900">
                  <c:v>275.5</c:v>
                </c:pt>
                <c:pt idx="1901">
                  <c:v>275.5</c:v>
                </c:pt>
                <c:pt idx="1902">
                  <c:v>274.5</c:v>
                </c:pt>
                <c:pt idx="1903">
                  <c:v>274.5</c:v>
                </c:pt>
                <c:pt idx="1904">
                  <c:v>274</c:v>
                </c:pt>
                <c:pt idx="1905">
                  <c:v>274</c:v>
                </c:pt>
                <c:pt idx="1906">
                  <c:v>274</c:v>
                </c:pt>
                <c:pt idx="1907">
                  <c:v>275</c:v>
                </c:pt>
                <c:pt idx="1908">
                  <c:v>275</c:v>
                </c:pt>
                <c:pt idx="1909">
                  <c:v>275</c:v>
                </c:pt>
                <c:pt idx="1910">
                  <c:v>274.5</c:v>
                </c:pt>
                <c:pt idx="1911">
                  <c:v>274.5</c:v>
                </c:pt>
                <c:pt idx="1912">
                  <c:v>276.5</c:v>
                </c:pt>
                <c:pt idx="1913">
                  <c:v>276.5</c:v>
                </c:pt>
                <c:pt idx="1914">
                  <c:v>276</c:v>
                </c:pt>
                <c:pt idx="1915">
                  <c:v>276</c:v>
                </c:pt>
                <c:pt idx="1916">
                  <c:v>276</c:v>
                </c:pt>
                <c:pt idx="1917">
                  <c:v>277</c:v>
                </c:pt>
                <c:pt idx="1918">
                  <c:v>277</c:v>
                </c:pt>
                <c:pt idx="1919">
                  <c:v>277</c:v>
                </c:pt>
                <c:pt idx="1920">
                  <c:v>276.5</c:v>
                </c:pt>
                <c:pt idx="1921">
                  <c:v>276.5</c:v>
                </c:pt>
                <c:pt idx="1922">
                  <c:v>275.5</c:v>
                </c:pt>
                <c:pt idx="1923">
                  <c:v>275.5</c:v>
                </c:pt>
                <c:pt idx="1924">
                  <c:v>272.34375</c:v>
                </c:pt>
                <c:pt idx="1925">
                  <c:v>272.34375</c:v>
                </c:pt>
                <c:pt idx="1926">
                  <c:v>282.9375</c:v>
                </c:pt>
                <c:pt idx="1927">
                  <c:v>282.9375</c:v>
                </c:pt>
                <c:pt idx="1928">
                  <c:v>280.25</c:v>
                </c:pt>
                <c:pt idx="1929">
                  <c:v>280.25</c:v>
                </c:pt>
                <c:pt idx="1930">
                  <c:v>278.75</c:v>
                </c:pt>
                <c:pt idx="1931">
                  <c:v>278.75</c:v>
                </c:pt>
                <c:pt idx="1932">
                  <c:v>278</c:v>
                </c:pt>
                <c:pt idx="1933">
                  <c:v>278</c:v>
                </c:pt>
                <c:pt idx="1934">
                  <c:v>278</c:v>
                </c:pt>
                <c:pt idx="1935">
                  <c:v>279.5</c:v>
                </c:pt>
                <c:pt idx="1936">
                  <c:v>279.5</c:v>
                </c:pt>
                <c:pt idx="1937">
                  <c:v>279</c:v>
                </c:pt>
                <c:pt idx="1938">
                  <c:v>279</c:v>
                </c:pt>
                <c:pt idx="1939">
                  <c:v>279</c:v>
                </c:pt>
                <c:pt idx="1940">
                  <c:v>280</c:v>
                </c:pt>
                <c:pt idx="1941">
                  <c:v>280</c:v>
                </c:pt>
                <c:pt idx="1942">
                  <c:v>280</c:v>
                </c:pt>
                <c:pt idx="1943">
                  <c:v>279.5</c:v>
                </c:pt>
                <c:pt idx="1944">
                  <c:v>279.5</c:v>
                </c:pt>
                <c:pt idx="1945">
                  <c:v>278.75</c:v>
                </c:pt>
                <c:pt idx="1946">
                  <c:v>278.75</c:v>
                </c:pt>
                <c:pt idx="1947">
                  <c:v>281.75</c:v>
                </c:pt>
                <c:pt idx="1948">
                  <c:v>281.75</c:v>
                </c:pt>
                <c:pt idx="1949">
                  <c:v>281</c:v>
                </c:pt>
                <c:pt idx="1950">
                  <c:v>281</c:v>
                </c:pt>
                <c:pt idx="1951">
                  <c:v>281</c:v>
                </c:pt>
                <c:pt idx="1952">
                  <c:v>282.5</c:v>
                </c:pt>
                <c:pt idx="1953">
                  <c:v>282.5</c:v>
                </c:pt>
                <c:pt idx="1954">
                  <c:v>282</c:v>
                </c:pt>
                <c:pt idx="1955">
                  <c:v>282</c:v>
                </c:pt>
                <c:pt idx="1956">
                  <c:v>282</c:v>
                </c:pt>
                <c:pt idx="1957">
                  <c:v>283</c:v>
                </c:pt>
                <c:pt idx="1958">
                  <c:v>283</c:v>
                </c:pt>
                <c:pt idx="1959">
                  <c:v>283</c:v>
                </c:pt>
                <c:pt idx="1960">
                  <c:v>282.5</c:v>
                </c:pt>
                <c:pt idx="1961">
                  <c:v>282.5</c:v>
                </c:pt>
                <c:pt idx="1962">
                  <c:v>281.75</c:v>
                </c:pt>
                <c:pt idx="1963">
                  <c:v>281.75</c:v>
                </c:pt>
                <c:pt idx="1964">
                  <c:v>280.25</c:v>
                </c:pt>
                <c:pt idx="1965">
                  <c:v>280.25</c:v>
                </c:pt>
                <c:pt idx="1966">
                  <c:v>285.625</c:v>
                </c:pt>
                <c:pt idx="1967">
                  <c:v>285.625</c:v>
                </c:pt>
                <c:pt idx="1968">
                  <c:v>284.5</c:v>
                </c:pt>
                <c:pt idx="1969">
                  <c:v>284.5</c:v>
                </c:pt>
                <c:pt idx="1970">
                  <c:v>284</c:v>
                </c:pt>
                <c:pt idx="1971">
                  <c:v>284</c:v>
                </c:pt>
                <c:pt idx="1972">
                  <c:v>284</c:v>
                </c:pt>
                <c:pt idx="1973">
                  <c:v>285</c:v>
                </c:pt>
                <c:pt idx="1974">
                  <c:v>285</c:v>
                </c:pt>
                <c:pt idx="1975">
                  <c:v>285</c:v>
                </c:pt>
                <c:pt idx="1976">
                  <c:v>284.5</c:v>
                </c:pt>
                <c:pt idx="1977">
                  <c:v>284.5</c:v>
                </c:pt>
                <c:pt idx="1978">
                  <c:v>286.75</c:v>
                </c:pt>
                <c:pt idx="1979">
                  <c:v>286.75</c:v>
                </c:pt>
                <c:pt idx="1980">
                  <c:v>286</c:v>
                </c:pt>
                <c:pt idx="1981">
                  <c:v>286</c:v>
                </c:pt>
                <c:pt idx="1982">
                  <c:v>286</c:v>
                </c:pt>
                <c:pt idx="1983">
                  <c:v>287.5</c:v>
                </c:pt>
                <c:pt idx="1984">
                  <c:v>287.5</c:v>
                </c:pt>
                <c:pt idx="1985">
                  <c:v>287</c:v>
                </c:pt>
                <c:pt idx="1986">
                  <c:v>287</c:v>
                </c:pt>
                <c:pt idx="1987">
                  <c:v>287</c:v>
                </c:pt>
                <c:pt idx="1988">
                  <c:v>288</c:v>
                </c:pt>
                <c:pt idx="1989">
                  <c:v>288</c:v>
                </c:pt>
                <c:pt idx="1990">
                  <c:v>288</c:v>
                </c:pt>
                <c:pt idx="1991">
                  <c:v>287.5</c:v>
                </c:pt>
                <c:pt idx="1992">
                  <c:v>287.5</c:v>
                </c:pt>
                <c:pt idx="1993">
                  <c:v>286.75</c:v>
                </c:pt>
                <c:pt idx="1994">
                  <c:v>286.75</c:v>
                </c:pt>
                <c:pt idx="1995">
                  <c:v>285.625</c:v>
                </c:pt>
                <c:pt idx="1996">
                  <c:v>285.625</c:v>
                </c:pt>
                <c:pt idx="1997">
                  <c:v>282.9375</c:v>
                </c:pt>
                <c:pt idx="1998">
                  <c:v>282.9375</c:v>
                </c:pt>
                <c:pt idx="1999">
                  <c:v>277.640625</c:v>
                </c:pt>
                <c:pt idx="2000">
                  <c:v>277.640625</c:v>
                </c:pt>
                <c:pt idx="2001">
                  <c:v>175.43490219116211</c:v>
                </c:pt>
                <c:pt idx="2002">
                  <c:v>175.43490219116211</c:v>
                </c:pt>
                <c:pt idx="2003">
                  <c:v>106.49088859558105</c:v>
                </c:pt>
                <c:pt idx="2004">
                  <c:v>106.49088859558105</c:v>
                </c:pt>
                <c:pt idx="2005">
                  <c:v>62.337241172790527</c:v>
                </c:pt>
                <c:pt idx="2006">
                  <c:v>62.337241172790527</c:v>
                </c:pt>
                <c:pt idx="2007">
                  <c:v>297.818359375</c:v>
                </c:pt>
                <c:pt idx="2008">
                  <c:v>297.818359375</c:v>
                </c:pt>
                <c:pt idx="2009">
                  <c:v>290.625</c:v>
                </c:pt>
                <c:pt idx="2010">
                  <c:v>290.625</c:v>
                </c:pt>
                <c:pt idx="2011">
                  <c:v>289.5</c:v>
                </c:pt>
                <c:pt idx="2012">
                  <c:v>289.5</c:v>
                </c:pt>
                <c:pt idx="2013">
                  <c:v>289</c:v>
                </c:pt>
                <c:pt idx="2014">
                  <c:v>289</c:v>
                </c:pt>
                <c:pt idx="2015">
                  <c:v>289</c:v>
                </c:pt>
                <c:pt idx="2016">
                  <c:v>290</c:v>
                </c:pt>
                <c:pt idx="2017">
                  <c:v>290</c:v>
                </c:pt>
                <c:pt idx="2018">
                  <c:v>290</c:v>
                </c:pt>
                <c:pt idx="2019">
                  <c:v>289.5</c:v>
                </c:pt>
                <c:pt idx="2020">
                  <c:v>289.5</c:v>
                </c:pt>
                <c:pt idx="2021">
                  <c:v>291.75</c:v>
                </c:pt>
                <c:pt idx="2022">
                  <c:v>291.75</c:v>
                </c:pt>
                <c:pt idx="2023">
                  <c:v>291</c:v>
                </c:pt>
                <c:pt idx="2024">
                  <c:v>291</c:v>
                </c:pt>
                <c:pt idx="2025">
                  <c:v>291</c:v>
                </c:pt>
                <c:pt idx="2026">
                  <c:v>292.5</c:v>
                </c:pt>
                <c:pt idx="2027">
                  <c:v>292.5</c:v>
                </c:pt>
                <c:pt idx="2028">
                  <c:v>292</c:v>
                </c:pt>
                <c:pt idx="2029">
                  <c:v>292</c:v>
                </c:pt>
                <c:pt idx="2030">
                  <c:v>292</c:v>
                </c:pt>
                <c:pt idx="2031">
                  <c:v>293</c:v>
                </c:pt>
                <c:pt idx="2032">
                  <c:v>293</c:v>
                </c:pt>
                <c:pt idx="2033">
                  <c:v>293</c:v>
                </c:pt>
                <c:pt idx="2034">
                  <c:v>292.5</c:v>
                </c:pt>
                <c:pt idx="2035">
                  <c:v>292.5</c:v>
                </c:pt>
                <c:pt idx="2036">
                  <c:v>291.75</c:v>
                </c:pt>
                <c:pt idx="2037">
                  <c:v>291.75</c:v>
                </c:pt>
                <c:pt idx="2038">
                  <c:v>290.625</c:v>
                </c:pt>
                <c:pt idx="2039">
                  <c:v>290.625</c:v>
                </c:pt>
                <c:pt idx="2040">
                  <c:v>305.01171875</c:v>
                </c:pt>
                <c:pt idx="2041">
                  <c:v>305.01171875</c:v>
                </c:pt>
                <c:pt idx="2042">
                  <c:v>297.875</c:v>
                </c:pt>
                <c:pt idx="2043">
                  <c:v>297.875</c:v>
                </c:pt>
                <c:pt idx="2044">
                  <c:v>295.25</c:v>
                </c:pt>
                <c:pt idx="2045">
                  <c:v>295.25</c:v>
                </c:pt>
                <c:pt idx="2046">
                  <c:v>294</c:v>
                </c:pt>
                <c:pt idx="2047">
                  <c:v>294</c:v>
                </c:pt>
                <c:pt idx="2048">
                  <c:v>294</c:v>
                </c:pt>
                <c:pt idx="2049">
                  <c:v>296.5</c:v>
                </c:pt>
                <c:pt idx="2050">
                  <c:v>296.5</c:v>
                </c:pt>
                <c:pt idx="2051">
                  <c:v>295.5</c:v>
                </c:pt>
                <c:pt idx="2052">
                  <c:v>295.5</c:v>
                </c:pt>
                <c:pt idx="2053">
                  <c:v>295</c:v>
                </c:pt>
                <c:pt idx="2054">
                  <c:v>295</c:v>
                </c:pt>
                <c:pt idx="2055">
                  <c:v>295</c:v>
                </c:pt>
                <c:pt idx="2056">
                  <c:v>296</c:v>
                </c:pt>
                <c:pt idx="2057">
                  <c:v>296</c:v>
                </c:pt>
                <c:pt idx="2058">
                  <c:v>296</c:v>
                </c:pt>
                <c:pt idx="2059">
                  <c:v>295.5</c:v>
                </c:pt>
                <c:pt idx="2060">
                  <c:v>295.5</c:v>
                </c:pt>
                <c:pt idx="2061">
                  <c:v>297.5</c:v>
                </c:pt>
                <c:pt idx="2062">
                  <c:v>297.5</c:v>
                </c:pt>
                <c:pt idx="2063">
                  <c:v>297</c:v>
                </c:pt>
                <c:pt idx="2064">
                  <c:v>297</c:v>
                </c:pt>
                <c:pt idx="2065">
                  <c:v>297</c:v>
                </c:pt>
                <c:pt idx="2066">
                  <c:v>298</c:v>
                </c:pt>
                <c:pt idx="2067">
                  <c:v>298</c:v>
                </c:pt>
                <c:pt idx="2068">
                  <c:v>298</c:v>
                </c:pt>
                <c:pt idx="2069">
                  <c:v>297.5</c:v>
                </c:pt>
                <c:pt idx="2070">
                  <c:v>297.5</c:v>
                </c:pt>
                <c:pt idx="2071">
                  <c:v>296.5</c:v>
                </c:pt>
                <c:pt idx="2072">
                  <c:v>296.5</c:v>
                </c:pt>
                <c:pt idx="2073">
                  <c:v>295.25</c:v>
                </c:pt>
                <c:pt idx="2074">
                  <c:v>295.25</c:v>
                </c:pt>
                <c:pt idx="2075">
                  <c:v>300.5</c:v>
                </c:pt>
                <c:pt idx="2076">
                  <c:v>300.5</c:v>
                </c:pt>
                <c:pt idx="2077">
                  <c:v>299.5</c:v>
                </c:pt>
                <c:pt idx="2078">
                  <c:v>299.5</c:v>
                </c:pt>
                <c:pt idx="2079">
                  <c:v>299</c:v>
                </c:pt>
                <c:pt idx="2080">
                  <c:v>299</c:v>
                </c:pt>
                <c:pt idx="2081">
                  <c:v>299</c:v>
                </c:pt>
                <c:pt idx="2082">
                  <c:v>300</c:v>
                </c:pt>
                <c:pt idx="2083">
                  <c:v>300</c:v>
                </c:pt>
                <c:pt idx="2084">
                  <c:v>300</c:v>
                </c:pt>
                <c:pt idx="2085">
                  <c:v>299.5</c:v>
                </c:pt>
                <c:pt idx="2086">
                  <c:v>299.5</c:v>
                </c:pt>
                <c:pt idx="2087">
                  <c:v>301.5</c:v>
                </c:pt>
                <c:pt idx="2088">
                  <c:v>301.5</c:v>
                </c:pt>
                <c:pt idx="2089">
                  <c:v>301</c:v>
                </c:pt>
                <c:pt idx="2090">
                  <c:v>301</c:v>
                </c:pt>
                <c:pt idx="2091">
                  <c:v>301</c:v>
                </c:pt>
                <c:pt idx="2092">
                  <c:v>302</c:v>
                </c:pt>
                <c:pt idx="2093">
                  <c:v>302</c:v>
                </c:pt>
                <c:pt idx="2094">
                  <c:v>302</c:v>
                </c:pt>
                <c:pt idx="2095">
                  <c:v>301.5</c:v>
                </c:pt>
                <c:pt idx="2096">
                  <c:v>301.5</c:v>
                </c:pt>
                <c:pt idx="2097">
                  <c:v>300.5</c:v>
                </c:pt>
                <c:pt idx="2098">
                  <c:v>300.5</c:v>
                </c:pt>
                <c:pt idx="2099">
                  <c:v>297.875</c:v>
                </c:pt>
                <c:pt idx="2100">
                  <c:v>297.875</c:v>
                </c:pt>
                <c:pt idx="2101">
                  <c:v>312.1484375</c:v>
                </c:pt>
                <c:pt idx="2102">
                  <c:v>312.1484375</c:v>
                </c:pt>
                <c:pt idx="2103">
                  <c:v>305.6875</c:v>
                </c:pt>
                <c:pt idx="2104">
                  <c:v>305.6875</c:v>
                </c:pt>
                <c:pt idx="2105">
                  <c:v>303.75</c:v>
                </c:pt>
                <c:pt idx="2106">
                  <c:v>303.75</c:v>
                </c:pt>
                <c:pt idx="2107">
                  <c:v>303</c:v>
                </c:pt>
                <c:pt idx="2108">
                  <c:v>303</c:v>
                </c:pt>
                <c:pt idx="2109">
                  <c:v>303</c:v>
                </c:pt>
                <c:pt idx="2110">
                  <c:v>304.5</c:v>
                </c:pt>
                <c:pt idx="2111">
                  <c:v>304.5</c:v>
                </c:pt>
                <c:pt idx="2112">
                  <c:v>304</c:v>
                </c:pt>
                <c:pt idx="2113">
                  <c:v>304</c:v>
                </c:pt>
                <c:pt idx="2114">
                  <c:v>304</c:v>
                </c:pt>
                <c:pt idx="2115">
                  <c:v>305</c:v>
                </c:pt>
                <c:pt idx="2116">
                  <c:v>305</c:v>
                </c:pt>
                <c:pt idx="2117">
                  <c:v>305</c:v>
                </c:pt>
                <c:pt idx="2118">
                  <c:v>304.5</c:v>
                </c:pt>
                <c:pt idx="2119">
                  <c:v>304.5</c:v>
                </c:pt>
                <c:pt idx="2120">
                  <c:v>303.75</c:v>
                </c:pt>
                <c:pt idx="2121">
                  <c:v>303.75</c:v>
                </c:pt>
                <c:pt idx="2122">
                  <c:v>307.625</c:v>
                </c:pt>
                <c:pt idx="2123">
                  <c:v>307.625</c:v>
                </c:pt>
                <c:pt idx="2124">
                  <c:v>306.5</c:v>
                </c:pt>
                <c:pt idx="2125">
                  <c:v>306.5</c:v>
                </c:pt>
                <c:pt idx="2126">
                  <c:v>306</c:v>
                </c:pt>
                <c:pt idx="2127">
                  <c:v>306</c:v>
                </c:pt>
                <c:pt idx="2128">
                  <c:v>306</c:v>
                </c:pt>
                <c:pt idx="2129">
                  <c:v>307</c:v>
                </c:pt>
                <c:pt idx="2130">
                  <c:v>307</c:v>
                </c:pt>
                <c:pt idx="2131">
                  <c:v>307</c:v>
                </c:pt>
                <c:pt idx="2132">
                  <c:v>306.5</c:v>
                </c:pt>
                <c:pt idx="2133">
                  <c:v>306.5</c:v>
                </c:pt>
                <c:pt idx="2134">
                  <c:v>308.75</c:v>
                </c:pt>
                <c:pt idx="2135">
                  <c:v>308.75</c:v>
                </c:pt>
                <c:pt idx="2136">
                  <c:v>308</c:v>
                </c:pt>
                <c:pt idx="2137">
                  <c:v>308</c:v>
                </c:pt>
                <c:pt idx="2138">
                  <c:v>308</c:v>
                </c:pt>
                <c:pt idx="2139">
                  <c:v>309.5</c:v>
                </c:pt>
                <c:pt idx="2140">
                  <c:v>309.5</c:v>
                </c:pt>
                <c:pt idx="2141">
                  <c:v>309</c:v>
                </c:pt>
                <c:pt idx="2142">
                  <c:v>309</c:v>
                </c:pt>
                <c:pt idx="2143">
                  <c:v>309</c:v>
                </c:pt>
                <c:pt idx="2144">
                  <c:v>310</c:v>
                </c:pt>
                <c:pt idx="2145">
                  <c:v>310</c:v>
                </c:pt>
                <c:pt idx="2146">
                  <c:v>310</c:v>
                </c:pt>
                <c:pt idx="2147">
                  <c:v>309.5</c:v>
                </c:pt>
                <c:pt idx="2148">
                  <c:v>309.5</c:v>
                </c:pt>
                <c:pt idx="2149">
                  <c:v>308.75</c:v>
                </c:pt>
                <c:pt idx="2150">
                  <c:v>308.75</c:v>
                </c:pt>
                <c:pt idx="2151">
                  <c:v>307.625</c:v>
                </c:pt>
                <c:pt idx="2152">
                  <c:v>307.625</c:v>
                </c:pt>
                <c:pt idx="2153">
                  <c:v>305.6875</c:v>
                </c:pt>
                <c:pt idx="2154">
                  <c:v>305.6875</c:v>
                </c:pt>
                <c:pt idx="2155">
                  <c:v>318.609375</c:v>
                </c:pt>
                <c:pt idx="2156">
                  <c:v>318.609375</c:v>
                </c:pt>
                <c:pt idx="2157">
                  <c:v>313.09375</c:v>
                </c:pt>
                <c:pt idx="2158">
                  <c:v>313.09375</c:v>
                </c:pt>
                <c:pt idx="2159">
                  <c:v>311.5</c:v>
                </c:pt>
                <c:pt idx="2160">
                  <c:v>311.5</c:v>
                </c:pt>
                <c:pt idx="2161">
                  <c:v>311</c:v>
                </c:pt>
                <c:pt idx="2162">
                  <c:v>311</c:v>
                </c:pt>
                <c:pt idx="2163">
                  <c:v>311</c:v>
                </c:pt>
                <c:pt idx="2164">
                  <c:v>312</c:v>
                </c:pt>
                <c:pt idx="2165">
                  <c:v>312</c:v>
                </c:pt>
                <c:pt idx="2166">
                  <c:v>312</c:v>
                </c:pt>
                <c:pt idx="2167">
                  <c:v>311.5</c:v>
                </c:pt>
                <c:pt idx="2168">
                  <c:v>311.5</c:v>
                </c:pt>
                <c:pt idx="2169">
                  <c:v>314.6875</c:v>
                </c:pt>
                <c:pt idx="2170">
                  <c:v>314.6875</c:v>
                </c:pt>
                <c:pt idx="2171">
                  <c:v>313.5</c:v>
                </c:pt>
                <c:pt idx="2172">
                  <c:v>313.5</c:v>
                </c:pt>
                <c:pt idx="2173">
                  <c:v>313</c:v>
                </c:pt>
                <c:pt idx="2174">
                  <c:v>313</c:v>
                </c:pt>
                <c:pt idx="2175">
                  <c:v>313</c:v>
                </c:pt>
                <c:pt idx="2176">
                  <c:v>314</c:v>
                </c:pt>
                <c:pt idx="2177">
                  <c:v>314</c:v>
                </c:pt>
                <c:pt idx="2178">
                  <c:v>314</c:v>
                </c:pt>
                <c:pt idx="2179">
                  <c:v>313.5</c:v>
                </c:pt>
                <c:pt idx="2180">
                  <c:v>313.5</c:v>
                </c:pt>
                <c:pt idx="2181">
                  <c:v>315.875</c:v>
                </c:pt>
                <c:pt idx="2182">
                  <c:v>315.875</c:v>
                </c:pt>
                <c:pt idx="2183">
                  <c:v>315</c:v>
                </c:pt>
                <c:pt idx="2184">
                  <c:v>315</c:v>
                </c:pt>
                <c:pt idx="2185">
                  <c:v>315</c:v>
                </c:pt>
                <c:pt idx="2186">
                  <c:v>316.75</c:v>
                </c:pt>
                <c:pt idx="2187">
                  <c:v>316.75</c:v>
                </c:pt>
                <c:pt idx="2188">
                  <c:v>316</c:v>
                </c:pt>
                <c:pt idx="2189">
                  <c:v>316</c:v>
                </c:pt>
                <c:pt idx="2190">
                  <c:v>316</c:v>
                </c:pt>
                <c:pt idx="2191">
                  <c:v>317.5</c:v>
                </c:pt>
                <c:pt idx="2192">
                  <c:v>317.5</c:v>
                </c:pt>
                <c:pt idx="2193">
                  <c:v>317</c:v>
                </c:pt>
                <c:pt idx="2194">
                  <c:v>317</c:v>
                </c:pt>
                <c:pt idx="2195">
                  <c:v>317</c:v>
                </c:pt>
                <c:pt idx="2196">
                  <c:v>318</c:v>
                </c:pt>
                <c:pt idx="2197">
                  <c:v>318</c:v>
                </c:pt>
                <c:pt idx="2198">
                  <c:v>318</c:v>
                </c:pt>
                <c:pt idx="2199">
                  <c:v>317.5</c:v>
                </c:pt>
                <c:pt idx="2200">
                  <c:v>317.5</c:v>
                </c:pt>
                <c:pt idx="2201">
                  <c:v>316.75</c:v>
                </c:pt>
                <c:pt idx="2202">
                  <c:v>316.75</c:v>
                </c:pt>
                <c:pt idx="2203">
                  <c:v>315.875</c:v>
                </c:pt>
                <c:pt idx="2204">
                  <c:v>315.875</c:v>
                </c:pt>
                <c:pt idx="2205">
                  <c:v>314.6875</c:v>
                </c:pt>
                <c:pt idx="2206">
                  <c:v>314.6875</c:v>
                </c:pt>
                <c:pt idx="2207">
                  <c:v>313.09375</c:v>
                </c:pt>
                <c:pt idx="2208">
                  <c:v>313.09375</c:v>
                </c:pt>
                <c:pt idx="2209">
                  <c:v>324.125</c:v>
                </c:pt>
                <c:pt idx="2210">
                  <c:v>324.125</c:v>
                </c:pt>
                <c:pt idx="2211">
                  <c:v>320.6875</c:v>
                </c:pt>
                <c:pt idx="2212">
                  <c:v>320.6875</c:v>
                </c:pt>
                <c:pt idx="2213">
                  <c:v>319.5</c:v>
                </c:pt>
                <c:pt idx="2214">
                  <c:v>319.5</c:v>
                </c:pt>
                <c:pt idx="2215">
                  <c:v>319</c:v>
                </c:pt>
                <c:pt idx="2216">
                  <c:v>319</c:v>
                </c:pt>
                <c:pt idx="2217">
                  <c:v>319</c:v>
                </c:pt>
                <c:pt idx="2218">
                  <c:v>320</c:v>
                </c:pt>
                <c:pt idx="2219">
                  <c:v>320</c:v>
                </c:pt>
                <c:pt idx="2220">
                  <c:v>320</c:v>
                </c:pt>
                <c:pt idx="2221">
                  <c:v>319.5</c:v>
                </c:pt>
                <c:pt idx="2222">
                  <c:v>319.5</c:v>
                </c:pt>
                <c:pt idx="2223">
                  <c:v>321.875</c:v>
                </c:pt>
                <c:pt idx="2224">
                  <c:v>321.875</c:v>
                </c:pt>
                <c:pt idx="2225">
                  <c:v>321</c:v>
                </c:pt>
                <c:pt idx="2226">
                  <c:v>321</c:v>
                </c:pt>
                <c:pt idx="2227">
                  <c:v>321</c:v>
                </c:pt>
                <c:pt idx="2228">
                  <c:v>322.75</c:v>
                </c:pt>
                <c:pt idx="2229">
                  <c:v>322.75</c:v>
                </c:pt>
                <c:pt idx="2230">
                  <c:v>322</c:v>
                </c:pt>
                <c:pt idx="2231">
                  <c:v>322</c:v>
                </c:pt>
                <c:pt idx="2232">
                  <c:v>322</c:v>
                </c:pt>
                <c:pt idx="2233">
                  <c:v>323.5</c:v>
                </c:pt>
                <c:pt idx="2234">
                  <c:v>323.5</c:v>
                </c:pt>
                <c:pt idx="2235">
                  <c:v>323</c:v>
                </c:pt>
                <c:pt idx="2236">
                  <c:v>323</c:v>
                </c:pt>
                <c:pt idx="2237">
                  <c:v>323</c:v>
                </c:pt>
                <c:pt idx="2238">
                  <c:v>324</c:v>
                </c:pt>
                <c:pt idx="2239">
                  <c:v>324</c:v>
                </c:pt>
                <c:pt idx="2240">
                  <c:v>324</c:v>
                </c:pt>
                <c:pt idx="2241">
                  <c:v>323.5</c:v>
                </c:pt>
                <c:pt idx="2242">
                  <c:v>323.5</c:v>
                </c:pt>
                <c:pt idx="2243">
                  <c:v>322.75</c:v>
                </c:pt>
                <c:pt idx="2244">
                  <c:v>322.75</c:v>
                </c:pt>
                <c:pt idx="2245">
                  <c:v>321.875</c:v>
                </c:pt>
                <c:pt idx="2246">
                  <c:v>321.875</c:v>
                </c:pt>
                <c:pt idx="2247">
                  <c:v>320.6875</c:v>
                </c:pt>
                <c:pt idx="2248">
                  <c:v>320.6875</c:v>
                </c:pt>
                <c:pt idx="2249">
                  <c:v>327.5625</c:v>
                </c:pt>
                <c:pt idx="2250">
                  <c:v>327.5625</c:v>
                </c:pt>
                <c:pt idx="2251">
                  <c:v>325.5</c:v>
                </c:pt>
                <c:pt idx="2252">
                  <c:v>325.5</c:v>
                </c:pt>
                <c:pt idx="2253">
                  <c:v>325</c:v>
                </c:pt>
                <c:pt idx="2254">
                  <c:v>325</c:v>
                </c:pt>
                <c:pt idx="2255">
                  <c:v>325</c:v>
                </c:pt>
                <c:pt idx="2256">
                  <c:v>326</c:v>
                </c:pt>
                <c:pt idx="2257">
                  <c:v>326</c:v>
                </c:pt>
                <c:pt idx="2258">
                  <c:v>326</c:v>
                </c:pt>
                <c:pt idx="2259">
                  <c:v>325.5</c:v>
                </c:pt>
                <c:pt idx="2260">
                  <c:v>325.5</c:v>
                </c:pt>
                <c:pt idx="2261">
                  <c:v>329.625</c:v>
                </c:pt>
                <c:pt idx="2262">
                  <c:v>329.625</c:v>
                </c:pt>
                <c:pt idx="2263">
                  <c:v>327.75</c:v>
                </c:pt>
                <c:pt idx="2264">
                  <c:v>327.75</c:v>
                </c:pt>
                <c:pt idx="2265">
                  <c:v>327</c:v>
                </c:pt>
                <c:pt idx="2266">
                  <c:v>327</c:v>
                </c:pt>
                <c:pt idx="2267">
                  <c:v>327</c:v>
                </c:pt>
                <c:pt idx="2268">
                  <c:v>328.5</c:v>
                </c:pt>
                <c:pt idx="2269">
                  <c:v>328.5</c:v>
                </c:pt>
                <c:pt idx="2270">
                  <c:v>328</c:v>
                </c:pt>
                <c:pt idx="2271">
                  <c:v>328</c:v>
                </c:pt>
                <c:pt idx="2272">
                  <c:v>328</c:v>
                </c:pt>
                <c:pt idx="2273">
                  <c:v>329</c:v>
                </c:pt>
                <c:pt idx="2274">
                  <c:v>329</c:v>
                </c:pt>
                <c:pt idx="2275">
                  <c:v>329</c:v>
                </c:pt>
                <c:pt idx="2276">
                  <c:v>328.5</c:v>
                </c:pt>
                <c:pt idx="2277">
                  <c:v>328.5</c:v>
                </c:pt>
                <c:pt idx="2278">
                  <c:v>327.75</c:v>
                </c:pt>
                <c:pt idx="2279">
                  <c:v>327.75</c:v>
                </c:pt>
                <c:pt idx="2280">
                  <c:v>331.5</c:v>
                </c:pt>
                <c:pt idx="2281">
                  <c:v>331.5</c:v>
                </c:pt>
                <c:pt idx="2282">
                  <c:v>330.5</c:v>
                </c:pt>
                <c:pt idx="2283">
                  <c:v>330.5</c:v>
                </c:pt>
                <c:pt idx="2284">
                  <c:v>330</c:v>
                </c:pt>
                <c:pt idx="2285">
                  <c:v>330</c:v>
                </c:pt>
                <c:pt idx="2286">
                  <c:v>330</c:v>
                </c:pt>
                <c:pt idx="2287">
                  <c:v>331</c:v>
                </c:pt>
                <c:pt idx="2288">
                  <c:v>331</c:v>
                </c:pt>
                <c:pt idx="2289">
                  <c:v>331</c:v>
                </c:pt>
                <c:pt idx="2290">
                  <c:v>330.5</c:v>
                </c:pt>
                <c:pt idx="2291">
                  <c:v>330.5</c:v>
                </c:pt>
                <c:pt idx="2292">
                  <c:v>332.5</c:v>
                </c:pt>
                <c:pt idx="2293">
                  <c:v>332.5</c:v>
                </c:pt>
                <c:pt idx="2294">
                  <c:v>332</c:v>
                </c:pt>
                <c:pt idx="2295">
                  <c:v>332</c:v>
                </c:pt>
                <c:pt idx="2296">
                  <c:v>332</c:v>
                </c:pt>
                <c:pt idx="2297">
                  <c:v>333</c:v>
                </c:pt>
                <c:pt idx="2298">
                  <c:v>333</c:v>
                </c:pt>
                <c:pt idx="2299">
                  <c:v>333</c:v>
                </c:pt>
                <c:pt idx="2300">
                  <c:v>332.5</c:v>
                </c:pt>
                <c:pt idx="2301">
                  <c:v>332.5</c:v>
                </c:pt>
                <c:pt idx="2302">
                  <c:v>331.5</c:v>
                </c:pt>
                <c:pt idx="2303">
                  <c:v>331.5</c:v>
                </c:pt>
                <c:pt idx="2304">
                  <c:v>329.625</c:v>
                </c:pt>
                <c:pt idx="2305">
                  <c:v>329.625</c:v>
                </c:pt>
                <c:pt idx="2306">
                  <c:v>327.5625</c:v>
                </c:pt>
                <c:pt idx="2307">
                  <c:v>327.5625</c:v>
                </c:pt>
                <c:pt idx="2308">
                  <c:v>324.125</c:v>
                </c:pt>
                <c:pt idx="2309">
                  <c:v>324.125</c:v>
                </c:pt>
                <c:pt idx="2310">
                  <c:v>318.609375</c:v>
                </c:pt>
                <c:pt idx="2311">
                  <c:v>318.609375</c:v>
                </c:pt>
                <c:pt idx="2312">
                  <c:v>312.1484375</c:v>
                </c:pt>
                <c:pt idx="2313">
                  <c:v>312.1484375</c:v>
                </c:pt>
                <c:pt idx="2314">
                  <c:v>305.01171875</c:v>
                </c:pt>
                <c:pt idx="2315">
                  <c:v>305.01171875</c:v>
                </c:pt>
                <c:pt idx="2316">
                  <c:v>297.818359375</c:v>
                </c:pt>
                <c:pt idx="2317">
                  <c:v>297.818359375</c:v>
                </c:pt>
                <c:pt idx="2318">
                  <c:v>180.07780027389526</c:v>
                </c:pt>
                <c:pt idx="2319">
                  <c:v>180.07780027389526</c:v>
                </c:pt>
                <c:pt idx="2320">
                  <c:v>93.101400136947632</c:v>
                </c:pt>
                <c:pt idx="2321">
                  <c:v>93.101400136947632</c:v>
                </c:pt>
                <c:pt idx="2322">
                  <c:v>48.550700068473816</c:v>
                </c:pt>
                <c:pt idx="2323">
                  <c:v>48.550700068473816</c:v>
                </c:pt>
                <c:pt idx="2324">
                  <c:v>25.1503500342369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DCD-4C4B-8120-8BECCC995D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9224176"/>
        <c:axId val="239230000"/>
      </c:scatterChart>
      <c:valAx>
        <c:axId val="239224176"/>
        <c:scaling>
          <c:orientation val="maxMin"/>
          <c:min val="0"/>
        </c:scaling>
        <c:delete val="0"/>
        <c:axPos val="b"/>
        <c:numFmt formatCode="General" sourceLinked="0"/>
        <c:majorTickMark val="none"/>
        <c:minorTickMark val="none"/>
        <c:tickLblPos val="none"/>
        <c:spPr>
          <a:ln w="6350">
            <a:noFill/>
          </a:ln>
        </c:spPr>
        <c:txPr>
          <a:bodyPr/>
          <a:lstStyle/>
          <a:p>
            <a:pPr>
              <a:defRPr sz="700"/>
            </a:pPr>
            <a:endParaRPr lang="fr-FR"/>
          </a:p>
        </c:txPr>
        <c:crossAx val="239230000"/>
        <c:crosses val="autoZero"/>
        <c:crossBetween val="midCat"/>
      </c:valAx>
      <c:valAx>
        <c:axId val="239230000"/>
        <c:scaling>
          <c:orientation val="minMax"/>
          <c:max val="333.5"/>
          <c:min val="0.5"/>
        </c:scaling>
        <c:delete val="0"/>
        <c:axPos val="r"/>
        <c:numFmt formatCode="General" sourceLinked="0"/>
        <c:majorTickMark val="none"/>
        <c:minorTickMark val="none"/>
        <c:tickLblPos val="none"/>
        <c:spPr>
          <a:ln w="6350">
            <a:noFill/>
          </a:ln>
        </c:spPr>
        <c:txPr>
          <a:bodyPr/>
          <a:lstStyle/>
          <a:p>
            <a:pPr>
              <a:defRPr sz="700"/>
            </a:pPr>
            <a:endParaRPr lang="fr-FR"/>
          </a:p>
        </c:txPr>
        <c:crossAx val="239224176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6350">
      <a:noFill/>
    </a:ln>
  </c:sp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xMode val="edge"/>
          <c:yMode val="edge"/>
          <c:x val="3.9285714285714285E-2"/>
          <c:y val="8.5616438356164379E-4"/>
          <c:w val="0.93639869866566094"/>
          <c:h val="0.94863013698630139"/>
        </c:manualLayout>
      </c:layout>
      <c:barChart>
        <c:barDir val="bar"/>
        <c:grouping val="stacked"/>
        <c:varyColors val="0"/>
        <c:ser>
          <c:idx val="0"/>
          <c:order val="0"/>
          <c:tx>
            <c:v>MDA-MB-361 S</c:v>
          </c:tx>
          <c:spPr>
            <a:solidFill>
              <a:srgbClr val="000000"/>
            </a:solidFill>
            <a:ln w="25400"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1-A2EB-4566-9B46-DAC7DE36ADA2}"/>
              </c:ext>
            </c:extLst>
          </c:dPt>
          <c:dPt>
            <c:idx val="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3-A2EB-4566-9B46-DAC7DE36ADA2}"/>
              </c:ext>
            </c:extLst>
          </c:dPt>
          <c:dPt>
            <c:idx val="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5-A2EB-4566-9B46-DAC7DE36ADA2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7-A2EB-4566-9B46-DAC7DE36ADA2}"/>
              </c:ext>
            </c:extLst>
          </c:dPt>
          <c:dPt>
            <c:idx val="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9-A2EB-4566-9B46-DAC7DE36ADA2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B-A2EB-4566-9B46-DAC7DE36ADA2}"/>
              </c:ext>
            </c:extLst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D-A2EB-4566-9B46-DAC7DE36ADA2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0F-A2EB-4566-9B46-DAC7DE36ADA2}"/>
              </c:ext>
            </c:extLst>
          </c:dPt>
          <c:dPt>
            <c:idx val="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11-A2EB-4566-9B46-DAC7DE36ADA2}"/>
              </c:ext>
            </c:extLst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13-A2EB-4566-9B46-DAC7DE36ADA2}"/>
              </c:ext>
            </c:extLst>
          </c:dPt>
          <c:dPt>
            <c:idx val="1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15-A2EB-4566-9B46-DAC7DE36ADA2}"/>
              </c:ext>
            </c:extLst>
          </c:dPt>
          <c:dPt>
            <c:idx val="1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17-A2EB-4566-9B46-DAC7DE36ADA2}"/>
              </c:ext>
            </c:extLst>
          </c:dPt>
          <c:dPt>
            <c:idx val="1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19-A2EB-4566-9B46-DAC7DE36ADA2}"/>
              </c:ext>
            </c:extLst>
          </c:dPt>
          <c:dPt>
            <c:idx val="1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1B-A2EB-4566-9B46-DAC7DE36ADA2}"/>
              </c:ext>
            </c:extLst>
          </c:dPt>
          <c:dPt>
            <c:idx val="1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1D-A2EB-4566-9B46-DAC7DE36ADA2}"/>
              </c:ext>
            </c:extLst>
          </c:dPt>
          <c:dPt>
            <c:idx val="1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1F-A2EB-4566-9B46-DAC7DE36ADA2}"/>
              </c:ext>
            </c:extLst>
          </c:dPt>
          <c:dPt>
            <c:idx val="1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21-A2EB-4566-9B46-DAC7DE36ADA2}"/>
              </c:ext>
            </c:extLst>
          </c:dPt>
          <c:dPt>
            <c:idx val="1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23-A2EB-4566-9B46-DAC7DE36ADA2}"/>
              </c:ext>
            </c:extLst>
          </c:dPt>
          <c:dPt>
            <c:idx val="1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25-A2EB-4566-9B46-DAC7DE36ADA2}"/>
              </c:ext>
            </c:extLst>
          </c:dPt>
          <c:dPt>
            <c:idx val="1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27-A2EB-4566-9B46-DAC7DE36ADA2}"/>
              </c:ext>
            </c:extLst>
          </c:dPt>
          <c:dPt>
            <c:idx val="2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29-A2EB-4566-9B46-DAC7DE36ADA2}"/>
              </c:ext>
            </c:extLst>
          </c:dPt>
          <c:dPt>
            <c:idx val="2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2B-A2EB-4566-9B46-DAC7DE36ADA2}"/>
              </c:ext>
            </c:extLst>
          </c:dPt>
          <c:dPt>
            <c:idx val="2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2D-A2EB-4566-9B46-DAC7DE36ADA2}"/>
              </c:ext>
            </c:extLst>
          </c:dPt>
          <c:dPt>
            <c:idx val="2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2F-A2EB-4566-9B46-DAC7DE36ADA2}"/>
              </c:ext>
            </c:extLst>
          </c:dPt>
          <c:dPt>
            <c:idx val="2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31-A2EB-4566-9B46-DAC7DE36ADA2}"/>
              </c:ext>
            </c:extLst>
          </c:dPt>
          <c:dPt>
            <c:idx val="2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33-A2EB-4566-9B46-DAC7DE36ADA2}"/>
              </c:ext>
            </c:extLst>
          </c:dPt>
          <c:dPt>
            <c:idx val="2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35-A2EB-4566-9B46-DAC7DE36ADA2}"/>
              </c:ext>
            </c:extLst>
          </c:dPt>
          <c:dPt>
            <c:idx val="2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37-A2EB-4566-9B46-DAC7DE36ADA2}"/>
              </c:ext>
            </c:extLst>
          </c:dPt>
          <c:dPt>
            <c:idx val="2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39-A2EB-4566-9B46-DAC7DE36ADA2}"/>
              </c:ext>
            </c:extLst>
          </c:dPt>
          <c:dPt>
            <c:idx val="2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3B-A2EB-4566-9B46-DAC7DE36ADA2}"/>
              </c:ext>
            </c:extLst>
          </c:dPt>
          <c:dPt>
            <c:idx val="3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3D-A2EB-4566-9B46-DAC7DE36ADA2}"/>
              </c:ext>
            </c:extLst>
          </c:dPt>
          <c:dPt>
            <c:idx val="3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3F-A2EB-4566-9B46-DAC7DE36ADA2}"/>
              </c:ext>
            </c:extLst>
          </c:dPt>
          <c:dPt>
            <c:idx val="3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41-A2EB-4566-9B46-DAC7DE36ADA2}"/>
              </c:ext>
            </c:extLst>
          </c:dPt>
          <c:dPt>
            <c:idx val="3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43-A2EB-4566-9B46-DAC7DE36ADA2}"/>
              </c:ext>
            </c:extLst>
          </c:dPt>
          <c:dPt>
            <c:idx val="3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45-A2EB-4566-9B46-DAC7DE36ADA2}"/>
              </c:ext>
            </c:extLst>
          </c:dPt>
          <c:dPt>
            <c:idx val="3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47-A2EB-4566-9B46-DAC7DE36ADA2}"/>
              </c:ext>
            </c:extLst>
          </c:dPt>
          <c:dPt>
            <c:idx val="3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49-A2EB-4566-9B46-DAC7DE36ADA2}"/>
              </c:ext>
            </c:extLst>
          </c:dPt>
          <c:dPt>
            <c:idx val="3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4B-A2EB-4566-9B46-DAC7DE36ADA2}"/>
              </c:ext>
            </c:extLst>
          </c:dPt>
          <c:dPt>
            <c:idx val="3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4D-A2EB-4566-9B46-DAC7DE36ADA2}"/>
              </c:ext>
            </c:extLst>
          </c:dPt>
          <c:dPt>
            <c:idx val="3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4F-A2EB-4566-9B46-DAC7DE36ADA2}"/>
              </c:ext>
            </c:extLst>
          </c:dPt>
          <c:dPt>
            <c:idx val="4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51-A2EB-4566-9B46-DAC7DE36ADA2}"/>
              </c:ext>
            </c:extLst>
          </c:dPt>
          <c:dPt>
            <c:idx val="4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53-A2EB-4566-9B46-DAC7DE36ADA2}"/>
              </c:ext>
            </c:extLst>
          </c:dPt>
          <c:dPt>
            <c:idx val="4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55-A2EB-4566-9B46-DAC7DE36ADA2}"/>
              </c:ext>
            </c:extLst>
          </c:dPt>
          <c:dPt>
            <c:idx val="4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57-A2EB-4566-9B46-DAC7DE36ADA2}"/>
              </c:ext>
            </c:extLst>
          </c:dPt>
          <c:dPt>
            <c:idx val="4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59-A2EB-4566-9B46-DAC7DE36ADA2}"/>
              </c:ext>
            </c:extLst>
          </c:dPt>
          <c:dPt>
            <c:idx val="4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5B-A2EB-4566-9B46-DAC7DE36ADA2}"/>
              </c:ext>
            </c:extLst>
          </c:dPt>
          <c:dPt>
            <c:idx val="4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5D-A2EB-4566-9B46-DAC7DE36ADA2}"/>
              </c:ext>
            </c:extLst>
          </c:dPt>
          <c:dPt>
            <c:idx val="4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5F-A2EB-4566-9B46-DAC7DE36ADA2}"/>
              </c:ext>
            </c:extLst>
          </c:dPt>
          <c:dPt>
            <c:idx val="4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61-A2EB-4566-9B46-DAC7DE36ADA2}"/>
              </c:ext>
            </c:extLst>
          </c:dPt>
          <c:dPt>
            <c:idx val="4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63-A2EB-4566-9B46-DAC7DE36ADA2}"/>
              </c:ext>
            </c:extLst>
          </c:dPt>
          <c:dPt>
            <c:idx val="5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65-A2EB-4566-9B46-DAC7DE36ADA2}"/>
              </c:ext>
            </c:extLst>
          </c:dPt>
          <c:dPt>
            <c:idx val="5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67-A2EB-4566-9B46-DAC7DE36ADA2}"/>
              </c:ext>
            </c:extLst>
          </c:dPt>
          <c:dPt>
            <c:idx val="5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69-A2EB-4566-9B46-DAC7DE36ADA2}"/>
              </c:ext>
            </c:extLst>
          </c:dPt>
          <c:dPt>
            <c:idx val="5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6B-A2EB-4566-9B46-DAC7DE36ADA2}"/>
              </c:ext>
            </c:extLst>
          </c:dPt>
          <c:dPt>
            <c:idx val="5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6D-A2EB-4566-9B46-DAC7DE36ADA2}"/>
              </c:ext>
            </c:extLst>
          </c:dPt>
          <c:dPt>
            <c:idx val="5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6F-A2EB-4566-9B46-DAC7DE36ADA2}"/>
              </c:ext>
            </c:extLst>
          </c:dPt>
          <c:dPt>
            <c:idx val="5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71-A2EB-4566-9B46-DAC7DE36ADA2}"/>
              </c:ext>
            </c:extLst>
          </c:dPt>
          <c:dPt>
            <c:idx val="5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73-A2EB-4566-9B46-DAC7DE36ADA2}"/>
              </c:ext>
            </c:extLst>
          </c:dPt>
          <c:dPt>
            <c:idx val="5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75-A2EB-4566-9B46-DAC7DE36ADA2}"/>
              </c:ext>
            </c:extLst>
          </c:dPt>
          <c:dPt>
            <c:idx val="5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77-A2EB-4566-9B46-DAC7DE36ADA2}"/>
              </c:ext>
            </c:extLst>
          </c:dPt>
          <c:dPt>
            <c:idx val="6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79-A2EB-4566-9B46-DAC7DE36ADA2}"/>
              </c:ext>
            </c:extLst>
          </c:dPt>
          <c:dPt>
            <c:idx val="6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7B-A2EB-4566-9B46-DAC7DE36ADA2}"/>
              </c:ext>
            </c:extLst>
          </c:dPt>
          <c:dPt>
            <c:idx val="6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7D-A2EB-4566-9B46-DAC7DE36ADA2}"/>
              </c:ext>
            </c:extLst>
          </c:dPt>
          <c:dPt>
            <c:idx val="6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7F-A2EB-4566-9B46-DAC7DE36ADA2}"/>
              </c:ext>
            </c:extLst>
          </c:dPt>
          <c:dPt>
            <c:idx val="6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81-A2EB-4566-9B46-DAC7DE36ADA2}"/>
              </c:ext>
            </c:extLst>
          </c:dPt>
          <c:dPt>
            <c:idx val="6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83-A2EB-4566-9B46-DAC7DE36ADA2}"/>
              </c:ext>
            </c:extLst>
          </c:dPt>
          <c:dPt>
            <c:idx val="6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85-A2EB-4566-9B46-DAC7DE36ADA2}"/>
              </c:ext>
            </c:extLst>
          </c:dPt>
          <c:dPt>
            <c:idx val="6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87-A2EB-4566-9B46-DAC7DE36ADA2}"/>
              </c:ext>
            </c:extLst>
          </c:dPt>
          <c:dPt>
            <c:idx val="6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89-A2EB-4566-9B46-DAC7DE36ADA2}"/>
              </c:ext>
            </c:extLst>
          </c:dPt>
          <c:dPt>
            <c:idx val="6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8B-A2EB-4566-9B46-DAC7DE36ADA2}"/>
              </c:ext>
            </c:extLst>
          </c:dPt>
          <c:dPt>
            <c:idx val="7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8D-A2EB-4566-9B46-DAC7DE36ADA2}"/>
              </c:ext>
            </c:extLst>
          </c:dPt>
          <c:dPt>
            <c:idx val="7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8F-A2EB-4566-9B46-DAC7DE36ADA2}"/>
              </c:ext>
            </c:extLst>
          </c:dPt>
          <c:dPt>
            <c:idx val="7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91-A2EB-4566-9B46-DAC7DE36ADA2}"/>
              </c:ext>
            </c:extLst>
          </c:dPt>
          <c:dPt>
            <c:idx val="7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93-A2EB-4566-9B46-DAC7DE36ADA2}"/>
              </c:ext>
            </c:extLst>
          </c:dPt>
          <c:dPt>
            <c:idx val="7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95-A2EB-4566-9B46-DAC7DE36ADA2}"/>
              </c:ext>
            </c:extLst>
          </c:dPt>
          <c:dPt>
            <c:idx val="7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97-A2EB-4566-9B46-DAC7DE36ADA2}"/>
              </c:ext>
            </c:extLst>
          </c:dPt>
          <c:dPt>
            <c:idx val="7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99-A2EB-4566-9B46-DAC7DE36ADA2}"/>
              </c:ext>
            </c:extLst>
          </c:dPt>
          <c:dPt>
            <c:idx val="7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9B-A2EB-4566-9B46-DAC7DE36ADA2}"/>
              </c:ext>
            </c:extLst>
          </c:dPt>
          <c:dPt>
            <c:idx val="7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9D-A2EB-4566-9B46-DAC7DE36ADA2}"/>
              </c:ext>
            </c:extLst>
          </c:dPt>
          <c:dPt>
            <c:idx val="7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9F-A2EB-4566-9B46-DAC7DE36ADA2}"/>
              </c:ext>
            </c:extLst>
          </c:dPt>
          <c:dPt>
            <c:idx val="8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A1-A2EB-4566-9B46-DAC7DE36ADA2}"/>
              </c:ext>
            </c:extLst>
          </c:dPt>
          <c:dPt>
            <c:idx val="8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A3-A2EB-4566-9B46-DAC7DE36ADA2}"/>
              </c:ext>
            </c:extLst>
          </c:dPt>
          <c:dPt>
            <c:idx val="8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A5-A2EB-4566-9B46-DAC7DE36ADA2}"/>
              </c:ext>
            </c:extLst>
          </c:dPt>
          <c:dPt>
            <c:idx val="8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A7-A2EB-4566-9B46-DAC7DE36ADA2}"/>
              </c:ext>
            </c:extLst>
          </c:dPt>
          <c:dPt>
            <c:idx val="8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A9-A2EB-4566-9B46-DAC7DE36ADA2}"/>
              </c:ext>
            </c:extLst>
          </c:dPt>
          <c:dPt>
            <c:idx val="8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AB-A2EB-4566-9B46-DAC7DE36ADA2}"/>
              </c:ext>
            </c:extLst>
          </c:dPt>
          <c:dPt>
            <c:idx val="8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AD-A2EB-4566-9B46-DAC7DE36ADA2}"/>
              </c:ext>
            </c:extLst>
          </c:dPt>
          <c:dPt>
            <c:idx val="8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AF-A2EB-4566-9B46-DAC7DE36ADA2}"/>
              </c:ext>
            </c:extLst>
          </c:dPt>
          <c:dPt>
            <c:idx val="8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B1-A2EB-4566-9B46-DAC7DE36ADA2}"/>
              </c:ext>
            </c:extLst>
          </c:dPt>
          <c:dPt>
            <c:idx val="8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B3-A2EB-4566-9B46-DAC7DE36ADA2}"/>
              </c:ext>
            </c:extLst>
          </c:dPt>
          <c:dPt>
            <c:idx val="9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B5-A2EB-4566-9B46-DAC7DE36ADA2}"/>
              </c:ext>
            </c:extLst>
          </c:dPt>
          <c:dPt>
            <c:idx val="9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B7-A2EB-4566-9B46-DAC7DE36ADA2}"/>
              </c:ext>
            </c:extLst>
          </c:dPt>
          <c:dPt>
            <c:idx val="9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B9-A2EB-4566-9B46-DAC7DE36ADA2}"/>
              </c:ext>
            </c:extLst>
          </c:dPt>
          <c:dPt>
            <c:idx val="9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BB-A2EB-4566-9B46-DAC7DE36ADA2}"/>
              </c:ext>
            </c:extLst>
          </c:dPt>
          <c:dPt>
            <c:idx val="9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BD-A2EB-4566-9B46-DAC7DE36ADA2}"/>
              </c:ext>
            </c:extLst>
          </c:dPt>
          <c:dPt>
            <c:idx val="9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BF-A2EB-4566-9B46-DAC7DE36ADA2}"/>
              </c:ext>
            </c:extLst>
          </c:dPt>
          <c:dPt>
            <c:idx val="9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C1-A2EB-4566-9B46-DAC7DE36ADA2}"/>
              </c:ext>
            </c:extLst>
          </c:dPt>
          <c:dPt>
            <c:idx val="9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C3-A2EB-4566-9B46-DAC7DE36ADA2}"/>
              </c:ext>
            </c:extLst>
          </c:dPt>
          <c:dPt>
            <c:idx val="9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C5-A2EB-4566-9B46-DAC7DE36ADA2}"/>
              </c:ext>
            </c:extLst>
          </c:dPt>
          <c:dPt>
            <c:idx val="9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C7-A2EB-4566-9B46-DAC7DE36ADA2}"/>
              </c:ext>
            </c:extLst>
          </c:dPt>
          <c:dPt>
            <c:idx val="10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C9-A2EB-4566-9B46-DAC7DE36ADA2}"/>
              </c:ext>
            </c:extLst>
          </c:dPt>
          <c:dPt>
            <c:idx val="10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CB-A2EB-4566-9B46-DAC7DE36ADA2}"/>
              </c:ext>
            </c:extLst>
          </c:dPt>
          <c:dPt>
            <c:idx val="10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CD-A2EB-4566-9B46-DAC7DE36ADA2}"/>
              </c:ext>
            </c:extLst>
          </c:dPt>
          <c:dPt>
            <c:idx val="10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CF-A2EB-4566-9B46-DAC7DE36ADA2}"/>
              </c:ext>
            </c:extLst>
          </c:dPt>
          <c:dPt>
            <c:idx val="10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D1-A2EB-4566-9B46-DAC7DE36ADA2}"/>
              </c:ext>
            </c:extLst>
          </c:dPt>
          <c:dPt>
            <c:idx val="10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D3-A2EB-4566-9B46-DAC7DE36ADA2}"/>
              </c:ext>
            </c:extLst>
          </c:dPt>
          <c:dPt>
            <c:idx val="10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D5-A2EB-4566-9B46-DAC7DE36ADA2}"/>
              </c:ext>
            </c:extLst>
          </c:dPt>
          <c:dPt>
            <c:idx val="10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D7-A2EB-4566-9B46-DAC7DE36ADA2}"/>
              </c:ext>
            </c:extLst>
          </c:dPt>
          <c:dPt>
            <c:idx val="10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D9-A2EB-4566-9B46-DAC7DE36ADA2}"/>
              </c:ext>
            </c:extLst>
          </c:dPt>
          <c:dPt>
            <c:idx val="10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DB-A2EB-4566-9B46-DAC7DE36ADA2}"/>
              </c:ext>
            </c:extLst>
          </c:dPt>
          <c:dPt>
            <c:idx val="11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DD-A2EB-4566-9B46-DAC7DE36ADA2}"/>
              </c:ext>
            </c:extLst>
          </c:dPt>
          <c:dPt>
            <c:idx val="11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DF-A2EB-4566-9B46-DAC7DE36ADA2}"/>
              </c:ext>
            </c:extLst>
          </c:dPt>
          <c:dPt>
            <c:idx val="11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E1-A2EB-4566-9B46-DAC7DE36ADA2}"/>
              </c:ext>
            </c:extLst>
          </c:dPt>
          <c:dPt>
            <c:idx val="11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E3-A2EB-4566-9B46-DAC7DE36ADA2}"/>
              </c:ext>
            </c:extLst>
          </c:dPt>
          <c:dPt>
            <c:idx val="11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E5-A2EB-4566-9B46-DAC7DE36ADA2}"/>
              </c:ext>
            </c:extLst>
          </c:dPt>
          <c:dPt>
            <c:idx val="11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E7-A2EB-4566-9B46-DAC7DE36ADA2}"/>
              </c:ext>
            </c:extLst>
          </c:dPt>
          <c:dPt>
            <c:idx val="11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E9-A2EB-4566-9B46-DAC7DE36ADA2}"/>
              </c:ext>
            </c:extLst>
          </c:dPt>
          <c:dPt>
            <c:idx val="11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EB-A2EB-4566-9B46-DAC7DE36ADA2}"/>
              </c:ext>
            </c:extLst>
          </c:dPt>
          <c:dPt>
            <c:idx val="11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ED-A2EB-4566-9B46-DAC7DE36ADA2}"/>
              </c:ext>
            </c:extLst>
          </c:dPt>
          <c:dPt>
            <c:idx val="11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EF-A2EB-4566-9B46-DAC7DE36ADA2}"/>
              </c:ext>
            </c:extLst>
          </c:dPt>
          <c:dPt>
            <c:idx val="12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F1-A2EB-4566-9B46-DAC7DE36ADA2}"/>
              </c:ext>
            </c:extLst>
          </c:dPt>
          <c:dPt>
            <c:idx val="12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F3-A2EB-4566-9B46-DAC7DE36ADA2}"/>
              </c:ext>
            </c:extLst>
          </c:dPt>
          <c:dPt>
            <c:idx val="12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F5-A2EB-4566-9B46-DAC7DE36ADA2}"/>
              </c:ext>
            </c:extLst>
          </c:dPt>
          <c:dPt>
            <c:idx val="12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F7-A2EB-4566-9B46-DAC7DE36ADA2}"/>
              </c:ext>
            </c:extLst>
          </c:dPt>
          <c:dPt>
            <c:idx val="12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F9-A2EB-4566-9B46-DAC7DE36ADA2}"/>
              </c:ext>
            </c:extLst>
          </c:dPt>
          <c:dPt>
            <c:idx val="12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FB-A2EB-4566-9B46-DAC7DE36ADA2}"/>
              </c:ext>
            </c:extLst>
          </c:dPt>
          <c:dPt>
            <c:idx val="12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FD-A2EB-4566-9B46-DAC7DE36ADA2}"/>
              </c:ext>
            </c:extLst>
          </c:dPt>
          <c:dPt>
            <c:idx val="12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0FF-A2EB-4566-9B46-DAC7DE36ADA2}"/>
              </c:ext>
            </c:extLst>
          </c:dPt>
          <c:dPt>
            <c:idx val="12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01-A2EB-4566-9B46-DAC7DE36ADA2}"/>
              </c:ext>
            </c:extLst>
          </c:dPt>
          <c:dPt>
            <c:idx val="12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03-A2EB-4566-9B46-DAC7DE36ADA2}"/>
              </c:ext>
            </c:extLst>
          </c:dPt>
          <c:dPt>
            <c:idx val="13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05-A2EB-4566-9B46-DAC7DE36ADA2}"/>
              </c:ext>
            </c:extLst>
          </c:dPt>
          <c:dPt>
            <c:idx val="13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07-A2EB-4566-9B46-DAC7DE36ADA2}"/>
              </c:ext>
            </c:extLst>
          </c:dPt>
          <c:dPt>
            <c:idx val="13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09-A2EB-4566-9B46-DAC7DE36ADA2}"/>
              </c:ext>
            </c:extLst>
          </c:dPt>
          <c:dPt>
            <c:idx val="13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0B-A2EB-4566-9B46-DAC7DE36ADA2}"/>
              </c:ext>
            </c:extLst>
          </c:dPt>
          <c:dPt>
            <c:idx val="13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0D-A2EB-4566-9B46-DAC7DE36ADA2}"/>
              </c:ext>
            </c:extLst>
          </c:dPt>
          <c:dPt>
            <c:idx val="13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0F-A2EB-4566-9B46-DAC7DE36ADA2}"/>
              </c:ext>
            </c:extLst>
          </c:dPt>
          <c:dPt>
            <c:idx val="13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11-A2EB-4566-9B46-DAC7DE36ADA2}"/>
              </c:ext>
            </c:extLst>
          </c:dPt>
          <c:dPt>
            <c:idx val="13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13-A2EB-4566-9B46-DAC7DE36ADA2}"/>
              </c:ext>
            </c:extLst>
          </c:dPt>
          <c:dPt>
            <c:idx val="13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15-A2EB-4566-9B46-DAC7DE36ADA2}"/>
              </c:ext>
            </c:extLst>
          </c:dPt>
          <c:dPt>
            <c:idx val="13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17-A2EB-4566-9B46-DAC7DE36ADA2}"/>
              </c:ext>
            </c:extLst>
          </c:dPt>
          <c:dPt>
            <c:idx val="14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19-A2EB-4566-9B46-DAC7DE36ADA2}"/>
              </c:ext>
            </c:extLst>
          </c:dPt>
          <c:dPt>
            <c:idx val="14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1B-A2EB-4566-9B46-DAC7DE36ADA2}"/>
              </c:ext>
            </c:extLst>
          </c:dPt>
          <c:dPt>
            <c:idx val="14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1D-A2EB-4566-9B46-DAC7DE36ADA2}"/>
              </c:ext>
            </c:extLst>
          </c:dPt>
          <c:dPt>
            <c:idx val="14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1F-A2EB-4566-9B46-DAC7DE36ADA2}"/>
              </c:ext>
            </c:extLst>
          </c:dPt>
          <c:dPt>
            <c:idx val="14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21-A2EB-4566-9B46-DAC7DE36ADA2}"/>
              </c:ext>
            </c:extLst>
          </c:dPt>
          <c:dPt>
            <c:idx val="14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23-A2EB-4566-9B46-DAC7DE36ADA2}"/>
              </c:ext>
            </c:extLst>
          </c:dPt>
          <c:dPt>
            <c:idx val="14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25-A2EB-4566-9B46-DAC7DE36ADA2}"/>
              </c:ext>
            </c:extLst>
          </c:dPt>
          <c:dPt>
            <c:idx val="14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27-A2EB-4566-9B46-DAC7DE36ADA2}"/>
              </c:ext>
            </c:extLst>
          </c:dPt>
          <c:dPt>
            <c:idx val="14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29-A2EB-4566-9B46-DAC7DE36ADA2}"/>
              </c:ext>
            </c:extLst>
          </c:dPt>
          <c:dPt>
            <c:idx val="14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2B-A2EB-4566-9B46-DAC7DE36ADA2}"/>
              </c:ext>
            </c:extLst>
          </c:dPt>
          <c:dPt>
            <c:idx val="15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2D-A2EB-4566-9B46-DAC7DE36ADA2}"/>
              </c:ext>
            </c:extLst>
          </c:dPt>
          <c:dPt>
            <c:idx val="15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2F-A2EB-4566-9B46-DAC7DE36ADA2}"/>
              </c:ext>
            </c:extLst>
          </c:dPt>
          <c:dPt>
            <c:idx val="15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31-A2EB-4566-9B46-DAC7DE36ADA2}"/>
              </c:ext>
            </c:extLst>
          </c:dPt>
          <c:dPt>
            <c:idx val="15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33-A2EB-4566-9B46-DAC7DE36ADA2}"/>
              </c:ext>
            </c:extLst>
          </c:dPt>
          <c:dPt>
            <c:idx val="15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35-A2EB-4566-9B46-DAC7DE36ADA2}"/>
              </c:ext>
            </c:extLst>
          </c:dPt>
          <c:dPt>
            <c:idx val="15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37-A2EB-4566-9B46-DAC7DE36ADA2}"/>
              </c:ext>
            </c:extLst>
          </c:dPt>
          <c:dPt>
            <c:idx val="15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39-A2EB-4566-9B46-DAC7DE36ADA2}"/>
              </c:ext>
            </c:extLst>
          </c:dPt>
          <c:dPt>
            <c:idx val="15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3B-A2EB-4566-9B46-DAC7DE36ADA2}"/>
              </c:ext>
            </c:extLst>
          </c:dPt>
          <c:dPt>
            <c:idx val="15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3D-A2EB-4566-9B46-DAC7DE36ADA2}"/>
              </c:ext>
            </c:extLst>
          </c:dPt>
          <c:dPt>
            <c:idx val="15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3F-A2EB-4566-9B46-DAC7DE36ADA2}"/>
              </c:ext>
            </c:extLst>
          </c:dPt>
          <c:dPt>
            <c:idx val="16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41-A2EB-4566-9B46-DAC7DE36ADA2}"/>
              </c:ext>
            </c:extLst>
          </c:dPt>
          <c:dPt>
            <c:idx val="16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43-A2EB-4566-9B46-DAC7DE36ADA2}"/>
              </c:ext>
            </c:extLst>
          </c:dPt>
          <c:dPt>
            <c:idx val="16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45-A2EB-4566-9B46-DAC7DE36ADA2}"/>
              </c:ext>
            </c:extLst>
          </c:dPt>
          <c:dPt>
            <c:idx val="16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47-A2EB-4566-9B46-DAC7DE36ADA2}"/>
              </c:ext>
            </c:extLst>
          </c:dPt>
          <c:dPt>
            <c:idx val="16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49-A2EB-4566-9B46-DAC7DE36ADA2}"/>
              </c:ext>
            </c:extLst>
          </c:dPt>
          <c:dPt>
            <c:idx val="16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4B-A2EB-4566-9B46-DAC7DE36ADA2}"/>
              </c:ext>
            </c:extLst>
          </c:dPt>
          <c:dPt>
            <c:idx val="16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4D-A2EB-4566-9B46-DAC7DE36ADA2}"/>
              </c:ext>
            </c:extLst>
          </c:dPt>
          <c:dPt>
            <c:idx val="16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4F-A2EB-4566-9B46-DAC7DE36ADA2}"/>
              </c:ext>
            </c:extLst>
          </c:dPt>
          <c:dPt>
            <c:idx val="16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51-A2EB-4566-9B46-DAC7DE36ADA2}"/>
              </c:ext>
            </c:extLst>
          </c:dPt>
          <c:dPt>
            <c:idx val="16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53-A2EB-4566-9B46-DAC7DE36ADA2}"/>
              </c:ext>
            </c:extLst>
          </c:dPt>
          <c:dPt>
            <c:idx val="17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55-A2EB-4566-9B46-DAC7DE36ADA2}"/>
              </c:ext>
            </c:extLst>
          </c:dPt>
          <c:dPt>
            <c:idx val="17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57-A2EB-4566-9B46-DAC7DE36ADA2}"/>
              </c:ext>
            </c:extLst>
          </c:dPt>
          <c:dPt>
            <c:idx val="17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59-A2EB-4566-9B46-DAC7DE36ADA2}"/>
              </c:ext>
            </c:extLst>
          </c:dPt>
          <c:dPt>
            <c:idx val="17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5B-A2EB-4566-9B46-DAC7DE36ADA2}"/>
              </c:ext>
            </c:extLst>
          </c:dPt>
          <c:dPt>
            <c:idx val="17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5D-A2EB-4566-9B46-DAC7DE36ADA2}"/>
              </c:ext>
            </c:extLst>
          </c:dPt>
          <c:dPt>
            <c:idx val="17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5F-A2EB-4566-9B46-DAC7DE36ADA2}"/>
              </c:ext>
            </c:extLst>
          </c:dPt>
          <c:dPt>
            <c:idx val="17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61-A2EB-4566-9B46-DAC7DE36ADA2}"/>
              </c:ext>
            </c:extLst>
          </c:dPt>
          <c:dPt>
            <c:idx val="178"/>
            <c:invertIfNegative val="0"/>
            <c:bubble3D val="0"/>
            <c:spPr>
              <a:solidFill>
                <a:srgbClr val="0064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63-A2EB-4566-9B46-DAC7DE36ADA2}"/>
              </c:ext>
            </c:extLst>
          </c:dPt>
          <c:dPt>
            <c:idx val="17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65-A2EB-4566-9B46-DAC7DE36ADA2}"/>
              </c:ext>
            </c:extLst>
          </c:dPt>
          <c:dPt>
            <c:idx val="180"/>
            <c:invertIfNegative val="0"/>
            <c:bubble3D val="0"/>
            <c:spPr>
              <a:solidFill>
                <a:srgbClr val="C8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67-A2EB-4566-9B46-DAC7DE36ADA2}"/>
              </c:ext>
            </c:extLst>
          </c:dPt>
          <c:dPt>
            <c:idx val="18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69-A2EB-4566-9B46-DAC7DE36ADA2}"/>
              </c:ext>
            </c:extLst>
          </c:dPt>
          <c:dPt>
            <c:idx val="18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6B-A2EB-4566-9B46-DAC7DE36ADA2}"/>
              </c:ext>
            </c:extLst>
          </c:dPt>
          <c:dPt>
            <c:idx val="18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6D-A2EB-4566-9B46-DAC7DE36ADA2}"/>
              </c:ext>
            </c:extLst>
          </c:dPt>
          <c:dPt>
            <c:idx val="18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6F-A2EB-4566-9B46-DAC7DE36ADA2}"/>
              </c:ext>
            </c:extLst>
          </c:dPt>
          <c:dPt>
            <c:idx val="18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71-A2EB-4566-9B46-DAC7DE36ADA2}"/>
              </c:ext>
            </c:extLst>
          </c:dPt>
          <c:dPt>
            <c:idx val="18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73-A2EB-4566-9B46-DAC7DE36ADA2}"/>
              </c:ext>
            </c:extLst>
          </c:dPt>
          <c:dPt>
            <c:idx val="187"/>
            <c:invertIfNegative val="0"/>
            <c:bubble3D val="0"/>
            <c:spPr>
              <a:solidFill>
                <a:srgbClr val="0046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75-A2EB-4566-9B46-DAC7DE36ADA2}"/>
              </c:ext>
            </c:extLst>
          </c:dPt>
          <c:dPt>
            <c:idx val="188"/>
            <c:invertIfNegative val="0"/>
            <c:bubble3D val="0"/>
            <c:spPr>
              <a:solidFill>
                <a:srgbClr val="96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77-A2EB-4566-9B46-DAC7DE36ADA2}"/>
              </c:ext>
            </c:extLst>
          </c:dPt>
          <c:dPt>
            <c:idx val="189"/>
            <c:invertIfNegative val="0"/>
            <c:bubble3D val="0"/>
            <c:spPr>
              <a:solidFill>
                <a:srgbClr val="46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79-A2EB-4566-9B46-DAC7DE36ADA2}"/>
              </c:ext>
            </c:extLst>
          </c:dPt>
          <c:dPt>
            <c:idx val="190"/>
            <c:invertIfNegative val="0"/>
            <c:bubble3D val="0"/>
            <c:spPr>
              <a:solidFill>
                <a:srgbClr val="64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7B-A2EB-4566-9B46-DAC7DE36ADA2}"/>
              </c:ext>
            </c:extLst>
          </c:dPt>
          <c:dPt>
            <c:idx val="191"/>
            <c:invertIfNegative val="0"/>
            <c:bubble3D val="0"/>
            <c:spPr>
              <a:solidFill>
                <a:srgbClr val="C8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7D-A2EB-4566-9B46-DAC7DE36ADA2}"/>
              </c:ext>
            </c:extLst>
          </c:dPt>
          <c:dPt>
            <c:idx val="19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7F-A2EB-4566-9B46-DAC7DE36ADA2}"/>
              </c:ext>
            </c:extLst>
          </c:dPt>
          <c:dPt>
            <c:idx val="19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81-A2EB-4566-9B46-DAC7DE36ADA2}"/>
              </c:ext>
            </c:extLst>
          </c:dPt>
          <c:dPt>
            <c:idx val="19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83-A2EB-4566-9B46-DAC7DE36ADA2}"/>
              </c:ext>
            </c:extLst>
          </c:dPt>
          <c:dPt>
            <c:idx val="19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85-A2EB-4566-9B46-DAC7DE36ADA2}"/>
              </c:ext>
            </c:extLst>
          </c:dPt>
          <c:dPt>
            <c:idx val="19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87-A2EB-4566-9B46-DAC7DE36ADA2}"/>
              </c:ext>
            </c:extLst>
          </c:dPt>
          <c:dPt>
            <c:idx val="19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89-A2EB-4566-9B46-DAC7DE36ADA2}"/>
              </c:ext>
            </c:extLst>
          </c:dPt>
          <c:dPt>
            <c:idx val="19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8B-A2EB-4566-9B46-DAC7DE36ADA2}"/>
              </c:ext>
            </c:extLst>
          </c:dPt>
          <c:dPt>
            <c:idx val="19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8D-A2EB-4566-9B46-DAC7DE36ADA2}"/>
              </c:ext>
            </c:extLst>
          </c:dPt>
          <c:dPt>
            <c:idx val="20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8F-A2EB-4566-9B46-DAC7DE36ADA2}"/>
              </c:ext>
            </c:extLst>
          </c:dPt>
          <c:dPt>
            <c:idx val="20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91-A2EB-4566-9B46-DAC7DE36ADA2}"/>
              </c:ext>
            </c:extLst>
          </c:dPt>
          <c:dPt>
            <c:idx val="20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93-A2EB-4566-9B46-DAC7DE36ADA2}"/>
              </c:ext>
            </c:extLst>
          </c:dPt>
          <c:dPt>
            <c:idx val="20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95-A2EB-4566-9B46-DAC7DE36ADA2}"/>
              </c:ext>
            </c:extLst>
          </c:dPt>
          <c:dPt>
            <c:idx val="20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97-A2EB-4566-9B46-DAC7DE36ADA2}"/>
              </c:ext>
            </c:extLst>
          </c:dPt>
          <c:dPt>
            <c:idx val="20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99-A2EB-4566-9B46-DAC7DE36ADA2}"/>
              </c:ext>
            </c:extLst>
          </c:dPt>
          <c:dPt>
            <c:idx val="20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9B-A2EB-4566-9B46-DAC7DE36ADA2}"/>
              </c:ext>
            </c:extLst>
          </c:dPt>
          <c:dPt>
            <c:idx val="20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9D-A2EB-4566-9B46-DAC7DE36ADA2}"/>
              </c:ext>
            </c:extLst>
          </c:dPt>
          <c:dPt>
            <c:idx val="20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9F-A2EB-4566-9B46-DAC7DE36ADA2}"/>
              </c:ext>
            </c:extLst>
          </c:dPt>
          <c:dPt>
            <c:idx val="20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A1-A2EB-4566-9B46-DAC7DE36ADA2}"/>
              </c:ext>
            </c:extLst>
          </c:dPt>
          <c:dPt>
            <c:idx val="21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A3-A2EB-4566-9B46-DAC7DE36ADA2}"/>
              </c:ext>
            </c:extLst>
          </c:dPt>
          <c:dPt>
            <c:idx val="21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A5-A2EB-4566-9B46-DAC7DE36ADA2}"/>
              </c:ext>
            </c:extLst>
          </c:dPt>
          <c:dPt>
            <c:idx val="21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A7-A2EB-4566-9B46-DAC7DE36ADA2}"/>
              </c:ext>
            </c:extLst>
          </c:dPt>
          <c:dPt>
            <c:idx val="21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A9-A2EB-4566-9B46-DAC7DE36ADA2}"/>
              </c:ext>
            </c:extLst>
          </c:dPt>
          <c:dPt>
            <c:idx val="21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AB-A2EB-4566-9B46-DAC7DE36ADA2}"/>
              </c:ext>
            </c:extLst>
          </c:dPt>
          <c:dPt>
            <c:idx val="21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AD-A2EB-4566-9B46-DAC7DE36ADA2}"/>
              </c:ext>
            </c:extLst>
          </c:dPt>
          <c:dPt>
            <c:idx val="21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AF-A2EB-4566-9B46-DAC7DE36ADA2}"/>
              </c:ext>
            </c:extLst>
          </c:dPt>
          <c:dPt>
            <c:idx val="21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B1-A2EB-4566-9B46-DAC7DE36ADA2}"/>
              </c:ext>
            </c:extLst>
          </c:dPt>
          <c:dPt>
            <c:idx val="21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B3-A2EB-4566-9B46-DAC7DE36ADA2}"/>
              </c:ext>
            </c:extLst>
          </c:dPt>
          <c:dPt>
            <c:idx val="21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B5-A2EB-4566-9B46-DAC7DE36ADA2}"/>
              </c:ext>
            </c:extLst>
          </c:dPt>
          <c:dPt>
            <c:idx val="22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B7-A2EB-4566-9B46-DAC7DE36ADA2}"/>
              </c:ext>
            </c:extLst>
          </c:dPt>
          <c:dPt>
            <c:idx val="22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B9-A2EB-4566-9B46-DAC7DE36ADA2}"/>
              </c:ext>
            </c:extLst>
          </c:dPt>
          <c:dPt>
            <c:idx val="22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BB-A2EB-4566-9B46-DAC7DE36ADA2}"/>
              </c:ext>
            </c:extLst>
          </c:dPt>
          <c:dPt>
            <c:idx val="22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BD-A2EB-4566-9B46-DAC7DE36ADA2}"/>
              </c:ext>
            </c:extLst>
          </c:dPt>
          <c:dPt>
            <c:idx val="22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BF-A2EB-4566-9B46-DAC7DE36ADA2}"/>
              </c:ext>
            </c:extLst>
          </c:dPt>
          <c:dPt>
            <c:idx val="22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C1-A2EB-4566-9B46-DAC7DE36ADA2}"/>
              </c:ext>
            </c:extLst>
          </c:dPt>
          <c:dPt>
            <c:idx val="22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C3-A2EB-4566-9B46-DAC7DE36ADA2}"/>
              </c:ext>
            </c:extLst>
          </c:dPt>
          <c:dPt>
            <c:idx val="22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C5-A2EB-4566-9B46-DAC7DE36ADA2}"/>
              </c:ext>
            </c:extLst>
          </c:dPt>
          <c:dPt>
            <c:idx val="22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C7-A2EB-4566-9B46-DAC7DE36ADA2}"/>
              </c:ext>
            </c:extLst>
          </c:dPt>
          <c:dPt>
            <c:idx val="22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C9-A2EB-4566-9B46-DAC7DE36ADA2}"/>
              </c:ext>
            </c:extLst>
          </c:dPt>
          <c:dPt>
            <c:idx val="23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CB-A2EB-4566-9B46-DAC7DE36ADA2}"/>
              </c:ext>
            </c:extLst>
          </c:dPt>
          <c:dPt>
            <c:idx val="23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CD-A2EB-4566-9B46-DAC7DE36ADA2}"/>
              </c:ext>
            </c:extLst>
          </c:dPt>
          <c:dPt>
            <c:idx val="23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CF-A2EB-4566-9B46-DAC7DE36ADA2}"/>
              </c:ext>
            </c:extLst>
          </c:dPt>
          <c:dPt>
            <c:idx val="23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D1-A2EB-4566-9B46-DAC7DE36ADA2}"/>
              </c:ext>
            </c:extLst>
          </c:dPt>
          <c:dPt>
            <c:idx val="23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D3-A2EB-4566-9B46-DAC7DE36ADA2}"/>
              </c:ext>
            </c:extLst>
          </c:dPt>
          <c:dPt>
            <c:idx val="23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D5-A2EB-4566-9B46-DAC7DE36ADA2}"/>
              </c:ext>
            </c:extLst>
          </c:dPt>
          <c:dPt>
            <c:idx val="23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D7-A2EB-4566-9B46-DAC7DE36ADA2}"/>
              </c:ext>
            </c:extLst>
          </c:dPt>
          <c:dPt>
            <c:idx val="23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D9-A2EB-4566-9B46-DAC7DE36ADA2}"/>
              </c:ext>
            </c:extLst>
          </c:dPt>
          <c:dPt>
            <c:idx val="23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DB-A2EB-4566-9B46-DAC7DE36ADA2}"/>
              </c:ext>
            </c:extLst>
          </c:dPt>
          <c:dPt>
            <c:idx val="23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DD-A2EB-4566-9B46-DAC7DE36ADA2}"/>
              </c:ext>
            </c:extLst>
          </c:dPt>
          <c:dPt>
            <c:idx val="24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DF-A2EB-4566-9B46-DAC7DE36ADA2}"/>
              </c:ext>
            </c:extLst>
          </c:dPt>
          <c:dPt>
            <c:idx val="24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E1-A2EB-4566-9B46-DAC7DE36ADA2}"/>
              </c:ext>
            </c:extLst>
          </c:dPt>
          <c:dPt>
            <c:idx val="24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E3-A2EB-4566-9B46-DAC7DE36ADA2}"/>
              </c:ext>
            </c:extLst>
          </c:dPt>
          <c:dPt>
            <c:idx val="24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E5-A2EB-4566-9B46-DAC7DE36ADA2}"/>
              </c:ext>
            </c:extLst>
          </c:dPt>
          <c:dPt>
            <c:idx val="24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E7-A2EB-4566-9B46-DAC7DE36ADA2}"/>
              </c:ext>
            </c:extLst>
          </c:dPt>
          <c:dPt>
            <c:idx val="24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E9-A2EB-4566-9B46-DAC7DE36ADA2}"/>
              </c:ext>
            </c:extLst>
          </c:dPt>
          <c:dPt>
            <c:idx val="24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EB-A2EB-4566-9B46-DAC7DE36ADA2}"/>
              </c:ext>
            </c:extLst>
          </c:dPt>
          <c:dPt>
            <c:idx val="247"/>
            <c:invertIfNegative val="0"/>
            <c:bubble3D val="0"/>
            <c:spPr>
              <a:solidFill>
                <a:srgbClr val="0064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ED-A2EB-4566-9B46-DAC7DE36ADA2}"/>
              </c:ext>
            </c:extLst>
          </c:dPt>
          <c:dPt>
            <c:idx val="24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EF-A2EB-4566-9B46-DAC7DE36ADA2}"/>
              </c:ext>
            </c:extLst>
          </c:dPt>
          <c:dPt>
            <c:idx val="24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F1-A2EB-4566-9B46-DAC7DE36ADA2}"/>
              </c:ext>
            </c:extLst>
          </c:dPt>
          <c:dPt>
            <c:idx val="25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F3-A2EB-4566-9B46-DAC7DE36ADA2}"/>
              </c:ext>
            </c:extLst>
          </c:dPt>
          <c:dPt>
            <c:idx val="25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F5-A2EB-4566-9B46-DAC7DE36ADA2}"/>
              </c:ext>
            </c:extLst>
          </c:dPt>
          <c:dPt>
            <c:idx val="25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F7-A2EB-4566-9B46-DAC7DE36ADA2}"/>
              </c:ext>
            </c:extLst>
          </c:dPt>
          <c:dPt>
            <c:idx val="25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F9-A2EB-4566-9B46-DAC7DE36ADA2}"/>
              </c:ext>
            </c:extLst>
          </c:dPt>
          <c:dPt>
            <c:idx val="25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FB-A2EB-4566-9B46-DAC7DE36ADA2}"/>
              </c:ext>
            </c:extLst>
          </c:dPt>
          <c:dPt>
            <c:idx val="25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FD-A2EB-4566-9B46-DAC7DE36ADA2}"/>
              </c:ext>
            </c:extLst>
          </c:dPt>
          <c:dPt>
            <c:idx val="25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1FF-A2EB-4566-9B46-DAC7DE36ADA2}"/>
              </c:ext>
            </c:extLst>
          </c:dPt>
          <c:dPt>
            <c:idx val="25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01-A2EB-4566-9B46-DAC7DE36ADA2}"/>
              </c:ext>
            </c:extLst>
          </c:dPt>
          <c:dPt>
            <c:idx val="25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03-A2EB-4566-9B46-DAC7DE36ADA2}"/>
              </c:ext>
            </c:extLst>
          </c:dPt>
          <c:dPt>
            <c:idx val="25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05-A2EB-4566-9B46-DAC7DE36ADA2}"/>
              </c:ext>
            </c:extLst>
          </c:dPt>
          <c:dPt>
            <c:idx val="26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07-A2EB-4566-9B46-DAC7DE36ADA2}"/>
              </c:ext>
            </c:extLst>
          </c:dPt>
          <c:dPt>
            <c:idx val="26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09-A2EB-4566-9B46-DAC7DE36ADA2}"/>
              </c:ext>
            </c:extLst>
          </c:dPt>
          <c:dPt>
            <c:idx val="26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0B-A2EB-4566-9B46-DAC7DE36ADA2}"/>
              </c:ext>
            </c:extLst>
          </c:dPt>
          <c:dPt>
            <c:idx val="26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0D-A2EB-4566-9B46-DAC7DE36ADA2}"/>
              </c:ext>
            </c:extLst>
          </c:dPt>
          <c:dPt>
            <c:idx val="26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0F-A2EB-4566-9B46-DAC7DE36ADA2}"/>
              </c:ext>
            </c:extLst>
          </c:dPt>
          <c:dPt>
            <c:idx val="26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11-A2EB-4566-9B46-DAC7DE36ADA2}"/>
              </c:ext>
            </c:extLst>
          </c:dPt>
          <c:dPt>
            <c:idx val="26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13-A2EB-4566-9B46-DAC7DE36ADA2}"/>
              </c:ext>
            </c:extLst>
          </c:dPt>
          <c:dPt>
            <c:idx val="26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15-A2EB-4566-9B46-DAC7DE36ADA2}"/>
              </c:ext>
            </c:extLst>
          </c:dPt>
          <c:dPt>
            <c:idx val="26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17-A2EB-4566-9B46-DAC7DE36ADA2}"/>
              </c:ext>
            </c:extLst>
          </c:dPt>
          <c:dPt>
            <c:idx val="26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19-A2EB-4566-9B46-DAC7DE36ADA2}"/>
              </c:ext>
            </c:extLst>
          </c:dPt>
          <c:dPt>
            <c:idx val="27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1B-A2EB-4566-9B46-DAC7DE36ADA2}"/>
              </c:ext>
            </c:extLst>
          </c:dPt>
          <c:dPt>
            <c:idx val="27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1D-A2EB-4566-9B46-DAC7DE36ADA2}"/>
              </c:ext>
            </c:extLst>
          </c:dPt>
          <c:dPt>
            <c:idx val="27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1F-A2EB-4566-9B46-DAC7DE36ADA2}"/>
              </c:ext>
            </c:extLst>
          </c:dPt>
          <c:dPt>
            <c:idx val="27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21-A2EB-4566-9B46-DAC7DE36ADA2}"/>
              </c:ext>
            </c:extLst>
          </c:dPt>
          <c:dPt>
            <c:idx val="27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23-A2EB-4566-9B46-DAC7DE36ADA2}"/>
              </c:ext>
            </c:extLst>
          </c:dPt>
          <c:dPt>
            <c:idx val="27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25-A2EB-4566-9B46-DAC7DE36ADA2}"/>
              </c:ext>
            </c:extLst>
          </c:dPt>
          <c:dPt>
            <c:idx val="27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27-A2EB-4566-9B46-DAC7DE36ADA2}"/>
              </c:ext>
            </c:extLst>
          </c:dPt>
          <c:dPt>
            <c:idx val="27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29-A2EB-4566-9B46-DAC7DE36ADA2}"/>
              </c:ext>
            </c:extLst>
          </c:dPt>
          <c:dPt>
            <c:idx val="27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2B-A2EB-4566-9B46-DAC7DE36ADA2}"/>
              </c:ext>
            </c:extLst>
          </c:dPt>
          <c:dPt>
            <c:idx val="27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2D-A2EB-4566-9B46-DAC7DE36ADA2}"/>
              </c:ext>
            </c:extLst>
          </c:dPt>
          <c:dPt>
            <c:idx val="28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2F-A2EB-4566-9B46-DAC7DE36ADA2}"/>
              </c:ext>
            </c:extLst>
          </c:dPt>
          <c:dPt>
            <c:idx val="28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31-A2EB-4566-9B46-DAC7DE36ADA2}"/>
              </c:ext>
            </c:extLst>
          </c:dPt>
          <c:dPt>
            <c:idx val="28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33-A2EB-4566-9B46-DAC7DE36ADA2}"/>
              </c:ext>
            </c:extLst>
          </c:dPt>
          <c:dPt>
            <c:idx val="28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35-A2EB-4566-9B46-DAC7DE36ADA2}"/>
              </c:ext>
            </c:extLst>
          </c:dPt>
          <c:dPt>
            <c:idx val="28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37-A2EB-4566-9B46-DAC7DE36ADA2}"/>
              </c:ext>
            </c:extLst>
          </c:dPt>
          <c:dPt>
            <c:idx val="28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39-A2EB-4566-9B46-DAC7DE36ADA2}"/>
              </c:ext>
            </c:extLst>
          </c:dPt>
          <c:dPt>
            <c:idx val="28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3B-A2EB-4566-9B46-DAC7DE36ADA2}"/>
              </c:ext>
            </c:extLst>
          </c:dPt>
          <c:dPt>
            <c:idx val="28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3D-A2EB-4566-9B46-DAC7DE36ADA2}"/>
              </c:ext>
            </c:extLst>
          </c:dPt>
          <c:dPt>
            <c:idx val="28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3F-A2EB-4566-9B46-DAC7DE36ADA2}"/>
              </c:ext>
            </c:extLst>
          </c:dPt>
          <c:dPt>
            <c:idx val="28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41-A2EB-4566-9B46-DAC7DE36ADA2}"/>
              </c:ext>
            </c:extLst>
          </c:dPt>
          <c:dPt>
            <c:idx val="29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43-A2EB-4566-9B46-DAC7DE36ADA2}"/>
              </c:ext>
            </c:extLst>
          </c:dPt>
          <c:dPt>
            <c:idx val="29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45-A2EB-4566-9B46-DAC7DE36ADA2}"/>
              </c:ext>
            </c:extLst>
          </c:dPt>
          <c:dPt>
            <c:idx val="29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47-A2EB-4566-9B46-DAC7DE36ADA2}"/>
              </c:ext>
            </c:extLst>
          </c:dPt>
          <c:dPt>
            <c:idx val="29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49-A2EB-4566-9B46-DAC7DE36ADA2}"/>
              </c:ext>
            </c:extLst>
          </c:dPt>
          <c:dPt>
            <c:idx val="29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4B-A2EB-4566-9B46-DAC7DE36ADA2}"/>
              </c:ext>
            </c:extLst>
          </c:dPt>
          <c:dPt>
            <c:idx val="29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4D-A2EB-4566-9B46-DAC7DE36ADA2}"/>
              </c:ext>
            </c:extLst>
          </c:dPt>
          <c:dPt>
            <c:idx val="29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4F-A2EB-4566-9B46-DAC7DE36ADA2}"/>
              </c:ext>
            </c:extLst>
          </c:dPt>
          <c:dPt>
            <c:idx val="29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51-A2EB-4566-9B46-DAC7DE36ADA2}"/>
              </c:ext>
            </c:extLst>
          </c:dPt>
          <c:dPt>
            <c:idx val="29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53-A2EB-4566-9B46-DAC7DE36ADA2}"/>
              </c:ext>
            </c:extLst>
          </c:dPt>
          <c:dPt>
            <c:idx val="29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55-A2EB-4566-9B46-DAC7DE36ADA2}"/>
              </c:ext>
            </c:extLst>
          </c:dPt>
          <c:dPt>
            <c:idx val="30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57-A2EB-4566-9B46-DAC7DE36ADA2}"/>
              </c:ext>
            </c:extLst>
          </c:dPt>
          <c:dPt>
            <c:idx val="30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59-A2EB-4566-9B46-DAC7DE36ADA2}"/>
              </c:ext>
            </c:extLst>
          </c:dPt>
          <c:dPt>
            <c:idx val="30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5B-A2EB-4566-9B46-DAC7DE36ADA2}"/>
              </c:ext>
            </c:extLst>
          </c:dPt>
          <c:dPt>
            <c:idx val="30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5D-A2EB-4566-9B46-DAC7DE36ADA2}"/>
              </c:ext>
            </c:extLst>
          </c:dPt>
          <c:dPt>
            <c:idx val="30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5F-A2EB-4566-9B46-DAC7DE36ADA2}"/>
              </c:ext>
            </c:extLst>
          </c:dPt>
          <c:dPt>
            <c:idx val="30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61-A2EB-4566-9B46-DAC7DE36ADA2}"/>
              </c:ext>
            </c:extLst>
          </c:dPt>
          <c:dPt>
            <c:idx val="30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63-A2EB-4566-9B46-DAC7DE36ADA2}"/>
              </c:ext>
            </c:extLst>
          </c:dPt>
          <c:dPt>
            <c:idx val="30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65-A2EB-4566-9B46-DAC7DE36ADA2}"/>
              </c:ext>
            </c:extLst>
          </c:dPt>
          <c:dPt>
            <c:idx val="30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67-A2EB-4566-9B46-DAC7DE36ADA2}"/>
              </c:ext>
            </c:extLst>
          </c:dPt>
          <c:dPt>
            <c:idx val="30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69-A2EB-4566-9B46-DAC7DE36ADA2}"/>
              </c:ext>
            </c:extLst>
          </c:dPt>
          <c:dPt>
            <c:idx val="31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6B-A2EB-4566-9B46-DAC7DE36ADA2}"/>
              </c:ext>
            </c:extLst>
          </c:dPt>
          <c:dPt>
            <c:idx val="31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6D-A2EB-4566-9B46-DAC7DE36ADA2}"/>
              </c:ext>
            </c:extLst>
          </c:dPt>
          <c:dPt>
            <c:idx val="31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6F-A2EB-4566-9B46-DAC7DE36ADA2}"/>
              </c:ext>
            </c:extLst>
          </c:dPt>
          <c:dPt>
            <c:idx val="31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71-A2EB-4566-9B46-DAC7DE36ADA2}"/>
              </c:ext>
            </c:extLst>
          </c:dPt>
          <c:dPt>
            <c:idx val="31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73-A2EB-4566-9B46-DAC7DE36ADA2}"/>
              </c:ext>
            </c:extLst>
          </c:dPt>
          <c:dPt>
            <c:idx val="31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75-A2EB-4566-9B46-DAC7DE36ADA2}"/>
              </c:ext>
            </c:extLst>
          </c:dPt>
          <c:dPt>
            <c:idx val="31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77-A2EB-4566-9B46-DAC7DE36ADA2}"/>
              </c:ext>
            </c:extLst>
          </c:dPt>
          <c:dPt>
            <c:idx val="31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79-A2EB-4566-9B46-DAC7DE36ADA2}"/>
              </c:ext>
            </c:extLst>
          </c:dPt>
          <c:dPt>
            <c:idx val="31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7B-A2EB-4566-9B46-DAC7DE36ADA2}"/>
              </c:ext>
            </c:extLst>
          </c:dPt>
          <c:dPt>
            <c:idx val="31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7D-A2EB-4566-9B46-DAC7DE36ADA2}"/>
              </c:ext>
            </c:extLst>
          </c:dPt>
          <c:dPt>
            <c:idx val="32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7F-A2EB-4566-9B46-DAC7DE36ADA2}"/>
              </c:ext>
            </c:extLst>
          </c:dPt>
          <c:dPt>
            <c:idx val="32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81-A2EB-4566-9B46-DAC7DE36ADA2}"/>
              </c:ext>
            </c:extLst>
          </c:dPt>
          <c:dPt>
            <c:idx val="32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83-A2EB-4566-9B46-DAC7DE36ADA2}"/>
              </c:ext>
            </c:extLst>
          </c:dPt>
          <c:dPt>
            <c:idx val="32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85-A2EB-4566-9B46-DAC7DE36ADA2}"/>
              </c:ext>
            </c:extLst>
          </c:dPt>
          <c:dPt>
            <c:idx val="32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87-A2EB-4566-9B46-DAC7DE36ADA2}"/>
              </c:ext>
            </c:extLst>
          </c:dPt>
          <c:dPt>
            <c:idx val="32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89-A2EB-4566-9B46-DAC7DE36ADA2}"/>
              </c:ext>
            </c:extLst>
          </c:dPt>
          <c:dPt>
            <c:idx val="32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8B-A2EB-4566-9B46-DAC7DE36ADA2}"/>
              </c:ext>
            </c:extLst>
          </c:dPt>
          <c:dPt>
            <c:idx val="32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8D-A2EB-4566-9B46-DAC7DE36ADA2}"/>
              </c:ext>
            </c:extLst>
          </c:dPt>
          <c:dPt>
            <c:idx val="32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8F-A2EB-4566-9B46-DAC7DE36ADA2}"/>
              </c:ext>
            </c:extLst>
          </c:dPt>
          <c:dPt>
            <c:idx val="32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91-A2EB-4566-9B46-DAC7DE36ADA2}"/>
              </c:ext>
            </c:extLst>
          </c:dPt>
          <c:dPt>
            <c:idx val="33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93-A2EB-4566-9B46-DAC7DE36ADA2}"/>
              </c:ext>
            </c:extLst>
          </c:dPt>
          <c:dPt>
            <c:idx val="33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95-A2EB-4566-9B46-DAC7DE36ADA2}"/>
              </c:ext>
            </c:extLst>
          </c:dPt>
          <c:dPt>
            <c:idx val="33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97-A2EB-4566-9B46-DAC7DE36ADA2}"/>
              </c:ext>
            </c:extLst>
          </c:dPt>
          <c:cat>
            <c:strRef>
              <c:f>'Heat maps3_HID7'!$A$2:$A$334</c:f>
              <c:strCache>
                <c:ptCount val="333"/>
                <c:pt idx="0">
                  <c:v>CDH1</c:v>
                </c:pt>
                <c:pt idx="1">
                  <c:v>CD8A</c:v>
                </c:pt>
                <c:pt idx="2">
                  <c:v>BCAM</c:v>
                </c:pt>
                <c:pt idx="3">
                  <c:v>LAMA5</c:v>
                </c:pt>
                <c:pt idx="4">
                  <c:v>RPSA</c:v>
                </c:pt>
                <c:pt idx="5">
                  <c:v>TNC</c:v>
                </c:pt>
                <c:pt idx="6">
                  <c:v>CLDN4</c:v>
                </c:pt>
                <c:pt idx="7">
                  <c:v>PTPRF</c:v>
                </c:pt>
                <c:pt idx="8">
                  <c:v>THBS1</c:v>
                </c:pt>
                <c:pt idx="9">
                  <c:v>ITGB4</c:v>
                </c:pt>
                <c:pt idx="10">
                  <c:v>CELSR1</c:v>
                </c:pt>
                <c:pt idx="11">
                  <c:v>PTPRU</c:v>
                </c:pt>
                <c:pt idx="12">
                  <c:v>CLSTN1</c:v>
                </c:pt>
                <c:pt idx="13">
                  <c:v>CD151</c:v>
                </c:pt>
                <c:pt idx="14">
                  <c:v>CTNND2</c:v>
                </c:pt>
                <c:pt idx="15">
                  <c:v>CD36</c:v>
                </c:pt>
                <c:pt idx="16">
                  <c:v>LAMB1</c:v>
                </c:pt>
                <c:pt idx="17">
                  <c:v>CTNND1</c:v>
                </c:pt>
                <c:pt idx="18">
                  <c:v>MAEA</c:v>
                </c:pt>
                <c:pt idx="19">
                  <c:v>DDR1</c:v>
                </c:pt>
                <c:pt idx="20">
                  <c:v>CLDN9</c:v>
                </c:pt>
                <c:pt idx="21">
                  <c:v>BYSL</c:v>
                </c:pt>
                <c:pt idx="22">
                  <c:v>ZYX</c:v>
                </c:pt>
                <c:pt idx="23">
                  <c:v>AJUBA</c:v>
                </c:pt>
                <c:pt idx="24">
                  <c:v>LAMB3</c:v>
                </c:pt>
                <c:pt idx="25">
                  <c:v>PKP3</c:v>
                </c:pt>
                <c:pt idx="26">
                  <c:v>CLDN3</c:v>
                </c:pt>
                <c:pt idx="27">
                  <c:v>DSG2</c:v>
                </c:pt>
                <c:pt idx="28">
                  <c:v>JUP</c:v>
                </c:pt>
                <c:pt idx="29">
                  <c:v>EPHA2</c:v>
                </c:pt>
                <c:pt idx="30">
                  <c:v>CLDN1</c:v>
                </c:pt>
                <c:pt idx="31">
                  <c:v>HSPG2</c:v>
                </c:pt>
                <c:pt idx="32">
                  <c:v>CDH24</c:v>
                </c:pt>
                <c:pt idx="33">
                  <c:v>VCAN</c:v>
                </c:pt>
                <c:pt idx="34">
                  <c:v>PTPRK</c:v>
                </c:pt>
                <c:pt idx="35">
                  <c:v>PKP2</c:v>
                </c:pt>
                <c:pt idx="36">
                  <c:v>ITGB5</c:v>
                </c:pt>
                <c:pt idx="37">
                  <c:v>LRFN4</c:v>
                </c:pt>
                <c:pt idx="38">
                  <c:v>CLDN7</c:v>
                </c:pt>
                <c:pt idx="39">
                  <c:v>BAIAP2</c:v>
                </c:pt>
                <c:pt idx="40">
                  <c:v>DSC2</c:v>
                </c:pt>
                <c:pt idx="41">
                  <c:v>ITGB1BP1</c:v>
                </c:pt>
                <c:pt idx="42">
                  <c:v>CELSR3</c:v>
                </c:pt>
                <c:pt idx="43">
                  <c:v>SDC1</c:v>
                </c:pt>
                <c:pt idx="44">
                  <c:v>CTNNB1</c:v>
                </c:pt>
                <c:pt idx="45">
                  <c:v>LAMB2</c:v>
                </c:pt>
                <c:pt idx="46">
                  <c:v>CYTH1</c:v>
                </c:pt>
                <c:pt idx="47">
                  <c:v>EPHB6</c:v>
                </c:pt>
                <c:pt idx="48">
                  <c:v>FLRT3</c:v>
                </c:pt>
                <c:pt idx="49">
                  <c:v>IGSF5</c:v>
                </c:pt>
                <c:pt idx="50">
                  <c:v>THBS3</c:v>
                </c:pt>
                <c:pt idx="51">
                  <c:v>ROBO3</c:v>
                </c:pt>
                <c:pt idx="52">
                  <c:v>PCDHGC3</c:v>
                </c:pt>
                <c:pt idx="53">
                  <c:v>EPHA1</c:v>
                </c:pt>
                <c:pt idx="54">
                  <c:v>BAIAP3</c:v>
                </c:pt>
                <c:pt idx="55">
                  <c:v>CADM1</c:v>
                </c:pt>
                <c:pt idx="56">
                  <c:v>NOTCH1</c:v>
                </c:pt>
                <c:pt idx="57">
                  <c:v>DLG5</c:v>
                </c:pt>
                <c:pt idx="58">
                  <c:v>L1CAM</c:v>
                </c:pt>
                <c:pt idx="59">
                  <c:v>ITGA2B</c:v>
                </c:pt>
                <c:pt idx="60">
                  <c:v>CNTNAP1</c:v>
                </c:pt>
                <c:pt idx="61">
                  <c:v>PVR</c:v>
                </c:pt>
                <c:pt idx="62">
                  <c:v>BAIAP2L1</c:v>
                </c:pt>
                <c:pt idx="63">
                  <c:v>EPHB4</c:v>
                </c:pt>
                <c:pt idx="64">
                  <c:v>CDH13</c:v>
                </c:pt>
                <c:pt idx="65">
                  <c:v>PTPRJ</c:v>
                </c:pt>
                <c:pt idx="66">
                  <c:v>ITGA7</c:v>
                </c:pt>
                <c:pt idx="67">
                  <c:v>EFNB1</c:v>
                </c:pt>
                <c:pt idx="68">
                  <c:v>ANTXR1</c:v>
                </c:pt>
                <c:pt idx="69">
                  <c:v>PCDHA11</c:v>
                </c:pt>
                <c:pt idx="70">
                  <c:v>ITGB2</c:v>
                </c:pt>
                <c:pt idx="71">
                  <c:v>PCDHGA10</c:v>
                </c:pt>
                <c:pt idx="72">
                  <c:v>GAS6</c:v>
                </c:pt>
                <c:pt idx="73">
                  <c:v>MDGA1</c:v>
                </c:pt>
                <c:pt idx="74">
                  <c:v>EPHB2</c:v>
                </c:pt>
                <c:pt idx="75">
                  <c:v>SSPN</c:v>
                </c:pt>
                <c:pt idx="76">
                  <c:v>PKP1</c:v>
                </c:pt>
                <c:pt idx="77">
                  <c:v>EFNA5</c:v>
                </c:pt>
                <c:pt idx="78">
                  <c:v>PCDHB14</c:v>
                </c:pt>
                <c:pt idx="79">
                  <c:v>ITGAE</c:v>
                </c:pt>
                <c:pt idx="80">
                  <c:v>NRP1</c:v>
                </c:pt>
                <c:pt idx="81">
                  <c:v>IL1RAP</c:v>
                </c:pt>
                <c:pt idx="82">
                  <c:v>CYTH3</c:v>
                </c:pt>
                <c:pt idx="83">
                  <c:v>ITGB8</c:v>
                </c:pt>
                <c:pt idx="84">
                  <c:v>PTPRM</c:v>
                </c:pt>
                <c:pt idx="85">
                  <c:v>ROBO1</c:v>
                </c:pt>
                <c:pt idx="86">
                  <c:v>PEAK1</c:v>
                </c:pt>
                <c:pt idx="87">
                  <c:v>SDK1</c:v>
                </c:pt>
                <c:pt idx="88">
                  <c:v>PCDHB11</c:v>
                </c:pt>
                <c:pt idx="89">
                  <c:v>CDON</c:v>
                </c:pt>
                <c:pt idx="90">
                  <c:v>BOC</c:v>
                </c:pt>
                <c:pt idx="91">
                  <c:v>PCDH17</c:v>
                </c:pt>
                <c:pt idx="92">
                  <c:v>ITGA10</c:v>
                </c:pt>
                <c:pt idx="93">
                  <c:v>MDGA2</c:v>
                </c:pt>
                <c:pt idx="94">
                  <c:v>PCDHB10</c:v>
                </c:pt>
                <c:pt idx="95">
                  <c:v>PCDHA1</c:v>
                </c:pt>
                <c:pt idx="96">
                  <c:v>SEMA3G</c:v>
                </c:pt>
                <c:pt idx="97">
                  <c:v>LAMA4</c:v>
                </c:pt>
                <c:pt idx="98">
                  <c:v>ICAM1</c:v>
                </c:pt>
                <c:pt idx="99">
                  <c:v>PCDHA3</c:v>
                </c:pt>
                <c:pt idx="100">
                  <c:v>PODXL2</c:v>
                </c:pt>
                <c:pt idx="101">
                  <c:v>ICAM3</c:v>
                </c:pt>
                <c:pt idx="102">
                  <c:v>CLDN15</c:v>
                </c:pt>
                <c:pt idx="103">
                  <c:v>NINJ1</c:v>
                </c:pt>
                <c:pt idx="104">
                  <c:v>PCDH20</c:v>
                </c:pt>
                <c:pt idx="105">
                  <c:v>PCDHB2</c:v>
                </c:pt>
                <c:pt idx="106">
                  <c:v>PCDHB8</c:v>
                </c:pt>
                <c:pt idx="107">
                  <c:v>PCDHA12</c:v>
                </c:pt>
                <c:pt idx="108">
                  <c:v>LRFN3</c:v>
                </c:pt>
                <c:pt idx="109">
                  <c:v>LRFN1</c:v>
                </c:pt>
                <c:pt idx="110">
                  <c:v>SGCE</c:v>
                </c:pt>
                <c:pt idx="111">
                  <c:v>EPHA4</c:v>
                </c:pt>
                <c:pt idx="112">
                  <c:v>ITGB7</c:v>
                </c:pt>
                <c:pt idx="113">
                  <c:v>SEMA4D</c:v>
                </c:pt>
                <c:pt idx="114">
                  <c:v>PCDHA4</c:v>
                </c:pt>
                <c:pt idx="115">
                  <c:v>CADM2</c:v>
                </c:pt>
                <c:pt idx="116">
                  <c:v>SDC3</c:v>
                </c:pt>
                <c:pt idx="117">
                  <c:v>CNTN1</c:v>
                </c:pt>
                <c:pt idx="118">
                  <c:v>CLDN12</c:v>
                </c:pt>
                <c:pt idx="119">
                  <c:v>PTPRH</c:v>
                </c:pt>
                <c:pt idx="120">
                  <c:v>PCDH12</c:v>
                </c:pt>
                <c:pt idx="121">
                  <c:v>CDH18</c:v>
                </c:pt>
                <c:pt idx="122">
                  <c:v>LPXN</c:v>
                </c:pt>
                <c:pt idx="123">
                  <c:v>CLDN8</c:v>
                </c:pt>
                <c:pt idx="124">
                  <c:v>AGER</c:v>
                </c:pt>
                <c:pt idx="125">
                  <c:v>RGMB</c:v>
                </c:pt>
                <c:pt idx="126">
                  <c:v>ITGB3BP</c:v>
                </c:pt>
                <c:pt idx="127">
                  <c:v>TNXB</c:v>
                </c:pt>
                <c:pt idx="128">
                  <c:v>EPHA3</c:v>
                </c:pt>
                <c:pt idx="129">
                  <c:v>CDHR3</c:v>
                </c:pt>
                <c:pt idx="130">
                  <c:v>CLDN23</c:v>
                </c:pt>
                <c:pt idx="131">
                  <c:v>PCDHAC2</c:v>
                </c:pt>
                <c:pt idx="132">
                  <c:v>PLXNC1</c:v>
                </c:pt>
                <c:pt idx="133">
                  <c:v>SELL</c:v>
                </c:pt>
                <c:pt idx="134">
                  <c:v>CDH2</c:v>
                </c:pt>
                <c:pt idx="135">
                  <c:v>PCDHGB1</c:v>
                </c:pt>
                <c:pt idx="136">
                  <c:v>PCDHGB4</c:v>
                </c:pt>
                <c:pt idx="137">
                  <c:v>ROBO2</c:v>
                </c:pt>
                <c:pt idx="138">
                  <c:v>IGSF11</c:v>
                </c:pt>
                <c:pt idx="139">
                  <c:v>NID2</c:v>
                </c:pt>
                <c:pt idx="140">
                  <c:v>CD58</c:v>
                </c:pt>
                <c:pt idx="141">
                  <c:v>PCDHB7</c:v>
                </c:pt>
                <c:pt idx="142">
                  <c:v>UMODL1</c:v>
                </c:pt>
                <c:pt idx="143">
                  <c:v>PCDHB9</c:v>
                </c:pt>
                <c:pt idx="144">
                  <c:v>BAIAP2L2</c:v>
                </c:pt>
                <c:pt idx="145">
                  <c:v>PCDHB12</c:v>
                </c:pt>
                <c:pt idx="146">
                  <c:v>PCDHA5</c:v>
                </c:pt>
                <c:pt idx="147">
                  <c:v>PRTG</c:v>
                </c:pt>
                <c:pt idx="148">
                  <c:v>PCDHB13</c:v>
                </c:pt>
                <c:pt idx="149">
                  <c:v>PCDHA2</c:v>
                </c:pt>
                <c:pt idx="150">
                  <c:v>PCDHGB2</c:v>
                </c:pt>
                <c:pt idx="151">
                  <c:v>LAMC3</c:v>
                </c:pt>
                <c:pt idx="152">
                  <c:v>AMIGO3</c:v>
                </c:pt>
                <c:pt idx="153">
                  <c:v>PCDHGA4</c:v>
                </c:pt>
                <c:pt idx="154">
                  <c:v>PCDH7</c:v>
                </c:pt>
                <c:pt idx="155">
                  <c:v>ITGAL</c:v>
                </c:pt>
                <c:pt idx="156">
                  <c:v>NLGN3</c:v>
                </c:pt>
                <c:pt idx="157">
                  <c:v>EPHA7</c:v>
                </c:pt>
                <c:pt idx="158">
                  <c:v>LRRN3</c:v>
                </c:pt>
                <c:pt idx="159">
                  <c:v>ICAM2</c:v>
                </c:pt>
                <c:pt idx="160">
                  <c:v>EDIL3</c:v>
                </c:pt>
                <c:pt idx="161">
                  <c:v>CDH5</c:v>
                </c:pt>
                <c:pt idx="162">
                  <c:v>CLDN19</c:v>
                </c:pt>
                <c:pt idx="163">
                  <c:v>CDHR5</c:v>
                </c:pt>
                <c:pt idx="164">
                  <c:v>SELPLG</c:v>
                </c:pt>
                <c:pt idx="165">
                  <c:v>DCHS1</c:v>
                </c:pt>
                <c:pt idx="166">
                  <c:v>DSC3</c:v>
                </c:pt>
                <c:pt idx="167">
                  <c:v>PCDHGA3</c:v>
                </c:pt>
                <c:pt idx="168">
                  <c:v>CD24P2</c:v>
                </c:pt>
                <c:pt idx="169">
                  <c:v>PCDHGC5</c:v>
                </c:pt>
                <c:pt idx="170">
                  <c:v>PCDHGA11</c:v>
                </c:pt>
                <c:pt idx="171">
                  <c:v>CLDN2</c:v>
                </c:pt>
                <c:pt idx="172">
                  <c:v>EPHA8</c:v>
                </c:pt>
                <c:pt idx="173">
                  <c:v>PCDHA10</c:v>
                </c:pt>
                <c:pt idx="174">
                  <c:v>PCDHGA7</c:v>
                </c:pt>
                <c:pt idx="175">
                  <c:v>ABI3BP</c:v>
                </c:pt>
                <c:pt idx="176">
                  <c:v>PCDHA6</c:v>
                </c:pt>
                <c:pt idx="177">
                  <c:v>PCDHB6</c:v>
                </c:pt>
                <c:pt idx="178">
                  <c:v>PCDHB5</c:v>
                </c:pt>
                <c:pt idx="179">
                  <c:v>PCDHGB7</c:v>
                </c:pt>
                <c:pt idx="180">
                  <c:v>CLDN6</c:v>
                </c:pt>
                <c:pt idx="181">
                  <c:v>NRXN3</c:v>
                </c:pt>
                <c:pt idx="182">
                  <c:v>PCDHGA12</c:v>
                </c:pt>
                <c:pt idx="183">
                  <c:v>CLDN5</c:v>
                </c:pt>
                <c:pt idx="184">
                  <c:v>PCDHB4</c:v>
                </c:pt>
                <c:pt idx="185">
                  <c:v>CD48</c:v>
                </c:pt>
                <c:pt idx="186">
                  <c:v>PCDHGC4</c:v>
                </c:pt>
                <c:pt idx="187">
                  <c:v>CYTIP</c:v>
                </c:pt>
                <c:pt idx="188">
                  <c:v>CDH10</c:v>
                </c:pt>
                <c:pt idx="189">
                  <c:v>ITGB3</c:v>
                </c:pt>
                <c:pt idx="190">
                  <c:v>CDH20</c:v>
                </c:pt>
                <c:pt idx="191">
                  <c:v>PCDHGA6</c:v>
                </c:pt>
                <c:pt idx="192">
                  <c:v>NINJ2</c:v>
                </c:pt>
                <c:pt idx="193">
                  <c:v>CDHR4</c:v>
                </c:pt>
                <c:pt idx="194">
                  <c:v>LRRN4</c:v>
                </c:pt>
                <c:pt idx="195">
                  <c:v>ICAM4</c:v>
                </c:pt>
                <c:pt idx="196">
                  <c:v>ITGA11</c:v>
                </c:pt>
                <c:pt idx="197">
                  <c:v>KIRREL2</c:v>
                </c:pt>
                <c:pt idx="198">
                  <c:v>THY1</c:v>
                </c:pt>
                <c:pt idx="199">
                  <c:v>PRPH2</c:v>
                </c:pt>
                <c:pt idx="200">
                  <c:v>FAT2</c:v>
                </c:pt>
                <c:pt idx="201">
                  <c:v>CD84</c:v>
                </c:pt>
                <c:pt idx="202">
                  <c:v>MPL</c:v>
                </c:pt>
                <c:pt idx="203">
                  <c:v>IL1RAPL1</c:v>
                </c:pt>
                <c:pt idx="204">
                  <c:v>NLGN1</c:v>
                </c:pt>
                <c:pt idx="205">
                  <c:v>OMG</c:v>
                </c:pt>
                <c:pt idx="206">
                  <c:v>DSC1</c:v>
                </c:pt>
                <c:pt idx="207">
                  <c:v>LIMS2</c:v>
                </c:pt>
                <c:pt idx="208">
                  <c:v>CD6</c:v>
                </c:pt>
                <c:pt idx="209">
                  <c:v>PCDHGA2</c:v>
                </c:pt>
                <c:pt idx="210">
                  <c:v>PCDH19</c:v>
                </c:pt>
                <c:pt idx="211">
                  <c:v>MADCAM1</c:v>
                </c:pt>
                <c:pt idx="212">
                  <c:v>PCDHGA5</c:v>
                </c:pt>
                <c:pt idx="213">
                  <c:v>MAG</c:v>
                </c:pt>
                <c:pt idx="214">
                  <c:v>MFAP4</c:v>
                </c:pt>
                <c:pt idx="215">
                  <c:v>PCDHB3</c:v>
                </c:pt>
                <c:pt idx="216">
                  <c:v>AXL</c:v>
                </c:pt>
                <c:pt idx="217">
                  <c:v>PCDHA8</c:v>
                </c:pt>
                <c:pt idx="218">
                  <c:v>JAM2</c:v>
                </c:pt>
                <c:pt idx="219">
                  <c:v>AMIGO1</c:v>
                </c:pt>
                <c:pt idx="220">
                  <c:v>PCDHGA1</c:v>
                </c:pt>
                <c:pt idx="221">
                  <c:v>THBS2</c:v>
                </c:pt>
                <c:pt idx="222">
                  <c:v>PTPRO</c:v>
                </c:pt>
                <c:pt idx="223">
                  <c:v>FBLN5</c:v>
                </c:pt>
                <c:pt idx="224">
                  <c:v>ELFN1</c:v>
                </c:pt>
                <c:pt idx="225">
                  <c:v>PCDHGA9</c:v>
                </c:pt>
                <c:pt idx="226">
                  <c:v>ITGAD</c:v>
                </c:pt>
                <c:pt idx="227">
                  <c:v>PCDHGA8</c:v>
                </c:pt>
                <c:pt idx="228">
                  <c:v>TRO</c:v>
                </c:pt>
                <c:pt idx="229">
                  <c:v>NCAM1</c:v>
                </c:pt>
                <c:pt idx="230">
                  <c:v>CDH26</c:v>
                </c:pt>
                <c:pt idx="231">
                  <c:v>LRRN2</c:v>
                </c:pt>
                <c:pt idx="232">
                  <c:v>CDH17</c:v>
                </c:pt>
                <c:pt idx="233">
                  <c:v>PCDHGB6</c:v>
                </c:pt>
                <c:pt idx="234">
                  <c:v>PTPRB</c:v>
                </c:pt>
                <c:pt idx="235">
                  <c:v>ITGA9</c:v>
                </c:pt>
                <c:pt idx="236">
                  <c:v>PCDHB15</c:v>
                </c:pt>
                <c:pt idx="237">
                  <c:v>CDHR2</c:v>
                </c:pt>
                <c:pt idx="238">
                  <c:v>MCAM</c:v>
                </c:pt>
                <c:pt idx="239">
                  <c:v>PTPRC</c:v>
                </c:pt>
                <c:pt idx="240">
                  <c:v>FBLN7</c:v>
                </c:pt>
                <c:pt idx="241">
                  <c:v>PCDHAC1</c:v>
                </c:pt>
                <c:pt idx="242">
                  <c:v>LRRN4CL</c:v>
                </c:pt>
                <c:pt idx="243">
                  <c:v>EPHA6</c:v>
                </c:pt>
                <c:pt idx="244">
                  <c:v>THBS4</c:v>
                </c:pt>
                <c:pt idx="245">
                  <c:v>NRP2</c:v>
                </c:pt>
                <c:pt idx="246">
                  <c:v>ITGAM</c:v>
                </c:pt>
                <c:pt idx="247">
                  <c:v>MEGF11</c:v>
                </c:pt>
                <c:pt idx="248">
                  <c:v>ITGA1</c:v>
                </c:pt>
                <c:pt idx="249">
                  <c:v>CLDN11</c:v>
                </c:pt>
                <c:pt idx="250">
                  <c:v>FREM1</c:v>
                </c:pt>
                <c:pt idx="251">
                  <c:v>LSAMP</c:v>
                </c:pt>
                <c:pt idx="252">
                  <c:v>CTNNA3</c:v>
                </c:pt>
                <c:pt idx="253">
                  <c:v>PCDHA7</c:v>
                </c:pt>
                <c:pt idx="254">
                  <c:v>PCDHA13</c:v>
                </c:pt>
                <c:pt idx="255">
                  <c:v>ICAM5</c:v>
                </c:pt>
                <c:pt idx="256">
                  <c:v>SLIT2</c:v>
                </c:pt>
                <c:pt idx="257">
                  <c:v>JAM3</c:v>
                </c:pt>
                <c:pt idx="258">
                  <c:v>CD72</c:v>
                </c:pt>
                <c:pt idx="259">
                  <c:v>PCDHGB3</c:v>
                </c:pt>
                <c:pt idx="260">
                  <c:v>CLDN20</c:v>
                </c:pt>
                <c:pt idx="261">
                  <c:v>CDH4</c:v>
                </c:pt>
                <c:pt idx="262">
                  <c:v>CNTNAP3</c:v>
                </c:pt>
                <c:pt idx="263">
                  <c:v>CDH15</c:v>
                </c:pt>
                <c:pt idx="264">
                  <c:v>FLRT1</c:v>
                </c:pt>
                <c:pt idx="265">
                  <c:v>CD47</c:v>
                </c:pt>
                <c:pt idx="266">
                  <c:v>ITGA5</c:v>
                </c:pt>
                <c:pt idx="267">
                  <c:v>SDC2</c:v>
                </c:pt>
                <c:pt idx="268">
                  <c:v>ESAM</c:v>
                </c:pt>
                <c:pt idx="269">
                  <c:v>EFNA1</c:v>
                </c:pt>
                <c:pt idx="270">
                  <c:v>PTPRS</c:v>
                </c:pt>
                <c:pt idx="271">
                  <c:v>CDH23</c:v>
                </c:pt>
                <c:pt idx="272">
                  <c:v>LAMC1</c:v>
                </c:pt>
                <c:pt idx="273">
                  <c:v>LAMC2</c:v>
                </c:pt>
                <c:pt idx="274">
                  <c:v>CTNNA1</c:v>
                </c:pt>
                <c:pt idx="275">
                  <c:v>TGFBI</c:v>
                </c:pt>
                <c:pt idx="276">
                  <c:v>F11R</c:v>
                </c:pt>
                <c:pt idx="277">
                  <c:v>CERCAM</c:v>
                </c:pt>
                <c:pt idx="278">
                  <c:v>SEMA3E</c:v>
                </c:pt>
                <c:pt idx="279">
                  <c:v>IGSF9</c:v>
                </c:pt>
                <c:pt idx="280">
                  <c:v>NEDD9</c:v>
                </c:pt>
                <c:pt idx="281">
                  <c:v>TMEM8B</c:v>
                </c:pt>
                <c:pt idx="282">
                  <c:v>AMIGO2</c:v>
                </c:pt>
                <c:pt idx="283">
                  <c:v>CYTH2</c:v>
                </c:pt>
                <c:pt idx="284">
                  <c:v>SDC4</c:v>
                </c:pt>
                <c:pt idx="285">
                  <c:v>PCDH10</c:v>
                </c:pt>
                <c:pt idx="286">
                  <c:v>TSC1</c:v>
                </c:pt>
                <c:pt idx="287">
                  <c:v>CLSTN3</c:v>
                </c:pt>
                <c:pt idx="288">
                  <c:v>ITGB1</c:v>
                </c:pt>
                <c:pt idx="289">
                  <c:v>EPCAM</c:v>
                </c:pt>
                <c:pt idx="290">
                  <c:v>ITGA6</c:v>
                </c:pt>
                <c:pt idx="291">
                  <c:v>DSP</c:v>
                </c:pt>
                <c:pt idx="292">
                  <c:v>CD9</c:v>
                </c:pt>
                <c:pt idx="293">
                  <c:v>CELSR2</c:v>
                </c:pt>
                <c:pt idx="294">
                  <c:v>NEO1</c:v>
                </c:pt>
                <c:pt idx="295">
                  <c:v>NPTN</c:v>
                </c:pt>
                <c:pt idx="296">
                  <c:v>ITGA2</c:v>
                </c:pt>
                <c:pt idx="297">
                  <c:v>DLG1</c:v>
                </c:pt>
                <c:pt idx="298">
                  <c:v>CD24P4</c:v>
                </c:pt>
                <c:pt idx="299">
                  <c:v>VEZT</c:v>
                </c:pt>
                <c:pt idx="300">
                  <c:v>CDH3</c:v>
                </c:pt>
                <c:pt idx="301">
                  <c:v>FAT1</c:v>
                </c:pt>
                <c:pt idx="302">
                  <c:v>ITGB6</c:v>
                </c:pt>
                <c:pt idx="303">
                  <c:v>FREM2</c:v>
                </c:pt>
                <c:pt idx="304">
                  <c:v>NRCAM</c:v>
                </c:pt>
                <c:pt idx="305">
                  <c:v>ASTN2</c:v>
                </c:pt>
                <c:pt idx="306">
                  <c:v>ITGAV</c:v>
                </c:pt>
                <c:pt idx="307">
                  <c:v>CD44</c:v>
                </c:pt>
                <c:pt idx="308">
                  <c:v>ITGA3</c:v>
                </c:pt>
                <c:pt idx="309">
                  <c:v>ALCAM</c:v>
                </c:pt>
                <c:pt idx="310">
                  <c:v>CTNNAL1</c:v>
                </c:pt>
                <c:pt idx="311">
                  <c:v>FN1</c:v>
                </c:pt>
                <c:pt idx="312">
                  <c:v>SDK2</c:v>
                </c:pt>
                <c:pt idx="313">
                  <c:v>PCDH1</c:v>
                </c:pt>
                <c:pt idx="314">
                  <c:v>LAMA3</c:v>
                </c:pt>
                <c:pt idx="315">
                  <c:v>CADM4</c:v>
                </c:pt>
                <c:pt idx="316">
                  <c:v>PCDH9</c:v>
                </c:pt>
                <c:pt idx="317">
                  <c:v>DST</c:v>
                </c:pt>
                <c:pt idx="318">
                  <c:v>EFNB2</c:v>
                </c:pt>
                <c:pt idx="319">
                  <c:v>PLXNB1</c:v>
                </c:pt>
                <c:pt idx="320">
                  <c:v>EPHB3</c:v>
                </c:pt>
                <c:pt idx="321">
                  <c:v>LRRN1</c:v>
                </c:pt>
                <c:pt idx="322">
                  <c:v>NCAM2</c:v>
                </c:pt>
                <c:pt idx="323">
                  <c:v>PCDH11X</c:v>
                </c:pt>
                <c:pt idx="324">
                  <c:v>PLXNB3</c:v>
                </c:pt>
                <c:pt idx="325">
                  <c:v>LPP</c:v>
                </c:pt>
                <c:pt idx="326">
                  <c:v>PTPRG</c:v>
                </c:pt>
                <c:pt idx="327">
                  <c:v>FERMT2</c:v>
                </c:pt>
                <c:pt idx="328">
                  <c:v>PKP4</c:v>
                </c:pt>
                <c:pt idx="329">
                  <c:v>CEACAM1</c:v>
                </c:pt>
                <c:pt idx="330">
                  <c:v>NTN1</c:v>
                </c:pt>
                <c:pt idx="331">
                  <c:v>NLGN2</c:v>
                </c:pt>
                <c:pt idx="332">
                  <c:v>MIA3</c:v>
                </c:pt>
              </c:strCache>
            </c:strRef>
          </c:cat>
          <c:val>
            <c:numRef>
              <c:f>'Heat maps3_HID7'!$B$2:$B$334</c:f>
              <c:numCache>
                <c:formatCode>General</c:formatCode>
                <c:ptCount val="333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  <c:pt idx="28">
                  <c:v>1</c:v>
                </c:pt>
                <c:pt idx="29">
                  <c:v>1</c:v>
                </c:pt>
                <c:pt idx="30">
                  <c:v>1</c:v>
                </c:pt>
                <c:pt idx="31">
                  <c:v>1</c:v>
                </c:pt>
                <c:pt idx="32">
                  <c:v>1</c:v>
                </c:pt>
                <c:pt idx="33">
                  <c:v>1</c:v>
                </c:pt>
                <c:pt idx="34">
                  <c:v>1</c:v>
                </c:pt>
                <c:pt idx="35">
                  <c:v>1</c:v>
                </c:pt>
                <c:pt idx="36">
                  <c:v>1</c:v>
                </c:pt>
                <c:pt idx="37">
                  <c:v>1</c:v>
                </c:pt>
                <c:pt idx="38">
                  <c:v>1</c:v>
                </c:pt>
                <c:pt idx="39">
                  <c:v>1</c:v>
                </c:pt>
                <c:pt idx="40">
                  <c:v>1</c:v>
                </c:pt>
                <c:pt idx="41">
                  <c:v>1</c:v>
                </c:pt>
                <c:pt idx="42">
                  <c:v>1</c:v>
                </c:pt>
                <c:pt idx="43">
                  <c:v>1</c:v>
                </c:pt>
                <c:pt idx="44">
                  <c:v>1</c:v>
                </c:pt>
                <c:pt idx="45">
                  <c:v>1</c:v>
                </c:pt>
                <c:pt idx="46">
                  <c:v>1</c:v>
                </c:pt>
                <c:pt idx="47">
                  <c:v>1</c:v>
                </c:pt>
                <c:pt idx="48">
                  <c:v>1</c:v>
                </c:pt>
                <c:pt idx="49">
                  <c:v>1</c:v>
                </c:pt>
                <c:pt idx="50">
                  <c:v>1</c:v>
                </c:pt>
                <c:pt idx="51">
                  <c:v>1</c:v>
                </c:pt>
                <c:pt idx="52">
                  <c:v>1</c:v>
                </c:pt>
                <c:pt idx="53">
                  <c:v>1</c:v>
                </c:pt>
                <c:pt idx="54">
                  <c:v>1</c:v>
                </c:pt>
                <c:pt idx="55">
                  <c:v>1</c:v>
                </c:pt>
                <c:pt idx="56">
                  <c:v>1</c:v>
                </c:pt>
                <c:pt idx="57">
                  <c:v>1</c:v>
                </c:pt>
                <c:pt idx="58">
                  <c:v>1</c:v>
                </c:pt>
                <c:pt idx="59">
                  <c:v>1</c:v>
                </c:pt>
                <c:pt idx="60">
                  <c:v>1</c:v>
                </c:pt>
                <c:pt idx="61">
                  <c:v>1</c:v>
                </c:pt>
                <c:pt idx="62">
                  <c:v>1</c:v>
                </c:pt>
                <c:pt idx="63">
                  <c:v>1</c:v>
                </c:pt>
                <c:pt idx="64">
                  <c:v>1</c:v>
                </c:pt>
                <c:pt idx="65">
                  <c:v>1</c:v>
                </c:pt>
                <c:pt idx="66">
                  <c:v>1</c:v>
                </c:pt>
                <c:pt idx="67">
                  <c:v>1</c:v>
                </c:pt>
                <c:pt idx="68">
                  <c:v>1</c:v>
                </c:pt>
                <c:pt idx="69">
                  <c:v>1</c:v>
                </c:pt>
                <c:pt idx="70">
                  <c:v>1</c:v>
                </c:pt>
                <c:pt idx="71">
                  <c:v>1</c:v>
                </c:pt>
                <c:pt idx="72">
                  <c:v>1</c:v>
                </c:pt>
                <c:pt idx="73">
                  <c:v>1</c:v>
                </c:pt>
                <c:pt idx="74">
                  <c:v>1</c:v>
                </c:pt>
                <c:pt idx="75">
                  <c:v>1</c:v>
                </c:pt>
                <c:pt idx="76">
                  <c:v>1</c:v>
                </c:pt>
                <c:pt idx="77">
                  <c:v>1</c:v>
                </c:pt>
                <c:pt idx="78">
                  <c:v>1</c:v>
                </c:pt>
                <c:pt idx="79">
                  <c:v>1</c:v>
                </c:pt>
                <c:pt idx="80">
                  <c:v>1</c:v>
                </c:pt>
                <c:pt idx="81">
                  <c:v>1</c:v>
                </c:pt>
                <c:pt idx="82">
                  <c:v>1</c:v>
                </c:pt>
                <c:pt idx="83">
                  <c:v>1</c:v>
                </c:pt>
                <c:pt idx="84">
                  <c:v>1</c:v>
                </c:pt>
                <c:pt idx="85">
                  <c:v>1</c:v>
                </c:pt>
                <c:pt idx="86">
                  <c:v>1</c:v>
                </c:pt>
                <c:pt idx="87">
                  <c:v>1</c:v>
                </c:pt>
                <c:pt idx="88">
                  <c:v>1</c:v>
                </c:pt>
                <c:pt idx="89">
                  <c:v>1</c:v>
                </c:pt>
                <c:pt idx="90">
                  <c:v>1</c:v>
                </c:pt>
                <c:pt idx="91">
                  <c:v>1</c:v>
                </c:pt>
                <c:pt idx="92">
                  <c:v>1</c:v>
                </c:pt>
                <c:pt idx="93">
                  <c:v>1</c:v>
                </c:pt>
                <c:pt idx="94">
                  <c:v>1</c:v>
                </c:pt>
                <c:pt idx="95">
                  <c:v>1</c:v>
                </c:pt>
                <c:pt idx="96">
                  <c:v>1</c:v>
                </c:pt>
                <c:pt idx="97">
                  <c:v>1</c:v>
                </c:pt>
                <c:pt idx="98">
                  <c:v>1</c:v>
                </c:pt>
                <c:pt idx="99">
                  <c:v>1</c:v>
                </c:pt>
                <c:pt idx="100">
                  <c:v>1</c:v>
                </c:pt>
                <c:pt idx="101">
                  <c:v>1</c:v>
                </c:pt>
                <c:pt idx="102">
                  <c:v>1</c:v>
                </c:pt>
                <c:pt idx="103">
                  <c:v>1</c:v>
                </c:pt>
                <c:pt idx="104">
                  <c:v>1</c:v>
                </c:pt>
                <c:pt idx="105">
                  <c:v>1</c:v>
                </c:pt>
                <c:pt idx="106">
                  <c:v>1</c:v>
                </c:pt>
                <c:pt idx="107">
                  <c:v>1</c:v>
                </c:pt>
                <c:pt idx="108">
                  <c:v>1</c:v>
                </c:pt>
                <c:pt idx="109">
                  <c:v>1</c:v>
                </c:pt>
                <c:pt idx="110">
                  <c:v>1</c:v>
                </c:pt>
                <c:pt idx="111">
                  <c:v>1</c:v>
                </c:pt>
                <c:pt idx="112">
                  <c:v>1</c:v>
                </c:pt>
                <c:pt idx="113">
                  <c:v>1</c:v>
                </c:pt>
                <c:pt idx="114">
                  <c:v>1</c:v>
                </c:pt>
                <c:pt idx="115">
                  <c:v>1</c:v>
                </c:pt>
                <c:pt idx="116">
                  <c:v>1</c:v>
                </c:pt>
                <c:pt idx="117">
                  <c:v>1</c:v>
                </c:pt>
                <c:pt idx="118">
                  <c:v>1</c:v>
                </c:pt>
                <c:pt idx="119">
                  <c:v>1</c:v>
                </c:pt>
                <c:pt idx="120">
                  <c:v>1</c:v>
                </c:pt>
                <c:pt idx="121">
                  <c:v>1</c:v>
                </c:pt>
                <c:pt idx="122">
                  <c:v>1</c:v>
                </c:pt>
                <c:pt idx="123">
                  <c:v>1</c:v>
                </c:pt>
                <c:pt idx="124">
                  <c:v>1</c:v>
                </c:pt>
                <c:pt idx="125">
                  <c:v>1</c:v>
                </c:pt>
                <c:pt idx="126">
                  <c:v>1</c:v>
                </c:pt>
                <c:pt idx="127">
                  <c:v>1</c:v>
                </c:pt>
                <c:pt idx="128">
                  <c:v>1</c:v>
                </c:pt>
                <c:pt idx="129">
                  <c:v>1</c:v>
                </c:pt>
                <c:pt idx="130">
                  <c:v>1</c:v>
                </c:pt>
                <c:pt idx="131">
                  <c:v>1</c:v>
                </c:pt>
                <c:pt idx="132">
                  <c:v>1</c:v>
                </c:pt>
                <c:pt idx="133">
                  <c:v>1</c:v>
                </c:pt>
                <c:pt idx="134">
                  <c:v>1</c:v>
                </c:pt>
                <c:pt idx="135">
                  <c:v>1</c:v>
                </c:pt>
                <c:pt idx="136">
                  <c:v>1</c:v>
                </c:pt>
                <c:pt idx="137">
                  <c:v>1</c:v>
                </c:pt>
                <c:pt idx="138">
                  <c:v>1</c:v>
                </c:pt>
                <c:pt idx="139">
                  <c:v>1</c:v>
                </c:pt>
                <c:pt idx="140">
                  <c:v>1</c:v>
                </c:pt>
                <c:pt idx="141">
                  <c:v>1</c:v>
                </c:pt>
                <c:pt idx="142">
                  <c:v>1</c:v>
                </c:pt>
                <c:pt idx="143">
                  <c:v>1</c:v>
                </c:pt>
                <c:pt idx="144">
                  <c:v>1</c:v>
                </c:pt>
                <c:pt idx="145">
                  <c:v>1</c:v>
                </c:pt>
                <c:pt idx="146">
                  <c:v>1</c:v>
                </c:pt>
                <c:pt idx="147">
                  <c:v>1</c:v>
                </c:pt>
                <c:pt idx="148">
                  <c:v>1</c:v>
                </c:pt>
                <c:pt idx="149">
                  <c:v>1</c:v>
                </c:pt>
                <c:pt idx="150">
                  <c:v>1</c:v>
                </c:pt>
                <c:pt idx="151">
                  <c:v>1</c:v>
                </c:pt>
                <c:pt idx="152">
                  <c:v>1</c:v>
                </c:pt>
                <c:pt idx="153">
                  <c:v>1</c:v>
                </c:pt>
                <c:pt idx="154">
                  <c:v>1</c:v>
                </c:pt>
                <c:pt idx="155">
                  <c:v>1</c:v>
                </c:pt>
                <c:pt idx="156">
                  <c:v>1</c:v>
                </c:pt>
                <c:pt idx="157">
                  <c:v>1</c:v>
                </c:pt>
                <c:pt idx="158">
                  <c:v>1</c:v>
                </c:pt>
                <c:pt idx="159">
                  <c:v>1</c:v>
                </c:pt>
                <c:pt idx="160">
                  <c:v>1</c:v>
                </c:pt>
                <c:pt idx="161">
                  <c:v>1</c:v>
                </c:pt>
                <c:pt idx="162">
                  <c:v>1</c:v>
                </c:pt>
                <c:pt idx="163">
                  <c:v>1</c:v>
                </c:pt>
                <c:pt idx="164">
                  <c:v>1</c:v>
                </c:pt>
                <c:pt idx="165">
                  <c:v>1</c:v>
                </c:pt>
                <c:pt idx="166">
                  <c:v>1</c:v>
                </c:pt>
                <c:pt idx="167">
                  <c:v>1</c:v>
                </c:pt>
                <c:pt idx="168">
                  <c:v>1</c:v>
                </c:pt>
                <c:pt idx="169">
                  <c:v>1</c:v>
                </c:pt>
                <c:pt idx="170">
                  <c:v>1</c:v>
                </c:pt>
                <c:pt idx="171">
                  <c:v>1</c:v>
                </c:pt>
                <c:pt idx="172">
                  <c:v>1</c:v>
                </c:pt>
                <c:pt idx="173">
                  <c:v>1</c:v>
                </c:pt>
                <c:pt idx="174">
                  <c:v>1</c:v>
                </c:pt>
                <c:pt idx="175">
                  <c:v>1</c:v>
                </c:pt>
                <c:pt idx="176">
                  <c:v>1</c:v>
                </c:pt>
                <c:pt idx="177">
                  <c:v>1</c:v>
                </c:pt>
                <c:pt idx="178">
                  <c:v>1</c:v>
                </c:pt>
                <c:pt idx="179">
                  <c:v>1</c:v>
                </c:pt>
                <c:pt idx="180">
                  <c:v>1</c:v>
                </c:pt>
                <c:pt idx="181">
                  <c:v>1</c:v>
                </c:pt>
                <c:pt idx="182">
                  <c:v>1</c:v>
                </c:pt>
                <c:pt idx="183">
                  <c:v>1</c:v>
                </c:pt>
                <c:pt idx="184">
                  <c:v>1</c:v>
                </c:pt>
                <c:pt idx="185">
                  <c:v>1</c:v>
                </c:pt>
                <c:pt idx="186">
                  <c:v>1</c:v>
                </c:pt>
                <c:pt idx="187">
                  <c:v>1</c:v>
                </c:pt>
                <c:pt idx="188">
                  <c:v>1</c:v>
                </c:pt>
                <c:pt idx="189">
                  <c:v>1</c:v>
                </c:pt>
                <c:pt idx="190">
                  <c:v>1</c:v>
                </c:pt>
                <c:pt idx="191">
                  <c:v>1</c:v>
                </c:pt>
                <c:pt idx="192">
                  <c:v>1</c:v>
                </c:pt>
                <c:pt idx="193">
                  <c:v>1</c:v>
                </c:pt>
                <c:pt idx="194">
                  <c:v>1</c:v>
                </c:pt>
                <c:pt idx="195">
                  <c:v>1</c:v>
                </c:pt>
                <c:pt idx="196">
                  <c:v>1</c:v>
                </c:pt>
                <c:pt idx="197">
                  <c:v>1</c:v>
                </c:pt>
                <c:pt idx="198">
                  <c:v>1</c:v>
                </c:pt>
                <c:pt idx="199">
                  <c:v>1</c:v>
                </c:pt>
                <c:pt idx="200">
                  <c:v>1</c:v>
                </c:pt>
                <c:pt idx="201">
                  <c:v>1</c:v>
                </c:pt>
                <c:pt idx="202">
                  <c:v>1</c:v>
                </c:pt>
                <c:pt idx="203">
                  <c:v>1</c:v>
                </c:pt>
                <c:pt idx="204">
                  <c:v>1</c:v>
                </c:pt>
                <c:pt idx="205">
                  <c:v>1</c:v>
                </c:pt>
                <c:pt idx="206">
                  <c:v>1</c:v>
                </c:pt>
                <c:pt idx="207">
                  <c:v>1</c:v>
                </c:pt>
                <c:pt idx="208">
                  <c:v>1</c:v>
                </c:pt>
                <c:pt idx="209">
                  <c:v>1</c:v>
                </c:pt>
                <c:pt idx="210">
                  <c:v>1</c:v>
                </c:pt>
                <c:pt idx="211">
                  <c:v>1</c:v>
                </c:pt>
                <c:pt idx="212">
                  <c:v>1</c:v>
                </c:pt>
                <c:pt idx="213">
                  <c:v>1</c:v>
                </c:pt>
                <c:pt idx="214">
                  <c:v>1</c:v>
                </c:pt>
                <c:pt idx="215">
                  <c:v>1</c:v>
                </c:pt>
                <c:pt idx="216">
                  <c:v>1</c:v>
                </c:pt>
                <c:pt idx="217">
                  <c:v>1</c:v>
                </c:pt>
                <c:pt idx="218">
                  <c:v>1</c:v>
                </c:pt>
                <c:pt idx="219">
                  <c:v>1</c:v>
                </c:pt>
                <c:pt idx="220">
                  <c:v>1</c:v>
                </c:pt>
                <c:pt idx="221">
                  <c:v>1</c:v>
                </c:pt>
                <c:pt idx="222">
                  <c:v>1</c:v>
                </c:pt>
                <c:pt idx="223">
                  <c:v>1</c:v>
                </c:pt>
                <c:pt idx="224">
                  <c:v>1</c:v>
                </c:pt>
                <c:pt idx="225">
                  <c:v>1</c:v>
                </c:pt>
                <c:pt idx="226">
                  <c:v>1</c:v>
                </c:pt>
                <c:pt idx="227">
                  <c:v>1</c:v>
                </c:pt>
                <c:pt idx="228">
                  <c:v>1</c:v>
                </c:pt>
                <c:pt idx="229">
                  <c:v>1</c:v>
                </c:pt>
                <c:pt idx="230">
                  <c:v>1</c:v>
                </c:pt>
                <c:pt idx="231">
                  <c:v>1</c:v>
                </c:pt>
                <c:pt idx="232">
                  <c:v>1</c:v>
                </c:pt>
                <c:pt idx="233">
                  <c:v>1</c:v>
                </c:pt>
                <c:pt idx="234">
                  <c:v>1</c:v>
                </c:pt>
                <c:pt idx="235">
                  <c:v>1</c:v>
                </c:pt>
                <c:pt idx="236">
                  <c:v>1</c:v>
                </c:pt>
                <c:pt idx="237">
                  <c:v>1</c:v>
                </c:pt>
                <c:pt idx="238">
                  <c:v>1</c:v>
                </c:pt>
                <c:pt idx="239">
                  <c:v>1</c:v>
                </c:pt>
                <c:pt idx="240">
                  <c:v>1</c:v>
                </c:pt>
                <c:pt idx="241">
                  <c:v>1</c:v>
                </c:pt>
                <c:pt idx="242">
                  <c:v>1</c:v>
                </c:pt>
                <c:pt idx="243">
                  <c:v>1</c:v>
                </c:pt>
                <c:pt idx="244">
                  <c:v>1</c:v>
                </c:pt>
                <c:pt idx="245">
                  <c:v>1</c:v>
                </c:pt>
                <c:pt idx="246">
                  <c:v>1</c:v>
                </c:pt>
                <c:pt idx="247">
                  <c:v>1</c:v>
                </c:pt>
                <c:pt idx="248">
                  <c:v>1</c:v>
                </c:pt>
                <c:pt idx="249">
                  <c:v>1</c:v>
                </c:pt>
                <c:pt idx="250">
                  <c:v>1</c:v>
                </c:pt>
                <c:pt idx="251">
                  <c:v>1</c:v>
                </c:pt>
                <c:pt idx="252">
                  <c:v>1</c:v>
                </c:pt>
                <c:pt idx="253">
                  <c:v>1</c:v>
                </c:pt>
                <c:pt idx="254">
                  <c:v>1</c:v>
                </c:pt>
                <c:pt idx="255">
                  <c:v>1</c:v>
                </c:pt>
                <c:pt idx="256">
                  <c:v>1</c:v>
                </c:pt>
                <c:pt idx="257">
                  <c:v>1</c:v>
                </c:pt>
                <c:pt idx="258">
                  <c:v>1</c:v>
                </c:pt>
                <c:pt idx="259">
                  <c:v>1</c:v>
                </c:pt>
                <c:pt idx="260">
                  <c:v>1</c:v>
                </c:pt>
                <c:pt idx="261">
                  <c:v>1</c:v>
                </c:pt>
                <c:pt idx="262">
                  <c:v>1</c:v>
                </c:pt>
                <c:pt idx="263">
                  <c:v>1</c:v>
                </c:pt>
                <c:pt idx="264">
                  <c:v>1</c:v>
                </c:pt>
                <c:pt idx="265">
                  <c:v>1</c:v>
                </c:pt>
                <c:pt idx="266">
                  <c:v>1</c:v>
                </c:pt>
                <c:pt idx="267">
                  <c:v>1</c:v>
                </c:pt>
                <c:pt idx="268">
                  <c:v>1</c:v>
                </c:pt>
                <c:pt idx="269">
                  <c:v>1</c:v>
                </c:pt>
                <c:pt idx="270">
                  <c:v>1</c:v>
                </c:pt>
                <c:pt idx="271">
                  <c:v>1</c:v>
                </c:pt>
                <c:pt idx="272">
                  <c:v>1</c:v>
                </c:pt>
                <c:pt idx="273">
                  <c:v>1</c:v>
                </c:pt>
                <c:pt idx="274">
                  <c:v>1</c:v>
                </c:pt>
                <c:pt idx="275">
                  <c:v>1</c:v>
                </c:pt>
                <c:pt idx="276">
                  <c:v>1</c:v>
                </c:pt>
                <c:pt idx="277">
                  <c:v>1</c:v>
                </c:pt>
                <c:pt idx="278">
                  <c:v>1</c:v>
                </c:pt>
                <c:pt idx="279">
                  <c:v>1</c:v>
                </c:pt>
                <c:pt idx="280">
                  <c:v>1</c:v>
                </c:pt>
                <c:pt idx="281">
                  <c:v>1</c:v>
                </c:pt>
                <c:pt idx="282">
                  <c:v>1</c:v>
                </c:pt>
                <c:pt idx="283">
                  <c:v>1</c:v>
                </c:pt>
                <c:pt idx="284">
                  <c:v>1</c:v>
                </c:pt>
                <c:pt idx="285">
                  <c:v>1</c:v>
                </c:pt>
                <c:pt idx="286">
                  <c:v>1</c:v>
                </c:pt>
                <c:pt idx="287">
                  <c:v>1</c:v>
                </c:pt>
                <c:pt idx="288">
                  <c:v>1</c:v>
                </c:pt>
                <c:pt idx="289">
                  <c:v>1</c:v>
                </c:pt>
                <c:pt idx="290">
                  <c:v>1</c:v>
                </c:pt>
                <c:pt idx="291">
                  <c:v>1</c:v>
                </c:pt>
                <c:pt idx="292">
                  <c:v>1</c:v>
                </c:pt>
                <c:pt idx="293">
                  <c:v>1</c:v>
                </c:pt>
                <c:pt idx="294">
                  <c:v>1</c:v>
                </c:pt>
                <c:pt idx="295">
                  <c:v>1</c:v>
                </c:pt>
                <c:pt idx="296">
                  <c:v>1</c:v>
                </c:pt>
                <c:pt idx="297">
                  <c:v>1</c:v>
                </c:pt>
                <c:pt idx="298">
                  <c:v>1</c:v>
                </c:pt>
                <c:pt idx="299">
                  <c:v>1</c:v>
                </c:pt>
                <c:pt idx="300">
                  <c:v>1</c:v>
                </c:pt>
                <c:pt idx="301">
                  <c:v>1</c:v>
                </c:pt>
                <c:pt idx="302">
                  <c:v>1</c:v>
                </c:pt>
                <c:pt idx="303">
                  <c:v>1</c:v>
                </c:pt>
                <c:pt idx="304">
                  <c:v>1</c:v>
                </c:pt>
                <c:pt idx="305">
                  <c:v>1</c:v>
                </c:pt>
                <c:pt idx="306">
                  <c:v>1</c:v>
                </c:pt>
                <c:pt idx="307">
                  <c:v>1</c:v>
                </c:pt>
                <c:pt idx="308">
                  <c:v>1</c:v>
                </c:pt>
                <c:pt idx="309">
                  <c:v>1</c:v>
                </c:pt>
                <c:pt idx="310">
                  <c:v>1</c:v>
                </c:pt>
                <c:pt idx="311">
                  <c:v>1</c:v>
                </c:pt>
                <c:pt idx="312">
                  <c:v>1</c:v>
                </c:pt>
                <c:pt idx="313">
                  <c:v>1</c:v>
                </c:pt>
                <c:pt idx="314">
                  <c:v>1</c:v>
                </c:pt>
                <c:pt idx="315">
                  <c:v>1</c:v>
                </c:pt>
                <c:pt idx="316">
                  <c:v>1</c:v>
                </c:pt>
                <c:pt idx="317">
                  <c:v>1</c:v>
                </c:pt>
                <c:pt idx="318">
                  <c:v>1</c:v>
                </c:pt>
                <c:pt idx="319">
                  <c:v>1</c:v>
                </c:pt>
                <c:pt idx="320">
                  <c:v>1</c:v>
                </c:pt>
                <c:pt idx="321">
                  <c:v>1</c:v>
                </c:pt>
                <c:pt idx="322">
                  <c:v>1</c:v>
                </c:pt>
                <c:pt idx="323">
                  <c:v>1</c:v>
                </c:pt>
                <c:pt idx="324">
                  <c:v>1</c:v>
                </c:pt>
                <c:pt idx="325">
                  <c:v>1</c:v>
                </c:pt>
                <c:pt idx="326">
                  <c:v>1</c:v>
                </c:pt>
                <c:pt idx="327">
                  <c:v>1</c:v>
                </c:pt>
                <c:pt idx="328">
                  <c:v>1</c:v>
                </c:pt>
                <c:pt idx="329">
                  <c:v>1</c:v>
                </c:pt>
                <c:pt idx="330">
                  <c:v>1</c:v>
                </c:pt>
                <c:pt idx="331">
                  <c:v>1</c:v>
                </c:pt>
                <c:pt idx="33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298-A2EB-4566-9B46-DAC7DE36ADA2}"/>
            </c:ext>
          </c:extLst>
        </c:ser>
        <c:ser>
          <c:idx val="1"/>
          <c:order val="1"/>
          <c:tx>
            <c:v>MDA-MB-361 TR</c:v>
          </c:tx>
          <c:spPr>
            <a:solidFill>
              <a:srgbClr val="000000"/>
            </a:solidFill>
            <a:ln w="25400"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9A-A2EB-4566-9B46-DAC7DE36ADA2}"/>
              </c:ext>
            </c:extLst>
          </c:dPt>
          <c:dPt>
            <c:idx val="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9C-A2EB-4566-9B46-DAC7DE36ADA2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9E-A2EB-4566-9B46-DAC7DE36ADA2}"/>
              </c:ext>
            </c:extLst>
          </c:dPt>
          <c:dPt>
            <c:idx val="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A0-A2EB-4566-9B46-DAC7DE36ADA2}"/>
              </c:ext>
            </c:extLst>
          </c:dPt>
          <c:dPt>
            <c:idx val="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A2-A2EB-4566-9B46-DAC7DE36ADA2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A4-A2EB-4566-9B46-DAC7DE36ADA2}"/>
              </c:ext>
            </c:extLst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A6-A2EB-4566-9B46-DAC7DE36ADA2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A8-A2EB-4566-9B46-DAC7DE36ADA2}"/>
              </c:ext>
            </c:extLst>
          </c:dPt>
          <c:dPt>
            <c:idx val="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AA-A2EB-4566-9B46-DAC7DE36ADA2}"/>
              </c:ext>
            </c:extLst>
          </c:dPt>
          <c:dPt>
            <c:idx val="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AC-A2EB-4566-9B46-DAC7DE36ADA2}"/>
              </c:ext>
            </c:extLst>
          </c:dPt>
          <c:dPt>
            <c:idx val="1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AE-A2EB-4566-9B46-DAC7DE36ADA2}"/>
              </c:ext>
            </c:extLst>
          </c:dPt>
          <c:dPt>
            <c:idx val="1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B0-A2EB-4566-9B46-DAC7DE36ADA2}"/>
              </c:ext>
            </c:extLst>
          </c:dPt>
          <c:dPt>
            <c:idx val="1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B2-A2EB-4566-9B46-DAC7DE36ADA2}"/>
              </c:ext>
            </c:extLst>
          </c:dPt>
          <c:dPt>
            <c:idx val="1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B4-A2EB-4566-9B46-DAC7DE36ADA2}"/>
              </c:ext>
            </c:extLst>
          </c:dPt>
          <c:dPt>
            <c:idx val="1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B6-A2EB-4566-9B46-DAC7DE36ADA2}"/>
              </c:ext>
            </c:extLst>
          </c:dPt>
          <c:dPt>
            <c:idx val="1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B8-A2EB-4566-9B46-DAC7DE36ADA2}"/>
              </c:ext>
            </c:extLst>
          </c:dPt>
          <c:dPt>
            <c:idx val="1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BA-A2EB-4566-9B46-DAC7DE36ADA2}"/>
              </c:ext>
            </c:extLst>
          </c:dPt>
          <c:dPt>
            <c:idx val="1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BC-A2EB-4566-9B46-DAC7DE36ADA2}"/>
              </c:ext>
            </c:extLst>
          </c:dPt>
          <c:dPt>
            <c:idx val="1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BE-A2EB-4566-9B46-DAC7DE36ADA2}"/>
              </c:ext>
            </c:extLst>
          </c:dPt>
          <c:dPt>
            <c:idx val="1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C0-A2EB-4566-9B46-DAC7DE36ADA2}"/>
              </c:ext>
            </c:extLst>
          </c:dPt>
          <c:dPt>
            <c:idx val="2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C2-A2EB-4566-9B46-DAC7DE36ADA2}"/>
              </c:ext>
            </c:extLst>
          </c:dPt>
          <c:dPt>
            <c:idx val="2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C4-A2EB-4566-9B46-DAC7DE36ADA2}"/>
              </c:ext>
            </c:extLst>
          </c:dPt>
          <c:dPt>
            <c:idx val="2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C6-A2EB-4566-9B46-DAC7DE36ADA2}"/>
              </c:ext>
            </c:extLst>
          </c:dPt>
          <c:dPt>
            <c:idx val="2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C8-A2EB-4566-9B46-DAC7DE36ADA2}"/>
              </c:ext>
            </c:extLst>
          </c:dPt>
          <c:dPt>
            <c:idx val="2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CA-A2EB-4566-9B46-DAC7DE36ADA2}"/>
              </c:ext>
            </c:extLst>
          </c:dPt>
          <c:dPt>
            <c:idx val="2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CC-A2EB-4566-9B46-DAC7DE36ADA2}"/>
              </c:ext>
            </c:extLst>
          </c:dPt>
          <c:dPt>
            <c:idx val="2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CE-A2EB-4566-9B46-DAC7DE36ADA2}"/>
              </c:ext>
            </c:extLst>
          </c:dPt>
          <c:dPt>
            <c:idx val="2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D0-A2EB-4566-9B46-DAC7DE36ADA2}"/>
              </c:ext>
            </c:extLst>
          </c:dPt>
          <c:dPt>
            <c:idx val="2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D2-A2EB-4566-9B46-DAC7DE36ADA2}"/>
              </c:ext>
            </c:extLst>
          </c:dPt>
          <c:dPt>
            <c:idx val="2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D4-A2EB-4566-9B46-DAC7DE36ADA2}"/>
              </c:ext>
            </c:extLst>
          </c:dPt>
          <c:dPt>
            <c:idx val="3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D6-A2EB-4566-9B46-DAC7DE36ADA2}"/>
              </c:ext>
            </c:extLst>
          </c:dPt>
          <c:dPt>
            <c:idx val="3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D8-A2EB-4566-9B46-DAC7DE36ADA2}"/>
              </c:ext>
            </c:extLst>
          </c:dPt>
          <c:dPt>
            <c:idx val="3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DA-A2EB-4566-9B46-DAC7DE36ADA2}"/>
              </c:ext>
            </c:extLst>
          </c:dPt>
          <c:dPt>
            <c:idx val="3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DC-A2EB-4566-9B46-DAC7DE36ADA2}"/>
              </c:ext>
            </c:extLst>
          </c:dPt>
          <c:dPt>
            <c:idx val="3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DE-A2EB-4566-9B46-DAC7DE36ADA2}"/>
              </c:ext>
            </c:extLst>
          </c:dPt>
          <c:dPt>
            <c:idx val="3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E0-A2EB-4566-9B46-DAC7DE36ADA2}"/>
              </c:ext>
            </c:extLst>
          </c:dPt>
          <c:dPt>
            <c:idx val="3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E2-A2EB-4566-9B46-DAC7DE36ADA2}"/>
              </c:ext>
            </c:extLst>
          </c:dPt>
          <c:dPt>
            <c:idx val="3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E4-A2EB-4566-9B46-DAC7DE36ADA2}"/>
              </c:ext>
            </c:extLst>
          </c:dPt>
          <c:dPt>
            <c:idx val="3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E6-A2EB-4566-9B46-DAC7DE36ADA2}"/>
              </c:ext>
            </c:extLst>
          </c:dPt>
          <c:dPt>
            <c:idx val="3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E8-A2EB-4566-9B46-DAC7DE36ADA2}"/>
              </c:ext>
            </c:extLst>
          </c:dPt>
          <c:dPt>
            <c:idx val="4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EA-A2EB-4566-9B46-DAC7DE36ADA2}"/>
              </c:ext>
            </c:extLst>
          </c:dPt>
          <c:dPt>
            <c:idx val="4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EC-A2EB-4566-9B46-DAC7DE36ADA2}"/>
              </c:ext>
            </c:extLst>
          </c:dPt>
          <c:dPt>
            <c:idx val="4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EE-A2EB-4566-9B46-DAC7DE36ADA2}"/>
              </c:ext>
            </c:extLst>
          </c:dPt>
          <c:dPt>
            <c:idx val="4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F0-A2EB-4566-9B46-DAC7DE36ADA2}"/>
              </c:ext>
            </c:extLst>
          </c:dPt>
          <c:dPt>
            <c:idx val="4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F2-A2EB-4566-9B46-DAC7DE36ADA2}"/>
              </c:ext>
            </c:extLst>
          </c:dPt>
          <c:dPt>
            <c:idx val="4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F4-A2EB-4566-9B46-DAC7DE36ADA2}"/>
              </c:ext>
            </c:extLst>
          </c:dPt>
          <c:dPt>
            <c:idx val="4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F6-A2EB-4566-9B46-DAC7DE36ADA2}"/>
              </c:ext>
            </c:extLst>
          </c:dPt>
          <c:dPt>
            <c:idx val="4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F8-A2EB-4566-9B46-DAC7DE36ADA2}"/>
              </c:ext>
            </c:extLst>
          </c:dPt>
          <c:dPt>
            <c:idx val="4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FA-A2EB-4566-9B46-DAC7DE36ADA2}"/>
              </c:ext>
            </c:extLst>
          </c:dPt>
          <c:dPt>
            <c:idx val="4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FC-A2EB-4566-9B46-DAC7DE36ADA2}"/>
              </c:ext>
            </c:extLst>
          </c:dPt>
          <c:dPt>
            <c:idx val="5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2FE-A2EB-4566-9B46-DAC7DE36ADA2}"/>
              </c:ext>
            </c:extLst>
          </c:dPt>
          <c:dPt>
            <c:idx val="5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00-A2EB-4566-9B46-DAC7DE36ADA2}"/>
              </c:ext>
            </c:extLst>
          </c:dPt>
          <c:dPt>
            <c:idx val="5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02-A2EB-4566-9B46-DAC7DE36ADA2}"/>
              </c:ext>
            </c:extLst>
          </c:dPt>
          <c:dPt>
            <c:idx val="5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04-A2EB-4566-9B46-DAC7DE36ADA2}"/>
              </c:ext>
            </c:extLst>
          </c:dPt>
          <c:dPt>
            <c:idx val="5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06-A2EB-4566-9B46-DAC7DE36ADA2}"/>
              </c:ext>
            </c:extLst>
          </c:dPt>
          <c:dPt>
            <c:idx val="5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08-A2EB-4566-9B46-DAC7DE36ADA2}"/>
              </c:ext>
            </c:extLst>
          </c:dPt>
          <c:dPt>
            <c:idx val="5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0A-A2EB-4566-9B46-DAC7DE36ADA2}"/>
              </c:ext>
            </c:extLst>
          </c:dPt>
          <c:dPt>
            <c:idx val="5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0C-A2EB-4566-9B46-DAC7DE36ADA2}"/>
              </c:ext>
            </c:extLst>
          </c:dPt>
          <c:dPt>
            <c:idx val="5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0E-A2EB-4566-9B46-DAC7DE36ADA2}"/>
              </c:ext>
            </c:extLst>
          </c:dPt>
          <c:dPt>
            <c:idx val="5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10-A2EB-4566-9B46-DAC7DE36ADA2}"/>
              </c:ext>
            </c:extLst>
          </c:dPt>
          <c:dPt>
            <c:idx val="6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12-A2EB-4566-9B46-DAC7DE36ADA2}"/>
              </c:ext>
            </c:extLst>
          </c:dPt>
          <c:dPt>
            <c:idx val="6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14-A2EB-4566-9B46-DAC7DE36ADA2}"/>
              </c:ext>
            </c:extLst>
          </c:dPt>
          <c:dPt>
            <c:idx val="6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16-A2EB-4566-9B46-DAC7DE36ADA2}"/>
              </c:ext>
            </c:extLst>
          </c:dPt>
          <c:dPt>
            <c:idx val="6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18-A2EB-4566-9B46-DAC7DE36ADA2}"/>
              </c:ext>
            </c:extLst>
          </c:dPt>
          <c:dPt>
            <c:idx val="6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1A-A2EB-4566-9B46-DAC7DE36ADA2}"/>
              </c:ext>
            </c:extLst>
          </c:dPt>
          <c:dPt>
            <c:idx val="6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1C-A2EB-4566-9B46-DAC7DE36ADA2}"/>
              </c:ext>
            </c:extLst>
          </c:dPt>
          <c:dPt>
            <c:idx val="6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1E-A2EB-4566-9B46-DAC7DE36ADA2}"/>
              </c:ext>
            </c:extLst>
          </c:dPt>
          <c:dPt>
            <c:idx val="6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20-A2EB-4566-9B46-DAC7DE36ADA2}"/>
              </c:ext>
            </c:extLst>
          </c:dPt>
          <c:dPt>
            <c:idx val="6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22-A2EB-4566-9B46-DAC7DE36ADA2}"/>
              </c:ext>
            </c:extLst>
          </c:dPt>
          <c:dPt>
            <c:idx val="6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24-A2EB-4566-9B46-DAC7DE36ADA2}"/>
              </c:ext>
            </c:extLst>
          </c:dPt>
          <c:dPt>
            <c:idx val="7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26-A2EB-4566-9B46-DAC7DE36ADA2}"/>
              </c:ext>
            </c:extLst>
          </c:dPt>
          <c:dPt>
            <c:idx val="7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28-A2EB-4566-9B46-DAC7DE36ADA2}"/>
              </c:ext>
            </c:extLst>
          </c:dPt>
          <c:dPt>
            <c:idx val="7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2A-A2EB-4566-9B46-DAC7DE36ADA2}"/>
              </c:ext>
            </c:extLst>
          </c:dPt>
          <c:dPt>
            <c:idx val="7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2C-A2EB-4566-9B46-DAC7DE36ADA2}"/>
              </c:ext>
            </c:extLst>
          </c:dPt>
          <c:dPt>
            <c:idx val="7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2E-A2EB-4566-9B46-DAC7DE36ADA2}"/>
              </c:ext>
            </c:extLst>
          </c:dPt>
          <c:dPt>
            <c:idx val="7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30-A2EB-4566-9B46-DAC7DE36ADA2}"/>
              </c:ext>
            </c:extLst>
          </c:dPt>
          <c:dPt>
            <c:idx val="7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32-A2EB-4566-9B46-DAC7DE36ADA2}"/>
              </c:ext>
            </c:extLst>
          </c:dPt>
          <c:dPt>
            <c:idx val="7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34-A2EB-4566-9B46-DAC7DE36ADA2}"/>
              </c:ext>
            </c:extLst>
          </c:dPt>
          <c:dPt>
            <c:idx val="7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36-A2EB-4566-9B46-DAC7DE36ADA2}"/>
              </c:ext>
            </c:extLst>
          </c:dPt>
          <c:dPt>
            <c:idx val="7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38-A2EB-4566-9B46-DAC7DE36ADA2}"/>
              </c:ext>
            </c:extLst>
          </c:dPt>
          <c:dPt>
            <c:idx val="8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3A-A2EB-4566-9B46-DAC7DE36ADA2}"/>
              </c:ext>
            </c:extLst>
          </c:dPt>
          <c:dPt>
            <c:idx val="8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3C-A2EB-4566-9B46-DAC7DE36ADA2}"/>
              </c:ext>
            </c:extLst>
          </c:dPt>
          <c:dPt>
            <c:idx val="8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3E-A2EB-4566-9B46-DAC7DE36ADA2}"/>
              </c:ext>
            </c:extLst>
          </c:dPt>
          <c:dPt>
            <c:idx val="8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40-A2EB-4566-9B46-DAC7DE36ADA2}"/>
              </c:ext>
            </c:extLst>
          </c:dPt>
          <c:dPt>
            <c:idx val="8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42-A2EB-4566-9B46-DAC7DE36ADA2}"/>
              </c:ext>
            </c:extLst>
          </c:dPt>
          <c:dPt>
            <c:idx val="8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44-A2EB-4566-9B46-DAC7DE36ADA2}"/>
              </c:ext>
            </c:extLst>
          </c:dPt>
          <c:dPt>
            <c:idx val="8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46-A2EB-4566-9B46-DAC7DE36ADA2}"/>
              </c:ext>
            </c:extLst>
          </c:dPt>
          <c:dPt>
            <c:idx val="8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48-A2EB-4566-9B46-DAC7DE36ADA2}"/>
              </c:ext>
            </c:extLst>
          </c:dPt>
          <c:dPt>
            <c:idx val="8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4A-A2EB-4566-9B46-DAC7DE36ADA2}"/>
              </c:ext>
            </c:extLst>
          </c:dPt>
          <c:dPt>
            <c:idx val="8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4C-A2EB-4566-9B46-DAC7DE36ADA2}"/>
              </c:ext>
            </c:extLst>
          </c:dPt>
          <c:dPt>
            <c:idx val="9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4E-A2EB-4566-9B46-DAC7DE36ADA2}"/>
              </c:ext>
            </c:extLst>
          </c:dPt>
          <c:dPt>
            <c:idx val="9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50-A2EB-4566-9B46-DAC7DE36ADA2}"/>
              </c:ext>
            </c:extLst>
          </c:dPt>
          <c:dPt>
            <c:idx val="9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52-A2EB-4566-9B46-DAC7DE36ADA2}"/>
              </c:ext>
            </c:extLst>
          </c:dPt>
          <c:dPt>
            <c:idx val="9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54-A2EB-4566-9B46-DAC7DE36ADA2}"/>
              </c:ext>
            </c:extLst>
          </c:dPt>
          <c:dPt>
            <c:idx val="9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56-A2EB-4566-9B46-DAC7DE36ADA2}"/>
              </c:ext>
            </c:extLst>
          </c:dPt>
          <c:dPt>
            <c:idx val="9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58-A2EB-4566-9B46-DAC7DE36ADA2}"/>
              </c:ext>
            </c:extLst>
          </c:dPt>
          <c:dPt>
            <c:idx val="9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5A-A2EB-4566-9B46-DAC7DE36ADA2}"/>
              </c:ext>
            </c:extLst>
          </c:dPt>
          <c:dPt>
            <c:idx val="9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5C-A2EB-4566-9B46-DAC7DE36ADA2}"/>
              </c:ext>
            </c:extLst>
          </c:dPt>
          <c:dPt>
            <c:idx val="9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5E-A2EB-4566-9B46-DAC7DE36ADA2}"/>
              </c:ext>
            </c:extLst>
          </c:dPt>
          <c:dPt>
            <c:idx val="9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60-A2EB-4566-9B46-DAC7DE36ADA2}"/>
              </c:ext>
            </c:extLst>
          </c:dPt>
          <c:dPt>
            <c:idx val="10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62-A2EB-4566-9B46-DAC7DE36ADA2}"/>
              </c:ext>
            </c:extLst>
          </c:dPt>
          <c:dPt>
            <c:idx val="10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64-A2EB-4566-9B46-DAC7DE36ADA2}"/>
              </c:ext>
            </c:extLst>
          </c:dPt>
          <c:dPt>
            <c:idx val="10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66-A2EB-4566-9B46-DAC7DE36ADA2}"/>
              </c:ext>
            </c:extLst>
          </c:dPt>
          <c:dPt>
            <c:idx val="10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68-A2EB-4566-9B46-DAC7DE36ADA2}"/>
              </c:ext>
            </c:extLst>
          </c:dPt>
          <c:dPt>
            <c:idx val="10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6A-A2EB-4566-9B46-DAC7DE36ADA2}"/>
              </c:ext>
            </c:extLst>
          </c:dPt>
          <c:dPt>
            <c:idx val="10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6C-A2EB-4566-9B46-DAC7DE36ADA2}"/>
              </c:ext>
            </c:extLst>
          </c:dPt>
          <c:dPt>
            <c:idx val="10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6E-A2EB-4566-9B46-DAC7DE36ADA2}"/>
              </c:ext>
            </c:extLst>
          </c:dPt>
          <c:dPt>
            <c:idx val="10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70-A2EB-4566-9B46-DAC7DE36ADA2}"/>
              </c:ext>
            </c:extLst>
          </c:dPt>
          <c:dPt>
            <c:idx val="10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72-A2EB-4566-9B46-DAC7DE36ADA2}"/>
              </c:ext>
            </c:extLst>
          </c:dPt>
          <c:dPt>
            <c:idx val="10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74-A2EB-4566-9B46-DAC7DE36ADA2}"/>
              </c:ext>
            </c:extLst>
          </c:dPt>
          <c:dPt>
            <c:idx val="11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76-A2EB-4566-9B46-DAC7DE36ADA2}"/>
              </c:ext>
            </c:extLst>
          </c:dPt>
          <c:dPt>
            <c:idx val="11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78-A2EB-4566-9B46-DAC7DE36ADA2}"/>
              </c:ext>
            </c:extLst>
          </c:dPt>
          <c:dPt>
            <c:idx val="11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7A-A2EB-4566-9B46-DAC7DE36ADA2}"/>
              </c:ext>
            </c:extLst>
          </c:dPt>
          <c:dPt>
            <c:idx val="11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7C-A2EB-4566-9B46-DAC7DE36ADA2}"/>
              </c:ext>
            </c:extLst>
          </c:dPt>
          <c:dPt>
            <c:idx val="11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7E-A2EB-4566-9B46-DAC7DE36ADA2}"/>
              </c:ext>
            </c:extLst>
          </c:dPt>
          <c:dPt>
            <c:idx val="11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80-A2EB-4566-9B46-DAC7DE36ADA2}"/>
              </c:ext>
            </c:extLst>
          </c:dPt>
          <c:dPt>
            <c:idx val="11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82-A2EB-4566-9B46-DAC7DE36ADA2}"/>
              </c:ext>
            </c:extLst>
          </c:dPt>
          <c:dPt>
            <c:idx val="11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84-A2EB-4566-9B46-DAC7DE36ADA2}"/>
              </c:ext>
            </c:extLst>
          </c:dPt>
          <c:dPt>
            <c:idx val="11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86-A2EB-4566-9B46-DAC7DE36ADA2}"/>
              </c:ext>
            </c:extLst>
          </c:dPt>
          <c:dPt>
            <c:idx val="11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88-A2EB-4566-9B46-DAC7DE36ADA2}"/>
              </c:ext>
            </c:extLst>
          </c:dPt>
          <c:dPt>
            <c:idx val="12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8A-A2EB-4566-9B46-DAC7DE36ADA2}"/>
              </c:ext>
            </c:extLst>
          </c:dPt>
          <c:dPt>
            <c:idx val="12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8C-A2EB-4566-9B46-DAC7DE36ADA2}"/>
              </c:ext>
            </c:extLst>
          </c:dPt>
          <c:dPt>
            <c:idx val="12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8E-A2EB-4566-9B46-DAC7DE36ADA2}"/>
              </c:ext>
            </c:extLst>
          </c:dPt>
          <c:dPt>
            <c:idx val="12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90-A2EB-4566-9B46-DAC7DE36ADA2}"/>
              </c:ext>
            </c:extLst>
          </c:dPt>
          <c:dPt>
            <c:idx val="12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92-A2EB-4566-9B46-DAC7DE36ADA2}"/>
              </c:ext>
            </c:extLst>
          </c:dPt>
          <c:dPt>
            <c:idx val="12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94-A2EB-4566-9B46-DAC7DE36ADA2}"/>
              </c:ext>
            </c:extLst>
          </c:dPt>
          <c:dPt>
            <c:idx val="12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96-A2EB-4566-9B46-DAC7DE36ADA2}"/>
              </c:ext>
            </c:extLst>
          </c:dPt>
          <c:dPt>
            <c:idx val="12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98-A2EB-4566-9B46-DAC7DE36ADA2}"/>
              </c:ext>
            </c:extLst>
          </c:dPt>
          <c:dPt>
            <c:idx val="12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9A-A2EB-4566-9B46-DAC7DE36ADA2}"/>
              </c:ext>
            </c:extLst>
          </c:dPt>
          <c:dPt>
            <c:idx val="12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9C-A2EB-4566-9B46-DAC7DE36ADA2}"/>
              </c:ext>
            </c:extLst>
          </c:dPt>
          <c:dPt>
            <c:idx val="13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9E-A2EB-4566-9B46-DAC7DE36ADA2}"/>
              </c:ext>
            </c:extLst>
          </c:dPt>
          <c:dPt>
            <c:idx val="13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A0-A2EB-4566-9B46-DAC7DE36ADA2}"/>
              </c:ext>
            </c:extLst>
          </c:dPt>
          <c:dPt>
            <c:idx val="13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A2-A2EB-4566-9B46-DAC7DE36ADA2}"/>
              </c:ext>
            </c:extLst>
          </c:dPt>
          <c:dPt>
            <c:idx val="13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A4-A2EB-4566-9B46-DAC7DE36ADA2}"/>
              </c:ext>
            </c:extLst>
          </c:dPt>
          <c:dPt>
            <c:idx val="13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A6-A2EB-4566-9B46-DAC7DE36ADA2}"/>
              </c:ext>
            </c:extLst>
          </c:dPt>
          <c:dPt>
            <c:idx val="13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A8-A2EB-4566-9B46-DAC7DE36ADA2}"/>
              </c:ext>
            </c:extLst>
          </c:dPt>
          <c:dPt>
            <c:idx val="13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AA-A2EB-4566-9B46-DAC7DE36ADA2}"/>
              </c:ext>
            </c:extLst>
          </c:dPt>
          <c:dPt>
            <c:idx val="13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AC-A2EB-4566-9B46-DAC7DE36ADA2}"/>
              </c:ext>
            </c:extLst>
          </c:dPt>
          <c:dPt>
            <c:idx val="13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AE-A2EB-4566-9B46-DAC7DE36ADA2}"/>
              </c:ext>
            </c:extLst>
          </c:dPt>
          <c:dPt>
            <c:idx val="13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B0-A2EB-4566-9B46-DAC7DE36ADA2}"/>
              </c:ext>
            </c:extLst>
          </c:dPt>
          <c:dPt>
            <c:idx val="140"/>
            <c:invertIfNegative val="0"/>
            <c:bubble3D val="0"/>
            <c:spPr>
              <a:solidFill>
                <a:srgbClr val="46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B2-A2EB-4566-9B46-DAC7DE36ADA2}"/>
              </c:ext>
            </c:extLst>
          </c:dPt>
          <c:dPt>
            <c:idx val="14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B4-A2EB-4566-9B46-DAC7DE36ADA2}"/>
              </c:ext>
            </c:extLst>
          </c:dPt>
          <c:dPt>
            <c:idx val="14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B6-A2EB-4566-9B46-DAC7DE36ADA2}"/>
              </c:ext>
            </c:extLst>
          </c:dPt>
          <c:dPt>
            <c:idx val="14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B8-A2EB-4566-9B46-DAC7DE36ADA2}"/>
              </c:ext>
            </c:extLst>
          </c:dPt>
          <c:dPt>
            <c:idx val="14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BA-A2EB-4566-9B46-DAC7DE36ADA2}"/>
              </c:ext>
            </c:extLst>
          </c:dPt>
          <c:dPt>
            <c:idx val="14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BC-A2EB-4566-9B46-DAC7DE36ADA2}"/>
              </c:ext>
            </c:extLst>
          </c:dPt>
          <c:dPt>
            <c:idx val="14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BE-A2EB-4566-9B46-DAC7DE36ADA2}"/>
              </c:ext>
            </c:extLst>
          </c:dPt>
          <c:dPt>
            <c:idx val="14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C0-A2EB-4566-9B46-DAC7DE36ADA2}"/>
              </c:ext>
            </c:extLst>
          </c:dPt>
          <c:dPt>
            <c:idx val="14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C2-A2EB-4566-9B46-DAC7DE36ADA2}"/>
              </c:ext>
            </c:extLst>
          </c:dPt>
          <c:dPt>
            <c:idx val="14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C4-A2EB-4566-9B46-DAC7DE36ADA2}"/>
              </c:ext>
            </c:extLst>
          </c:dPt>
          <c:dPt>
            <c:idx val="15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C6-A2EB-4566-9B46-DAC7DE36ADA2}"/>
              </c:ext>
            </c:extLst>
          </c:dPt>
          <c:dPt>
            <c:idx val="15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C8-A2EB-4566-9B46-DAC7DE36ADA2}"/>
              </c:ext>
            </c:extLst>
          </c:dPt>
          <c:dPt>
            <c:idx val="15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CA-A2EB-4566-9B46-DAC7DE36ADA2}"/>
              </c:ext>
            </c:extLst>
          </c:dPt>
          <c:dPt>
            <c:idx val="15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CC-A2EB-4566-9B46-DAC7DE36ADA2}"/>
              </c:ext>
            </c:extLst>
          </c:dPt>
          <c:dPt>
            <c:idx val="15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CE-A2EB-4566-9B46-DAC7DE36ADA2}"/>
              </c:ext>
            </c:extLst>
          </c:dPt>
          <c:dPt>
            <c:idx val="15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D0-A2EB-4566-9B46-DAC7DE36ADA2}"/>
              </c:ext>
            </c:extLst>
          </c:dPt>
          <c:dPt>
            <c:idx val="15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D2-A2EB-4566-9B46-DAC7DE36ADA2}"/>
              </c:ext>
            </c:extLst>
          </c:dPt>
          <c:dPt>
            <c:idx val="15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D4-A2EB-4566-9B46-DAC7DE36ADA2}"/>
              </c:ext>
            </c:extLst>
          </c:dPt>
          <c:dPt>
            <c:idx val="15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D6-A2EB-4566-9B46-DAC7DE36ADA2}"/>
              </c:ext>
            </c:extLst>
          </c:dPt>
          <c:dPt>
            <c:idx val="15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D8-A2EB-4566-9B46-DAC7DE36ADA2}"/>
              </c:ext>
            </c:extLst>
          </c:dPt>
          <c:dPt>
            <c:idx val="16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DA-A2EB-4566-9B46-DAC7DE36ADA2}"/>
              </c:ext>
            </c:extLst>
          </c:dPt>
          <c:dPt>
            <c:idx val="16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DC-A2EB-4566-9B46-DAC7DE36ADA2}"/>
              </c:ext>
            </c:extLst>
          </c:dPt>
          <c:dPt>
            <c:idx val="16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DE-A2EB-4566-9B46-DAC7DE36ADA2}"/>
              </c:ext>
            </c:extLst>
          </c:dPt>
          <c:dPt>
            <c:idx val="16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E0-A2EB-4566-9B46-DAC7DE36ADA2}"/>
              </c:ext>
            </c:extLst>
          </c:dPt>
          <c:dPt>
            <c:idx val="16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E2-A2EB-4566-9B46-DAC7DE36ADA2}"/>
              </c:ext>
            </c:extLst>
          </c:dPt>
          <c:dPt>
            <c:idx val="16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E4-A2EB-4566-9B46-DAC7DE36ADA2}"/>
              </c:ext>
            </c:extLst>
          </c:dPt>
          <c:dPt>
            <c:idx val="16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E6-A2EB-4566-9B46-DAC7DE36ADA2}"/>
              </c:ext>
            </c:extLst>
          </c:dPt>
          <c:dPt>
            <c:idx val="16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E8-A2EB-4566-9B46-DAC7DE36ADA2}"/>
              </c:ext>
            </c:extLst>
          </c:dPt>
          <c:dPt>
            <c:idx val="16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EA-A2EB-4566-9B46-DAC7DE36ADA2}"/>
              </c:ext>
            </c:extLst>
          </c:dPt>
          <c:dPt>
            <c:idx val="16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EC-A2EB-4566-9B46-DAC7DE36ADA2}"/>
              </c:ext>
            </c:extLst>
          </c:dPt>
          <c:dPt>
            <c:idx val="17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EE-A2EB-4566-9B46-DAC7DE36ADA2}"/>
              </c:ext>
            </c:extLst>
          </c:dPt>
          <c:dPt>
            <c:idx val="17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F0-A2EB-4566-9B46-DAC7DE36ADA2}"/>
              </c:ext>
            </c:extLst>
          </c:dPt>
          <c:dPt>
            <c:idx val="17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F2-A2EB-4566-9B46-DAC7DE36ADA2}"/>
              </c:ext>
            </c:extLst>
          </c:dPt>
          <c:dPt>
            <c:idx val="17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F4-A2EB-4566-9B46-DAC7DE36ADA2}"/>
              </c:ext>
            </c:extLst>
          </c:dPt>
          <c:dPt>
            <c:idx val="17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F6-A2EB-4566-9B46-DAC7DE36ADA2}"/>
              </c:ext>
            </c:extLst>
          </c:dPt>
          <c:dPt>
            <c:idx val="17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F8-A2EB-4566-9B46-DAC7DE36ADA2}"/>
              </c:ext>
            </c:extLst>
          </c:dPt>
          <c:dPt>
            <c:idx val="17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FA-A2EB-4566-9B46-DAC7DE36ADA2}"/>
              </c:ext>
            </c:extLst>
          </c:dPt>
          <c:dPt>
            <c:idx val="17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FC-A2EB-4566-9B46-DAC7DE36ADA2}"/>
              </c:ext>
            </c:extLst>
          </c:dPt>
          <c:dPt>
            <c:idx val="17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3FE-A2EB-4566-9B46-DAC7DE36ADA2}"/>
              </c:ext>
            </c:extLst>
          </c:dPt>
          <c:dPt>
            <c:idx val="17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00-A2EB-4566-9B46-DAC7DE36ADA2}"/>
              </c:ext>
            </c:extLst>
          </c:dPt>
          <c:dPt>
            <c:idx val="18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02-A2EB-4566-9B46-DAC7DE36ADA2}"/>
              </c:ext>
            </c:extLst>
          </c:dPt>
          <c:dPt>
            <c:idx val="18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04-A2EB-4566-9B46-DAC7DE36ADA2}"/>
              </c:ext>
            </c:extLst>
          </c:dPt>
          <c:dPt>
            <c:idx val="182"/>
            <c:invertIfNegative val="0"/>
            <c:bubble3D val="0"/>
            <c:spPr>
              <a:solidFill>
                <a:srgbClr val="0064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06-A2EB-4566-9B46-DAC7DE36ADA2}"/>
              </c:ext>
            </c:extLst>
          </c:dPt>
          <c:dPt>
            <c:idx val="18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08-A2EB-4566-9B46-DAC7DE36ADA2}"/>
              </c:ext>
            </c:extLst>
          </c:dPt>
          <c:dPt>
            <c:idx val="18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0A-A2EB-4566-9B46-DAC7DE36ADA2}"/>
              </c:ext>
            </c:extLst>
          </c:dPt>
          <c:dPt>
            <c:idx val="18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0C-A2EB-4566-9B46-DAC7DE36ADA2}"/>
              </c:ext>
            </c:extLst>
          </c:dPt>
          <c:dPt>
            <c:idx val="18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0E-A2EB-4566-9B46-DAC7DE36ADA2}"/>
              </c:ext>
            </c:extLst>
          </c:dPt>
          <c:dPt>
            <c:idx val="18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10-A2EB-4566-9B46-DAC7DE36ADA2}"/>
              </c:ext>
            </c:extLst>
          </c:dPt>
          <c:dPt>
            <c:idx val="18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12-A2EB-4566-9B46-DAC7DE36ADA2}"/>
              </c:ext>
            </c:extLst>
          </c:dPt>
          <c:dPt>
            <c:idx val="18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14-A2EB-4566-9B46-DAC7DE36ADA2}"/>
              </c:ext>
            </c:extLst>
          </c:dPt>
          <c:dPt>
            <c:idx val="190"/>
            <c:invertIfNegative val="0"/>
            <c:bubble3D val="0"/>
            <c:spPr>
              <a:solidFill>
                <a:srgbClr val="46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16-A2EB-4566-9B46-DAC7DE36ADA2}"/>
              </c:ext>
            </c:extLst>
          </c:dPt>
          <c:dPt>
            <c:idx val="19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18-A2EB-4566-9B46-DAC7DE36ADA2}"/>
              </c:ext>
            </c:extLst>
          </c:dPt>
          <c:dPt>
            <c:idx val="19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1A-A2EB-4566-9B46-DAC7DE36ADA2}"/>
              </c:ext>
            </c:extLst>
          </c:dPt>
          <c:dPt>
            <c:idx val="194"/>
            <c:invertIfNegative val="0"/>
            <c:bubble3D val="0"/>
            <c:spPr>
              <a:solidFill>
                <a:srgbClr val="0046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1C-A2EB-4566-9B46-DAC7DE36ADA2}"/>
              </c:ext>
            </c:extLst>
          </c:dPt>
          <c:dPt>
            <c:idx val="196"/>
            <c:invertIfNegative val="0"/>
            <c:bubble3D val="0"/>
            <c:spPr>
              <a:solidFill>
                <a:srgbClr val="C8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1E-A2EB-4566-9B46-DAC7DE36ADA2}"/>
              </c:ext>
            </c:extLst>
          </c:dPt>
          <c:dPt>
            <c:idx val="197"/>
            <c:invertIfNegative val="0"/>
            <c:bubble3D val="0"/>
            <c:spPr>
              <a:solidFill>
                <a:srgbClr val="C8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20-A2EB-4566-9B46-DAC7DE36ADA2}"/>
              </c:ext>
            </c:extLst>
          </c:dPt>
          <c:dPt>
            <c:idx val="19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22-A2EB-4566-9B46-DAC7DE36ADA2}"/>
              </c:ext>
            </c:extLst>
          </c:dPt>
          <c:dPt>
            <c:idx val="19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24-A2EB-4566-9B46-DAC7DE36ADA2}"/>
              </c:ext>
            </c:extLst>
          </c:dPt>
          <c:dPt>
            <c:idx val="20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26-A2EB-4566-9B46-DAC7DE36ADA2}"/>
              </c:ext>
            </c:extLst>
          </c:dPt>
          <c:dPt>
            <c:idx val="20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28-A2EB-4566-9B46-DAC7DE36ADA2}"/>
              </c:ext>
            </c:extLst>
          </c:dPt>
          <c:dPt>
            <c:idx val="20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2A-A2EB-4566-9B46-DAC7DE36ADA2}"/>
              </c:ext>
            </c:extLst>
          </c:dPt>
          <c:dPt>
            <c:idx val="20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2C-A2EB-4566-9B46-DAC7DE36ADA2}"/>
              </c:ext>
            </c:extLst>
          </c:dPt>
          <c:dPt>
            <c:idx val="20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2E-A2EB-4566-9B46-DAC7DE36ADA2}"/>
              </c:ext>
            </c:extLst>
          </c:dPt>
          <c:dPt>
            <c:idx val="20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30-A2EB-4566-9B46-DAC7DE36ADA2}"/>
              </c:ext>
            </c:extLst>
          </c:dPt>
          <c:dPt>
            <c:idx val="20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32-A2EB-4566-9B46-DAC7DE36ADA2}"/>
              </c:ext>
            </c:extLst>
          </c:dPt>
          <c:dPt>
            <c:idx val="20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34-A2EB-4566-9B46-DAC7DE36ADA2}"/>
              </c:ext>
            </c:extLst>
          </c:dPt>
          <c:dPt>
            <c:idx val="20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36-A2EB-4566-9B46-DAC7DE36ADA2}"/>
              </c:ext>
            </c:extLst>
          </c:dPt>
          <c:dPt>
            <c:idx val="20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38-A2EB-4566-9B46-DAC7DE36ADA2}"/>
              </c:ext>
            </c:extLst>
          </c:dPt>
          <c:dPt>
            <c:idx val="210"/>
            <c:invertIfNegative val="0"/>
            <c:bubble3D val="0"/>
            <c:spPr>
              <a:solidFill>
                <a:srgbClr val="0046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3A-A2EB-4566-9B46-DAC7DE36ADA2}"/>
              </c:ext>
            </c:extLst>
          </c:dPt>
          <c:dPt>
            <c:idx val="21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3C-A2EB-4566-9B46-DAC7DE36ADA2}"/>
              </c:ext>
            </c:extLst>
          </c:dPt>
          <c:dPt>
            <c:idx val="21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3E-A2EB-4566-9B46-DAC7DE36ADA2}"/>
              </c:ext>
            </c:extLst>
          </c:dPt>
          <c:dPt>
            <c:idx val="21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40-A2EB-4566-9B46-DAC7DE36ADA2}"/>
              </c:ext>
            </c:extLst>
          </c:dPt>
          <c:dPt>
            <c:idx val="21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42-A2EB-4566-9B46-DAC7DE36ADA2}"/>
              </c:ext>
            </c:extLst>
          </c:dPt>
          <c:dPt>
            <c:idx val="21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44-A2EB-4566-9B46-DAC7DE36ADA2}"/>
              </c:ext>
            </c:extLst>
          </c:dPt>
          <c:dPt>
            <c:idx val="21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46-A2EB-4566-9B46-DAC7DE36ADA2}"/>
              </c:ext>
            </c:extLst>
          </c:dPt>
          <c:dPt>
            <c:idx val="21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48-A2EB-4566-9B46-DAC7DE36ADA2}"/>
              </c:ext>
            </c:extLst>
          </c:dPt>
          <c:dPt>
            <c:idx val="21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4A-A2EB-4566-9B46-DAC7DE36ADA2}"/>
              </c:ext>
            </c:extLst>
          </c:dPt>
          <c:dPt>
            <c:idx val="21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4C-A2EB-4566-9B46-DAC7DE36ADA2}"/>
              </c:ext>
            </c:extLst>
          </c:dPt>
          <c:dPt>
            <c:idx val="22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4E-A2EB-4566-9B46-DAC7DE36ADA2}"/>
              </c:ext>
            </c:extLst>
          </c:dPt>
          <c:dPt>
            <c:idx val="22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50-A2EB-4566-9B46-DAC7DE36ADA2}"/>
              </c:ext>
            </c:extLst>
          </c:dPt>
          <c:dPt>
            <c:idx val="22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52-A2EB-4566-9B46-DAC7DE36ADA2}"/>
              </c:ext>
            </c:extLst>
          </c:dPt>
          <c:dPt>
            <c:idx val="22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54-A2EB-4566-9B46-DAC7DE36ADA2}"/>
              </c:ext>
            </c:extLst>
          </c:dPt>
          <c:dPt>
            <c:idx val="22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56-A2EB-4566-9B46-DAC7DE36ADA2}"/>
              </c:ext>
            </c:extLst>
          </c:dPt>
          <c:dPt>
            <c:idx val="22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58-A2EB-4566-9B46-DAC7DE36ADA2}"/>
              </c:ext>
            </c:extLst>
          </c:dPt>
          <c:dPt>
            <c:idx val="22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5A-A2EB-4566-9B46-DAC7DE36ADA2}"/>
              </c:ext>
            </c:extLst>
          </c:dPt>
          <c:dPt>
            <c:idx val="22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5C-A2EB-4566-9B46-DAC7DE36ADA2}"/>
              </c:ext>
            </c:extLst>
          </c:dPt>
          <c:dPt>
            <c:idx val="22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5E-A2EB-4566-9B46-DAC7DE36ADA2}"/>
              </c:ext>
            </c:extLst>
          </c:dPt>
          <c:dPt>
            <c:idx val="22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60-A2EB-4566-9B46-DAC7DE36ADA2}"/>
              </c:ext>
            </c:extLst>
          </c:dPt>
          <c:dPt>
            <c:idx val="23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62-A2EB-4566-9B46-DAC7DE36ADA2}"/>
              </c:ext>
            </c:extLst>
          </c:dPt>
          <c:dPt>
            <c:idx val="23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64-A2EB-4566-9B46-DAC7DE36ADA2}"/>
              </c:ext>
            </c:extLst>
          </c:dPt>
          <c:dPt>
            <c:idx val="23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66-A2EB-4566-9B46-DAC7DE36ADA2}"/>
              </c:ext>
            </c:extLst>
          </c:dPt>
          <c:dPt>
            <c:idx val="23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68-A2EB-4566-9B46-DAC7DE36ADA2}"/>
              </c:ext>
            </c:extLst>
          </c:dPt>
          <c:dPt>
            <c:idx val="23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6A-A2EB-4566-9B46-DAC7DE36ADA2}"/>
              </c:ext>
            </c:extLst>
          </c:dPt>
          <c:dPt>
            <c:idx val="23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6C-A2EB-4566-9B46-DAC7DE36ADA2}"/>
              </c:ext>
            </c:extLst>
          </c:dPt>
          <c:dPt>
            <c:idx val="23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6E-A2EB-4566-9B46-DAC7DE36ADA2}"/>
              </c:ext>
            </c:extLst>
          </c:dPt>
          <c:dPt>
            <c:idx val="23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70-A2EB-4566-9B46-DAC7DE36ADA2}"/>
              </c:ext>
            </c:extLst>
          </c:dPt>
          <c:dPt>
            <c:idx val="23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72-A2EB-4566-9B46-DAC7DE36ADA2}"/>
              </c:ext>
            </c:extLst>
          </c:dPt>
          <c:dPt>
            <c:idx val="23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74-A2EB-4566-9B46-DAC7DE36ADA2}"/>
              </c:ext>
            </c:extLst>
          </c:dPt>
          <c:dPt>
            <c:idx val="240"/>
            <c:invertIfNegative val="0"/>
            <c:bubble3D val="0"/>
            <c:spPr>
              <a:solidFill>
                <a:srgbClr val="C8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76-A2EB-4566-9B46-DAC7DE36ADA2}"/>
              </c:ext>
            </c:extLst>
          </c:dPt>
          <c:dPt>
            <c:idx val="24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78-A2EB-4566-9B46-DAC7DE36ADA2}"/>
              </c:ext>
            </c:extLst>
          </c:dPt>
          <c:dPt>
            <c:idx val="24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7A-A2EB-4566-9B46-DAC7DE36ADA2}"/>
              </c:ext>
            </c:extLst>
          </c:dPt>
          <c:dPt>
            <c:idx val="24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7C-A2EB-4566-9B46-DAC7DE36ADA2}"/>
              </c:ext>
            </c:extLst>
          </c:dPt>
          <c:dPt>
            <c:idx val="24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7E-A2EB-4566-9B46-DAC7DE36ADA2}"/>
              </c:ext>
            </c:extLst>
          </c:dPt>
          <c:dPt>
            <c:idx val="24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80-A2EB-4566-9B46-DAC7DE36ADA2}"/>
              </c:ext>
            </c:extLst>
          </c:dPt>
          <c:dPt>
            <c:idx val="24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82-A2EB-4566-9B46-DAC7DE36ADA2}"/>
              </c:ext>
            </c:extLst>
          </c:dPt>
          <c:dPt>
            <c:idx val="24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84-A2EB-4566-9B46-DAC7DE36ADA2}"/>
              </c:ext>
            </c:extLst>
          </c:dPt>
          <c:dPt>
            <c:idx val="24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86-A2EB-4566-9B46-DAC7DE36ADA2}"/>
              </c:ext>
            </c:extLst>
          </c:dPt>
          <c:dPt>
            <c:idx val="24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88-A2EB-4566-9B46-DAC7DE36ADA2}"/>
              </c:ext>
            </c:extLst>
          </c:dPt>
          <c:dPt>
            <c:idx val="25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8A-A2EB-4566-9B46-DAC7DE36ADA2}"/>
              </c:ext>
            </c:extLst>
          </c:dPt>
          <c:dPt>
            <c:idx val="251"/>
            <c:invertIfNegative val="0"/>
            <c:bubble3D val="0"/>
            <c:spPr>
              <a:solidFill>
                <a:srgbClr val="C8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8C-A2EB-4566-9B46-DAC7DE36ADA2}"/>
              </c:ext>
            </c:extLst>
          </c:dPt>
          <c:dPt>
            <c:idx val="25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8E-A2EB-4566-9B46-DAC7DE36ADA2}"/>
              </c:ext>
            </c:extLst>
          </c:dPt>
          <c:dPt>
            <c:idx val="25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90-A2EB-4566-9B46-DAC7DE36ADA2}"/>
              </c:ext>
            </c:extLst>
          </c:dPt>
          <c:dPt>
            <c:idx val="25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92-A2EB-4566-9B46-DAC7DE36ADA2}"/>
              </c:ext>
            </c:extLst>
          </c:dPt>
          <c:dPt>
            <c:idx val="25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94-A2EB-4566-9B46-DAC7DE36ADA2}"/>
              </c:ext>
            </c:extLst>
          </c:dPt>
          <c:dPt>
            <c:idx val="25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96-A2EB-4566-9B46-DAC7DE36ADA2}"/>
              </c:ext>
            </c:extLst>
          </c:dPt>
          <c:dPt>
            <c:idx val="25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98-A2EB-4566-9B46-DAC7DE36ADA2}"/>
              </c:ext>
            </c:extLst>
          </c:dPt>
          <c:dPt>
            <c:idx val="25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9A-A2EB-4566-9B46-DAC7DE36ADA2}"/>
              </c:ext>
            </c:extLst>
          </c:dPt>
          <c:dPt>
            <c:idx val="25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9C-A2EB-4566-9B46-DAC7DE36ADA2}"/>
              </c:ext>
            </c:extLst>
          </c:dPt>
          <c:dPt>
            <c:idx val="26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9E-A2EB-4566-9B46-DAC7DE36ADA2}"/>
              </c:ext>
            </c:extLst>
          </c:dPt>
          <c:dPt>
            <c:idx val="26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A0-A2EB-4566-9B46-DAC7DE36ADA2}"/>
              </c:ext>
            </c:extLst>
          </c:dPt>
          <c:dPt>
            <c:idx val="26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A2-A2EB-4566-9B46-DAC7DE36ADA2}"/>
              </c:ext>
            </c:extLst>
          </c:dPt>
          <c:dPt>
            <c:idx val="26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A4-A2EB-4566-9B46-DAC7DE36ADA2}"/>
              </c:ext>
            </c:extLst>
          </c:dPt>
          <c:dPt>
            <c:idx val="26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A6-A2EB-4566-9B46-DAC7DE36ADA2}"/>
              </c:ext>
            </c:extLst>
          </c:dPt>
          <c:dPt>
            <c:idx val="26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A8-A2EB-4566-9B46-DAC7DE36ADA2}"/>
              </c:ext>
            </c:extLst>
          </c:dPt>
          <c:dPt>
            <c:idx val="26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AA-A2EB-4566-9B46-DAC7DE36ADA2}"/>
              </c:ext>
            </c:extLst>
          </c:dPt>
          <c:dPt>
            <c:idx val="26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AC-A2EB-4566-9B46-DAC7DE36ADA2}"/>
              </c:ext>
            </c:extLst>
          </c:dPt>
          <c:dPt>
            <c:idx val="26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AE-A2EB-4566-9B46-DAC7DE36ADA2}"/>
              </c:ext>
            </c:extLst>
          </c:dPt>
          <c:dPt>
            <c:idx val="26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B0-A2EB-4566-9B46-DAC7DE36ADA2}"/>
              </c:ext>
            </c:extLst>
          </c:dPt>
          <c:dPt>
            <c:idx val="27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B2-A2EB-4566-9B46-DAC7DE36ADA2}"/>
              </c:ext>
            </c:extLst>
          </c:dPt>
          <c:dPt>
            <c:idx val="27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B4-A2EB-4566-9B46-DAC7DE36ADA2}"/>
              </c:ext>
            </c:extLst>
          </c:dPt>
          <c:dPt>
            <c:idx val="27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B6-A2EB-4566-9B46-DAC7DE36ADA2}"/>
              </c:ext>
            </c:extLst>
          </c:dPt>
          <c:dPt>
            <c:idx val="27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B8-A2EB-4566-9B46-DAC7DE36ADA2}"/>
              </c:ext>
            </c:extLst>
          </c:dPt>
          <c:dPt>
            <c:idx val="27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BA-A2EB-4566-9B46-DAC7DE36ADA2}"/>
              </c:ext>
            </c:extLst>
          </c:dPt>
          <c:dPt>
            <c:idx val="27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BC-A2EB-4566-9B46-DAC7DE36ADA2}"/>
              </c:ext>
            </c:extLst>
          </c:dPt>
          <c:dPt>
            <c:idx val="27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BE-A2EB-4566-9B46-DAC7DE36ADA2}"/>
              </c:ext>
            </c:extLst>
          </c:dPt>
          <c:dPt>
            <c:idx val="27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C0-A2EB-4566-9B46-DAC7DE36ADA2}"/>
              </c:ext>
            </c:extLst>
          </c:dPt>
          <c:dPt>
            <c:idx val="27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C2-A2EB-4566-9B46-DAC7DE36ADA2}"/>
              </c:ext>
            </c:extLst>
          </c:dPt>
          <c:dPt>
            <c:idx val="27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C4-A2EB-4566-9B46-DAC7DE36ADA2}"/>
              </c:ext>
            </c:extLst>
          </c:dPt>
          <c:dPt>
            <c:idx val="28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C6-A2EB-4566-9B46-DAC7DE36ADA2}"/>
              </c:ext>
            </c:extLst>
          </c:dPt>
          <c:dPt>
            <c:idx val="28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C8-A2EB-4566-9B46-DAC7DE36ADA2}"/>
              </c:ext>
            </c:extLst>
          </c:dPt>
          <c:dPt>
            <c:idx val="28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CA-A2EB-4566-9B46-DAC7DE36ADA2}"/>
              </c:ext>
            </c:extLst>
          </c:dPt>
          <c:dPt>
            <c:idx val="28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CC-A2EB-4566-9B46-DAC7DE36ADA2}"/>
              </c:ext>
            </c:extLst>
          </c:dPt>
          <c:dPt>
            <c:idx val="28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CE-A2EB-4566-9B46-DAC7DE36ADA2}"/>
              </c:ext>
            </c:extLst>
          </c:dPt>
          <c:dPt>
            <c:idx val="28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D0-A2EB-4566-9B46-DAC7DE36ADA2}"/>
              </c:ext>
            </c:extLst>
          </c:dPt>
          <c:dPt>
            <c:idx val="28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D2-A2EB-4566-9B46-DAC7DE36ADA2}"/>
              </c:ext>
            </c:extLst>
          </c:dPt>
          <c:dPt>
            <c:idx val="28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D4-A2EB-4566-9B46-DAC7DE36ADA2}"/>
              </c:ext>
            </c:extLst>
          </c:dPt>
          <c:dPt>
            <c:idx val="28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D6-A2EB-4566-9B46-DAC7DE36ADA2}"/>
              </c:ext>
            </c:extLst>
          </c:dPt>
          <c:dPt>
            <c:idx val="28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D8-A2EB-4566-9B46-DAC7DE36ADA2}"/>
              </c:ext>
            </c:extLst>
          </c:dPt>
          <c:dPt>
            <c:idx val="29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DA-A2EB-4566-9B46-DAC7DE36ADA2}"/>
              </c:ext>
            </c:extLst>
          </c:dPt>
          <c:dPt>
            <c:idx val="29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DC-A2EB-4566-9B46-DAC7DE36ADA2}"/>
              </c:ext>
            </c:extLst>
          </c:dPt>
          <c:dPt>
            <c:idx val="292"/>
            <c:invertIfNegative val="0"/>
            <c:bubble3D val="0"/>
            <c:spPr>
              <a:solidFill>
                <a:srgbClr val="C8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DE-A2EB-4566-9B46-DAC7DE36ADA2}"/>
              </c:ext>
            </c:extLst>
          </c:dPt>
          <c:dPt>
            <c:idx val="29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E0-A2EB-4566-9B46-DAC7DE36ADA2}"/>
              </c:ext>
            </c:extLst>
          </c:dPt>
          <c:dPt>
            <c:idx val="29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E2-A2EB-4566-9B46-DAC7DE36ADA2}"/>
              </c:ext>
            </c:extLst>
          </c:dPt>
          <c:dPt>
            <c:idx val="29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E4-A2EB-4566-9B46-DAC7DE36ADA2}"/>
              </c:ext>
            </c:extLst>
          </c:dPt>
          <c:dPt>
            <c:idx val="29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E6-A2EB-4566-9B46-DAC7DE36ADA2}"/>
              </c:ext>
            </c:extLst>
          </c:dPt>
          <c:dPt>
            <c:idx val="29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E8-A2EB-4566-9B46-DAC7DE36ADA2}"/>
              </c:ext>
            </c:extLst>
          </c:dPt>
          <c:dPt>
            <c:idx val="29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EA-A2EB-4566-9B46-DAC7DE36ADA2}"/>
              </c:ext>
            </c:extLst>
          </c:dPt>
          <c:dPt>
            <c:idx val="29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EC-A2EB-4566-9B46-DAC7DE36ADA2}"/>
              </c:ext>
            </c:extLst>
          </c:dPt>
          <c:dPt>
            <c:idx val="30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EE-A2EB-4566-9B46-DAC7DE36ADA2}"/>
              </c:ext>
            </c:extLst>
          </c:dPt>
          <c:dPt>
            <c:idx val="30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F0-A2EB-4566-9B46-DAC7DE36ADA2}"/>
              </c:ext>
            </c:extLst>
          </c:dPt>
          <c:dPt>
            <c:idx val="30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F2-A2EB-4566-9B46-DAC7DE36ADA2}"/>
              </c:ext>
            </c:extLst>
          </c:dPt>
          <c:dPt>
            <c:idx val="30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F4-A2EB-4566-9B46-DAC7DE36ADA2}"/>
              </c:ext>
            </c:extLst>
          </c:dPt>
          <c:dPt>
            <c:idx val="30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F6-A2EB-4566-9B46-DAC7DE36ADA2}"/>
              </c:ext>
            </c:extLst>
          </c:dPt>
          <c:dPt>
            <c:idx val="30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F8-A2EB-4566-9B46-DAC7DE36ADA2}"/>
              </c:ext>
            </c:extLst>
          </c:dPt>
          <c:dPt>
            <c:idx val="30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FA-A2EB-4566-9B46-DAC7DE36ADA2}"/>
              </c:ext>
            </c:extLst>
          </c:dPt>
          <c:dPt>
            <c:idx val="30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FC-A2EB-4566-9B46-DAC7DE36ADA2}"/>
              </c:ext>
            </c:extLst>
          </c:dPt>
          <c:dPt>
            <c:idx val="30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4FE-A2EB-4566-9B46-DAC7DE36ADA2}"/>
              </c:ext>
            </c:extLst>
          </c:dPt>
          <c:dPt>
            <c:idx val="30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00-A2EB-4566-9B46-DAC7DE36ADA2}"/>
              </c:ext>
            </c:extLst>
          </c:dPt>
          <c:dPt>
            <c:idx val="31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02-A2EB-4566-9B46-DAC7DE36ADA2}"/>
              </c:ext>
            </c:extLst>
          </c:dPt>
          <c:dPt>
            <c:idx val="31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04-A2EB-4566-9B46-DAC7DE36ADA2}"/>
              </c:ext>
            </c:extLst>
          </c:dPt>
          <c:dPt>
            <c:idx val="31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06-A2EB-4566-9B46-DAC7DE36ADA2}"/>
              </c:ext>
            </c:extLst>
          </c:dPt>
          <c:dPt>
            <c:idx val="31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08-A2EB-4566-9B46-DAC7DE36ADA2}"/>
              </c:ext>
            </c:extLst>
          </c:dPt>
          <c:dPt>
            <c:idx val="31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0A-A2EB-4566-9B46-DAC7DE36ADA2}"/>
              </c:ext>
            </c:extLst>
          </c:dPt>
          <c:dPt>
            <c:idx val="31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0C-A2EB-4566-9B46-DAC7DE36ADA2}"/>
              </c:ext>
            </c:extLst>
          </c:dPt>
          <c:dPt>
            <c:idx val="31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0E-A2EB-4566-9B46-DAC7DE36ADA2}"/>
              </c:ext>
            </c:extLst>
          </c:dPt>
          <c:dPt>
            <c:idx val="31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10-A2EB-4566-9B46-DAC7DE36ADA2}"/>
              </c:ext>
            </c:extLst>
          </c:dPt>
          <c:dPt>
            <c:idx val="31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12-A2EB-4566-9B46-DAC7DE36ADA2}"/>
              </c:ext>
            </c:extLst>
          </c:dPt>
          <c:dPt>
            <c:idx val="31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14-A2EB-4566-9B46-DAC7DE36ADA2}"/>
              </c:ext>
            </c:extLst>
          </c:dPt>
          <c:dPt>
            <c:idx val="32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16-A2EB-4566-9B46-DAC7DE36ADA2}"/>
              </c:ext>
            </c:extLst>
          </c:dPt>
          <c:dPt>
            <c:idx val="32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18-A2EB-4566-9B46-DAC7DE36ADA2}"/>
              </c:ext>
            </c:extLst>
          </c:dPt>
          <c:dPt>
            <c:idx val="32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1A-A2EB-4566-9B46-DAC7DE36ADA2}"/>
              </c:ext>
            </c:extLst>
          </c:dPt>
          <c:dPt>
            <c:idx val="32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1C-A2EB-4566-9B46-DAC7DE36ADA2}"/>
              </c:ext>
            </c:extLst>
          </c:dPt>
          <c:dPt>
            <c:idx val="32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1E-A2EB-4566-9B46-DAC7DE36ADA2}"/>
              </c:ext>
            </c:extLst>
          </c:dPt>
          <c:dPt>
            <c:idx val="32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20-A2EB-4566-9B46-DAC7DE36ADA2}"/>
              </c:ext>
            </c:extLst>
          </c:dPt>
          <c:dPt>
            <c:idx val="32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22-A2EB-4566-9B46-DAC7DE36ADA2}"/>
              </c:ext>
            </c:extLst>
          </c:dPt>
          <c:dPt>
            <c:idx val="32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24-A2EB-4566-9B46-DAC7DE36ADA2}"/>
              </c:ext>
            </c:extLst>
          </c:dPt>
          <c:dPt>
            <c:idx val="32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26-A2EB-4566-9B46-DAC7DE36ADA2}"/>
              </c:ext>
            </c:extLst>
          </c:dPt>
          <c:dPt>
            <c:idx val="32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28-A2EB-4566-9B46-DAC7DE36ADA2}"/>
              </c:ext>
            </c:extLst>
          </c:dPt>
          <c:dPt>
            <c:idx val="33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2A-A2EB-4566-9B46-DAC7DE36ADA2}"/>
              </c:ext>
            </c:extLst>
          </c:dPt>
          <c:dPt>
            <c:idx val="33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2C-A2EB-4566-9B46-DAC7DE36ADA2}"/>
              </c:ext>
            </c:extLst>
          </c:dPt>
          <c:dPt>
            <c:idx val="33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2E-A2EB-4566-9B46-DAC7DE36ADA2}"/>
              </c:ext>
            </c:extLst>
          </c:dPt>
          <c:cat>
            <c:strRef>
              <c:f>'Heat maps3_HID7'!$A$2:$A$334</c:f>
              <c:strCache>
                <c:ptCount val="333"/>
                <c:pt idx="0">
                  <c:v>CDH1</c:v>
                </c:pt>
                <c:pt idx="1">
                  <c:v>CD8A</c:v>
                </c:pt>
                <c:pt idx="2">
                  <c:v>BCAM</c:v>
                </c:pt>
                <c:pt idx="3">
                  <c:v>LAMA5</c:v>
                </c:pt>
                <c:pt idx="4">
                  <c:v>RPSA</c:v>
                </c:pt>
                <c:pt idx="5">
                  <c:v>TNC</c:v>
                </c:pt>
                <c:pt idx="6">
                  <c:v>CLDN4</c:v>
                </c:pt>
                <c:pt idx="7">
                  <c:v>PTPRF</c:v>
                </c:pt>
                <c:pt idx="8">
                  <c:v>THBS1</c:v>
                </c:pt>
                <c:pt idx="9">
                  <c:v>ITGB4</c:v>
                </c:pt>
                <c:pt idx="10">
                  <c:v>CELSR1</c:v>
                </c:pt>
                <c:pt idx="11">
                  <c:v>PTPRU</c:v>
                </c:pt>
                <c:pt idx="12">
                  <c:v>CLSTN1</c:v>
                </c:pt>
                <c:pt idx="13">
                  <c:v>CD151</c:v>
                </c:pt>
                <c:pt idx="14">
                  <c:v>CTNND2</c:v>
                </c:pt>
                <c:pt idx="15">
                  <c:v>CD36</c:v>
                </c:pt>
                <c:pt idx="16">
                  <c:v>LAMB1</c:v>
                </c:pt>
                <c:pt idx="17">
                  <c:v>CTNND1</c:v>
                </c:pt>
                <c:pt idx="18">
                  <c:v>MAEA</c:v>
                </c:pt>
                <c:pt idx="19">
                  <c:v>DDR1</c:v>
                </c:pt>
                <c:pt idx="20">
                  <c:v>CLDN9</c:v>
                </c:pt>
                <c:pt idx="21">
                  <c:v>BYSL</c:v>
                </c:pt>
                <c:pt idx="22">
                  <c:v>ZYX</c:v>
                </c:pt>
                <c:pt idx="23">
                  <c:v>AJUBA</c:v>
                </c:pt>
                <c:pt idx="24">
                  <c:v>LAMB3</c:v>
                </c:pt>
                <c:pt idx="25">
                  <c:v>PKP3</c:v>
                </c:pt>
                <c:pt idx="26">
                  <c:v>CLDN3</c:v>
                </c:pt>
                <c:pt idx="27">
                  <c:v>DSG2</c:v>
                </c:pt>
                <c:pt idx="28">
                  <c:v>JUP</c:v>
                </c:pt>
                <c:pt idx="29">
                  <c:v>EPHA2</c:v>
                </c:pt>
                <c:pt idx="30">
                  <c:v>CLDN1</c:v>
                </c:pt>
                <c:pt idx="31">
                  <c:v>HSPG2</c:v>
                </c:pt>
                <c:pt idx="32">
                  <c:v>CDH24</c:v>
                </c:pt>
                <c:pt idx="33">
                  <c:v>VCAN</c:v>
                </c:pt>
                <c:pt idx="34">
                  <c:v>PTPRK</c:v>
                </c:pt>
                <c:pt idx="35">
                  <c:v>PKP2</c:v>
                </c:pt>
                <c:pt idx="36">
                  <c:v>ITGB5</c:v>
                </c:pt>
                <c:pt idx="37">
                  <c:v>LRFN4</c:v>
                </c:pt>
                <c:pt idx="38">
                  <c:v>CLDN7</c:v>
                </c:pt>
                <c:pt idx="39">
                  <c:v>BAIAP2</c:v>
                </c:pt>
                <c:pt idx="40">
                  <c:v>DSC2</c:v>
                </c:pt>
                <c:pt idx="41">
                  <c:v>ITGB1BP1</c:v>
                </c:pt>
                <c:pt idx="42">
                  <c:v>CELSR3</c:v>
                </c:pt>
                <c:pt idx="43">
                  <c:v>SDC1</c:v>
                </c:pt>
                <c:pt idx="44">
                  <c:v>CTNNB1</c:v>
                </c:pt>
                <c:pt idx="45">
                  <c:v>LAMB2</c:v>
                </c:pt>
                <c:pt idx="46">
                  <c:v>CYTH1</c:v>
                </c:pt>
                <c:pt idx="47">
                  <c:v>EPHB6</c:v>
                </c:pt>
                <c:pt idx="48">
                  <c:v>FLRT3</c:v>
                </c:pt>
                <c:pt idx="49">
                  <c:v>IGSF5</c:v>
                </c:pt>
                <c:pt idx="50">
                  <c:v>THBS3</c:v>
                </c:pt>
                <c:pt idx="51">
                  <c:v>ROBO3</c:v>
                </c:pt>
                <c:pt idx="52">
                  <c:v>PCDHGC3</c:v>
                </c:pt>
                <c:pt idx="53">
                  <c:v>EPHA1</c:v>
                </c:pt>
                <c:pt idx="54">
                  <c:v>BAIAP3</c:v>
                </c:pt>
                <c:pt idx="55">
                  <c:v>CADM1</c:v>
                </c:pt>
                <c:pt idx="56">
                  <c:v>NOTCH1</c:v>
                </c:pt>
                <c:pt idx="57">
                  <c:v>DLG5</c:v>
                </c:pt>
                <c:pt idx="58">
                  <c:v>L1CAM</c:v>
                </c:pt>
                <c:pt idx="59">
                  <c:v>ITGA2B</c:v>
                </c:pt>
                <c:pt idx="60">
                  <c:v>CNTNAP1</c:v>
                </c:pt>
                <c:pt idx="61">
                  <c:v>PVR</c:v>
                </c:pt>
                <c:pt idx="62">
                  <c:v>BAIAP2L1</c:v>
                </c:pt>
                <c:pt idx="63">
                  <c:v>EPHB4</c:v>
                </c:pt>
                <c:pt idx="64">
                  <c:v>CDH13</c:v>
                </c:pt>
                <c:pt idx="65">
                  <c:v>PTPRJ</c:v>
                </c:pt>
                <c:pt idx="66">
                  <c:v>ITGA7</c:v>
                </c:pt>
                <c:pt idx="67">
                  <c:v>EFNB1</c:v>
                </c:pt>
                <c:pt idx="68">
                  <c:v>ANTXR1</c:v>
                </c:pt>
                <c:pt idx="69">
                  <c:v>PCDHA11</c:v>
                </c:pt>
                <c:pt idx="70">
                  <c:v>ITGB2</c:v>
                </c:pt>
                <c:pt idx="71">
                  <c:v>PCDHGA10</c:v>
                </c:pt>
                <c:pt idx="72">
                  <c:v>GAS6</c:v>
                </c:pt>
                <c:pt idx="73">
                  <c:v>MDGA1</c:v>
                </c:pt>
                <c:pt idx="74">
                  <c:v>EPHB2</c:v>
                </c:pt>
                <c:pt idx="75">
                  <c:v>SSPN</c:v>
                </c:pt>
                <c:pt idx="76">
                  <c:v>PKP1</c:v>
                </c:pt>
                <c:pt idx="77">
                  <c:v>EFNA5</c:v>
                </c:pt>
                <c:pt idx="78">
                  <c:v>PCDHB14</c:v>
                </c:pt>
                <c:pt idx="79">
                  <c:v>ITGAE</c:v>
                </c:pt>
                <c:pt idx="80">
                  <c:v>NRP1</c:v>
                </c:pt>
                <c:pt idx="81">
                  <c:v>IL1RAP</c:v>
                </c:pt>
                <c:pt idx="82">
                  <c:v>CYTH3</c:v>
                </c:pt>
                <c:pt idx="83">
                  <c:v>ITGB8</c:v>
                </c:pt>
                <c:pt idx="84">
                  <c:v>PTPRM</c:v>
                </c:pt>
                <c:pt idx="85">
                  <c:v>ROBO1</c:v>
                </c:pt>
                <c:pt idx="86">
                  <c:v>PEAK1</c:v>
                </c:pt>
                <c:pt idx="87">
                  <c:v>SDK1</c:v>
                </c:pt>
                <c:pt idx="88">
                  <c:v>PCDHB11</c:v>
                </c:pt>
                <c:pt idx="89">
                  <c:v>CDON</c:v>
                </c:pt>
                <c:pt idx="90">
                  <c:v>BOC</c:v>
                </c:pt>
                <c:pt idx="91">
                  <c:v>PCDH17</c:v>
                </c:pt>
                <c:pt idx="92">
                  <c:v>ITGA10</c:v>
                </c:pt>
                <c:pt idx="93">
                  <c:v>MDGA2</c:v>
                </c:pt>
                <c:pt idx="94">
                  <c:v>PCDHB10</c:v>
                </c:pt>
                <c:pt idx="95">
                  <c:v>PCDHA1</c:v>
                </c:pt>
                <c:pt idx="96">
                  <c:v>SEMA3G</c:v>
                </c:pt>
                <c:pt idx="97">
                  <c:v>LAMA4</c:v>
                </c:pt>
                <c:pt idx="98">
                  <c:v>ICAM1</c:v>
                </c:pt>
                <c:pt idx="99">
                  <c:v>PCDHA3</c:v>
                </c:pt>
                <c:pt idx="100">
                  <c:v>PODXL2</c:v>
                </c:pt>
                <c:pt idx="101">
                  <c:v>ICAM3</c:v>
                </c:pt>
                <c:pt idx="102">
                  <c:v>CLDN15</c:v>
                </c:pt>
                <c:pt idx="103">
                  <c:v>NINJ1</c:v>
                </c:pt>
                <c:pt idx="104">
                  <c:v>PCDH20</c:v>
                </c:pt>
                <c:pt idx="105">
                  <c:v>PCDHB2</c:v>
                </c:pt>
                <c:pt idx="106">
                  <c:v>PCDHB8</c:v>
                </c:pt>
                <c:pt idx="107">
                  <c:v>PCDHA12</c:v>
                </c:pt>
                <c:pt idx="108">
                  <c:v>LRFN3</c:v>
                </c:pt>
                <c:pt idx="109">
                  <c:v>LRFN1</c:v>
                </c:pt>
                <c:pt idx="110">
                  <c:v>SGCE</c:v>
                </c:pt>
                <c:pt idx="111">
                  <c:v>EPHA4</c:v>
                </c:pt>
                <c:pt idx="112">
                  <c:v>ITGB7</c:v>
                </c:pt>
                <c:pt idx="113">
                  <c:v>SEMA4D</c:v>
                </c:pt>
                <c:pt idx="114">
                  <c:v>PCDHA4</c:v>
                </c:pt>
                <c:pt idx="115">
                  <c:v>CADM2</c:v>
                </c:pt>
                <c:pt idx="116">
                  <c:v>SDC3</c:v>
                </c:pt>
                <c:pt idx="117">
                  <c:v>CNTN1</c:v>
                </c:pt>
                <c:pt idx="118">
                  <c:v>CLDN12</c:v>
                </c:pt>
                <c:pt idx="119">
                  <c:v>PTPRH</c:v>
                </c:pt>
                <c:pt idx="120">
                  <c:v>PCDH12</c:v>
                </c:pt>
                <c:pt idx="121">
                  <c:v>CDH18</c:v>
                </c:pt>
                <c:pt idx="122">
                  <c:v>LPXN</c:v>
                </c:pt>
                <c:pt idx="123">
                  <c:v>CLDN8</c:v>
                </c:pt>
                <c:pt idx="124">
                  <c:v>AGER</c:v>
                </c:pt>
                <c:pt idx="125">
                  <c:v>RGMB</c:v>
                </c:pt>
                <c:pt idx="126">
                  <c:v>ITGB3BP</c:v>
                </c:pt>
                <c:pt idx="127">
                  <c:v>TNXB</c:v>
                </c:pt>
                <c:pt idx="128">
                  <c:v>EPHA3</c:v>
                </c:pt>
                <c:pt idx="129">
                  <c:v>CDHR3</c:v>
                </c:pt>
                <c:pt idx="130">
                  <c:v>CLDN23</c:v>
                </c:pt>
                <c:pt idx="131">
                  <c:v>PCDHAC2</c:v>
                </c:pt>
                <c:pt idx="132">
                  <c:v>PLXNC1</c:v>
                </c:pt>
                <c:pt idx="133">
                  <c:v>SELL</c:v>
                </c:pt>
                <c:pt idx="134">
                  <c:v>CDH2</c:v>
                </c:pt>
                <c:pt idx="135">
                  <c:v>PCDHGB1</c:v>
                </c:pt>
                <c:pt idx="136">
                  <c:v>PCDHGB4</c:v>
                </c:pt>
                <c:pt idx="137">
                  <c:v>ROBO2</c:v>
                </c:pt>
                <c:pt idx="138">
                  <c:v>IGSF11</c:v>
                </c:pt>
                <c:pt idx="139">
                  <c:v>NID2</c:v>
                </c:pt>
                <c:pt idx="140">
                  <c:v>CD58</c:v>
                </c:pt>
                <c:pt idx="141">
                  <c:v>PCDHB7</c:v>
                </c:pt>
                <c:pt idx="142">
                  <c:v>UMODL1</c:v>
                </c:pt>
                <c:pt idx="143">
                  <c:v>PCDHB9</c:v>
                </c:pt>
                <c:pt idx="144">
                  <c:v>BAIAP2L2</c:v>
                </c:pt>
                <c:pt idx="145">
                  <c:v>PCDHB12</c:v>
                </c:pt>
                <c:pt idx="146">
                  <c:v>PCDHA5</c:v>
                </c:pt>
                <c:pt idx="147">
                  <c:v>PRTG</c:v>
                </c:pt>
                <c:pt idx="148">
                  <c:v>PCDHB13</c:v>
                </c:pt>
                <c:pt idx="149">
                  <c:v>PCDHA2</c:v>
                </c:pt>
                <c:pt idx="150">
                  <c:v>PCDHGB2</c:v>
                </c:pt>
                <c:pt idx="151">
                  <c:v>LAMC3</c:v>
                </c:pt>
                <c:pt idx="152">
                  <c:v>AMIGO3</c:v>
                </c:pt>
                <c:pt idx="153">
                  <c:v>PCDHGA4</c:v>
                </c:pt>
                <c:pt idx="154">
                  <c:v>PCDH7</c:v>
                </c:pt>
                <c:pt idx="155">
                  <c:v>ITGAL</c:v>
                </c:pt>
                <c:pt idx="156">
                  <c:v>NLGN3</c:v>
                </c:pt>
                <c:pt idx="157">
                  <c:v>EPHA7</c:v>
                </c:pt>
                <c:pt idx="158">
                  <c:v>LRRN3</c:v>
                </c:pt>
                <c:pt idx="159">
                  <c:v>ICAM2</c:v>
                </c:pt>
                <c:pt idx="160">
                  <c:v>EDIL3</c:v>
                </c:pt>
                <c:pt idx="161">
                  <c:v>CDH5</c:v>
                </c:pt>
                <c:pt idx="162">
                  <c:v>CLDN19</c:v>
                </c:pt>
                <c:pt idx="163">
                  <c:v>CDHR5</c:v>
                </c:pt>
                <c:pt idx="164">
                  <c:v>SELPLG</c:v>
                </c:pt>
                <c:pt idx="165">
                  <c:v>DCHS1</c:v>
                </c:pt>
                <c:pt idx="166">
                  <c:v>DSC3</c:v>
                </c:pt>
                <c:pt idx="167">
                  <c:v>PCDHGA3</c:v>
                </c:pt>
                <c:pt idx="168">
                  <c:v>CD24P2</c:v>
                </c:pt>
                <c:pt idx="169">
                  <c:v>PCDHGC5</c:v>
                </c:pt>
                <c:pt idx="170">
                  <c:v>PCDHGA11</c:v>
                </c:pt>
                <c:pt idx="171">
                  <c:v>CLDN2</c:v>
                </c:pt>
                <c:pt idx="172">
                  <c:v>EPHA8</c:v>
                </c:pt>
                <c:pt idx="173">
                  <c:v>PCDHA10</c:v>
                </c:pt>
                <c:pt idx="174">
                  <c:v>PCDHGA7</c:v>
                </c:pt>
                <c:pt idx="175">
                  <c:v>ABI3BP</c:v>
                </c:pt>
                <c:pt idx="176">
                  <c:v>PCDHA6</c:v>
                </c:pt>
                <c:pt idx="177">
                  <c:v>PCDHB6</c:v>
                </c:pt>
                <c:pt idx="178">
                  <c:v>PCDHB5</c:v>
                </c:pt>
                <c:pt idx="179">
                  <c:v>PCDHGB7</c:v>
                </c:pt>
                <c:pt idx="180">
                  <c:v>CLDN6</c:v>
                </c:pt>
                <c:pt idx="181">
                  <c:v>NRXN3</c:v>
                </c:pt>
                <c:pt idx="182">
                  <c:v>PCDHGA12</c:v>
                </c:pt>
                <c:pt idx="183">
                  <c:v>CLDN5</c:v>
                </c:pt>
                <c:pt idx="184">
                  <c:v>PCDHB4</c:v>
                </c:pt>
                <c:pt idx="185">
                  <c:v>CD48</c:v>
                </c:pt>
                <c:pt idx="186">
                  <c:v>PCDHGC4</c:v>
                </c:pt>
                <c:pt idx="187">
                  <c:v>CYTIP</c:v>
                </c:pt>
                <c:pt idx="188">
                  <c:v>CDH10</c:v>
                </c:pt>
                <c:pt idx="189">
                  <c:v>ITGB3</c:v>
                </c:pt>
                <c:pt idx="190">
                  <c:v>CDH20</c:v>
                </c:pt>
                <c:pt idx="191">
                  <c:v>PCDHGA6</c:v>
                </c:pt>
                <c:pt idx="192">
                  <c:v>NINJ2</c:v>
                </c:pt>
                <c:pt idx="193">
                  <c:v>CDHR4</c:v>
                </c:pt>
                <c:pt idx="194">
                  <c:v>LRRN4</c:v>
                </c:pt>
                <c:pt idx="195">
                  <c:v>ICAM4</c:v>
                </c:pt>
                <c:pt idx="196">
                  <c:v>ITGA11</c:v>
                </c:pt>
                <c:pt idx="197">
                  <c:v>KIRREL2</c:v>
                </c:pt>
                <c:pt idx="198">
                  <c:v>THY1</c:v>
                </c:pt>
                <c:pt idx="199">
                  <c:v>PRPH2</c:v>
                </c:pt>
                <c:pt idx="200">
                  <c:v>FAT2</c:v>
                </c:pt>
                <c:pt idx="201">
                  <c:v>CD84</c:v>
                </c:pt>
                <c:pt idx="202">
                  <c:v>MPL</c:v>
                </c:pt>
                <c:pt idx="203">
                  <c:v>IL1RAPL1</c:v>
                </c:pt>
                <c:pt idx="204">
                  <c:v>NLGN1</c:v>
                </c:pt>
                <c:pt idx="205">
                  <c:v>OMG</c:v>
                </c:pt>
                <c:pt idx="206">
                  <c:v>DSC1</c:v>
                </c:pt>
                <c:pt idx="207">
                  <c:v>LIMS2</c:v>
                </c:pt>
                <c:pt idx="208">
                  <c:v>CD6</c:v>
                </c:pt>
                <c:pt idx="209">
                  <c:v>PCDHGA2</c:v>
                </c:pt>
                <c:pt idx="210">
                  <c:v>PCDH19</c:v>
                </c:pt>
                <c:pt idx="211">
                  <c:v>MADCAM1</c:v>
                </c:pt>
                <c:pt idx="212">
                  <c:v>PCDHGA5</c:v>
                </c:pt>
                <c:pt idx="213">
                  <c:v>MAG</c:v>
                </c:pt>
                <c:pt idx="214">
                  <c:v>MFAP4</c:v>
                </c:pt>
                <c:pt idx="215">
                  <c:v>PCDHB3</c:v>
                </c:pt>
                <c:pt idx="216">
                  <c:v>AXL</c:v>
                </c:pt>
                <c:pt idx="217">
                  <c:v>PCDHA8</c:v>
                </c:pt>
                <c:pt idx="218">
                  <c:v>JAM2</c:v>
                </c:pt>
                <c:pt idx="219">
                  <c:v>AMIGO1</c:v>
                </c:pt>
                <c:pt idx="220">
                  <c:v>PCDHGA1</c:v>
                </c:pt>
                <c:pt idx="221">
                  <c:v>THBS2</c:v>
                </c:pt>
                <c:pt idx="222">
                  <c:v>PTPRO</c:v>
                </c:pt>
                <c:pt idx="223">
                  <c:v>FBLN5</c:v>
                </c:pt>
                <c:pt idx="224">
                  <c:v>ELFN1</c:v>
                </c:pt>
                <c:pt idx="225">
                  <c:v>PCDHGA9</c:v>
                </c:pt>
                <c:pt idx="226">
                  <c:v>ITGAD</c:v>
                </c:pt>
                <c:pt idx="227">
                  <c:v>PCDHGA8</c:v>
                </c:pt>
                <c:pt idx="228">
                  <c:v>TRO</c:v>
                </c:pt>
                <c:pt idx="229">
                  <c:v>NCAM1</c:v>
                </c:pt>
                <c:pt idx="230">
                  <c:v>CDH26</c:v>
                </c:pt>
                <c:pt idx="231">
                  <c:v>LRRN2</c:v>
                </c:pt>
                <c:pt idx="232">
                  <c:v>CDH17</c:v>
                </c:pt>
                <c:pt idx="233">
                  <c:v>PCDHGB6</c:v>
                </c:pt>
                <c:pt idx="234">
                  <c:v>PTPRB</c:v>
                </c:pt>
                <c:pt idx="235">
                  <c:v>ITGA9</c:v>
                </c:pt>
                <c:pt idx="236">
                  <c:v>PCDHB15</c:v>
                </c:pt>
                <c:pt idx="237">
                  <c:v>CDHR2</c:v>
                </c:pt>
                <c:pt idx="238">
                  <c:v>MCAM</c:v>
                </c:pt>
                <c:pt idx="239">
                  <c:v>PTPRC</c:v>
                </c:pt>
                <c:pt idx="240">
                  <c:v>FBLN7</c:v>
                </c:pt>
                <c:pt idx="241">
                  <c:v>PCDHAC1</c:v>
                </c:pt>
                <c:pt idx="242">
                  <c:v>LRRN4CL</c:v>
                </c:pt>
                <c:pt idx="243">
                  <c:v>EPHA6</c:v>
                </c:pt>
                <c:pt idx="244">
                  <c:v>THBS4</c:v>
                </c:pt>
                <c:pt idx="245">
                  <c:v>NRP2</c:v>
                </c:pt>
                <c:pt idx="246">
                  <c:v>ITGAM</c:v>
                </c:pt>
                <c:pt idx="247">
                  <c:v>MEGF11</c:v>
                </c:pt>
                <c:pt idx="248">
                  <c:v>ITGA1</c:v>
                </c:pt>
                <c:pt idx="249">
                  <c:v>CLDN11</c:v>
                </c:pt>
                <c:pt idx="250">
                  <c:v>FREM1</c:v>
                </c:pt>
                <c:pt idx="251">
                  <c:v>LSAMP</c:v>
                </c:pt>
                <c:pt idx="252">
                  <c:v>CTNNA3</c:v>
                </c:pt>
                <c:pt idx="253">
                  <c:v>PCDHA7</c:v>
                </c:pt>
                <c:pt idx="254">
                  <c:v>PCDHA13</c:v>
                </c:pt>
                <c:pt idx="255">
                  <c:v>ICAM5</c:v>
                </c:pt>
                <c:pt idx="256">
                  <c:v>SLIT2</c:v>
                </c:pt>
                <c:pt idx="257">
                  <c:v>JAM3</c:v>
                </c:pt>
                <c:pt idx="258">
                  <c:v>CD72</c:v>
                </c:pt>
                <c:pt idx="259">
                  <c:v>PCDHGB3</c:v>
                </c:pt>
                <c:pt idx="260">
                  <c:v>CLDN20</c:v>
                </c:pt>
                <c:pt idx="261">
                  <c:v>CDH4</c:v>
                </c:pt>
                <c:pt idx="262">
                  <c:v>CNTNAP3</c:v>
                </c:pt>
                <c:pt idx="263">
                  <c:v>CDH15</c:v>
                </c:pt>
                <c:pt idx="264">
                  <c:v>FLRT1</c:v>
                </c:pt>
                <c:pt idx="265">
                  <c:v>CD47</c:v>
                </c:pt>
                <c:pt idx="266">
                  <c:v>ITGA5</c:v>
                </c:pt>
                <c:pt idx="267">
                  <c:v>SDC2</c:v>
                </c:pt>
                <c:pt idx="268">
                  <c:v>ESAM</c:v>
                </c:pt>
                <c:pt idx="269">
                  <c:v>EFNA1</c:v>
                </c:pt>
                <c:pt idx="270">
                  <c:v>PTPRS</c:v>
                </c:pt>
                <c:pt idx="271">
                  <c:v>CDH23</c:v>
                </c:pt>
                <c:pt idx="272">
                  <c:v>LAMC1</c:v>
                </c:pt>
                <c:pt idx="273">
                  <c:v>LAMC2</c:v>
                </c:pt>
                <c:pt idx="274">
                  <c:v>CTNNA1</c:v>
                </c:pt>
                <c:pt idx="275">
                  <c:v>TGFBI</c:v>
                </c:pt>
                <c:pt idx="276">
                  <c:v>F11R</c:v>
                </c:pt>
                <c:pt idx="277">
                  <c:v>CERCAM</c:v>
                </c:pt>
                <c:pt idx="278">
                  <c:v>SEMA3E</c:v>
                </c:pt>
                <c:pt idx="279">
                  <c:v>IGSF9</c:v>
                </c:pt>
                <c:pt idx="280">
                  <c:v>NEDD9</c:v>
                </c:pt>
                <c:pt idx="281">
                  <c:v>TMEM8B</c:v>
                </c:pt>
                <c:pt idx="282">
                  <c:v>AMIGO2</c:v>
                </c:pt>
                <c:pt idx="283">
                  <c:v>CYTH2</c:v>
                </c:pt>
                <c:pt idx="284">
                  <c:v>SDC4</c:v>
                </c:pt>
                <c:pt idx="285">
                  <c:v>PCDH10</c:v>
                </c:pt>
                <c:pt idx="286">
                  <c:v>TSC1</c:v>
                </c:pt>
                <c:pt idx="287">
                  <c:v>CLSTN3</c:v>
                </c:pt>
                <c:pt idx="288">
                  <c:v>ITGB1</c:v>
                </c:pt>
                <c:pt idx="289">
                  <c:v>EPCAM</c:v>
                </c:pt>
                <c:pt idx="290">
                  <c:v>ITGA6</c:v>
                </c:pt>
                <c:pt idx="291">
                  <c:v>DSP</c:v>
                </c:pt>
                <c:pt idx="292">
                  <c:v>CD9</c:v>
                </c:pt>
                <c:pt idx="293">
                  <c:v>CELSR2</c:v>
                </c:pt>
                <c:pt idx="294">
                  <c:v>NEO1</c:v>
                </c:pt>
                <c:pt idx="295">
                  <c:v>NPTN</c:v>
                </c:pt>
                <c:pt idx="296">
                  <c:v>ITGA2</c:v>
                </c:pt>
                <c:pt idx="297">
                  <c:v>DLG1</c:v>
                </c:pt>
                <c:pt idx="298">
                  <c:v>CD24P4</c:v>
                </c:pt>
                <c:pt idx="299">
                  <c:v>VEZT</c:v>
                </c:pt>
                <c:pt idx="300">
                  <c:v>CDH3</c:v>
                </c:pt>
                <c:pt idx="301">
                  <c:v>FAT1</c:v>
                </c:pt>
                <c:pt idx="302">
                  <c:v>ITGB6</c:v>
                </c:pt>
                <c:pt idx="303">
                  <c:v>FREM2</c:v>
                </c:pt>
                <c:pt idx="304">
                  <c:v>NRCAM</c:v>
                </c:pt>
                <c:pt idx="305">
                  <c:v>ASTN2</c:v>
                </c:pt>
                <c:pt idx="306">
                  <c:v>ITGAV</c:v>
                </c:pt>
                <c:pt idx="307">
                  <c:v>CD44</c:v>
                </c:pt>
                <c:pt idx="308">
                  <c:v>ITGA3</c:v>
                </c:pt>
                <c:pt idx="309">
                  <c:v>ALCAM</c:v>
                </c:pt>
                <c:pt idx="310">
                  <c:v>CTNNAL1</c:v>
                </c:pt>
                <c:pt idx="311">
                  <c:v>FN1</c:v>
                </c:pt>
                <c:pt idx="312">
                  <c:v>SDK2</c:v>
                </c:pt>
                <c:pt idx="313">
                  <c:v>PCDH1</c:v>
                </c:pt>
                <c:pt idx="314">
                  <c:v>LAMA3</c:v>
                </c:pt>
                <c:pt idx="315">
                  <c:v>CADM4</c:v>
                </c:pt>
                <c:pt idx="316">
                  <c:v>PCDH9</c:v>
                </c:pt>
                <c:pt idx="317">
                  <c:v>DST</c:v>
                </c:pt>
                <c:pt idx="318">
                  <c:v>EFNB2</c:v>
                </c:pt>
                <c:pt idx="319">
                  <c:v>PLXNB1</c:v>
                </c:pt>
                <c:pt idx="320">
                  <c:v>EPHB3</c:v>
                </c:pt>
                <c:pt idx="321">
                  <c:v>LRRN1</c:v>
                </c:pt>
                <c:pt idx="322">
                  <c:v>NCAM2</c:v>
                </c:pt>
                <c:pt idx="323">
                  <c:v>PCDH11X</c:v>
                </c:pt>
                <c:pt idx="324">
                  <c:v>PLXNB3</c:v>
                </c:pt>
                <c:pt idx="325">
                  <c:v>LPP</c:v>
                </c:pt>
                <c:pt idx="326">
                  <c:v>PTPRG</c:v>
                </c:pt>
                <c:pt idx="327">
                  <c:v>FERMT2</c:v>
                </c:pt>
                <c:pt idx="328">
                  <c:v>PKP4</c:v>
                </c:pt>
                <c:pt idx="329">
                  <c:v>CEACAM1</c:v>
                </c:pt>
                <c:pt idx="330">
                  <c:v>NTN1</c:v>
                </c:pt>
                <c:pt idx="331">
                  <c:v>NLGN2</c:v>
                </c:pt>
                <c:pt idx="332">
                  <c:v>MIA3</c:v>
                </c:pt>
              </c:strCache>
            </c:strRef>
          </c:cat>
          <c:val>
            <c:numRef>
              <c:f>'Heat maps3_HID7'!$C$2:$C$334</c:f>
              <c:numCache>
                <c:formatCode>General</c:formatCode>
                <c:ptCount val="333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  <c:pt idx="28">
                  <c:v>1</c:v>
                </c:pt>
                <c:pt idx="29">
                  <c:v>1</c:v>
                </c:pt>
                <c:pt idx="30">
                  <c:v>1</c:v>
                </c:pt>
                <c:pt idx="31">
                  <c:v>1</c:v>
                </c:pt>
                <c:pt idx="32">
                  <c:v>1</c:v>
                </c:pt>
                <c:pt idx="33">
                  <c:v>1</c:v>
                </c:pt>
                <c:pt idx="34">
                  <c:v>1</c:v>
                </c:pt>
                <c:pt idx="35">
                  <c:v>1</c:v>
                </c:pt>
                <c:pt idx="36">
                  <c:v>1</c:v>
                </c:pt>
                <c:pt idx="37">
                  <c:v>1</c:v>
                </c:pt>
                <c:pt idx="38">
                  <c:v>1</c:v>
                </c:pt>
                <c:pt idx="39">
                  <c:v>1</c:v>
                </c:pt>
                <c:pt idx="40">
                  <c:v>1</c:v>
                </c:pt>
                <c:pt idx="41">
                  <c:v>1</c:v>
                </c:pt>
                <c:pt idx="42">
                  <c:v>1</c:v>
                </c:pt>
                <c:pt idx="43">
                  <c:v>1</c:v>
                </c:pt>
                <c:pt idx="44">
                  <c:v>1</c:v>
                </c:pt>
                <c:pt idx="45">
                  <c:v>1</c:v>
                </c:pt>
                <c:pt idx="46">
                  <c:v>1</c:v>
                </c:pt>
                <c:pt idx="47">
                  <c:v>1</c:v>
                </c:pt>
                <c:pt idx="48">
                  <c:v>1</c:v>
                </c:pt>
                <c:pt idx="49">
                  <c:v>1</c:v>
                </c:pt>
                <c:pt idx="50">
                  <c:v>1</c:v>
                </c:pt>
                <c:pt idx="51">
                  <c:v>1</c:v>
                </c:pt>
                <c:pt idx="52">
                  <c:v>1</c:v>
                </c:pt>
                <c:pt idx="53">
                  <c:v>1</c:v>
                </c:pt>
                <c:pt idx="54">
                  <c:v>1</c:v>
                </c:pt>
                <c:pt idx="55">
                  <c:v>1</c:v>
                </c:pt>
                <c:pt idx="56">
                  <c:v>1</c:v>
                </c:pt>
                <c:pt idx="57">
                  <c:v>1</c:v>
                </c:pt>
                <c:pt idx="58">
                  <c:v>1</c:v>
                </c:pt>
                <c:pt idx="59">
                  <c:v>1</c:v>
                </c:pt>
                <c:pt idx="60">
                  <c:v>1</c:v>
                </c:pt>
                <c:pt idx="61">
                  <c:v>1</c:v>
                </c:pt>
                <c:pt idx="62">
                  <c:v>1</c:v>
                </c:pt>
                <c:pt idx="63">
                  <c:v>1</c:v>
                </c:pt>
                <c:pt idx="64">
                  <c:v>1</c:v>
                </c:pt>
                <c:pt idx="65">
                  <c:v>1</c:v>
                </c:pt>
                <c:pt idx="66">
                  <c:v>1</c:v>
                </c:pt>
                <c:pt idx="67">
                  <c:v>1</c:v>
                </c:pt>
                <c:pt idx="68">
                  <c:v>1</c:v>
                </c:pt>
                <c:pt idx="69">
                  <c:v>1</c:v>
                </c:pt>
                <c:pt idx="70">
                  <c:v>1</c:v>
                </c:pt>
                <c:pt idx="71">
                  <c:v>1</c:v>
                </c:pt>
                <c:pt idx="72">
                  <c:v>1</c:v>
                </c:pt>
                <c:pt idx="73">
                  <c:v>1</c:v>
                </c:pt>
                <c:pt idx="74">
                  <c:v>1</c:v>
                </c:pt>
                <c:pt idx="75">
                  <c:v>1</c:v>
                </c:pt>
                <c:pt idx="76">
                  <c:v>1</c:v>
                </c:pt>
                <c:pt idx="77">
                  <c:v>1</c:v>
                </c:pt>
                <c:pt idx="78">
                  <c:v>1</c:v>
                </c:pt>
                <c:pt idx="79">
                  <c:v>1</c:v>
                </c:pt>
                <c:pt idx="80">
                  <c:v>1</c:v>
                </c:pt>
                <c:pt idx="81">
                  <c:v>1</c:v>
                </c:pt>
                <c:pt idx="82">
                  <c:v>1</c:v>
                </c:pt>
                <c:pt idx="83">
                  <c:v>1</c:v>
                </c:pt>
                <c:pt idx="84">
                  <c:v>1</c:v>
                </c:pt>
                <c:pt idx="85">
                  <c:v>1</c:v>
                </c:pt>
                <c:pt idx="86">
                  <c:v>1</c:v>
                </c:pt>
                <c:pt idx="87">
                  <c:v>1</c:v>
                </c:pt>
                <c:pt idx="88">
                  <c:v>1</c:v>
                </c:pt>
                <c:pt idx="89">
                  <c:v>1</c:v>
                </c:pt>
                <c:pt idx="90">
                  <c:v>1</c:v>
                </c:pt>
                <c:pt idx="91">
                  <c:v>1</c:v>
                </c:pt>
                <c:pt idx="92">
                  <c:v>1</c:v>
                </c:pt>
                <c:pt idx="93">
                  <c:v>1</c:v>
                </c:pt>
                <c:pt idx="94">
                  <c:v>1</c:v>
                </c:pt>
                <c:pt idx="95">
                  <c:v>1</c:v>
                </c:pt>
                <c:pt idx="96">
                  <c:v>1</c:v>
                </c:pt>
                <c:pt idx="97">
                  <c:v>1</c:v>
                </c:pt>
                <c:pt idx="98">
                  <c:v>1</c:v>
                </c:pt>
                <c:pt idx="99">
                  <c:v>1</c:v>
                </c:pt>
                <c:pt idx="100">
                  <c:v>1</c:v>
                </c:pt>
                <c:pt idx="101">
                  <c:v>1</c:v>
                </c:pt>
                <c:pt idx="102">
                  <c:v>1</c:v>
                </c:pt>
                <c:pt idx="103">
                  <c:v>1</c:v>
                </c:pt>
                <c:pt idx="104">
                  <c:v>1</c:v>
                </c:pt>
                <c:pt idx="105">
                  <c:v>1</c:v>
                </c:pt>
                <c:pt idx="106">
                  <c:v>1</c:v>
                </c:pt>
                <c:pt idx="107">
                  <c:v>1</c:v>
                </c:pt>
                <c:pt idx="108">
                  <c:v>1</c:v>
                </c:pt>
                <c:pt idx="109">
                  <c:v>1</c:v>
                </c:pt>
                <c:pt idx="110">
                  <c:v>1</c:v>
                </c:pt>
                <c:pt idx="111">
                  <c:v>1</c:v>
                </c:pt>
                <c:pt idx="112">
                  <c:v>1</c:v>
                </c:pt>
                <c:pt idx="113">
                  <c:v>1</c:v>
                </c:pt>
                <c:pt idx="114">
                  <c:v>1</c:v>
                </c:pt>
                <c:pt idx="115">
                  <c:v>1</c:v>
                </c:pt>
                <c:pt idx="116">
                  <c:v>1</c:v>
                </c:pt>
                <c:pt idx="117">
                  <c:v>1</c:v>
                </c:pt>
                <c:pt idx="118">
                  <c:v>1</c:v>
                </c:pt>
                <c:pt idx="119">
                  <c:v>1</c:v>
                </c:pt>
                <c:pt idx="120">
                  <c:v>1</c:v>
                </c:pt>
                <c:pt idx="121">
                  <c:v>1</c:v>
                </c:pt>
                <c:pt idx="122">
                  <c:v>1</c:v>
                </c:pt>
                <c:pt idx="123">
                  <c:v>1</c:v>
                </c:pt>
                <c:pt idx="124">
                  <c:v>1</c:v>
                </c:pt>
                <c:pt idx="125">
                  <c:v>1</c:v>
                </c:pt>
                <c:pt idx="126">
                  <c:v>1</c:v>
                </c:pt>
                <c:pt idx="127">
                  <c:v>1</c:v>
                </c:pt>
                <c:pt idx="128">
                  <c:v>1</c:v>
                </c:pt>
                <c:pt idx="129">
                  <c:v>1</c:v>
                </c:pt>
                <c:pt idx="130">
                  <c:v>1</c:v>
                </c:pt>
                <c:pt idx="131">
                  <c:v>1</c:v>
                </c:pt>
                <c:pt idx="132">
                  <c:v>1</c:v>
                </c:pt>
                <c:pt idx="133">
                  <c:v>1</c:v>
                </c:pt>
                <c:pt idx="134">
                  <c:v>1</c:v>
                </c:pt>
                <c:pt idx="135">
                  <c:v>1</c:v>
                </c:pt>
                <c:pt idx="136">
                  <c:v>1</c:v>
                </c:pt>
                <c:pt idx="137">
                  <c:v>1</c:v>
                </c:pt>
                <c:pt idx="138">
                  <c:v>1</c:v>
                </c:pt>
                <c:pt idx="139">
                  <c:v>1</c:v>
                </c:pt>
                <c:pt idx="140">
                  <c:v>1</c:v>
                </c:pt>
                <c:pt idx="141">
                  <c:v>1</c:v>
                </c:pt>
                <c:pt idx="142">
                  <c:v>1</c:v>
                </c:pt>
                <c:pt idx="143">
                  <c:v>1</c:v>
                </c:pt>
                <c:pt idx="144">
                  <c:v>1</c:v>
                </c:pt>
                <c:pt idx="145">
                  <c:v>1</c:v>
                </c:pt>
                <c:pt idx="146">
                  <c:v>1</c:v>
                </c:pt>
                <c:pt idx="147">
                  <c:v>1</c:v>
                </c:pt>
                <c:pt idx="148">
                  <c:v>1</c:v>
                </c:pt>
                <c:pt idx="149">
                  <c:v>1</c:v>
                </c:pt>
                <c:pt idx="150">
                  <c:v>1</c:v>
                </c:pt>
                <c:pt idx="151">
                  <c:v>1</c:v>
                </c:pt>
                <c:pt idx="152">
                  <c:v>1</c:v>
                </c:pt>
                <c:pt idx="153">
                  <c:v>1</c:v>
                </c:pt>
                <c:pt idx="154">
                  <c:v>1</c:v>
                </c:pt>
                <c:pt idx="155">
                  <c:v>1</c:v>
                </c:pt>
                <c:pt idx="156">
                  <c:v>1</c:v>
                </c:pt>
                <c:pt idx="157">
                  <c:v>1</c:v>
                </c:pt>
                <c:pt idx="158">
                  <c:v>1</c:v>
                </c:pt>
                <c:pt idx="159">
                  <c:v>1</c:v>
                </c:pt>
                <c:pt idx="160">
                  <c:v>1</c:v>
                </c:pt>
                <c:pt idx="161">
                  <c:v>1</c:v>
                </c:pt>
                <c:pt idx="162">
                  <c:v>1</c:v>
                </c:pt>
                <c:pt idx="163">
                  <c:v>1</c:v>
                </c:pt>
                <c:pt idx="164">
                  <c:v>1</c:v>
                </c:pt>
                <c:pt idx="165">
                  <c:v>1</c:v>
                </c:pt>
                <c:pt idx="166">
                  <c:v>1</c:v>
                </c:pt>
                <c:pt idx="167">
                  <c:v>1</c:v>
                </c:pt>
                <c:pt idx="168">
                  <c:v>1</c:v>
                </c:pt>
                <c:pt idx="169">
                  <c:v>1</c:v>
                </c:pt>
                <c:pt idx="170">
                  <c:v>1</c:v>
                </c:pt>
                <c:pt idx="171">
                  <c:v>1</c:v>
                </c:pt>
                <c:pt idx="172">
                  <c:v>1</c:v>
                </c:pt>
                <c:pt idx="173">
                  <c:v>1</c:v>
                </c:pt>
                <c:pt idx="174">
                  <c:v>1</c:v>
                </c:pt>
                <c:pt idx="175">
                  <c:v>1</c:v>
                </c:pt>
                <c:pt idx="176">
                  <c:v>1</c:v>
                </c:pt>
                <c:pt idx="177">
                  <c:v>1</c:v>
                </c:pt>
                <c:pt idx="178">
                  <c:v>1</c:v>
                </c:pt>
                <c:pt idx="179">
                  <c:v>1</c:v>
                </c:pt>
                <c:pt idx="180">
                  <c:v>1</c:v>
                </c:pt>
                <c:pt idx="181">
                  <c:v>1</c:v>
                </c:pt>
                <c:pt idx="182">
                  <c:v>1</c:v>
                </c:pt>
                <c:pt idx="183">
                  <c:v>1</c:v>
                </c:pt>
                <c:pt idx="184">
                  <c:v>1</c:v>
                </c:pt>
                <c:pt idx="185">
                  <c:v>1</c:v>
                </c:pt>
                <c:pt idx="186">
                  <c:v>1</c:v>
                </c:pt>
                <c:pt idx="187">
                  <c:v>1</c:v>
                </c:pt>
                <c:pt idx="188">
                  <c:v>1</c:v>
                </c:pt>
                <c:pt idx="189">
                  <c:v>1</c:v>
                </c:pt>
                <c:pt idx="190">
                  <c:v>1</c:v>
                </c:pt>
                <c:pt idx="191">
                  <c:v>1</c:v>
                </c:pt>
                <c:pt idx="192">
                  <c:v>1</c:v>
                </c:pt>
                <c:pt idx="193">
                  <c:v>1</c:v>
                </c:pt>
                <c:pt idx="194">
                  <c:v>1</c:v>
                </c:pt>
                <c:pt idx="195">
                  <c:v>1</c:v>
                </c:pt>
                <c:pt idx="196">
                  <c:v>1</c:v>
                </c:pt>
                <c:pt idx="197">
                  <c:v>1</c:v>
                </c:pt>
                <c:pt idx="198">
                  <c:v>1</c:v>
                </c:pt>
                <c:pt idx="199">
                  <c:v>1</c:v>
                </c:pt>
                <c:pt idx="200">
                  <c:v>1</c:v>
                </c:pt>
                <c:pt idx="201">
                  <c:v>1</c:v>
                </c:pt>
                <c:pt idx="202">
                  <c:v>1</c:v>
                </c:pt>
                <c:pt idx="203">
                  <c:v>1</c:v>
                </c:pt>
                <c:pt idx="204">
                  <c:v>1</c:v>
                </c:pt>
                <c:pt idx="205">
                  <c:v>1</c:v>
                </c:pt>
                <c:pt idx="206">
                  <c:v>1</c:v>
                </c:pt>
                <c:pt idx="207">
                  <c:v>1</c:v>
                </c:pt>
                <c:pt idx="208">
                  <c:v>1</c:v>
                </c:pt>
                <c:pt idx="209">
                  <c:v>1</c:v>
                </c:pt>
                <c:pt idx="210">
                  <c:v>1</c:v>
                </c:pt>
                <c:pt idx="211">
                  <c:v>1</c:v>
                </c:pt>
                <c:pt idx="212">
                  <c:v>1</c:v>
                </c:pt>
                <c:pt idx="213">
                  <c:v>1</c:v>
                </c:pt>
                <c:pt idx="214">
                  <c:v>1</c:v>
                </c:pt>
                <c:pt idx="215">
                  <c:v>1</c:v>
                </c:pt>
                <c:pt idx="216">
                  <c:v>1</c:v>
                </c:pt>
                <c:pt idx="217">
                  <c:v>1</c:v>
                </c:pt>
                <c:pt idx="218">
                  <c:v>1</c:v>
                </c:pt>
                <c:pt idx="219">
                  <c:v>1</c:v>
                </c:pt>
                <c:pt idx="220">
                  <c:v>1</c:v>
                </c:pt>
                <c:pt idx="221">
                  <c:v>1</c:v>
                </c:pt>
                <c:pt idx="222">
                  <c:v>1</c:v>
                </c:pt>
                <c:pt idx="223">
                  <c:v>1</c:v>
                </c:pt>
                <c:pt idx="224">
                  <c:v>1</c:v>
                </c:pt>
                <c:pt idx="225">
                  <c:v>1</c:v>
                </c:pt>
                <c:pt idx="226">
                  <c:v>1</c:v>
                </c:pt>
                <c:pt idx="227">
                  <c:v>1</c:v>
                </c:pt>
                <c:pt idx="228">
                  <c:v>1</c:v>
                </c:pt>
                <c:pt idx="229">
                  <c:v>1</c:v>
                </c:pt>
                <c:pt idx="230">
                  <c:v>1</c:v>
                </c:pt>
                <c:pt idx="231">
                  <c:v>1</c:v>
                </c:pt>
                <c:pt idx="232">
                  <c:v>1</c:v>
                </c:pt>
                <c:pt idx="233">
                  <c:v>1</c:v>
                </c:pt>
                <c:pt idx="234">
                  <c:v>1</c:v>
                </c:pt>
                <c:pt idx="235">
                  <c:v>1</c:v>
                </c:pt>
                <c:pt idx="236">
                  <c:v>1</c:v>
                </c:pt>
                <c:pt idx="237">
                  <c:v>1</c:v>
                </c:pt>
                <c:pt idx="238">
                  <c:v>1</c:v>
                </c:pt>
                <c:pt idx="239">
                  <c:v>1</c:v>
                </c:pt>
                <c:pt idx="240">
                  <c:v>1</c:v>
                </c:pt>
                <c:pt idx="241">
                  <c:v>1</c:v>
                </c:pt>
                <c:pt idx="242">
                  <c:v>1</c:v>
                </c:pt>
                <c:pt idx="243">
                  <c:v>1</c:v>
                </c:pt>
                <c:pt idx="244">
                  <c:v>1</c:v>
                </c:pt>
                <c:pt idx="245">
                  <c:v>1</c:v>
                </c:pt>
                <c:pt idx="246">
                  <c:v>1</c:v>
                </c:pt>
                <c:pt idx="247">
                  <c:v>1</c:v>
                </c:pt>
                <c:pt idx="248">
                  <c:v>1</c:v>
                </c:pt>
                <c:pt idx="249">
                  <c:v>1</c:v>
                </c:pt>
                <c:pt idx="250">
                  <c:v>1</c:v>
                </c:pt>
                <c:pt idx="251">
                  <c:v>1</c:v>
                </c:pt>
                <c:pt idx="252">
                  <c:v>1</c:v>
                </c:pt>
                <c:pt idx="253">
                  <c:v>1</c:v>
                </c:pt>
                <c:pt idx="254">
                  <c:v>1</c:v>
                </c:pt>
                <c:pt idx="255">
                  <c:v>1</c:v>
                </c:pt>
                <c:pt idx="256">
                  <c:v>1</c:v>
                </c:pt>
                <c:pt idx="257">
                  <c:v>1</c:v>
                </c:pt>
                <c:pt idx="258">
                  <c:v>1</c:v>
                </c:pt>
                <c:pt idx="259">
                  <c:v>1</c:v>
                </c:pt>
                <c:pt idx="260">
                  <c:v>1</c:v>
                </c:pt>
                <c:pt idx="261">
                  <c:v>1</c:v>
                </c:pt>
                <c:pt idx="262">
                  <c:v>1</c:v>
                </c:pt>
                <c:pt idx="263">
                  <c:v>1</c:v>
                </c:pt>
                <c:pt idx="264">
                  <c:v>1</c:v>
                </c:pt>
                <c:pt idx="265">
                  <c:v>1</c:v>
                </c:pt>
                <c:pt idx="266">
                  <c:v>1</c:v>
                </c:pt>
                <c:pt idx="267">
                  <c:v>1</c:v>
                </c:pt>
                <c:pt idx="268">
                  <c:v>1</c:v>
                </c:pt>
                <c:pt idx="269">
                  <c:v>1</c:v>
                </c:pt>
                <c:pt idx="270">
                  <c:v>1</c:v>
                </c:pt>
                <c:pt idx="271">
                  <c:v>1</c:v>
                </c:pt>
                <c:pt idx="272">
                  <c:v>1</c:v>
                </c:pt>
                <c:pt idx="273">
                  <c:v>1</c:v>
                </c:pt>
                <c:pt idx="274">
                  <c:v>1</c:v>
                </c:pt>
                <c:pt idx="275">
                  <c:v>1</c:v>
                </c:pt>
                <c:pt idx="276">
                  <c:v>1</c:v>
                </c:pt>
                <c:pt idx="277">
                  <c:v>1</c:v>
                </c:pt>
                <c:pt idx="278">
                  <c:v>1</c:v>
                </c:pt>
                <c:pt idx="279">
                  <c:v>1</c:v>
                </c:pt>
                <c:pt idx="280">
                  <c:v>1</c:v>
                </c:pt>
                <c:pt idx="281">
                  <c:v>1</c:v>
                </c:pt>
                <c:pt idx="282">
                  <c:v>1</c:v>
                </c:pt>
                <c:pt idx="283">
                  <c:v>1</c:v>
                </c:pt>
                <c:pt idx="284">
                  <c:v>1</c:v>
                </c:pt>
                <c:pt idx="285">
                  <c:v>1</c:v>
                </c:pt>
                <c:pt idx="286">
                  <c:v>1</c:v>
                </c:pt>
                <c:pt idx="287">
                  <c:v>1</c:v>
                </c:pt>
                <c:pt idx="288">
                  <c:v>1</c:v>
                </c:pt>
                <c:pt idx="289">
                  <c:v>1</c:v>
                </c:pt>
                <c:pt idx="290">
                  <c:v>1</c:v>
                </c:pt>
                <c:pt idx="291">
                  <c:v>1</c:v>
                </c:pt>
                <c:pt idx="292">
                  <c:v>1</c:v>
                </c:pt>
                <c:pt idx="293">
                  <c:v>1</c:v>
                </c:pt>
                <c:pt idx="294">
                  <c:v>1</c:v>
                </c:pt>
                <c:pt idx="295">
                  <c:v>1</c:v>
                </c:pt>
                <c:pt idx="296">
                  <c:v>1</c:v>
                </c:pt>
                <c:pt idx="297">
                  <c:v>1</c:v>
                </c:pt>
                <c:pt idx="298">
                  <c:v>1</c:v>
                </c:pt>
                <c:pt idx="299">
                  <c:v>1</c:v>
                </c:pt>
                <c:pt idx="300">
                  <c:v>1</c:v>
                </c:pt>
                <c:pt idx="301">
                  <c:v>1</c:v>
                </c:pt>
                <c:pt idx="302">
                  <c:v>1</c:v>
                </c:pt>
                <c:pt idx="303">
                  <c:v>1</c:v>
                </c:pt>
                <c:pt idx="304">
                  <c:v>1</c:v>
                </c:pt>
                <c:pt idx="305">
                  <c:v>1</c:v>
                </c:pt>
                <c:pt idx="306">
                  <c:v>1</c:v>
                </c:pt>
                <c:pt idx="307">
                  <c:v>1</c:v>
                </c:pt>
                <c:pt idx="308">
                  <c:v>1</c:v>
                </c:pt>
                <c:pt idx="309">
                  <c:v>1</c:v>
                </c:pt>
                <c:pt idx="310">
                  <c:v>1</c:v>
                </c:pt>
                <c:pt idx="311">
                  <c:v>1</c:v>
                </c:pt>
                <c:pt idx="312">
                  <c:v>1</c:v>
                </c:pt>
                <c:pt idx="313">
                  <c:v>1</c:v>
                </c:pt>
                <c:pt idx="314">
                  <c:v>1</c:v>
                </c:pt>
                <c:pt idx="315">
                  <c:v>1</c:v>
                </c:pt>
                <c:pt idx="316">
                  <c:v>1</c:v>
                </c:pt>
                <c:pt idx="317">
                  <c:v>1</c:v>
                </c:pt>
                <c:pt idx="318">
                  <c:v>1</c:v>
                </c:pt>
                <c:pt idx="319">
                  <c:v>1</c:v>
                </c:pt>
                <c:pt idx="320">
                  <c:v>1</c:v>
                </c:pt>
                <c:pt idx="321">
                  <c:v>1</c:v>
                </c:pt>
                <c:pt idx="322">
                  <c:v>1</c:v>
                </c:pt>
                <c:pt idx="323">
                  <c:v>1</c:v>
                </c:pt>
                <c:pt idx="324">
                  <c:v>1</c:v>
                </c:pt>
                <c:pt idx="325">
                  <c:v>1</c:v>
                </c:pt>
                <c:pt idx="326">
                  <c:v>1</c:v>
                </c:pt>
                <c:pt idx="327">
                  <c:v>1</c:v>
                </c:pt>
                <c:pt idx="328">
                  <c:v>1</c:v>
                </c:pt>
                <c:pt idx="329">
                  <c:v>1</c:v>
                </c:pt>
                <c:pt idx="330">
                  <c:v>1</c:v>
                </c:pt>
                <c:pt idx="331">
                  <c:v>1</c:v>
                </c:pt>
                <c:pt idx="33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52F-A2EB-4566-9B46-DAC7DE36ADA2}"/>
            </c:ext>
          </c:extLst>
        </c:ser>
        <c:ser>
          <c:idx val="2"/>
          <c:order val="2"/>
          <c:tx>
            <c:v>MDA-MB-361 TCR</c:v>
          </c:tx>
          <c:spPr>
            <a:solidFill>
              <a:srgbClr val="000000"/>
            </a:solidFill>
            <a:ln w="25400"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31-A2EB-4566-9B46-DAC7DE36ADA2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33-A2EB-4566-9B46-DAC7DE36ADA2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35-A2EB-4566-9B46-DAC7DE36ADA2}"/>
              </c:ext>
            </c:extLst>
          </c:dPt>
          <c:dPt>
            <c:idx val="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37-A2EB-4566-9B46-DAC7DE36ADA2}"/>
              </c:ext>
            </c:extLst>
          </c:dPt>
          <c:dPt>
            <c:idx val="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39-A2EB-4566-9B46-DAC7DE36ADA2}"/>
              </c:ext>
            </c:extLst>
          </c:dPt>
          <c:dPt>
            <c:idx val="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3B-A2EB-4566-9B46-DAC7DE36ADA2}"/>
              </c:ext>
            </c:extLst>
          </c:dPt>
          <c:dPt>
            <c:idx val="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3D-A2EB-4566-9B46-DAC7DE36ADA2}"/>
              </c:ext>
            </c:extLst>
          </c:dPt>
          <c:dPt>
            <c:idx val="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3F-A2EB-4566-9B46-DAC7DE36ADA2}"/>
              </c:ext>
            </c:extLst>
          </c:dPt>
          <c:dPt>
            <c:idx val="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41-A2EB-4566-9B46-DAC7DE36ADA2}"/>
              </c:ext>
            </c:extLst>
          </c:dPt>
          <c:dPt>
            <c:idx val="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43-A2EB-4566-9B46-DAC7DE36ADA2}"/>
              </c:ext>
            </c:extLst>
          </c:dPt>
          <c:dPt>
            <c:idx val="1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45-A2EB-4566-9B46-DAC7DE36ADA2}"/>
              </c:ext>
            </c:extLst>
          </c:dPt>
          <c:dPt>
            <c:idx val="1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47-A2EB-4566-9B46-DAC7DE36ADA2}"/>
              </c:ext>
            </c:extLst>
          </c:dPt>
          <c:dPt>
            <c:idx val="1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49-A2EB-4566-9B46-DAC7DE36ADA2}"/>
              </c:ext>
            </c:extLst>
          </c:dPt>
          <c:dPt>
            <c:idx val="1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4B-A2EB-4566-9B46-DAC7DE36ADA2}"/>
              </c:ext>
            </c:extLst>
          </c:dPt>
          <c:dPt>
            <c:idx val="1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4D-A2EB-4566-9B46-DAC7DE36ADA2}"/>
              </c:ext>
            </c:extLst>
          </c:dPt>
          <c:dPt>
            <c:idx val="1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4F-A2EB-4566-9B46-DAC7DE36ADA2}"/>
              </c:ext>
            </c:extLst>
          </c:dPt>
          <c:dPt>
            <c:idx val="1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51-A2EB-4566-9B46-DAC7DE36ADA2}"/>
              </c:ext>
            </c:extLst>
          </c:dPt>
          <c:dPt>
            <c:idx val="1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53-A2EB-4566-9B46-DAC7DE36ADA2}"/>
              </c:ext>
            </c:extLst>
          </c:dPt>
          <c:dPt>
            <c:idx val="1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55-A2EB-4566-9B46-DAC7DE36ADA2}"/>
              </c:ext>
            </c:extLst>
          </c:dPt>
          <c:dPt>
            <c:idx val="1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57-A2EB-4566-9B46-DAC7DE36ADA2}"/>
              </c:ext>
            </c:extLst>
          </c:dPt>
          <c:dPt>
            <c:idx val="2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59-A2EB-4566-9B46-DAC7DE36ADA2}"/>
              </c:ext>
            </c:extLst>
          </c:dPt>
          <c:dPt>
            <c:idx val="2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5B-A2EB-4566-9B46-DAC7DE36ADA2}"/>
              </c:ext>
            </c:extLst>
          </c:dPt>
          <c:dPt>
            <c:idx val="2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5D-A2EB-4566-9B46-DAC7DE36ADA2}"/>
              </c:ext>
            </c:extLst>
          </c:dPt>
          <c:dPt>
            <c:idx val="2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5F-A2EB-4566-9B46-DAC7DE36ADA2}"/>
              </c:ext>
            </c:extLst>
          </c:dPt>
          <c:dPt>
            <c:idx val="2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61-A2EB-4566-9B46-DAC7DE36ADA2}"/>
              </c:ext>
            </c:extLst>
          </c:dPt>
          <c:dPt>
            <c:idx val="2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63-A2EB-4566-9B46-DAC7DE36ADA2}"/>
              </c:ext>
            </c:extLst>
          </c:dPt>
          <c:dPt>
            <c:idx val="2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65-A2EB-4566-9B46-DAC7DE36ADA2}"/>
              </c:ext>
            </c:extLst>
          </c:dPt>
          <c:dPt>
            <c:idx val="2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67-A2EB-4566-9B46-DAC7DE36ADA2}"/>
              </c:ext>
            </c:extLst>
          </c:dPt>
          <c:dPt>
            <c:idx val="2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69-A2EB-4566-9B46-DAC7DE36ADA2}"/>
              </c:ext>
            </c:extLst>
          </c:dPt>
          <c:dPt>
            <c:idx val="2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6B-A2EB-4566-9B46-DAC7DE36ADA2}"/>
              </c:ext>
            </c:extLst>
          </c:dPt>
          <c:dPt>
            <c:idx val="3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6D-A2EB-4566-9B46-DAC7DE36ADA2}"/>
              </c:ext>
            </c:extLst>
          </c:dPt>
          <c:dPt>
            <c:idx val="3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6F-A2EB-4566-9B46-DAC7DE36ADA2}"/>
              </c:ext>
            </c:extLst>
          </c:dPt>
          <c:dPt>
            <c:idx val="3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71-A2EB-4566-9B46-DAC7DE36ADA2}"/>
              </c:ext>
            </c:extLst>
          </c:dPt>
          <c:dPt>
            <c:idx val="3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73-A2EB-4566-9B46-DAC7DE36ADA2}"/>
              </c:ext>
            </c:extLst>
          </c:dPt>
          <c:dPt>
            <c:idx val="3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75-A2EB-4566-9B46-DAC7DE36ADA2}"/>
              </c:ext>
            </c:extLst>
          </c:dPt>
          <c:dPt>
            <c:idx val="3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77-A2EB-4566-9B46-DAC7DE36ADA2}"/>
              </c:ext>
            </c:extLst>
          </c:dPt>
          <c:dPt>
            <c:idx val="3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79-A2EB-4566-9B46-DAC7DE36ADA2}"/>
              </c:ext>
            </c:extLst>
          </c:dPt>
          <c:dPt>
            <c:idx val="3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7B-A2EB-4566-9B46-DAC7DE36ADA2}"/>
              </c:ext>
            </c:extLst>
          </c:dPt>
          <c:dPt>
            <c:idx val="3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7D-A2EB-4566-9B46-DAC7DE36ADA2}"/>
              </c:ext>
            </c:extLst>
          </c:dPt>
          <c:dPt>
            <c:idx val="3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7F-A2EB-4566-9B46-DAC7DE36ADA2}"/>
              </c:ext>
            </c:extLst>
          </c:dPt>
          <c:dPt>
            <c:idx val="4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81-A2EB-4566-9B46-DAC7DE36ADA2}"/>
              </c:ext>
            </c:extLst>
          </c:dPt>
          <c:dPt>
            <c:idx val="4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83-A2EB-4566-9B46-DAC7DE36ADA2}"/>
              </c:ext>
            </c:extLst>
          </c:dPt>
          <c:dPt>
            <c:idx val="4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85-A2EB-4566-9B46-DAC7DE36ADA2}"/>
              </c:ext>
            </c:extLst>
          </c:dPt>
          <c:dPt>
            <c:idx val="4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87-A2EB-4566-9B46-DAC7DE36ADA2}"/>
              </c:ext>
            </c:extLst>
          </c:dPt>
          <c:dPt>
            <c:idx val="4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89-A2EB-4566-9B46-DAC7DE36ADA2}"/>
              </c:ext>
            </c:extLst>
          </c:dPt>
          <c:dPt>
            <c:idx val="4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8B-A2EB-4566-9B46-DAC7DE36ADA2}"/>
              </c:ext>
            </c:extLst>
          </c:dPt>
          <c:dPt>
            <c:idx val="4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8D-A2EB-4566-9B46-DAC7DE36ADA2}"/>
              </c:ext>
            </c:extLst>
          </c:dPt>
          <c:dPt>
            <c:idx val="4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8F-A2EB-4566-9B46-DAC7DE36ADA2}"/>
              </c:ext>
            </c:extLst>
          </c:dPt>
          <c:dPt>
            <c:idx val="4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91-A2EB-4566-9B46-DAC7DE36ADA2}"/>
              </c:ext>
            </c:extLst>
          </c:dPt>
          <c:dPt>
            <c:idx val="4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93-A2EB-4566-9B46-DAC7DE36ADA2}"/>
              </c:ext>
            </c:extLst>
          </c:dPt>
          <c:dPt>
            <c:idx val="5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95-A2EB-4566-9B46-DAC7DE36ADA2}"/>
              </c:ext>
            </c:extLst>
          </c:dPt>
          <c:dPt>
            <c:idx val="5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97-A2EB-4566-9B46-DAC7DE36ADA2}"/>
              </c:ext>
            </c:extLst>
          </c:dPt>
          <c:dPt>
            <c:idx val="5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99-A2EB-4566-9B46-DAC7DE36ADA2}"/>
              </c:ext>
            </c:extLst>
          </c:dPt>
          <c:dPt>
            <c:idx val="5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9B-A2EB-4566-9B46-DAC7DE36ADA2}"/>
              </c:ext>
            </c:extLst>
          </c:dPt>
          <c:dPt>
            <c:idx val="5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9D-A2EB-4566-9B46-DAC7DE36ADA2}"/>
              </c:ext>
            </c:extLst>
          </c:dPt>
          <c:dPt>
            <c:idx val="5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9F-A2EB-4566-9B46-DAC7DE36ADA2}"/>
              </c:ext>
            </c:extLst>
          </c:dPt>
          <c:dPt>
            <c:idx val="5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A1-A2EB-4566-9B46-DAC7DE36ADA2}"/>
              </c:ext>
            </c:extLst>
          </c:dPt>
          <c:dPt>
            <c:idx val="5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A3-A2EB-4566-9B46-DAC7DE36ADA2}"/>
              </c:ext>
            </c:extLst>
          </c:dPt>
          <c:dPt>
            <c:idx val="5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A5-A2EB-4566-9B46-DAC7DE36ADA2}"/>
              </c:ext>
            </c:extLst>
          </c:dPt>
          <c:dPt>
            <c:idx val="5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A7-A2EB-4566-9B46-DAC7DE36ADA2}"/>
              </c:ext>
            </c:extLst>
          </c:dPt>
          <c:dPt>
            <c:idx val="6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A9-A2EB-4566-9B46-DAC7DE36ADA2}"/>
              </c:ext>
            </c:extLst>
          </c:dPt>
          <c:dPt>
            <c:idx val="6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AB-A2EB-4566-9B46-DAC7DE36ADA2}"/>
              </c:ext>
            </c:extLst>
          </c:dPt>
          <c:dPt>
            <c:idx val="6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AD-A2EB-4566-9B46-DAC7DE36ADA2}"/>
              </c:ext>
            </c:extLst>
          </c:dPt>
          <c:dPt>
            <c:idx val="6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AF-A2EB-4566-9B46-DAC7DE36ADA2}"/>
              </c:ext>
            </c:extLst>
          </c:dPt>
          <c:dPt>
            <c:idx val="6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B1-A2EB-4566-9B46-DAC7DE36ADA2}"/>
              </c:ext>
            </c:extLst>
          </c:dPt>
          <c:dPt>
            <c:idx val="6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B3-A2EB-4566-9B46-DAC7DE36ADA2}"/>
              </c:ext>
            </c:extLst>
          </c:dPt>
          <c:dPt>
            <c:idx val="6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B5-A2EB-4566-9B46-DAC7DE36ADA2}"/>
              </c:ext>
            </c:extLst>
          </c:dPt>
          <c:dPt>
            <c:idx val="6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B7-A2EB-4566-9B46-DAC7DE36ADA2}"/>
              </c:ext>
            </c:extLst>
          </c:dPt>
          <c:dPt>
            <c:idx val="6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B9-A2EB-4566-9B46-DAC7DE36ADA2}"/>
              </c:ext>
            </c:extLst>
          </c:dPt>
          <c:dPt>
            <c:idx val="6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BB-A2EB-4566-9B46-DAC7DE36ADA2}"/>
              </c:ext>
            </c:extLst>
          </c:dPt>
          <c:dPt>
            <c:idx val="7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BD-A2EB-4566-9B46-DAC7DE36ADA2}"/>
              </c:ext>
            </c:extLst>
          </c:dPt>
          <c:dPt>
            <c:idx val="7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BF-A2EB-4566-9B46-DAC7DE36ADA2}"/>
              </c:ext>
            </c:extLst>
          </c:dPt>
          <c:dPt>
            <c:idx val="7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C1-A2EB-4566-9B46-DAC7DE36ADA2}"/>
              </c:ext>
            </c:extLst>
          </c:dPt>
          <c:dPt>
            <c:idx val="7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C3-A2EB-4566-9B46-DAC7DE36ADA2}"/>
              </c:ext>
            </c:extLst>
          </c:dPt>
          <c:dPt>
            <c:idx val="7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C5-A2EB-4566-9B46-DAC7DE36ADA2}"/>
              </c:ext>
            </c:extLst>
          </c:dPt>
          <c:dPt>
            <c:idx val="7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C7-A2EB-4566-9B46-DAC7DE36ADA2}"/>
              </c:ext>
            </c:extLst>
          </c:dPt>
          <c:dPt>
            <c:idx val="7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C9-A2EB-4566-9B46-DAC7DE36ADA2}"/>
              </c:ext>
            </c:extLst>
          </c:dPt>
          <c:dPt>
            <c:idx val="7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CB-A2EB-4566-9B46-DAC7DE36ADA2}"/>
              </c:ext>
            </c:extLst>
          </c:dPt>
          <c:dPt>
            <c:idx val="7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CD-A2EB-4566-9B46-DAC7DE36ADA2}"/>
              </c:ext>
            </c:extLst>
          </c:dPt>
          <c:dPt>
            <c:idx val="7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CF-A2EB-4566-9B46-DAC7DE36ADA2}"/>
              </c:ext>
            </c:extLst>
          </c:dPt>
          <c:dPt>
            <c:idx val="8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D1-A2EB-4566-9B46-DAC7DE36ADA2}"/>
              </c:ext>
            </c:extLst>
          </c:dPt>
          <c:dPt>
            <c:idx val="8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D3-A2EB-4566-9B46-DAC7DE36ADA2}"/>
              </c:ext>
            </c:extLst>
          </c:dPt>
          <c:dPt>
            <c:idx val="8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D5-A2EB-4566-9B46-DAC7DE36ADA2}"/>
              </c:ext>
            </c:extLst>
          </c:dPt>
          <c:dPt>
            <c:idx val="8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D7-A2EB-4566-9B46-DAC7DE36ADA2}"/>
              </c:ext>
            </c:extLst>
          </c:dPt>
          <c:dPt>
            <c:idx val="8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D9-A2EB-4566-9B46-DAC7DE36ADA2}"/>
              </c:ext>
            </c:extLst>
          </c:dPt>
          <c:dPt>
            <c:idx val="8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DB-A2EB-4566-9B46-DAC7DE36ADA2}"/>
              </c:ext>
            </c:extLst>
          </c:dPt>
          <c:dPt>
            <c:idx val="8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DD-A2EB-4566-9B46-DAC7DE36ADA2}"/>
              </c:ext>
            </c:extLst>
          </c:dPt>
          <c:dPt>
            <c:idx val="8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DF-A2EB-4566-9B46-DAC7DE36ADA2}"/>
              </c:ext>
            </c:extLst>
          </c:dPt>
          <c:dPt>
            <c:idx val="8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E1-A2EB-4566-9B46-DAC7DE36ADA2}"/>
              </c:ext>
            </c:extLst>
          </c:dPt>
          <c:dPt>
            <c:idx val="8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E3-A2EB-4566-9B46-DAC7DE36ADA2}"/>
              </c:ext>
            </c:extLst>
          </c:dPt>
          <c:dPt>
            <c:idx val="9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E5-A2EB-4566-9B46-DAC7DE36ADA2}"/>
              </c:ext>
            </c:extLst>
          </c:dPt>
          <c:dPt>
            <c:idx val="9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E7-A2EB-4566-9B46-DAC7DE36ADA2}"/>
              </c:ext>
            </c:extLst>
          </c:dPt>
          <c:dPt>
            <c:idx val="9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E9-A2EB-4566-9B46-DAC7DE36ADA2}"/>
              </c:ext>
            </c:extLst>
          </c:dPt>
          <c:dPt>
            <c:idx val="9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EB-A2EB-4566-9B46-DAC7DE36ADA2}"/>
              </c:ext>
            </c:extLst>
          </c:dPt>
          <c:dPt>
            <c:idx val="9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ED-A2EB-4566-9B46-DAC7DE36ADA2}"/>
              </c:ext>
            </c:extLst>
          </c:dPt>
          <c:dPt>
            <c:idx val="9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EF-A2EB-4566-9B46-DAC7DE36ADA2}"/>
              </c:ext>
            </c:extLst>
          </c:dPt>
          <c:dPt>
            <c:idx val="9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F1-A2EB-4566-9B46-DAC7DE36ADA2}"/>
              </c:ext>
            </c:extLst>
          </c:dPt>
          <c:dPt>
            <c:idx val="9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F3-A2EB-4566-9B46-DAC7DE36ADA2}"/>
              </c:ext>
            </c:extLst>
          </c:dPt>
          <c:dPt>
            <c:idx val="9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F5-A2EB-4566-9B46-DAC7DE36ADA2}"/>
              </c:ext>
            </c:extLst>
          </c:dPt>
          <c:dPt>
            <c:idx val="9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F7-A2EB-4566-9B46-DAC7DE36ADA2}"/>
              </c:ext>
            </c:extLst>
          </c:dPt>
          <c:dPt>
            <c:idx val="10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F9-A2EB-4566-9B46-DAC7DE36ADA2}"/>
              </c:ext>
            </c:extLst>
          </c:dPt>
          <c:dPt>
            <c:idx val="10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FB-A2EB-4566-9B46-DAC7DE36ADA2}"/>
              </c:ext>
            </c:extLst>
          </c:dPt>
          <c:dPt>
            <c:idx val="10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FD-A2EB-4566-9B46-DAC7DE36ADA2}"/>
              </c:ext>
            </c:extLst>
          </c:dPt>
          <c:dPt>
            <c:idx val="10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5FF-A2EB-4566-9B46-DAC7DE36ADA2}"/>
              </c:ext>
            </c:extLst>
          </c:dPt>
          <c:dPt>
            <c:idx val="10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01-A2EB-4566-9B46-DAC7DE36ADA2}"/>
              </c:ext>
            </c:extLst>
          </c:dPt>
          <c:dPt>
            <c:idx val="10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03-A2EB-4566-9B46-DAC7DE36ADA2}"/>
              </c:ext>
            </c:extLst>
          </c:dPt>
          <c:dPt>
            <c:idx val="10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05-A2EB-4566-9B46-DAC7DE36ADA2}"/>
              </c:ext>
            </c:extLst>
          </c:dPt>
          <c:dPt>
            <c:idx val="10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07-A2EB-4566-9B46-DAC7DE36ADA2}"/>
              </c:ext>
            </c:extLst>
          </c:dPt>
          <c:dPt>
            <c:idx val="10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09-A2EB-4566-9B46-DAC7DE36ADA2}"/>
              </c:ext>
            </c:extLst>
          </c:dPt>
          <c:dPt>
            <c:idx val="10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0B-A2EB-4566-9B46-DAC7DE36ADA2}"/>
              </c:ext>
            </c:extLst>
          </c:dPt>
          <c:dPt>
            <c:idx val="11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0D-A2EB-4566-9B46-DAC7DE36ADA2}"/>
              </c:ext>
            </c:extLst>
          </c:dPt>
          <c:dPt>
            <c:idx val="11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0F-A2EB-4566-9B46-DAC7DE36ADA2}"/>
              </c:ext>
            </c:extLst>
          </c:dPt>
          <c:dPt>
            <c:idx val="11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11-A2EB-4566-9B46-DAC7DE36ADA2}"/>
              </c:ext>
            </c:extLst>
          </c:dPt>
          <c:dPt>
            <c:idx val="11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13-A2EB-4566-9B46-DAC7DE36ADA2}"/>
              </c:ext>
            </c:extLst>
          </c:dPt>
          <c:dPt>
            <c:idx val="11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15-A2EB-4566-9B46-DAC7DE36ADA2}"/>
              </c:ext>
            </c:extLst>
          </c:dPt>
          <c:dPt>
            <c:idx val="11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17-A2EB-4566-9B46-DAC7DE36ADA2}"/>
              </c:ext>
            </c:extLst>
          </c:dPt>
          <c:dPt>
            <c:idx val="11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19-A2EB-4566-9B46-DAC7DE36ADA2}"/>
              </c:ext>
            </c:extLst>
          </c:dPt>
          <c:dPt>
            <c:idx val="11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1B-A2EB-4566-9B46-DAC7DE36ADA2}"/>
              </c:ext>
            </c:extLst>
          </c:dPt>
          <c:dPt>
            <c:idx val="11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1D-A2EB-4566-9B46-DAC7DE36ADA2}"/>
              </c:ext>
            </c:extLst>
          </c:dPt>
          <c:dPt>
            <c:idx val="11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1F-A2EB-4566-9B46-DAC7DE36ADA2}"/>
              </c:ext>
            </c:extLst>
          </c:dPt>
          <c:dPt>
            <c:idx val="12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21-A2EB-4566-9B46-DAC7DE36ADA2}"/>
              </c:ext>
            </c:extLst>
          </c:dPt>
          <c:dPt>
            <c:idx val="12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23-A2EB-4566-9B46-DAC7DE36ADA2}"/>
              </c:ext>
            </c:extLst>
          </c:dPt>
          <c:dPt>
            <c:idx val="12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25-A2EB-4566-9B46-DAC7DE36ADA2}"/>
              </c:ext>
            </c:extLst>
          </c:dPt>
          <c:dPt>
            <c:idx val="12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27-A2EB-4566-9B46-DAC7DE36ADA2}"/>
              </c:ext>
            </c:extLst>
          </c:dPt>
          <c:dPt>
            <c:idx val="12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29-A2EB-4566-9B46-DAC7DE36ADA2}"/>
              </c:ext>
            </c:extLst>
          </c:dPt>
          <c:dPt>
            <c:idx val="12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2B-A2EB-4566-9B46-DAC7DE36ADA2}"/>
              </c:ext>
            </c:extLst>
          </c:dPt>
          <c:dPt>
            <c:idx val="12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2D-A2EB-4566-9B46-DAC7DE36ADA2}"/>
              </c:ext>
            </c:extLst>
          </c:dPt>
          <c:dPt>
            <c:idx val="12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2F-A2EB-4566-9B46-DAC7DE36ADA2}"/>
              </c:ext>
            </c:extLst>
          </c:dPt>
          <c:dPt>
            <c:idx val="12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31-A2EB-4566-9B46-DAC7DE36ADA2}"/>
              </c:ext>
            </c:extLst>
          </c:dPt>
          <c:dPt>
            <c:idx val="12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33-A2EB-4566-9B46-DAC7DE36ADA2}"/>
              </c:ext>
            </c:extLst>
          </c:dPt>
          <c:dPt>
            <c:idx val="13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35-A2EB-4566-9B46-DAC7DE36ADA2}"/>
              </c:ext>
            </c:extLst>
          </c:dPt>
          <c:dPt>
            <c:idx val="13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37-A2EB-4566-9B46-DAC7DE36ADA2}"/>
              </c:ext>
            </c:extLst>
          </c:dPt>
          <c:dPt>
            <c:idx val="13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39-A2EB-4566-9B46-DAC7DE36ADA2}"/>
              </c:ext>
            </c:extLst>
          </c:dPt>
          <c:dPt>
            <c:idx val="13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3B-A2EB-4566-9B46-DAC7DE36ADA2}"/>
              </c:ext>
            </c:extLst>
          </c:dPt>
          <c:dPt>
            <c:idx val="13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3D-A2EB-4566-9B46-DAC7DE36ADA2}"/>
              </c:ext>
            </c:extLst>
          </c:dPt>
          <c:dPt>
            <c:idx val="13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3F-A2EB-4566-9B46-DAC7DE36ADA2}"/>
              </c:ext>
            </c:extLst>
          </c:dPt>
          <c:dPt>
            <c:idx val="13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41-A2EB-4566-9B46-DAC7DE36ADA2}"/>
              </c:ext>
            </c:extLst>
          </c:dPt>
          <c:dPt>
            <c:idx val="13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43-A2EB-4566-9B46-DAC7DE36ADA2}"/>
              </c:ext>
            </c:extLst>
          </c:dPt>
          <c:dPt>
            <c:idx val="13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45-A2EB-4566-9B46-DAC7DE36ADA2}"/>
              </c:ext>
            </c:extLst>
          </c:dPt>
          <c:dPt>
            <c:idx val="13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47-A2EB-4566-9B46-DAC7DE36ADA2}"/>
              </c:ext>
            </c:extLst>
          </c:dPt>
          <c:dPt>
            <c:idx val="14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49-A2EB-4566-9B46-DAC7DE36ADA2}"/>
              </c:ext>
            </c:extLst>
          </c:dPt>
          <c:dPt>
            <c:idx val="14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4B-A2EB-4566-9B46-DAC7DE36ADA2}"/>
              </c:ext>
            </c:extLst>
          </c:dPt>
          <c:dPt>
            <c:idx val="14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4D-A2EB-4566-9B46-DAC7DE36ADA2}"/>
              </c:ext>
            </c:extLst>
          </c:dPt>
          <c:dPt>
            <c:idx val="14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4F-A2EB-4566-9B46-DAC7DE36ADA2}"/>
              </c:ext>
            </c:extLst>
          </c:dPt>
          <c:dPt>
            <c:idx val="14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51-A2EB-4566-9B46-DAC7DE36ADA2}"/>
              </c:ext>
            </c:extLst>
          </c:dPt>
          <c:dPt>
            <c:idx val="14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53-A2EB-4566-9B46-DAC7DE36ADA2}"/>
              </c:ext>
            </c:extLst>
          </c:dPt>
          <c:dPt>
            <c:idx val="14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55-A2EB-4566-9B46-DAC7DE36ADA2}"/>
              </c:ext>
            </c:extLst>
          </c:dPt>
          <c:dPt>
            <c:idx val="14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57-A2EB-4566-9B46-DAC7DE36ADA2}"/>
              </c:ext>
            </c:extLst>
          </c:dPt>
          <c:dPt>
            <c:idx val="14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59-A2EB-4566-9B46-DAC7DE36ADA2}"/>
              </c:ext>
            </c:extLst>
          </c:dPt>
          <c:dPt>
            <c:idx val="14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5B-A2EB-4566-9B46-DAC7DE36ADA2}"/>
              </c:ext>
            </c:extLst>
          </c:dPt>
          <c:dPt>
            <c:idx val="15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5D-A2EB-4566-9B46-DAC7DE36ADA2}"/>
              </c:ext>
            </c:extLst>
          </c:dPt>
          <c:dPt>
            <c:idx val="15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5F-A2EB-4566-9B46-DAC7DE36ADA2}"/>
              </c:ext>
            </c:extLst>
          </c:dPt>
          <c:dPt>
            <c:idx val="15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61-A2EB-4566-9B46-DAC7DE36ADA2}"/>
              </c:ext>
            </c:extLst>
          </c:dPt>
          <c:dPt>
            <c:idx val="15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63-A2EB-4566-9B46-DAC7DE36ADA2}"/>
              </c:ext>
            </c:extLst>
          </c:dPt>
          <c:dPt>
            <c:idx val="15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65-A2EB-4566-9B46-DAC7DE36ADA2}"/>
              </c:ext>
            </c:extLst>
          </c:dPt>
          <c:dPt>
            <c:idx val="15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67-A2EB-4566-9B46-DAC7DE36ADA2}"/>
              </c:ext>
            </c:extLst>
          </c:dPt>
          <c:dPt>
            <c:idx val="15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69-A2EB-4566-9B46-DAC7DE36ADA2}"/>
              </c:ext>
            </c:extLst>
          </c:dPt>
          <c:dPt>
            <c:idx val="15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6B-A2EB-4566-9B46-DAC7DE36ADA2}"/>
              </c:ext>
            </c:extLst>
          </c:dPt>
          <c:dPt>
            <c:idx val="15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6D-A2EB-4566-9B46-DAC7DE36ADA2}"/>
              </c:ext>
            </c:extLst>
          </c:dPt>
          <c:dPt>
            <c:idx val="15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6F-A2EB-4566-9B46-DAC7DE36ADA2}"/>
              </c:ext>
            </c:extLst>
          </c:dPt>
          <c:dPt>
            <c:idx val="16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71-A2EB-4566-9B46-DAC7DE36ADA2}"/>
              </c:ext>
            </c:extLst>
          </c:dPt>
          <c:dPt>
            <c:idx val="16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73-A2EB-4566-9B46-DAC7DE36ADA2}"/>
              </c:ext>
            </c:extLst>
          </c:dPt>
          <c:dPt>
            <c:idx val="16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75-A2EB-4566-9B46-DAC7DE36ADA2}"/>
              </c:ext>
            </c:extLst>
          </c:dPt>
          <c:dPt>
            <c:idx val="16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77-A2EB-4566-9B46-DAC7DE36ADA2}"/>
              </c:ext>
            </c:extLst>
          </c:dPt>
          <c:dPt>
            <c:idx val="16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79-A2EB-4566-9B46-DAC7DE36ADA2}"/>
              </c:ext>
            </c:extLst>
          </c:dPt>
          <c:dPt>
            <c:idx val="16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7B-A2EB-4566-9B46-DAC7DE36ADA2}"/>
              </c:ext>
            </c:extLst>
          </c:dPt>
          <c:dPt>
            <c:idx val="16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7D-A2EB-4566-9B46-DAC7DE36ADA2}"/>
              </c:ext>
            </c:extLst>
          </c:dPt>
          <c:dPt>
            <c:idx val="16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7F-A2EB-4566-9B46-DAC7DE36ADA2}"/>
              </c:ext>
            </c:extLst>
          </c:dPt>
          <c:dPt>
            <c:idx val="16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81-A2EB-4566-9B46-DAC7DE36ADA2}"/>
              </c:ext>
            </c:extLst>
          </c:dPt>
          <c:dPt>
            <c:idx val="16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83-A2EB-4566-9B46-DAC7DE36ADA2}"/>
              </c:ext>
            </c:extLst>
          </c:dPt>
          <c:dPt>
            <c:idx val="17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85-A2EB-4566-9B46-DAC7DE36ADA2}"/>
              </c:ext>
            </c:extLst>
          </c:dPt>
          <c:dPt>
            <c:idx val="171"/>
            <c:invertIfNegative val="0"/>
            <c:bubble3D val="0"/>
            <c:spPr>
              <a:solidFill>
                <a:srgbClr val="64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87-A2EB-4566-9B46-DAC7DE36ADA2}"/>
              </c:ext>
            </c:extLst>
          </c:dPt>
          <c:dPt>
            <c:idx val="17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89-A2EB-4566-9B46-DAC7DE36ADA2}"/>
              </c:ext>
            </c:extLst>
          </c:dPt>
          <c:dPt>
            <c:idx val="173"/>
            <c:invertIfNegative val="0"/>
            <c:bubble3D val="0"/>
            <c:spPr>
              <a:solidFill>
                <a:srgbClr val="0096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8B-A2EB-4566-9B46-DAC7DE36ADA2}"/>
              </c:ext>
            </c:extLst>
          </c:dPt>
          <c:dPt>
            <c:idx val="17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8D-A2EB-4566-9B46-DAC7DE36ADA2}"/>
              </c:ext>
            </c:extLst>
          </c:dPt>
          <c:dPt>
            <c:idx val="17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8F-A2EB-4566-9B46-DAC7DE36ADA2}"/>
              </c:ext>
            </c:extLst>
          </c:dPt>
          <c:dPt>
            <c:idx val="17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91-A2EB-4566-9B46-DAC7DE36ADA2}"/>
              </c:ext>
            </c:extLst>
          </c:dPt>
          <c:dPt>
            <c:idx val="17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93-A2EB-4566-9B46-DAC7DE36ADA2}"/>
              </c:ext>
            </c:extLst>
          </c:dPt>
          <c:dPt>
            <c:idx val="17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95-A2EB-4566-9B46-DAC7DE36ADA2}"/>
              </c:ext>
            </c:extLst>
          </c:dPt>
          <c:dPt>
            <c:idx val="18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97-A2EB-4566-9B46-DAC7DE36ADA2}"/>
              </c:ext>
            </c:extLst>
          </c:dPt>
          <c:dPt>
            <c:idx val="18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99-A2EB-4566-9B46-DAC7DE36ADA2}"/>
              </c:ext>
            </c:extLst>
          </c:dPt>
          <c:dPt>
            <c:idx val="18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9B-A2EB-4566-9B46-DAC7DE36ADA2}"/>
              </c:ext>
            </c:extLst>
          </c:dPt>
          <c:dPt>
            <c:idx val="18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9D-A2EB-4566-9B46-DAC7DE36ADA2}"/>
              </c:ext>
            </c:extLst>
          </c:dPt>
          <c:dPt>
            <c:idx val="18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9F-A2EB-4566-9B46-DAC7DE36ADA2}"/>
              </c:ext>
            </c:extLst>
          </c:dPt>
          <c:dPt>
            <c:idx val="18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A1-A2EB-4566-9B46-DAC7DE36ADA2}"/>
              </c:ext>
            </c:extLst>
          </c:dPt>
          <c:dPt>
            <c:idx val="18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A3-A2EB-4566-9B46-DAC7DE36ADA2}"/>
              </c:ext>
            </c:extLst>
          </c:dPt>
          <c:dPt>
            <c:idx val="18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A5-A2EB-4566-9B46-DAC7DE36ADA2}"/>
              </c:ext>
            </c:extLst>
          </c:dPt>
          <c:dPt>
            <c:idx val="18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A7-A2EB-4566-9B46-DAC7DE36ADA2}"/>
              </c:ext>
            </c:extLst>
          </c:dPt>
          <c:dPt>
            <c:idx val="18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A9-A2EB-4566-9B46-DAC7DE36ADA2}"/>
              </c:ext>
            </c:extLst>
          </c:dPt>
          <c:dPt>
            <c:idx val="19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AB-A2EB-4566-9B46-DAC7DE36ADA2}"/>
              </c:ext>
            </c:extLst>
          </c:dPt>
          <c:dPt>
            <c:idx val="19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AD-A2EB-4566-9B46-DAC7DE36ADA2}"/>
              </c:ext>
            </c:extLst>
          </c:dPt>
          <c:dPt>
            <c:idx val="19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AF-A2EB-4566-9B46-DAC7DE36ADA2}"/>
              </c:ext>
            </c:extLst>
          </c:dPt>
          <c:dPt>
            <c:idx val="19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B1-A2EB-4566-9B46-DAC7DE36ADA2}"/>
              </c:ext>
            </c:extLst>
          </c:dPt>
          <c:dPt>
            <c:idx val="194"/>
            <c:invertIfNegative val="0"/>
            <c:bubble3D val="0"/>
            <c:spPr>
              <a:solidFill>
                <a:srgbClr val="C8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B3-A2EB-4566-9B46-DAC7DE36ADA2}"/>
              </c:ext>
            </c:extLst>
          </c:dPt>
          <c:dPt>
            <c:idx val="195"/>
            <c:invertIfNegative val="0"/>
            <c:bubble3D val="0"/>
            <c:spPr>
              <a:solidFill>
                <a:srgbClr val="0046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B5-A2EB-4566-9B46-DAC7DE36ADA2}"/>
              </c:ext>
            </c:extLst>
          </c:dPt>
          <c:dPt>
            <c:idx val="19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B7-A2EB-4566-9B46-DAC7DE36ADA2}"/>
              </c:ext>
            </c:extLst>
          </c:dPt>
          <c:dPt>
            <c:idx val="197"/>
            <c:invertIfNegative val="0"/>
            <c:bubble3D val="0"/>
            <c:spPr>
              <a:solidFill>
                <a:srgbClr val="0046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B9-A2EB-4566-9B46-DAC7DE36ADA2}"/>
              </c:ext>
            </c:extLst>
          </c:dPt>
          <c:dPt>
            <c:idx val="19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BB-A2EB-4566-9B46-DAC7DE36ADA2}"/>
              </c:ext>
            </c:extLst>
          </c:dPt>
          <c:dPt>
            <c:idx val="19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BD-A2EB-4566-9B46-DAC7DE36ADA2}"/>
              </c:ext>
            </c:extLst>
          </c:dPt>
          <c:dPt>
            <c:idx val="20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BF-A2EB-4566-9B46-DAC7DE36ADA2}"/>
              </c:ext>
            </c:extLst>
          </c:dPt>
          <c:dPt>
            <c:idx val="201"/>
            <c:invertIfNegative val="0"/>
            <c:bubble3D val="0"/>
            <c:spPr>
              <a:solidFill>
                <a:srgbClr val="C8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C1-A2EB-4566-9B46-DAC7DE36ADA2}"/>
              </c:ext>
            </c:extLst>
          </c:dPt>
          <c:dPt>
            <c:idx val="202"/>
            <c:invertIfNegative val="0"/>
            <c:bubble3D val="0"/>
            <c:spPr>
              <a:solidFill>
                <a:srgbClr val="0096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C3-A2EB-4566-9B46-DAC7DE36ADA2}"/>
              </c:ext>
            </c:extLst>
          </c:dPt>
          <c:dPt>
            <c:idx val="203"/>
            <c:invertIfNegative val="0"/>
            <c:bubble3D val="0"/>
            <c:spPr>
              <a:solidFill>
                <a:srgbClr val="C8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C5-A2EB-4566-9B46-DAC7DE36ADA2}"/>
              </c:ext>
            </c:extLst>
          </c:dPt>
          <c:dPt>
            <c:idx val="204"/>
            <c:invertIfNegative val="0"/>
            <c:bubble3D val="0"/>
            <c:spPr>
              <a:solidFill>
                <a:srgbClr val="C8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C7-A2EB-4566-9B46-DAC7DE36ADA2}"/>
              </c:ext>
            </c:extLst>
          </c:dPt>
          <c:dPt>
            <c:idx val="20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C9-A2EB-4566-9B46-DAC7DE36ADA2}"/>
              </c:ext>
            </c:extLst>
          </c:dPt>
          <c:dPt>
            <c:idx val="206"/>
            <c:invertIfNegative val="0"/>
            <c:bubble3D val="0"/>
            <c:spPr>
              <a:solidFill>
                <a:srgbClr val="0046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CB-A2EB-4566-9B46-DAC7DE36ADA2}"/>
              </c:ext>
            </c:extLst>
          </c:dPt>
          <c:dPt>
            <c:idx val="20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CD-A2EB-4566-9B46-DAC7DE36ADA2}"/>
              </c:ext>
            </c:extLst>
          </c:dPt>
          <c:dPt>
            <c:idx val="20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CF-A2EB-4566-9B46-DAC7DE36ADA2}"/>
              </c:ext>
            </c:extLst>
          </c:dPt>
          <c:dPt>
            <c:idx val="20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D1-A2EB-4566-9B46-DAC7DE36ADA2}"/>
              </c:ext>
            </c:extLst>
          </c:dPt>
          <c:dPt>
            <c:idx val="21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D3-A2EB-4566-9B46-DAC7DE36ADA2}"/>
              </c:ext>
            </c:extLst>
          </c:dPt>
          <c:dPt>
            <c:idx val="21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D5-A2EB-4566-9B46-DAC7DE36ADA2}"/>
              </c:ext>
            </c:extLst>
          </c:dPt>
          <c:dPt>
            <c:idx val="21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D7-A2EB-4566-9B46-DAC7DE36ADA2}"/>
              </c:ext>
            </c:extLst>
          </c:dPt>
          <c:dPt>
            <c:idx val="21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D9-A2EB-4566-9B46-DAC7DE36ADA2}"/>
              </c:ext>
            </c:extLst>
          </c:dPt>
          <c:dPt>
            <c:idx val="21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DB-A2EB-4566-9B46-DAC7DE36ADA2}"/>
              </c:ext>
            </c:extLst>
          </c:dPt>
          <c:dPt>
            <c:idx val="21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DD-A2EB-4566-9B46-DAC7DE36ADA2}"/>
              </c:ext>
            </c:extLst>
          </c:dPt>
          <c:dPt>
            <c:idx val="21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DF-A2EB-4566-9B46-DAC7DE36ADA2}"/>
              </c:ext>
            </c:extLst>
          </c:dPt>
          <c:dPt>
            <c:idx val="21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E1-A2EB-4566-9B46-DAC7DE36ADA2}"/>
              </c:ext>
            </c:extLst>
          </c:dPt>
          <c:dPt>
            <c:idx val="21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E3-A2EB-4566-9B46-DAC7DE36ADA2}"/>
              </c:ext>
            </c:extLst>
          </c:dPt>
          <c:dPt>
            <c:idx val="21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E5-A2EB-4566-9B46-DAC7DE36ADA2}"/>
              </c:ext>
            </c:extLst>
          </c:dPt>
          <c:dPt>
            <c:idx val="22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E7-A2EB-4566-9B46-DAC7DE36ADA2}"/>
              </c:ext>
            </c:extLst>
          </c:dPt>
          <c:dPt>
            <c:idx val="22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E9-A2EB-4566-9B46-DAC7DE36ADA2}"/>
              </c:ext>
            </c:extLst>
          </c:dPt>
          <c:dPt>
            <c:idx val="22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EB-A2EB-4566-9B46-DAC7DE36ADA2}"/>
              </c:ext>
            </c:extLst>
          </c:dPt>
          <c:dPt>
            <c:idx val="22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ED-A2EB-4566-9B46-DAC7DE36ADA2}"/>
              </c:ext>
            </c:extLst>
          </c:dPt>
          <c:dPt>
            <c:idx val="22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EF-A2EB-4566-9B46-DAC7DE36ADA2}"/>
              </c:ext>
            </c:extLst>
          </c:dPt>
          <c:dPt>
            <c:idx val="22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F1-A2EB-4566-9B46-DAC7DE36ADA2}"/>
              </c:ext>
            </c:extLst>
          </c:dPt>
          <c:dPt>
            <c:idx val="22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F3-A2EB-4566-9B46-DAC7DE36ADA2}"/>
              </c:ext>
            </c:extLst>
          </c:dPt>
          <c:dPt>
            <c:idx val="22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F5-A2EB-4566-9B46-DAC7DE36ADA2}"/>
              </c:ext>
            </c:extLst>
          </c:dPt>
          <c:dPt>
            <c:idx val="22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F7-A2EB-4566-9B46-DAC7DE36ADA2}"/>
              </c:ext>
            </c:extLst>
          </c:dPt>
          <c:dPt>
            <c:idx val="22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F9-A2EB-4566-9B46-DAC7DE36ADA2}"/>
              </c:ext>
            </c:extLst>
          </c:dPt>
          <c:dPt>
            <c:idx val="23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FB-A2EB-4566-9B46-DAC7DE36ADA2}"/>
              </c:ext>
            </c:extLst>
          </c:dPt>
          <c:dPt>
            <c:idx val="23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FD-A2EB-4566-9B46-DAC7DE36ADA2}"/>
              </c:ext>
            </c:extLst>
          </c:dPt>
          <c:dPt>
            <c:idx val="23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6FF-A2EB-4566-9B46-DAC7DE36ADA2}"/>
              </c:ext>
            </c:extLst>
          </c:dPt>
          <c:dPt>
            <c:idx val="23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01-A2EB-4566-9B46-DAC7DE36ADA2}"/>
              </c:ext>
            </c:extLst>
          </c:dPt>
          <c:dPt>
            <c:idx val="23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03-A2EB-4566-9B46-DAC7DE36ADA2}"/>
              </c:ext>
            </c:extLst>
          </c:dPt>
          <c:dPt>
            <c:idx val="23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05-A2EB-4566-9B46-DAC7DE36ADA2}"/>
              </c:ext>
            </c:extLst>
          </c:dPt>
          <c:dPt>
            <c:idx val="23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07-A2EB-4566-9B46-DAC7DE36ADA2}"/>
              </c:ext>
            </c:extLst>
          </c:dPt>
          <c:dPt>
            <c:idx val="23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09-A2EB-4566-9B46-DAC7DE36ADA2}"/>
              </c:ext>
            </c:extLst>
          </c:dPt>
          <c:dPt>
            <c:idx val="23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0B-A2EB-4566-9B46-DAC7DE36ADA2}"/>
              </c:ext>
            </c:extLst>
          </c:dPt>
          <c:dPt>
            <c:idx val="23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0D-A2EB-4566-9B46-DAC7DE36ADA2}"/>
              </c:ext>
            </c:extLst>
          </c:dPt>
          <c:dPt>
            <c:idx val="24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0F-A2EB-4566-9B46-DAC7DE36ADA2}"/>
              </c:ext>
            </c:extLst>
          </c:dPt>
          <c:dPt>
            <c:idx val="24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11-A2EB-4566-9B46-DAC7DE36ADA2}"/>
              </c:ext>
            </c:extLst>
          </c:dPt>
          <c:dPt>
            <c:idx val="24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13-A2EB-4566-9B46-DAC7DE36ADA2}"/>
              </c:ext>
            </c:extLst>
          </c:dPt>
          <c:dPt>
            <c:idx val="24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15-A2EB-4566-9B46-DAC7DE36ADA2}"/>
              </c:ext>
            </c:extLst>
          </c:dPt>
          <c:dPt>
            <c:idx val="24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17-A2EB-4566-9B46-DAC7DE36ADA2}"/>
              </c:ext>
            </c:extLst>
          </c:dPt>
          <c:dPt>
            <c:idx val="24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19-A2EB-4566-9B46-DAC7DE36ADA2}"/>
              </c:ext>
            </c:extLst>
          </c:dPt>
          <c:dPt>
            <c:idx val="24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1B-A2EB-4566-9B46-DAC7DE36ADA2}"/>
              </c:ext>
            </c:extLst>
          </c:dPt>
          <c:dPt>
            <c:idx val="24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1D-A2EB-4566-9B46-DAC7DE36ADA2}"/>
              </c:ext>
            </c:extLst>
          </c:dPt>
          <c:dPt>
            <c:idx val="24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1F-A2EB-4566-9B46-DAC7DE36ADA2}"/>
              </c:ext>
            </c:extLst>
          </c:dPt>
          <c:dPt>
            <c:idx val="24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21-A2EB-4566-9B46-DAC7DE36ADA2}"/>
              </c:ext>
            </c:extLst>
          </c:dPt>
          <c:dPt>
            <c:idx val="25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23-A2EB-4566-9B46-DAC7DE36ADA2}"/>
              </c:ext>
            </c:extLst>
          </c:dPt>
          <c:dPt>
            <c:idx val="25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25-A2EB-4566-9B46-DAC7DE36ADA2}"/>
              </c:ext>
            </c:extLst>
          </c:dPt>
          <c:dPt>
            <c:idx val="25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27-A2EB-4566-9B46-DAC7DE36ADA2}"/>
              </c:ext>
            </c:extLst>
          </c:dPt>
          <c:dPt>
            <c:idx val="25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29-A2EB-4566-9B46-DAC7DE36ADA2}"/>
              </c:ext>
            </c:extLst>
          </c:dPt>
          <c:dPt>
            <c:idx val="25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2B-A2EB-4566-9B46-DAC7DE36ADA2}"/>
              </c:ext>
            </c:extLst>
          </c:dPt>
          <c:dPt>
            <c:idx val="25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2D-A2EB-4566-9B46-DAC7DE36ADA2}"/>
              </c:ext>
            </c:extLst>
          </c:dPt>
          <c:dPt>
            <c:idx val="25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2F-A2EB-4566-9B46-DAC7DE36ADA2}"/>
              </c:ext>
            </c:extLst>
          </c:dPt>
          <c:dPt>
            <c:idx val="25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31-A2EB-4566-9B46-DAC7DE36ADA2}"/>
              </c:ext>
            </c:extLst>
          </c:dPt>
          <c:dPt>
            <c:idx val="25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33-A2EB-4566-9B46-DAC7DE36ADA2}"/>
              </c:ext>
            </c:extLst>
          </c:dPt>
          <c:dPt>
            <c:idx val="25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35-A2EB-4566-9B46-DAC7DE36ADA2}"/>
              </c:ext>
            </c:extLst>
          </c:dPt>
          <c:dPt>
            <c:idx val="26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37-A2EB-4566-9B46-DAC7DE36ADA2}"/>
              </c:ext>
            </c:extLst>
          </c:dPt>
          <c:dPt>
            <c:idx val="26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39-A2EB-4566-9B46-DAC7DE36ADA2}"/>
              </c:ext>
            </c:extLst>
          </c:dPt>
          <c:dPt>
            <c:idx val="26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3B-A2EB-4566-9B46-DAC7DE36ADA2}"/>
              </c:ext>
            </c:extLst>
          </c:dPt>
          <c:dPt>
            <c:idx val="26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3D-A2EB-4566-9B46-DAC7DE36ADA2}"/>
              </c:ext>
            </c:extLst>
          </c:dPt>
          <c:dPt>
            <c:idx val="26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3F-A2EB-4566-9B46-DAC7DE36ADA2}"/>
              </c:ext>
            </c:extLst>
          </c:dPt>
          <c:dPt>
            <c:idx val="26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41-A2EB-4566-9B46-DAC7DE36ADA2}"/>
              </c:ext>
            </c:extLst>
          </c:dPt>
          <c:dPt>
            <c:idx val="26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43-A2EB-4566-9B46-DAC7DE36ADA2}"/>
              </c:ext>
            </c:extLst>
          </c:dPt>
          <c:dPt>
            <c:idx val="26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45-A2EB-4566-9B46-DAC7DE36ADA2}"/>
              </c:ext>
            </c:extLst>
          </c:dPt>
          <c:dPt>
            <c:idx val="26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47-A2EB-4566-9B46-DAC7DE36ADA2}"/>
              </c:ext>
            </c:extLst>
          </c:dPt>
          <c:dPt>
            <c:idx val="26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49-A2EB-4566-9B46-DAC7DE36ADA2}"/>
              </c:ext>
            </c:extLst>
          </c:dPt>
          <c:dPt>
            <c:idx val="27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4B-A2EB-4566-9B46-DAC7DE36ADA2}"/>
              </c:ext>
            </c:extLst>
          </c:dPt>
          <c:dPt>
            <c:idx val="27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4D-A2EB-4566-9B46-DAC7DE36ADA2}"/>
              </c:ext>
            </c:extLst>
          </c:dPt>
          <c:dPt>
            <c:idx val="27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4F-A2EB-4566-9B46-DAC7DE36ADA2}"/>
              </c:ext>
            </c:extLst>
          </c:dPt>
          <c:dPt>
            <c:idx val="27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51-A2EB-4566-9B46-DAC7DE36ADA2}"/>
              </c:ext>
            </c:extLst>
          </c:dPt>
          <c:dPt>
            <c:idx val="27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53-A2EB-4566-9B46-DAC7DE36ADA2}"/>
              </c:ext>
            </c:extLst>
          </c:dPt>
          <c:dPt>
            <c:idx val="27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55-A2EB-4566-9B46-DAC7DE36ADA2}"/>
              </c:ext>
            </c:extLst>
          </c:dPt>
          <c:dPt>
            <c:idx val="27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57-A2EB-4566-9B46-DAC7DE36ADA2}"/>
              </c:ext>
            </c:extLst>
          </c:dPt>
          <c:dPt>
            <c:idx val="27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59-A2EB-4566-9B46-DAC7DE36ADA2}"/>
              </c:ext>
            </c:extLst>
          </c:dPt>
          <c:dPt>
            <c:idx val="27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5B-A2EB-4566-9B46-DAC7DE36ADA2}"/>
              </c:ext>
            </c:extLst>
          </c:dPt>
          <c:dPt>
            <c:idx val="27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5D-A2EB-4566-9B46-DAC7DE36ADA2}"/>
              </c:ext>
            </c:extLst>
          </c:dPt>
          <c:dPt>
            <c:idx val="280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5F-A2EB-4566-9B46-DAC7DE36ADA2}"/>
              </c:ext>
            </c:extLst>
          </c:dPt>
          <c:dPt>
            <c:idx val="281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61-A2EB-4566-9B46-DAC7DE36ADA2}"/>
              </c:ext>
            </c:extLst>
          </c:dPt>
          <c:dPt>
            <c:idx val="282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63-A2EB-4566-9B46-DAC7DE36ADA2}"/>
              </c:ext>
            </c:extLst>
          </c:dPt>
          <c:dPt>
            <c:idx val="283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65-A2EB-4566-9B46-DAC7DE36ADA2}"/>
              </c:ext>
            </c:extLst>
          </c:dPt>
          <c:dPt>
            <c:idx val="284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67-A2EB-4566-9B46-DAC7DE36ADA2}"/>
              </c:ext>
            </c:extLst>
          </c:dPt>
          <c:dPt>
            <c:idx val="285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69-A2EB-4566-9B46-DAC7DE36ADA2}"/>
              </c:ext>
            </c:extLst>
          </c:dPt>
          <c:dPt>
            <c:idx val="286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6B-A2EB-4566-9B46-DAC7DE36ADA2}"/>
              </c:ext>
            </c:extLst>
          </c:dPt>
          <c:dPt>
            <c:idx val="28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6D-A2EB-4566-9B46-DAC7DE36ADA2}"/>
              </c:ext>
            </c:extLst>
          </c:dPt>
          <c:dPt>
            <c:idx val="28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6F-A2EB-4566-9B46-DAC7DE36ADA2}"/>
              </c:ext>
            </c:extLst>
          </c:dPt>
          <c:dPt>
            <c:idx val="28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71-A2EB-4566-9B46-DAC7DE36ADA2}"/>
              </c:ext>
            </c:extLst>
          </c:dPt>
          <c:dPt>
            <c:idx val="29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73-A2EB-4566-9B46-DAC7DE36ADA2}"/>
              </c:ext>
            </c:extLst>
          </c:dPt>
          <c:dPt>
            <c:idx val="29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75-A2EB-4566-9B46-DAC7DE36ADA2}"/>
              </c:ext>
            </c:extLst>
          </c:dPt>
          <c:dPt>
            <c:idx val="29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77-A2EB-4566-9B46-DAC7DE36ADA2}"/>
              </c:ext>
            </c:extLst>
          </c:dPt>
          <c:dPt>
            <c:idx val="29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79-A2EB-4566-9B46-DAC7DE36ADA2}"/>
              </c:ext>
            </c:extLst>
          </c:dPt>
          <c:dPt>
            <c:idx val="29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7B-A2EB-4566-9B46-DAC7DE36ADA2}"/>
              </c:ext>
            </c:extLst>
          </c:dPt>
          <c:dPt>
            <c:idx val="29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7D-A2EB-4566-9B46-DAC7DE36ADA2}"/>
              </c:ext>
            </c:extLst>
          </c:dPt>
          <c:dPt>
            <c:idx val="29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7F-A2EB-4566-9B46-DAC7DE36ADA2}"/>
              </c:ext>
            </c:extLst>
          </c:dPt>
          <c:dPt>
            <c:idx val="29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81-A2EB-4566-9B46-DAC7DE36ADA2}"/>
              </c:ext>
            </c:extLst>
          </c:dPt>
          <c:dPt>
            <c:idx val="29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83-A2EB-4566-9B46-DAC7DE36ADA2}"/>
              </c:ext>
            </c:extLst>
          </c:dPt>
          <c:dPt>
            <c:idx val="29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85-A2EB-4566-9B46-DAC7DE36ADA2}"/>
              </c:ext>
            </c:extLst>
          </c:dPt>
          <c:dPt>
            <c:idx val="30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87-A2EB-4566-9B46-DAC7DE36ADA2}"/>
              </c:ext>
            </c:extLst>
          </c:dPt>
          <c:dPt>
            <c:idx val="30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89-A2EB-4566-9B46-DAC7DE36ADA2}"/>
              </c:ext>
            </c:extLst>
          </c:dPt>
          <c:dPt>
            <c:idx val="30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8B-A2EB-4566-9B46-DAC7DE36ADA2}"/>
              </c:ext>
            </c:extLst>
          </c:dPt>
          <c:dPt>
            <c:idx val="30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8D-A2EB-4566-9B46-DAC7DE36ADA2}"/>
              </c:ext>
            </c:extLst>
          </c:dPt>
          <c:dPt>
            <c:idx val="30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8F-A2EB-4566-9B46-DAC7DE36ADA2}"/>
              </c:ext>
            </c:extLst>
          </c:dPt>
          <c:dPt>
            <c:idx val="30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91-A2EB-4566-9B46-DAC7DE36ADA2}"/>
              </c:ext>
            </c:extLst>
          </c:dPt>
          <c:dPt>
            <c:idx val="30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93-A2EB-4566-9B46-DAC7DE36ADA2}"/>
              </c:ext>
            </c:extLst>
          </c:dPt>
          <c:dPt>
            <c:idx val="307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95-A2EB-4566-9B46-DAC7DE36ADA2}"/>
              </c:ext>
            </c:extLst>
          </c:dPt>
          <c:dPt>
            <c:idx val="308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97-A2EB-4566-9B46-DAC7DE36ADA2}"/>
              </c:ext>
            </c:extLst>
          </c:dPt>
          <c:dPt>
            <c:idx val="309"/>
            <c:invertIfNegative val="0"/>
            <c:bubble3D val="0"/>
            <c:spPr>
              <a:solidFill>
                <a:srgbClr val="00FF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99-A2EB-4566-9B46-DAC7DE36ADA2}"/>
              </c:ext>
            </c:extLst>
          </c:dPt>
          <c:dPt>
            <c:idx val="31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9B-A2EB-4566-9B46-DAC7DE36ADA2}"/>
              </c:ext>
            </c:extLst>
          </c:dPt>
          <c:dPt>
            <c:idx val="31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9D-A2EB-4566-9B46-DAC7DE36ADA2}"/>
              </c:ext>
            </c:extLst>
          </c:dPt>
          <c:dPt>
            <c:idx val="31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9F-A2EB-4566-9B46-DAC7DE36ADA2}"/>
              </c:ext>
            </c:extLst>
          </c:dPt>
          <c:dPt>
            <c:idx val="31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A1-A2EB-4566-9B46-DAC7DE36ADA2}"/>
              </c:ext>
            </c:extLst>
          </c:dPt>
          <c:dPt>
            <c:idx val="31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A3-A2EB-4566-9B46-DAC7DE36ADA2}"/>
              </c:ext>
            </c:extLst>
          </c:dPt>
          <c:dPt>
            <c:idx val="31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A5-A2EB-4566-9B46-DAC7DE36ADA2}"/>
              </c:ext>
            </c:extLst>
          </c:dPt>
          <c:dPt>
            <c:idx val="31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A7-A2EB-4566-9B46-DAC7DE36ADA2}"/>
              </c:ext>
            </c:extLst>
          </c:dPt>
          <c:dPt>
            <c:idx val="31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A9-A2EB-4566-9B46-DAC7DE36ADA2}"/>
              </c:ext>
            </c:extLst>
          </c:dPt>
          <c:dPt>
            <c:idx val="31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AB-A2EB-4566-9B46-DAC7DE36ADA2}"/>
              </c:ext>
            </c:extLst>
          </c:dPt>
          <c:dPt>
            <c:idx val="31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AD-A2EB-4566-9B46-DAC7DE36ADA2}"/>
              </c:ext>
            </c:extLst>
          </c:dPt>
          <c:dPt>
            <c:idx val="32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AF-A2EB-4566-9B46-DAC7DE36ADA2}"/>
              </c:ext>
            </c:extLst>
          </c:dPt>
          <c:dPt>
            <c:idx val="32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B1-A2EB-4566-9B46-DAC7DE36ADA2}"/>
              </c:ext>
            </c:extLst>
          </c:dPt>
          <c:dPt>
            <c:idx val="32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B3-A2EB-4566-9B46-DAC7DE36ADA2}"/>
              </c:ext>
            </c:extLst>
          </c:dPt>
          <c:dPt>
            <c:idx val="323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B5-A2EB-4566-9B46-DAC7DE36ADA2}"/>
              </c:ext>
            </c:extLst>
          </c:dPt>
          <c:dPt>
            <c:idx val="324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B7-A2EB-4566-9B46-DAC7DE36ADA2}"/>
              </c:ext>
            </c:extLst>
          </c:dPt>
          <c:dPt>
            <c:idx val="325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B9-A2EB-4566-9B46-DAC7DE36ADA2}"/>
              </c:ext>
            </c:extLst>
          </c:dPt>
          <c:dPt>
            <c:idx val="326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BB-A2EB-4566-9B46-DAC7DE36ADA2}"/>
              </c:ext>
            </c:extLst>
          </c:dPt>
          <c:dPt>
            <c:idx val="327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BD-A2EB-4566-9B46-DAC7DE36ADA2}"/>
              </c:ext>
            </c:extLst>
          </c:dPt>
          <c:dPt>
            <c:idx val="328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BF-A2EB-4566-9B46-DAC7DE36ADA2}"/>
              </c:ext>
            </c:extLst>
          </c:dPt>
          <c:dPt>
            <c:idx val="329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C1-A2EB-4566-9B46-DAC7DE36ADA2}"/>
              </c:ext>
            </c:extLst>
          </c:dPt>
          <c:dPt>
            <c:idx val="330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C3-A2EB-4566-9B46-DAC7DE36ADA2}"/>
              </c:ext>
            </c:extLst>
          </c:dPt>
          <c:dPt>
            <c:idx val="331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C5-A2EB-4566-9B46-DAC7DE36ADA2}"/>
              </c:ext>
            </c:extLst>
          </c:dPt>
          <c:dPt>
            <c:idx val="332"/>
            <c:invertIfNegative val="0"/>
            <c:bubble3D val="0"/>
            <c:spPr>
              <a:solidFill>
                <a:srgbClr val="FF0000"/>
              </a:solidFill>
              <a:ln w="25400">
                <a:noFill/>
              </a:ln>
            </c:spPr>
            <c:extLst>
              <c:ext xmlns:c16="http://schemas.microsoft.com/office/drawing/2014/chart" uri="{C3380CC4-5D6E-409C-BE32-E72D297353CC}">
                <c16:uniqueId val="{000007C7-A2EB-4566-9B46-DAC7DE36ADA2}"/>
              </c:ext>
            </c:extLst>
          </c:dPt>
          <c:cat>
            <c:strRef>
              <c:f>'Heat maps3_HID7'!$A$2:$A$334</c:f>
              <c:strCache>
                <c:ptCount val="333"/>
                <c:pt idx="0">
                  <c:v>CDH1</c:v>
                </c:pt>
                <c:pt idx="1">
                  <c:v>CD8A</c:v>
                </c:pt>
                <c:pt idx="2">
                  <c:v>BCAM</c:v>
                </c:pt>
                <c:pt idx="3">
                  <c:v>LAMA5</c:v>
                </c:pt>
                <c:pt idx="4">
                  <c:v>RPSA</c:v>
                </c:pt>
                <c:pt idx="5">
                  <c:v>TNC</c:v>
                </c:pt>
                <c:pt idx="6">
                  <c:v>CLDN4</c:v>
                </c:pt>
                <c:pt idx="7">
                  <c:v>PTPRF</c:v>
                </c:pt>
                <c:pt idx="8">
                  <c:v>THBS1</c:v>
                </c:pt>
                <c:pt idx="9">
                  <c:v>ITGB4</c:v>
                </c:pt>
                <c:pt idx="10">
                  <c:v>CELSR1</c:v>
                </c:pt>
                <c:pt idx="11">
                  <c:v>PTPRU</c:v>
                </c:pt>
                <c:pt idx="12">
                  <c:v>CLSTN1</c:v>
                </c:pt>
                <c:pt idx="13">
                  <c:v>CD151</c:v>
                </c:pt>
                <c:pt idx="14">
                  <c:v>CTNND2</c:v>
                </c:pt>
                <c:pt idx="15">
                  <c:v>CD36</c:v>
                </c:pt>
                <c:pt idx="16">
                  <c:v>LAMB1</c:v>
                </c:pt>
                <c:pt idx="17">
                  <c:v>CTNND1</c:v>
                </c:pt>
                <c:pt idx="18">
                  <c:v>MAEA</c:v>
                </c:pt>
                <c:pt idx="19">
                  <c:v>DDR1</c:v>
                </c:pt>
                <c:pt idx="20">
                  <c:v>CLDN9</c:v>
                </c:pt>
                <c:pt idx="21">
                  <c:v>BYSL</c:v>
                </c:pt>
                <c:pt idx="22">
                  <c:v>ZYX</c:v>
                </c:pt>
                <c:pt idx="23">
                  <c:v>AJUBA</c:v>
                </c:pt>
                <c:pt idx="24">
                  <c:v>LAMB3</c:v>
                </c:pt>
                <c:pt idx="25">
                  <c:v>PKP3</c:v>
                </c:pt>
                <c:pt idx="26">
                  <c:v>CLDN3</c:v>
                </c:pt>
                <c:pt idx="27">
                  <c:v>DSG2</c:v>
                </c:pt>
                <c:pt idx="28">
                  <c:v>JUP</c:v>
                </c:pt>
                <c:pt idx="29">
                  <c:v>EPHA2</c:v>
                </c:pt>
                <c:pt idx="30">
                  <c:v>CLDN1</c:v>
                </c:pt>
                <c:pt idx="31">
                  <c:v>HSPG2</c:v>
                </c:pt>
                <c:pt idx="32">
                  <c:v>CDH24</c:v>
                </c:pt>
                <c:pt idx="33">
                  <c:v>VCAN</c:v>
                </c:pt>
                <c:pt idx="34">
                  <c:v>PTPRK</c:v>
                </c:pt>
                <c:pt idx="35">
                  <c:v>PKP2</c:v>
                </c:pt>
                <c:pt idx="36">
                  <c:v>ITGB5</c:v>
                </c:pt>
                <c:pt idx="37">
                  <c:v>LRFN4</c:v>
                </c:pt>
                <c:pt idx="38">
                  <c:v>CLDN7</c:v>
                </c:pt>
                <c:pt idx="39">
                  <c:v>BAIAP2</c:v>
                </c:pt>
                <c:pt idx="40">
                  <c:v>DSC2</c:v>
                </c:pt>
                <c:pt idx="41">
                  <c:v>ITGB1BP1</c:v>
                </c:pt>
                <c:pt idx="42">
                  <c:v>CELSR3</c:v>
                </c:pt>
                <c:pt idx="43">
                  <c:v>SDC1</c:v>
                </c:pt>
                <c:pt idx="44">
                  <c:v>CTNNB1</c:v>
                </c:pt>
                <c:pt idx="45">
                  <c:v>LAMB2</c:v>
                </c:pt>
                <c:pt idx="46">
                  <c:v>CYTH1</c:v>
                </c:pt>
                <c:pt idx="47">
                  <c:v>EPHB6</c:v>
                </c:pt>
                <c:pt idx="48">
                  <c:v>FLRT3</c:v>
                </c:pt>
                <c:pt idx="49">
                  <c:v>IGSF5</c:v>
                </c:pt>
                <c:pt idx="50">
                  <c:v>THBS3</c:v>
                </c:pt>
                <c:pt idx="51">
                  <c:v>ROBO3</c:v>
                </c:pt>
                <c:pt idx="52">
                  <c:v>PCDHGC3</c:v>
                </c:pt>
                <c:pt idx="53">
                  <c:v>EPHA1</c:v>
                </c:pt>
                <c:pt idx="54">
                  <c:v>BAIAP3</c:v>
                </c:pt>
                <c:pt idx="55">
                  <c:v>CADM1</c:v>
                </c:pt>
                <c:pt idx="56">
                  <c:v>NOTCH1</c:v>
                </c:pt>
                <c:pt idx="57">
                  <c:v>DLG5</c:v>
                </c:pt>
                <c:pt idx="58">
                  <c:v>L1CAM</c:v>
                </c:pt>
                <c:pt idx="59">
                  <c:v>ITGA2B</c:v>
                </c:pt>
                <c:pt idx="60">
                  <c:v>CNTNAP1</c:v>
                </c:pt>
                <c:pt idx="61">
                  <c:v>PVR</c:v>
                </c:pt>
                <c:pt idx="62">
                  <c:v>BAIAP2L1</c:v>
                </c:pt>
                <c:pt idx="63">
                  <c:v>EPHB4</c:v>
                </c:pt>
                <c:pt idx="64">
                  <c:v>CDH13</c:v>
                </c:pt>
                <c:pt idx="65">
                  <c:v>PTPRJ</c:v>
                </c:pt>
                <c:pt idx="66">
                  <c:v>ITGA7</c:v>
                </c:pt>
                <c:pt idx="67">
                  <c:v>EFNB1</c:v>
                </c:pt>
                <c:pt idx="68">
                  <c:v>ANTXR1</c:v>
                </c:pt>
                <c:pt idx="69">
                  <c:v>PCDHA11</c:v>
                </c:pt>
                <c:pt idx="70">
                  <c:v>ITGB2</c:v>
                </c:pt>
                <c:pt idx="71">
                  <c:v>PCDHGA10</c:v>
                </c:pt>
                <c:pt idx="72">
                  <c:v>GAS6</c:v>
                </c:pt>
                <c:pt idx="73">
                  <c:v>MDGA1</c:v>
                </c:pt>
                <c:pt idx="74">
                  <c:v>EPHB2</c:v>
                </c:pt>
                <c:pt idx="75">
                  <c:v>SSPN</c:v>
                </c:pt>
                <c:pt idx="76">
                  <c:v>PKP1</c:v>
                </c:pt>
                <c:pt idx="77">
                  <c:v>EFNA5</c:v>
                </c:pt>
                <c:pt idx="78">
                  <c:v>PCDHB14</c:v>
                </c:pt>
                <c:pt idx="79">
                  <c:v>ITGAE</c:v>
                </c:pt>
                <c:pt idx="80">
                  <c:v>NRP1</c:v>
                </c:pt>
                <c:pt idx="81">
                  <c:v>IL1RAP</c:v>
                </c:pt>
                <c:pt idx="82">
                  <c:v>CYTH3</c:v>
                </c:pt>
                <c:pt idx="83">
                  <c:v>ITGB8</c:v>
                </c:pt>
                <c:pt idx="84">
                  <c:v>PTPRM</c:v>
                </c:pt>
                <c:pt idx="85">
                  <c:v>ROBO1</c:v>
                </c:pt>
                <c:pt idx="86">
                  <c:v>PEAK1</c:v>
                </c:pt>
                <c:pt idx="87">
                  <c:v>SDK1</c:v>
                </c:pt>
                <c:pt idx="88">
                  <c:v>PCDHB11</c:v>
                </c:pt>
                <c:pt idx="89">
                  <c:v>CDON</c:v>
                </c:pt>
                <c:pt idx="90">
                  <c:v>BOC</c:v>
                </c:pt>
                <c:pt idx="91">
                  <c:v>PCDH17</c:v>
                </c:pt>
                <c:pt idx="92">
                  <c:v>ITGA10</c:v>
                </c:pt>
                <c:pt idx="93">
                  <c:v>MDGA2</c:v>
                </c:pt>
                <c:pt idx="94">
                  <c:v>PCDHB10</c:v>
                </c:pt>
                <c:pt idx="95">
                  <c:v>PCDHA1</c:v>
                </c:pt>
                <c:pt idx="96">
                  <c:v>SEMA3G</c:v>
                </c:pt>
                <c:pt idx="97">
                  <c:v>LAMA4</c:v>
                </c:pt>
                <c:pt idx="98">
                  <c:v>ICAM1</c:v>
                </c:pt>
                <c:pt idx="99">
                  <c:v>PCDHA3</c:v>
                </c:pt>
                <c:pt idx="100">
                  <c:v>PODXL2</c:v>
                </c:pt>
                <c:pt idx="101">
                  <c:v>ICAM3</c:v>
                </c:pt>
                <c:pt idx="102">
                  <c:v>CLDN15</c:v>
                </c:pt>
                <c:pt idx="103">
                  <c:v>NINJ1</c:v>
                </c:pt>
                <c:pt idx="104">
                  <c:v>PCDH20</c:v>
                </c:pt>
                <c:pt idx="105">
                  <c:v>PCDHB2</c:v>
                </c:pt>
                <c:pt idx="106">
                  <c:v>PCDHB8</c:v>
                </c:pt>
                <c:pt idx="107">
                  <c:v>PCDHA12</c:v>
                </c:pt>
                <c:pt idx="108">
                  <c:v>LRFN3</c:v>
                </c:pt>
                <c:pt idx="109">
                  <c:v>LRFN1</c:v>
                </c:pt>
                <c:pt idx="110">
                  <c:v>SGCE</c:v>
                </c:pt>
                <c:pt idx="111">
                  <c:v>EPHA4</c:v>
                </c:pt>
                <c:pt idx="112">
                  <c:v>ITGB7</c:v>
                </c:pt>
                <c:pt idx="113">
                  <c:v>SEMA4D</c:v>
                </c:pt>
                <c:pt idx="114">
                  <c:v>PCDHA4</c:v>
                </c:pt>
                <c:pt idx="115">
                  <c:v>CADM2</c:v>
                </c:pt>
                <c:pt idx="116">
                  <c:v>SDC3</c:v>
                </c:pt>
                <c:pt idx="117">
                  <c:v>CNTN1</c:v>
                </c:pt>
                <c:pt idx="118">
                  <c:v>CLDN12</c:v>
                </c:pt>
                <c:pt idx="119">
                  <c:v>PTPRH</c:v>
                </c:pt>
                <c:pt idx="120">
                  <c:v>PCDH12</c:v>
                </c:pt>
                <c:pt idx="121">
                  <c:v>CDH18</c:v>
                </c:pt>
                <c:pt idx="122">
                  <c:v>LPXN</c:v>
                </c:pt>
                <c:pt idx="123">
                  <c:v>CLDN8</c:v>
                </c:pt>
                <c:pt idx="124">
                  <c:v>AGER</c:v>
                </c:pt>
                <c:pt idx="125">
                  <c:v>RGMB</c:v>
                </c:pt>
                <c:pt idx="126">
                  <c:v>ITGB3BP</c:v>
                </c:pt>
                <c:pt idx="127">
                  <c:v>TNXB</c:v>
                </c:pt>
                <c:pt idx="128">
                  <c:v>EPHA3</c:v>
                </c:pt>
                <c:pt idx="129">
                  <c:v>CDHR3</c:v>
                </c:pt>
                <c:pt idx="130">
                  <c:v>CLDN23</c:v>
                </c:pt>
                <c:pt idx="131">
                  <c:v>PCDHAC2</c:v>
                </c:pt>
                <c:pt idx="132">
                  <c:v>PLXNC1</c:v>
                </c:pt>
                <c:pt idx="133">
                  <c:v>SELL</c:v>
                </c:pt>
                <c:pt idx="134">
                  <c:v>CDH2</c:v>
                </c:pt>
                <c:pt idx="135">
                  <c:v>PCDHGB1</c:v>
                </c:pt>
                <c:pt idx="136">
                  <c:v>PCDHGB4</c:v>
                </c:pt>
                <c:pt idx="137">
                  <c:v>ROBO2</c:v>
                </c:pt>
                <c:pt idx="138">
                  <c:v>IGSF11</c:v>
                </c:pt>
                <c:pt idx="139">
                  <c:v>NID2</c:v>
                </c:pt>
                <c:pt idx="140">
                  <c:v>CD58</c:v>
                </c:pt>
                <c:pt idx="141">
                  <c:v>PCDHB7</c:v>
                </c:pt>
                <c:pt idx="142">
                  <c:v>UMODL1</c:v>
                </c:pt>
                <c:pt idx="143">
                  <c:v>PCDHB9</c:v>
                </c:pt>
                <c:pt idx="144">
                  <c:v>BAIAP2L2</c:v>
                </c:pt>
                <c:pt idx="145">
                  <c:v>PCDHB12</c:v>
                </c:pt>
                <c:pt idx="146">
                  <c:v>PCDHA5</c:v>
                </c:pt>
                <c:pt idx="147">
                  <c:v>PRTG</c:v>
                </c:pt>
                <c:pt idx="148">
                  <c:v>PCDHB13</c:v>
                </c:pt>
                <c:pt idx="149">
                  <c:v>PCDHA2</c:v>
                </c:pt>
                <c:pt idx="150">
                  <c:v>PCDHGB2</c:v>
                </c:pt>
                <c:pt idx="151">
                  <c:v>LAMC3</c:v>
                </c:pt>
                <c:pt idx="152">
                  <c:v>AMIGO3</c:v>
                </c:pt>
                <c:pt idx="153">
                  <c:v>PCDHGA4</c:v>
                </c:pt>
                <c:pt idx="154">
                  <c:v>PCDH7</c:v>
                </c:pt>
                <c:pt idx="155">
                  <c:v>ITGAL</c:v>
                </c:pt>
                <c:pt idx="156">
                  <c:v>NLGN3</c:v>
                </c:pt>
                <c:pt idx="157">
                  <c:v>EPHA7</c:v>
                </c:pt>
                <c:pt idx="158">
                  <c:v>LRRN3</c:v>
                </c:pt>
                <c:pt idx="159">
                  <c:v>ICAM2</c:v>
                </c:pt>
                <c:pt idx="160">
                  <c:v>EDIL3</c:v>
                </c:pt>
                <c:pt idx="161">
                  <c:v>CDH5</c:v>
                </c:pt>
                <c:pt idx="162">
                  <c:v>CLDN19</c:v>
                </c:pt>
                <c:pt idx="163">
                  <c:v>CDHR5</c:v>
                </c:pt>
                <c:pt idx="164">
                  <c:v>SELPLG</c:v>
                </c:pt>
                <c:pt idx="165">
                  <c:v>DCHS1</c:v>
                </c:pt>
                <c:pt idx="166">
                  <c:v>DSC3</c:v>
                </c:pt>
                <c:pt idx="167">
                  <c:v>PCDHGA3</c:v>
                </c:pt>
                <c:pt idx="168">
                  <c:v>CD24P2</c:v>
                </c:pt>
                <c:pt idx="169">
                  <c:v>PCDHGC5</c:v>
                </c:pt>
                <c:pt idx="170">
                  <c:v>PCDHGA11</c:v>
                </c:pt>
                <c:pt idx="171">
                  <c:v>CLDN2</c:v>
                </c:pt>
                <c:pt idx="172">
                  <c:v>EPHA8</c:v>
                </c:pt>
                <c:pt idx="173">
                  <c:v>PCDHA10</c:v>
                </c:pt>
                <c:pt idx="174">
                  <c:v>PCDHGA7</c:v>
                </c:pt>
                <c:pt idx="175">
                  <c:v>ABI3BP</c:v>
                </c:pt>
                <c:pt idx="176">
                  <c:v>PCDHA6</c:v>
                </c:pt>
                <c:pt idx="177">
                  <c:v>PCDHB6</c:v>
                </c:pt>
                <c:pt idx="178">
                  <c:v>PCDHB5</c:v>
                </c:pt>
                <c:pt idx="179">
                  <c:v>PCDHGB7</c:v>
                </c:pt>
                <c:pt idx="180">
                  <c:v>CLDN6</c:v>
                </c:pt>
                <c:pt idx="181">
                  <c:v>NRXN3</c:v>
                </c:pt>
                <c:pt idx="182">
                  <c:v>PCDHGA12</c:v>
                </c:pt>
                <c:pt idx="183">
                  <c:v>CLDN5</c:v>
                </c:pt>
                <c:pt idx="184">
                  <c:v>PCDHB4</c:v>
                </c:pt>
                <c:pt idx="185">
                  <c:v>CD48</c:v>
                </c:pt>
                <c:pt idx="186">
                  <c:v>PCDHGC4</c:v>
                </c:pt>
                <c:pt idx="187">
                  <c:v>CYTIP</c:v>
                </c:pt>
                <c:pt idx="188">
                  <c:v>CDH10</c:v>
                </c:pt>
                <c:pt idx="189">
                  <c:v>ITGB3</c:v>
                </c:pt>
                <c:pt idx="190">
                  <c:v>CDH20</c:v>
                </c:pt>
                <c:pt idx="191">
                  <c:v>PCDHGA6</c:v>
                </c:pt>
                <c:pt idx="192">
                  <c:v>NINJ2</c:v>
                </c:pt>
                <c:pt idx="193">
                  <c:v>CDHR4</c:v>
                </c:pt>
                <c:pt idx="194">
                  <c:v>LRRN4</c:v>
                </c:pt>
                <c:pt idx="195">
                  <c:v>ICAM4</c:v>
                </c:pt>
                <c:pt idx="196">
                  <c:v>ITGA11</c:v>
                </c:pt>
                <c:pt idx="197">
                  <c:v>KIRREL2</c:v>
                </c:pt>
                <c:pt idx="198">
                  <c:v>THY1</c:v>
                </c:pt>
                <c:pt idx="199">
                  <c:v>PRPH2</c:v>
                </c:pt>
                <c:pt idx="200">
                  <c:v>FAT2</c:v>
                </c:pt>
                <c:pt idx="201">
                  <c:v>CD84</c:v>
                </c:pt>
                <c:pt idx="202">
                  <c:v>MPL</c:v>
                </c:pt>
                <c:pt idx="203">
                  <c:v>IL1RAPL1</c:v>
                </c:pt>
                <c:pt idx="204">
                  <c:v>NLGN1</c:v>
                </c:pt>
                <c:pt idx="205">
                  <c:v>OMG</c:v>
                </c:pt>
                <c:pt idx="206">
                  <c:v>DSC1</c:v>
                </c:pt>
                <c:pt idx="207">
                  <c:v>LIMS2</c:v>
                </c:pt>
                <c:pt idx="208">
                  <c:v>CD6</c:v>
                </c:pt>
                <c:pt idx="209">
                  <c:v>PCDHGA2</c:v>
                </c:pt>
                <c:pt idx="210">
                  <c:v>PCDH19</c:v>
                </c:pt>
                <c:pt idx="211">
                  <c:v>MADCAM1</c:v>
                </c:pt>
                <c:pt idx="212">
                  <c:v>PCDHGA5</c:v>
                </c:pt>
                <c:pt idx="213">
                  <c:v>MAG</c:v>
                </c:pt>
                <c:pt idx="214">
                  <c:v>MFAP4</c:v>
                </c:pt>
                <c:pt idx="215">
                  <c:v>PCDHB3</c:v>
                </c:pt>
                <c:pt idx="216">
                  <c:v>AXL</c:v>
                </c:pt>
                <c:pt idx="217">
                  <c:v>PCDHA8</c:v>
                </c:pt>
                <c:pt idx="218">
                  <c:v>JAM2</c:v>
                </c:pt>
                <c:pt idx="219">
                  <c:v>AMIGO1</c:v>
                </c:pt>
                <c:pt idx="220">
                  <c:v>PCDHGA1</c:v>
                </c:pt>
                <c:pt idx="221">
                  <c:v>THBS2</c:v>
                </c:pt>
                <c:pt idx="222">
                  <c:v>PTPRO</c:v>
                </c:pt>
                <c:pt idx="223">
                  <c:v>FBLN5</c:v>
                </c:pt>
                <c:pt idx="224">
                  <c:v>ELFN1</c:v>
                </c:pt>
                <c:pt idx="225">
                  <c:v>PCDHGA9</c:v>
                </c:pt>
                <c:pt idx="226">
                  <c:v>ITGAD</c:v>
                </c:pt>
                <c:pt idx="227">
                  <c:v>PCDHGA8</c:v>
                </c:pt>
                <c:pt idx="228">
                  <c:v>TRO</c:v>
                </c:pt>
                <c:pt idx="229">
                  <c:v>NCAM1</c:v>
                </c:pt>
                <c:pt idx="230">
                  <c:v>CDH26</c:v>
                </c:pt>
                <c:pt idx="231">
                  <c:v>LRRN2</c:v>
                </c:pt>
                <c:pt idx="232">
                  <c:v>CDH17</c:v>
                </c:pt>
                <c:pt idx="233">
                  <c:v>PCDHGB6</c:v>
                </c:pt>
                <c:pt idx="234">
                  <c:v>PTPRB</c:v>
                </c:pt>
                <c:pt idx="235">
                  <c:v>ITGA9</c:v>
                </c:pt>
                <c:pt idx="236">
                  <c:v>PCDHB15</c:v>
                </c:pt>
                <c:pt idx="237">
                  <c:v>CDHR2</c:v>
                </c:pt>
                <c:pt idx="238">
                  <c:v>MCAM</c:v>
                </c:pt>
                <c:pt idx="239">
                  <c:v>PTPRC</c:v>
                </c:pt>
                <c:pt idx="240">
                  <c:v>FBLN7</c:v>
                </c:pt>
                <c:pt idx="241">
                  <c:v>PCDHAC1</c:v>
                </c:pt>
                <c:pt idx="242">
                  <c:v>LRRN4CL</c:v>
                </c:pt>
                <c:pt idx="243">
                  <c:v>EPHA6</c:v>
                </c:pt>
                <c:pt idx="244">
                  <c:v>THBS4</c:v>
                </c:pt>
                <c:pt idx="245">
                  <c:v>NRP2</c:v>
                </c:pt>
                <c:pt idx="246">
                  <c:v>ITGAM</c:v>
                </c:pt>
                <c:pt idx="247">
                  <c:v>MEGF11</c:v>
                </c:pt>
                <c:pt idx="248">
                  <c:v>ITGA1</c:v>
                </c:pt>
                <c:pt idx="249">
                  <c:v>CLDN11</c:v>
                </c:pt>
                <c:pt idx="250">
                  <c:v>FREM1</c:v>
                </c:pt>
                <c:pt idx="251">
                  <c:v>LSAMP</c:v>
                </c:pt>
                <c:pt idx="252">
                  <c:v>CTNNA3</c:v>
                </c:pt>
                <c:pt idx="253">
                  <c:v>PCDHA7</c:v>
                </c:pt>
                <c:pt idx="254">
                  <c:v>PCDHA13</c:v>
                </c:pt>
                <c:pt idx="255">
                  <c:v>ICAM5</c:v>
                </c:pt>
                <c:pt idx="256">
                  <c:v>SLIT2</c:v>
                </c:pt>
                <c:pt idx="257">
                  <c:v>JAM3</c:v>
                </c:pt>
                <c:pt idx="258">
                  <c:v>CD72</c:v>
                </c:pt>
                <c:pt idx="259">
                  <c:v>PCDHGB3</c:v>
                </c:pt>
                <c:pt idx="260">
                  <c:v>CLDN20</c:v>
                </c:pt>
                <c:pt idx="261">
                  <c:v>CDH4</c:v>
                </c:pt>
                <c:pt idx="262">
                  <c:v>CNTNAP3</c:v>
                </c:pt>
                <c:pt idx="263">
                  <c:v>CDH15</c:v>
                </c:pt>
                <c:pt idx="264">
                  <c:v>FLRT1</c:v>
                </c:pt>
                <c:pt idx="265">
                  <c:v>CD47</c:v>
                </c:pt>
                <c:pt idx="266">
                  <c:v>ITGA5</c:v>
                </c:pt>
                <c:pt idx="267">
                  <c:v>SDC2</c:v>
                </c:pt>
                <c:pt idx="268">
                  <c:v>ESAM</c:v>
                </c:pt>
                <c:pt idx="269">
                  <c:v>EFNA1</c:v>
                </c:pt>
                <c:pt idx="270">
                  <c:v>PTPRS</c:v>
                </c:pt>
                <c:pt idx="271">
                  <c:v>CDH23</c:v>
                </c:pt>
                <c:pt idx="272">
                  <c:v>LAMC1</c:v>
                </c:pt>
                <c:pt idx="273">
                  <c:v>LAMC2</c:v>
                </c:pt>
                <c:pt idx="274">
                  <c:v>CTNNA1</c:v>
                </c:pt>
                <c:pt idx="275">
                  <c:v>TGFBI</c:v>
                </c:pt>
                <c:pt idx="276">
                  <c:v>F11R</c:v>
                </c:pt>
                <c:pt idx="277">
                  <c:v>CERCAM</c:v>
                </c:pt>
                <c:pt idx="278">
                  <c:v>SEMA3E</c:v>
                </c:pt>
                <c:pt idx="279">
                  <c:v>IGSF9</c:v>
                </c:pt>
                <c:pt idx="280">
                  <c:v>NEDD9</c:v>
                </c:pt>
                <c:pt idx="281">
                  <c:v>TMEM8B</c:v>
                </c:pt>
                <c:pt idx="282">
                  <c:v>AMIGO2</c:v>
                </c:pt>
                <c:pt idx="283">
                  <c:v>CYTH2</c:v>
                </c:pt>
                <c:pt idx="284">
                  <c:v>SDC4</c:v>
                </c:pt>
                <c:pt idx="285">
                  <c:v>PCDH10</c:v>
                </c:pt>
                <c:pt idx="286">
                  <c:v>TSC1</c:v>
                </c:pt>
                <c:pt idx="287">
                  <c:v>CLSTN3</c:v>
                </c:pt>
                <c:pt idx="288">
                  <c:v>ITGB1</c:v>
                </c:pt>
                <c:pt idx="289">
                  <c:v>EPCAM</c:v>
                </c:pt>
                <c:pt idx="290">
                  <c:v>ITGA6</c:v>
                </c:pt>
                <c:pt idx="291">
                  <c:v>DSP</c:v>
                </c:pt>
                <c:pt idx="292">
                  <c:v>CD9</c:v>
                </c:pt>
                <c:pt idx="293">
                  <c:v>CELSR2</c:v>
                </c:pt>
                <c:pt idx="294">
                  <c:v>NEO1</c:v>
                </c:pt>
                <c:pt idx="295">
                  <c:v>NPTN</c:v>
                </c:pt>
                <c:pt idx="296">
                  <c:v>ITGA2</c:v>
                </c:pt>
                <c:pt idx="297">
                  <c:v>DLG1</c:v>
                </c:pt>
                <c:pt idx="298">
                  <c:v>CD24P4</c:v>
                </c:pt>
                <c:pt idx="299">
                  <c:v>VEZT</c:v>
                </c:pt>
                <c:pt idx="300">
                  <c:v>CDH3</c:v>
                </c:pt>
                <c:pt idx="301">
                  <c:v>FAT1</c:v>
                </c:pt>
                <c:pt idx="302">
                  <c:v>ITGB6</c:v>
                </c:pt>
                <c:pt idx="303">
                  <c:v>FREM2</c:v>
                </c:pt>
                <c:pt idx="304">
                  <c:v>NRCAM</c:v>
                </c:pt>
                <c:pt idx="305">
                  <c:v>ASTN2</c:v>
                </c:pt>
                <c:pt idx="306">
                  <c:v>ITGAV</c:v>
                </c:pt>
                <c:pt idx="307">
                  <c:v>CD44</c:v>
                </c:pt>
                <c:pt idx="308">
                  <c:v>ITGA3</c:v>
                </c:pt>
                <c:pt idx="309">
                  <c:v>ALCAM</c:v>
                </c:pt>
                <c:pt idx="310">
                  <c:v>CTNNAL1</c:v>
                </c:pt>
                <c:pt idx="311">
                  <c:v>FN1</c:v>
                </c:pt>
                <c:pt idx="312">
                  <c:v>SDK2</c:v>
                </c:pt>
                <c:pt idx="313">
                  <c:v>PCDH1</c:v>
                </c:pt>
                <c:pt idx="314">
                  <c:v>LAMA3</c:v>
                </c:pt>
                <c:pt idx="315">
                  <c:v>CADM4</c:v>
                </c:pt>
                <c:pt idx="316">
                  <c:v>PCDH9</c:v>
                </c:pt>
                <c:pt idx="317">
                  <c:v>DST</c:v>
                </c:pt>
                <c:pt idx="318">
                  <c:v>EFNB2</c:v>
                </c:pt>
                <c:pt idx="319">
                  <c:v>PLXNB1</c:v>
                </c:pt>
                <c:pt idx="320">
                  <c:v>EPHB3</c:v>
                </c:pt>
                <c:pt idx="321">
                  <c:v>LRRN1</c:v>
                </c:pt>
                <c:pt idx="322">
                  <c:v>NCAM2</c:v>
                </c:pt>
                <c:pt idx="323">
                  <c:v>PCDH11X</c:v>
                </c:pt>
                <c:pt idx="324">
                  <c:v>PLXNB3</c:v>
                </c:pt>
                <c:pt idx="325">
                  <c:v>LPP</c:v>
                </c:pt>
                <c:pt idx="326">
                  <c:v>PTPRG</c:v>
                </c:pt>
                <c:pt idx="327">
                  <c:v>FERMT2</c:v>
                </c:pt>
                <c:pt idx="328">
                  <c:v>PKP4</c:v>
                </c:pt>
                <c:pt idx="329">
                  <c:v>CEACAM1</c:v>
                </c:pt>
                <c:pt idx="330">
                  <c:v>NTN1</c:v>
                </c:pt>
                <c:pt idx="331">
                  <c:v>NLGN2</c:v>
                </c:pt>
                <c:pt idx="332">
                  <c:v>MIA3</c:v>
                </c:pt>
              </c:strCache>
            </c:strRef>
          </c:cat>
          <c:val>
            <c:numRef>
              <c:f>'Heat maps3_HID7'!$D$2:$D$334</c:f>
              <c:numCache>
                <c:formatCode>General</c:formatCode>
                <c:ptCount val="333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  <c:pt idx="28">
                  <c:v>1</c:v>
                </c:pt>
                <c:pt idx="29">
                  <c:v>1</c:v>
                </c:pt>
                <c:pt idx="30">
                  <c:v>1</c:v>
                </c:pt>
                <c:pt idx="31">
                  <c:v>1</c:v>
                </c:pt>
                <c:pt idx="32">
                  <c:v>1</c:v>
                </c:pt>
                <c:pt idx="33">
                  <c:v>1</c:v>
                </c:pt>
                <c:pt idx="34">
                  <c:v>1</c:v>
                </c:pt>
                <c:pt idx="35">
                  <c:v>1</c:v>
                </c:pt>
                <c:pt idx="36">
                  <c:v>1</c:v>
                </c:pt>
                <c:pt idx="37">
                  <c:v>1</c:v>
                </c:pt>
                <c:pt idx="38">
                  <c:v>1</c:v>
                </c:pt>
                <c:pt idx="39">
                  <c:v>1</c:v>
                </c:pt>
                <c:pt idx="40">
                  <c:v>1</c:v>
                </c:pt>
                <c:pt idx="41">
                  <c:v>1</c:v>
                </c:pt>
                <c:pt idx="42">
                  <c:v>1</c:v>
                </c:pt>
                <c:pt idx="43">
                  <c:v>1</c:v>
                </c:pt>
                <c:pt idx="44">
                  <c:v>1</c:v>
                </c:pt>
                <c:pt idx="45">
                  <c:v>1</c:v>
                </c:pt>
                <c:pt idx="46">
                  <c:v>1</c:v>
                </c:pt>
                <c:pt idx="47">
                  <c:v>1</c:v>
                </c:pt>
                <c:pt idx="48">
                  <c:v>1</c:v>
                </c:pt>
                <c:pt idx="49">
                  <c:v>1</c:v>
                </c:pt>
                <c:pt idx="50">
                  <c:v>1</c:v>
                </c:pt>
                <c:pt idx="51">
                  <c:v>1</c:v>
                </c:pt>
                <c:pt idx="52">
                  <c:v>1</c:v>
                </c:pt>
                <c:pt idx="53">
                  <c:v>1</c:v>
                </c:pt>
                <c:pt idx="54">
                  <c:v>1</c:v>
                </c:pt>
                <c:pt idx="55">
                  <c:v>1</c:v>
                </c:pt>
                <c:pt idx="56">
                  <c:v>1</c:v>
                </c:pt>
                <c:pt idx="57">
                  <c:v>1</c:v>
                </c:pt>
                <c:pt idx="58">
                  <c:v>1</c:v>
                </c:pt>
                <c:pt idx="59">
                  <c:v>1</c:v>
                </c:pt>
                <c:pt idx="60">
                  <c:v>1</c:v>
                </c:pt>
                <c:pt idx="61">
                  <c:v>1</c:v>
                </c:pt>
                <c:pt idx="62">
                  <c:v>1</c:v>
                </c:pt>
                <c:pt idx="63">
                  <c:v>1</c:v>
                </c:pt>
                <c:pt idx="64">
                  <c:v>1</c:v>
                </c:pt>
                <c:pt idx="65">
                  <c:v>1</c:v>
                </c:pt>
                <c:pt idx="66">
                  <c:v>1</c:v>
                </c:pt>
                <c:pt idx="67">
                  <c:v>1</c:v>
                </c:pt>
                <c:pt idx="68">
                  <c:v>1</c:v>
                </c:pt>
                <c:pt idx="69">
                  <c:v>1</c:v>
                </c:pt>
                <c:pt idx="70">
                  <c:v>1</c:v>
                </c:pt>
                <c:pt idx="71">
                  <c:v>1</c:v>
                </c:pt>
                <c:pt idx="72">
                  <c:v>1</c:v>
                </c:pt>
                <c:pt idx="73">
                  <c:v>1</c:v>
                </c:pt>
                <c:pt idx="74">
                  <c:v>1</c:v>
                </c:pt>
                <c:pt idx="75">
                  <c:v>1</c:v>
                </c:pt>
                <c:pt idx="76">
                  <c:v>1</c:v>
                </c:pt>
                <c:pt idx="77">
                  <c:v>1</c:v>
                </c:pt>
                <c:pt idx="78">
                  <c:v>1</c:v>
                </c:pt>
                <c:pt idx="79">
                  <c:v>1</c:v>
                </c:pt>
                <c:pt idx="80">
                  <c:v>1</c:v>
                </c:pt>
                <c:pt idx="81">
                  <c:v>1</c:v>
                </c:pt>
                <c:pt idx="82">
                  <c:v>1</c:v>
                </c:pt>
                <c:pt idx="83">
                  <c:v>1</c:v>
                </c:pt>
                <c:pt idx="84">
                  <c:v>1</c:v>
                </c:pt>
                <c:pt idx="85">
                  <c:v>1</c:v>
                </c:pt>
                <c:pt idx="86">
                  <c:v>1</c:v>
                </c:pt>
                <c:pt idx="87">
                  <c:v>1</c:v>
                </c:pt>
                <c:pt idx="88">
                  <c:v>1</c:v>
                </c:pt>
                <c:pt idx="89">
                  <c:v>1</c:v>
                </c:pt>
                <c:pt idx="90">
                  <c:v>1</c:v>
                </c:pt>
                <c:pt idx="91">
                  <c:v>1</c:v>
                </c:pt>
                <c:pt idx="92">
                  <c:v>1</c:v>
                </c:pt>
                <c:pt idx="93">
                  <c:v>1</c:v>
                </c:pt>
                <c:pt idx="94">
                  <c:v>1</c:v>
                </c:pt>
                <c:pt idx="95">
                  <c:v>1</c:v>
                </c:pt>
                <c:pt idx="96">
                  <c:v>1</c:v>
                </c:pt>
                <c:pt idx="97">
                  <c:v>1</c:v>
                </c:pt>
                <c:pt idx="98">
                  <c:v>1</c:v>
                </c:pt>
                <c:pt idx="99">
                  <c:v>1</c:v>
                </c:pt>
                <c:pt idx="100">
                  <c:v>1</c:v>
                </c:pt>
                <c:pt idx="101">
                  <c:v>1</c:v>
                </c:pt>
                <c:pt idx="102">
                  <c:v>1</c:v>
                </c:pt>
                <c:pt idx="103">
                  <c:v>1</c:v>
                </c:pt>
                <c:pt idx="104">
                  <c:v>1</c:v>
                </c:pt>
                <c:pt idx="105">
                  <c:v>1</c:v>
                </c:pt>
                <c:pt idx="106">
                  <c:v>1</c:v>
                </c:pt>
                <c:pt idx="107">
                  <c:v>1</c:v>
                </c:pt>
                <c:pt idx="108">
                  <c:v>1</c:v>
                </c:pt>
                <c:pt idx="109">
                  <c:v>1</c:v>
                </c:pt>
                <c:pt idx="110">
                  <c:v>1</c:v>
                </c:pt>
                <c:pt idx="111">
                  <c:v>1</c:v>
                </c:pt>
                <c:pt idx="112">
                  <c:v>1</c:v>
                </c:pt>
                <c:pt idx="113">
                  <c:v>1</c:v>
                </c:pt>
                <c:pt idx="114">
                  <c:v>1</c:v>
                </c:pt>
                <c:pt idx="115">
                  <c:v>1</c:v>
                </c:pt>
                <c:pt idx="116">
                  <c:v>1</c:v>
                </c:pt>
                <c:pt idx="117">
                  <c:v>1</c:v>
                </c:pt>
                <c:pt idx="118">
                  <c:v>1</c:v>
                </c:pt>
                <c:pt idx="119">
                  <c:v>1</c:v>
                </c:pt>
                <c:pt idx="120">
                  <c:v>1</c:v>
                </c:pt>
                <c:pt idx="121">
                  <c:v>1</c:v>
                </c:pt>
                <c:pt idx="122">
                  <c:v>1</c:v>
                </c:pt>
                <c:pt idx="123">
                  <c:v>1</c:v>
                </c:pt>
                <c:pt idx="124">
                  <c:v>1</c:v>
                </c:pt>
                <c:pt idx="125">
                  <c:v>1</c:v>
                </c:pt>
                <c:pt idx="126">
                  <c:v>1</c:v>
                </c:pt>
                <c:pt idx="127">
                  <c:v>1</c:v>
                </c:pt>
                <c:pt idx="128">
                  <c:v>1</c:v>
                </c:pt>
                <c:pt idx="129">
                  <c:v>1</c:v>
                </c:pt>
                <c:pt idx="130">
                  <c:v>1</c:v>
                </c:pt>
                <c:pt idx="131">
                  <c:v>1</c:v>
                </c:pt>
                <c:pt idx="132">
                  <c:v>1</c:v>
                </c:pt>
                <c:pt idx="133">
                  <c:v>1</c:v>
                </c:pt>
                <c:pt idx="134">
                  <c:v>1</c:v>
                </c:pt>
                <c:pt idx="135">
                  <c:v>1</c:v>
                </c:pt>
                <c:pt idx="136">
                  <c:v>1</c:v>
                </c:pt>
                <c:pt idx="137">
                  <c:v>1</c:v>
                </c:pt>
                <c:pt idx="138">
                  <c:v>1</c:v>
                </c:pt>
                <c:pt idx="139">
                  <c:v>1</c:v>
                </c:pt>
                <c:pt idx="140">
                  <c:v>1</c:v>
                </c:pt>
                <c:pt idx="141">
                  <c:v>1</c:v>
                </c:pt>
                <c:pt idx="142">
                  <c:v>1</c:v>
                </c:pt>
                <c:pt idx="143">
                  <c:v>1</c:v>
                </c:pt>
                <c:pt idx="144">
                  <c:v>1</c:v>
                </c:pt>
                <c:pt idx="145">
                  <c:v>1</c:v>
                </c:pt>
                <c:pt idx="146">
                  <c:v>1</c:v>
                </c:pt>
                <c:pt idx="147">
                  <c:v>1</c:v>
                </c:pt>
                <c:pt idx="148">
                  <c:v>1</c:v>
                </c:pt>
                <c:pt idx="149">
                  <c:v>1</c:v>
                </c:pt>
                <c:pt idx="150">
                  <c:v>1</c:v>
                </c:pt>
                <c:pt idx="151">
                  <c:v>1</c:v>
                </c:pt>
                <c:pt idx="152">
                  <c:v>1</c:v>
                </c:pt>
                <c:pt idx="153">
                  <c:v>1</c:v>
                </c:pt>
                <c:pt idx="154">
                  <c:v>1</c:v>
                </c:pt>
                <c:pt idx="155">
                  <c:v>1</c:v>
                </c:pt>
                <c:pt idx="156">
                  <c:v>1</c:v>
                </c:pt>
                <c:pt idx="157">
                  <c:v>1</c:v>
                </c:pt>
                <c:pt idx="158">
                  <c:v>1</c:v>
                </c:pt>
                <c:pt idx="159">
                  <c:v>1</c:v>
                </c:pt>
                <c:pt idx="160">
                  <c:v>1</c:v>
                </c:pt>
                <c:pt idx="161">
                  <c:v>1</c:v>
                </c:pt>
                <c:pt idx="162">
                  <c:v>1</c:v>
                </c:pt>
                <c:pt idx="163">
                  <c:v>1</c:v>
                </c:pt>
                <c:pt idx="164">
                  <c:v>1</c:v>
                </c:pt>
                <c:pt idx="165">
                  <c:v>1</c:v>
                </c:pt>
                <c:pt idx="166">
                  <c:v>1</c:v>
                </c:pt>
                <c:pt idx="167">
                  <c:v>1</c:v>
                </c:pt>
                <c:pt idx="168">
                  <c:v>1</c:v>
                </c:pt>
                <c:pt idx="169">
                  <c:v>1</c:v>
                </c:pt>
                <c:pt idx="170">
                  <c:v>1</c:v>
                </c:pt>
                <c:pt idx="171">
                  <c:v>1</c:v>
                </c:pt>
                <c:pt idx="172">
                  <c:v>1</c:v>
                </c:pt>
                <c:pt idx="173">
                  <c:v>1</c:v>
                </c:pt>
                <c:pt idx="174">
                  <c:v>1</c:v>
                </c:pt>
                <c:pt idx="175">
                  <c:v>1</c:v>
                </c:pt>
                <c:pt idx="176">
                  <c:v>1</c:v>
                </c:pt>
                <c:pt idx="177">
                  <c:v>1</c:v>
                </c:pt>
                <c:pt idx="178">
                  <c:v>1</c:v>
                </c:pt>
                <c:pt idx="179">
                  <c:v>1</c:v>
                </c:pt>
                <c:pt idx="180">
                  <c:v>1</c:v>
                </c:pt>
                <c:pt idx="181">
                  <c:v>1</c:v>
                </c:pt>
                <c:pt idx="182">
                  <c:v>1</c:v>
                </c:pt>
                <c:pt idx="183">
                  <c:v>1</c:v>
                </c:pt>
                <c:pt idx="184">
                  <c:v>1</c:v>
                </c:pt>
                <c:pt idx="185">
                  <c:v>1</c:v>
                </c:pt>
                <c:pt idx="186">
                  <c:v>1</c:v>
                </c:pt>
                <c:pt idx="187">
                  <c:v>1</c:v>
                </c:pt>
                <c:pt idx="188">
                  <c:v>1</c:v>
                </c:pt>
                <c:pt idx="189">
                  <c:v>1</c:v>
                </c:pt>
                <c:pt idx="190">
                  <c:v>1</c:v>
                </c:pt>
                <c:pt idx="191">
                  <c:v>1</c:v>
                </c:pt>
                <c:pt idx="192">
                  <c:v>1</c:v>
                </c:pt>
                <c:pt idx="193">
                  <c:v>1</c:v>
                </c:pt>
                <c:pt idx="194">
                  <c:v>1</c:v>
                </c:pt>
                <c:pt idx="195">
                  <c:v>1</c:v>
                </c:pt>
                <c:pt idx="196">
                  <c:v>1</c:v>
                </c:pt>
                <c:pt idx="197">
                  <c:v>1</c:v>
                </c:pt>
                <c:pt idx="198">
                  <c:v>1</c:v>
                </c:pt>
                <c:pt idx="199">
                  <c:v>1</c:v>
                </c:pt>
                <c:pt idx="200">
                  <c:v>1</c:v>
                </c:pt>
                <c:pt idx="201">
                  <c:v>1</c:v>
                </c:pt>
                <c:pt idx="202">
                  <c:v>1</c:v>
                </c:pt>
                <c:pt idx="203">
                  <c:v>1</c:v>
                </c:pt>
                <c:pt idx="204">
                  <c:v>1</c:v>
                </c:pt>
                <c:pt idx="205">
                  <c:v>1</c:v>
                </c:pt>
                <c:pt idx="206">
                  <c:v>1</c:v>
                </c:pt>
                <c:pt idx="207">
                  <c:v>1</c:v>
                </c:pt>
                <c:pt idx="208">
                  <c:v>1</c:v>
                </c:pt>
                <c:pt idx="209">
                  <c:v>1</c:v>
                </c:pt>
                <c:pt idx="210">
                  <c:v>1</c:v>
                </c:pt>
                <c:pt idx="211">
                  <c:v>1</c:v>
                </c:pt>
                <c:pt idx="212">
                  <c:v>1</c:v>
                </c:pt>
                <c:pt idx="213">
                  <c:v>1</c:v>
                </c:pt>
                <c:pt idx="214">
                  <c:v>1</c:v>
                </c:pt>
                <c:pt idx="215">
                  <c:v>1</c:v>
                </c:pt>
                <c:pt idx="216">
                  <c:v>1</c:v>
                </c:pt>
                <c:pt idx="217">
                  <c:v>1</c:v>
                </c:pt>
                <c:pt idx="218">
                  <c:v>1</c:v>
                </c:pt>
                <c:pt idx="219">
                  <c:v>1</c:v>
                </c:pt>
                <c:pt idx="220">
                  <c:v>1</c:v>
                </c:pt>
                <c:pt idx="221">
                  <c:v>1</c:v>
                </c:pt>
                <c:pt idx="222">
                  <c:v>1</c:v>
                </c:pt>
                <c:pt idx="223">
                  <c:v>1</c:v>
                </c:pt>
                <c:pt idx="224">
                  <c:v>1</c:v>
                </c:pt>
                <c:pt idx="225">
                  <c:v>1</c:v>
                </c:pt>
                <c:pt idx="226">
                  <c:v>1</c:v>
                </c:pt>
                <c:pt idx="227">
                  <c:v>1</c:v>
                </c:pt>
                <c:pt idx="228">
                  <c:v>1</c:v>
                </c:pt>
                <c:pt idx="229">
                  <c:v>1</c:v>
                </c:pt>
                <c:pt idx="230">
                  <c:v>1</c:v>
                </c:pt>
                <c:pt idx="231">
                  <c:v>1</c:v>
                </c:pt>
                <c:pt idx="232">
                  <c:v>1</c:v>
                </c:pt>
                <c:pt idx="233">
                  <c:v>1</c:v>
                </c:pt>
                <c:pt idx="234">
                  <c:v>1</c:v>
                </c:pt>
                <c:pt idx="235">
                  <c:v>1</c:v>
                </c:pt>
                <c:pt idx="236">
                  <c:v>1</c:v>
                </c:pt>
                <c:pt idx="237">
                  <c:v>1</c:v>
                </c:pt>
                <c:pt idx="238">
                  <c:v>1</c:v>
                </c:pt>
                <c:pt idx="239">
                  <c:v>1</c:v>
                </c:pt>
                <c:pt idx="240">
                  <c:v>1</c:v>
                </c:pt>
                <c:pt idx="241">
                  <c:v>1</c:v>
                </c:pt>
                <c:pt idx="242">
                  <c:v>1</c:v>
                </c:pt>
                <c:pt idx="243">
                  <c:v>1</c:v>
                </c:pt>
                <c:pt idx="244">
                  <c:v>1</c:v>
                </c:pt>
                <c:pt idx="245">
                  <c:v>1</c:v>
                </c:pt>
                <c:pt idx="246">
                  <c:v>1</c:v>
                </c:pt>
                <c:pt idx="247">
                  <c:v>1</c:v>
                </c:pt>
                <c:pt idx="248">
                  <c:v>1</c:v>
                </c:pt>
                <c:pt idx="249">
                  <c:v>1</c:v>
                </c:pt>
                <c:pt idx="250">
                  <c:v>1</c:v>
                </c:pt>
                <c:pt idx="251">
                  <c:v>1</c:v>
                </c:pt>
                <c:pt idx="252">
                  <c:v>1</c:v>
                </c:pt>
                <c:pt idx="253">
                  <c:v>1</c:v>
                </c:pt>
                <c:pt idx="254">
                  <c:v>1</c:v>
                </c:pt>
                <c:pt idx="255">
                  <c:v>1</c:v>
                </c:pt>
                <c:pt idx="256">
                  <c:v>1</c:v>
                </c:pt>
                <c:pt idx="257">
                  <c:v>1</c:v>
                </c:pt>
                <c:pt idx="258">
                  <c:v>1</c:v>
                </c:pt>
                <c:pt idx="259">
                  <c:v>1</c:v>
                </c:pt>
                <c:pt idx="260">
                  <c:v>1</c:v>
                </c:pt>
                <c:pt idx="261">
                  <c:v>1</c:v>
                </c:pt>
                <c:pt idx="262">
                  <c:v>1</c:v>
                </c:pt>
                <c:pt idx="263">
                  <c:v>1</c:v>
                </c:pt>
                <c:pt idx="264">
                  <c:v>1</c:v>
                </c:pt>
                <c:pt idx="265">
                  <c:v>1</c:v>
                </c:pt>
                <c:pt idx="266">
                  <c:v>1</c:v>
                </c:pt>
                <c:pt idx="267">
                  <c:v>1</c:v>
                </c:pt>
                <c:pt idx="268">
                  <c:v>1</c:v>
                </c:pt>
                <c:pt idx="269">
                  <c:v>1</c:v>
                </c:pt>
                <c:pt idx="270">
                  <c:v>1</c:v>
                </c:pt>
                <c:pt idx="271">
                  <c:v>1</c:v>
                </c:pt>
                <c:pt idx="272">
                  <c:v>1</c:v>
                </c:pt>
                <c:pt idx="273">
                  <c:v>1</c:v>
                </c:pt>
                <c:pt idx="274">
                  <c:v>1</c:v>
                </c:pt>
                <c:pt idx="275">
                  <c:v>1</c:v>
                </c:pt>
                <c:pt idx="276">
                  <c:v>1</c:v>
                </c:pt>
                <c:pt idx="277">
                  <c:v>1</c:v>
                </c:pt>
                <c:pt idx="278">
                  <c:v>1</c:v>
                </c:pt>
                <c:pt idx="279">
                  <c:v>1</c:v>
                </c:pt>
                <c:pt idx="280">
                  <c:v>1</c:v>
                </c:pt>
                <c:pt idx="281">
                  <c:v>1</c:v>
                </c:pt>
                <c:pt idx="282">
                  <c:v>1</c:v>
                </c:pt>
                <c:pt idx="283">
                  <c:v>1</c:v>
                </c:pt>
                <c:pt idx="284">
                  <c:v>1</c:v>
                </c:pt>
                <c:pt idx="285">
                  <c:v>1</c:v>
                </c:pt>
                <c:pt idx="286">
                  <c:v>1</c:v>
                </c:pt>
                <c:pt idx="287">
                  <c:v>1</c:v>
                </c:pt>
                <c:pt idx="288">
                  <c:v>1</c:v>
                </c:pt>
                <c:pt idx="289">
                  <c:v>1</c:v>
                </c:pt>
                <c:pt idx="290">
                  <c:v>1</c:v>
                </c:pt>
                <c:pt idx="291">
                  <c:v>1</c:v>
                </c:pt>
                <c:pt idx="292">
                  <c:v>1</c:v>
                </c:pt>
                <c:pt idx="293">
                  <c:v>1</c:v>
                </c:pt>
                <c:pt idx="294">
                  <c:v>1</c:v>
                </c:pt>
                <c:pt idx="295">
                  <c:v>1</c:v>
                </c:pt>
                <c:pt idx="296">
                  <c:v>1</c:v>
                </c:pt>
                <c:pt idx="297">
                  <c:v>1</c:v>
                </c:pt>
                <c:pt idx="298">
                  <c:v>1</c:v>
                </c:pt>
                <c:pt idx="299">
                  <c:v>1</c:v>
                </c:pt>
                <c:pt idx="300">
                  <c:v>1</c:v>
                </c:pt>
                <c:pt idx="301">
                  <c:v>1</c:v>
                </c:pt>
                <c:pt idx="302">
                  <c:v>1</c:v>
                </c:pt>
                <c:pt idx="303">
                  <c:v>1</c:v>
                </c:pt>
                <c:pt idx="304">
                  <c:v>1</c:v>
                </c:pt>
                <c:pt idx="305">
                  <c:v>1</c:v>
                </c:pt>
                <c:pt idx="306">
                  <c:v>1</c:v>
                </c:pt>
                <c:pt idx="307">
                  <c:v>1</c:v>
                </c:pt>
                <c:pt idx="308">
                  <c:v>1</c:v>
                </c:pt>
                <c:pt idx="309">
                  <c:v>1</c:v>
                </c:pt>
                <c:pt idx="310">
                  <c:v>1</c:v>
                </c:pt>
                <c:pt idx="311">
                  <c:v>1</c:v>
                </c:pt>
                <c:pt idx="312">
                  <c:v>1</c:v>
                </c:pt>
                <c:pt idx="313">
                  <c:v>1</c:v>
                </c:pt>
                <c:pt idx="314">
                  <c:v>1</c:v>
                </c:pt>
                <c:pt idx="315">
                  <c:v>1</c:v>
                </c:pt>
                <c:pt idx="316">
                  <c:v>1</c:v>
                </c:pt>
                <c:pt idx="317">
                  <c:v>1</c:v>
                </c:pt>
                <c:pt idx="318">
                  <c:v>1</c:v>
                </c:pt>
                <c:pt idx="319">
                  <c:v>1</c:v>
                </c:pt>
                <c:pt idx="320">
                  <c:v>1</c:v>
                </c:pt>
                <c:pt idx="321">
                  <c:v>1</c:v>
                </c:pt>
                <c:pt idx="322">
                  <c:v>1</c:v>
                </c:pt>
                <c:pt idx="323">
                  <c:v>1</c:v>
                </c:pt>
                <c:pt idx="324">
                  <c:v>1</c:v>
                </c:pt>
                <c:pt idx="325">
                  <c:v>1</c:v>
                </c:pt>
                <c:pt idx="326">
                  <c:v>1</c:v>
                </c:pt>
                <c:pt idx="327">
                  <c:v>1</c:v>
                </c:pt>
                <c:pt idx="328">
                  <c:v>1</c:v>
                </c:pt>
                <c:pt idx="329">
                  <c:v>1</c:v>
                </c:pt>
                <c:pt idx="330">
                  <c:v>1</c:v>
                </c:pt>
                <c:pt idx="331">
                  <c:v>1</c:v>
                </c:pt>
                <c:pt idx="33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7C8-A2EB-4566-9B46-DAC7DE36AD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239228336"/>
        <c:axId val="239220016"/>
      </c:barChart>
      <c:catAx>
        <c:axId val="239228336"/>
        <c:scaling>
          <c:orientation val="minMax"/>
        </c:scaling>
        <c:delete val="0"/>
        <c:axPos val="r"/>
        <c:numFmt formatCode="General" sourceLinked="0"/>
        <c:majorTickMark val="out"/>
        <c:minorTickMark val="none"/>
        <c:tickLblPos val="high"/>
        <c:txPr>
          <a:bodyPr rot="0" vert="horz"/>
          <a:lstStyle/>
          <a:p>
            <a:pPr>
              <a:defRPr sz="700"/>
            </a:pPr>
            <a:endParaRPr lang="fr-FR"/>
          </a:p>
        </c:txPr>
        <c:crossAx val="239220016"/>
        <c:crosses val="max"/>
        <c:auto val="1"/>
        <c:lblAlgn val="ctr"/>
        <c:lblOffset val="100"/>
        <c:tickLblSkip val="3"/>
        <c:tickMarkSkip val="3"/>
        <c:noMultiLvlLbl val="0"/>
      </c:catAx>
      <c:valAx>
        <c:axId val="239220016"/>
        <c:scaling>
          <c:orientation val="minMax"/>
          <c:max val="3"/>
          <c:min val="0"/>
        </c:scaling>
        <c:delete val="0"/>
        <c:axPos val="b"/>
        <c:numFmt formatCode="General" sourceLinked="0"/>
        <c:majorTickMark val="out"/>
        <c:minorTickMark val="none"/>
        <c:tickLblPos val="none"/>
        <c:txPr>
          <a:bodyPr rot="-5400000" vert="horz"/>
          <a:lstStyle/>
          <a:p>
            <a:pPr>
              <a:defRPr sz="700"/>
            </a:pPr>
            <a:endParaRPr lang="fr-FR"/>
          </a:p>
        </c:txPr>
        <c:crossAx val="239228336"/>
        <c:crosses val="autoZero"/>
        <c:crossBetween val="between"/>
        <c:majorUnit val="1"/>
      </c:valAx>
      <c:spPr>
        <a:ln>
          <a:solidFill>
            <a:srgbClr val="C0C0C0"/>
          </a:solidFill>
          <a:prstDash val="solid"/>
        </a:ln>
      </c:spPr>
    </c:plotArea>
    <c:plotVisOnly val="1"/>
    <c:dispBlanksAs val="gap"/>
    <c:showDLblsOverMax val="0"/>
  </c:chart>
  <c:spPr>
    <a:noFill/>
    <a:ln w="6350"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 b="1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1200" b="1" i="0" baseline="0" dirty="0">
                <a:effectLst/>
              </a:rPr>
              <a:t>Relative expression of MRP1 (normalized to 28S) </a:t>
            </a:r>
            <a:endParaRPr lang="fr-FR" sz="1200" dirty="0">
              <a:effectLst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 b="1">
                <a:solidFill>
                  <a:prstClr val="black">
                    <a:lumMod val="65000"/>
                    <a:lumOff val="35000"/>
                  </a:prstClr>
                </a:solidFill>
              </a:defRPr>
            </a:pPr>
            <a:endParaRPr lang="en-US" sz="1200" b="1" dirty="0"/>
          </a:p>
        </c:rich>
      </c:tx>
      <c:layout>
        <c:manualLayout>
          <c:xMode val="edge"/>
          <c:yMode val="edge"/>
          <c:x val="0.16867638888888889"/>
          <c:y val="3.580992063492063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200" b="1" i="0" u="none" strike="noStrike" kern="1200" spc="0" baseline="0">
              <a:solidFill>
                <a:prstClr val="black">
                  <a:lumMod val="65000"/>
                  <a:lumOff val="35000"/>
                </a:prst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3.9783021688510362E-2"/>
          <c:y val="0.17747599473754391"/>
          <c:w val="0.94352321365365921"/>
          <c:h val="0.659092298531258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RP1 (1b)'!$E$3:$E$5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tx>
          <c:spPr>
            <a:solidFill>
              <a:schemeClr val="accent1"/>
            </a:solidFill>
            <a:ln w="9525">
              <a:solidFill>
                <a:schemeClr val="accent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RP1 (1b)'!$Y$3:$Y$4</c:f>
                <c:numCache>
                  <c:formatCode>General</c:formatCode>
                  <c:ptCount val="2"/>
                  <c:pt idx="1">
                    <c:v>7.2942530335227004E-2</c:v>
                  </c:pt>
                </c:numCache>
              </c:numRef>
            </c:plus>
            <c:minus>
              <c:numRef>
                <c:f>'MRP1 (1b)'!$Y$3:$Y$4</c:f>
                <c:numCache>
                  <c:formatCode>General</c:formatCode>
                  <c:ptCount val="2"/>
                  <c:pt idx="1">
                    <c:v>7.294253033522700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RP1 (1b)'!$E$3:$E$5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cat>
          <c:val>
            <c:numRef>
              <c:f>'MRP1 (1b)'!$X$3:$X$5</c:f>
              <c:numCache>
                <c:formatCode>0.000</c:formatCode>
                <c:ptCount val="3"/>
                <c:pt idx="0" formatCode="General">
                  <c:v>1</c:v>
                </c:pt>
                <c:pt idx="1">
                  <c:v>0.69255473405545653</c:v>
                </c:pt>
                <c:pt idx="2">
                  <c:v>0.182588355576258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7E3-6A40-9485-10D4E8A79B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2"/>
        <c:axId val="188151232"/>
        <c:axId val="188149984"/>
      </c:barChart>
      <c:catAx>
        <c:axId val="188151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49984"/>
        <c:crosses val="autoZero"/>
        <c:auto val="1"/>
        <c:lblAlgn val="ctr"/>
        <c:lblOffset val="100"/>
        <c:noMultiLvlLbl val="0"/>
      </c:catAx>
      <c:valAx>
        <c:axId val="1881499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512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 b="1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1200" b="1" i="0" baseline="0" dirty="0">
                <a:effectLst/>
              </a:rPr>
              <a:t>Relative expression of MRP1 (normalized to 28S) </a:t>
            </a:r>
            <a:endParaRPr lang="fr-FR" sz="1200" dirty="0">
              <a:effectLst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 b="1">
                <a:solidFill>
                  <a:prstClr val="black">
                    <a:lumMod val="65000"/>
                    <a:lumOff val="35000"/>
                  </a:prstClr>
                </a:solidFill>
              </a:defRPr>
            </a:pPr>
            <a:endParaRPr lang="en-US" sz="1200" b="1" dirty="0"/>
          </a:p>
        </c:rich>
      </c:tx>
      <c:layout>
        <c:manualLayout>
          <c:xMode val="edge"/>
          <c:yMode val="edge"/>
          <c:x val="0.18278750000000002"/>
          <c:y val="5.3214285714285505E-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200" b="1" i="0" u="none" strike="noStrike" kern="1200" spc="0" baseline="0">
              <a:solidFill>
                <a:prstClr val="black">
                  <a:lumMod val="65000"/>
                  <a:lumOff val="35000"/>
                </a:prst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3.9783021688510362E-2"/>
          <c:y val="0.17747599473754391"/>
          <c:w val="0.94352321365365921"/>
          <c:h val="0.659092298531258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RP1 (2a)'!$E$3:$E$5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RP1 (2a)'!$Y$3:$Y$4</c:f>
                <c:numCache>
                  <c:formatCode>General</c:formatCode>
                  <c:ptCount val="2"/>
                  <c:pt idx="1">
                    <c:v>5.4110549995465248E-3</c:v>
                  </c:pt>
                </c:numCache>
              </c:numRef>
            </c:plus>
            <c:minus>
              <c:numRef>
                <c:f>'MRP1 (2a)'!$Y$3:$Y$4</c:f>
                <c:numCache>
                  <c:formatCode>General</c:formatCode>
                  <c:ptCount val="2"/>
                  <c:pt idx="1">
                    <c:v>5.411054999546524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RP1 (2a)'!$E$3:$E$5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cat>
          <c:val>
            <c:numRef>
              <c:f>'MRP1 (2a)'!$X$3:$X$5</c:f>
              <c:numCache>
                <c:formatCode>0.000</c:formatCode>
                <c:ptCount val="3"/>
                <c:pt idx="0" formatCode="General">
                  <c:v>1</c:v>
                </c:pt>
                <c:pt idx="1">
                  <c:v>0.73543343209297585</c:v>
                </c:pt>
                <c:pt idx="2">
                  <c:v>1.04005993388848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AE-C745-90E7-6BF4475189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2"/>
        <c:axId val="188151232"/>
        <c:axId val="188149984"/>
      </c:barChart>
      <c:catAx>
        <c:axId val="188151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49984"/>
        <c:crosses val="autoZero"/>
        <c:auto val="1"/>
        <c:lblAlgn val="ctr"/>
        <c:lblOffset val="100"/>
        <c:noMultiLvlLbl val="0"/>
      </c:catAx>
      <c:valAx>
        <c:axId val="1881499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512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 b="1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1200" b="1" i="0" baseline="0" dirty="0">
                <a:effectLst/>
              </a:rPr>
              <a:t>Relative expression of MRP1 (normalized to 28S) </a:t>
            </a:r>
            <a:endParaRPr lang="fr-FR" sz="1000" dirty="0">
              <a:effectLst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 b="1">
                <a:solidFill>
                  <a:prstClr val="black">
                    <a:lumMod val="65000"/>
                    <a:lumOff val="35000"/>
                  </a:prstClr>
                </a:solidFill>
              </a:defRPr>
            </a:pPr>
            <a:endParaRPr lang="en-US" sz="1200" b="1" dirty="0"/>
          </a:p>
        </c:rich>
      </c:tx>
      <c:layout>
        <c:manualLayout>
          <c:xMode val="edge"/>
          <c:yMode val="edge"/>
          <c:x val="0.14045416666666666"/>
          <c:y val="5.3214285714285711E-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200" b="1" i="0" u="none" strike="noStrike" kern="1200" spc="0" baseline="0">
              <a:solidFill>
                <a:prstClr val="black">
                  <a:lumMod val="65000"/>
                  <a:lumOff val="35000"/>
                </a:prst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3.9783021688510362E-2"/>
          <c:y val="0.17747599473754391"/>
          <c:w val="0.94352321365365921"/>
          <c:h val="0.659092298531258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RP1 (2b)'!$E$3:$E$5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RP1 (2b)'!$Y$3:$Y$4</c:f>
                <c:numCache>
                  <c:formatCode>General</c:formatCode>
                  <c:ptCount val="2"/>
                  <c:pt idx="1">
                    <c:v>1.2190150952801874E-2</c:v>
                  </c:pt>
                </c:numCache>
              </c:numRef>
            </c:plus>
            <c:minus>
              <c:numRef>
                <c:f>'MRP1 (2b)'!$Y$3:$Y$4</c:f>
                <c:numCache>
                  <c:formatCode>General</c:formatCode>
                  <c:ptCount val="2"/>
                  <c:pt idx="1">
                    <c:v>1.219015095280187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RP1 (2b)'!$E$3:$E$5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cat>
          <c:val>
            <c:numRef>
              <c:f>'MRP1 (2b)'!$X$3:$X$5</c:f>
              <c:numCache>
                <c:formatCode>0.000</c:formatCode>
                <c:ptCount val="3"/>
                <c:pt idx="0" formatCode="General">
                  <c:v>1</c:v>
                </c:pt>
                <c:pt idx="1">
                  <c:v>0.17965902732236605</c:v>
                </c:pt>
                <c:pt idx="2">
                  <c:v>0.460093825312438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01F-3945-98F2-B8911CC44C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2"/>
        <c:axId val="188151232"/>
        <c:axId val="188149984"/>
      </c:barChart>
      <c:catAx>
        <c:axId val="188151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49984"/>
        <c:crosses val="autoZero"/>
        <c:auto val="1"/>
        <c:lblAlgn val="ctr"/>
        <c:lblOffset val="100"/>
        <c:noMultiLvlLbl val="0"/>
      </c:catAx>
      <c:valAx>
        <c:axId val="1881499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512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 b="1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1200" b="1" i="0" baseline="0" dirty="0">
                <a:effectLst/>
              </a:rPr>
              <a:t>Relative expression of MRP1 (normalized to 28S) </a:t>
            </a:r>
            <a:endParaRPr lang="fr-FR" sz="1200" dirty="0">
              <a:effectLst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 b="1">
                <a:solidFill>
                  <a:prstClr val="black">
                    <a:lumMod val="65000"/>
                    <a:lumOff val="35000"/>
                  </a:prstClr>
                </a:solidFill>
              </a:defRPr>
            </a:pPr>
            <a:endParaRPr lang="en-US" sz="1200" b="1" dirty="0"/>
          </a:p>
        </c:rich>
      </c:tx>
      <c:layout>
        <c:manualLayout>
          <c:xMode val="edge"/>
          <c:yMode val="edge"/>
          <c:x val="0.18278750000000002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200" b="1" i="0" u="none" strike="noStrike" kern="1200" spc="0" baseline="0">
              <a:solidFill>
                <a:prstClr val="black">
                  <a:lumMod val="65000"/>
                  <a:lumOff val="35000"/>
                </a:prst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3.9783021688510362E-2"/>
          <c:y val="0.17747599473754391"/>
          <c:w val="0.94352321365365921"/>
          <c:h val="0.659092298531258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RP1 (3b)'!$E$3:$E$5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RP1 (3b)'!$Y$3:$Y$4</c:f>
                <c:numCache>
                  <c:formatCode>General</c:formatCode>
                  <c:ptCount val="2"/>
                  <c:pt idx="1">
                    <c:v>1.1630938547975913E-2</c:v>
                  </c:pt>
                </c:numCache>
              </c:numRef>
            </c:plus>
            <c:minus>
              <c:numRef>
                <c:f>'MRP1 (3b)'!$Y$3:$Y$4</c:f>
                <c:numCache>
                  <c:formatCode>General</c:formatCode>
                  <c:ptCount val="2"/>
                  <c:pt idx="1">
                    <c:v>1.163093854797591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RP1 (3b)'!$E$3:$E$5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cat>
          <c:val>
            <c:numRef>
              <c:f>'MRP1 (3b)'!$X$3:$X$5</c:f>
              <c:numCache>
                <c:formatCode>0.000</c:formatCode>
                <c:ptCount val="3"/>
                <c:pt idx="0" formatCode="General">
                  <c:v>1</c:v>
                </c:pt>
                <c:pt idx="1">
                  <c:v>0.54841248984731283</c:v>
                </c:pt>
                <c:pt idx="2">
                  <c:v>0.569065517293910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639-2349-B4C2-8D3599D8DD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2"/>
        <c:axId val="188151232"/>
        <c:axId val="188149984"/>
      </c:barChart>
      <c:catAx>
        <c:axId val="188151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49984"/>
        <c:crosses val="autoZero"/>
        <c:auto val="1"/>
        <c:lblAlgn val="ctr"/>
        <c:lblOffset val="100"/>
        <c:noMultiLvlLbl val="0"/>
      </c:catAx>
      <c:valAx>
        <c:axId val="1881499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512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sz="12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b="1"/>
              <a:t>Expression relative de</a:t>
            </a:r>
            <a:r>
              <a:rPr lang="en-US" sz="1200" b="1" baseline="0"/>
              <a:t> MRP1 (normalisé 28S) - Extraction 5</a:t>
            </a:r>
            <a:endParaRPr lang="en-US" sz="1200" b="1"/>
          </a:p>
        </c:rich>
      </c:tx>
      <c:layout>
        <c:manualLayout>
          <c:xMode val="edge"/>
          <c:yMode val="edge"/>
          <c:x val="0.18984300311521954"/>
          <c:y val="3.077015240210246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sz="12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3.9783021688510362E-2"/>
          <c:y val="0.17747599473754391"/>
          <c:w val="0.94352321365365921"/>
          <c:h val="0.659092298531258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VP (7)'!$E$3:$E$5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tx>
          <c:spPr>
            <a:solidFill>
              <a:schemeClr val="accent1"/>
            </a:solidFill>
            <a:ln w="9525">
              <a:solidFill>
                <a:schemeClr val="accent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VP (7)'!$Y$3:$Y$4</c:f>
                <c:numCache>
                  <c:formatCode>General</c:formatCode>
                  <c:ptCount val="2"/>
                  <c:pt idx="1">
                    <c:v>7.5534969400439488E-3</c:v>
                  </c:pt>
                </c:numCache>
              </c:numRef>
            </c:plus>
            <c:minus>
              <c:numRef>
                <c:f>'MVP (7)'!$Y$3:$Y$4</c:f>
                <c:numCache>
                  <c:formatCode>General</c:formatCode>
                  <c:ptCount val="2"/>
                  <c:pt idx="1">
                    <c:v>7.553496940043948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VP (7)'!$E$3:$E$5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cat>
          <c:val>
            <c:numRef>
              <c:f>'MVP (7)'!$X$3:$X$5</c:f>
              <c:numCache>
                <c:formatCode>0.000</c:formatCode>
                <c:ptCount val="3"/>
                <c:pt idx="0" formatCode="General">
                  <c:v>1</c:v>
                </c:pt>
                <c:pt idx="1">
                  <c:v>1</c:v>
                </c:pt>
                <c:pt idx="2">
                  <c:v>0.918064019965216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944-0C42-9CA8-29876E4614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2"/>
        <c:axId val="188151232"/>
        <c:axId val="188149984"/>
      </c:barChart>
      <c:catAx>
        <c:axId val="188151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49984"/>
        <c:crosses val="autoZero"/>
        <c:auto val="1"/>
        <c:lblAlgn val="ctr"/>
        <c:lblOffset val="100"/>
        <c:noMultiLvlLbl val="0"/>
      </c:catAx>
      <c:valAx>
        <c:axId val="188149984"/>
        <c:scaling>
          <c:orientation val="minMax"/>
          <c:max val="1.2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51232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sz="12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b="1" i="0" baseline="0" dirty="0">
                <a:effectLst/>
              </a:rPr>
              <a:t>Relative expression of MVP/LRP (normalized to 28S) </a:t>
            </a:r>
            <a:endParaRPr lang="fr-FR" sz="1200" dirty="0">
              <a:effectLst/>
            </a:endParaRPr>
          </a:p>
        </c:rich>
      </c:tx>
      <c:layout>
        <c:manualLayout>
          <c:xMode val="edge"/>
          <c:yMode val="edge"/>
          <c:x val="0.18984300311521954"/>
          <c:y val="3.077015240210246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sz="12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3.9783021688510362E-2"/>
          <c:y val="0.17747599473754391"/>
          <c:w val="0.94352321365365921"/>
          <c:h val="0.659092298531258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VP (1)'!$E$3:$E$5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tx>
          <c:spPr>
            <a:solidFill>
              <a:schemeClr val="accent2"/>
            </a:solidFill>
            <a:ln w="9525">
              <a:solidFill>
                <a:schemeClr val="accent2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VP (1)'!$Y$3:$Y$4</c:f>
                <c:numCache>
                  <c:formatCode>General</c:formatCode>
                  <c:ptCount val="2"/>
                  <c:pt idx="1">
                    <c:v>2.0397975075261778E-2</c:v>
                  </c:pt>
                </c:numCache>
              </c:numRef>
            </c:plus>
            <c:minus>
              <c:numRef>
                <c:f>'MVP (1)'!$Y$3:$Y$4</c:f>
                <c:numCache>
                  <c:formatCode>General</c:formatCode>
                  <c:ptCount val="2"/>
                  <c:pt idx="1">
                    <c:v>2.039797507526177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VP (1)'!$E$3:$E$5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cat>
          <c:val>
            <c:numRef>
              <c:f>'MVP (1)'!$X$3:$X$5</c:f>
              <c:numCache>
                <c:formatCode>0.000</c:formatCode>
                <c:ptCount val="3"/>
                <c:pt idx="0" formatCode="General">
                  <c:v>1</c:v>
                </c:pt>
                <c:pt idx="1">
                  <c:v>1.1540187517635621</c:v>
                </c:pt>
                <c:pt idx="2">
                  <c:v>1.54756499354239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3DE-8B42-BE41-A78DAAA8A4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2"/>
        <c:axId val="188151232"/>
        <c:axId val="188149984"/>
      </c:barChart>
      <c:catAx>
        <c:axId val="188151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49984"/>
        <c:crosses val="autoZero"/>
        <c:auto val="1"/>
        <c:lblAlgn val="ctr"/>
        <c:lblOffset val="100"/>
        <c:noMultiLvlLbl val="0"/>
      </c:catAx>
      <c:valAx>
        <c:axId val="188149984"/>
        <c:scaling>
          <c:orientation val="minMax"/>
          <c:max val="2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512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 b="1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1200" b="1" i="0" baseline="0" dirty="0">
                <a:effectLst/>
              </a:rPr>
              <a:t>Relative expression of MVP/LRP (normalized to 28S) </a:t>
            </a:r>
            <a:endParaRPr lang="fr-FR" sz="1200" dirty="0">
              <a:effectLst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 b="1">
                <a:solidFill>
                  <a:prstClr val="black">
                    <a:lumMod val="65000"/>
                    <a:lumOff val="35000"/>
                  </a:prstClr>
                </a:solidFill>
              </a:defRPr>
            </a:pPr>
            <a:endParaRPr lang="en-US" sz="1200" b="1" dirty="0"/>
          </a:p>
        </c:rich>
      </c:tx>
      <c:layout>
        <c:manualLayout>
          <c:xMode val="edge"/>
          <c:yMode val="edge"/>
          <c:x val="0.18984300311521954"/>
          <c:y val="3.077015240210246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200" b="1" i="0" u="none" strike="noStrike" kern="1200" spc="0" baseline="0">
              <a:solidFill>
                <a:prstClr val="black">
                  <a:lumMod val="65000"/>
                  <a:lumOff val="35000"/>
                </a:prst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3.9783021688510362E-2"/>
          <c:y val="0.18779352580927383"/>
          <c:w val="0.94352321365365921"/>
          <c:h val="0.6487751531058617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VP (2)'!$E$3:$E$5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VP (2)'!$Y$3:$Y$4</c:f>
                <c:numCache>
                  <c:formatCode>General</c:formatCode>
                  <c:ptCount val="2"/>
                  <c:pt idx="1">
                    <c:v>5.510839943161241E-3</c:v>
                  </c:pt>
                </c:numCache>
              </c:numRef>
            </c:plus>
            <c:minus>
              <c:numRef>
                <c:f>'MVP (2)'!$Y$3:$Y$4</c:f>
                <c:numCache>
                  <c:formatCode>General</c:formatCode>
                  <c:ptCount val="2"/>
                  <c:pt idx="1">
                    <c:v>5.51083994316124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VP (2)'!$E$3:$E$5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cat>
          <c:val>
            <c:numRef>
              <c:f>'MVP (2)'!$X$3:$X$5</c:f>
              <c:numCache>
                <c:formatCode>0.000</c:formatCode>
                <c:ptCount val="3"/>
                <c:pt idx="0" formatCode="General">
                  <c:v>1</c:v>
                </c:pt>
                <c:pt idx="1">
                  <c:v>0.53464999929086965</c:v>
                </c:pt>
                <c:pt idx="2">
                  <c:v>1.15401875176355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C61-114D-A066-B9FB2000E3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2"/>
        <c:axId val="188151232"/>
        <c:axId val="188149984"/>
      </c:barChart>
      <c:catAx>
        <c:axId val="188151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49984"/>
        <c:crosses val="autoZero"/>
        <c:auto val="1"/>
        <c:lblAlgn val="ctr"/>
        <c:lblOffset val="100"/>
        <c:noMultiLvlLbl val="0"/>
      </c:catAx>
      <c:valAx>
        <c:axId val="188149984"/>
        <c:scaling>
          <c:orientation val="minMax"/>
          <c:max val="2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512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 b="1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1200" b="1" i="0" baseline="0" dirty="0">
                <a:effectLst/>
              </a:rPr>
              <a:t>Relative expression of MVP/LRP (normalized to 28S) </a:t>
            </a:r>
            <a:endParaRPr lang="fr-FR" sz="1200" dirty="0">
              <a:effectLst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 b="1">
                <a:solidFill>
                  <a:prstClr val="black">
                    <a:lumMod val="65000"/>
                    <a:lumOff val="35000"/>
                  </a:prstClr>
                </a:solidFill>
              </a:defRPr>
            </a:pPr>
            <a:endParaRPr lang="en-US" sz="1200" b="1" dirty="0"/>
          </a:p>
        </c:rich>
      </c:tx>
      <c:layout>
        <c:manualLayout>
          <c:xMode val="edge"/>
          <c:yMode val="edge"/>
          <c:x val="0.18984300311521954"/>
          <c:y val="3.077015240210246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200" b="1" i="0" u="none" strike="noStrike" kern="1200" spc="0" baseline="0">
              <a:solidFill>
                <a:prstClr val="black">
                  <a:lumMod val="65000"/>
                  <a:lumOff val="35000"/>
                </a:prst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3.9783021688510362E-2"/>
          <c:y val="0.17747599473754391"/>
          <c:w val="0.94352321365365921"/>
          <c:h val="0.659092298531258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VP (3)'!$E$3:$E$5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VP (3)'!$Y$3:$Y$5</c:f>
                <c:numCache>
                  <c:formatCode>General</c:formatCode>
                  <c:ptCount val="3"/>
                  <c:pt idx="1">
                    <c:v>2.0914848015396881E-2</c:v>
                  </c:pt>
                  <c:pt idx="2">
                    <c:v>1.2678954132235245E-2</c:v>
                  </c:pt>
                </c:numCache>
              </c:numRef>
            </c:plus>
            <c:minus>
              <c:numRef>
                <c:f>'MVP (3)'!$Y$3:$Y$5</c:f>
                <c:numCache>
                  <c:formatCode>General</c:formatCode>
                  <c:ptCount val="3"/>
                  <c:pt idx="1">
                    <c:v>2.0914848015396881E-2</c:v>
                  </c:pt>
                  <c:pt idx="2">
                    <c:v>1.267895413223524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VP (3)'!$E$3:$E$8</c:f>
              <c:strCache>
                <c:ptCount val="3"/>
                <c:pt idx="0">
                  <c:v>S</c:v>
                </c:pt>
                <c:pt idx="1">
                  <c:v>TR</c:v>
                </c:pt>
                <c:pt idx="2">
                  <c:v>TCR</c:v>
                </c:pt>
              </c:strCache>
            </c:strRef>
          </c:cat>
          <c:val>
            <c:numRef>
              <c:f>'MVP (3)'!$X$3:$X$5</c:f>
              <c:numCache>
                <c:formatCode>0.000</c:formatCode>
                <c:ptCount val="3"/>
                <c:pt idx="0" formatCode="General">
                  <c:v>1</c:v>
                </c:pt>
                <c:pt idx="1">
                  <c:v>1.1566881839052796</c:v>
                </c:pt>
                <c:pt idx="2">
                  <c:v>2.15098878091474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476-3B4E-9DAB-A693348772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2"/>
        <c:axId val="188151232"/>
        <c:axId val="188149984"/>
      </c:barChart>
      <c:catAx>
        <c:axId val="188151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49984"/>
        <c:crosses val="autoZero"/>
        <c:auto val="1"/>
        <c:lblAlgn val="ctr"/>
        <c:lblOffset val="100"/>
        <c:noMultiLvlLbl val="0"/>
      </c:catAx>
      <c:valAx>
        <c:axId val="18814998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81512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837F72-E5DE-3545-86B6-310126035B15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1DDD56-A8C9-9E42-A467-94CC9D0CB3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495354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C0D73-E8B6-4CE0-9DA5-22EADEC3FEDA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B6C0-2ABD-4C74-899D-EBFFB0A730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46013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C0D73-E8B6-4CE0-9DA5-22EADEC3FEDA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B6C0-2ABD-4C74-899D-EBFFB0A730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0000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C0D73-E8B6-4CE0-9DA5-22EADEC3FEDA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B6C0-2ABD-4C74-899D-EBFFB0A730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064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C0D73-E8B6-4CE0-9DA5-22EADEC3FEDA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B6C0-2ABD-4C74-899D-EBFFB0A730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7224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C0D73-E8B6-4CE0-9DA5-22EADEC3FEDA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B6C0-2ABD-4C74-899D-EBFFB0A730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85936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C0D73-E8B6-4CE0-9DA5-22EADEC3FEDA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B6C0-2ABD-4C74-899D-EBFFB0A730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2522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C0D73-E8B6-4CE0-9DA5-22EADEC3FEDA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B6C0-2ABD-4C74-899D-EBFFB0A730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5413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C0D73-E8B6-4CE0-9DA5-22EADEC3FEDA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B6C0-2ABD-4C74-899D-EBFFB0A730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90294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C0D73-E8B6-4CE0-9DA5-22EADEC3FEDA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B6C0-2ABD-4C74-899D-EBFFB0A730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10011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C0D73-E8B6-4CE0-9DA5-22EADEC3FEDA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B6C0-2ABD-4C74-899D-EBFFB0A730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96071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C0D73-E8B6-4CE0-9DA5-22EADEC3FEDA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B6C0-2ABD-4C74-899D-EBFFB0A730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4168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EC0D73-E8B6-4CE0-9DA5-22EADEC3FEDA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3CB6C0-2ABD-4C74-899D-EBFFB0A730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58967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7" Type="http://schemas.openxmlformats.org/officeDocument/2006/relationships/image" Target="../media/image2.png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.png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/>
          <p:cNvSpPr txBox="1"/>
          <p:nvPr/>
        </p:nvSpPr>
        <p:spPr>
          <a:xfrm>
            <a:off x="63334" y="7556471"/>
            <a:ext cx="743474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Franklin Gothic Book" panose="020B0503020102020204" pitchFamily="34" charset="0"/>
              </a:rPr>
              <a:t>Table. S1. SLC primers list used for RT-PCR. </a:t>
            </a:r>
            <a:r>
              <a:rPr lang="en-US" sz="1100" dirty="0">
                <a:latin typeface="Franklin Gothic Book" panose="020B0503020102020204" pitchFamily="34" charset="0"/>
              </a:rPr>
              <a:t>Oligonucleotides primers were designed using the </a:t>
            </a:r>
            <a:r>
              <a:rPr lang="en-US" sz="1100" dirty="0" err="1">
                <a:latin typeface="Franklin Gothic Book" panose="020B0503020102020204" pitchFamily="34" charset="0"/>
              </a:rPr>
              <a:t>ncbi’s</a:t>
            </a:r>
            <a:r>
              <a:rPr lang="en-US" sz="1100" dirty="0">
                <a:latin typeface="Franklin Gothic Book" panose="020B0503020102020204" pitchFamily="34" charset="0"/>
              </a:rPr>
              <a:t> primer-BLAST designer.</a:t>
            </a:r>
            <a:r>
              <a:rPr lang="en-US" sz="1100" b="1" dirty="0">
                <a:latin typeface="Franklin Gothic Book" panose="020B0503020102020204" pitchFamily="34" charset="0"/>
              </a:rPr>
              <a:t> </a:t>
            </a:r>
            <a:r>
              <a:rPr lang="en-US" sz="1100" b="1" dirty="0" err="1">
                <a:latin typeface="Franklin Gothic Book" panose="020B0503020102020204" pitchFamily="34" charset="0"/>
              </a:rPr>
              <a:t>RNAseq</a:t>
            </a:r>
            <a:r>
              <a:rPr lang="en-US" sz="1100" b="1" dirty="0">
                <a:latin typeface="Franklin Gothic Book" panose="020B0503020102020204" pitchFamily="34" charset="0"/>
              </a:rPr>
              <a:t> expression data </a:t>
            </a:r>
            <a:r>
              <a:rPr lang="en-US" sz="1100" dirty="0">
                <a:latin typeface="Franklin Gothic Book" panose="020B0503020102020204" pitchFamily="34" charset="0"/>
              </a:rPr>
              <a:t>represents the expression fold change values of the genes of interest from </a:t>
            </a:r>
            <a:r>
              <a:rPr lang="en-US" sz="1100" dirty="0" err="1">
                <a:latin typeface="Franklin Gothic Book" panose="020B0503020102020204" pitchFamily="34" charset="0"/>
              </a:rPr>
              <a:t>RNAseq</a:t>
            </a:r>
            <a:r>
              <a:rPr lang="en-US" sz="1100" dirty="0">
                <a:latin typeface="Franklin Gothic Book" panose="020B0503020102020204" pitchFamily="34" charset="0"/>
              </a:rPr>
              <a:t> assays. The fold change was calculated as the level of expression in each resistant cell line over the parental one (*: p&lt;0,05; **: P&lt;0,01; ***: P&lt;0,001). </a:t>
            </a:r>
            <a:r>
              <a:rPr lang="en-US" sz="1100" b="1" dirty="0">
                <a:latin typeface="Franklin Gothic Book" panose="020B0503020102020204" pitchFamily="34" charset="0"/>
              </a:rPr>
              <a:t> Grey background  </a:t>
            </a:r>
            <a:r>
              <a:rPr lang="en-US" sz="1100" dirty="0">
                <a:latin typeface="Franklin Gothic Book" panose="020B0503020102020204" pitchFamily="34" charset="0"/>
              </a:rPr>
              <a:t>shows endosomal or lysosomal localization of the encoded protein accorded to </a:t>
            </a:r>
            <a:r>
              <a:rPr lang="en-US" sz="1100" dirty="0" err="1">
                <a:latin typeface="Franklin Gothic Book" panose="020B0503020102020204" pitchFamily="34" charset="0"/>
              </a:rPr>
              <a:t>GeneCards</a:t>
            </a:r>
            <a:r>
              <a:rPr lang="en-US" sz="1100" dirty="0">
                <a:latin typeface="Franklin Gothic Book" panose="020B0503020102020204" pitchFamily="34" charset="0"/>
              </a:rPr>
              <a:t> (Dark grey: high confidence score; Grey: medium confidence score; Light grey: low confidence score).</a:t>
            </a:r>
          </a:p>
        </p:txBody>
      </p:sp>
      <p:graphicFrame>
        <p:nvGraphicFramePr>
          <p:cNvPr id="9" name="Tableau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1766243"/>
              </p:ext>
            </p:extLst>
          </p:nvPr>
        </p:nvGraphicFramePr>
        <p:xfrm>
          <a:off x="1040476" y="512492"/>
          <a:ext cx="5795753" cy="6783384"/>
        </p:xfrm>
        <a:graphic>
          <a:graphicData uri="http://schemas.openxmlformats.org/drawingml/2006/table">
            <a:tbl>
              <a:tblPr/>
              <a:tblGrid>
                <a:gridCol w="739339">
                  <a:extLst>
                    <a:ext uri="{9D8B030D-6E8A-4147-A177-3AD203B41FA5}">
                      <a16:colId xmlns:a16="http://schemas.microsoft.com/office/drawing/2014/main" val="3021285970"/>
                    </a:ext>
                  </a:extLst>
                </a:gridCol>
                <a:gridCol w="1594478">
                  <a:extLst>
                    <a:ext uri="{9D8B030D-6E8A-4147-A177-3AD203B41FA5}">
                      <a16:colId xmlns:a16="http://schemas.microsoft.com/office/drawing/2014/main" val="1501885614"/>
                    </a:ext>
                  </a:extLst>
                </a:gridCol>
                <a:gridCol w="1596705">
                  <a:extLst>
                    <a:ext uri="{9D8B030D-6E8A-4147-A177-3AD203B41FA5}">
                      <a16:colId xmlns:a16="http://schemas.microsoft.com/office/drawing/2014/main" val="791162333"/>
                    </a:ext>
                  </a:extLst>
                </a:gridCol>
                <a:gridCol w="933413">
                  <a:extLst>
                    <a:ext uri="{9D8B030D-6E8A-4147-A177-3AD203B41FA5}">
                      <a16:colId xmlns:a16="http://schemas.microsoft.com/office/drawing/2014/main" val="3487108937"/>
                    </a:ext>
                  </a:extLst>
                </a:gridCol>
                <a:gridCol w="931818">
                  <a:extLst>
                    <a:ext uri="{9D8B030D-6E8A-4147-A177-3AD203B41FA5}">
                      <a16:colId xmlns:a16="http://schemas.microsoft.com/office/drawing/2014/main" val="3220160625"/>
                    </a:ext>
                  </a:extLst>
                </a:gridCol>
              </a:tblGrid>
              <a:tr h="306742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1050" b="1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Gene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fr-FR" sz="105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 </a:t>
                      </a:r>
                    </a:p>
                  </a:txBody>
                  <a:tcPr marL="8764" marR="8764" marT="8764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Primer </a:t>
                      </a:r>
                      <a:r>
                        <a:rPr lang="fr-FR" sz="105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equence</a:t>
                      </a:r>
                      <a:r>
                        <a:rPr lang="fr-FR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 (5'-&gt;3')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NA </a:t>
                      </a:r>
                      <a:r>
                        <a:rPr lang="fr-FR" sz="105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eq</a:t>
                      </a:r>
                      <a:r>
                        <a:rPr lang="fr-FR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 expression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39510186"/>
                  </a:ext>
                </a:extLst>
              </a:tr>
              <a:tr h="306742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1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MDA-MB-361 TR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MDA-MB-361 TCR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1052563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17A9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</a:t>
                      </a:r>
                      <a:r>
                        <a:rPr lang="fr-FR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TGGACCTGAGCTCTACCCAT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84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59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839332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TGTTCCTCTCTGCTCGTGTG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11190515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7A2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GAACGGCCTGTTCCATTGTT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39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,09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23124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ACACTGGAGCTTGTATTATTAGGCT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88121635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17A7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TTCGCCATCTCTGGGTTCAA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755934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,16</a:t>
                      </a:r>
                      <a:r>
                        <a:rPr lang="fr-FR" sz="8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,20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5104177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TCCTCCCGAGTCTTGTGCTT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04045688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25A27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CTGGTCGGATCTCACAAGGC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,50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,49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8572148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TCTGAAATGCTGGCTCCCTC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79777087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47A1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GGAGTGATGGGTCTGTGGTC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755934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,20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,09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4815756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TCCGAGGCACGTTGTTTACT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69537974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9B2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</a:t>
                      </a:r>
                      <a:r>
                        <a:rPr lang="fr-FR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CATTCTGGCCATCACTGGCT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24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755934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,47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901073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TTTGTCCTGGTCACGGCTTG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15849135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36A4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</a:t>
                      </a:r>
                      <a:r>
                        <a:rPr lang="fr-FR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ACTCAGGCTGGTGATACTCT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0,82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0,80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2117592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GATGATCAGTTAACGATACAAGCA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4584867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38A9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TGAGGGACTTGTGCATTGCT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02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19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4998377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CCTTGCAATGAAGGACAGGG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03671517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11A1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CCAATGGCCTGCTGAACAAG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,93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,51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5685870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ACAGGTCCAGACCAGGTAGG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89051490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9A7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GGGAAGGCAGCAAGAAACCTA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,57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,46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0954665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TCTCATGCATTCGTCGGCTC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93777089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2A12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ACACACAAGTGGTCTGGACA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,28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94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5485942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AAATCCTAGCCAGGACCCTCT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79462805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27A5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TGGGATCACATGGAGAAGCC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755934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67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14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9185973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TCCCAACGACAAGTCCCATC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43480127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27A6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GATGTGTTGAGTTGGGTGCC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,02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,21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0427834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CCAATTGCCAAACGCACCTT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23052309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28A3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AGGGAGCATCCTCCTCCATC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,85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32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0450191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CCTGCCATTCCACTCCCATC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91272296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29A1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CCAAGAGCAGGCAAAGAGGA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72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35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3629325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ACGGCTGGAAACATCCCAAT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12089988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29A2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CTGGAGAAGGAGCCGGAATC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12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21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5708718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GAAGACGGACAGGGTGACTG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8075238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29A3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ATTGATTCCCACACACCCCC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755934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,80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,19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3330224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GGACTCGATGTTGGTGCAGA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4908819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30A2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CATCCATGTGATCGGCGACT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,43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,85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3020945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GGTCCCTTCCATCAACACCA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45355073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3A2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AGACAGGCTCTTGATTGCGG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76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58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9462970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TGCTCCCCAGTAGAACCAGA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9516818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48A1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AGAGCTGGTCTCCCATGAGT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,79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,73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3136065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GGTTTGGGGGCTCTTTCCAG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96841407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7A5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TCCTTCTGGAAGACACCCGT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75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25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5591517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CTTCTGACACAGGACGGTCG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47486795"/>
                  </a:ext>
                </a:extLst>
              </a:tr>
              <a:tr h="1402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SLC46A3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Forward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AACAAAAGCAGCCCAATTTTT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31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,53 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Franklin Gothic Book" panose="020B0503020102020204" pitchFamily="34" charset="0"/>
                        </a:rPr>
                        <a:t>(**)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1134235"/>
                  </a:ext>
                </a:extLst>
              </a:tr>
              <a:tr h="1402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Reverse </a:t>
                      </a:r>
                    </a:p>
                  </a:txBody>
                  <a:tcPr marL="8764" marR="8764" marT="876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 Light" panose="020F0302020204030204" pitchFamily="34" charset="0"/>
                        </a:rPr>
                        <a:t>GACCAGGAATTAATCCACTTATGTC</a:t>
                      </a:r>
                    </a:p>
                  </a:txBody>
                  <a:tcPr marL="8764" marR="8764" marT="876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111335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947869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>
            <a:extLst>
              <a:ext uri="{FF2B5EF4-FFF2-40B4-BE49-F238E27FC236}">
                <a16:creationId xmlns:a16="http://schemas.microsoft.com/office/drawing/2014/main" id="{4CCD3F81-0D09-BB4B-B911-B684A2B133C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3148107"/>
              </p:ext>
            </p:extLst>
          </p:nvPr>
        </p:nvGraphicFramePr>
        <p:xfrm>
          <a:off x="592384" y="177733"/>
          <a:ext cx="3040289" cy="27010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phique 4">
            <a:extLst>
              <a:ext uri="{FF2B5EF4-FFF2-40B4-BE49-F238E27FC236}">
                <a16:creationId xmlns:a16="http://schemas.microsoft.com/office/drawing/2014/main" id="{E9EDA85D-09D6-5F45-BCC1-04B4F15B9B0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52731279"/>
              </p:ext>
            </p:extLst>
          </p:nvPr>
        </p:nvGraphicFramePr>
        <p:xfrm>
          <a:off x="4091757" y="358751"/>
          <a:ext cx="3339427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Graphique 5">
            <a:extLst>
              <a:ext uri="{FF2B5EF4-FFF2-40B4-BE49-F238E27FC236}">
                <a16:creationId xmlns:a16="http://schemas.microsoft.com/office/drawing/2014/main" id="{CF569F85-1A9B-4348-8394-5173DBC36BC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95264695"/>
              </p:ext>
            </p:extLst>
          </p:nvPr>
        </p:nvGraphicFramePr>
        <p:xfrm>
          <a:off x="439196" y="3134235"/>
          <a:ext cx="3339427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Graphique 6">
            <a:extLst>
              <a:ext uri="{FF2B5EF4-FFF2-40B4-BE49-F238E27FC236}">
                <a16:creationId xmlns:a16="http://schemas.microsoft.com/office/drawing/2014/main" id="{B86906B5-871C-3D40-87BC-7DBE7974A11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2621608"/>
              </p:ext>
            </p:extLst>
          </p:nvPr>
        </p:nvGraphicFramePr>
        <p:xfrm>
          <a:off x="4055552" y="3134235"/>
          <a:ext cx="3339427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Graphique 7">
            <a:extLst>
              <a:ext uri="{FF2B5EF4-FFF2-40B4-BE49-F238E27FC236}">
                <a16:creationId xmlns:a16="http://schemas.microsoft.com/office/drawing/2014/main" id="{C2558FE0-BAF3-AC4F-9534-9BE51F3E1CD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6415657"/>
              </p:ext>
            </p:extLst>
          </p:nvPr>
        </p:nvGraphicFramePr>
        <p:xfrm>
          <a:off x="439593" y="5989315"/>
          <a:ext cx="3340244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9" name="ZoneTexte 8">
            <a:extLst>
              <a:ext uri="{FF2B5EF4-FFF2-40B4-BE49-F238E27FC236}">
                <a16:creationId xmlns:a16="http://schemas.microsoft.com/office/drawing/2014/main" id="{7641D146-A0F5-354D-987F-04643B38237C}"/>
              </a:ext>
            </a:extLst>
          </p:cNvPr>
          <p:cNvSpPr txBox="1"/>
          <p:nvPr/>
        </p:nvSpPr>
        <p:spPr>
          <a:xfrm rot="16200000">
            <a:off x="-860133" y="1375935"/>
            <a:ext cx="21819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err="1"/>
              <a:t>mRNA</a:t>
            </a:r>
            <a:r>
              <a:rPr lang="fr-FR" sz="1200" dirty="0"/>
              <a:t> </a:t>
            </a:r>
            <a:r>
              <a:rPr lang="fr-FR" sz="1200" dirty="0" err="1"/>
              <a:t>level</a:t>
            </a:r>
            <a:r>
              <a:rPr lang="fr-FR" sz="1200" dirty="0"/>
              <a:t> </a:t>
            </a:r>
          </a:p>
          <a:p>
            <a:pPr algn="ctr"/>
            <a:r>
              <a:rPr lang="fr-FR" sz="1200" dirty="0"/>
              <a:t>Relative to MDA-MB-361 S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8DC32C1E-E68E-C841-B98E-9EEDCB4AF99D}"/>
              </a:ext>
            </a:extLst>
          </p:cNvPr>
          <p:cNvSpPr txBox="1"/>
          <p:nvPr/>
        </p:nvSpPr>
        <p:spPr>
          <a:xfrm rot="16200000">
            <a:off x="2768864" y="1387918"/>
            <a:ext cx="21819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err="1"/>
              <a:t>mRNA</a:t>
            </a:r>
            <a:r>
              <a:rPr lang="fr-FR" sz="1200" dirty="0"/>
              <a:t> </a:t>
            </a:r>
            <a:r>
              <a:rPr lang="fr-FR" sz="1200" dirty="0" err="1"/>
              <a:t>level</a:t>
            </a:r>
            <a:r>
              <a:rPr lang="fr-FR" sz="1200" dirty="0"/>
              <a:t> </a:t>
            </a:r>
          </a:p>
          <a:p>
            <a:pPr algn="ctr"/>
            <a:r>
              <a:rPr lang="fr-FR" sz="1200" dirty="0"/>
              <a:t>Relative to MDA-MB-361 S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6A5D7385-B45E-AE43-8CB9-7D86718029CE}"/>
              </a:ext>
            </a:extLst>
          </p:cNvPr>
          <p:cNvSpPr txBox="1"/>
          <p:nvPr/>
        </p:nvSpPr>
        <p:spPr>
          <a:xfrm rot="16200000">
            <a:off x="-860133" y="4204424"/>
            <a:ext cx="21819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err="1"/>
              <a:t>mRNA</a:t>
            </a:r>
            <a:r>
              <a:rPr lang="fr-FR" sz="1200" dirty="0"/>
              <a:t> </a:t>
            </a:r>
            <a:r>
              <a:rPr lang="fr-FR" sz="1200" dirty="0" err="1"/>
              <a:t>level</a:t>
            </a:r>
            <a:r>
              <a:rPr lang="fr-FR" sz="1200" dirty="0"/>
              <a:t> </a:t>
            </a:r>
          </a:p>
          <a:p>
            <a:pPr algn="ctr"/>
            <a:r>
              <a:rPr lang="fr-FR" sz="1200" dirty="0"/>
              <a:t>Relative to MDA-MB-361 S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56C8250A-6706-204F-8291-D2C043FB9493}"/>
              </a:ext>
            </a:extLst>
          </p:cNvPr>
          <p:cNvSpPr txBox="1"/>
          <p:nvPr/>
        </p:nvSpPr>
        <p:spPr>
          <a:xfrm rot="16200000">
            <a:off x="2767650" y="4261836"/>
            <a:ext cx="21819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err="1"/>
              <a:t>mRNA</a:t>
            </a:r>
            <a:r>
              <a:rPr lang="fr-FR" sz="1200" dirty="0"/>
              <a:t> </a:t>
            </a:r>
            <a:r>
              <a:rPr lang="fr-FR" sz="1200" dirty="0" err="1"/>
              <a:t>level</a:t>
            </a:r>
            <a:r>
              <a:rPr lang="fr-FR" sz="1200" dirty="0"/>
              <a:t> </a:t>
            </a:r>
          </a:p>
          <a:p>
            <a:pPr algn="ctr"/>
            <a:r>
              <a:rPr lang="fr-FR" sz="1200" dirty="0"/>
              <a:t>Relative to MDA-MB-361 S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444B483D-6456-7C43-AAE1-28B16248A494}"/>
              </a:ext>
            </a:extLst>
          </p:cNvPr>
          <p:cNvSpPr txBox="1"/>
          <p:nvPr/>
        </p:nvSpPr>
        <p:spPr>
          <a:xfrm rot="16200000">
            <a:off x="2919704" y="7143871"/>
            <a:ext cx="21819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err="1"/>
              <a:t>mRNA</a:t>
            </a:r>
            <a:r>
              <a:rPr lang="fr-FR" sz="1200" dirty="0"/>
              <a:t> </a:t>
            </a:r>
            <a:r>
              <a:rPr lang="fr-FR" sz="1200" dirty="0" err="1"/>
              <a:t>level</a:t>
            </a:r>
            <a:r>
              <a:rPr lang="fr-FR" sz="1200" dirty="0"/>
              <a:t> </a:t>
            </a:r>
          </a:p>
          <a:p>
            <a:pPr algn="ctr"/>
            <a:r>
              <a:rPr lang="fr-FR" sz="1200" dirty="0"/>
              <a:t>Relative to MDA-MB-361 S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18596BF9-2738-FE4E-88C4-CB31CA9899E2}"/>
              </a:ext>
            </a:extLst>
          </p:cNvPr>
          <p:cNvSpPr txBox="1"/>
          <p:nvPr/>
        </p:nvSpPr>
        <p:spPr>
          <a:xfrm>
            <a:off x="0" y="9786376"/>
            <a:ext cx="75596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Franklin Gothic Book" panose="020B0503020102020204" pitchFamily="34" charset="0"/>
                <a:ea typeface="Palatino" pitchFamily="2" charset="77"/>
              </a:rPr>
              <a:t>Figure S1 (A) </a:t>
            </a:r>
            <a:r>
              <a:rPr lang="fr-FR" sz="1200" dirty="0">
                <a:latin typeface="Franklin Gothic Book" panose="020B0503020102020204" pitchFamily="34" charset="0"/>
                <a:ea typeface="Palatino" pitchFamily="2" charset="77"/>
              </a:rPr>
              <a:t>MRP1 expression </a:t>
            </a:r>
            <a:r>
              <a:rPr lang="fr-FR" sz="1200" dirty="0" err="1">
                <a:latin typeface="Franklin Gothic Book" panose="020B0503020102020204" pitchFamily="34" charset="0"/>
                <a:ea typeface="Palatino" pitchFamily="2" charset="77"/>
              </a:rPr>
              <a:t>assessed</a:t>
            </a:r>
            <a:r>
              <a:rPr lang="fr-FR" sz="1200" dirty="0">
                <a:latin typeface="Franklin Gothic Book" panose="020B0503020102020204" pitchFamily="34" charset="0"/>
                <a:ea typeface="Palatino" pitchFamily="2" charset="77"/>
              </a:rPr>
              <a:t> by RT-</a:t>
            </a:r>
            <a:r>
              <a:rPr lang="fr-FR" sz="1200" dirty="0" err="1">
                <a:latin typeface="Franklin Gothic Book" panose="020B0503020102020204" pitchFamily="34" charset="0"/>
                <a:ea typeface="Palatino" pitchFamily="2" charset="77"/>
              </a:rPr>
              <a:t>qPCR</a:t>
            </a:r>
            <a:r>
              <a:rPr lang="en-US" sz="1200" b="1" dirty="0">
                <a:latin typeface="Franklin Gothic Book" panose="020B0503020102020204" pitchFamily="34" charset="0"/>
                <a:ea typeface="Palatino" pitchFamily="2" charset="77"/>
              </a:rPr>
              <a:t>. </a:t>
            </a:r>
            <a:r>
              <a:rPr lang="en-US" sz="1200" dirty="0">
                <a:latin typeface="Franklin Gothic Book" panose="020B0503020102020204" pitchFamily="34" charset="0"/>
                <a:ea typeface="Palatino" pitchFamily="2" charset="77"/>
              </a:rPr>
              <a:t>mRNA levels are normalized to the 28S gene and then compared to the parental cell line (MDA-MB-361 S) as the fold of each resistant cell line over the parental one. Data are shown as the fold of a single experiment including 3 technical replicates.</a:t>
            </a:r>
            <a:endParaRPr lang="fr-FR" sz="1200" dirty="0">
              <a:latin typeface="Franklin Gothic Book" panose="020B0503020102020204" pitchFamily="34" charset="0"/>
              <a:ea typeface="Palatino" pitchFamily="2" charset="77"/>
            </a:endParaRPr>
          </a:p>
        </p:txBody>
      </p:sp>
      <p:graphicFrame>
        <p:nvGraphicFramePr>
          <p:cNvPr id="15" name="Graphique 14">
            <a:extLst>
              <a:ext uri="{FF2B5EF4-FFF2-40B4-BE49-F238E27FC236}">
                <a16:creationId xmlns:a16="http://schemas.microsoft.com/office/drawing/2014/main" id="{F162BF05-43A2-4E4D-92EC-56A1B204D08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8644975"/>
              </p:ext>
            </p:extLst>
          </p:nvPr>
        </p:nvGraphicFramePr>
        <p:xfrm>
          <a:off x="4189264" y="5835252"/>
          <a:ext cx="3339427" cy="27685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6" name="ZoneTexte 15">
            <a:extLst>
              <a:ext uri="{FF2B5EF4-FFF2-40B4-BE49-F238E27FC236}">
                <a16:creationId xmlns:a16="http://schemas.microsoft.com/office/drawing/2014/main" id="{DFE8330D-6FD3-F04C-B9B3-C419B5A56BC5}"/>
              </a:ext>
            </a:extLst>
          </p:cNvPr>
          <p:cNvSpPr txBox="1"/>
          <p:nvPr/>
        </p:nvSpPr>
        <p:spPr>
          <a:xfrm rot="16200000">
            <a:off x="-849771" y="7018483"/>
            <a:ext cx="21819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err="1"/>
              <a:t>mRNA</a:t>
            </a:r>
            <a:r>
              <a:rPr lang="fr-FR" sz="1200" dirty="0"/>
              <a:t> </a:t>
            </a:r>
            <a:r>
              <a:rPr lang="fr-FR" sz="1200" dirty="0" err="1"/>
              <a:t>level</a:t>
            </a:r>
            <a:r>
              <a:rPr lang="fr-FR" sz="1200" dirty="0"/>
              <a:t> </a:t>
            </a:r>
          </a:p>
          <a:p>
            <a:pPr algn="ctr"/>
            <a:r>
              <a:rPr lang="fr-FR" sz="1200" dirty="0"/>
              <a:t>Relative to MDA-MB-361 S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63E95783-C5C6-3C41-A190-090DD56FCF32}"/>
              </a:ext>
            </a:extLst>
          </p:cNvPr>
          <p:cNvSpPr txBox="1"/>
          <p:nvPr/>
        </p:nvSpPr>
        <p:spPr>
          <a:xfrm>
            <a:off x="48729" y="0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(A)</a:t>
            </a:r>
          </a:p>
        </p:txBody>
      </p:sp>
    </p:spTree>
    <p:extLst>
      <p:ext uri="{BB962C8B-B14F-4D97-AF65-F5344CB8AC3E}">
        <p14:creationId xmlns:p14="http://schemas.microsoft.com/office/powerpoint/2010/main" val="21200968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>
            <a:extLst>
              <a:ext uri="{FF2B5EF4-FFF2-40B4-BE49-F238E27FC236}">
                <a16:creationId xmlns:a16="http://schemas.microsoft.com/office/drawing/2014/main" id="{67F10A39-A1FF-6E4A-94D2-8124D87F98D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1004382"/>
              </p:ext>
            </p:extLst>
          </p:nvPr>
        </p:nvGraphicFramePr>
        <p:xfrm>
          <a:off x="614350" y="217548"/>
          <a:ext cx="3153697" cy="27685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phique 4">
            <a:extLst>
              <a:ext uri="{FF2B5EF4-FFF2-40B4-BE49-F238E27FC236}">
                <a16:creationId xmlns:a16="http://schemas.microsoft.com/office/drawing/2014/main" id="{9895182D-F2C0-8D4B-8345-331A6B5F3B5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2052808"/>
              </p:ext>
            </p:extLst>
          </p:nvPr>
        </p:nvGraphicFramePr>
        <p:xfrm>
          <a:off x="626140" y="3113147"/>
          <a:ext cx="3153697" cy="285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Graphique 5">
            <a:extLst>
              <a:ext uri="{FF2B5EF4-FFF2-40B4-BE49-F238E27FC236}">
                <a16:creationId xmlns:a16="http://schemas.microsoft.com/office/drawing/2014/main" id="{6CE81017-E36C-C14E-B671-CC4EEB455A5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89877877"/>
              </p:ext>
            </p:extLst>
          </p:nvPr>
        </p:nvGraphicFramePr>
        <p:xfrm>
          <a:off x="4295997" y="220626"/>
          <a:ext cx="3153697" cy="27685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Graphique 6">
            <a:extLst>
              <a:ext uri="{FF2B5EF4-FFF2-40B4-BE49-F238E27FC236}">
                <a16:creationId xmlns:a16="http://schemas.microsoft.com/office/drawing/2014/main" id="{C8DD424F-27C0-854A-8761-735A532A387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7945340"/>
              </p:ext>
            </p:extLst>
          </p:nvPr>
        </p:nvGraphicFramePr>
        <p:xfrm>
          <a:off x="4295998" y="3116225"/>
          <a:ext cx="3153697" cy="285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" name="ZoneTexte 7">
            <a:extLst>
              <a:ext uri="{FF2B5EF4-FFF2-40B4-BE49-F238E27FC236}">
                <a16:creationId xmlns:a16="http://schemas.microsoft.com/office/drawing/2014/main" id="{E96EAAB5-2E0C-6F41-B2CD-F7267B89CECD}"/>
              </a:ext>
            </a:extLst>
          </p:cNvPr>
          <p:cNvSpPr txBox="1"/>
          <p:nvPr/>
        </p:nvSpPr>
        <p:spPr>
          <a:xfrm>
            <a:off x="60096" y="9812492"/>
            <a:ext cx="749958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Franklin Gothic Book" panose="020B0503020102020204" pitchFamily="34" charset="0"/>
                <a:ea typeface="Palatino" pitchFamily="2" charset="77"/>
              </a:rPr>
              <a:t>Figure S1 (B) </a:t>
            </a:r>
            <a:r>
              <a:rPr lang="fr-FR" sz="1200" dirty="0">
                <a:latin typeface="Franklin Gothic Book" panose="020B0503020102020204" pitchFamily="34" charset="0"/>
                <a:ea typeface="Palatino" pitchFamily="2" charset="77"/>
              </a:rPr>
              <a:t>MVP/LRP expression </a:t>
            </a:r>
            <a:r>
              <a:rPr lang="fr-FR" sz="1200" dirty="0" err="1">
                <a:latin typeface="Franklin Gothic Book" panose="020B0503020102020204" pitchFamily="34" charset="0"/>
                <a:ea typeface="Palatino" pitchFamily="2" charset="77"/>
              </a:rPr>
              <a:t>assessed</a:t>
            </a:r>
            <a:r>
              <a:rPr lang="fr-FR" sz="1200" dirty="0">
                <a:latin typeface="Franklin Gothic Book" panose="020B0503020102020204" pitchFamily="34" charset="0"/>
                <a:ea typeface="Palatino" pitchFamily="2" charset="77"/>
              </a:rPr>
              <a:t> by RT-</a:t>
            </a:r>
            <a:r>
              <a:rPr lang="fr-FR" sz="1200" dirty="0" err="1">
                <a:latin typeface="Franklin Gothic Book" panose="020B0503020102020204" pitchFamily="34" charset="0"/>
                <a:ea typeface="Palatino" pitchFamily="2" charset="77"/>
              </a:rPr>
              <a:t>qPCR</a:t>
            </a:r>
            <a:r>
              <a:rPr lang="en-US" sz="1200" b="1" dirty="0">
                <a:latin typeface="Franklin Gothic Book" panose="020B0503020102020204" pitchFamily="34" charset="0"/>
                <a:ea typeface="Palatino" pitchFamily="2" charset="77"/>
              </a:rPr>
              <a:t>. </a:t>
            </a:r>
            <a:r>
              <a:rPr lang="en-US" sz="1200" dirty="0">
                <a:latin typeface="Franklin Gothic Book" panose="020B0503020102020204" pitchFamily="34" charset="0"/>
                <a:ea typeface="Palatino" pitchFamily="2" charset="77"/>
              </a:rPr>
              <a:t>mRNA levels are normalized to the 28S gene and then compared to the parental cell line (MDA-MB-361 S) as the fold of each resistant cell line over the parental one. Data are shown as the fold of a single experiment including 3 technical replicates. (</a:t>
            </a:r>
            <a:r>
              <a:rPr lang="en-US" sz="1200" b="1" dirty="0">
                <a:latin typeface="Franklin Gothic Book" panose="020B0503020102020204" pitchFamily="34" charset="0"/>
                <a:ea typeface="Palatino" pitchFamily="2" charset="77"/>
              </a:rPr>
              <a:t>C) </a:t>
            </a:r>
            <a:r>
              <a:rPr lang="en-US" sz="1200" dirty="0">
                <a:latin typeface="Franklin Gothic Book" panose="020B0503020102020204" pitchFamily="34" charset="0"/>
                <a:ea typeface="Palatino" pitchFamily="2" charset="77"/>
              </a:rPr>
              <a:t>MVP/LRP expression assessed by Western Blot. </a:t>
            </a:r>
            <a:endParaRPr lang="fr-FR" sz="1200" dirty="0">
              <a:latin typeface="Franklin Gothic Book" panose="020B0503020102020204" pitchFamily="34" charset="0"/>
              <a:ea typeface="Palatino" pitchFamily="2" charset="77"/>
            </a:endParaRPr>
          </a:p>
        </p:txBody>
      </p:sp>
      <p:pic>
        <p:nvPicPr>
          <p:cNvPr id="9" name="Image 8">
            <a:extLst>
              <a:ext uri="{FF2B5EF4-FFF2-40B4-BE49-F238E27FC236}">
                <a16:creationId xmlns:a16="http://schemas.microsoft.com/office/drawing/2014/main" id="{3C7C7925-B7EE-014B-97BE-F9F635F9663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19711" y="9022919"/>
            <a:ext cx="1552575" cy="40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7FF2FA75-B945-F045-9701-BB7552E413F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794" t="15306" r="1"/>
          <a:stretch/>
        </p:blipFill>
        <p:spPr>
          <a:xfrm>
            <a:off x="3526061" y="8273620"/>
            <a:ext cx="1546225" cy="39528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ZoneTexte 10">
            <a:extLst>
              <a:ext uri="{FF2B5EF4-FFF2-40B4-BE49-F238E27FC236}">
                <a16:creationId xmlns:a16="http://schemas.microsoft.com/office/drawing/2014/main" id="{7CBADF8D-1C8D-1444-8521-A86B4565567C}"/>
              </a:ext>
            </a:extLst>
          </p:cNvPr>
          <p:cNvSpPr txBox="1"/>
          <p:nvPr/>
        </p:nvSpPr>
        <p:spPr>
          <a:xfrm>
            <a:off x="1566291" y="8273620"/>
            <a:ext cx="1953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MVP/LRP (110kDa)</a:t>
            </a:r>
            <a:endParaRPr lang="en-GB" dirty="0"/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A2D05EB9-9DBB-2C4F-9F47-947D86566BD8}"/>
              </a:ext>
            </a:extLst>
          </p:cNvPr>
          <p:cNvSpPr txBox="1"/>
          <p:nvPr/>
        </p:nvSpPr>
        <p:spPr>
          <a:xfrm>
            <a:off x="2328291" y="9022919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Actin</a:t>
            </a:r>
            <a:endParaRPr lang="en-GB" dirty="0"/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B12F2342-755B-714C-97C8-18875C6B8631}"/>
              </a:ext>
            </a:extLst>
          </p:cNvPr>
          <p:cNvSpPr txBox="1"/>
          <p:nvPr/>
        </p:nvSpPr>
        <p:spPr>
          <a:xfrm>
            <a:off x="3528861" y="6530670"/>
            <a:ext cx="461665" cy="153484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FR" dirty="0"/>
              <a:t>MDA-MB-361 S</a:t>
            </a:r>
            <a:endParaRPr lang="en-GB" dirty="0"/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92BA5B7B-3662-5449-AAC6-CC284917DCE9}"/>
              </a:ext>
            </a:extLst>
          </p:cNvPr>
          <p:cNvSpPr txBox="1"/>
          <p:nvPr/>
        </p:nvSpPr>
        <p:spPr>
          <a:xfrm>
            <a:off x="4065165" y="6402398"/>
            <a:ext cx="461665" cy="166629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FR" dirty="0"/>
              <a:t>MDA-MB-361 TR</a:t>
            </a:r>
            <a:endParaRPr lang="en-GB" dirty="0"/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6361DD89-7F7A-8740-B2AA-8FDFFC68A5A8}"/>
              </a:ext>
            </a:extLst>
          </p:cNvPr>
          <p:cNvSpPr txBox="1"/>
          <p:nvPr/>
        </p:nvSpPr>
        <p:spPr>
          <a:xfrm>
            <a:off x="4559821" y="6280538"/>
            <a:ext cx="461665" cy="1784976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FR" dirty="0"/>
              <a:t>MDA-MB-361 TCR</a:t>
            </a:r>
            <a:endParaRPr lang="en-GB" dirty="0"/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089FA42F-C403-6B48-8BD4-A3CF7845F3D2}"/>
              </a:ext>
            </a:extLst>
          </p:cNvPr>
          <p:cNvSpPr txBox="1"/>
          <p:nvPr/>
        </p:nvSpPr>
        <p:spPr>
          <a:xfrm>
            <a:off x="290715" y="217548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(B)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E982A976-F26F-6D48-BE52-7DE10DEE91CA}"/>
              </a:ext>
            </a:extLst>
          </p:cNvPr>
          <p:cNvSpPr txBox="1"/>
          <p:nvPr/>
        </p:nvSpPr>
        <p:spPr>
          <a:xfrm>
            <a:off x="1732119" y="6142621"/>
            <a:ext cx="449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(C)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234515DC-4419-034A-8D64-CA537EE88B26}"/>
              </a:ext>
            </a:extLst>
          </p:cNvPr>
          <p:cNvSpPr txBox="1"/>
          <p:nvPr/>
        </p:nvSpPr>
        <p:spPr>
          <a:xfrm rot="16200000">
            <a:off x="-694091" y="1447014"/>
            <a:ext cx="21819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err="1"/>
              <a:t>mRNA</a:t>
            </a:r>
            <a:r>
              <a:rPr lang="fr-FR" sz="1200" dirty="0"/>
              <a:t> </a:t>
            </a:r>
            <a:r>
              <a:rPr lang="fr-FR" sz="1200" dirty="0" err="1"/>
              <a:t>level</a:t>
            </a:r>
            <a:r>
              <a:rPr lang="fr-FR" sz="1200" dirty="0"/>
              <a:t> </a:t>
            </a:r>
          </a:p>
          <a:p>
            <a:pPr algn="ctr"/>
            <a:r>
              <a:rPr lang="fr-FR" sz="1200" dirty="0"/>
              <a:t>Relative to MDA-MB-361 S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C70F04F6-B123-AE47-93E2-4F03176245A3}"/>
              </a:ext>
            </a:extLst>
          </p:cNvPr>
          <p:cNvSpPr txBox="1"/>
          <p:nvPr/>
        </p:nvSpPr>
        <p:spPr>
          <a:xfrm rot="16200000">
            <a:off x="2974155" y="1371015"/>
            <a:ext cx="21819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err="1"/>
              <a:t>mRNA</a:t>
            </a:r>
            <a:r>
              <a:rPr lang="fr-FR" sz="1200" dirty="0"/>
              <a:t> </a:t>
            </a:r>
            <a:r>
              <a:rPr lang="fr-FR" sz="1200" dirty="0" err="1"/>
              <a:t>level</a:t>
            </a:r>
            <a:r>
              <a:rPr lang="fr-FR" sz="1200" dirty="0"/>
              <a:t> </a:t>
            </a:r>
          </a:p>
          <a:p>
            <a:pPr algn="ctr"/>
            <a:r>
              <a:rPr lang="fr-FR" sz="1200" dirty="0"/>
              <a:t>Relative to MDA-MB-361 S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82058669-650E-7244-A66D-F9AE75F452AC}"/>
              </a:ext>
            </a:extLst>
          </p:cNvPr>
          <p:cNvSpPr txBox="1"/>
          <p:nvPr/>
        </p:nvSpPr>
        <p:spPr>
          <a:xfrm rot="16200000">
            <a:off x="2974155" y="4378915"/>
            <a:ext cx="21819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err="1"/>
              <a:t>mRNA</a:t>
            </a:r>
            <a:r>
              <a:rPr lang="fr-FR" sz="1200" dirty="0"/>
              <a:t> </a:t>
            </a:r>
            <a:r>
              <a:rPr lang="fr-FR" sz="1200" dirty="0" err="1"/>
              <a:t>level</a:t>
            </a:r>
            <a:r>
              <a:rPr lang="fr-FR" sz="1200" dirty="0"/>
              <a:t> </a:t>
            </a:r>
          </a:p>
          <a:p>
            <a:pPr algn="ctr"/>
            <a:r>
              <a:rPr lang="fr-FR" sz="1200" dirty="0"/>
              <a:t>Relative to MDA-MB-361 S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EA75BF2F-DD28-5446-B442-A1FEA43D7607}"/>
              </a:ext>
            </a:extLst>
          </p:cNvPr>
          <p:cNvSpPr txBox="1"/>
          <p:nvPr/>
        </p:nvSpPr>
        <p:spPr>
          <a:xfrm rot="16200000">
            <a:off x="-694092" y="4311064"/>
            <a:ext cx="21819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err="1"/>
              <a:t>mRNA</a:t>
            </a:r>
            <a:r>
              <a:rPr lang="fr-FR" sz="1200" dirty="0"/>
              <a:t> </a:t>
            </a:r>
            <a:r>
              <a:rPr lang="fr-FR" sz="1200" dirty="0" err="1"/>
              <a:t>level</a:t>
            </a:r>
            <a:r>
              <a:rPr lang="fr-FR" sz="1200" dirty="0"/>
              <a:t> </a:t>
            </a:r>
          </a:p>
          <a:p>
            <a:pPr algn="ctr"/>
            <a:r>
              <a:rPr lang="fr-FR" sz="1200" dirty="0"/>
              <a:t>Relative to MDA-MB-361 S</a:t>
            </a:r>
          </a:p>
        </p:txBody>
      </p:sp>
    </p:spTree>
    <p:extLst>
      <p:ext uri="{BB962C8B-B14F-4D97-AF65-F5344CB8AC3E}">
        <p14:creationId xmlns:p14="http://schemas.microsoft.com/office/powerpoint/2010/main" val="14536028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ZoneTexte 53"/>
          <p:cNvSpPr txBox="1"/>
          <p:nvPr/>
        </p:nvSpPr>
        <p:spPr>
          <a:xfrm>
            <a:off x="124928" y="9280550"/>
            <a:ext cx="7434746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Franklin Gothic Book" panose="020B0503020102020204" pitchFamily="34" charset="0"/>
              </a:rPr>
              <a:t>Fig. S2. Adhesion genes’ heat map. </a:t>
            </a:r>
            <a:r>
              <a:rPr lang="en-US" sz="1050" dirty="0">
                <a:latin typeface="Franklin Gothic Book" panose="020B0503020102020204" pitchFamily="34" charset="0"/>
              </a:rPr>
              <a:t>Heat map were realized using </a:t>
            </a:r>
            <a:r>
              <a:rPr lang="en-US" sz="1050" dirty="0" err="1">
                <a:latin typeface="Franklin Gothic Book" panose="020B0503020102020204" pitchFamily="34" charset="0"/>
              </a:rPr>
              <a:t>RNAseq</a:t>
            </a:r>
            <a:r>
              <a:rPr lang="en-US" sz="1050" dirty="0">
                <a:latin typeface="Franklin Gothic Book" panose="020B0503020102020204" pitchFamily="34" charset="0"/>
              </a:rPr>
              <a:t> expression data with the </a:t>
            </a:r>
            <a:r>
              <a:rPr lang="en-US" sz="1050" dirty="0" err="1">
                <a:latin typeface="Franklin Gothic Book" panose="020B0503020102020204" pitchFamily="34" charset="0"/>
              </a:rPr>
              <a:t>XLstat</a:t>
            </a:r>
            <a:r>
              <a:rPr lang="en-US" sz="1050" dirty="0">
                <a:latin typeface="Franklin Gothic Book" panose="020B0503020102020204" pitchFamily="34" charset="0"/>
              </a:rPr>
              <a:t> software. Adhesion genes were selected from </a:t>
            </a:r>
            <a:r>
              <a:rPr lang="en-US" sz="1050" i="1" dirty="0">
                <a:latin typeface="Franklin Gothic Book" panose="020B0503020102020204" pitchFamily="34" charset="0"/>
              </a:rPr>
              <a:t>Human cell adhesion molecules: annotated functional subtypes and overrepresentation of addiction-associated genes, 2015 May.</a:t>
            </a:r>
            <a:endParaRPr lang="en-US" sz="1050" dirty="0">
              <a:latin typeface="Franklin Gothic Book" panose="020B0503020102020204" pitchFamily="34" charset="0"/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837958" y="819149"/>
            <a:ext cx="6008687" cy="838200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fr-FR" sz="1100"/>
          </a:p>
        </p:txBody>
      </p:sp>
      <p:graphicFrame>
        <p:nvGraphicFramePr>
          <p:cNvPr id="60" name="Chart 3-XLSTAT"/>
          <p:cNvGraphicFramePr/>
          <p:nvPr>
            <p:extLst>
              <p:ext uri="{D42A27DB-BD31-4B8C-83A1-F6EECF244321}">
                <p14:modId xmlns:p14="http://schemas.microsoft.com/office/powerpoint/2010/main" val="3524481521"/>
              </p:ext>
            </p:extLst>
          </p:nvPr>
        </p:nvGraphicFramePr>
        <p:xfrm>
          <a:off x="2019995" y="819150"/>
          <a:ext cx="2758086" cy="3853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1" name="Chart 9-XLSTAT"/>
          <p:cNvGraphicFramePr/>
          <p:nvPr>
            <p:extLst>
              <p:ext uri="{D42A27DB-BD31-4B8C-83A1-F6EECF244321}">
                <p14:modId xmlns:p14="http://schemas.microsoft.com/office/powerpoint/2010/main" val="1679291955"/>
              </p:ext>
            </p:extLst>
          </p:nvPr>
        </p:nvGraphicFramePr>
        <p:xfrm>
          <a:off x="837958" y="1204494"/>
          <a:ext cx="1182037" cy="71741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2" name="Graphique 61"/>
          <p:cNvGraphicFramePr/>
          <p:nvPr>
            <p:extLst>
              <p:ext uri="{D42A27DB-BD31-4B8C-83A1-F6EECF244321}">
                <p14:modId xmlns:p14="http://schemas.microsoft.com/office/powerpoint/2010/main" val="2754936043"/>
              </p:ext>
            </p:extLst>
          </p:nvPr>
        </p:nvGraphicFramePr>
        <p:xfrm>
          <a:off x="2019995" y="1204494"/>
          <a:ext cx="3290002" cy="75394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63" name="Groupe 62"/>
          <p:cNvGrpSpPr/>
          <p:nvPr/>
        </p:nvGrpSpPr>
        <p:grpSpPr>
          <a:xfrm>
            <a:off x="5566105" y="1287984"/>
            <a:ext cx="1182037" cy="1493316"/>
            <a:chOff x="6096000" y="927100"/>
            <a:chExt cx="1524000" cy="2133600"/>
          </a:xfrm>
        </p:grpSpPr>
        <p:grpSp>
          <p:nvGrpSpPr>
            <p:cNvPr id="64" name="Groupe 63"/>
            <p:cNvGrpSpPr/>
            <p:nvPr/>
          </p:nvGrpSpPr>
          <p:grpSpPr>
            <a:xfrm>
              <a:off x="6096000" y="927100"/>
              <a:ext cx="1524000" cy="2133600"/>
              <a:chOff x="6096000" y="927100"/>
              <a:chExt cx="1524000" cy="2133600"/>
            </a:xfrm>
          </p:grpSpPr>
          <p:grpSp>
            <p:nvGrpSpPr>
              <p:cNvPr id="66" name="Groupe 65"/>
              <p:cNvGrpSpPr/>
              <p:nvPr/>
            </p:nvGrpSpPr>
            <p:grpSpPr>
              <a:xfrm>
                <a:off x="6096000" y="927100"/>
                <a:ext cx="1524000" cy="2133600"/>
                <a:chOff x="6096000" y="927100"/>
                <a:chExt cx="1524000" cy="2133600"/>
              </a:xfrm>
            </p:grpSpPr>
            <p:grpSp>
              <p:nvGrpSpPr>
                <p:cNvPr id="68" name="Groupe 67"/>
                <p:cNvGrpSpPr/>
                <p:nvPr/>
              </p:nvGrpSpPr>
              <p:grpSpPr>
                <a:xfrm>
                  <a:off x="6096000" y="927100"/>
                  <a:ext cx="1524000" cy="2133600"/>
                  <a:chOff x="6096000" y="927100"/>
                  <a:chExt cx="1524000" cy="2133600"/>
                </a:xfrm>
              </p:grpSpPr>
              <p:grpSp>
                <p:nvGrpSpPr>
                  <p:cNvPr id="70" name="Groupe 69"/>
                  <p:cNvGrpSpPr/>
                  <p:nvPr/>
                </p:nvGrpSpPr>
                <p:grpSpPr>
                  <a:xfrm>
                    <a:off x="6096000" y="927100"/>
                    <a:ext cx="1524000" cy="2133600"/>
                    <a:chOff x="6096000" y="927100"/>
                    <a:chExt cx="1524000" cy="2133600"/>
                  </a:xfrm>
                </p:grpSpPr>
                <p:grpSp>
                  <p:nvGrpSpPr>
                    <p:cNvPr id="72" name="Groupe 71"/>
                    <p:cNvGrpSpPr/>
                    <p:nvPr/>
                  </p:nvGrpSpPr>
                  <p:grpSpPr>
                    <a:xfrm>
                      <a:off x="6096000" y="927100"/>
                      <a:ext cx="1524000" cy="2133600"/>
                      <a:chOff x="6096000" y="927100"/>
                      <a:chExt cx="1524000" cy="2133600"/>
                    </a:xfrm>
                  </p:grpSpPr>
                  <p:grpSp>
                    <p:nvGrpSpPr>
                      <p:cNvPr id="74" name="Groupe 73"/>
                      <p:cNvGrpSpPr/>
                      <p:nvPr/>
                    </p:nvGrpSpPr>
                    <p:grpSpPr>
                      <a:xfrm>
                        <a:off x="6096000" y="927100"/>
                        <a:ext cx="1524000" cy="2133600"/>
                        <a:chOff x="6096000" y="927100"/>
                        <a:chExt cx="1524000" cy="2133600"/>
                      </a:xfrm>
                    </p:grpSpPr>
                    <p:grpSp>
                      <p:nvGrpSpPr>
                        <p:cNvPr id="76" name="Groupe 75"/>
                        <p:cNvGrpSpPr/>
                        <p:nvPr/>
                      </p:nvGrpSpPr>
                      <p:grpSpPr>
                        <a:xfrm>
                          <a:off x="6096000" y="927100"/>
                          <a:ext cx="1524000" cy="2133600"/>
                          <a:chOff x="6096000" y="927100"/>
                          <a:chExt cx="1524000" cy="2133600"/>
                        </a:xfrm>
                      </p:grpSpPr>
                      <p:grpSp>
                        <p:nvGrpSpPr>
                          <p:cNvPr id="78" name="Groupe 77"/>
                          <p:cNvGrpSpPr/>
                          <p:nvPr/>
                        </p:nvGrpSpPr>
                        <p:grpSpPr>
                          <a:xfrm>
                            <a:off x="6096000" y="927100"/>
                            <a:ext cx="1524000" cy="2133600"/>
                            <a:chOff x="6096000" y="927100"/>
                            <a:chExt cx="1524000" cy="2133600"/>
                          </a:xfrm>
                        </p:grpSpPr>
                        <p:grpSp>
                          <p:nvGrpSpPr>
                            <p:cNvPr id="80" name="Groupe 79"/>
                            <p:cNvGrpSpPr/>
                            <p:nvPr/>
                          </p:nvGrpSpPr>
                          <p:grpSpPr>
                            <a:xfrm>
                              <a:off x="6096000" y="927100"/>
                              <a:ext cx="1524000" cy="2133600"/>
                              <a:chOff x="6096000" y="927100"/>
                              <a:chExt cx="1524000" cy="2133600"/>
                            </a:xfrm>
                          </p:grpSpPr>
                          <p:grpSp>
                            <p:nvGrpSpPr>
                              <p:cNvPr id="82" name="Groupe 81"/>
                              <p:cNvGrpSpPr/>
                              <p:nvPr/>
                            </p:nvGrpSpPr>
                            <p:grpSpPr>
                              <a:xfrm>
                                <a:off x="6096000" y="927100"/>
                                <a:ext cx="1524000" cy="2133600"/>
                                <a:chOff x="6096000" y="927100"/>
                                <a:chExt cx="1524000" cy="2133600"/>
                              </a:xfrm>
                            </p:grpSpPr>
                            <p:grpSp>
                              <p:nvGrpSpPr>
                                <p:cNvPr id="84" name="Groupe 83"/>
                                <p:cNvGrpSpPr/>
                                <p:nvPr/>
                              </p:nvGrpSpPr>
                              <p:grpSpPr>
                                <a:xfrm>
                                  <a:off x="6096000" y="927100"/>
                                  <a:ext cx="1524000" cy="2133600"/>
                                  <a:chOff x="6096000" y="927100"/>
                                  <a:chExt cx="1524000" cy="2133600"/>
                                </a:xfrm>
                              </p:grpSpPr>
                              <p:grpSp>
                                <p:nvGrpSpPr>
                                  <p:cNvPr id="86" name="Groupe 85"/>
                                  <p:cNvGrpSpPr/>
                                  <p:nvPr/>
                                </p:nvGrpSpPr>
                                <p:grpSpPr>
                                  <a:xfrm>
                                    <a:off x="6096000" y="927100"/>
                                    <a:ext cx="1524000" cy="2133600"/>
                                    <a:chOff x="6096000" y="927100"/>
                                    <a:chExt cx="1524000" cy="2133600"/>
                                  </a:xfrm>
                                </p:grpSpPr>
                                <p:grpSp>
                                  <p:nvGrpSpPr>
                                    <p:cNvPr id="88" name="Groupe 87"/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6096000" y="927100"/>
                                      <a:ext cx="1524000" cy="2133600"/>
                                      <a:chOff x="6096000" y="927100"/>
                                      <a:chExt cx="1524000" cy="2133600"/>
                                    </a:xfrm>
                                  </p:grpSpPr>
                                  <p:grpSp>
                                    <p:nvGrpSpPr>
                                      <p:cNvPr id="90" name="Groupe 89"/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6096000" y="927100"/>
                                        <a:ext cx="1524000" cy="2133600"/>
                                        <a:chOff x="6096000" y="927100"/>
                                        <a:chExt cx="1524000" cy="2133600"/>
                                      </a:xfrm>
                                    </p:grpSpPr>
                                    <p:grpSp>
                                      <p:nvGrpSpPr>
                                        <p:cNvPr id="92" name="Groupe 91"/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6096000" y="927100"/>
                                          <a:ext cx="1524000" cy="2133600"/>
                                          <a:chOff x="6096000" y="927100"/>
                                          <a:chExt cx="1524000" cy="2133600"/>
                                        </a:xfrm>
                                      </p:grpSpPr>
                                      <p:grpSp>
                                        <p:nvGrpSpPr>
                                          <p:cNvPr id="94" name="Groupe 93"/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6096000" y="927100"/>
                                            <a:ext cx="1524000" cy="2133600"/>
                                            <a:chOff x="6096000" y="927100"/>
                                            <a:chExt cx="1524000" cy="2133600"/>
                                          </a:xfrm>
                                        </p:grpSpPr>
                                        <p:grpSp>
                                          <p:nvGrpSpPr>
                                            <p:cNvPr id="96" name="Groupe 95"/>
                                            <p:cNvGrpSpPr/>
                                            <p:nvPr/>
                                          </p:nvGrpSpPr>
                                          <p:grpSpPr>
                                            <a:xfrm>
                                              <a:off x="6096000" y="927100"/>
                                              <a:ext cx="1524000" cy="2133600"/>
                                              <a:chOff x="6096000" y="927100"/>
                                              <a:chExt cx="1524000" cy="2133600"/>
                                            </a:xfrm>
                                          </p:grpSpPr>
                                          <p:grpSp>
                                            <p:nvGrpSpPr>
                                              <p:cNvPr id="98" name="Groupe 97"/>
                                              <p:cNvGrpSpPr/>
                                              <p:nvPr/>
                                            </p:nvGrpSpPr>
                                            <p:grpSpPr>
                                              <a:xfrm>
                                                <a:off x="6096000" y="927100"/>
                                                <a:ext cx="1524000" cy="2133600"/>
                                                <a:chOff x="6096000" y="927100"/>
                                                <a:chExt cx="1524000" cy="2133600"/>
                                              </a:xfrm>
                                            </p:grpSpPr>
                                            <p:grpSp>
                                              <p:nvGrpSpPr>
                                                <p:cNvPr id="100" name="Groupe 99"/>
                                                <p:cNvGrpSpPr/>
                                                <p:nvPr/>
                                              </p:nvGrpSpPr>
                                              <p:grpSpPr>
                                                <a:xfrm>
                                                  <a:off x="6096000" y="927100"/>
                                                  <a:ext cx="1524000" cy="2133600"/>
                                                  <a:chOff x="6096000" y="927100"/>
                                                  <a:chExt cx="1524000" cy="2133600"/>
                                                </a:xfrm>
                                              </p:grpSpPr>
                                              <p:grpSp>
                                                <p:nvGrpSpPr>
                                                  <p:cNvPr id="102" name="Groupe 101"/>
                                                  <p:cNvGrpSpPr/>
                                                  <p:nvPr/>
                                                </p:nvGrpSpPr>
                                                <p:grpSpPr>
                                                  <a:xfrm>
                                                    <a:off x="6096000" y="927100"/>
                                                    <a:ext cx="1524000" cy="2133600"/>
                                                    <a:chOff x="6096000" y="927100"/>
                                                    <a:chExt cx="1524000" cy="2133600"/>
                                                  </a:xfrm>
                                                </p:grpSpPr>
                                                <p:grpSp>
                                                  <p:nvGrpSpPr>
                                                    <p:cNvPr id="104" name="Groupe 103"/>
                                                    <p:cNvGrpSpPr/>
                                                    <p:nvPr/>
                                                  </p:nvGrpSpPr>
                                                  <p:grpSpPr>
                                                    <a:xfrm>
                                                      <a:off x="6096000" y="927100"/>
                                                      <a:ext cx="1524000" cy="2133600"/>
                                                      <a:chOff x="6096000" y="927100"/>
                                                      <a:chExt cx="1524000" cy="2133600"/>
                                                    </a:xfrm>
                                                  </p:grpSpPr>
                                                  <p:sp>
                                                    <p:nvSpPr>
                                                      <p:cNvPr id="106" name="Rectangle 105"/>
                                                      <p:cNvSpPr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6096000" y="952500"/>
                                                        <a:ext cx="1524000" cy="2108200"/>
                                                      </a:xfrm>
                                                      <a:prstGeom prst="rect">
                                                        <a:avLst/>
                                                      </a:prstGeom>
                                                      <a:solidFill>
                                                        <a:srgbClr val="FFFFFF"/>
                                                      </a:solidFill>
                                                      <a:ln w="6350">
                                                        <a:solidFill>
                                                          <a:srgbClr val="000000"/>
                                                        </a:solidFill>
                                                      </a:ln>
                                                    </p:spPr>
                                                    <p:style>
                                                      <a:lnRef idx="2">
                                                        <a:schemeClr val="accent1">
                                                          <a:shade val="50000"/>
                                                        </a:schemeClr>
                                                      </a:lnRef>
                                                      <a:fillRef idx="1">
                                                        <a:schemeClr val="accent1"/>
                                                      </a:fillRef>
                                                      <a:effectRef idx="0">
                                                        <a:schemeClr val="accent1"/>
                                                      </a:effectRef>
                                                      <a:fontRef idx="minor">
                                                        <a:schemeClr val="lt1"/>
                                                      </a:fontRef>
                                                    </p:style>
                                                    <p:txBody>
                                                      <a:bodyPr rtlCol="0" anchor="t"/>
                                                      <a:lstStyle>
                                                        <a:lvl1pPr marL="0" indent="0">
                                                          <a:defRPr sz="1100">
                                                            <a:solidFill>
                                                              <a:schemeClr val="lt1"/>
                                                            </a:solidFill>
                                                            <a:latin typeface="+mn-lt"/>
                                                            <a:ea typeface="+mn-ea"/>
                                                            <a:cs typeface="+mn-cs"/>
                                                          </a:defRPr>
                                                        </a:lvl1pPr>
                                                        <a:lvl2pPr marL="457200" indent="0">
                                                          <a:defRPr sz="1100">
                                                            <a:solidFill>
                                                              <a:schemeClr val="lt1"/>
                                                            </a:solidFill>
                                                            <a:latin typeface="+mn-lt"/>
                                                            <a:ea typeface="+mn-ea"/>
                                                            <a:cs typeface="+mn-cs"/>
                                                          </a:defRPr>
                                                        </a:lvl2pPr>
                                                        <a:lvl3pPr marL="914400" indent="0">
                                                          <a:defRPr sz="1100">
                                                            <a:solidFill>
                                                              <a:schemeClr val="lt1"/>
                                                            </a:solidFill>
                                                            <a:latin typeface="+mn-lt"/>
                                                            <a:ea typeface="+mn-ea"/>
                                                            <a:cs typeface="+mn-cs"/>
                                                          </a:defRPr>
                                                        </a:lvl3pPr>
                                                        <a:lvl4pPr marL="1371600" indent="0">
                                                          <a:defRPr sz="1100">
                                                            <a:solidFill>
                                                              <a:schemeClr val="lt1"/>
                                                            </a:solidFill>
                                                            <a:latin typeface="+mn-lt"/>
                                                            <a:ea typeface="+mn-ea"/>
                                                            <a:cs typeface="+mn-cs"/>
                                                          </a:defRPr>
                                                        </a:lvl4pPr>
                                                        <a:lvl5pPr marL="1828800" indent="0">
                                                          <a:defRPr sz="1100">
                                                            <a:solidFill>
                                                              <a:schemeClr val="lt1"/>
                                                            </a:solidFill>
                                                            <a:latin typeface="+mn-lt"/>
                                                            <a:ea typeface="+mn-ea"/>
                                                            <a:cs typeface="+mn-cs"/>
                                                          </a:defRPr>
                                                        </a:lvl5pPr>
                                                        <a:lvl6pPr marL="2286000" indent="0">
                                                          <a:defRPr sz="1100">
                                                            <a:solidFill>
                                                              <a:schemeClr val="lt1"/>
                                                            </a:solidFill>
                                                            <a:latin typeface="+mn-lt"/>
                                                            <a:ea typeface="+mn-ea"/>
                                                            <a:cs typeface="+mn-cs"/>
                                                          </a:defRPr>
                                                        </a:lvl6pPr>
                                                        <a:lvl7pPr marL="2743200" indent="0">
                                                          <a:defRPr sz="1100">
                                                            <a:solidFill>
                                                              <a:schemeClr val="lt1"/>
                                                            </a:solidFill>
                                                            <a:latin typeface="+mn-lt"/>
                                                            <a:ea typeface="+mn-ea"/>
                                                            <a:cs typeface="+mn-cs"/>
                                                          </a:defRPr>
                                                        </a:lvl7pPr>
                                                        <a:lvl8pPr marL="3200400" indent="0">
                                                          <a:defRPr sz="1100">
                                                            <a:solidFill>
                                                              <a:schemeClr val="lt1"/>
                                                            </a:solidFill>
                                                            <a:latin typeface="+mn-lt"/>
                                                            <a:ea typeface="+mn-ea"/>
                                                            <a:cs typeface="+mn-cs"/>
                                                          </a:defRPr>
                                                        </a:lvl8pPr>
                                                        <a:lvl9pPr marL="3657600" indent="0">
                                                          <a:defRPr sz="1100">
                                                            <a:solidFill>
                                                              <a:schemeClr val="lt1"/>
                                                            </a:solidFill>
                                                            <a:latin typeface="+mn-lt"/>
                                                            <a:ea typeface="+mn-ea"/>
                                                            <a:cs typeface="+mn-cs"/>
                                                          </a:defRPr>
                                                        </a:lvl9pPr>
                                                      </a:lstStyle>
                                                      <a:p>
                                                        <a:pPr algn="l"/>
                                                        <a:endParaRPr lang="fr-FR" sz="1100"/>
                                                      </a:p>
                                                    </p:txBody>
                                                  </p:sp>
                                                  <p:sp>
                                                    <p:nvSpPr>
                                                      <p:cNvPr id="107" name="ZoneTexte 12"/>
                                                      <p:cNvSpPr txBox="1"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6096000" y="927100"/>
                                                        <a:ext cx="914400" cy="177800"/>
                                                      </a:xfrm>
                                                      <a:prstGeom prst="rect">
                                                        <a:avLst/>
                                                      </a:prstGeom>
                                                      <a:noFill/>
                                                      <a:ln w="9525" cmpd="sng">
                                                        <a:noFill/>
                                                      </a:ln>
                                                      <a:effectLst/>
                                                      <a:extLst>
                                                        <a:ext uri="{909E8E84-426E-40DD-AFC4-6F175D3DCCD1}">
                                                          <a14:hiddenFill xmlns:a14="http://schemas.microsoft.com/office/drawing/2010/main">
                                                            <a:solidFill>
                                                              <a:schemeClr val="lt1"/>
                                                            </a:solidFill>
                                                          </a14:hiddenFill>
                                                        </a:ext>
                                                        <a:ext uri="{91240B29-F687-4F45-9708-019B960494DF}">
                                                          <a14:hiddenLine xmlns:a14="http://schemas.microsoft.com/office/drawing/2010/main" w="9525" cmpd="sng">
                                                            <a:solidFill>
                                                              <a:schemeClr val="lt1">
                                                                <a:shade val="50000"/>
                                                              </a:schemeClr>
                                                            </a:solidFill>
                                                          </a14:hiddenLine>
                                                        </a:ext>
                                                      </a:extLst>
                                                    </p:spPr>
                                                    <p:style>
                                                      <a:lnRef idx="0">
                                                        <a:scrgbClr r="0" g="0" b="0"/>
                                                      </a:lnRef>
                                                      <a:fillRef idx="0">
                                                        <a:scrgbClr r="0" g="0" b="0"/>
                                                      </a:fillRef>
                                                      <a:effectRef idx="0">
                                                        <a:scrgbClr r="0" g="0" b="0"/>
                                                      </a:effectRef>
                                                      <a:fontRef idx="minor">
                                                        <a:schemeClr val="dk1"/>
                                                      </a:fontRef>
                                                    </p:style>
                                                    <p:txBody>
                                                      <a:bodyPr vert="horz" rtlCol="0" anchor="t"/>
                                                      <a:lstStyle>
                                                        <a:lvl1pPr marL="0" indent="0">
                                                          <a:defRPr sz="1100">
                                                            <a:solidFill>
                                                              <a:schemeClr val="dk1"/>
                                                            </a:solidFill>
                                                            <a:latin typeface="+mn-lt"/>
                                                            <a:ea typeface="+mn-ea"/>
                                                            <a:cs typeface="+mn-cs"/>
                                                          </a:defRPr>
                                                        </a:lvl1pPr>
                                                        <a:lvl2pPr marL="457200" indent="0">
                                                          <a:defRPr sz="1100">
                                                            <a:solidFill>
                                                              <a:schemeClr val="dk1"/>
                                                            </a:solidFill>
                                                            <a:latin typeface="+mn-lt"/>
                                                            <a:ea typeface="+mn-ea"/>
                                                            <a:cs typeface="+mn-cs"/>
                                                          </a:defRPr>
                                                        </a:lvl2pPr>
                                                        <a:lvl3pPr marL="914400" indent="0">
                                                          <a:defRPr sz="1100">
                                                            <a:solidFill>
                                                              <a:schemeClr val="dk1"/>
                                                            </a:solidFill>
                                                            <a:latin typeface="+mn-lt"/>
                                                            <a:ea typeface="+mn-ea"/>
                                                            <a:cs typeface="+mn-cs"/>
                                                          </a:defRPr>
                                                        </a:lvl3pPr>
                                                        <a:lvl4pPr marL="1371600" indent="0">
                                                          <a:defRPr sz="1100">
                                                            <a:solidFill>
                                                              <a:schemeClr val="dk1"/>
                                                            </a:solidFill>
                                                            <a:latin typeface="+mn-lt"/>
                                                            <a:ea typeface="+mn-ea"/>
                                                            <a:cs typeface="+mn-cs"/>
                                                          </a:defRPr>
                                                        </a:lvl4pPr>
                                                        <a:lvl5pPr marL="1828800" indent="0">
                                                          <a:defRPr sz="1100">
                                                            <a:solidFill>
                                                              <a:schemeClr val="dk1"/>
                                                            </a:solidFill>
                                                            <a:latin typeface="+mn-lt"/>
                                                            <a:ea typeface="+mn-ea"/>
                                                            <a:cs typeface="+mn-cs"/>
                                                          </a:defRPr>
                                                        </a:lvl5pPr>
                                                        <a:lvl6pPr marL="2286000" indent="0">
                                                          <a:defRPr sz="1100">
                                                            <a:solidFill>
                                                              <a:schemeClr val="dk1"/>
                                                            </a:solidFill>
                                                            <a:latin typeface="+mn-lt"/>
                                                            <a:ea typeface="+mn-ea"/>
                                                            <a:cs typeface="+mn-cs"/>
                                                          </a:defRPr>
                                                        </a:lvl6pPr>
                                                        <a:lvl7pPr marL="2743200" indent="0">
                                                          <a:defRPr sz="1100">
                                                            <a:solidFill>
                                                              <a:schemeClr val="dk1"/>
                                                            </a:solidFill>
                                                            <a:latin typeface="+mn-lt"/>
                                                            <a:ea typeface="+mn-ea"/>
                                                            <a:cs typeface="+mn-cs"/>
                                                          </a:defRPr>
                                                        </a:lvl7pPr>
                                                        <a:lvl8pPr marL="3200400" indent="0">
                                                          <a:defRPr sz="1100">
                                                            <a:solidFill>
                                                              <a:schemeClr val="dk1"/>
                                                            </a:solidFill>
                                                            <a:latin typeface="+mn-lt"/>
                                                            <a:ea typeface="+mn-ea"/>
                                                            <a:cs typeface="+mn-cs"/>
                                                          </a:defRPr>
                                                        </a:lvl8pPr>
                                                        <a:lvl9pPr marL="3657600" indent="0">
                                                          <a:defRPr sz="1100">
                                                            <a:solidFill>
                                                              <a:schemeClr val="dk1"/>
                                                            </a:solidFill>
                                                            <a:latin typeface="+mn-lt"/>
                                                            <a:ea typeface="+mn-ea"/>
                                                            <a:cs typeface="+mn-cs"/>
                                                          </a:defRPr>
                                                        </a:lvl9pPr>
                                                      </a:lstStyle>
                                                      <a:p>
                                                        <a:r>
                                                          <a:rPr lang="fr-FR" sz="800"/>
                                                          <a:t> &lt; 0</a:t>
                                                        </a:r>
                                                      </a:p>
                                                    </p:txBody>
                                                  </p:sp>
                                                </p:grpSp>
                                                <p:sp>
                                                  <p:nvSpPr>
                                                    <p:cNvPr id="105" name="ZoneTexte 13"/>
                                                    <p:cNvSpPr txBox="1"/>
                                                    <p:nvPr/>
                                                  </p:nvSpPr>
                                                  <p:spPr>
                                                    <a:xfrm>
                                                      <a:off x="6096000" y="1117600"/>
                                                      <a:ext cx="914400" cy="177800"/>
                                                    </a:xfrm>
                                                    <a:prstGeom prst="rect">
                                                      <a:avLst/>
                                                    </a:prstGeom>
                                                    <a:noFill/>
                                                    <a:ln w="9525" cmpd="sng">
                                                      <a:noFill/>
                                                    </a:ln>
                                                    <a:effectLst/>
                                                    <a:extLst>
                                                      <a:ext uri="{909E8E84-426E-40DD-AFC4-6F175D3DCCD1}">
                                                        <a14:hiddenFill xmlns:a14="http://schemas.microsoft.com/office/drawing/2010/main">
                                                          <a:solidFill>
                                                            <a:schemeClr val="lt1"/>
                                                          </a:solidFill>
                                                        </a14:hiddenFill>
                                                      </a:ext>
                                                      <a:ext uri="{91240B29-F687-4F45-9708-019B960494DF}">
                                                        <a14:hiddenLine xmlns:a14="http://schemas.microsoft.com/office/drawing/2010/main" w="9525" cmpd="sng">
                                                          <a:solidFill>
                                                            <a:schemeClr val="lt1">
                                                              <a:shade val="50000"/>
                                                            </a:schemeClr>
                                                          </a:solidFill>
                                                        </a14:hiddenLine>
                                                      </a:ext>
                                                    </a:extLst>
                                                  </p:spPr>
                                                  <p:style>
                                                    <a:lnRef idx="0">
                                                      <a:scrgbClr r="0" g="0" b="0"/>
                                                    </a:lnRef>
                                                    <a:fillRef idx="0">
                                                      <a:scrgbClr r="0" g="0" b="0"/>
                                                    </a:fillRef>
                                                    <a:effectRef idx="0">
                                                      <a:scrgbClr r="0" g="0" b="0"/>
                                                    </a:effectRef>
                                                    <a:fontRef idx="minor">
                                                      <a:schemeClr val="dk1"/>
                                                    </a:fontRef>
                                                  </p:style>
                                                  <p:txBody>
                                                    <a:bodyPr vert="horz" rtlCol="0" anchor="t"/>
                                                    <a:lstStyle>
                                                      <a:lvl1pPr marL="0" indent="0">
                                                        <a:defRPr sz="1100">
                                                          <a:solidFill>
                                                            <a:schemeClr val="dk1"/>
                                                          </a:solidFill>
                                                          <a:latin typeface="+mn-lt"/>
                                                          <a:ea typeface="+mn-ea"/>
                                                          <a:cs typeface="+mn-cs"/>
                                                        </a:defRPr>
                                                      </a:lvl1pPr>
                                                      <a:lvl2pPr marL="457200" indent="0">
                                                        <a:defRPr sz="1100">
                                                          <a:solidFill>
                                                            <a:schemeClr val="dk1"/>
                                                          </a:solidFill>
                                                          <a:latin typeface="+mn-lt"/>
                                                          <a:ea typeface="+mn-ea"/>
                                                          <a:cs typeface="+mn-cs"/>
                                                        </a:defRPr>
                                                      </a:lvl2pPr>
                                                      <a:lvl3pPr marL="914400" indent="0">
                                                        <a:defRPr sz="1100">
                                                          <a:solidFill>
                                                            <a:schemeClr val="dk1"/>
                                                          </a:solidFill>
                                                          <a:latin typeface="+mn-lt"/>
                                                          <a:ea typeface="+mn-ea"/>
                                                          <a:cs typeface="+mn-cs"/>
                                                        </a:defRPr>
                                                      </a:lvl3pPr>
                                                      <a:lvl4pPr marL="1371600" indent="0">
                                                        <a:defRPr sz="1100">
                                                          <a:solidFill>
                                                            <a:schemeClr val="dk1"/>
                                                          </a:solidFill>
                                                          <a:latin typeface="+mn-lt"/>
                                                          <a:ea typeface="+mn-ea"/>
                                                          <a:cs typeface="+mn-cs"/>
                                                        </a:defRPr>
                                                      </a:lvl4pPr>
                                                      <a:lvl5pPr marL="1828800" indent="0">
                                                        <a:defRPr sz="1100">
                                                          <a:solidFill>
                                                            <a:schemeClr val="dk1"/>
                                                          </a:solidFill>
                                                          <a:latin typeface="+mn-lt"/>
                                                          <a:ea typeface="+mn-ea"/>
                                                          <a:cs typeface="+mn-cs"/>
                                                        </a:defRPr>
                                                      </a:lvl5pPr>
                                                      <a:lvl6pPr marL="2286000" indent="0">
                                                        <a:defRPr sz="1100">
                                                          <a:solidFill>
                                                            <a:schemeClr val="dk1"/>
                                                          </a:solidFill>
                                                          <a:latin typeface="+mn-lt"/>
                                                          <a:ea typeface="+mn-ea"/>
                                                          <a:cs typeface="+mn-cs"/>
                                                        </a:defRPr>
                                                      </a:lvl6pPr>
                                                      <a:lvl7pPr marL="2743200" indent="0">
                                                        <a:defRPr sz="1100">
                                                          <a:solidFill>
                                                            <a:schemeClr val="dk1"/>
                                                          </a:solidFill>
                                                          <a:latin typeface="+mn-lt"/>
                                                          <a:ea typeface="+mn-ea"/>
                                                          <a:cs typeface="+mn-cs"/>
                                                        </a:defRPr>
                                                      </a:lvl7pPr>
                                                      <a:lvl8pPr marL="3200400" indent="0">
                                                        <a:defRPr sz="1100">
                                                          <a:solidFill>
                                                            <a:schemeClr val="dk1"/>
                                                          </a:solidFill>
                                                          <a:latin typeface="+mn-lt"/>
                                                          <a:ea typeface="+mn-ea"/>
                                                          <a:cs typeface="+mn-cs"/>
                                                        </a:defRPr>
                                                      </a:lvl8pPr>
                                                      <a:lvl9pPr marL="3657600" indent="0">
                                                        <a:defRPr sz="1100">
                                                          <a:solidFill>
                                                            <a:schemeClr val="dk1"/>
                                                          </a:solidFill>
                                                          <a:latin typeface="+mn-lt"/>
                                                          <a:ea typeface="+mn-ea"/>
                                                          <a:cs typeface="+mn-cs"/>
                                                        </a:defRPr>
                                                      </a:lvl9pPr>
                                                    </a:lstStyle>
                                                    <a:p>
                                                      <a:r>
                                                        <a:rPr lang="fr-FR" sz="800"/>
                                                        <a:t> 0 - 0,11</a:t>
                                                      </a:r>
                                                    </a:p>
                                                  </p:txBody>
                                                </p:sp>
                                              </p:grpSp>
                                              <p:sp>
                                                <p:nvSpPr>
                                                  <p:cNvPr id="103" name="ZoneTexte 14"/>
                                                  <p:cNvSpPr txBox="1"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6096000" y="1308100"/>
                                                    <a:ext cx="914400" cy="177800"/>
                                                  </a:xfrm>
                                                  <a:prstGeom prst="rect">
                                                    <a:avLst/>
                                                  </a:prstGeom>
                                                  <a:noFill/>
                                                  <a:ln w="9525" cmpd="sng">
                                                    <a:noFill/>
                                                  </a:ln>
                                                  <a:effectLst/>
                                                  <a:extLst>
                                                    <a:ext uri="{909E8E84-426E-40DD-AFC4-6F175D3DCCD1}">
                                                      <a14:hiddenFill xmlns:a14="http://schemas.microsoft.com/office/drawing/2010/main">
                                                        <a:solidFill>
                                                          <a:schemeClr val="lt1"/>
                                                        </a:solidFill>
                                                      </a14:hiddenFill>
                                                    </a:ext>
                                                    <a:ext uri="{91240B29-F687-4F45-9708-019B960494DF}">
                                                      <a14:hiddenLine xmlns:a14="http://schemas.microsoft.com/office/drawing/2010/main" w="9525" cmpd="sng">
                                                        <a:solidFill>
                                                          <a:schemeClr val="lt1">
                                                            <a:shade val="50000"/>
                                                          </a:schemeClr>
                                                        </a:solidFill>
                                                      </a14:hiddenLine>
                                                    </a:ext>
                                                  </a:extLst>
                                                </p:spPr>
                                                <p:style>
                                                  <a:lnRef idx="0">
                                                    <a:scrgbClr r="0" g="0" b="0"/>
                                                  </a:lnRef>
                                                  <a:fillRef idx="0">
                                                    <a:scrgbClr r="0" g="0" b="0"/>
                                                  </a:fillRef>
                                                  <a:effectRef idx="0">
                                                    <a:scrgbClr r="0" g="0" b="0"/>
                                                  </a:effectRef>
                                                  <a:fontRef idx="minor">
                                                    <a:schemeClr val="dk1"/>
                                                  </a:fontRef>
                                                </p:style>
                                                <p:txBody>
                                                  <a:bodyPr vert="horz" rtlCol="0" anchor="t"/>
                                                  <a:lstStyle>
                                                    <a:lvl1pPr marL="0" indent="0">
                                                      <a:defRPr sz="1100">
                                                        <a:solidFill>
                                                          <a:schemeClr val="dk1"/>
                                                        </a:solidFill>
                                                        <a:latin typeface="+mn-lt"/>
                                                        <a:ea typeface="+mn-ea"/>
                                                        <a:cs typeface="+mn-cs"/>
                                                      </a:defRPr>
                                                    </a:lvl1pPr>
                                                    <a:lvl2pPr marL="457200" indent="0">
                                                      <a:defRPr sz="1100">
                                                        <a:solidFill>
                                                          <a:schemeClr val="dk1"/>
                                                        </a:solidFill>
                                                        <a:latin typeface="+mn-lt"/>
                                                        <a:ea typeface="+mn-ea"/>
                                                        <a:cs typeface="+mn-cs"/>
                                                      </a:defRPr>
                                                    </a:lvl2pPr>
                                                    <a:lvl3pPr marL="914400" indent="0">
                                                      <a:defRPr sz="1100">
                                                        <a:solidFill>
                                                          <a:schemeClr val="dk1"/>
                                                        </a:solidFill>
                                                        <a:latin typeface="+mn-lt"/>
                                                        <a:ea typeface="+mn-ea"/>
                                                        <a:cs typeface="+mn-cs"/>
                                                      </a:defRPr>
                                                    </a:lvl3pPr>
                                                    <a:lvl4pPr marL="1371600" indent="0">
                                                      <a:defRPr sz="1100">
                                                        <a:solidFill>
                                                          <a:schemeClr val="dk1"/>
                                                        </a:solidFill>
                                                        <a:latin typeface="+mn-lt"/>
                                                        <a:ea typeface="+mn-ea"/>
                                                        <a:cs typeface="+mn-cs"/>
                                                      </a:defRPr>
                                                    </a:lvl4pPr>
                                                    <a:lvl5pPr marL="1828800" indent="0">
                                                      <a:defRPr sz="1100">
                                                        <a:solidFill>
                                                          <a:schemeClr val="dk1"/>
                                                        </a:solidFill>
                                                        <a:latin typeface="+mn-lt"/>
                                                        <a:ea typeface="+mn-ea"/>
                                                        <a:cs typeface="+mn-cs"/>
                                                      </a:defRPr>
                                                    </a:lvl5pPr>
                                                    <a:lvl6pPr marL="2286000" indent="0">
                                                      <a:defRPr sz="1100">
                                                        <a:solidFill>
                                                          <a:schemeClr val="dk1"/>
                                                        </a:solidFill>
                                                        <a:latin typeface="+mn-lt"/>
                                                        <a:ea typeface="+mn-ea"/>
                                                        <a:cs typeface="+mn-cs"/>
                                                      </a:defRPr>
                                                    </a:lvl6pPr>
                                                    <a:lvl7pPr marL="2743200" indent="0">
                                                      <a:defRPr sz="1100">
                                                        <a:solidFill>
                                                          <a:schemeClr val="dk1"/>
                                                        </a:solidFill>
                                                        <a:latin typeface="+mn-lt"/>
                                                        <a:ea typeface="+mn-ea"/>
                                                        <a:cs typeface="+mn-cs"/>
                                                      </a:defRPr>
                                                    </a:lvl7pPr>
                                                    <a:lvl8pPr marL="3200400" indent="0">
                                                      <a:defRPr sz="1100">
                                                        <a:solidFill>
                                                          <a:schemeClr val="dk1"/>
                                                        </a:solidFill>
                                                        <a:latin typeface="+mn-lt"/>
                                                        <a:ea typeface="+mn-ea"/>
                                                        <a:cs typeface="+mn-cs"/>
                                                      </a:defRPr>
                                                    </a:lvl8pPr>
                                                    <a:lvl9pPr marL="3657600" indent="0">
                                                      <a:defRPr sz="1100">
                                                        <a:solidFill>
                                                          <a:schemeClr val="dk1"/>
                                                        </a:solidFill>
                                                        <a:latin typeface="+mn-lt"/>
                                                        <a:ea typeface="+mn-ea"/>
                                                        <a:cs typeface="+mn-cs"/>
                                                      </a:defRPr>
                                                    </a:lvl9pPr>
                                                  </a:lstStyle>
                                                  <a:p>
                                                    <a:r>
                                                      <a:rPr lang="fr-FR" sz="800"/>
                                                      <a:t> 0,11 - 0,22</a:t>
                                                    </a:r>
                                                  </a:p>
                                                </p:txBody>
                                              </p:sp>
                                            </p:grpSp>
                                            <p:sp>
                                              <p:nvSpPr>
                                                <p:cNvPr id="101" name="ZoneTexte 15"/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6096000" y="1498600"/>
                                                  <a:ext cx="914400" cy="177800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  <a:ln w="9525" cmpd="sng">
                                                  <a:noFill/>
                                                </a:ln>
                                                <a:effectLst/>
                                                <a:extLst>
                                                  <a:ext uri="{909E8E84-426E-40DD-AFC4-6F175D3DCCD1}">
                                                    <a14:hiddenFill xmlns:a14="http://schemas.microsoft.com/office/drawing/2010/main">
                                                      <a:solidFill>
                                                        <a:schemeClr val="lt1"/>
                                                      </a:solidFill>
                                                    </a14:hiddenFill>
                                                  </a:ext>
                                                  <a:ext uri="{91240B29-F687-4F45-9708-019B960494DF}">
                                                    <a14:hiddenLine xmlns:a14="http://schemas.microsoft.com/office/drawing/2010/main" w="9525" cmpd="sng">
                                                      <a:solidFill>
                                                        <a:schemeClr val="lt1">
                                                          <a:shade val="50000"/>
                                                        </a:schemeClr>
                                                      </a:solidFill>
                                                    </a14:hiddenLine>
                                                  </a:ext>
                                                </a:extLst>
                                              </p:spPr>
                                              <p:style>
                                                <a:lnRef idx="0">
                                                  <a:scrgbClr r="0" g="0" b="0"/>
                                                </a:lnRef>
                                                <a:fillRef idx="0">
                                                  <a:scrgbClr r="0" g="0" b="0"/>
                                                </a:fillRef>
                                                <a:effectRef idx="0">
                                                  <a:scrgbClr r="0" g="0" b="0"/>
                                                </a:effectRef>
                                                <a:fontRef idx="minor">
                                                  <a:schemeClr val="dk1"/>
                                                </a:fontRef>
                                              </p:style>
                                              <p:txBody>
                                                <a:bodyPr vert="horz" rtlCol="0" anchor="t"/>
                                                <a:lstStyle>
                                                  <a:lvl1pPr marL="0" indent="0">
                                                    <a:defRPr sz="1100">
                                                      <a:solidFill>
                                                        <a:schemeClr val="dk1"/>
                                                      </a:solidFill>
                                                      <a:latin typeface="+mn-lt"/>
                                                      <a:ea typeface="+mn-ea"/>
                                                      <a:cs typeface="+mn-cs"/>
                                                    </a:defRPr>
                                                  </a:lvl1pPr>
                                                  <a:lvl2pPr marL="457200" indent="0">
                                                    <a:defRPr sz="1100">
                                                      <a:solidFill>
                                                        <a:schemeClr val="dk1"/>
                                                      </a:solidFill>
                                                      <a:latin typeface="+mn-lt"/>
                                                      <a:ea typeface="+mn-ea"/>
                                                      <a:cs typeface="+mn-cs"/>
                                                    </a:defRPr>
                                                  </a:lvl2pPr>
                                                  <a:lvl3pPr marL="914400" indent="0">
                                                    <a:defRPr sz="1100">
                                                      <a:solidFill>
                                                        <a:schemeClr val="dk1"/>
                                                      </a:solidFill>
                                                      <a:latin typeface="+mn-lt"/>
                                                      <a:ea typeface="+mn-ea"/>
                                                      <a:cs typeface="+mn-cs"/>
                                                    </a:defRPr>
                                                  </a:lvl3pPr>
                                                  <a:lvl4pPr marL="1371600" indent="0">
                                                    <a:defRPr sz="1100">
                                                      <a:solidFill>
                                                        <a:schemeClr val="dk1"/>
                                                      </a:solidFill>
                                                      <a:latin typeface="+mn-lt"/>
                                                      <a:ea typeface="+mn-ea"/>
                                                      <a:cs typeface="+mn-cs"/>
                                                    </a:defRPr>
                                                  </a:lvl4pPr>
                                                  <a:lvl5pPr marL="1828800" indent="0">
                                                    <a:defRPr sz="1100">
                                                      <a:solidFill>
                                                        <a:schemeClr val="dk1"/>
                                                      </a:solidFill>
                                                      <a:latin typeface="+mn-lt"/>
                                                      <a:ea typeface="+mn-ea"/>
                                                      <a:cs typeface="+mn-cs"/>
                                                    </a:defRPr>
                                                  </a:lvl5pPr>
                                                  <a:lvl6pPr marL="2286000" indent="0">
                                                    <a:defRPr sz="1100">
                                                      <a:solidFill>
                                                        <a:schemeClr val="dk1"/>
                                                      </a:solidFill>
                                                      <a:latin typeface="+mn-lt"/>
                                                      <a:ea typeface="+mn-ea"/>
                                                      <a:cs typeface="+mn-cs"/>
                                                    </a:defRPr>
                                                  </a:lvl6pPr>
                                                  <a:lvl7pPr marL="2743200" indent="0">
                                                    <a:defRPr sz="1100">
                                                      <a:solidFill>
                                                        <a:schemeClr val="dk1"/>
                                                      </a:solidFill>
                                                      <a:latin typeface="+mn-lt"/>
                                                      <a:ea typeface="+mn-ea"/>
                                                      <a:cs typeface="+mn-cs"/>
                                                    </a:defRPr>
                                                  </a:lvl7pPr>
                                                  <a:lvl8pPr marL="3200400" indent="0">
                                                    <a:defRPr sz="1100">
                                                      <a:solidFill>
                                                        <a:schemeClr val="dk1"/>
                                                      </a:solidFill>
                                                      <a:latin typeface="+mn-lt"/>
                                                      <a:ea typeface="+mn-ea"/>
                                                      <a:cs typeface="+mn-cs"/>
                                                    </a:defRPr>
                                                  </a:lvl8pPr>
                                                  <a:lvl9pPr marL="3657600" indent="0">
                                                    <a:defRPr sz="1100">
                                                      <a:solidFill>
                                                        <a:schemeClr val="dk1"/>
                                                      </a:solidFill>
                                                      <a:latin typeface="+mn-lt"/>
                                                      <a:ea typeface="+mn-ea"/>
                                                      <a:cs typeface="+mn-cs"/>
                                                    </a:defRPr>
                                                  </a:lvl9pPr>
                                                </a:lstStyle>
                                                <a:p>
                                                  <a:r>
                                                    <a:rPr lang="fr-FR" sz="800"/>
                                                    <a:t> 0,22 - 0,33</a:t>
                                                  </a:r>
                                                </a:p>
                                              </p:txBody>
                                            </p:sp>
                                          </p:grpSp>
                                          <p:sp>
                                            <p:nvSpPr>
                                              <p:cNvPr id="99" name="ZoneTexte 16"/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6096000" y="1689100"/>
                                                <a:ext cx="914400" cy="177800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  <a:ln w="9525" cmpd="sng">
                                                <a:noFill/>
                                              </a:ln>
                                              <a:effectLst/>
                                              <a:extLst>
                                                <a:ext uri="{909E8E84-426E-40DD-AFC4-6F175D3DCCD1}">
                                                  <a14:hiddenFill xmlns:a14="http://schemas.microsoft.com/office/drawing/2010/main">
                                                    <a:solidFill>
                                                      <a:schemeClr val="lt1"/>
                                                    </a:solidFill>
                                                  </a14:hiddenFill>
                                                </a:ext>
                                                <a:ext uri="{91240B29-F687-4F45-9708-019B960494DF}">
                                                  <a14:hiddenLine xmlns:a14="http://schemas.microsoft.com/office/drawing/2010/main" w="9525" cmpd="sng">
                                                    <a:solidFill>
                                                      <a:schemeClr val="lt1">
                                                        <a:shade val="50000"/>
                                                      </a:schemeClr>
                                                    </a:solidFill>
                                                  </a14:hiddenLine>
                                                </a:ext>
                                              </a:extLst>
                                            </p:spPr>
                                            <p:style>
                                              <a:lnRef idx="0">
                                                <a:scrgbClr r="0" g="0" b="0"/>
                                              </a:lnRef>
                                              <a:fillRef idx="0">
                                                <a:scrgbClr r="0" g="0" b="0"/>
                                              </a:fillRef>
                                              <a:effectRef idx="0">
                                                <a:scrgbClr r="0" g="0" b="0"/>
                                              </a:effectRef>
                                              <a:fontRef idx="minor">
                                                <a:schemeClr val="dk1"/>
                                              </a:fontRef>
                                            </p:style>
                                            <p:txBody>
                                              <a:bodyPr vert="horz" rtlCol="0" anchor="t"/>
                                              <a:lstStyle>
                                                <a:lvl1pPr marL="0" indent="0">
                                                  <a:defRPr sz="1100">
                                                    <a:solidFill>
                                                      <a:schemeClr val="dk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1pPr>
                                                <a:lvl2pPr marL="457200" indent="0">
                                                  <a:defRPr sz="1100">
                                                    <a:solidFill>
                                                      <a:schemeClr val="dk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2pPr>
                                                <a:lvl3pPr marL="914400" indent="0">
                                                  <a:defRPr sz="1100">
                                                    <a:solidFill>
                                                      <a:schemeClr val="dk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3pPr>
                                                <a:lvl4pPr marL="1371600" indent="0">
                                                  <a:defRPr sz="1100">
                                                    <a:solidFill>
                                                      <a:schemeClr val="dk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4pPr>
                                                <a:lvl5pPr marL="1828800" indent="0">
                                                  <a:defRPr sz="1100">
                                                    <a:solidFill>
                                                      <a:schemeClr val="dk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5pPr>
                                                <a:lvl6pPr marL="2286000" indent="0">
                                                  <a:defRPr sz="1100">
                                                    <a:solidFill>
                                                      <a:schemeClr val="dk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6pPr>
                                                <a:lvl7pPr marL="2743200" indent="0">
                                                  <a:defRPr sz="1100">
                                                    <a:solidFill>
                                                      <a:schemeClr val="dk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7pPr>
                                                <a:lvl8pPr marL="3200400" indent="0">
                                                  <a:defRPr sz="1100">
                                                    <a:solidFill>
                                                      <a:schemeClr val="dk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8pPr>
                                                <a:lvl9pPr marL="3657600" indent="0">
                                                  <a:defRPr sz="1100">
                                                    <a:solidFill>
                                                      <a:schemeClr val="dk1"/>
                                                    </a:solidFill>
                                                    <a:latin typeface="+mn-lt"/>
                                                    <a:ea typeface="+mn-ea"/>
                                                    <a:cs typeface="+mn-cs"/>
                                                  </a:defRPr>
                                                </a:lvl9pPr>
                                              </a:lstStyle>
                                              <a:p>
                                                <a:r>
                                                  <a:rPr lang="fr-FR" sz="800"/>
                                                  <a:t> 0,33 - 0,44</a:t>
                                                </a:r>
                                              </a:p>
                                            </p:txBody>
                                          </p:sp>
                                        </p:grpSp>
                                        <p:sp>
                                          <p:nvSpPr>
                                            <p:cNvPr id="97" name="ZoneTexte 17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6096000" y="1879600"/>
                                              <a:ext cx="914400" cy="177800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  <a:ln w="9525" cmpd="sng">
                                              <a:noFill/>
                                            </a:ln>
                                            <a:effectLst/>
                                            <a:extLst>
                                              <a:ext uri="{909E8E84-426E-40DD-AFC4-6F175D3DCCD1}">
                                                <a14:hiddenFill xmlns:a14="http://schemas.microsoft.com/office/drawing/2010/main">
                                                  <a:solidFill>
                                                    <a:schemeClr val="lt1"/>
                                                  </a:solidFill>
                                                </a14:hiddenFill>
                                              </a:ext>
                                              <a:ext uri="{91240B29-F687-4F45-9708-019B960494DF}">
                                                <a14:hiddenLine xmlns:a14="http://schemas.microsoft.com/office/drawing/2010/main" w="9525" cmpd="sng">
                                                  <a:solidFill>
                                                    <a:schemeClr val="lt1">
                                                      <a:shade val="50000"/>
                                                    </a:schemeClr>
                                                  </a:solidFill>
                                                </a14:hiddenLine>
                                              </a:ext>
                                            </a:extLst>
                                          </p:spPr>
                                          <p:style>
                                            <a:lnRef idx="0">
                                              <a:scrgbClr r="0" g="0" b="0"/>
                                            </a:lnRef>
                                            <a:fillRef idx="0">
                                              <a:scrgbClr r="0" g="0" b="0"/>
                                            </a:fillRef>
                                            <a:effectRef idx="0">
                                              <a:scrgbClr r="0" g="0" b="0"/>
                                            </a:effectRef>
                                            <a:fontRef idx="minor">
                                              <a:schemeClr val="dk1"/>
                                            </a:fontRef>
                                          </p:style>
                                          <p:txBody>
                                            <a:bodyPr vert="horz" rtlCol="0" anchor="t"/>
                                            <a:lstStyle>
                                              <a:lvl1pPr marL="0" indent="0">
                                                <a:defRPr sz="1100">
                                                  <a:solidFill>
                                                    <a:schemeClr val="dk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1pPr>
                                              <a:lvl2pPr marL="457200" indent="0">
                                                <a:defRPr sz="1100">
                                                  <a:solidFill>
                                                    <a:schemeClr val="dk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2pPr>
                                              <a:lvl3pPr marL="914400" indent="0">
                                                <a:defRPr sz="1100">
                                                  <a:solidFill>
                                                    <a:schemeClr val="dk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3pPr>
                                              <a:lvl4pPr marL="1371600" indent="0">
                                                <a:defRPr sz="1100">
                                                  <a:solidFill>
                                                    <a:schemeClr val="dk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4pPr>
                                              <a:lvl5pPr marL="1828800" indent="0">
                                                <a:defRPr sz="1100">
                                                  <a:solidFill>
                                                    <a:schemeClr val="dk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5pPr>
                                              <a:lvl6pPr marL="2286000" indent="0">
                                                <a:defRPr sz="1100">
                                                  <a:solidFill>
                                                    <a:schemeClr val="dk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6pPr>
                                              <a:lvl7pPr marL="2743200" indent="0">
                                                <a:defRPr sz="1100">
                                                  <a:solidFill>
                                                    <a:schemeClr val="dk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7pPr>
                                              <a:lvl8pPr marL="3200400" indent="0">
                                                <a:defRPr sz="1100">
                                                  <a:solidFill>
                                                    <a:schemeClr val="dk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8pPr>
                                              <a:lvl9pPr marL="3657600" indent="0">
                                                <a:defRPr sz="1100">
                                                  <a:solidFill>
                                                    <a:schemeClr val="dk1"/>
                                                  </a:solidFill>
                                                  <a:latin typeface="+mn-lt"/>
                                                  <a:ea typeface="+mn-ea"/>
                                                  <a:cs typeface="+mn-cs"/>
                                                </a:defRPr>
                                              </a:lvl9pPr>
                                            </a:lstStyle>
                                            <a:p>
                                              <a:r>
                                                <a:rPr lang="fr-FR" sz="800"/>
                                                <a:t> 0,44 - 0,56</a:t>
                                              </a:r>
                                            </a:p>
                                          </p:txBody>
                                        </p:sp>
                                      </p:grpSp>
                                      <p:sp>
                                        <p:nvSpPr>
                                          <p:cNvPr id="95" name="ZoneTexte 18"/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6096000" y="2070100"/>
                                            <a:ext cx="914400" cy="177800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  <a:ln w="9525" cmpd="sng">
                                            <a:noFill/>
                                          </a:ln>
                                          <a:effectLst/>
                                          <a:extLst>
                                            <a:ext uri="{909E8E84-426E-40DD-AFC4-6F175D3DCCD1}">
                                              <a14:hiddenFill xmlns:a14="http://schemas.microsoft.com/office/drawing/2010/main">
                                                <a:solidFill>
                                                  <a:schemeClr val="lt1"/>
                                                </a:solidFill>
                                              </a14:hiddenFill>
                                            </a:ext>
                                            <a:ext uri="{91240B29-F687-4F45-9708-019B960494DF}">
                                              <a14:hiddenLine xmlns:a14="http://schemas.microsoft.com/office/drawing/2010/main" w="9525" cmpd="sng">
                                                <a:solidFill>
                                                  <a:schemeClr val="lt1">
                                                    <a:shade val="50000"/>
                                                  </a:schemeClr>
                                                </a:solidFill>
                                              </a14:hiddenLine>
                                            </a:ext>
                                          </a:extLst>
                                        </p:spPr>
                                        <p:style>
                                          <a:lnRef idx="0">
                                            <a:scrgbClr r="0" g="0" b="0"/>
                                          </a:lnRef>
                                          <a:fillRef idx="0">
                                            <a:scrgbClr r="0" g="0" b="0"/>
                                          </a:fillRef>
                                          <a:effectRef idx="0">
                                            <a:scrgbClr r="0" g="0" b="0"/>
                                          </a:effectRef>
                                          <a:fontRef idx="minor">
                                            <a:schemeClr val="dk1"/>
                                          </a:fontRef>
                                        </p:style>
                                        <p:txBody>
                                          <a:bodyPr vert="horz" rtlCol="0" anchor="t"/>
                                          <a:lstStyle>
                                            <a:lvl1pPr marL="0" indent="0">
                                              <a:defRPr sz="1100">
                                                <a:solidFill>
                                                  <a:schemeClr val="dk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1pPr>
                                            <a:lvl2pPr marL="457200" indent="0">
                                              <a:defRPr sz="1100">
                                                <a:solidFill>
                                                  <a:schemeClr val="dk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2pPr>
                                            <a:lvl3pPr marL="914400" indent="0">
                                              <a:defRPr sz="1100">
                                                <a:solidFill>
                                                  <a:schemeClr val="dk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3pPr>
                                            <a:lvl4pPr marL="1371600" indent="0">
                                              <a:defRPr sz="1100">
                                                <a:solidFill>
                                                  <a:schemeClr val="dk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4pPr>
                                            <a:lvl5pPr marL="1828800" indent="0">
                                              <a:defRPr sz="1100">
                                                <a:solidFill>
                                                  <a:schemeClr val="dk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5pPr>
                                            <a:lvl6pPr marL="2286000" indent="0">
                                              <a:defRPr sz="1100">
                                                <a:solidFill>
                                                  <a:schemeClr val="dk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6pPr>
                                            <a:lvl7pPr marL="2743200" indent="0">
                                              <a:defRPr sz="1100">
                                                <a:solidFill>
                                                  <a:schemeClr val="dk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7pPr>
                                            <a:lvl8pPr marL="3200400" indent="0">
                                              <a:defRPr sz="1100">
                                                <a:solidFill>
                                                  <a:schemeClr val="dk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8pPr>
                                            <a:lvl9pPr marL="3657600" indent="0">
                                              <a:defRPr sz="1100">
                                                <a:solidFill>
                                                  <a:schemeClr val="dk1"/>
                                                </a:solidFill>
                                                <a:latin typeface="+mn-lt"/>
                                                <a:ea typeface="+mn-ea"/>
                                                <a:cs typeface="+mn-cs"/>
                                              </a:defRPr>
                                            </a:lvl9pPr>
                                          </a:lstStyle>
                                          <a:p>
                                            <a:r>
                                              <a:rPr lang="fr-FR" sz="800"/>
                                              <a:t> 0,56 - 0,67</a:t>
                                            </a:r>
                                          </a:p>
                                        </p:txBody>
                                      </p:sp>
                                    </p:grpSp>
                                    <p:sp>
                                      <p:nvSpPr>
                                        <p:cNvPr id="93" name="ZoneTexte 19"/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6096000" y="2260600"/>
                                          <a:ext cx="914400" cy="177800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  <a:ln w="9525" cmpd="sng">
                                          <a:noFill/>
                                        </a:ln>
                                        <a:effectLst/>
                                        <a:extLst>
                                          <a:ext uri="{909E8E84-426E-40DD-AFC4-6F175D3DCCD1}">
                                            <a14:hiddenFill xmlns:a14="http://schemas.microsoft.com/office/drawing/2010/main">
                                              <a:solidFill>
                                                <a:schemeClr val="lt1"/>
                                              </a:solidFill>
                                            </a14:hiddenFill>
                                          </a:ext>
                                          <a:ext uri="{91240B29-F687-4F45-9708-019B960494DF}">
                                            <a14:hiddenLine xmlns:a14="http://schemas.microsoft.com/office/drawing/2010/main" w="9525" cmpd="sng">
                                              <a:solidFill>
                                                <a:schemeClr val="lt1">
                                                  <a:shade val="50000"/>
                                                </a:schemeClr>
                                              </a:solidFill>
                                            </a14:hiddenLine>
                                          </a:ext>
                                        </a:extLst>
                                      </p:spPr>
                                      <p:style>
                                        <a:lnRef idx="0">
                                          <a:scrgbClr r="0" g="0" b="0"/>
                                        </a:lnRef>
                                        <a:fillRef idx="0">
                                          <a:scrgbClr r="0" g="0" b="0"/>
                                        </a:fillRef>
                                        <a:effectRef idx="0">
                                          <a:scrgbClr r="0" g="0" b="0"/>
                                        </a:effectRef>
                                        <a:fontRef idx="minor">
                                          <a:schemeClr val="dk1"/>
                                        </a:fontRef>
                                      </p:style>
                                      <p:txBody>
                                        <a:bodyPr vert="horz" rtlCol="0" anchor="t"/>
                                        <a:lstStyle>
                                          <a:lvl1pPr marL="0" indent="0">
                                            <a:defRPr sz="1100">
                                              <a:solidFill>
                                                <a:schemeClr val="dk1"/>
                                              </a:solidFill>
                                              <a:latin typeface="+mn-lt"/>
                                              <a:ea typeface="+mn-ea"/>
                                              <a:cs typeface="+mn-cs"/>
                                            </a:defRPr>
                                          </a:lvl1pPr>
                                          <a:lvl2pPr marL="457200" indent="0">
                                            <a:defRPr sz="1100">
                                              <a:solidFill>
                                                <a:schemeClr val="dk1"/>
                                              </a:solidFill>
                                              <a:latin typeface="+mn-lt"/>
                                              <a:ea typeface="+mn-ea"/>
                                              <a:cs typeface="+mn-cs"/>
                                            </a:defRPr>
                                          </a:lvl2pPr>
                                          <a:lvl3pPr marL="914400" indent="0">
                                            <a:defRPr sz="1100">
                                              <a:solidFill>
                                                <a:schemeClr val="dk1"/>
                                              </a:solidFill>
                                              <a:latin typeface="+mn-lt"/>
                                              <a:ea typeface="+mn-ea"/>
                                              <a:cs typeface="+mn-cs"/>
                                            </a:defRPr>
                                          </a:lvl3pPr>
                                          <a:lvl4pPr marL="1371600" indent="0">
                                            <a:defRPr sz="1100">
                                              <a:solidFill>
                                                <a:schemeClr val="dk1"/>
                                              </a:solidFill>
                                              <a:latin typeface="+mn-lt"/>
                                              <a:ea typeface="+mn-ea"/>
                                              <a:cs typeface="+mn-cs"/>
                                            </a:defRPr>
                                          </a:lvl4pPr>
                                          <a:lvl5pPr marL="1828800" indent="0">
                                            <a:defRPr sz="1100">
                                              <a:solidFill>
                                                <a:schemeClr val="dk1"/>
                                              </a:solidFill>
                                              <a:latin typeface="+mn-lt"/>
                                              <a:ea typeface="+mn-ea"/>
                                              <a:cs typeface="+mn-cs"/>
                                            </a:defRPr>
                                          </a:lvl5pPr>
                                          <a:lvl6pPr marL="2286000" indent="0">
                                            <a:defRPr sz="1100">
                                              <a:solidFill>
                                                <a:schemeClr val="dk1"/>
                                              </a:solidFill>
                                              <a:latin typeface="+mn-lt"/>
                                              <a:ea typeface="+mn-ea"/>
                                              <a:cs typeface="+mn-cs"/>
                                            </a:defRPr>
                                          </a:lvl6pPr>
                                          <a:lvl7pPr marL="2743200" indent="0">
                                            <a:defRPr sz="1100">
                                              <a:solidFill>
                                                <a:schemeClr val="dk1"/>
                                              </a:solidFill>
                                              <a:latin typeface="+mn-lt"/>
                                              <a:ea typeface="+mn-ea"/>
                                              <a:cs typeface="+mn-cs"/>
                                            </a:defRPr>
                                          </a:lvl7pPr>
                                          <a:lvl8pPr marL="3200400" indent="0">
                                            <a:defRPr sz="1100">
                                              <a:solidFill>
                                                <a:schemeClr val="dk1"/>
                                              </a:solidFill>
                                              <a:latin typeface="+mn-lt"/>
                                              <a:ea typeface="+mn-ea"/>
                                              <a:cs typeface="+mn-cs"/>
                                            </a:defRPr>
                                          </a:lvl8pPr>
                                          <a:lvl9pPr marL="3657600" indent="0">
                                            <a:defRPr sz="1100">
                                              <a:solidFill>
                                                <a:schemeClr val="dk1"/>
                                              </a:solidFill>
                                              <a:latin typeface="+mn-lt"/>
                                              <a:ea typeface="+mn-ea"/>
                                              <a:cs typeface="+mn-cs"/>
                                            </a:defRPr>
                                          </a:lvl9pPr>
                                        </a:lstStyle>
                                        <a:p>
                                          <a:r>
                                            <a:rPr lang="fr-FR" sz="800"/>
                                            <a:t> 0,67 - 0,78</a:t>
                                          </a:r>
                                        </a:p>
                                      </p:txBody>
                                    </p:sp>
                                  </p:grpSp>
                                  <p:sp>
                                    <p:nvSpPr>
                                      <p:cNvPr id="91" name="ZoneTexte 20"/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6096000" y="2451100"/>
                                        <a:ext cx="914400" cy="177800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  <a:ln w="9525" cmpd="sng">
                                        <a:noFill/>
                                      </a:ln>
                                      <a:effectLst/>
                                      <a:extLst>
                                        <a:ext uri="{909E8E84-426E-40DD-AFC4-6F175D3DCCD1}">
                                          <a14:hiddenFill xmlns:a14="http://schemas.microsoft.com/office/drawing/2010/main">
                                            <a:solidFill>
                                              <a:schemeClr val="lt1"/>
                                            </a:solidFill>
                                          </a14:hiddenFill>
                                        </a:ext>
                                        <a:ext uri="{91240B29-F687-4F45-9708-019B960494DF}">
                                          <a14:hiddenLine xmlns:a14="http://schemas.microsoft.com/office/drawing/2010/main" w="9525" cmpd="sng">
                                            <a:solidFill>
                                              <a:schemeClr val="lt1">
                                                <a:shade val="50000"/>
                                              </a:schemeClr>
                                            </a:solidFill>
                                          </a14:hiddenLine>
                                        </a:ext>
                                      </a:extLst>
                                    </p:spPr>
                                    <p:style>
                                      <a:lnRef idx="0">
                                        <a:scrgbClr r="0" g="0" b="0"/>
                                      </a:lnRef>
                                      <a:fillRef idx="0">
                                        <a:scrgbClr r="0" g="0" b="0"/>
                                      </a:fillRef>
                                      <a:effectRef idx="0">
                                        <a:scrgbClr r="0" g="0" b="0"/>
                                      </a:effectRef>
                                      <a:fontRef idx="minor">
                                        <a:schemeClr val="dk1"/>
                                      </a:fontRef>
                                    </p:style>
                                    <p:txBody>
                                      <a:bodyPr vert="horz" rtlCol="0" anchor="t"/>
                                      <a:lstStyle>
                                        <a:lvl1pPr marL="0" indent="0">
                                          <a:defRPr sz="1100">
                                            <a:solidFill>
                                              <a:schemeClr val="dk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1pPr>
                                        <a:lvl2pPr marL="457200" indent="0">
                                          <a:defRPr sz="1100">
                                            <a:solidFill>
                                              <a:schemeClr val="dk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2pPr>
                                        <a:lvl3pPr marL="914400" indent="0">
                                          <a:defRPr sz="1100">
                                            <a:solidFill>
                                              <a:schemeClr val="dk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3pPr>
                                        <a:lvl4pPr marL="1371600" indent="0">
                                          <a:defRPr sz="1100">
                                            <a:solidFill>
                                              <a:schemeClr val="dk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4pPr>
                                        <a:lvl5pPr marL="1828800" indent="0">
                                          <a:defRPr sz="1100">
                                            <a:solidFill>
                                              <a:schemeClr val="dk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5pPr>
                                        <a:lvl6pPr marL="2286000" indent="0">
                                          <a:defRPr sz="1100">
                                            <a:solidFill>
                                              <a:schemeClr val="dk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6pPr>
                                        <a:lvl7pPr marL="2743200" indent="0">
                                          <a:defRPr sz="1100">
                                            <a:solidFill>
                                              <a:schemeClr val="dk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7pPr>
                                        <a:lvl8pPr marL="3200400" indent="0">
                                          <a:defRPr sz="1100">
                                            <a:solidFill>
                                              <a:schemeClr val="dk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8pPr>
                                        <a:lvl9pPr marL="3657600" indent="0">
                                          <a:defRPr sz="1100">
                                            <a:solidFill>
                                              <a:schemeClr val="dk1"/>
                                            </a:solidFill>
                                            <a:latin typeface="+mn-lt"/>
                                            <a:ea typeface="+mn-ea"/>
                                            <a:cs typeface="+mn-cs"/>
                                          </a:defRPr>
                                        </a:lvl9pPr>
                                      </a:lstStyle>
                                      <a:p>
                                        <a:r>
                                          <a:rPr lang="fr-FR" sz="800"/>
                                          <a:t> 0,78 - 0,89</a:t>
                                        </a:r>
                                      </a:p>
                                    </p:txBody>
                                  </p:sp>
                                </p:grpSp>
                                <p:sp>
                                  <p:nvSpPr>
                                    <p:cNvPr id="89" name="ZoneTexte 21"/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6096000" y="2641600"/>
                                      <a:ext cx="914400" cy="177800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  <a:ln w="9525" cmpd="sng">
                                      <a:noFill/>
                                    </a:ln>
                                    <a:effectLst/>
                                    <a:extLst>
                                      <a:ext uri="{909E8E84-426E-40DD-AFC4-6F175D3DCCD1}">
                                        <a14:hiddenFill xmlns:a14="http://schemas.microsoft.com/office/drawing/2010/main">
                                          <a:solidFill>
                                            <a:schemeClr val="lt1"/>
                                          </a:solidFill>
                                        </a14:hiddenFill>
                                      </a:ext>
                                      <a:ext uri="{91240B29-F687-4F45-9708-019B960494DF}">
                                        <a14:hiddenLine xmlns:a14="http://schemas.microsoft.com/office/drawing/2010/main" w="9525" cmpd="sng">
                                          <a:solidFill>
                                            <a:schemeClr val="lt1">
                                              <a:shade val="50000"/>
                                            </a:schemeClr>
                                          </a:solidFill>
                                        </a14:hiddenLine>
                                      </a:ext>
                                    </a:extLst>
                                  </p:spPr>
                                  <p:style>
                                    <a:lnRef idx="0">
                                      <a:scrgbClr r="0" g="0" b="0"/>
                                    </a:lnRef>
                                    <a:fillRef idx="0">
                                      <a:scrgbClr r="0" g="0" b="0"/>
                                    </a:fillRef>
                                    <a:effectRef idx="0">
                                      <a:scrgbClr r="0" g="0" b="0"/>
                                    </a:effectRef>
                                    <a:fontRef idx="minor">
                                      <a:schemeClr val="dk1"/>
                                    </a:fontRef>
                                  </p:style>
                                  <p:txBody>
                                    <a:bodyPr vert="horz" rtlCol="0" anchor="t"/>
                                    <a:lstStyle>
                                      <a:lvl1pPr marL="0" indent="0">
                                        <a:defRPr sz="1100">
                                          <a:solidFill>
                                            <a:schemeClr val="dk1"/>
                                          </a:solidFill>
                                          <a:latin typeface="+mn-lt"/>
                                          <a:ea typeface="+mn-ea"/>
                                          <a:cs typeface="+mn-cs"/>
                                        </a:defRPr>
                                      </a:lvl1pPr>
                                      <a:lvl2pPr marL="457200" indent="0">
                                        <a:defRPr sz="1100">
                                          <a:solidFill>
                                            <a:schemeClr val="dk1"/>
                                          </a:solidFill>
                                          <a:latin typeface="+mn-lt"/>
                                          <a:ea typeface="+mn-ea"/>
                                          <a:cs typeface="+mn-cs"/>
                                        </a:defRPr>
                                      </a:lvl2pPr>
                                      <a:lvl3pPr marL="914400" indent="0">
                                        <a:defRPr sz="1100">
                                          <a:solidFill>
                                            <a:schemeClr val="dk1"/>
                                          </a:solidFill>
                                          <a:latin typeface="+mn-lt"/>
                                          <a:ea typeface="+mn-ea"/>
                                          <a:cs typeface="+mn-cs"/>
                                        </a:defRPr>
                                      </a:lvl3pPr>
                                      <a:lvl4pPr marL="1371600" indent="0">
                                        <a:defRPr sz="1100">
                                          <a:solidFill>
                                            <a:schemeClr val="dk1"/>
                                          </a:solidFill>
                                          <a:latin typeface="+mn-lt"/>
                                          <a:ea typeface="+mn-ea"/>
                                          <a:cs typeface="+mn-cs"/>
                                        </a:defRPr>
                                      </a:lvl4pPr>
                                      <a:lvl5pPr marL="1828800" indent="0">
                                        <a:defRPr sz="1100">
                                          <a:solidFill>
                                            <a:schemeClr val="dk1"/>
                                          </a:solidFill>
                                          <a:latin typeface="+mn-lt"/>
                                          <a:ea typeface="+mn-ea"/>
                                          <a:cs typeface="+mn-cs"/>
                                        </a:defRPr>
                                      </a:lvl5pPr>
                                      <a:lvl6pPr marL="2286000" indent="0">
                                        <a:defRPr sz="1100">
                                          <a:solidFill>
                                            <a:schemeClr val="dk1"/>
                                          </a:solidFill>
                                          <a:latin typeface="+mn-lt"/>
                                          <a:ea typeface="+mn-ea"/>
                                          <a:cs typeface="+mn-cs"/>
                                        </a:defRPr>
                                      </a:lvl6pPr>
                                      <a:lvl7pPr marL="2743200" indent="0">
                                        <a:defRPr sz="1100">
                                          <a:solidFill>
                                            <a:schemeClr val="dk1"/>
                                          </a:solidFill>
                                          <a:latin typeface="+mn-lt"/>
                                          <a:ea typeface="+mn-ea"/>
                                          <a:cs typeface="+mn-cs"/>
                                        </a:defRPr>
                                      </a:lvl7pPr>
                                      <a:lvl8pPr marL="3200400" indent="0">
                                        <a:defRPr sz="1100">
                                          <a:solidFill>
                                            <a:schemeClr val="dk1"/>
                                          </a:solidFill>
                                          <a:latin typeface="+mn-lt"/>
                                          <a:ea typeface="+mn-ea"/>
                                          <a:cs typeface="+mn-cs"/>
                                        </a:defRPr>
                                      </a:lvl8pPr>
                                      <a:lvl9pPr marL="3657600" indent="0">
                                        <a:defRPr sz="1100">
                                          <a:solidFill>
                                            <a:schemeClr val="dk1"/>
                                          </a:solidFill>
                                          <a:latin typeface="+mn-lt"/>
                                          <a:ea typeface="+mn-ea"/>
                                          <a:cs typeface="+mn-cs"/>
                                        </a:defRPr>
                                      </a:lvl9pPr>
                                    </a:lstStyle>
                                    <a:p>
                                      <a:r>
                                        <a:rPr lang="fr-FR" sz="800"/>
                                        <a:t> 0,89 - 1</a:t>
                                      </a:r>
                                    </a:p>
                                  </p:txBody>
                                </p:sp>
                              </p:grpSp>
                              <p:sp>
                                <p:nvSpPr>
                                  <p:cNvPr id="87" name="ZoneTexte 22"/>
                                  <p:cNvSpPr txBox="1"/>
                                  <p:nvPr/>
                                </p:nvSpPr>
                                <p:spPr>
                                  <a:xfrm>
                                    <a:off x="6096000" y="2832100"/>
                                    <a:ext cx="914400" cy="177800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  <a:ln w="9525" cmpd="sng">
                                    <a:noFill/>
                                  </a:ln>
                                  <a:effectLst/>
                                  <a:extLst>
                                    <a:ext uri="{909E8E84-426E-40DD-AFC4-6F175D3DCCD1}">
                                      <a14:hiddenFill xmlns:a14="http://schemas.microsoft.com/office/drawing/2010/main">
                                        <a:solidFill>
                                          <a:schemeClr val="lt1"/>
                                        </a:solidFill>
                                      </a14:hiddenFill>
                                    </a:ext>
                                    <a:ext uri="{91240B29-F687-4F45-9708-019B960494DF}">
                                      <a14:hiddenLine xmlns:a14="http://schemas.microsoft.com/office/drawing/2010/main" w="9525" cmpd="sng">
                                        <a:solidFill>
                                          <a:schemeClr val="lt1">
                                            <a:shade val="50000"/>
                                          </a:schemeClr>
                                        </a:solidFill>
                                      </a14:hiddenLine>
                                    </a:ext>
                                  </a:extLst>
                                </p:spPr>
                                <p:style>
                                  <a:lnRef idx="0">
                                    <a:scrgbClr r="0" g="0" b="0"/>
                                  </a:lnRef>
                                  <a:fillRef idx="0">
                                    <a:scrgbClr r="0" g="0" b="0"/>
                                  </a:fillRef>
                                  <a:effectRef idx="0">
                                    <a:scrgbClr r="0" g="0" b="0"/>
                                  </a:effectRef>
                                  <a:fontRef idx="minor">
                                    <a:schemeClr val="dk1"/>
                                  </a:fontRef>
                                </p:style>
                                <p:txBody>
                                  <a:bodyPr vert="horz" rtlCol="0" anchor="t"/>
                                  <a:lstStyle>
                                    <a:lvl1pPr marL="0" indent="0">
                                      <a:defRPr sz="1100">
                                        <a:solidFill>
                                          <a:schemeClr val="dk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1pPr>
                                    <a:lvl2pPr marL="457200" indent="0">
                                      <a:defRPr sz="1100">
                                        <a:solidFill>
                                          <a:schemeClr val="dk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2pPr>
                                    <a:lvl3pPr marL="914400" indent="0">
                                      <a:defRPr sz="1100">
                                        <a:solidFill>
                                          <a:schemeClr val="dk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3pPr>
                                    <a:lvl4pPr marL="1371600" indent="0">
                                      <a:defRPr sz="1100">
                                        <a:solidFill>
                                          <a:schemeClr val="dk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4pPr>
                                    <a:lvl5pPr marL="1828800" indent="0">
                                      <a:defRPr sz="1100">
                                        <a:solidFill>
                                          <a:schemeClr val="dk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5pPr>
                                    <a:lvl6pPr marL="2286000" indent="0">
                                      <a:defRPr sz="1100">
                                        <a:solidFill>
                                          <a:schemeClr val="dk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6pPr>
                                    <a:lvl7pPr marL="2743200" indent="0">
                                      <a:defRPr sz="1100">
                                        <a:solidFill>
                                          <a:schemeClr val="dk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7pPr>
                                    <a:lvl8pPr marL="3200400" indent="0">
                                      <a:defRPr sz="1100">
                                        <a:solidFill>
                                          <a:schemeClr val="dk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8pPr>
                                    <a:lvl9pPr marL="3657600" indent="0">
                                      <a:defRPr sz="1100">
                                        <a:solidFill>
                                          <a:schemeClr val="dk1"/>
                                        </a:solidFill>
                                        <a:latin typeface="+mn-lt"/>
                                        <a:ea typeface="+mn-ea"/>
                                        <a:cs typeface="+mn-cs"/>
                                      </a:defRPr>
                                    </a:lvl9pPr>
                                  </a:lstStyle>
                                  <a:p>
                                    <a:r>
                                      <a:rPr lang="fr-FR" sz="800"/>
                                      <a:t> &gt; 1</a:t>
                                    </a:r>
                                  </a:p>
                                </p:txBody>
                              </p:sp>
                            </p:grpSp>
                            <p:sp>
                              <p:nvSpPr>
                                <p:cNvPr id="85" name="ZoneTexte 23"/>
                                <p:cNvSpPr txBox="1"/>
                                <p:nvPr/>
                              </p:nvSpPr>
                              <p:spPr>
                                <a:xfrm>
                                  <a:off x="7086600" y="977900"/>
                                  <a:ext cx="457200" cy="114300"/>
                                </a:xfrm>
                                <a:prstGeom prst="rect">
                                  <a:avLst/>
                                </a:prstGeom>
                                <a:solidFill>
                                  <a:srgbClr val="FF0000"/>
                                </a:solidFill>
                                <a:ln w="3175" cmpd="sng">
                                  <a:solidFill>
                                    <a:schemeClr val="lt1">
                                      <a:shade val="50000"/>
                                    </a:schemeClr>
                                  </a:solidFill>
                                </a:ln>
                              </p:spPr>
                              <p:style>
                                <a:lnRef idx="0">
                                  <a:scrgbClr r="0" g="0" b="0"/>
                                </a:lnRef>
                                <a:fillRef idx="0">
                                  <a:scrgbClr r="0" g="0" b="0"/>
                                </a:fillRef>
                                <a:effectRef idx="0">
                                  <a:scrgbClr r="0" g="0" b="0"/>
                                </a:effectRef>
                                <a:fontRef idx="minor">
                                  <a:schemeClr val="dk1"/>
                                </a:fontRef>
                              </p:style>
                              <p:txBody>
                                <a:bodyPr vert="horz" rtlCol="0" anchor="ctr"/>
                                <a:lstStyle>
                                  <a:lvl1pPr marL="0" indent="0">
                                    <a:defRPr sz="1100">
                                      <a:solidFill>
                                        <a:schemeClr val="dk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1pPr>
                                  <a:lvl2pPr marL="457200" indent="0">
                                    <a:defRPr sz="1100">
                                      <a:solidFill>
                                        <a:schemeClr val="dk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2pPr>
                                  <a:lvl3pPr marL="914400" indent="0">
                                    <a:defRPr sz="1100">
                                      <a:solidFill>
                                        <a:schemeClr val="dk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3pPr>
                                  <a:lvl4pPr marL="1371600" indent="0">
                                    <a:defRPr sz="1100">
                                      <a:solidFill>
                                        <a:schemeClr val="dk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4pPr>
                                  <a:lvl5pPr marL="1828800" indent="0">
                                    <a:defRPr sz="1100">
                                      <a:solidFill>
                                        <a:schemeClr val="dk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5pPr>
                                  <a:lvl6pPr marL="2286000" indent="0">
                                    <a:defRPr sz="1100">
                                      <a:solidFill>
                                        <a:schemeClr val="dk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6pPr>
                                  <a:lvl7pPr marL="2743200" indent="0">
                                    <a:defRPr sz="1100">
                                      <a:solidFill>
                                        <a:schemeClr val="dk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7pPr>
                                  <a:lvl8pPr marL="3200400" indent="0">
                                    <a:defRPr sz="1100">
                                      <a:solidFill>
                                        <a:schemeClr val="dk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8pPr>
                                  <a:lvl9pPr marL="3657600" indent="0">
                                    <a:defRPr sz="1100">
                                      <a:solidFill>
                                        <a:schemeClr val="dk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9pPr>
                                </a:lstStyle>
                                <a:p>
                                  <a:endParaRPr lang="fr-FR" sz="1100"/>
                                </a:p>
                              </p:txBody>
                            </p:sp>
                          </p:grpSp>
                          <p:sp>
                            <p:nvSpPr>
                              <p:cNvPr id="83" name="ZoneTexte 24"/>
                              <p:cNvSpPr txBox="1"/>
                              <p:nvPr/>
                            </p:nvSpPr>
                            <p:spPr>
                              <a:xfrm>
                                <a:off x="7086600" y="1168400"/>
                                <a:ext cx="457200" cy="114300"/>
                              </a:xfrm>
                              <a:prstGeom prst="rect">
                                <a:avLst/>
                              </a:prstGeom>
                              <a:solidFill>
                                <a:srgbClr val="C80000"/>
                              </a:solidFill>
                              <a:ln w="3175" cmpd="sng">
                                <a:solidFill>
                                  <a:schemeClr val="lt1">
                                    <a:shade val="50000"/>
                                  </a:schemeClr>
                                </a:solidFill>
                              </a:ln>
                            </p:spPr>
                            <p:style>
                              <a:lnRef idx="0">
                                <a:scrgbClr r="0" g="0" b="0"/>
                              </a:lnRef>
                              <a:fillRef idx="0">
                                <a:scrgbClr r="0" g="0" b="0"/>
                              </a:fillRef>
                              <a:effectRef idx="0">
                                <a:scrgbClr r="0" g="0" b="0"/>
                              </a:effectRef>
                              <a:fontRef idx="minor">
                                <a:schemeClr val="dk1"/>
                              </a:fontRef>
                            </p:style>
                            <p:txBody>
                              <a:bodyPr vert="horz" rtlCol="0" anchor="ctr"/>
                              <a:lstStyle>
                                <a:lvl1pPr marL="0" indent="0">
                                  <a:defRPr sz="1100">
                                    <a:solidFill>
                                      <a:schemeClr val="dk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1pPr>
                                <a:lvl2pPr marL="457200" indent="0">
                                  <a:defRPr sz="1100">
                                    <a:solidFill>
                                      <a:schemeClr val="dk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2pPr>
                                <a:lvl3pPr marL="914400" indent="0">
                                  <a:defRPr sz="1100">
                                    <a:solidFill>
                                      <a:schemeClr val="dk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3pPr>
                                <a:lvl4pPr marL="1371600" indent="0">
                                  <a:defRPr sz="1100">
                                    <a:solidFill>
                                      <a:schemeClr val="dk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4pPr>
                                <a:lvl5pPr marL="1828800" indent="0">
                                  <a:defRPr sz="1100">
                                    <a:solidFill>
                                      <a:schemeClr val="dk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5pPr>
                                <a:lvl6pPr marL="2286000" indent="0">
                                  <a:defRPr sz="1100">
                                    <a:solidFill>
                                      <a:schemeClr val="dk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6pPr>
                                <a:lvl7pPr marL="2743200" indent="0">
                                  <a:defRPr sz="1100">
                                    <a:solidFill>
                                      <a:schemeClr val="dk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7pPr>
                                <a:lvl8pPr marL="3200400" indent="0">
                                  <a:defRPr sz="1100">
                                    <a:solidFill>
                                      <a:schemeClr val="dk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8pPr>
                                <a:lvl9pPr marL="3657600" indent="0">
                                  <a:defRPr sz="1100">
                                    <a:solidFill>
                                      <a:schemeClr val="dk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9pPr>
                              </a:lstStyle>
                              <a:p>
                                <a:endParaRPr lang="fr-FR" sz="1100"/>
                              </a:p>
                            </p:txBody>
                          </p:sp>
                        </p:grpSp>
                        <p:sp>
                          <p:nvSpPr>
                            <p:cNvPr id="81" name="ZoneTexte 25"/>
                            <p:cNvSpPr txBox="1"/>
                            <p:nvPr/>
                          </p:nvSpPr>
                          <p:spPr>
                            <a:xfrm>
                              <a:off x="7086600" y="1358900"/>
                              <a:ext cx="457200" cy="114300"/>
                            </a:xfrm>
                            <a:prstGeom prst="rect">
                              <a:avLst/>
                            </a:prstGeom>
                            <a:solidFill>
                              <a:srgbClr val="960000"/>
                            </a:solidFill>
                            <a:ln w="3175" cmpd="sng">
                              <a:solidFill>
                                <a:schemeClr val="lt1">
                                  <a:shade val="50000"/>
                                </a:schemeClr>
                              </a:solidFill>
                            </a:ln>
                          </p:spPr>
                          <p:style>
                            <a:lnRef idx="0">
                              <a:scrgbClr r="0" g="0" b="0"/>
                            </a:lnRef>
                            <a:fillRef idx="0">
                              <a:scrgbClr r="0" g="0" b="0"/>
                            </a:fillRef>
                            <a:effectRef idx="0">
                              <a:scrgbClr r="0" g="0" b="0"/>
                            </a:effectRef>
                            <a:fontRef idx="minor">
                              <a:schemeClr val="dk1"/>
                            </a:fontRef>
                          </p:style>
                          <p:txBody>
                            <a:bodyPr vert="horz" rtlCol="0" anchor="ctr"/>
                            <a:lstStyle>
                              <a:lvl1pPr marL="0" indent="0">
                                <a:defRPr sz="1100">
                                  <a:solidFill>
                                    <a:schemeClr val="dk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indent="0">
                                <a:defRPr sz="1100">
                                  <a:solidFill>
                                    <a:schemeClr val="dk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indent="0">
                                <a:defRPr sz="1100">
                                  <a:solidFill>
                                    <a:schemeClr val="dk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indent="0">
                                <a:defRPr sz="1100">
                                  <a:solidFill>
                                    <a:schemeClr val="dk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indent="0">
                                <a:defRPr sz="1100">
                                  <a:solidFill>
                                    <a:schemeClr val="dk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indent="0">
                                <a:defRPr sz="1100">
                                  <a:solidFill>
                                    <a:schemeClr val="dk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indent="0">
                                <a:defRPr sz="1100">
                                  <a:solidFill>
                                    <a:schemeClr val="dk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indent="0">
                                <a:defRPr sz="1100">
                                  <a:solidFill>
                                    <a:schemeClr val="dk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indent="0">
                                <a:defRPr sz="1100">
                                  <a:solidFill>
                                    <a:schemeClr val="dk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endParaRPr lang="fr-FR" sz="1100"/>
                            </a:p>
                          </p:txBody>
                        </p:sp>
                      </p:grpSp>
                      <p:sp>
                        <p:nvSpPr>
                          <p:cNvPr id="79" name="ZoneTexte 26"/>
                          <p:cNvSpPr txBox="1"/>
                          <p:nvPr/>
                        </p:nvSpPr>
                        <p:spPr>
                          <a:xfrm>
                            <a:off x="7086600" y="1549400"/>
                            <a:ext cx="457200" cy="114300"/>
                          </a:xfrm>
                          <a:prstGeom prst="rect">
                            <a:avLst/>
                          </a:prstGeom>
                          <a:solidFill>
                            <a:srgbClr val="640000"/>
                          </a:solidFill>
                          <a:ln w="3175" cmpd="sng">
                            <a:solidFill>
                              <a:schemeClr val="lt1">
                                <a:shade val="50000"/>
                              </a:schemeClr>
                            </a:solidFill>
                          </a:ln>
                        </p:spPr>
                        <p:style>
                          <a:lnRef idx="0">
                            <a:scrgbClr r="0" g="0" b="0"/>
                          </a:lnRef>
                          <a:fillRef idx="0">
                            <a:scrgbClr r="0" g="0" b="0"/>
                          </a:fillRef>
                          <a:effectRef idx="0">
                            <a:scrgbClr r="0" g="0" b="0"/>
                          </a:effectRef>
                          <a:fontRef idx="minor">
                            <a:schemeClr val="dk1"/>
                          </a:fontRef>
                        </p:style>
                        <p:txBody>
                          <a:bodyPr vert="horz" rtlCol="0" anchor="ctr"/>
                          <a:lstStyle>
                            <a:lvl1pPr marL="0" indent="0">
                              <a:defRPr sz="1100">
                                <a:solidFill>
                                  <a:schemeClr val="dk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1pPr>
                            <a:lvl2pPr marL="457200" indent="0">
                              <a:defRPr sz="1100">
                                <a:solidFill>
                                  <a:schemeClr val="dk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2pPr>
                            <a:lvl3pPr marL="914400" indent="0">
                              <a:defRPr sz="1100">
                                <a:solidFill>
                                  <a:schemeClr val="dk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3pPr>
                            <a:lvl4pPr marL="1371600" indent="0">
                              <a:defRPr sz="1100">
                                <a:solidFill>
                                  <a:schemeClr val="dk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4pPr>
                            <a:lvl5pPr marL="1828800" indent="0">
                              <a:defRPr sz="1100">
                                <a:solidFill>
                                  <a:schemeClr val="dk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5pPr>
                            <a:lvl6pPr marL="2286000" indent="0">
                              <a:defRPr sz="1100">
                                <a:solidFill>
                                  <a:schemeClr val="dk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6pPr>
                            <a:lvl7pPr marL="2743200" indent="0">
                              <a:defRPr sz="1100">
                                <a:solidFill>
                                  <a:schemeClr val="dk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7pPr>
                            <a:lvl8pPr marL="3200400" indent="0">
                              <a:defRPr sz="1100">
                                <a:solidFill>
                                  <a:schemeClr val="dk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8pPr>
                            <a:lvl9pPr marL="3657600" indent="0">
                              <a:defRPr sz="1100">
                                <a:solidFill>
                                  <a:schemeClr val="dk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9pPr>
                          </a:lstStyle>
                          <a:p>
                            <a:endParaRPr lang="fr-FR" sz="1100"/>
                          </a:p>
                        </p:txBody>
                      </p:sp>
                    </p:grpSp>
                    <p:sp>
                      <p:nvSpPr>
                        <p:cNvPr id="77" name="ZoneTexte 27"/>
                        <p:cNvSpPr txBox="1"/>
                        <p:nvPr/>
                      </p:nvSpPr>
                      <p:spPr>
                        <a:xfrm>
                          <a:off x="7086600" y="1739900"/>
                          <a:ext cx="457200" cy="114300"/>
                        </a:xfrm>
                        <a:prstGeom prst="rect">
                          <a:avLst/>
                        </a:prstGeom>
                        <a:solidFill>
                          <a:srgbClr val="460000"/>
                        </a:solidFill>
                        <a:ln w="3175" cmpd="sng">
                          <a:solidFill>
                            <a:schemeClr val="lt1">
                              <a:shade val="50000"/>
                            </a:schemeClr>
                          </a:solidFill>
                        </a:ln>
                      </p:spPr>
                      <p:style>
                        <a:lnRef idx="0">
                          <a:scrgbClr r="0" g="0" b="0"/>
                        </a:lnRef>
                        <a:fillRef idx="0">
                          <a:scrgbClr r="0" g="0" b="0"/>
                        </a:fillRef>
                        <a:effectRef idx="0">
                          <a:scrgbClr r="0" g="0" b="0"/>
                        </a:effectRef>
                        <a:fontRef idx="minor">
                          <a:schemeClr val="dk1"/>
                        </a:fontRef>
                      </p:style>
                      <p:txBody>
                        <a:bodyPr vert="horz" rtlCol="0" anchor="ctr"/>
                        <a:lstStyle>
                          <a:lvl1pPr marL="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endParaRPr lang="fr-FR" sz="1100"/>
                        </a:p>
                      </p:txBody>
                    </p:sp>
                  </p:grpSp>
                  <p:sp>
                    <p:nvSpPr>
                      <p:cNvPr id="75" name="ZoneTexte 28"/>
                      <p:cNvSpPr txBox="1"/>
                      <p:nvPr/>
                    </p:nvSpPr>
                    <p:spPr>
                      <a:xfrm>
                        <a:off x="7086600" y="1930400"/>
                        <a:ext cx="457200" cy="114300"/>
                      </a:xfrm>
                      <a:prstGeom prst="rect">
                        <a:avLst/>
                      </a:prstGeom>
                      <a:solidFill>
                        <a:srgbClr val="000000"/>
                      </a:solidFill>
                      <a:ln w="3175" cmpd="sng">
                        <a:solidFill>
                          <a:schemeClr val="lt1">
                            <a:shade val="50000"/>
                          </a:schemeClr>
                        </a:solidFill>
                      </a:ln>
                    </p:spPr>
                    <p:style>
                      <a:lnRef idx="0">
                        <a:scrgbClr r="0" g="0" b="0"/>
                      </a:lnRef>
                      <a:fillRef idx="0">
                        <a:scrgbClr r="0" g="0" b="0"/>
                      </a:fillRef>
                      <a:effectRef idx="0">
                        <a:scrgbClr r="0" g="0" b="0"/>
                      </a:effectRef>
                      <a:fontRef idx="minor">
                        <a:schemeClr val="dk1"/>
                      </a:fontRef>
                    </p:style>
                    <p:txBody>
                      <a:bodyPr vert="horz" rtlCol="0" anchor="ctr"/>
                      <a:lstStyle>
                        <a:lvl1pPr marL="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endParaRPr lang="fr-FR" sz="1100"/>
                      </a:p>
                    </p:txBody>
                  </p:sp>
                </p:grpSp>
                <p:sp>
                  <p:nvSpPr>
                    <p:cNvPr id="73" name="ZoneTexte 29"/>
                    <p:cNvSpPr txBox="1"/>
                    <p:nvPr/>
                  </p:nvSpPr>
                  <p:spPr>
                    <a:xfrm>
                      <a:off x="7086600" y="2120900"/>
                      <a:ext cx="457200" cy="114300"/>
                    </a:xfrm>
                    <a:prstGeom prst="rect">
                      <a:avLst/>
                    </a:prstGeom>
                    <a:solidFill>
                      <a:srgbClr val="004600"/>
                    </a:solidFill>
                    <a:ln w="3175" cmpd="sng">
                      <a:solidFill>
                        <a:schemeClr val="lt1">
                          <a:shade val="50000"/>
                        </a:schemeClr>
                      </a:solidFill>
                    </a:ln>
                  </p:spPr>
                  <p:style>
                    <a:lnRef idx="0">
                      <a:scrgbClr r="0" g="0" b="0"/>
                    </a:lnRef>
                    <a:fillRef idx="0">
                      <a:scrgbClr r="0" g="0" b="0"/>
                    </a:fillRef>
                    <a:effectRef idx="0">
                      <a:scrgbClr r="0" g="0" b="0"/>
                    </a:effectRef>
                    <a:fontRef idx="minor">
                      <a:schemeClr val="dk1"/>
                    </a:fontRef>
                  </p:style>
                  <p:txBody>
                    <a:bodyPr vert="horz" rtlCol="0" anchor="ctr"/>
                    <a:lstStyle>
                      <a:lvl1pPr marL="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endParaRPr lang="fr-FR" sz="1100"/>
                    </a:p>
                  </p:txBody>
                </p:sp>
              </p:grpSp>
              <p:sp>
                <p:nvSpPr>
                  <p:cNvPr id="71" name="ZoneTexte 30"/>
                  <p:cNvSpPr txBox="1"/>
                  <p:nvPr/>
                </p:nvSpPr>
                <p:spPr>
                  <a:xfrm>
                    <a:off x="7086600" y="2311400"/>
                    <a:ext cx="457200" cy="114300"/>
                  </a:xfrm>
                  <a:prstGeom prst="rect">
                    <a:avLst/>
                  </a:prstGeom>
                  <a:solidFill>
                    <a:srgbClr val="006400"/>
                  </a:solidFill>
                  <a:ln w="3175" cmpd="sng">
                    <a:solidFill>
                      <a:schemeClr val="lt1">
                        <a:shade val="50000"/>
                      </a:schemeClr>
                    </a:solidFill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dk1"/>
                  </a:fontRef>
                </p:style>
                <p:txBody>
                  <a:bodyPr vert="horz" rtlCol="0" anchor="ctr"/>
                  <a:lstStyle>
                    <a:lvl1pPr marL="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endParaRPr lang="fr-FR" sz="1100"/>
                  </a:p>
                </p:txBody>
              </p:sp>
            </p:grpSp>
            <p:sp>
              <p:nvSpPr>
                <p:cNvPr id="69" name="ZoneTexte 31"/>
                <p:cNvSpPr txBox="1"/>
                <p:nvPr/>
              </p:nvSpPr>
              <p:spPr>
                <a:xfrm>
                  <a:off x="7086600" y="2501900"/>
                  <a:ext cx="457200" cy="114300"/>
                </a:xfrm>
                <a:prstGeom prst="rect">
                  <a:avLst/>
                </a:prstGeom>
                <a:solidFill>
                  <a:srgbClr val="009600"/>
                </a:solidFill>
                <a:ln w="3175" cmpd="sng">
                  <a:solidFill>
                    <a:schemeClr val="lt1">
                      <a:shade val="50000"/>
                    </a:schemeClr>
                  </a:solidFill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vert="horz" rtlCol="0" anchor="ctr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endParaRPr lang="fr-FR" sz="1100"/>
                </a:p>
              </p:txBody>
            </p:sp>
          </p:grpSp>
          <p:sp>
            <p:nvSpPr>
              <p:cNvPr id="67" name="ZoneTexte 32"/>
              <p:cNvSpPr txBox="1"/>
              <p:nvPr/>
            </p:nvSpPr>
            <p:spPr>
              <a:xfrm>
                <a:off x="7086600" y="2692400"/>
                <a:ext cx="457200" cy="114300"/>
              </a:xfrm>
              <a:prstGeom prst="rect">
                <a:avLst/>
              </a:prstGeom>
              <a:solidFill>
                <a:srgbClr val="00C800"/>
              </a:solidFill>
              <a:ln w="3175" cmpd="sng">
                <a:solidFill>
                  <a:schemeClr val="lt1">
                    <a:shade val="50000"/>
                  </a:schemeClr>
                </a:solidFill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vert="horz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fr-FR" sz="1100"/>
              </a:p>
            </p:txBody>
          </p:sp>
        </p:grpSp>
        <p:sp>
          <p:nvSpPr>
            <p:cNvPr id="65" name="ZoneTexte 33"/>
            <p:cNvSpPr txBox="1"/>
            <p:nvPr/>
          </p:nvSpPr>
          <p:spPr>
            <a:xfrm>
              <a:off x="7086600" y="2882900"/>
              <a:ext cx="457200" cy="114300"/>
            </a:xfrm>
            <a:prstGeom prst="rect">
              <a:avLst/>
            </a:prstGeom>
            <a:solidFill>
              <a:srgbClr val="00FF00"/>
            </a:solidFill>
            <a:ln w="3175" cmpd="sng">
              <a:solidFill>
                <a:schemeClr val="lt1">
                  <a:shade val="50000"/>
                </a:schemeClr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vert="horz" rtlCol="0"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fr-FR" sz="1100"/>
            </a:p>
          </p:txBody>
        </p:sp>
      </p:grpSp>
      <p:sp>
        <p:nvSpPr>
          <p:cNvPr id="3" name="ZoneTexte 2"/>
          <p:cNvSpPr txBox="1"/>
          <p:nvPr/>
        </p:nvSpPr>
        <p:spPr>
          <a:xfrm>
            <a:off x="2409149" y="8254136"/>
            <a:ext cx="323165" cy="81368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FR" sz="900" dirty="0"/>
              <a:t>MDA-MB-361 S</a:t>
            </a:r>
            <a:endParaRPr lang="en-GB" sz="900" dirty="0"/>
          </a:p>
        </p:txBody>
      </p:sp>
      <p:sp>
        <p:nvSpPr>
          <p:cNvPr id="109" name="ZoneTexte 108"/>
          <p:cNvSpPr txBox="1"/>
          <p:nvPr/>
        </p:nvSpPr>
        <p:spPr>
          <a:xfrm>
            <a:off x="3298412" y="8254136"/>
            <a:ext cx="323165" cy="87940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FR" sz="900" dirty="0"/>
              <a:t>MDA-MB-361 TR</a:t>
            </a:r>
            <a:endParaRPr lang="en-GB" sz="900" dirty="0"/>
          </a:p>
        </p:txBody>
      </p:sp>
      <p:sp>
        <p:nvSpPr>
          <p:cNvPr id="110" name="ZoneTexte 109"/>
          <p:cNvSpPr txBox="1"/>
          <p:nvPr/>
        </p:nvSpPr>
        <p:spPr>
          <a:xfrm>
            <a:off x="4187675" y="8254136"/>
            <a:ext cx="323165" cy="94032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FR" sz="900" dirty="0"/>
              <a:t>MDA-MB-361 TCR</a:t>
            </a:r>
            <a:endParaRPr lang="en-GB" sz="900" dirty="0"/>
          </a:p>
        </p:txBody>
      </p:sp>
    </p:spTree>
    <p:extLst>
      <p:ext uri="{BB962C8B-B14F-4D97-AF65-F5344CB8AC3E}">
        <p14:creationId xmlns:p14="http://schemas.microsoft.com/office/powerpoint/2010/main" val="102177256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8</TotalTime>
  <Words>710</Words>
  <Application>Microsoft Macintosh PowerPoint</Application>
  <PresentationFormat>Personnalisé</PresentationFormat>
  <Paragraphs>216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Franklin Gothic Book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>UCBL - Lyon 1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ONILH LOUISE</dc:creator>
  <cp:lastModifiedBy>A3989</cp:lastModifiedBy>
  <cp:revision>24</cp:revision>
  <dcterms:created xsi:type="dcterms:W3CDTF">2019-05-13T13:09:28Z</dcterms:created>
  <dcterms:modified xsi:type="dcterms:W3CDTF">2020-05-15T13:09:02Z</dcterms:modified>
</cp:coreProperties>
</file>